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slides/slide60.xml" ContentType="application/vnd.openxmlformats-officedocument.presentationml.slide+xml"/>
  <Override PartName="/ppt/slides/slide61.xml" ContentType="application/vnd.openxmlformats-officedocument.presentationml.slide+xml"/>
  <Override PartName="/ppt/slides/slide62.xml" ContentType="application/vnd.openxmlformats-officedocument.presentationml.slide+xml"/>
  <Override PartName="/ppt/slides/slide63.xml" ContentType="application/vnd.openxmlformats-officedocument.presentationml.slide+xml"/>
  <Override PartName="/ppt/slides/slide64.xml" ContentType="application/vnd.openxmlformats-officedocument.presentationml.slide+xml"/>
  <Override PartName="/ppt/slides/slide65.xml" ContentType="application/vnd.openxmlformats-officedocument.presentationml.slide+xml"/>
  <Override PartName="/ppt/slides/slide66.xml" ContentType="application/vnd.openxmlformats-officedocument.presentationml.slide+xml"/>
  <Override PartName="/ppt/slides/slide67.xml" ContentType="application/vnd.openxmlformats-officedocument.presentationml.slide+xml"/>
  <Override PartName="/ppt/slides/slide68.xml" ContentType="application/vnd.openxmlformats-officedocument.presentationml.slide+xml"/>
  <Override PartName="/ppt/slides/slide69.xml" ContentType="application/vnd.openxmlformats-officedocument.presentationml.slide+xml"/>
  <Override PartName="/ppt/slides/slide70.xml" ContentType="application/vnd.openxmlformats-officedocument.presentationml.slide+xml"/>
  <Override PartName="/ppt/slides/slide71.xml" ContentType="application/vnd.openxmlformats-officedocument.presentationml.slide+xml"/>
  <Override PartName="/ppt/slides/slide72.xml" ContentType="application/vnd.openxmlformats-officedocument.presentationml.slide+xml"/>
  <Override PartName="/ppt/slides/slide73.xml" ContentType="application/vnd.openxmlformats-officedocument.presentationml.slide+xml"/>
  <Override PartName="/ppt/slides/slide74.xml" ContentType="application/vnd.openxmlformats-officedocument.presentationml.slide+xml"/>
  <Override PartName="/ppt/slides/slide75.xml" ContentType="application/vnd.openxmlformats-officedocument.presentationml.slide+xml"/>
  <Override PartName="/ppt/slides/slide76.xml" ContentType="application/vnd.openxmlformats-officedocument.presentationml.slide+xml"/>
  <Override PartName="/ppt/slides/slide77.xml" ContentType="application/vnd.openxmlformats-officedocument.presentationml.slide+xml"/>
  <Override PartName="/ppt/slides/slide78.xml" ContentType="application/vnd.openxmlformats-officedocument.presentationml.slide+xml"/>
  <Override PartName="/ppt/slides/slide79.xml" ContentType="application/vnd.openxmlformats-officedocument.presentationml.slide+xml"/>
  <Override PartName="/ppt/slides/slide80.xml" ContentType="application/vnd.openxmlformats-officedocument.presentationml.slide+xml"/>
  <Override PartName="/ppt/slides/slide81.xml" ContentType="application/vnd.openxmlformats-officedocument.presentationml.slide+xml"/>
  <Override PartName="/ppt/slides/slide82.xml" ContentType="application/vnd.openxmlformats-officedocument.presentationml.slide+xml"/>
  <Override PartName="/ppt/slides/slide83.xml" ContentType="application/vnd.openxmlformats-officedocument.presentationml.slide+xml"/>
  <Override PartName="/ppt/slides/slide84.xml" ContentType="application/vnd.openxmlformats-officedocument.presentationml.slide+xml"/>
  <Override PartName="/ppt/slides/slide85.xml" ContentType="application/vnd.openxmlformats-officedocument.presentationml.slide+xml"/>
  <Override PartName="/ppt/slides/slide86.xml" ContentType="application/vnd.openxmlformats-officedocument.presentationml.slide+xml"/>
  <Override PartName="/ppt/slides/slide87.xml" ContentType="application/vnd.openxmlformats-officedocument.presentationml.slide+xml"/>
  <Override PartName="/ppt/slides/slide88.xml" ContentType="application/vnd.openxmlformats-officedocument.presentationml.slide+xml"/>
  <Override PartName="/ppt/slides/slide89.xml" ContentType="application/vnd.openxmlformats-officedocument.presentationml.slide+xml"/>
  <Override PartName="/ppt/slides/slide90.xml" ContentType="application/vnd.openxmlformats-officedocument.presentationml.slide+xml"/>
  <Override PartName="/ppt/slides/slide91.xml" ContentType="application/vnd.openxmlformats-officedocument.presentationml.slide+xml"/>
  <Override PartName="/ppt/slides/slide92.xml" ContentType="application/vnd.openxmlformats-officedocument.presentationml.slide+xml"/>
  <Override PartName="/ppt/slides/slide93.xml" ContentType="application/vnd.openxmlformats-officedocument.presentationml.slide+xml"/>
  <Override PartName="/ppt/slides/slide94.xml" ContentType="application/vnd.openxmlformats-officedocument.presentationml.slide+xml"/>
  <Override PartName="/ppt/slides/slide95.xml" ContentType="application/vnd.openxmlformats-officedocument.presentationml.slide+xml"/>
  <Override PartName="/ppt/slides/slide96.xml" ContentType="application/vnd.openxmlformats-officedocument.presentationml.slide+xml"/>
  <Override PartName="/ppt/slides/slide97.xml" ContentType="application/vnd.openxmlformats-officedocument.presentationml.slide+xml"/>
  <Override PartName="/ppt/slides/slide98.xml" ContentType="application/vnd.openxmlformats-officedocument.presentationml.slide+xml"/>
  <Override PartName="/ppt/slides/slide99.xml" ContentType="application/vnd.openxmlformats-officedocument.presentationml.slide+xml"/>
  <Override PartName="/ppt/slides/slide100.xml" ContentType="application/vnd.openxmlformats-officedocument.presentationml.slide+xml"/>
  <Override PartName="/ppt/slides/slide101.xml" ContentType="application/vnd.openxmlformats-officedocument.presentationml.slide+xml"/>
  <Override PartName="/ppt/slides/slide102.xml" ContentType="application/vnd.openxmlformats-officedocument.presentationml.slide+xml"/>
  <Override PartName="/ppt/slides/slide103.xml" ContentType="application/vnd.openxmlformats-officedocument.presentationml.slide+xml"/>
  <Override PartName="/ppt/slides/slide104.xml" ContentType="application/vnd.openxmlformats-officedocument.presentationml.slide+xml"/>
  <Override PartName="/ppt/slides/slide105.xml" ContentType="application/vnd.openxmlformats-officedocument.presentationml.slide+xml"/>
  <Override PartName="/ppt/slides/slide106.xml" ContentType="application/vnd.openxmlformats-officedocument.presentationml.slide+xml"/>
  <Override PartName="/ppt/slides/slide107.xml" ContentType="application/vnd.openxmlformats-officedocument.presentationml.slide+xml"/>
  <Override PartName="/ppt/slides/slide108.xml" ContentType="application/vnd.openxmlformats-officedocument.presentationml.slide+xml"/>
  <Override PartName="/ppt/slides/slide109.xml" ContentType="application/vnd.openxmlformats-officedocument.presentationml.slide+xml"/>
  <Override PartName="/ppt/slides/slide110.xml" ContentType="application/vnd.openxmlformats-officedocument.presentationml.slide+xml"/>
  <Override PartName="/ppt/slides/slide111.xml" ContentType="application/vnd.openxmlformats-officedocument.presentationml.slide+xml"/>
  <Override PartName="/ppt/slides/slide112.xml" ContentType="application/vnd.openxmlformats-officedocument.presentationml.slide+xml"/>
  <Override PartName="/ppt/slides/slide113.xml" ContentType="application/vnd.openxmlformats-officedocument.presentationml.slide+xml"/>
  <Override PartName="/ppt/slides/slide114.xml" ContentType="application/vnd.openxmlformats-officedocument.presentationml.slide+xml"/>
  <Override PartName="/ppt/slides/slide115.xml" ContentType="application/vnd.openxmlformats-officedocument.presentationml.slide+xml"/>
  <Override PartName="/ppt/slides/slide116.xml" ContentType="application/vnd.openxmlformats-officedocument.presentationml.slide+xml"/>
  <Override PartName="/ppt/slides/slide117.xml" ContentType="application/vnd.openxmlformats-officedocument.presentationml.slide+xml"/>
  <Override PartName="/ppt/slides/slide118.xml" ContentType="application/vnd.openxmlformats-officedocument.presentationml.slide+xml"/>
  <Override PartName="/ppt/slides/slide119.xml" ContentType="application/vnd.openxmlformats-officedocument.presentationml.slide+xml"/>
  <Override PartName="/ppt/slides/slide120.xml" ContentType="application/vnd.openxmlformats-officedocument.presentationml.slide+xml"/>
  <Override PartName="/ppt/slides/slide121.xml" ContentType="application/vnd.openxmlformats-officedocument.presentationml.slide+xml"/>
  <Override PartName="/ppt/slides/slide122.xml" ContentType="application/vnd.openxmlformats-officedocument.presentationml.slide+xml"/>
  <Override PartName="/ppt/slides/slide123.xml" ContentType="application/vnd.openxmlformats-officedocument.presentationml.slide+xml"/>
  <Override PartName="/ppt/slides/slide124.xml" ContentType="application/vnd.openxmlformats-officedocument.presentationml.slide+xml"/>
  <Override PartName="/ppt/slides/slide125.xml" ContentType="application/vnd.openxmlformats-officedocument.presentationml.slide+xml"/>
  <Override PartName="/ppt/slides/slide126.xml" ContentType="application/vnd.openxmlformats-officedocument.presentationml.slide+xml"/>
  <Override PartName="/ppt/slides/slide127.xml" ContentType="application/vnd.openxmlformats-officedocument.presentationml.slide+xml"/>
  <Override PartName="/ppt/slides/slide128.xml" ContentType="application/vnd.openxmlformats-officedocument.presentationml.slide+xml"/>
  <Override PartName="/ppt/slides/slide129.xml" ContentType="application/vnd.openxmlformats-officedocument.presentationml.slide+xml"/>
  <Override PartName="/ppt/slides/slide130.xml" ContentType="application/vnd.openxmlformats-officedocument.presentationml.slide+xml"/>
  <Override PartName="/ppt/slides/slide131.xml" ContentType="application/vnd.openxmlformats-officedocument.presentationml.slide+xml"/>
  <Override PartName="/ppt/slides/slide132.xml" ContentType="application/vnd.openxmlformats-officedocument.presentationml.slide+xml"/>
  <Override PartName="/ppt/slides/slide133.xml" ContentType="application/vnd.openxmlformats-officedocument.presentationml.slide+xml"/>
  <Override PartName="/ppt/slides/slide134.xml" ContentType="application/vnd.openxmlformats-officedocument.presentationml.slide+xml"/>
  <Override PartName="/ppt/slides/slide135.xml" ContentType="application/vnd.openxmlformats-officedocument.presentationml.slide+xml"/>
  <Override PartName="/ppt/slides/slide136.xml" ContentType="application/vnd.openxmlformats-officedocument.presentationml.slide+xml"/>
  <Override PartName="/ppt/slides/slide137.xml" ContentType="application/vnd.openxmlformats-officedocument.presentationml.slide+xml"/>
  <Override PartName="/ppt/slides/slide138.xml" ContentType="application/vnd.openxmlformats-officedocument.presentationml.slide+xml"/>
  <Override PartName="/ppt/slides/slide139.xml" ContentType="application/vnd.openxmlformats-officedocument.presentationml.slide+xml"/>
  <Override PartName="/ppt/slides/slide140.xml" ContentType="application/vnd.openxmlformats-officedocument.presentationml.slide+xml"/>
  <Override PartName="/ppt/slides/slide141.xml" ContentType="application/vnd.openxmlformats-officedocument.presentationml.slide+xml"/>
  <Override PartName="/ppt/slides/slide142.xml" ContentType="application/vnd.openxmlformats-officedocument.presentationml.slide+xml"/>
  <Override PartName="/ppt/slides/slide143.xml" ContentType="application/vnd.openxmlformats-officedocument.presentationml.slide+xml"/>
  <Override PartName="/ppt/slides/slide144.xml" ContentType="application/vnd.openxmlformats-officedocument.presentationml.slide+xml"/>
  <Override PartName="/ppt/slides/slide145.xml" ContentType="application/vnd.openxmlformats-officedocument.presentationml.slide+xml"/>
  <Override PartName="/ppt/slides/slide146.xml" ContentType="application/vnd.openxmlformats-officedocument.presentationml.slide+xml"/>
  <Override PartName="/ppt/slides/slide147.xml" ContentType="application/vnd.openxmlformats-officedocument.presentationml.slide+xml"/>
  <Override PartName="/ppt/slides/slide148.xml" ContentType="application/vnd.openxmlformats-officedocument.presentationml.slide+xml"/>
  <Override PartName="/ppt/slides/slide149.xml" ContentType="application/vnd.openxmlformats-officedocument.presentationml.slide+xml"/>
  <Override PartName="/ppt/slides/slide150.xml" ContentType="application/vnd.openxmlformats-officedocument.presentationml.slide+xml"/>
  <Override PartName="/ppt/slides/slide151.xml" ContentType="application/vnd.openxmlformats-officedocument.presentationml.slide+xml"/>
  <Override PartName="/ppt/slides/slide152.xml" ContentType="application/vnd.openxmlformats-officedocument.presentationml.slide+xml"/>
  <Override PartName="/ppt/slides/slide153.xml" ContentType="application/vnd.openxmlformats-officedocument.presentationml.slide+xml"/>
  <Override PartName="/ppt/slides/slide154.xml" ContentType="application/vnd.openxmlformats-officedocument.presentationml.slide+xml"/>
  <Override PartName="/ppt/slides/slide155.xml" ContentType="application/vnd.openxmlformats-officedocument.presentationml.slide+xml"/>
  <Override PartName="/ppt/slides/slide156.xml" ContentType="application/vnd.openxmlformats-officedocument.presentationml.slide+xml"/>
  <Override PartName="/ppt/slides/slide157.xml" ContentType="application/vnd.openxmlformats-officedocument.presentationml.slide+xml"/>
  <Override PartName="/ppt/slides/slide158.xml" ContentType="application/vnd.openxmlformats-officedocument.presentationml.slide+xml"/>
  <Override PartName="/ppt/slides/slide159.xml" ContentType="application/vnd.openxmlformats-officedocument.presentationml.slide+xml"/>
  <Override PartName="/ppt/slides/slide160.xml" ContentType="application/vnd.openxmlformats-officedocument.presentationml.slide+xml"/>
  <Override PartName="/ppt/slides/slide161.xml" ContentType="application/vnd.openxmlformats-officedocument.presentationml.slide+xml"/>
  <Override PartName="/ppt/slides/slide162.xml" ContentType="application/vnd.openxmlformats-officedocument.presentationml.slide+xml"/>
  <Override PartName="/ppt/slides/slide163.xml" ContentType="application/vnd.openxmlformats-officedocument.presentationml.slide+xml"/>
  <Override PartName="/ppt/slides/slide164.xml" ContentType="application/vnd.openxmlformats-officedocument.presentationml.slide+xml"/>
  <Override PartName="/ppt/slides/slide165.xml" ContentType="application/vnd.openxmlformats-officedocument.presentationml.slide+xml"/>
  <Override PartName="/ppt/slides/slide166.xml" ContentType="application/vnd.openxmlformats-officedocument.presentationml.slide+xml"/>
  <Override PartName="/ppt/slides/slide167.xml" ContentType="application/vnd.openxmlformats-officedocument.presentationml.slide+xml"/>
  <Override PartName="/ppt/slides/slide168.xml" ContentType="application/vnd.openxmlformats-officedocument.presentationml.slide+xml"/>
  <Override PartName="/ppt/slides/slide169.xml" ContentType="application/vnd.openxmlformats-officedocument.presentationml.slide+xml"/>
  <Override PartName="/ppt/slides/slide170.xml" ContentType="application/vnd.openxmlformats-officedocument.presentationml.slide+xml"/>
  <Override PartName="/ppt/slides/slide171.xml" ContentType="application/vnd.openxmlformats-officedocument.presentationml.slide+xml"/>
  <Override PartName="/ppt/slides/slide172.xml" ContentType="application/vnd.openxmlformats-officedocument.presentationml.slide+xml"/>
  <Override PartName="/ppt/slides/slide173.xml" ContentType="application/vnd.openxmlformats-officedocument.presentationml.slide+xml"/>
  <Override PartName="/ppt/slides/slide174.xml" ContentType="application/vnd.openxmlformats-officedocument.presentationml.slide+xml"/>
  <Override PartName="/ppt/slides/slide175.xml" ContentType="application/vnd.openxmlformats-officedocument.presentationml.slide+xml"/>
  <Override PartName="/ppt/slides/slide176.xml" ContentType="application/vnd.openxmlformats-officedocument.presentationml.slide+xml"/>
  <Override PartName="/ppt/slides/slide177.xml" ContentType="application/vnd.openxmlformats-officedocument.presentationml.slide+xml"/>
  <Override PartName="/ppt/slides/slide178.xml" ContentType="application/vnd.openxmlformats-officedocument.presentationml.slide+xml"/>
  <Override PartName="/ppt/slides/slide179.xml" ContentType="application/vnd.openxmlformats-officedocument.presentationml.slide+xml"/>
  <Override PartName="/ppt/slides/slide180.xml" ContentType="application/vnd.openxmlformats-officedocument.presentationml.slide+xml"/>
  <Override PartName="/ppt/slides/slide181.xml" ContentType="application/vnd.openxmlformats-officedocument.presentationml.slide+xml"/>
  <Override PartName="/ppt/slides/slide182.xml" ContentType="application/vnd.openxmlformats-officedocument.presentationml.slide+xml"/>
  <Override PartName="/ppt/slides/slide183.xml" ContentType="application/vnd.openxmlformats-officedocument.presentationml.slide+xml"/>
  <Override PartName="/ppt/slides/slide184.xml" ContentType="application/vnd.openxmlformats-officedocument.presentationml.slide+xml"/>
  <Override PartName="/ppt/slides/slide185.xml" ContentType="application/vnd.openxmlformats-officedocument.presentationml.slide+xml"/>
  <Override PartName="/ppt/slides/slide186.xml" ContentType="application/vnd.openxmlformats-officedocument.presentationml.slide+xml"/>
  <Override PartName="/ppt/slides/slide187.xml" ContentType="application/vnd.openxmlformats-officedocument.presentationml.slide+xml"/>
  <Override PartName="/ppt/slides/slide188.xml" ContentType="application/vnd.openxmlformats-officedocument.presentationml.slide+xml"/>
  <Override PartName="/ppt/slides/slide189.xml" ContentType="application/vnd.openxmlformats-officedocument.presentationml.slide+xml"/>
  <Override PartName="/ppt/slides/slide190.xml" ContentType="application/vnd.openxmlformats-officedocument.presentationml.slide+xml"/>
  <Override PartName="/ppt/slides/slide191.xml" ContentType="application/vnd.openxmlformats-officedocument.presentationml.slide+xml"/>
  <Override PartName="/ppt/slides/slide192.xml" ContentType="application/vnd.openxmlformats-officedocument.presentationml.slide+xml"/>
  <Override PartName="/ppt/slides/slide193.xml" ContentType="application/vnd.openxmlformats-officedocument.presentationml.slide+xml"/>
  <Override PartName="/ppt/slides/slide194.xml" ContentType="application/vnd.openxmlformats-officedocument.presentationml.slide+xml"/>
  <Override PartName="/ppt/slides/slide195.xml" ContentType="application/vnd.openxmlformats-officedocument.presentationml.slide+xml"/>
  <Override PartName="/ppt/slides/slide196.xml" ContentType="application/vnd.openxmlformats-officedocument.presentationml.slide+xml"/>
  <Override PartName="/ppt/slides/slide197.xml" ContentType="application/vnd.openxmlformats-officedocument.presentationml.slide+xml"/>
  <Override PartName="/ppt/slides/slide198.xml" ContentType="application/vnd.openxmlformats-officedocument.presentationml.slide+xml"/>
  <Override PartName="/ppt/slides/slide199.xml" ContentType="application/vnd.openxmlformats-officedocument.presentationml.slide+xml"/>
  <Override PartName="/ppt/slides/slide200.xml" ContentType="application/vnd.openxmlformats-officedocument.presentationml.slide+xml"/>
  <Override PartName="/ppt/slides/slide201.xml" ContentType="application/vnd.openxmlformats-officedocument.presentationml.slide+xml"/>
  <Override PartName="/ppt/slides/slide202.xml" ContentType="application/vnd.openxmlformats-officedocument.presentationml.slide+xml"/>
  <Override PartName="/ppt/slides/slide203.xml" ContentType="application/vnd.openxmlformats-officedocument.presentationml.slide+xml"/>
  <Override PartName="/ppt/slides/slide204.xml" ContentType="application/vnd.openxmlformats-officedocument.presentationml.slide+xml"/>
  <Override PartName="/ppt/slides/slide205.xml" ContentType="application/vnd.openxmlformats-officedocument.presentationml.slide+xml"/>
  <Override PartName="/ppt/slides/slide206.xml" ContentType="application/vnd.openxmlformats-officedocument.presentationml.slide+xml"/>
  <Override PartName="/ppt/slides/slide207.xml" ContentType="application/vnd.openxmlformats-officedocument.presentationml.slide+xml"/>
  <Override PartName="/ppt/slides/slide208.xml" ContentType="application/vnd.openxmlformats-officedocument.presentationml.slide+xml"/>
  <Override PartName="/ppt/slides/slide209.xml" ContentType="application/vnd.openxmlformats-officedocument.presentationml.slide+xml"/>
  <Override PartName="/ppt/slides/slide210.xml" ContentType="application/vnd.openxmlformats-officedocument.presentationml.slide+xml"/>
  <Override PartName="/ppt/slides/slide211.xml" ContentType="application/vnd.openxmlformats-officedocument.presentationml.slide+xml"/>
  <Override PartName="/ppt/slides/slide212.xml" ContentType="application/vnd.openxmlformats-officedocument.presentationml.slide+xml"/>
  <Override PartName="/ppt/slides/slide213.xml" ContentType="application/vnd.openxmlformats-officedocument.presentationml.slide+xml"/>
  <Override PartName="/ppt/slides/slide214.xml" ContentType="application/vnd.openxmlformats-officedocument.presentationml.slide+xml"/>
  <Override PartName="/ppt/slides/slide215.xml" ContentType="application/vnd.openxmlformats-officedocument.presentationml.slide+xml"/>
  <Override PartName="/ppt/slides/slide216.xml" ContentType="application/vnd.openxmlformats-officedocument.presentationml.slide+xml"/>
  <Override PartName="/ppt/slides/slide217.xml" ContentType="application/vnd.openxmlformats-officedocument.presentationml.slide+xml"/>
  <Override PartName="/ppt/slides/slide218.xml" ContentType="application/vnd.openxmlformats-officedocument.presentationml.slide+xml"/>
  <Override PartName="/ppt/slides/slide219.xml" ContentType="application/vnd.openxmlformats-officedocument.presentationml.slide+xml"/>
  <Override PartName="/ppt/slides/slide220.xml" ContentType="application/vnd.openxmlformats-officedocument.presentationml.slide+xml"/>
  <Override PartName="/ppt/slides/slide221.xml" ContentType="application/vnd.openxmlformats-officedocument.presentationml.slide+xml"/>
  <Override PartName="/ppt/slides/slide222.xml" ContentType="application/vnd.openxmlformats-officedocument.presentationml.slide+xml"/>
  <Override PartName="/ppt/slides/slide223.xml" ContentType="application/vnd.openxmlformats-officedocument.presentationml.slide+xml"/>
  <Override PartName="/ppt/slides/slide224.xml" ContentType="application/vnd.openxmlformats-officedocument.presentationml.slide+xml"/>
  <Override PartName="/ppt/slides/slide225.xml" ContentType="application/vnd.openxmlformats-officedocument.presentationml.slide+xml"/>
  <Override PartName="/ppt/slides/slide226.xml" ContentType="application/vnd.openxmlformats-officedocument.presentationml.slide+xml"/>
  <Override PartName="/ppt/slides/slide22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4" r:id="rId2"/>
    <p:sldId id="285" r:id="rId3"/>
    <p:sldId id="286" r:id="rId4"/>
    <p:sldId id="287" r:id="rId5"/>
    <p:sldId id="288" r:id="rId6"/>
    <p:sldId id="289" r:id="rId7"/>
    <p:sldId id="290" r:id="rId8"/>
    <p:sldId id="291" r:id="rId9"/>
    <p:sldId id="292" r:id="rId10"/>
    <p:sldId id="293" r:id="rId11"/>
    <p:sldId id="294" r:id="rId12"/>
    <p:sldId id="295" r:id="rId13"/>
    <p:sldId id="296" r:id="rId14"/>
    <p:sldId id="297" r:id="rId15"/>
    <p:sldId id="298" r:id="rId16"/>
    <p:sldId id="299" r:id="rId17"/>
    <p:sldId id="300" r:id="rId18"/>
    <p:sldId id="301" r:id="rId19"/>
    <p:sldId id="302" r:id="rId20"/>
    <p:sldId id="303" r:id="rId21"/>
    <p:sldId id="304" r:id="rId22"/>
    <p:sldId id="305" r:id="rId23"/>
    <p:sldId id="306" r:id="rId24"/>
    <p:sldId id="307" r:id="rId25"/>
    <p:sldId id="308" r:id="rId26"/>
    <p:sldId id="309" r:id="rId27"/>
    <p:sldId id="310" r:id="rId28"/>
    <p:sldId id="311" r:id="rId29"/>
    <p:sldId id="312" r:id="rId30"/>
    <p:sldId id="313" r:id="rId31"/>
    <p:sldId id="314" r:id="rId32"/>
    <p:sldId id="315" r:id="rId33"/>
    <p:sldId id="316" r:id="rId34"/>
    <p:sldId id="317" r:id="rId35"/>
    <p:sldId id="318" r:id="rId36"/>
    <p:sldId id="319" r:id="rId37"/>
    <p:sldId id="320" r:id="rId38"/>
    <p:sldId id="321" r:id="rId39"/>
    <p:sldId id="322" r:id="rId40"/>
    <p:sldId id="323" r:id="rId41"/>
    <p:sldId id="324" r:id="rId42"/>
    <p:sldId id="325" r:id="rId43"/>
    <p:sldId id="326" r:id="rId44"/>
    <p:sldId id="327" r:id="rId45"/>
    <p:sldId id="328" r:id="rId46"/>
    <p:sldId id="329" r:id="rId47"/>
    <p:sldId id="330" r:id="rId48"/>
    <p:sldId id="331" r:id="rId49"/>
    <p:sldId id="332" r:id="rId50"/>
    <p:sldId id="333" r:id="rId51"/>
    <p:sldId id="334" r:id="rId52"/>
    <p:sldId id="335" r:id="rId53"/>
    <p:sldId id="336" r:id="rId54"/>
    <p:sldId id="337" r:id="rId55"/>
    <p:sldId id="338" r:id="rId56"/>
    <p:sldId id="339" r:id="rId57"/>
    <p:sldId id="340" r:id="rId58"/>
    <p:sldId id="341" r:id="rId59"/>
    <p:sldId id="342" r:id="rId60"/>
    <p:sldId id="343" r:id="rId61"/>
    <p:sldId id="344" r:id="rId62"/>
    <p:sldId id="345" r:id="rId63"/>
    <p:sldId id="346" r:id="rId64"/>
    <p:sldId id="347" r:id="rId65"/>
    <p:sldId id="348" r:id="rId66"/>
    <p:sldId id="349" r:id="rId67"/>
    <p:sldId id="350" r:id="rId68"/>
    <p:sldId id="351" r:id="rId69"/>
    <p:sldId id="352" r:id="rId70"/>
    <p:sldId id="353" r:id="rId71"/>
    <p:sldId id="354" r:id="rId72"/>
    <p:sldId id="355" r:id="rId73"/>
    <p:sldId id="356" r:id="rId74"/>
    <p:sldId id="357" r:id="rId75"/>
    <p:sldId id="358" r:id="rId76"/>
    <p:sldId id="359" r:id="rId77"/>
    <p:sldId id="360" r:id="rId78"/>
    <p:sldId id="361" r:id="rId79"/>
    <p:sldId id="362" r:id="rId80"/>
    <p:sldId id="363" r:id="rId81"/>
    <p:sldId id="364" r:id="rId82"/>
    <p:sldId id="365" r:id="rId83"/>
    <p:sldId id="366" r:id="rId84"/>
    <p:sldId id="367" r:id="rId85"/>
    <p:sldId id="368" r:id="rId86"/>
    <p:sldId id="369" r:id="rId87"/>
    <p:sldId id="370" r:id="rId88"/>
    <p:sldId id="371" r:id="rId89"/>
    <p:sldId id="372" r:id="rId90"/>
    <p:sldId id="373" r:id="rId91"/>
    <p:sldId id="374" r:id="rId92"/>
    <p:sldId id="375" r:id="rId93"/>
    <p:sldId id="376" r:id="rId94"/>
    <p:sldId id="377" r:id="rId95"/>
    <p:sldId id="378" r:id="rId96"/>
    <p:sldId id="379" r:id="rId97"/>
    <p:sldId id="380" r:id="rId98"/>
    <p:sldId id="381" r:id="rId99"/>
    <p:sldId id="382" r:id="rId100"/>
    <p:sldId id="383" r:id="rId101"/>
    <p:sldId id="384" r:id="rId102"/>
    <p:sldId id="385" r:id="rId103"/>
    <p:sldId id="386" r:id="rId104"/>
    <p:sldId id="387" r:id="rId105"/>
    <p:sldId id="388" r:id="rId106"/>
    <p:sldId id="389" r:id="rId107"/>
    <p:sldId id="390" r:id="rId108"/>
    <p:sldId id="391" r:id="rId109"/>
    <p:sldId id="392" r:id="rId110"/>
    <p:sldId id="393" r:id="rId111"/>
    <p:sldId id="394" r:id="rId112"/>
    <p:sldId id="395" r:id="rId113"/>
    <p:sldId id="396" r:id="rId114"/>
    <p:sldId id="397" r:id="rId115"/>
    <p:sldId id="398" r:id="rId116"/>
    <p:sldId id="399" r:id="rId117"/>
    <p:sldId id="400" r:id="rId118"/>
    <p:sldId id="401" r:id="rId119"/>
    <p:sldId id="402" r:id="rId120"/>
    <p:sldId id="403" r:id="rId121"/>
    <p:sldId id="404" r:id="rId122"/>
    <p:sldId id="405" r:id="rId123"/>
    <p:sldId id="406" r:id="rId124"/>
    <p:sldId id="407" r:id="rId125"/>
    <p:sldId id="408" r:id="rId126"/>
    <p:sldId id="409" r:id="rId127"/>
    <p:sldId id="410" r:id="rId128"/>
    <p:sldId id="411" r:id="rId129"/>
    <p:sldId id="412" r:id="rId130"/>
    <p:sldId id="413" r:id="rId131"/>
    <p:sldId id="414" r:id="rId132"/>
    <p:sldId id="415" r:id="rId133"/>
    <p:sldId id="416" r:id="rId134"/>
    <p:sldId id="417" r:id="rId135"/>
    <p:sldId id="418" r:id="rId136"/>
    <p:sldId id="419" r:id="rId137"/>
    <p:sldId id="420" r:id="rId138"/>
    <p:sldId id="421" r:id="rId139"/>
    <p:sldId id="422" r:id="rId140"/>
    <p:sldId id="423" r:id="rId141"/>
    <p:sldId id="424" r:id="rId142"/>
    <p:sldId id="425" r:id="rId143"/>
    <p:sldId id="426" r:id="rId144"/>
    <p:sldId id="427" r:id="rId145"/>
    <p:sldId id="428" r:id="rId146"/>
    <p:sldId id="429" r:id="rId147"/>
    <p:sldId id="430" r:id="rId148"/>
    <p:sldId id="431" r:id="rId149"/>
    <p:sldId id="432" r:id="rId150"/>
    <p:sldId id="433" r:id="rId151"/>
    <p:sldId id="434" r:id="rId152"/>
    <p:sldId id="435" r:id="rId153"/>
    <p:sldId id="436" r:id="rId154"/>
    <p:sldId id="437" r:id="rId155"/>
    <p:sldId id="438" r:id="rId156"/>
    <p:sldId id="439" r:id="rId157"/>
    <p:sldId id="440" r:id="rId158"/>
    <p:sldId id="441" r:id="rId159"/>
    <p:sldId id="442" r:id="rId160"/>
    <p:sldId id="443" r:id="rId161"/>
    <p:sldId id="444" r:id="rId162"/>
    <p:sldId id="445" r:id="rId163"/>
    <p:sldId id="446" r:id="rId164"/>
    <p:sldId id="447" r:id="rId165"/>
    <p:sldId id="448" r:id="rId166"/>
    <p:sldId id="449" r:id="rId167"/>
    <p:sldId id="257" r:id="rId168"/>
    <p:sldId id="258" r:id="rId169"/>
    <p:sldId id="259" r:id="rId170"/>
    <p:sldId id="260" r:id="rId171"/>
    <p:sldId id="261" r:id="rId172"/>
    <p:sldId id="262" r:id="rId173"/>
    <p:sldId id="263" r:id="rId174"/>
    <p:sldId id="264" r:id="rId175"/>
    <p:sldId id="265" r:id="rId176"/>
    <p:sldId id="266" r:id="rId177"/>
    <p:sldId id="267" r:id="rId178"/>
    <p:sldId id="268" r:id="rId179"/>
    <p:sldId id="269" r:id="rId180"/>
    <p:sldId id="270" r:id="rId181"/>
    <p:sldId id="271" r:id="rId182"/>
    <p:sldId id="272" r:id="rId183"/>
    <p:sldId id="273" r:id="rId184"/>
    <p:sldId id="274" r:id="rId185"/>
    <p:sldId id="275" r:id="rId186"/>
    <p:sldId id="276" r:id="rId187"/>
    <p:sldId id="277" r:id="rId188"/>
    <p:sldId id="278" r:id="rId189"/>
    <p:sldId id="481" r:id="rId190"/>
    <p:sldId id="279" r:id="rId191"/>
    <p:sldId id="280" r:id="rId192"/>
    <p:sldId id="482" r:id="rId193"/>
    <p:sldId id="483" r:id="rId194"/>
    <p:sldId id="450" r:id="rId195"/>
    <p:sldId id="451" r:id="rId196"/>
    <p:sldId id="281" r:id="rId197"/>
    <p:sldId id="452" r:id="rId198"/>
    <p:sldId id="453" r:id="rId199"/>
    <p:sldId id="454" r:id="rId200"/>
    <p:sldId id="282" r:id="rId201"/>
    <p:sldId id="455" r:id="rId202"/>
    <p:sldId id="456" r:id="rId203"/>
    <p:sldId id="457" r:id="rId204"/>
    <p:sldId id="283" r:id="rId205"/>
    <p:sldId id="458" r:id="rId206"/>
    <p:sldId id="459" r:id="rId207"/>
    <p:sldId id="460" r:id="rId208"/>
    <p:sldId id="461" r:id="rId209"/>
    <p:sldId id="462" r:id="rId210"/>
    <p:sldId id="463" r:id="rId211"/>
    <p:sldId id="464" r:id="rId212"/>
    <p:sldId id="465" r:id="rId213"/>
    <p:sldId id="466" r:id="rId214"/>
    <p:sldId id="467" r:id="rId215"/>
    <p:sldId id="468" r:id="rId216"/>
    <p:sldId id="469" r:id="rId217"/>
    <p:sldId id="470" r:id="rId218"/>
    <p:sldId id="471" r:id="rId219"/>
    <p:sldId id="472" r:id="rId220"/>
    <p:sldId id="473" r:id="rId221"/>
    <p:sldId id="474" r:id="rId222"/>
    <p:sldId id="475" r:id="rId223"/>
    <p:sldId id="476" r:id="rId224"/>
    <p:sldId id="477" r:id="rId225"/>
    <p:sldId id="478" r:id="rId226"/>
    <p:sldId id="479" r:id="rId227"/>
    <p:sldId id="480" r:id="rId228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BB04EDD-A3E3-453A-B4B6-6AA1C24487B8}" v="770" dt="2022-08-24T04:26:25.05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1914" y="7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7" Type="http://schemas.openxmlformats.org/officeDocument/2006/relationships/slide" Target="slides/slide116.xml"/><Relationship Id="rId21" Type="http://schemas.openxmlformats.org/officeDocument/2006/relationships/slide" Target="slides/slide20.xml"/><Relationship Id="rId42" Type="http://schemas.openxmlformats.org/officeDocument/2006/relationships/slide" Target="slides/slide41.xml"/><Relationship Id="rId63" Type="http://schemas.openxmlformats.org/officeDocument/2006/relationships/slide" Target="slides/slide62.xml"/><Relationship Id="rId84" Type="http://schemas.openxmlformats.org/officeDocument/2006/relationships/slide" Target="slides/slide83.xml"/><Relationship Id="rId138" Type="http://schemas.openxmlformats.org/officeDocument/2006/relationships/slide" Target="slides/slide137.xml"/><Relationship Id="rId159" Type="http://schemas.openxmlformats.org/officeDocument/2006/relationships/slide" Target="slides/slide158.xml"/><Relationship Id="rId170" Type="http://schemas.openxmlformats.org/officeDocument/2006/relationships/slide" Target="slides/slide169.xml"/><Relationship Id="rId191" Type="http://schemas.openxmlformats.org/officeDocument/2006/relationships/slide" Target="slides/slide190.xml"/><Relationship Id="rId205" Type="http://schemas.openxmlformats.org/officeDocument/2006/relationships/slide" Target="slides/slide204.xml"/><Relationship Id="rId226" Type="http://schemas.openxmlformats.org/officeDocument/2006/relationships/slide" Target="slides/slide225.xml"/><Relationship Id="rId107" Type="http://schemas.openxmlformats.org/officeDocument/2006/relationships/slide" Target="slides/slide106.xml"/><Relationship Id="rId11" Type="http://schemas.openxmlformats.org/officeDocument/2006/relationships/slide" Target="slides/slide10.xml"/><Relationship Id="rId32" Type="http://schemas.openxmlformats.org/officeDocument/2006/relationships/slide" Target="slides/slide31.xml"/><Relationship Id="rId53" Type="http://schemas.openxmlformats.org/officeDocument/2006/relationships/slide" Target="slides/slide52.xml"/><Relationship Id="rId74" Type="http://schemas.openxmlformats.org/officeDocument/2006/relationships/slide" Target="slides/slide73.xml"/><Relationship Id="rId128" Type="http://schemas.openxmlformats.org/officeDocument/2006/relationships/slide" Target="slides/slide127.xml"/><Relationship Id="rId149" Type="http://schemas.openxmlformats.org/officeDocument/2006/relationships/slide" Target="slides/slide148.xml"/><Relationship Id="rId5" Type="http://schemas.openxmlformats.org/officeDocument/2006/relationships/slide" Target="slides/slide4.xml"/><Relationship Id="rId95" Type="http://schemas.openxmlformats.org/officeDocument/2006/relationships/slide" Target="slides/slide94.xml"/><Relationship Id="rId160" Type="http://schemas.openxmlformats.org/officeDocument/2006/relationships/slide" Target="slides/slide159.xml"/><Relationship Id="rId181" Type="http://schemas.openxmlformats.org/officeDocument/2006/relationships/slide" Target="slides/slide180.xml"/><Relationship Id="rId216" Type="http://schemas.openxmlformats.org/officeDocument/2006/relationships/slide" Target="slides/slide215.xml"/><Relationship Id="rId22" Type="http://schemas.openxmlformats.org/officeDocument/2006/relationships/slide" Target="slides/slide21.xml"/><Relationship Id="rId43" Type="http://schemas.openxmlformats.org/officeDocument/2006/relationships/slide" Target="slides/slide42.xml"/><Relationship Id="rId64" Type="http://schemas.openxmlformats.org/officeDocument/2006/relationships/slide" Target="slides/slide63.xml"/><Relationship Id="rId118" Type="http://schemas.openxmlformats.org/officeDocument/2006/relationships/slide" Target="slides/slide117.xml"/><Relationship Id="rId139" Type="http://schemas.openxmlformats.org/officeDocument/2006/relationships/slide" Target="slides/slide138.xml"/><Relationship Id="rId85" Type="http://schemas.openxmlformats.org/officeDocument/2006/relationships/slide" Target="slides/slide84.xml"/><Relationship Id="rId150" Type="http://schemas.openxmlformats.org/officeDocument/2006/relationships/slide" Target="slides/slide149.xml"/><Relationship Id="rId171" Type="http://schemas.openxmlformats.org/officeDocument/2006/relationships/slide" Target="slides/slide170.xml"/><Relationship Id="rId192" Type="http://schemas.openxmlformats.org/officeDocument/2006/relationships/slide" Target="slides/slide191.xml"/><Relationship Id="rId206" Type="http://schemas.openxmlformats.org/officeDocument/2006/relationships/slide" Target="slides/slide205.xml"/><Relationship Id="rId227" Type="http://schemas.openxmlformats.org/officeDocument/2006/relationships/slide" Target="slides/slide226.xml"/><Relationship Id="rId12" Type="http://schemas.openxmlformats.org/officeDocument/2006/relationships/slide" Target="slides/slide11.xml"/><Relationship Id="rId33" Type="http://schemas.openxmlformats.org/officeDocument/2006/relationships/slide" Target="slides/slide32.xml"/><Relationship Id="rId108" Type="http://schemas.openxmlformats.org/officeDocument/2006/relationships/slide" Target="slides/slide107.xml"/><Relationship Id="rId129" Type="http://schemas.openxmlformats.org/officeDocument/2006/relationships/slide" Target="slides/slide128.xml"/><Relationship Id="rId54" Type="http://schemas.openxmlformats.org/officeDocument/2006/relationships/slide" Target="slides/slide53.xml"/><Relationship Id="rId75" Type="http://schemas.openxmlformats.org/officeDocument/2006/relationships/slide" Target="slides/slide74.xml"/><Relationship Id="rId96" Type="http://schemas.openxmlformats.org/officeDocument/2006/relationships/slide" Target="slides/slide95.xml"/><Relationship Id="rId140" Type="http://schemas.openxmlformats.org/officeDocument/2006/relationships/slide" Target="slides/slide139.xml"/><Relationship Id="rId161" Type="http://schemas.openxmlformats.org/officeDocument/2006/relationships/slide" Target="slides/slide160.xml"/><Relationship Id="rId182" Type="http://schemas.openxmlformats.org/officeDocument/2006/relationships/slide" Target="slides/slide181.xml"/><Relationship Id="rId217" Type="http://schemas.openxmlformats.org/officeDocument/2006/relationships/slide" Target="slides/slide216.xml"/><Relationship Id="rId6" Type="http://schemas.openxmlformats.org/officeDocument/2006/relationships/slide" Target="slides/slide5.xml"/><Relationship Id="rId23" Type="http://schemas.openxmlformats.org/officeDocument/2006/relationships/slide" Target="slides/slide22.xml"/><Relationship Id="rId119" Type="http://schemas.openxmlformats.org/officeDocument/2006/relationships/slide" Target="slides/slide118.xml"/><Relationship Id="rId44" Type="http://schemas.openxmlformats.org/officeDocument/2006/relationships/slide" Target="slides/slide43.xml"/><Relationship Id="rId65" Type="http://schemas.openxmlformats.org/officeDocument/2006/relationships/slide" Target="slides/slide64.xml"/><Relationship Id="rId86" Type="http://schemas.openxmlformats.org/officeDocument/2006/relationships/slide" Target="slides/slide85.xml"/><Relationship Id="rId130" Type="http://schemas.openxmlformats.org/officeDocument/2006/relationships/slide" Target="slides/slide129.xml"/><Relationship Id="rId151" Type="http://schemas.openxmlformats.org/officeDocument/2006/relationships/slide" Target="slides/slide150.xml"/><Relationship Id="rId172" Type="http://schemas.openxmlformats.org/officeDocument/2006/relationships/slide" Target="slides/slide171.xml"/><Relationship Id="rId193" Type="http://schemas.openxmlformats.org/officeDocument/2006/relationships/slide" Target="slides/slide192.xml"/><Relationship Id="rId207" Type="http://schemas.openxmlformats.org/officeDocument/2006/relationships/slide" Target="slides/slide206.xml"/><Relationship Id="rId228" Type="http://schemas.openxmlformats.org/officeDocument/2006/relationships/slide" Target="slides/slide227.xml"/><Relationship Id="rId13" Type="http://schemas.openxmlformats.org/officeDocument/2006/relationships/slide" Target="slides/slide12.xml"/><Relationship Id="rId109" Type="http://schemas.openxmlformats.org/officeDocument/2006/relationships/slide" Target="slides/slide108.xml"/><Relationship Id="rId34" Type="http://schemas.openxmlformats.org/officeDocument/2006/relationships/slide" Target="slides/slide33.xml"/><Relationship Id="rId55" Type="http://schemas.openxmlformats.org/officeDocument/2006/relationships/slide" Target="slides/slide54.xml"/><Relationship Id="rId76" Type="http://schemas.openxmlformats.org/officeDocument/2006/relationships/slide" Target="slides/slide75.xml"/><Relationship Id="rId97" Type="http://schemas.openxmlformats.org/officeDocument/2006/relationships/slide" Target="slides/slide96.xml"/><Relationship Id="rId120" Type="http://schemas.openxmlformats.org/officeDocument/2006/relationships/slide" Target="slides/slide119.xml"/><Relationship Id="rId141" Type="http://schemas.openxmlformats.org/officeDocument/2006/relationships/slide" Target="slides/slide140.xml"/><Relationship Id="rId7" Type="http://schemas.openxmlformats.org/officeDocument/2006/relationships/slide" Target="slides/slide6.xml"/><Relationship Id="rId162" Type="http://schemas.openxmlformats.org/officeDocument/2006/relationships/slide" Target="slides/slide161.xml"/><Relationship Id="rId183" Type="http://schemas.openxmlformats.org/officeDocument/2006/relationships/slide" Target="slides/slide182.xml"/><Relationship Id="rId218" Type="http://schemas.openxmlformats.org/officeDocument/2006/relationships/slide" Target="slides/slide217.xml"/><Relationship Id="rId24" Type="http://schemas.openxmlformats.org/officeDocument/2006/relationships/slide" Target="slides/slide23.xml"/><Relationship Id="rId45" Type="http://schemas.openxmlformats.org/officeDocument/2006/relationships/slide" Target="slides/slide44.xml"/><Relationship Id="rId66" Type="http://schemas.openxmlformats.org/officeDocument/2006/relationships/slide" Target="slides/slide65.xml"/><Relationship Id="rId87" Type="http://schemas.openxmlformats.org/officeDocument/2006/relationships/slide" Target="slides/slide86.xml"/><Relationship Id="rId110" Type="http://schemas.openxmlformats.org/officeDocument/2006/relationships/slide" Target="slides/slide109.xml"/><Relationship Id="rId131" Type="http://schemas.openxmlformats.org/officeDocument/2006/relationships/slide" Target="slides/slide130.xml"/><Relationship Id="rId152" Type="http://schemas.openxmlformats.org/officeDocument/2006/relationships/slide" Target="slides/slide151.xml"/><Relationship Id="rId173" Type="http://schemas.openxmlformats.org/officeDocument/2006/relationships/slide" Target="slides/slide172.xml"/><Relationship Id="rId194" Type="http://schemas.openxmlformats.org/officeDocument/2006/relationships/slide" Target="slides/slide193.xml"/><Relationship Id="rId208" Type="http://schemas.openxmlformats.org/officeDocument/2006/relationships/slide" Target="slides/slide207.xml"/><Relationship Id="rId229" Type="http://schemas.openxmlformats.org/officeDocument/2006/relationships/presProps" Target="presProps.xml"/><Relationship Id="rId14" Type="http://schemas.openxmlformats.org/officeDocument/2006/relationships/slide" Target="slides/slide13.xml"/><Relationship Id="rId35" Type="http://schemas.openxmlformats.org/officeDocument/2006/relationships/slide" Target="slides/slide34.xml"/><Relationship Id="rId56" Type="http://schemas.openxmlformats.org/officeDocument/2006/relationships/slide" Target="slides/slide55.xml"/><Relationship Id="rId77" Type="http://schemas.openxmlformats.org/officeDocument/2006/relationships/slide" Target="slides/slide76.xml"/><Relationship Id="rId100" Type="http://schemas.openxmlformats.org/officeDocument/2006/relationships/slide" Target="slides/slide99.xml"/><Relationship Id="rId8" Type="http://schemas.openxmlformats.org/officeDocument/2006/relationships/slide" Target="slides/slide7.xml"/><Relationship Id="rId98" Type="http://schemas.openxmlformats.org/officeDocument/2006/relationships/slide" Target="slides/slide97.xml"/><Relationship Id="rId121" Type="http://schemas.openxmlformats.org/officeDocument/2006/relationships/slide" Target="slides/slide120.xml"/><Relationship Id="rId142" Type="http://schemas.openxmlformats.org/officeDocument/2006/relationships/slide" Target="slides/slide141.xml"/><Relationship Id="rId163" Type="http://schemas.openxmlformats.org/officeDocument/2006/relationships/slide" Target="slides/slide162.xml"/><Relationship Id="rId184" Type="http://schemas.openxmlformats.org/officeDocument/2006/relationships/slide" Target="slides/slide183.xml"/><Relationship Id="rId219" Type="http://schemas.openxmlformats.org/officeDocument/2006/relationships/slide" Target="slides/slide218.xml"/><Relationship Id="rId230" Type="http://schemas.openxmlformats.org/officeDocument/2006/relationships/viewProps" Target="viewProps.xml"/><Relationship Id="rId25" Type="http://schemas.openxmlformats.org/officeDocument/2006/relationships/slide" Target="slides/slide24.xml"/><Relationship Id="rId46" Type="http://schemas.openxmlformats.org/officeDocument/2006/relationships/slide" Target="slides/slide45.xml"/><Relationship Id="rId67" Type="http://schemas.openxmlformats.org/officeDocument/2006/relationships/slide" Target="slides/slide66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62" Type="http://schemas.openxmlformats.org/officeDocument/2006/relationships/slide" Target="slides/slide61.xml"/><Relationship Id="rId83" Type="http://schemas.openxmlformats.org/officeDocument/2006/relationships/slide" Target="slides/slide82.xml"/><Relationship Id="rId88" Type="http://schemas.openxmlformats.org/officeDocument/2006/relationships/slide" Target="slides/slide87.xml"/><Relationship Id="rId111" Type="http://schemas.openxmlformats.org/officeDocument/2006/relationships/slide" Target="slides/slide110.xml"/><Relationship Id="rId132" Type="http://schemas.openxmlformats.org/officeDocument/2006/relationships/slide" Target="slides/slide131.xml"/><Relationship Id="rId153" Type="http://schemas.openxmlformats.org/officeDocument/2006/relationships/slide" Target="slides/slide152.xml"/><Relationship Id="rId174" Type="http://schemas.openxmlformats.org/officeDocument/2006/relationships/slide" Target="slides/slide173.xml"/><Relationship Id="rId179" Type="http://schemas.openxmlformats.org/officeDocument/2006/relationships/slide" Target="slides/slide178.xml"/><Relationship Id="rId195" Type="http://schemas.openxmlformats.org/officeDocument/2006/relationships/slide" Target="slides/slide194.xml"/><Relationship Id="rId209" Type="http://schemas.openxmlformats.org/officeDocument/2006/relationships/slide" Target="slides/slide208.xml"/><Relationship Id="rId190" Type="http://schemas.openxmlformats.org/officeDocument/2006/relationships/slide" Target="slides/slide189.xml"/><Relationship Id="rId204" Type="http://schemas.openxmlformats.org/officeDocument/2006/relationships/slide" Target="slides/slide203.xml"/><Relationship Id="rId220" Type="http://schemas.openxmlformats.org/officeDocument/2006/relationships/slide" Target="slides/slide219.xml"/><Relationship Id="rId225" Type="http://schemas.openxmlformats.org/officeDocument/2006/relationships/slide" Target="slides/slide224.xml"/><Relationship Id="rId15" Type="http://schemas.openxmlformats.org/officeDocument/2006/relationships/slide" Target="slides/slide14.xml"/><Relationship Id="rId36" Type="http://schemas.openxmlformats.org/officeDocument/2006/relationships/slide" Target="slides/slide35.xml"/><Relationship Id="rId57" Type="http://schemas.openxmlformats.org/officeDocument/2006/relationships/slide" Target="slides/slide56.xml"/><Relationship Id="rId106" Type="http://schemas.openxmlformats.org/officeDocument/2006/relationships/slide" Target="slides/slide105.xml"/><Relationship Id="rId127" Type="http://schemas.openxmlformats.org/officeDocument/2006/relationships/slide" Target="slides/slide126.xml"/><Relationship Id="rId10" Type="http://schemas.openxmlformats.org/officeDocument/2006/relationships/slide" Target="slides/slide9.xml"/><Relationship Id="rId31" Type="http://schemas.openxmlformats.org/officeDocument/2006/relationships/slide" Target="slides/slide30.xml"/><Relationship Id="rId52" Type="http://schemas.openxmlformats.org/officeDocument/2006/relationships/slide" Target="slides/slide51.xml"/><Relationship Id="rId73" Type="http://schemas.openxmlformats.org/officeDocument/2006/relationships/slide" Target="slides/slide72.xml"/><Relationship Id="rId78" Type="http://schemas.openxmlformats.org/officeDocument/2006/relationships/slide" Target="slides/slide77.xml"/><Relationship Id="rId94" Type="http://schemas.openxmlformats.org/officeDocument/2006/relationships/slide" Target="slides/slide93.xml"/><Relationship Id="rId99" Type="http://schemas.openxmlformats.org/officeDocument/2006/relationships/slide" Target="slides/slide98.xml"/><Relationship Id="rId101" Type="http://schemas.openxmlformats.org/officeDocument/2006/relationships/slide" Target="slides/slide100.xml"/><Relationship Id="rId122" Type="http://schemas.openxmlformats.org/officeDocument/2006/relationships/slide" Target="slides/slide121.xml"/><Relationship Id="rId143" Type="http://schemas.openxmlformats.org/officeDocument/2006/relationships/slide" Target="slides/slide142.xml"/><Relationship Id="rId148" Type="http://schemas.openxmlformats.org/officeDocument/2006/relationships/slide" Target="slides/slide147.xml"/><Relationship Id="rId164" Type="http://schemas.openxmlformats.org/officeDocument/2006/relationships/slide" Target="slides/slide163.xml"/><Relationship Id="rId169" Type="http://schemas.openxmlformats.org/officeDocument/2006/relationships/slide" Target="slides/slide168.xml"/><Relationship Id="rId185" Type="http://schemas.openxmlformats.org/officeDocument/2006/relationships/slide" Target="slides/slide184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80" Type="http://schemas.openxmlformats.org/officeDocument/2006/relationships/slide" Target="slides/slide179.xml"/><Relationship Id="rId210" Type="http://schemas.openxmlformats.org/officeDocument/2006/relationships/slide" Target="slides/slide209.xml"/><Relationship Id="rId215" Type="http://schemas.openxmlformats.org/officeDocument/2006/relationships/slide" Target="slides/slide214.xml"/><Relationship Id="rId26" Type="http://schemas.openxmlformats.org/officeDocument/2006/relationships/slide" Target="slides/slide25.xml"/><Relationship Id="rId231" Type="http://schemas.openxmlformats.org/officeDocument/2006/relationships/theme" Target="theme/theme1.xml"/><Relationship Id="rId47" Type="http://schemas.openxmlformats.org/officeDocument/2006/relationships/slide" Target="slides/slide46.xml"/><Relationship Id="rId68" Type="http://schemas.openxmlformats.org/officeDocument/2006/relationships/slide" Target="slides/slide67.xml"/><Relationship Id="rId89" Type="http://schemas.openxmlformats.org/officeDocument/2006/relationships/slide" Target="slides/slide88.xml"/><Relationship Id="rId112" Type="http://schemas.openxmlformats.org/officeDocument/2006/relationships/slide" Target="slides/slide111.xml"/><Relationship Id="rId133" Type="http://schemas.openxmlformats.org/officeDocument/2006/relationships/slide" Target="slides/slide132.xml"/><Relationship Id="rId154" Type="http://schemas.openxmlformats.org/officeDocument/2006/relationships/slide" Target="slides/slide153.xml"/><Relationship Id="rId175" Type="http://schemas.openxmlformats.org/officeDocument/2006/relationships/slide" Target="slides/slide174.xml"/><Relationship Id="rId196" Type="http://schemas.openxmlformats.org/officeDocument/2006/relationships/slide" Target="slides/slide195.xml"/><Relationship Id="rId200" Type="http://schemas.openxmlformats.org/officeDocument/2006/relationships/slide" Target="slides/slide199.xml"/><Relationship Id="rId16" Type="http://schemas.openxmlformats.org/officeDocument/2006/relationships/slide" Target="slides/slide15.xml"/><Relationship Id="rId221" Type="http://schemas.openxmlformats.org/officeDocument/2006/relationships/slide" Target="slides/slide220.xml"/><Relationship Id="rId37" Type="http://schemas.openxmlformats.org/officeDocument/2006/relationships/slide" Target="slides/slide36.xml"/><Relationship Id="rId58" Type="http://schemas.openxmlformats.org/officeDocument/2006/relationships/slide" Target="slides/slide57.xml"/><Relationship Id="rId79" Type="http://schemas.openxmlformats.org/officeDocument/2006/relationships/slide" Target="slides/slide78.xml"/><Relationship Id="rId102" Type="http://schemas.openxmlformats.org/officeDocument/2006/relationships/slide" Target="slides/slide101.xml"/><Relationship Id="rId123" Type="http://schemas.openxmlformats.org/officeDocument/2006/relationships/slide" Target="slides/slide122.xml"/><Relationship Id="rId144" Type="http://schemas.openxmlformats.org/officeDocument/2006/relationships/slide" Target="slides/slide143.xml"/><Relationship Id="rId90" Type="http://schemas.openxmlformats.org/officeDocument/2006/relationships/slide" Target="slides/slide89.xml"/><Relationship Id="rId165" Type="http://schemas.openxmlformats.org/officeDocument/2006/relationships/slide" Target="slides/slide164.xml"/><Relationship Id="rId186" Type="http://schemas.openxmlformats.org/officeDocument/2006/relationships/slide" Target="slides/slide185.xml"/><Relationship Id="rId211" Type="http://schemas.openxmlformats.org/officeDocument/2006/relationships/slide" Target="slides/slide210.xml"/><Relationship Id="rId232" Type="http://schemas.openxmlformats.org/officeDocument/2006/relationships/tableStyles" Target="tableStyles.xml"/><Relationship Id="rId27" Type="http://schemas.openxmlformats.org/officeDocument/2006/relationships/slide" Target="slides/slide26.xml"/><Relationship Id="rId48" Type="http://schemas.openxmlformats.org/officeDocument/2006/relationships/slide" Target="slides/slide47.xml"/><Relationship Id="rId69" Type="http://schemas.openxmlformats.org/officeDocument/2006/relationships/slide" Target="slides/slide68.xml"/><Relationship Id="rId113" Type="http://schemas.openxmlformats.org/officeDocument/2006/relationships/slide" Target="slides/slide112.xml"/><Relationship Id="rId134" Type="http://schemas.openxmlformats.org/officeDocument/2006/relationships/slide" Target="slides/slide133.xml"/><Relationship Id="rId80" Type="http://schemas.openxmlformats.org/officeDocument/2006/relationships/slide" Target="slides/slide79.xml"/><Relationship Id="rId155" Type="http://schemas.openxmlformats.org/officeDocument/2006/relationships/slide" Target="slides/slide154.xml"/><Relationship Id="rId176" Type="http://schemas.openxmlformats.org/officeDocument/2006/relationships/slide" Target="slides/slide175.xml"/><Relationship Id="rId197" Type="http://schemas.openxmlformats.org/officeDocument/2006/relationships/slide" Target="slides/slide196.xml"/><Relationship Id="rId201" Type="http://schemas.openxmlformats.org/officeDocument/2006/relationships/slide" Target="slides/slide200.xml"/><Relationship Id="rId222" Type="http://schemas.openxmlformats.org/officeDocument/2006/relationships/slide" Target="slides/slide221.xml"/><Relationship Id="rId17" Type="http://schemas.openxmlformats.org/officeDocument/2006/relationships/slide" Target="slides/slide16.xml"/><Relationship Id="rId38" Type="http://schemas.openxmlformats.org/officeDocument/2006/relationships/slide" Target="slides/slide37.xml"/><Relationship Id="rId59" Type="http://schemas.openxmlformats.org/officeDocument/2006/relationships/slide" Target="slides/slide58.xml"/><Relationship Id="rId103" Type="http://schemas.openxmlformats.org/officeDocument/2006/relationships/slide" Target="slides/slide102.xml"/><Relationship Id="rId124" Type="http://schemas.openxmlformats.org/officeDocument/2006/relationships/slide" Target="slides/slide123.xml"/><Relationship Id="rId70" Type="http://schemas.openxmlformats.org/officeDocument/2006/relationships/slide" Target="slides/slide69.xml"/><Relationship Id="rId91" Type="http://schemas.openxmlformats.org/officeDocument/2006/relationships/slide" Target="slides/slide90.xml"/><Relationship Id="rId145" Type="http://schemas.openxmlformats.org/officeDocument/2006/relationships/slide" Target="slides/slide144.xml"/><Relationship Id="rId166" Type="http://schemas.openxmlformats.org/officeDocument/2006/relationships/slide" Target="slides/slide165.xml"/><Relationship Id="rId187" Type="http://schemas.openxmlformats.org/officeDocument/2006/relationships/slide" Target="slides/slide186.xml"/><Relationship Id="rId1" Type="http://schemas.openxmlformats.org/officeDocument/2006/relationships/slideMaster" Target="slideMasters/slideMaster1.xml"/><Relationship Id="rId212" Type="http://schemas.openxmlformats.org/officeDocument/2006/relationships/slide" Target="slides/slide211.xml"/><Relationship Id="rId233" Type="http://schemas.microsoft.com/office/2016/11/relationships/changesInfo" Target="changesInfos/changesInfo1.xml"/><Relationship Id="rId28" Type="http://schemas.openxmlformats.org/officeDocument/2006/relationships/slide" Target="slides/slide27.xml"/><Relationship Id="rId49" Type="http://schemas.openxmlformats.org/officeDocument/2006/relationships/slide" Target="slides/slide48.xml"/><Relationship Id="rId114" Type="http://schemas.openxmlformats.org/officeDocument/2006/relationships/slide" Target="slides/slide113.xml"/><Relationship Id="rId60" Type="http://schemas.openxmlformats.org/officeDocument/2006/relationships/slide" Target="slides/slide59.xml"/><Relationship Id="rId81" Type="http://schemas.openxmlformats.org/officeDocument/2006/relationships/slide" Target="slides/slide80.xml"/><Relationship Id="rId135" Type="http://schemas.openxmlformats.org/officeDocument/2006/relationships/slide" Target="slides/slide134.xml"/><Relationship Id="rId156" Type="http://schemas.openxmlformats.org/officeDocument/2006/relationships/slide" Target="slides/slide155.xml"/><Relationship Id="rId177" Type="http://schemas.openxmlformats.org/officeDocument/2006/relationships/slide" Target="slides/slide176.xml"/><Relationship Id="rId198" Type="http://schemas.openxmlformats.org/officeDocument/2006/relationships/slide" Target="slides/slide197.xml"/><Relationship Id="rId202" Type="http://schemas.openxmlformats.org/officeDocument/2006/relationships/slide" Target="slides/slide201.xml"/><Relationship Id="rId223" Type="http://schemas.openxmlformats.org/officeDocument/2006/relationships/slide" Target="slides/slide222.xml"/><Relationship Id="rId18" Type="http://schemas.openxmlformats.org/officeDocument/2006/relationships/slide" Target="slides/slide17.xml"/><Relationship Id="rId39" Type="http://schemas.openxmlformats.org/officeDocument/2006/relationships/slide" Target="slides/slide38.xml"/><Relationship Id="rId50" Type="http://schemas.openxmlformats.org/officeDocument/2006/relationships/slide" Target="slides/slide49.xml"/><Relationship Id="rId104" Type="http://schemas.openxmlformats.org/officeDocument/2006/relationships/slide" Target="slides/slide103.xml"/><Relationship Id="rId125" Type="http://schemas.openxmlformats.org/officeDocument/2006/relationships/slide" Target="slides/slide124.xml"/><Relationship Id="rId146" Type="http://schemas.openxmlformats.org/officeDocument/2006/relationships/slide" Target="slides/slide145.xml"/><Relationship Id="rId167" Type="http://schemas.openxmlformats.org/officeDocument/2006/relationships/slide" Target="slides/slide166.xml"/><Relationship Id="rId188" Type="http://schemas.openxmlformats.org/officeDocument/2006/relationships/slide" Target="slides/slide187.xml"/><Relationship Id="rId71" Type="http://schemas.openxmlformats.org/officeDocument/2006/relationships/slide" Target="slides/slide70.xml"/><Relationship Id="rId92" Type="http://schemas.openxmlformats.org/officeDocument/2006/relationships/slide" Target="slides/slide91.xml"/><Relationship Id="rId213" Type="http://schemas.openxmlformats.org/officeDocument/2006/relationships/slide" Target="slides/slide212.xml"/><Relationship Id="rId234" Type="http://schemas.microsoft.com/office/2015/10/relationships/revisionInfo" Target="revisionInfo.xml"/><Relationship Id="rId2" Type="http://schemas.openxmlformats.org/officeDocument/2006/relationships/slide" Target="slides/slide1.xml"/><Relationship Id="rId29" Type="http://schemas.openxmlformats.org/officeDocument/2006/relationships/slide" Target="slides/slide28.xml"/><Relationship Id="rId40" Type="http://schemas.openxmlformats.org/officeDocument/2006/relationships/slide" Target="slides/slide39.xml"/><Relationship Id="rId115" Type="http://schemas.openxmlformats.org/officeDocument/2006/relationships/slide" Target="slides/slide114.xml"/><Relationship Id="rId136" Type="http://schemas.openxmlformats.org/officeDocument/2006/relationships/slide" Target="slides/slide135.xml"/><Relationship Id="rId157" Type="http://schemas.openxmlformats.org/officeDocument/2006/relationships/slide" Target="slides/slide156.xml"/><Relationship Id="rId178" Type="http://schemas.openxmlformats.org/officeDocument/2006/relationships/slide" Target="slides/slide177.xml"/><Relationship Id="rId61" Type="http://schemas.openxmlformats.org/officeDocument/2006/relationships/slide" Target="slides/slide60.xml"/><Relationship Id="rId82" Type="http://schemas.openxmlformats.org/officeDocument/2006/relationships/slide" Target="slides/slide81.xml"/><Relationship Id="rId199" Type="http://schemas.openxmlformats.org/officeDocument/2006/relationships/slide" Target="slides/slide198.xml"/><Relationship Id="rId203" Type="http://schemas.openxmlformats.org/officeDocument/2006/relationships/slide" Target="slides/slide202.xml"/><Relationship Id="rId19" Type="http://schemas.openxmlformats.org/officeDocument/2006/relationships/slide" Target="slides/slide18.xml"/><Relationship Id="rId224" Type="http://schemas.openxmlformats.org/officeDocument/2006/relationships/slide" Target="slides/slide223.xml"/><Relationship Id="rId30" Type="http://schemas.openxmlformats.org/officeDocument/2006/relationships/slide" Target="slides/slide29.xml"/><Relationship Id="rId105" Type="http://schemas.openxmlformats.org/officeDocument/2006/relationships/slide" Target="slides/slide104.xml"/><Relationship Id="rId126" Type="http://schemas.openxmlformats.org/officeDocument/2006/relationships/slide" Target="slides/slide125.xml"/><Relationship Id="rId147" Type="http://schemas.openxmlformats.org/officeDocument/2006/relationships/slide" Target="slides/slide146.xml"/><Relationship Id="rId168" Type="http://schemas.openxmlformats.org/officeDocument/2006/relationships/slide" Target="slides/slide167.xml"/><Relationship Id="rId51" Type="http://schemas.openxmlformats.org/officeDocument/2006/relationships/slide" Target="slides/slide50.xml"/><Relationship Id="rId72" Type="http://schemas.openxmlformats.org/officeDocument/2006/relationships/slide" Target="slides/slide71.xml"/><Relationship Id="rId93" Type="http://schemas.openxmlformats.org/officeDocument/2006/relationships/slide" Target="slides/slide92.xml"/><Relationship Id="rId189" Type="http://schemas.openxmlformats.org/officeDocument/2006/relationships/slide" Target="slides/slide188.xml"/><Relationship Id="rId3" Type="http://schemas.openxmlformats.org/officeDocument/2006/relationships/slide" Target="slides/slide2.xml"/><Relationship Id="rId214" Type="http://schemas.openxmlformats.org/officeDocument/2006/relationships/slide" Target="slides/slide213.xml"/><Relationship Id="rId116" Type="http://schemas.openxmlformats.org/officeDocument/2006/relationships/slide" Target="slides/slide115.xml"/><Relationship Id="rId137" Type="http://schemas.openxmlformats.org/officeDocument/2006/relationships/slide" Target="slides/slide136.xml"/><Relationship Id="rId158" Type="http://schemas.openxmlformats.org/officeDocument/2006/relationships/slide" Target="slides/slide157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ygisiz, Kübra" userId="4bfbf330-8776-4086-a830-2184b07ba8db" providerId="ADAL" clId="{1BB04EDD-A3E3-453A-B4B6-6AA1C24487B8}"/>
    <pc:docChg chg="custSel modSld">
      <pc:chgData name="Kaygisiz, Kübra" userId="4bfbf330-8776-4086-a830-2184b07ba8db" providerId="ADAL" clId="{1BB04EDD-A3E3-453A-B4B6-6AA1C24487B8}" dt="2022-08-24T05:17:52.948" v="843" actId="1076"/>
      <pc:docMkLst>
        <pc:docMk/>
      </pc:docMkLst>
      <pc:sldChg chg="modSp">
        <pc:chgData name="Kaygisiz, Kübra" userId="4bfbf330-8776-4086-a830-2184b07ba8db" providerId="ADAL" clId="{1BB04EDD-A3E3-453A-B4B6-6AA1C24487B8}" dt="2022-08-23T12:19:19.218" v="606"/>
        <pc:sldMkLst>
          <pc:docMk/>
          <pc:sldMk cId="3709697322" sldId="257"/>
        </pc:sldMkLst>
        <pc:graphicFrameChg chg="mod">
          <ac:chgData name="Kaygisiz, Kübra" userId="4bfbf330-8776-4086-a830-2184b07ba8db" providerId="ADAL" clId="{1BB04EDD-A3E3-453A-B4B6-6AA1C24487B8}" dt="2022-08-23T12:19:14.969" v="603"/>
          <ac:graphicFrameMkLst>
            <pc:docMk/>
            <pc:sldMk cId="3709697322" sldId="257"/>
            <ac:graphicFrameMk id="5" creationId="{9598A848-6988-DFBC-6317-EF5FC0B056AD}"/>
          </ac:graphicFrameMkLst>
        </pc:graphicFrameChg>
        <pc:graphicFrameChg chg="mod">
          <ac:chgData name="Kaygisiz, Kübra" userId="4bfbf330-8776-4086-a830-2184b07ba8db" providerId="ADAL" clId="{1BB04EDD-A3E3-453A-B4B6-6AA1C24487B8}" dt="2022-08-23T12:19:19.218" v="606"/>
          <ac:graphicFrameMkLst>
            <pc:docMk/>
            <pc:sldMk cId="3709697322" sldId="257"/>
            <ac:graphicFrameMk id="6" creationId="{856BF660-8C66-F835-CC5A-AB4AC80A3C7D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9:29.445" v="612"/>
        <pc:sldMkLst>
          <pc:docMk/>
          <pc:sldMk cId="3448490834" sldId="258"/>
        </pc:sldMkLst>
        <pc:graphicFrameChg chg="mod">
          <ac:chgData name="Kaygisiz, Kübra" userId="4bfbf330-8776-4086-a830-2184b07ba8db" providerId="ADAL" clId="{1BB04EDD-A3E3-453A-B4B6-6AA1C24487B8}" dt="2022-08-23T12:19:25.387" v="609"/>
          <ac:graphicFrameMkLst>
            <pc:docMk/>
            <pc:sldMk cId="3448490834" sldId="258"/>
            <ac:graphicFrameMk id="3" creationId="{9C2AD32A-2B87-78AD-C822-3CF649D4C623}"/>
          </ac:graphicFrameMkLst>
        </pc:graphicFrameChg>
        <pc:graphicFrameChg chg="mod">
          <ac:chgData name="Kaygisiz, Kübra" userId="4bfbf330-8776-4086-a830-2184b07ba8db" providerId="ADAL" clId="{1BB04EDD-A3E3-453A-B4B6-6AA1C24487B8}" dt="2022-08-23T12:19:29.445" v="612"/>
          <ac:graphicFrameMkLst>
            <pc:docMk/>
            <pc:sldMk cId="3448490834" sldId="258"/>
            <ac:graphicFrameMk id="5" creationId="{9D144CA1-CBDE-5053-25C2-6EBC7ABAE7D7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9:36.111" v="615"/>
        <pc:sldMkLst>
          <pc:docMk/>
          <pc:sldMk cId="4170109118" sldId="259"/>
        </pc:sldMkLst>
        <pc:graphicFrameChg chg="mod">
          <ac:chgData name="Kaygisiz, Kübra" userId="4bfbf330-8776-4086-a830-2184b07ba8db" providerId="ADAL" clId="{1BB04EDD-A3E3-453A-B4B6-6AA1C24487B8}" dt="2022-08-23T12:19:36.111" v="615"/>
          <ac:graphicFrameMkLst>
            <pc:docMk/>
            <pc:sldMk cId="4170109118" sldId="259"/>
            <ac:graphicFrameMk id="3" creationId="{012EBF41-B7D4-9D2C-4A45-329EEA3CC952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9:46.088" v="621"/>
        <pc:sldMkLst>
          <pc:docMk/>
          <pc:sldMk cId="1431922808" sldId="260"/>
        </pc:sldMkLst>
        <pc:graphicFrameChg chg="mod">
          <ac:chgData name="Kaygisiz, Kübra" userId="4bfbf330-8776-4086-a830-2184b07ba8db" providerId="ADAL" clId="{1BB04EDD-A3E3-453A-B4B6-6AA1C24487B8}" dt="2022-08-23T12:19:41.485" v="618"/>
          <ac:graphicFrameMkLst>
            <pc:docMk/>
            <pc:sldMk cId="1431922808" sldId="260"/>
            <ac:graphicFrameMk id="3" creationId="{5781A883-D93D-D814-CBAC-2B920ADF72D0}"/>
          </ac:graphicFrameMkLst>
        </pc:graphicFrameChg>
        <pc:graphicFrameChg chg="mod">
          <ac:chgData name="Kaygisiz, Kübra" userId="4bfbf330-8776-4086-a830-2184b07ba8db" providerId="ADAL" clId="{1BB04EDD-A3E3-453A-B4B6-6AA1C24487B8}" dt="2022-08-23T12:19:46.088" v="621"/>
          <ac:graphicFrameMkLst>
            <pc:docMk/>
            <pc:sldMk cId="1431922808" sldId="260"/>
            <ac:graphicFrameMk id="5" creationId="{C854EF07-69E9-5204-C931-0DA1C45B1BD2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9:58.701" v="627"/>
        <pc:sldMkLst>
          <pc:docMk/>
          <pc:sldMk cId="3658403204" sldId="261"/>
        </pc:sldMkLst>
        <pc:graphicFrameChg chg="mod">
          <ac:chgData name="Kaygisiz, Kübra" userId="4bfbf330-8776-4086-a830-2184b07ba8db" providerId="ADAL" clId="{1BB04EDD-A3E3-453A-B4B6-6AA1C24487B8}" dt="2022-08-23T12:19:58.701" v="627"/>
          <ac:graphicFrameMkLst>
            <pc:docMk/>
            <pc:sldMk cId="3658403204" sldId="261"/>
            <ac:graphicFrameMk id="5" creationId="{CE39D2A4-C425-470D-070C-1DB7B4580FEF}"/>
          </ac:graphicFrameMkLst>
        </pc:graphicFrameChg>
        <pc:graphicFrameChg chg="mod">
          <ac:chgData name="Kaygisiz, Kübra" userId="4bfbf330-8776-4086-a830-2184b07ba8db" providerId="ADAL" clId="{1BB04EDD-A3E3-453A-B4B6-6AA1C24487B8}" dt="2022-08-23T12:19:53.171" v="624"/>
          <ac:graphicFrameMkLst>
            <pc:docMk/>
            <pc:sldMk cId="3658403204" sldId="261"/>
            <ac:graphicFrameMk id="6" creationId="{8CB58870-95FA-CF82-EAFA-8AC9FF9A9F4F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20:08.149" v="633"/>
        <pc:sldMkLst>
          <pc:docMk/>
          <pc:sldMk cId="2878210316" sldId="262"/>
        </pc:sldMkLst>
        <pc:graphicFrameChg chg="mod">
          <ac:chgData name="Kaygisiz, Kübra" userId="4bfbf330-8776-4086-a830-2184b07ba8db" providerId="ADAL" clId="{1BB04EDD-A3E3-453A-B4B6-6AA1C24487B8}" dt="2022-08-23T12:20:03.328" v="630"/>
          <ac:graphicFrameMkLst>
            <pc:docMk/>
            <pc:sldMk cId="2878210316" sldId="262"/>
            <ac:graphicFrameMk id="3" creationId="{F870D1C8-184E-6001-7338-BA0399938D02}"/>
          </ac:graphicFrameMkLst>
        </pc:graphicFrameChg>
        <pc:graphicFrameChg chg="mod">
          <ac:chgData name="Kaygisiz, Kübra" userId="4bfbf330-8776-4086-a830-2184b07ba8db" providerId="ADAL" clId="{1BB04EDD-A3E3-453A-B4B6-6AA1C24487B8}" dt="2022-08-23T12:20:08.149" v="633"/>
          <ac:graphicFrameMkLst>
            <pc:docMk/>
            <pc:sldMk cId="2878210316" sldId="262"/>
            <ac:graphicFrameMk id="5" creationId="{4F08B011-A543-C786-B2BE-96BE967B524D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20:17.889" v="639"/>
        <pc:sldMkLst>
          <pc:docMk/>
          <pc:sldMk cId="104774107" sldId="263"/>
        </pc:sldMkLst>
        <pc:graphicFrameChg chg="mod">
          <ac:chgData name="Kaygisiz, Kübra" userId="4bfbf330-8776-4086-a830-2184b07ba8db" providerId="ADAL" clId="{1BB04EDD-A3E3-453A-B4B6-6AA1C24487B8}" dt="2022-08-23T12:20:13.613" v="636"/>
          <ac:graphicFrameMkLst>
            <pc:docMk/>
            <pc:sldMk cId="104774107" sldId="263"/>
            <ac:graphicFrameMk id="3" creationId="{CFB50CA3-FD73-6A78-B319-17AD4B1E708C}"/>
          </ac:graphicFrameMkLst>
        </pc:graphicFrameChg>
        <pc:graphicFrameChg chg="mod">
          <ac:chgData name="Kaygisiz, Kübra" userId="4bfbf330-8776-4086-a830-2184b07ba8db" providerId="ADAL" clId="{1BB04EDD-A3E3-453A-B4B6-6AA1C24487B8}" dt="2022-08-23T12:20:17.889" v="639"/>
          <ac:graphicFrameMkLst>
            <pc:docMk/>
            <pc:sldMk cId="104774107" sldId="263"/>
            <ac:graphicFrameMk id="5" creationId="{2671258B-EBE7-2013-D0A9-95DA85C6DDC4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20:27.330" v="645"/>
        <pc:sldMkLst>
          <pc:docMk/>
          <pc:sldMk cId="519245554" sldId="264"/>
        </pc:sldMkLst>
        <pc:graphicFrameChg chg="mod">
          <ac:chgData name="Kaygisiz, Kübra" userId="4bfbf330-8776-4086-a830-2184b07ba8db" providerId="ADAL" clId="{1BB04EDD-A3E3-453A-B4B6-6AA1C24487B8}" dt="2022-08-23T12:20:23.064" v="642"/>
          <ac:graphicFrameMkLst>
            <pc:docMk/>
            <pc:sldMk cId="519245554" sldId="264"/>
            <ac:graphicFrameMk id="3" creationId="{8002B9A2-D110-DEE8-0024-28ADA583481E}"/>
          </ac:graphicFrameMkLst>
        </pc:graphicFrameChg>
        <pc:graphicFrameChg chg="mod">
          <ac:chgData name="Kaygisiz, Kübra" userId="4bfbf330-8776-4086-a830-2184b07ba8db" providerId="ADAL" clId="{1BB04EDD-A3E3-453A-B4B6-6AA1C24487B8}" dt="2022-08-23T12:20:27.330" v="645"/>
          <ac:graphicFrameMkLst>
            <pc:docMk/>
            <pc:sldMk cId="519245554" sldId="264"/>
            <ac:graphicFrameMk id="5" creationId="{FB484AF1-5689-BB96-F8DD-264BE0B256A2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21:03.409" v="651"/>
        <pc:sldMkLst>
          <pc:docMk/>
          <pc:sldMk cId="3314426039" sldId="265"/>
        </pc:sldMkLst>
        <pc:graphicFrameChg chg="mod">
          <ac:chgData name="Kaygisiz, Kübra" userId="4bfbf330-8776-4086-a830-2184b07ba8db" providerId="ADAL" clId="{1BB04EDD-A3E3-453A-B4B6-6AA1C24487B8}" dt="2022-08-23T12:20:58.843" v="648"/>
          <ac:graphicFrameMkLst>
            <pc:docMk/>
            <pc:sldMk cId="3314426039" sldId="265"/>
            <ac:graphicFrameMk id="3" creationId="{154D3A0C-81BC-106A-BC28-A4EC58E520BB}"/>
          </ac:graphicFrameMkLst>
        </pc:graphicFrameChg>
        <pc:graphicFrameChg chg="mod">
          <ac:chgData name="Kaygisiz, Kübra" userId="4bfbf330-8776-4086-a830-2184b07ba8db" providerId="ADAL" clId="{1BB04EDD-A3E3-453A-B4B6-6AA1C24487B8}" dt="2022-08-23T12:21:03.409" v="651"/>
          <ac:graphicFrameMkLst>
            <pc:docMk/>
            <pc:sldMk cId="3314426039" sldId="265"/>
            <ac:graphicFrameMk id="5" creationId="{C1133F88-E3B1-B52E-D6C1-8FC93FDE46FA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21:28.280" v="657"/>
        <pc:sldMkLst>
          <pc:docMk/>
          <pc:sldMk cId="1323477964" sldId="266"/>
        </pc:sldMkLst>
        <pc:graphicFrameChg chg="mod">
          <ac:chgData name="Kaygisiz, Kübra" userId="4bfbf330-8776-4086-a830-2184b07ba8db" providerId="ADAL" clId="{1BB04EDD-A3E3-453A-B4B6-6AA1C24487B8}" dt="2022-08-23T12:21:23.735" v="654"/>
          <ac:graphicFrameMkLst>
            <pc:docMk/>
            <pc:sldMk cId="1323477964" sldId="266"/>
            <ac:graphicFrameMk id="3" creationId="{68C253E2-E1AF-B950-604C-44EEF399FC7D}"/>
          </ac:graphicFrameMkLst>
        </pc:graphicFrameChg>
        <pc:graphicFrameChg chg="mod">
          <ac:chgData name="Kaygisiz, Kübra" userId="4bfbf330-8776-4086-a830-2184b07ba8db" providerId="ADAL" clId="{1BB04EDD-A3E3-453A-B4B6-6AA1C24487B8}" dt="2022-08-23T12:21:28.280" v="657"/>
          <ac:graphicFrameMkLst>
            <pc:docMk/>
            <pc:sldMk cId="1323477964" sldId="266"/>
            <ac:graphicFrameMk id="5" creationId="{0E63375F-CC09-B095-7523-564CDA594A59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22:02.392" v="663"/>
        <pc:sldMkLst>
          <pc:docMk/>
          <pc:sldMk cId="3493876726" sldId="267"/>
        </pc:sldMkLst>
        <pc:graphicFrameChg chg="mod">
          <ac:chgData name="Kaygisiz, Kübra" userId="4bfbf330-8776-4086-a830-2184b07ba8db" providerId="ADAL" clId="{1BB04EDD-A3E3-453A-B4B6-6AA1C24487B8}" dt="2022-08-23T12:21:43.381" v="660"/>
          <ac:graphicFrameMkLst>
            <pc:docMk/>
            <pc:sldMk cId="3493876726" sldId="267"/>
            <ac:graphicFrameMk id="3" creationId="{CA2B8A02-D028-D752-87A6-AFDCE4589CFE}"/>
          </ac:graphicFrameMkLst>
        </pc:graphicFrameChg>
        <pc:graphicFrameChg chg="mod">
          <ac:chgData name="Kaygisiz, Kübra" userId="4bfbf330-8776-4086-a830-2184b07ba8db" providerId="ADAL" clId="{1BB04EDD-A3E3-453A-B4B6-6AA1C24487B8}" dt="2022-08-23T12:22:02.392" v="663"/>
          <ac:graphicFrameMkLst>
            <pc:docMk/>
            <pc:sldMk cId="3493876726" sldId="267"/>
            <ac:graphicFrameMk id="5" creationId="{E3686079-5496-F3DB-D331-FEAD96114ABF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22:20.363" v="669"/>
        <pc:sldMkLst>
          <pc:docMk/>
          <pc:sldMk cId="3621259937" sldId="268"/>
        </pc:sldMkLst>
        <pc:graphicFrameChg chg="mod">
          <ac:chgData name="Kaygisiz, Kübra" userId="4bfbf330-8776-4086-a830-2184b07ba8db" providerId="ADAL" clId="{1BB04EDD-A3E3-453A-B4B6-6AA1C24487B8}" dt="2022-08-23T12:22:09.589" v="666"/>
          <ac:graphicFrameMkLst>
            <pc:docMk/>
            <pc:sldMk cId="3621259937" sldId="268"/>
            <ac:graphicFrameMk id="3" creationId="{313DACC5-4C42-35BE-9FCF-1357981C1BB0}"/>
          </ac:graphicFrameMkLst>
        </pc:graphicFrameChg>
        <pc:graphicFrameChg chg="mod">
          <ac:chgData name="Kaygisiz, Kübra" userId="4bfbf330-8776-4086-a830-2184b07ba8db" providerId="ADAL" clId="{1BB04EDD-A3E3-453A-B4B6-6AA1C24487B8}" dt="2022-08-23T12:22:20.363" v="669"/>
          <ac:graphicFrameMkLst>
            <pc:docMk/>
            <pc:sldMk cId="3621259937" sldId="268"/>
            <ac:graphicFrameMk id="5" creationId="{552C6901-7EEB-507E-51E1-CA03E162E1B1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22:27.592" v="672"/>
        <pc:sldMkLst>
          <pc:docMk/>
          <pc:sldMk cId="770258183" sldId="269"/>
        </pc:sldMkLst>
        <pc:graphicFrameChg chg="mod">
          <ac:chgData name="Kaygisiz, Kübra" userId="4bfbf330-8776-4086-a830-2184b07ba8db" providerId="ADAL" clId="{1BB04EDD-A3E3-453A-B4B6-6AA1C24487B8}" dt="2022-08-23T12:22:27.592" v="672"/>
          <ac:graphicFrameMkLst>
            <pc:docMk/>
            <pc:sldMk cId="770258183" sldId="269"/>
            <ac:graphicFrameMk id="3" creationId="{D25435BF-DDCD-4A2C-7BCA-436E2F69E98F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22:37.526" v="678"/>
        <pc:sldMkLst>
          <pc:docMk/>
          <pc:sldMk cId="1899709365" sldId="270"/>
        </pc:sldMkLst>
        <pc:graphicFrameChg chg="mod">
          <ac:chgData name="Kaygisiz, Kübra" userId="4bfbf330-8776-4086-a830-2184b07ba8db" providerId="ADAL" clId="{1BB04EDD-A3E3-453A-B4B6-6AA1C24487B8}" dt="2022-08-23T12:22:32.997" v="675"/>
          <ac:graphicFrameMkLst>
            <pc:docMk/>
            <pc:sldMk cId="1899709365" sldId="270"/>
            <ac:graphicFrameMk id="3" creationId="{8CC16FAB-C433-E4E8-CC86-155B936E4A86}"/>
          </ac:graphicFrameMkLst>
        </pc:graphicFrameChg>
        <pc:graphicFrameChg chg="mod">
          <ac:chgData name="Kaygisiz, Kübra" userId="4bfbf330-8776-4086-a830-2184b07ba8db" providerId="ADAL" clId="{1BB04EDD-A3E3-453A-B4B6-6AA1C24487B8}" dt="2022-08-23T12:22:37.526" v="678"/>
          <ac:graphicFrameMkLst>
            <pc:docMk/>
            <pc:sldMk cId="1899709365" sldId="270"/>
            <ac:graphicFrameMk id="5" creationId="{8CCB2249-7320-0447-4C16-C62AF9CB79D1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22:43.772" v="681"/>
        <pc:sldMkLst>
          <pc:docMk/>
          <pc:sldMk cId="2437039918" sldId="271"/>
        </pc:sldMkLst>
        <pc:graphicFrameChg chg="mod">
          <ac:chgData name="Kaygisiz, Kübra" userId="4bfbf330-8776-4086-a830-2184b07ba8db" providerId="ADAL" clId="{1BB04EDD-A3E3-453A-B4B6-6AA1C24487B8}" dt="2022-08-23T12:22:43.772" v="681"/>
          <ac:graphicFrameMkLst>
            <pc:docMk/>
            <pc:sldMk cId="2437039918" sldId="271"/>
            <ac:graphicFrameMk id="3" creationId="{A2791670-238E-B8FA-F3CC-DF6A9382AA73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22:49.066" v="684"/>
        <pc:sldMkLst>
          <pc:docMk/>
          <pc:sldMk cId="326007136" sldId="272"/>
        </pc:sldMkLst>
        <pc:graphicFrameChg chg="mod">
          <ac:chgData name="Kaygisiz, Kübra" userId="4bfbf330-8776-4086-a830-2184b07ba8db" providerId="ADAL" clId="{1BB04EDD-A3E3-453A-B4B6-6AA1C24487B8}" dt="2022-08-23T12:22:49.066" v="684"/>
          <ac:graphicFrameMkLst>
            <pc:docMk/>
            <pc:sldMk cId="326007136" sldId="272"/>
            <ac:graphicFrameMk id="3" creationId="{78C13780-7BAA-CC82-C411-0B23C07BBE9F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29:00.306" v="687"/>
        <pc:sldMkLst>
          <pc:docMk/>
          <pc:sldMk cId="373315249" sldId="273"/>
        </pc:sldMkLst>
        <pc:graphicFrameChg chg="mod">
          <ac:chgData name="Kaygisiz, Kübra" userId="4bfbf330-8776-4086-a830-2184b07ba8db" providerId="ADAL" clId="{1BB04EDD-A3E3-453A-B4B6-6AA1C24487B8}" dt="2022-08-23T12:29:00.306" v="687"/>
          <ac:graphicFrameMkLst>
            <pc:docMk/>
            <pc:sldMk cId="373315249" sldId="273"/>
            <ac:graphicFrameMk id="3" creationId="{BDFE954A-D566-E8AE-ADE2-86091278C531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29:13.053" v="693"/>
        <pc:sldMkLst>
          <pc:docMk/>
          <pc:sldMk cId="2847818880" sldId="274"/>
        </pc:sldMkLst>
        <pc:graphicFrameChg chg="mod">
          <ac:chgData name="Kaygisiz, Kübra" userId="4bfbf330-8776-4086-a830-2184b07ba8db" providerId="ADAL" clId="{1BB04EDD-A3E3-453A-B4B6-6AA1C24487B8}" dt="2022-08-23T12:29:08.679" v="690"/>
          <ac:graphicFrameMkLst>
            <pc:docMk/>
            <pc:sldMk cId="2847818880" sldId="274"/>
            <ac:graphicFrameMk id="3" creationId="{78C048C6-E7ED-D0B0-24FE-C93EA8F2F217}"/>
          </ac:graphicFrameMkLst>
        </pc:graphicFrameChg>
        <pc:graphicFrameChg chg="mod">
          <ac:chgData name="Kaygisiz, Kübra" userId="4bfbf330-8776-4086-a830-2184b07ba8db" providerId="ADAL" clId="{1BB04EDD-A3E3-453A-B4B6-6AA1C24487B8}" dt="2022-08-23T12:29:13.053" v="693"/>
          <ac:graphicFrameMkLst>
            <pc:docMk/>
            <pc:sldMk cId="2847818880" sldId="274"/>
            <ac:graphicFrameMk id="5" creationId="{4FE9C41A-653D-F713-4C7E-0F88F78E3867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29:21.770" v="699"/>
        <pc:sldMkLst>
          <pc:docMk/>
          <pc:sldMk cId="1948445893" sldId="275"/>
        </pc:sldMkLst>
        <pc:graphicFrameChg chg="mod">
          <ac:chgData name="Kaygisiz, Kübra" userId="4bfbf330-8776-4086-a830-2184b07ba8db" providerId="ADAL" clId="{1BB04EDD-A3E3-453A-B4B6-6AA1C24487B8}" dt="2022-08-23T12:29:17.552" v="696"/>
          <ac:graphicFrameMkLst>
            <pc:docMk/>
            <pc:sldMk cId="1948445893" sldId="275"/>
            <ac:graphicFrameMk id="3" creationId="{F5DF9242-8188-8B28-50E6-A3FF5BE88177}"/>
          </ac:graphicFrameMkLst>
        </pc:graphicFrameChg>
        <pc:graphicFrameChg chg="mod">
          <ac:chgData name="Kaygisiz, Kübra" userId="4bfbf330-8776-4086-a830-2184b07ba8db" providerId="ADAL" clId="{1BB04EDD-A3E3-453A-B4B6-6AA1C24487B8}" dt="2022-08-23T12:29:21.770" v="699"/>
          <ac:graphicFrameMkLst>
            <pc:docMk/>
            <pc:sldMk cId="1948445893" sldId="275"/>
            <ac:graphicFrameMk id="5" creationId="{B33E8DF4-407B-694A-60A6-433F78F122CE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29:26.816" v="702"/>
        <pc:sldMkLst>
          <pc:docMk/>
          <pc:sldMk cId="1287938043" sldId="276"/>
        </pc:sldMkLst>
        <pc:graphicFrameChg chg="mod">
          <ac:chgData name="Kaygisiz, Kübra" userId="4bfbf330-8776-4086-a830-2184b07ba8db" providerId="ADAL" clId="{1BB04EDD-A3E3-453A-B4B6-6AA1C24487B8}" dt="2022-08-23T12:29:26.816" v="702"/>
          <ac:graphicFrameMkLst>
            <pc:docMk/>
            <pc:sldMk cId="1287938043" sldId="276"/>
            <ac:graphicFrameMk id="3" creationId="{70B99AB6-7F82-7257-8FEE-3AFD43D9220C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29:31.752" v="705"/>
        <pc:sldMkLst>
          <pc:docMk/>
          <pc:sldMk cId="4003129706" sldId="277"/>
        </pc:sldMkLst>
        <pc:graphicFrameChg chg="mod">
          <ac:chgData name="Kaygisiz, Kübra" userId="4bfbf330-8776-4086-a830-2184b07ba8db" providerId="ADAL" clId="{1BB04EDD-A3E3-453A-B4B6-6AA1C24487B8}" dt="2022-08-23T12:29:31.752" v="705"/>
          <ac:graphicFrameMkLst>
            <pc:docMk/>
            <pc:sldMk cId="4003129706" sldId="277"/>
            <ac:graphicFrameMk id="3" creationId="{3EC4075D-4811-17C5-937B-C6DE9276D943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29:36.704" v="708"/>
        <pc:sldMkLst>
          <pc:docMk/>
          <pc:sldMk cId="3258684061" sldId="278"/>
        </pc:sldMkLst>
        <pc:graphicFrameChg chg="mod">
          <ac:chgData name="Kaygisiz, Kübra" userId="4bfbf330-8776-4086-a830-2184b07ba8db" providerId="ADAL" clId="{1BB04EDD-A3E3-453A-B4B6-6AA1C24487B8}" dt="2022-08-23T12:29:36.704" v="708"/>
          <ac:graphicFrameMkLst>
            <pc:docMk/>
            <pc:sldMk cId="3258684061" sldId="278"/>
            <ac:graphicFrameMk id="3" creationId="{02D19A7D-1863-202C-DA52-98F0047B46FC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29:52.763" v="717"/>
        <pc:sldMkLst>
          <pc:docMk/>
          <pc:sldMk cId="2974409549" sldId="279"/>
        </pc:sldMkLst>
        <pc:graphicFrameChg chg="mod">
          <ac:chgData name="Kaygisiz, Kübra" userId="4bfbf330-8776-4086-a830-2184b07ba8db" providerId="ADAL" clId="{1BB04EDD-A3E3-453A-B4B6-6AA1C24487B8}" dt="2022-08-23T12:29:48.514" v="714"/>
          <ac:graphicFrameMkLst>
            <pc:docMk/>
            <pc:sldMk cId="2974409549" sldId="279"/>
            <ac:graphicFrameMk id="3" creationId="{02E56959-CD39-2CD2-EE37-EB9B3D314E77}"/>
          </ac:graphicFrameMkLst>
        </pc:graphicFrameChg>
        <pc:graphicFrameChg chg="mod">
          <ac:chgData name="Kaygisiz, Kübra" userId="4bfbf330-8776-4086-a830-2184b07ba8db" providerId="ADAL" clId="{1BB04EDD-A3E3-453A-B4B6-6AA1C24487B8}" dt="2022-08-23T12:29:52.763" v="717"/>
          <ac:graphicFrameMkLst>
            <pc:docMk/>
            <pc:sldMk cId="2974409549" sldId="279"/>
            <ac:graphicFrameMk id="4" creationId="{8ED53B63-9C62-114C-27C5-13E9DE928979}"/>
          </ac:graphicFrameMkLst>
        </pc:graphicFrameChg>
      </pc:sldChg>
      <pc:sldChg chg="delSp modSp mod">
        <pc:chgData name="Kaygisiz, Kübra" userId="4bfbf330-8776-4086-a830-2184b07ba8db" providerId="ADAL" clId="{1BB04EDD-A3E3-453A-B4B6-6AA1C24487B8}" dt="2022-08-24T05:17:52.948" v="843" actId="1076"/>
        <pc:sldMkLst>
          <pc:docMk/>
          <pc:sldMk cId="3384423603" sldId="280"/>
        </pc:sldMkLst>
        <pc:graphicFrameChg chg="del mod">
          <ac:chgData name="Kaygisiz, Kübra" userId="4bfbf330-8776-4086-a830-2184b07ba8db" providerId="ADAL" clId="{1BB04EDD-A3E3-453A-B4B6-6AA1C24487B8}" dt="2022-08-24T05:17:51.804" v="842" actId="478"/>
          <ac:graphicFrameMkLst>
            <pc:docMk/>
            <pc:sldMk cId="3384423603" sldId="280"/>
            <ac:graphicFrameMk id="3" creationId="{37633C7D-85A8-104A-1536-C30567B415E0}"/>
          </ac:graphicFrameMkLst>
        </pc:graphicFrameChg>
        <pc:graphicFrameChg chg="mod">
          <ac:chgData name="Kaygisiz, Kübra" userId="4bfbf330-8776-4086-a830-2184b07ba8db" providerId="ADAL" clId="{1BB04EDD-A3E3-453A-B4B6-6AA1C24487B8}" dt="2022-08-23T12:30:04.896" v="723"/>
          <ac:graphicFrameMkLst>
            <pc:docMk/>
            <pc:sldMk cId="3384423603" sldId="280"/>
            <ac:graphicFrameMk id="5" creationId="{BA11648F-6610-AD21-8690-E2E5D19F7092}"/>
          </ac:graphicFrameMkLst>
        </pc:graphicFrameChg>
        <pc:graphicFrameChg chg="mod">
          <ac:chgData name="Kaygisiz, Kübra" userId="4bfbf330-8776-4086-a830-2184b07ba8db" providerId="ADAL" clId="{1BB04EDD-A3E3-453A-B4B6-6AA1C24487B8}" dt="2022-08-24T05:17:52.948" v="843" actId="1076"/>
          <ac:graphicFrameMkLst>
            <pc:docMk/>
            <pc:sldMk cId="3384423603" sldId="280"/>
            <ac:graphicFrameMk id="6" creationId="{B16414CD-835F-723A-26F8-06A229535EB8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0:29.578" v="738"/>
        <pc:sldMkLst>
          <pc:docMk/>
          <pc:sldMk cId="499453516" sldId="281"/>
        </pc:sldMkLst>
        <pc:graphicFrameChg chg="mod">
          <ac:chgData name="Kaygisiz, Kübra" userId="4bfbf330-8776-4086-a830-2184b07ba8db" providerId="ADAL" clId="{1BB04EDD-A3E3-453A-B4B6-6AA1C24487B8}" dt="2022-08-23T12:30:29.578" v="738"/>
          <ac:graphicFrameMkLst>
            <pc:docMk/>
            <pc:sldMk cId="499453516" sldId="281"/>
            <ac:graphicFrameMk id="3" creationId="{2D0C0B03-3EA2-336C-A998-467DAFADF957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0:49.197" v="750"/>
        <pc:sldMkLst>
          <pc:docMk/>
          <pc:sldMk cId="602044471" sldId="282"/>
        </pc:sldMkLst>
        <pc:graphicFrameChg chg="mod">
          <ac:chgData name="Kaygisiz, Kübra" userId="4bfbf330-8776-4086-a830-2184b07ba8db" providerId="ADAL" clId="{1BB04EDD-A3E3-453A-B4B6-6AA1C24487B8}" dt="2022-08-23T12:30:49.197" v="750"/>
          <ac:graphicFrameMkLst>
            <pc:docMk/>
            <pc:sldMk cId="602044471" sldId="282"/>
            <ac:graphicFrameMk id="3" creationId="{CCCF0F9C-9600-0CA4-DADF-E4E4B502E7B7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1:15.020" v="762"/>
        <pc:sldMkLst>
          <pc:docMk/>
          <pc:sldMk cId="2177583764" sldId="283"/>
        </pc:sldMkLst>
        <pc:graphicFrameChg chg="mod">
          <ac:chgData name="Kaygisiz, Kübra" userId="4bfbf330-8776-4086-a830-2184b07ba8db" providerId="ADAL" clId="{1BB04EDD-A3E3-453A-B4B6-6AA1C24487B8}" dt="2022-08-23T12:31:15.020" v="762"/>
          <ac:graphicFrameMkLst>
            <pc:docMk/>
            <pc:sldMk cId="2177583764" sldId="283"/>
            <ac:graphicFrameMk id="3" creationId="{2B6FD32D-98D7-1798-EF4D-AF58EE30C7F6}"/>
          </ac:graphicFrameMkLst>
        </pc:graphicFrameChg>
      </pc:sldChg>
      <pc:sldChg chg="addSp delSp modSp mod">
        <pc:chgData name="Kaygisiz, Kübra" userId="4bfbf330-8776-4086-a830-2184b07ba8db" providerId="ADAL" clId="{1BB04EDD-A3E3-453A-B4B6-6AA1C24487B8}" dt="2022-08-22T03:31:24.849" v="114" actId="478"/>
        <pc:sldMkLst>
          <pc:docMk/>
          <pc:sldMk cId="1537632101" sldId="284"/>
        </pc:sldMkLst>
        <pc:graphicFrameChg chg="mod">
          <ac:chgData name="Kaygisiz, Kübra" userId="4bfbf330-8776-4086-a830-2184b07ba8db" providerId="ADAL" clId="{1BB04EDD-A3E3-453A-B4B6-6AA1C24487B8}" dt="2022-08-22T03:30:23.546" v="111" actId="5736"/>
          <ac:graphicFrameMkLst>
            <pc:docMk/>
            <pc:sldMk cId="1537632101" sldId="284"/>
            <ac:graphicFrameMk id="3" creationId="{15944574-0C88-192E-9923-2217E78D7546}"/>
          </ac:graphicFrameMkLst>
        </pc:graphicFrameChg>
        <pc:graphicFrameChg chg="add del mod">
          <ac:chgData name="Kaygisiz, Kübra" userId="4bfbf330-8776-4086-a830-2184b07ba8db" providerId="ADAL" clId="{1BB04EDD-A3E3-453A-B4B6-6AA1C24487B8}" dt="2022-08-22T03:28:58.044" v="101" actId="478"/>
          <ac:graphicFrameMkLst>
            <pc:docMk/>
            <pc:sldMk cId="1537632101" sldId="284"/>
            <ac:graphicFrameMk id="4" creationId="{89728263-5257-D9C4-3C61-FDF1906F6162}"/>
          </ac:graphicFrameMkLst>
        </pc:graphicFrameChg>
        <pc:graphicFrameChg chg="add del mod">
          <ac:chgData name="Kaygisiz, Kübra" userId="4bfbf330-8776-4086-a830-2184b07ba8db" providerId="ADAL" clId="{1BB04EDD-A3E3-453A-B4B6-6AA1C24487B8}" dt="2022-08-22T03:29:28.492" v="107" actId="478"/>
          <ac:graphicFrameMkLst>
            <pc:docMk/>
            <pc:sldMk cId="1537632101" sldId="284"/>
            <ac:graphicFrameMk id="6" creationId="{852D43A3-DBA6-CBDF-0D3B-87FAD0DEFDC5}"/>
          </ac:graphicFrameMkLst>
        </pc:graphicFrameChg>
        <pc:picChg chg="add del mod">
          <ac:chgData name="Kaygisiz, Kübra" userId="4bfbf330-8776-4086-a830-2184b07ba8db" providerId="ADAL" clId="{1BB04EDD-A3E3-453A-B4B6-6AA1C24487B8}" dt="2022-08-22T03:29:03.606" v="104" actId="478"/>
          <ac:picMkLst>
            <pc:docMk/>
            <pc:sldMk cId="1537632101" sldId="284"/>
            <ac:picMk id="5" creationId="{CCC10000-4199-AB83-6D13-FF45AD93695D}"/>
          </ac:picMkLst>
        </pc:picChg>
        <pc:picChg chg="add del mod">
          <ac:chgData name="Kaygisiz, Kübra" userId="4bfbf330-8776-4086-a830-2184b07ba8db" providerId="ADAL" clId="{1BB04EDD-A3E3-453A-B4B6-6AA1C24487B8}" dt="2022-08-22T03:31:24.849" v="114" actId="478"/>
          <ac:picMkLst>
            <pc:docMk/>
            <pc:sldMk cId="1537632101" sldId="284"/>
            <ac:picMk id="8" creationId="{F5E71A3F-CE1C-1222-9421-9884B39E403B}"/>
          </ac:picMkLst>
        </pc:picChg>
      </pc:sldChg>
      <pc:sldChg chg="modSp mod">
        <pc:chgData name="Kaygisiz, Kübra" userId="4bfbf330-8776-4086-a830-2184b07ba8db" providerId="ADAL" clId="{1BB04EDD-A3E3-453A-B4B6-6AA1C24487B8}" dt="2022-08-22T03:29:38.092" v="110"/>
        <pc:sldMkLst>
          <pc:docMk/>
          <pc:sldMk cId="2546421780" sldId="285"/>
        </pc:sldMkLst>
        <pc:graphicFrameChg chg="mod">
          <ac:chgData name="Kaygisiz, Kübra" userId="4bfbf330-8776-4086-a830-2184b07ba8db" providerId="ADAL" clId="{1BB04EDD-A3E3-453A-B4B6-6AA1C24487B8}" dt="2022-08-22T02:42:50.583" v="48" actId="1076"/>
          <ac:graphicFrameMkLst>
            <pc:docMk/>
            <pc:sldMk cId="2546421780" sldId="285"/>
            <ac:graphicFrameMk id="3" creationId="{D4CB603E-3E50-020A-1AE0-36D991A8DB13}"/>
          </ac:graphicFrameMkLst>
        </pc:graphicFrameChg>
        <pc:graphicFrameChg chg="mod">
          <ac:chgData name="Kaygisiz, Kübra" userId="4bfbf330-8776-4086-a830-2184b07ba8db" providerId="ADAL" clId="{1BB04EDD-A3E3-453A-B4B6-6AA1C24487B8}" dt="2022-08-22T03:29:38.092" v="110"/>
          <ac:graphicFrameMkLst>
            <pc:docMk/>
            <pc:sldMk cId="2546421780" sldId="285"/>
            <ac:graphicFrameMk id="4" creationId="{7C40838B-7BA5-525B-B2D3-AEF9671AFA91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2T10:39:56.281" v="117"/>
        <pc:sldMkLst>
          <pc:docMk/>
          <pc:sldMk cId="865975180" sldId="286"/>
        </pc:sldMkLst>
        <pc:graphicFrameChg chg="mod">
          <ac:chgData name="Kaygisiz, Kübra" userId="4bfbf330-8776-4086-a830-2184b07ba8db" providerId="ADAL" clId="{1BB04EDD-A3E3-453A-B4B6-6AA1C24487B8}" dt="2022-08-22T10:39:56.281" v="117"/>
          <ac:graphicFrameMkLst>
            <pc:docMk/>
            <pc:sldMk cId="865975180" sldId="286"/>
            <ac:graphicFrameMk id="3" creationId="{9F42F0FA-FF40-E1B2-21C6-73F63B1C549B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1:22:49.060" v="120"/>
        <pc:sldMkLst>
          <pc:docMk/>
          <pc:sldMk cId="4284137325" sldId="287"/>
        </pc:sldMkLst>
        <pc:graphicFrameChg chg="mod">
          <ac:chgData name="Kaygisiz, Kübra" userId="4bfbf330-8776-4086-a830-2184b07ba8db" providerId="ADAL" clId="{1BB04EDD-A3E3-453A-B4B6-6AA1C24487B8}" dt="2022-08-23T11:22:49.060" v="120"/>
          <ac:graphicFrameMkLst>
            <pc:docMk/>
            <pc:sldMk cId="4284137325" sldId="287"/>
            <ac:graphicFrameMk id="3" creationId="{346B088D-8CB3-57F2-5BEE-C181F3EE31CD}"/>
          </ac:graphicFrameMkLst>
        </pc:graphicFrameChg>
        <pc:graphicFrameChg chg="add mod">
          <ac:chgData name="Kaygisiz, Kübra" userId="4bfbf330-8776-4086-a830-2184b07ba8db" providerId="ADAL" clId="{1BB04EDD-A3E3-453A-B4B6-6AA1C24487B8}" dt="2022-08-21T11:41:54.972" v="33" actId="1076"/>
          <ac:graphicFrameMkLst>
            <pc:docMk/>
            <pc:sldMk cId="4284137325" sldId="287"/>
            <ac:graphicFrameMk id="5" creationId="{EF6982A8-DD67-7133-5613-1ABEED969B17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1:23:25.386" v="123"/>
        <pc:sldMkLst>
          <pc:docMk/>
          <pc:sldMk cId="331403962" sldId="288"/>
        </pc:sldMkLst>
        <pc:graphicFrameChg chg="mod">
          <ac:chgData name="Kaygisiz, Kübra" userId="4bfbf330-8776-4086-a830-2184b07ba8db" providerId="ADAL" clId="{1BB04EDD-A3E3-453A-B4B6-6AA1C24487B8}" dt="2022-08-23T11:23:25.386" v="123"/>
          <ac:graphicFrameMkLst>
            <pc:docMk/>
            <pc:sldMk cId="331403962" sldId="288"/>
            <ac:graphicFrameMk id="3" creationId="{E4DA1A9F-D00B-2F3B-8ADE-BA3F267754EF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1:23:47.002" v="126"/>
        <pc:sldMkLst>
          <pc:docMk/>
          <pc:sldMk cId="1480316319" sldId="289"/>
        </pc:sldMkLst>
        <pc:graphicFrameChg chg="add mod">
          <ac:chgData name="Kaygisiz, Kübra" userId="4bfbf330-8776-4086-a830-2184b07ba8db" providerId="ADAL" clId="{1BB04EDD-A3E3-453A-B4B6-6AA1C24487B8}" dt="2022-08-21T11:42:19.937" v="36" actId="1076"/>
          <ac:graphicFrameMkLst>
            <pc:docMk/>
            <pc:sldMk cId="1480316319" sldId="289"/>
            <ac:graphicFrameMk id="3" creationId="{9D729D63-1DEA-9680-C111-4916B78BD34A}"/>
          </ac:graphicFrameMkLst>
        </pc:graphicFrameChg>
        <pc:graphicFrameChg chg="mod">
          <ac:chgData name="Kaygisiz, Kübra" userId="4bfbf330-8776-4086-a830-2184b07ba8db" providerId="ADAL" clId="{1BB04EDD-A3E3-453A-B4B6-6AA1C24487B8}" dt="2022-08-23T11:23:47.002" v="126"/>
          <ac:graphicFrameMkLst>
            <pc:docMk/>
            <pc:sldMk cId="1480316319" sldId="289"/>
            <ac:graphicFrameMk id="4" creationId="{BD0DC6EC-8E6B-4456-6AA5-E7EE91D246D5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1:24:09.426" v="129"/>
        <pc:sldMkLst>
          <pc:docMk/>
          <pc:sldMk cId="4059308301" sldId="290"/>
        </pc:sldMkLst>
        <pc:graphicFrameChg chg="mod">
          <ac:chgData name="Kaygisiz, Kübra" userId="4bfbf330-8776-4086-a830-2184b07ba8db" providerId="ADAL" clId="{1BB04EDD-A3E3-453A-B4B6-6AA1C24487B8}" dt="2022-08-23T11:24:09.426" v="129"/>
          <ac:graphicFrameMkLst>
            <pc:docMk/>
            <pc:sldMk cId="4059308301" sldId="290"/>
            <ac:graphicFrameMk id="3" creationId="{EB9500F5-0599-D9FC-0AA9-1AE413FA4471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1:25:02.448" v="132"/>
        <pc:sldMkLst>
          <pc:docMk/>
          <pc:sldMk cId="2298076905" sldId="291"/>
        </pc:sldMkLst>
        <pc:graphicFrameChg chg="mod">
          <ac:chgData name="Kaygisiz, Kübra" userId="4bfbf330-8776-4086-a830-2184b07ba8db" providerId="ADAL" clId="{1BB04EDD-A3E3-453A-B4B6-6AA1C24487B8}" dt="2022-08-23T11:25:02.448" v="132"/>
          <ac:graphicFrameMkLst>
            <pc:docMk/>
            <pc:sldMk cId="2298076905" sldId="291"/>
            <ac:graphicFrameMk id="3" creationId="{45D34166-909E-80A5-C3D4-4811E3180698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1:25:25.400" v="135"/>
        <pc:sldMkLst>
          <pc:docMk/>
          <pc:sldMk cId="2063604901" sldId="292"/>
        </pc:sldMkLst>
        <pc:graphicFrameChg chg="mod">
          <ac:chgData name="Kaygisiz, Kübra" userId="4bfbf330-8776-4086-a830-2184b07ba8db" providerId="ADAL" clId="{1BB04EDD-A3E3-453A-B4B6-6AA1C24487B8}" dt="2022-08-23T11:25:25.400" v="135"/>
          <ac:graphicFrameMkLst>
            <pc:docMk/>
            <pc:sldMk cId="2063604901" sldId="292"/>
            <ac:graphicFrameMk id="3" creationId="{D36D3617-DD46-9E60-F8EF-9D594A5DCD58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1:25:58.386" v="138"/>
        <pc:sldMkLst>
          <pc:docMk/>
          <pc:sldMk cId="2855801071" sldId="293"/>
        </pc:sldMkLst>
        <pc:graphicFrameChg chg="mod">
          <ac:chgData name="Kaygisiz, Kübra" userId="4bfbf330-8776-4086-a830-2184b07ba8db" providerId="ADAL" clId="{1BB04EDD-A3E3-453A-B4B6-6AA1C24487B8}" dt="2022-08-23T11:25:58.386" v="138"/>
          <ac:graphicFrameMkLst>
            <pc:docMk/>
            <pc:sldMk cId="2855801071" sldId="293"/>
            <ac:graphicFrameMk id="3" creationId="{2F977E70-FEFE-4112-2E77-8692776A3814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1:26:28.591" v="141"/>
        <pc:sldMkLst>
          <pc:docMk/>
          <pc:sldMk cId="2886679313" sldId="294"/>
        </pc:sldMkLst>
        <pc:graphicFrameChg chg="mod">
          <ac:chgData name="Kaygisiz, Kübra" userId="4bfbf330-8776-4086-a830-2184b07ba8db" providerId="ADAL" clId="{1BB04EDD-A3E3-453A-B4B6-6AA1C24487B8}" dt="2022-08-23T11:26:28.591" v="141"/>
          <ac:graphicFrameMkLst>
            <pc:docMk/>
            <pc:sldMk cId="2886679313" sldId="294"/>
            <ac:graphicFrameMk id="3" creationId="{F4B8E875-44C3-728C-6B1E-7CB0E3DB3BC6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1:26:54.750" v="144"/>
        <pc:sldMkLst>
          <pc:docMk/>
          <pc:sldMk cId="2197959177" sldId="295"/>
        </pc:sldMkLst>
        <pc:graphicFrameChg chg="add mod">
          <ac:chgData name="Kaygisiz, Kübra" userId="4bfbf330-8776-4086-a830-2184b07ba8db" providerId="ADAL" clId="{1BB04EDD-A3E3-453A-B4B6-6AA1C24487B8}" dt="2022-08-23T11:26:54.750" v="144"/>
          <ac:graphicFrameMkLst>
            <pc:docMk/>
            <pc:sldMk cId="2197959177" sldId="295"/>
            <ac:graphicFrameMk id="3" creationId="{94C98DDD-5398-22F8-96E8-587759A083E4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1:27:45.789" v="148"/>
        <pc:sldMkLst>
          <pc:docMk/>
          <pc:sldMk cId="3987638391" sldId="296"/>
        </pc:sldMkLst>
        <pc:graphicFrameChg chg="mod">
          <ac:chgData name="Kaygisiz, Kübra" userId="4bfbf330-8776-4086-a830-2184b07ba8db" providerId="ADAL" clId="{1BB04EDD-A3E3-453A-B4B6-6AA1C24487B8}" dt="2022-08-23T11:27:45.789" v="148"/>
          <ac:graphicFrameMkLst>
            <pc:docMk/>
            <pc:sldMk cId="3987638391" sldId="296"/>
            <ac:graphicFrameMk id="3" creationId="{9B0AA601-E4C9-45D5-5B81-EAE783E413C7}"/>
          </ac:graphicFrameMkLst>
        </pc:graphicFrameChg>
        <pc:graphicFrameChg chg="add mod">
          <ac:chgData name="Kaygisiz, Kübra" userId="4bfbf330-8776-4086-a830-2184b07ba8db" providerId="ADAL" clId="{1BB04EDD-A3E3-453A-B4B6-6AA1C24487B8}" dt="2022-08-21T11:43:11.440" v="41" actId="1076"/>
          <ac:graphicFrameMkLst>
            <pc:docMk/>
            <pc:sldMk cId="3987638391" sldId="296"/>
            <ac:graphicFrameMk id="4" creationId="{DCAA814C-0822-9454-345B-09B0AF5C3134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1:28:34.589" v="151"/>
        <pc:sldMkLst>
          <pc:docMk/>
          <pc:sldMk cId="3343825750" sldId="297"/>
        </pc:sldMkLst>
        <pc:graphicFrameChg chg="mod">
          <ac:chgData name="Kaygisiz, Kübra" userId="4bfbf330-8776-4086-a830-2184b07ba8db" providerId="ADAL" clId="{1BB04EDD-A3E3-453A-B4B6-6AA1C24487B8}" dt="2022-08-23T11:28:34.589" v="151"/>
          <ac:graphicFrameMkLst>
            <pc:docMk/>
            <pc:sldMk cId="3343825750" sldId="297"/>
            <ac:graphicFrameMk id="3" creationId="{53914EA1-6FF0-C5BF-D3BE-F593A89E9479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1:29:10.718" v="154"/>
        <pc:sldMkLst>
          <pc:docMk/>
          <pc:sldMk cId="2851249939" sldId="298"/>
        </pc:sldMkLst>
        <pc:graphicFrameChg chg="add mod">
          <ac:chgData name="Kaygisiz, Kübra" userId="4bfbf330-8776-4086-a830-2184b07ba8db" providerId="ADAL" clId="{1BB04EDD-A3E3-453A-B4B6-6AA1C24487B8}" dt="2022-08-23T11:29:10.718" v="154"/>
          <ac:graphicFrameMkLst>
            <pc:docMk/>
            <pc:sldMk cId="2851249939" sldId="298"/>
            <ac:graphicFrameMk id="3" creationId="{F356E024-BB70-46D3-AE78-B66822315B38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1:29:53.523" v="157"/>
        <pc:sldMkLst>
          <pc:docMk/>
          <pc:sldMk cId="3683274127" sldId="299"/>
        </pc:sldMkLst>
        <pc:graphicFrameChg chg="mod">
          <ac:chgData name="Kaygisiz, Kübra" userId="4bfbf330-8776-4086-a830-2184b07ba8db" providerId="ADAL" clId="{1BB04EDD-A3E3-453A-B4B6-6AA1C24487B8}" dt="2022-08-23T11:29:53.523" v="157"/>
          <ac:graphicFrameMkLst>
            <pc:docMk/>
            <pc:sldMk cId="3683274127" sldId="299"/>
            <ac:graphicFrameMk id="3" creationId="{C5669C77-A2B5-F13A-D84C-5FCA0608B623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1:31:02.564" v="160"/>
        <pc:sldMkLst>
          <pc:docMk/>
          <pc:sldMk cId="2299203109" sldId="300"/>
        </pc:sldMkLst>
        <pc:graphicFrameChg chg="add mod">
          <ac:chgData name="Kaygisiz, Kübra" userId="4bfbf330-8776-4086-a830-2184b07ba8db" providerId="ADAL" clId="{1BB04EDD-A3E3-453A-B4B6-6AA1C24487B8}" dt="2022-08-23T11:31:02.564" v="160"/>
          <ac:graphicFrameMkLst>
            <pc:docMk/>
            <pc:sldMk cId="2299203109" sldId="300"/>
            <ac:graphicFrameMk id="3" creationId="{EDB75FA1-76E3-52B6-B324-8A150A05E5CB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1:31:22.457" v="163"/>
        <pc:sldMkLst>
          <pc:docMk/>
          <pc:sldMk cId="2742778679" sldId="301"/>
        </pc:sldMkLst>
        <pc:graphicFrameChg chg="mod">
          <ac:chgData name="Kaygisiz, Kübra" userId="4bfbf330-8776-4086-a830-2184b07ba8db" providerId="ADAL" clId="{1BB04EDD-A3E3-453A-B4B6-6AA1C24487B8}" dt="2022-08-23T11:31:22.457" v="163"/>
          <ac:graphicFrameMkLst>
            <pc:docMk/>
            <pc:sldMk cId="2742778679" sldId="301"/>
            <ac:graphicFrameMk id="5" creationId="{F9250C84-3361-58E9-3959-1EC257DE5F48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1:32:20.736" v="166"/>
        <pc:sldMkLst>
          <pc:docMk/>
          <pc:sldMk cId="2016114902" sldId="302"/>
        </pc:sldMkLst>
        <pc:graphicFrameChg chg="mod">
          <ac:chgData name="Kaygisiz, Kübra" userId="4bfbf330-8776-4086-a830-2184b07ba8db" providerId="ADAL" clId="{1BB04EDD-A3E3-453A-B4B6-6AA1C24487B8}" dt="2022-08-23T11:32:20.736" v="166"/>
          <ac:graphicFrameMkLst>
            <pc:docMk/>
            <pc:sldMk cId="2016114902" sldId="302"/>
            <ac:graphicFrameMk id="3" creationId="{A1C6BF0E-94B5-E79D-11F0-0DE6A56D05C8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1:32:56.846" v="169"/>
        <pc:sldMkLst>
          <pc:docMk/>
          <pc:sldMk cId="2405711615" sldId="303"/>
        </pc:sldMkLst>
        <pc:graphicFrameChg chg="mod">
          <ac:chgData name="Kaygisiz, Kübra" userId="4bfbf330-8776-4086-a830-2184b07ba8db" providerId="ADAL" clId="{1BB04EDD-A3E3-453A-B4B6-6AA1C24487B8}" dt="2022-08-23T11:32:56.846" v="169"/>
          <ac:graphicFrameMkLst>
            <pc:docMk/>
            <pc:sldMk cId="2405711615" sldId="303"/>
            <ac:graphicFrameMk id="3" creationId="{C02FC30C-74AC-BBD8-94EC-AD58FF376118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1:33:33.607" v="172"/>
        <pc:sldMkLst>
          <pc:docMk/>
          <pc:sldMk cId="4114209786" sldId="304"/>
        </pc:sldMkLst>
        <pc:graphicFrameChg chg="mod">
          <ac:chgData name="Kaygisiz, Kübra" userId="4bfbf330-8776-4086-a830-2184b07ba8db" providerId="ADAL" clId="{1BB04EDD-A3E3-453A-B4B6-6AA1C24487B8}" dt="2022-08-23T11:33:33.607" v="172"/>
          <ac:graphicFrameMkLst>
            <pc:docMk/>
            <pc:sldMk cId="4114209786" sldId="304"/>
            <ac:graphicFrameMk id="3" creationId="{CCB15E3C-1DB0-D9BE-D9BC-C6C1CA46132E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1:34:56.055" v="175"/>
        <pc:sldMkLst>
          <pc:docMk/>
          <pc:sldMk cId="2441172026" sldId="305"/>
        </pc:sldMkLst>
        <pc:graphicFrameChg chg="mod">
          <ac:chgData name="Kaygisiz, Kübra" userId="4bfbf330-8776-4086-a830-2184b07ba8db" providerId="ADAL" clId="{1BB04EDD-A3E3-453A-B4B6-6AA1C24487B8}" dt="2022-08-23T11:34:56.055" v="175"/>
          <ac:graphicFrameMkLst>
            <pc:docMk/>
            <pc:sldMk cId="2441172026" sldId="305"/>
            <ac:graphicFrameMk id="5" creationId="{F65A1131-DB1B-0A3C-50E9-12946A24F84E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1:36:59.027" v="178"/>
        <pc:sldMkLst>
          <pc:docMk/>
          <pc:sldMk cId="4067679584" sldId="306"/>
        </pc:sldMkLst>
        <pc:graphicFrameChg chg="mod">
          <ac:chgData name="Kaygisiz, Kübra" userId="4bfbf330-8776-4086-a830-2184b07ba8db" providerId="ADAL" clId="{1BB04EDD-A3E3-453A-B4B6-6AA1C24487B8}" dt="2022-08-23T11:36:59.027" v="178"/>
          <ac:graphicFrameMkLst>
            <pc:docMk/>
            <pc:sldMk cId="4067679584" sldId="306"/>
            <ac:graphicFrameMk id="3" creationId="{F8512932-B216-CD4A-B959-FCEE03AF85B8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1:38:03.157" v="181"/>
        <pc:sldMkLst>
          <pc:docMk/>
          <pc:sldMk cId="763965190" sldId="307"/>
        </pc:sldMkLst>
        <pc:graphicFrameChg chg="mod">
          <ac:chgData name="Kaygisiz, Kübra" userId="4bfbf330-8776-4086-a830-2184b07ba8db" providerId="ADAL" clId="{1BB04EDD-A3E3-453A-B4B6-6AA1C24487B8}" dt="2022-08-23T11:38:03.157" v="181"/>
          <ac:graphicFrameMkLst>
            <pc:docMk/>
            <pc:sldMk cId="763965190" sldId="307"/>
            <ac:graphicFrameMk id="3" creationId="{20C47D5B-4459-7B1C-635A-53212593B0EF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1:38:55.919" v="184"/>
        <pc:sldMkLst>
          <pc:docMk/>
          <pc:sldMk cId="987594625" sldId="308"/>
        </pc:sldMkLst>
        <pc:graphicFrameChg chg="mod">
          <ac:chgData name="Kaygisiz, Kübra" userId="4bfbf330-8776-4086-a830-2184b07ba8db" providerId="ADAL" clId="{1BB04EDD-A3E3-453A-B4B6-6AA1C24487B8}" dt="2022-08-23T11:38:55.919" v="184"/>
          <ac:graphicFrameMkLst>
            <pc:docMk/>
            <pc:sldMk cId="987594625" sldId="308"/>
            <ac:graphicFrameMk id="3" creationId="{FB751166-C1F8-23D0-D9CD-A5AB22D27543}"/>
          </ac:graphicFrameMkLst>
        </pc:graphicFrameChg>
        <pc:graphicFrameChg chg="add mod">
          <ac:chgData name="Kaygisiz, Kübra" userId="4bfbf330-8776-4086-a830-2184b07ba8db" providerId="ADAL" clId="{1BB04EDD-A3E3-453A-B4B6-6AA1C24487B8}" dt="2022-08-21T11:42:43.944" v="38" actId="1076"/>
          <ac:graphicFrameMkLst>
            <pc:docMk/>
            <pc:sldMk cId="987594625" sldId="308"/>
            <ac:graphicFrameMk id="4" creationId="{74DE949A-E36D-6AA7-8938-4D5209D7A405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1:40:20.116" v="187"/>
        <pc:sldMkLst>
          <pc:docMk/>
          <pc:sldMk cId="2310401326" sldId="309"/>
        </pc:sldMkLst>
        <pc:graphicFrameChg chg="mod">
          <ac:chgData name="Kaygisiz, Kübra" userId="4bfbf330-8776-4086-a830-2184b07ba8db" providerId="ADAL" clId="{1BB04EDD-A3E3-453A-B4B6-6AA1C24487B8}" dt="2022-08-23T11:40:20.116" v="187"/>
          <ac:graphicFrameMkLst>
            <pc:docMk/>
            <pc:sldMk cId="2310401326" sldId="309"/>
            <ac:graphicFrameMk id="3" creationId="{98DF8AB7-29AE-0F61-20FA-9298A0A5FFC6}"/>
          </ac:graphicFrameMkLst>
        </pc:graphicFrameChg>
      </pc:sldChg>
      <pc:sldChg chg="modSp mod">
        <pc:chgData name="Kaygisiz, Kübra" userId="4bfbf330-8776-4086-a830-2184b07ba8db" providerId="ADAL" clId="{1BB04EDD-A3E3-453A-B4B6-6AA1C24487B8}" dt="2022-08-23T11:42:04.634" v="191"/>
        <pc:sldMkLst>
          <pc:docMk/>
          <pc:sldMk cId="1689812694" sldId="310"/>
        </pc:sldMkLst>
        <pc:graphicFrameChg chg="mod">
          <ac:chgData name="Kaygisiz, Kübra" userId="4bfbf330-8776-4086-a830-2184b07ba8db" providerId="ADAL" clId="{1BB04EDD-A3E3-453A-B4B6-6AA1C24487B8}" dt="2022-08-23T11:42:04.634" v="191"/>
          <ac:graphicFrameMkLst>
            <pc:docMk/>
            <pc:sldMk cId="1689812694" sldId="310"/>
            <ac:graphicFrameMk id="3" creationId="{B4E6F0D2-E5C1-9461-2220-D28A3E40418B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1:42:52.416" v="194"/>
        <pc:sldMkLst>
          <pc:docMk/>
          <pc:sldMk cId="419106980" sldId="311"/>
        </pc:sldMkLst>
        <pc:graphicFrameChg chg="add mod">
          <ac:chgData name="Kaygisiz, Kübra" userId="4bfbf330-8776-4086-a830-2184b07ba8db" providerId="ADAL" clId="{1BB04EDD-A3E3-453A-B4B6-6AA1C24487B8}" dt="2022-08-23T11:42:52.416" v="194"/>
          <ac:graphicFrameMkLst>
            <pc:docMk/>
            <pc:sldMk cId="419106980" sldId="311"/>
            <ac:graphicFrameMk id="3" creationId="{9EE2D2F2-006D-F568-7F33-5092F3BE8F25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1:43:41.576" v="197"/>
        <pc:sldMkLst>
          <pc:docMk/>
          <pc:sldMk cId="1431698952" sldId="312"/>
        </pc:sldMkLst>
        <pc:graphicFrameChg chg="add mod">
          <ac:chgData name="Kaygisiz, Kübra" userId="4bfbf330-8776-4086-a830-2184b07ba8db" providerId="ADAL" clId="{1BB04EDD-A3E3-453A-B4B6-6AA1C24487B8}" dt="2022-08-23T11:43:41.576" v="197"/>
          <ac:graphicFrameMkLst>
            <pc:docMk/>
            <pc:sldMk cId="1431698952" sldId="312"/>
            <ac:graphicFrameMk id="3" creationId="{B50C3C23-4BE0-D8C8-869A-58480BD2318A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1:44:23.309" v="200"/>
        <pc:sldMkLst>
          <pc:docMk/>
          <pc:sldMk cId="3859182696" sldId="313"/>
        </pc:sldMkLst>
        <pc:graphicFrameChg chg="add mod">
          <ac:chgData name="Kaygisiz, Kübra" userId="4bfbf330-8776-4086-a830-2184b07ba8db" providerId="ADAL" clId="{1BB04EDD-A3E3-453A-B4B6-6AA1C24487B8}" dt="2022-08-23T11:44:23.309" v="200"/>
          <ac:graphicFrameMkLst>
            <pc:docMk/>
            <pc:sldMk cId="3859182696" sldId="313"/>
            <ac:graphicFrameMk id="3" creationId="{53030F4E-A0BD-9A75-47B1-1822CB401F46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1:46:16.896" v="203"/>
        <pc:sldMkLst>
          <pc:docMk/>
          <pc:sldMk cId="113699548" sldId="314"/>
        </pc:sldMkLst>
        <pc:graphicFrameChg chg="add mod">
          <ac:chgData name="Kaygisiz, Kübra" userId="4bfbf330-8776-4086-a830-2184b07ba8db" providerId="ADAL" clId="{1BB04EDD-A3E3-453A-B4B6-6AA1C24487B8}" dt="2022-08-23T11:46:16.896" v="203"/>
          <ac:graphicFrameMkLst>
            <pc:docMk/>
            <pc:sldMk cId="113699548" sldId="314"/>
            <ac:graphicFrameMk id="3" creationId="{8C6E1C5D-A648-83D6-63C8-52DAB799EB13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1:49:56.530" v="206"/>
        <pc:sldMkLst>
          <pc:docMk/>
          <pc:sldMk cId="2559766795" sldId="315"/>
        </pc:sldMkLst>
        <pc:graphicFrameChg chg="add mod">
          <ac:chgData name="Kaygisiz, Kübra" userId="4bfbf330-8776-4086-a830-2184b07ba8db" providerId="ADAL" clId="{1BB04EDD-A3E3-453A-B4B6-6AA1C24487B8}" dt="2022-08-23T11:49:56.530" v="206"/>
          <ac:graphicFrameMkLst>
            <pc:docMk/>
            <pc:sldMk cId="2559766795" sldId="315"/>
            <ac:graphicFrameMk id="3" creationId="{DD461AB0-1002-C89D-90DA-7183BFE40089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1:50:39.907" v="209"/>
        <pc:sldMkLst>
          <pc:docMk/>
          <pc:sldMk cId="1545965503" sldId="316"/>
        </pc:sldMkLst>
        <pc:graphicFrameChg chg="mod">
          <ac:chgData name="Kaygisiz, Kübra" userId="4bfbf330-8776-4086-a830-2184b07ba8db" providerId="ADAL" clId="{1BB04EDD-A3E3-453A-B4B6-6AA1C24487B8}" dt="2022-08-21T11:36:41.137" v="20" actId="1076"/>
          <ac:graphicFrameMkLst>
            <pc:docMk/>
            <pc:sldMk cId="1545965503" sldId="316"/>
            <ac:graphicFrameMk id="3" creationId="{CC70E3E1-624B-979A-996A-95ADB5957BF7}"/>
          </ac:graphicFrameMkLst>
        </pc:graphicFrameChg>
        <pc:graphicFrameChg chg="add mod">
          <ac:chgData name="Kaygisiz, Kübra" userId="4bfbf330-8776-4086-a830-2184b07ba8db" providerId="ADAL" clId="{1BB04EDD-A3E3-453A-B4B6-6AA1C24487B8}" dt="2022-08-23T11:50:39.907" v="209"/>
          <ac:graphicFrameMkLst>
            <pc:docMk/>
            <pc:sldMk cId="1545965503" sldId="316"/>
            <ac:graphicFrameMk id="4" creationId="{9256F613-15D4-9465-B5F7-09D8EDDFAA14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1:51:39.671" v="212"/>
        <pc:sldMkLst>
          <pc:docMk/>
          <pc:sldMk cId="2041474977" sldId="317"/>
        </pc:sldMkLst>
        <pc:graphicFrameChg chg="mod">
          <ac:chgData name="Kaygisiz, Kübra" userId="4bfbf330-8776-4086-a830-2184b07ba8db" providerId="ADAL" clId="{1BB04EDD-A3E3-453A-B4B6-6AA1C24487B8}" dt="2022-08-23T11:51:39.671" v="212"/>
          <ac:graphicFrameMkLst>
            <pc:docMk/>
            <pc:sldMk cId="2041474977" sldId="317"/>
            <ac:graphicFrameMk id="3" creationId="{17250403-2DD8-17A2-A469-5EE18AA2C766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1:52:18.886" v="215"/>
        <pc:sldMkLst>
          <pc:docMk/>
          <pc:sldMk cId="2351088502" sldId="318"/>
        </pc:sldMkLst>
        <pc:graphicFrameChg chg="add mod">
          <ac:chgData name="Kaygisiz, Kübra" userId="4bfbf330-8776-4086-a830-2184b07ba8db" providerId="ADAL" clId="{1BB04EDD-A3E3-453A-B4B6-6AA1C24487B8}" dt="2022-08-23T11:52:18.886" v="215"/>
          <ac:graphicFrameMkLst>
            <pc:docMk/>
            <pc:sldMk cId="2351088502" sldId="318"/>
            <ac:graphicFrameMk id="3" creationId="{C248C8BB-5769-6ACD-9357-BBE0E3722765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1:53:30.887" v="218"/>
        <pc:sldMkLst>
          <pc:docMk/>
          <pc:sldMk cId="3991689879" sldId="319"/>
        </pc:sldMkLst>
        <pc:graphicFrameChg chg="mod">
          <ac:chgData name="Kaygisiz, Kübra" userId="4bfbf330-8776-4086-a830-2184b07ba8db" providerId="ADAL" clId="{1BB04EDD-A3E3-453A-B4B6-6AA1C24487B8}" dt="2022-08-23T11:53:30.887" v="218"/>
          <ac:graphicFrameMkLst>
            <pc:docMk/>
            <pc:sldMk cId="3991689879" sldId="319"/>
            <ac:graphicFrameMk id="3" creationId="{C709CED4-15BC-9476-6F2C-AC6EE5118CAA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1:54:01.584" v="221"/>
        <pc:sldMkLst>
          <pc:docMk/>
          <pc:sldMk cId="177861567" sldId="320"/>
        </pc:sldMkLst>
        <pc:graphicFrameChg chg="mod">
          <ac:chgData name="Kaygisiz, Kübra" userId="4bfbf330-8776-4086-a830-2184b07ba8db" providerId="ADAL" clId="{1BB04EDD-A3E3-453A-B4B6-6AA1C24487B8}" dt="2022-08-23T11:54:01.584" v="221"/>
          <ac:graphicFrameMkLst>
            <pc:docMk/>
            <pc:sldMk cId="177861567" sldId="320"/>
            <ac:graphicFrameMk id="3" creationId="{88CB67B6-5576-DA24-C04D-72A8C4224FAA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1:54:24.184" v="224"/>
        <pc:sldMkLst>
          <pc:docMk/>
          <pc:sldMk cId="2153042501" sldId="321"/>
        </pc:sldMkLst>
        <pc:graphicFrameChg chg="mod">
          <ac:chgData name="Kaygisiz, Kübra" userId="4bfbf330-8776-4086-a830-2184b07ba8db" providerId="ADAL" clId="{1BB04EDD-A3E3-453A-B4B6-6AA1C24487B8}" dt="2022-08-23T11:54:24.184" v="224"/>
          <ac:graphicFrameMkLst>
            <pc:docMk/>
            <pc:sldMk cId="2153042501" sldId="321"/>
            <ac:graphicFrameMk id="3" creationId="{BE3F8CF9-94DD-40C5-01AD-BA18D06D75FE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1:55:16.499" v="227"/>
        <pc:sldMkLst>
          <pc:docMk/>
          <pc:sldMk cId="2688409802" sldId="322"/>
        </pc:sldMkLst>
        <pc:graphicFrameChg chg="add mod">
          <ac:chgData name="Kaygisiz, Kübra" userId="4bfbf330-8776-4086-a830-2184b07ba8db" providerId="ADAL" clId="{1BB04EDD-A3E3-453A-B4B6-6AA1C24487B8}" dt="2022-08-23T11:55:16.499" v="227"/>
          <ac:graphicFrameMkLst>
            <pc:docMk/>
            <pc:sldMk cId="2688409802" sldId="322"/>
            <ac:graphicFrameMk id="3" creationId="{5253DA81-4971-87A8-AF92-DAFD1905D8F9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1:55:50.946" v="230"/>
        <pc:sldMkLst>
          <pc:docMk/>
          <pc:sldMk cId="1920020108" sldId="323"/>
        </pc:sldMkLst>
        <pc:graphicFrameChg chg="mod">
          <ac:chgData name="Kaygisiz, Kübra" userId="4bfbf330-8776-4086-a830-2184b07ba8db" providerId="ADAL" clId="{1BB04EDD-A3E3-453A-B4B6-6AA1C24487B8}" dt="2022-08-23T11:55:50.946" v="230"/>
          <ac:graphicFrameMkLst>
            <pc:docMk/>
            <pc:sldMk cId="1920020108" sldId="323"/>
            <ac:graphicFrameMk id="3" creationId="{8A8CB048-90F9-CB30-3370-BFD140CAB733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1:56:35.796" v="233"/>
        <pc:sldMkLst>
          <pc:docMk/>
          <pc:sldMk cId="1727516209" sldId="324"/>
        </pc:sldMkLst>
        <pc:graphicFrameChg chg="mod">
          <ac:chgData name="Kaygisiz, Kübra" userId="4bfbf330-8776-4086-a830-2184b07ba8db" providerId="ADAL" clId="{1BB04EDD-A3E3-453A-B4B6-6AA1C24487B8}" dt="2022-08-23T11:56:35.796" v="233"/>
          <ac:graphicFrameMkLst>
            <pc:docMk/>
            <pc:sldMk cId="1727516209" sldId="324"/>
            <ac:graphicFrameMk id="3" creationId="{FFF8AD63-E72F-4786-932C-B644638F10C6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1:57:51.956" v="236"/>
        <pc:sldMkLst>
          <pc:docMk/>
          <pc:sldMk cId="111667840" sldId="325"/>
        </pc:sldMkLst>
        <pc:graphicFrameChg chg="mod">
          <ac:chgData name="Kaygisiz, Kübra" userId="4bfbf330-8776-4086-a830-2184b07ba8db" providerId="ADAL" clId="{1BB04EDD-A3E3-453A-B4B6-6AA1C24487B8}" dt="2022-08-23T11:57:51.956" v="236"/>
          <ac:graphicFrameMkLst>
            <pc:docMk/>
            <pc:sldMk cId="111667840" sldId="325"/>
            <ac:graphicFrameMk id="3" creationId="{A2B8719F-8685-4D65-8D20-21338BB33AB2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1:58:16.998" v="239"/>
        <pc:sldMkLst>
          <pc:docMk/>
          <pc:sldMk cId="1460808408" sldId="326"/>
        </pc:sldMkLst>
        <pc:graphicFrameChg chg="mod">
          <ac:chgData name="Kaygisiz, Kübra" userId="4bfbf330-8776-4086-a830-2184b07ba8db" providerId="ADAL" clId="{1BB04EDD-A3E3-453A-B4B6-6AA1C24487B8}" dt="2022-08-23T11:58:16.998" v="239"/>
          <ac:graphicFrameMkLst>
            <pc:docMk/>
            <pc:sldMk cId="1460808408" sldId="326"/>
            <ac:graphicFrameMk id="3" creationId="{C47A0BC4-71BC-5B6D-2C8D-A0F03D9F979F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1:59:03.344" v="242"/>
        <pc:sldMkLst>
          <pc:docMk/>
          <pc:sldMk cId="475343453" sldId="327"/>
        </pc:sldMkLst>
        <pc:graphicFrameChg chg="add mod">
          <ac:chgData name="Kaygisiz, Kübra" userId="4bfbf330-8776-4086-a830-2184b07ba8db" providerId="ADAL" clId="{1BB04EDD-A3E3-453A-B4B6-6AA1C24487B8}" dt="2022-08-23T11:59:03.344" v="242"/>
          <ac:graphicFrameMkLst>
            <pc:docMk/>
            <pc:sldMk cId="475343453" sldId="327"/>
            <ac:graphicFrameMk id="3" creationId="{AE5AD7B3-601A-5BFD-8A0C-75CBA020C7EB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1:59:52.945" v="245"/>
        <pc:sldMkLst>
          <pc:docMk/>
          <pc:sldMk cId="3262892428" sldId="328"/>
        </pc:sldMkLst>
        <pc:graphicFrameChg chg="add mod">
          <ac:chgData name="Kaygisiz, Kübra" userId="4bfbf330-8776-4086-a830-2184b07ba8db" providerId="ADAL" clId="{1BB04EDD-A3E3-453A-B4B6-6AA1C24487B8}" dt="2022-08-23T11:59:52.945" v="245"/>
          <ac:graphicFrameMkLst>
            <pc:docMk/>
            <pc:sldMk cId="3262892428" sldId="328"/>
            <ac:graphicFrameMk id="3" creationId="{4E162DDE-EFE0-93E6-CCA0-005C8AE894D7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2:00:42.631" v="248"/>
        <pc:sldMkLst>
          <pc:docMk/>
          <pc:sldMk cId="3031801590" sldId="329"/>
        </pc:sldMkLst>
        <pc:graphicFrameChg chg="add mod">
          <ac:chgData name="Kaygisiz, Kübra" userId="4bfbf330-8776-4086-a830-2184b07ba8db" providerId="ADAL" clId="{1BB04EDD-A3E3-453A-B4B6-6AA1C24487B8}" dt="2022-08-23T12:00:42.631" v="248"/>
          <ac:graphicFrameMkLst>
            <pc:docMk/>
            <pc:sldMk cId="3031801590" sldId="329"/>
            <ac:graphicFrameMk id="3" creationId="{183BC702-71D8-0B3F-79A2-E1A9BDDDF8E8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01:08.949" v="251"/>
        <pc:sldMkLst>
          <pc:docMk/>
          <pc:sldMk cId="3853370157" sldId="330"/>
        </pc:sldMkLst>
        <pc:graphicFrameChg chg="mod">
          <ac:chgData name="Kaygisiz, Kübra" userId="4bfbf330-8776-4086-a830-2184b07ba8db" providerId="ADAL" clId="{1BB04EDD-A3E3-453A-B4B6-6AA1C24487B8}" dt="2022-08-23T12:01:08.949" v="251"/>
          <ac:graphicFrameMkLst>
            <pc:docMk/>
            <pc:sldMk cId="3853370157" sldId="330"/>
            <ac:graphicFrameMk id="3" creationId="{63E2FB85-C666-5C39-BA2C-B74F2DD4CA37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2:01:59.197" v="254"/>
        <pc:sldMkLst>
          <pc:docMk/>
          <pc:sldMk cId="1962231915" sldId="331"/>
        </pc:sldMkLst>
        <pc:graphicFrameChg chg="add mod">
          <ac:chgData name="Kaygisiz, Kübra" userId="4bfbf330-8776-4086-a830-2184b07ba8db" providerId="ADAL" clId="{1BB04EDD-A3E3-453A-B4B6-6AA1C24487B8}" dt="2022-08-23T12:01:59.197" v="254"/>
          <ac:graphicFrameMkLst>
            <pc:docMk/>
            <pc:sldMk cId="1962231915" sldId="331"/>
            <ac:graphicFrameMk id="3" creationId="{D824F1F0-8452-76A4-9B1A-2656D0F952BD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02:46.529" v="257"/>
        <pc:sldMkLst>
          <pc:docMk/>
          <pc:sldMk cId="3901561466" sldId="332"/>
        </pc:sldMkLst>
        <pc:graphicFrameChg chg="mod">
          <ac:chgData name="Kaygisiz, Kübra" userId="4bfbf330-8776-4086-a830-2184b07ba8db" providerId="ADAL" clId="{1BB04EDD-A3E3-453A-B4B6-6AA1C24487B8}" dt="2022-08-23T12:02:46.529" v="257"/>
          <ac:graphicFrameMkLst>
            <pc:docMk/>
            <pc:sldMk cId="3901561466" sldId="332"/>
            <ac:graphicFrameMk id="3" creationId="{BDAD28CC-A52F-B9DC-308C-C256C623BD98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2:03:43.047" v="260"/>
        <pc:sldMkLst>
          <pc:docMk/>
          <pc:sldMk cId="3003807109" sldId="333"/>
        </pc:sldMkLst>
        <pc:graphicFrameChg chg="add mod">
          <ac:chgData name="Kaygisiz, Kübra" userId="4bfbf330-8776-4086-a830-2184b07ba8db" providerId="ADAL" clId="{1BB04EDD-A3E3-453A-B4B6-6AA1C24487B8}" dt="2022-08-23T12:03:43.047" v="260"/>
          <ac:graphicFrameMkLst>
            <pc:docMk/>
            <pc:sldMk cId="3003807109" sldId="333"/>
            <ac:graphicFrameMk id="3" creationId="{FABF5DF3-1ECC-7C6B-5772-010751BAF097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2:04:52.685" v="263"/>
        <pc:sldMkLst>
          <pc:docMk/>
          <pc:sldMk cId="3461780314" sldId="334"/>
        </pc:sldMkLst>
        <pc:graphicFrameChg chg="add mod">
          <ac:chgData name="Kaygisiz, Kübra" userId="4bfbf330-8776-4086-a830-2184b07ba8db" providerId="ADAL" clId="{1BB04EDD-A3E3-453A-B4B6-6AA1C24487B8}" dt="2022-08-23T12:04:52.685" v="263"/>
          <ac:graphicFrameMkLst>
            <pc:docMk/>
            <pc:sldMk cId="3461780314" sldId="334"/>
            <ac:graphicFrameMk id="3" creationId="{E897E94C-C84E-45C4-C319-6AE12739F6B3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04:57.776" v="266"/>
        <pc:sldMkLst>
          <pc:docMk/>
          <pc:sldMk cId="1096788961" sldId="335"/>
        </pc:sldMkLst>
        <pc:graphicFrameChg chg="mod">
          <ac:chgData name="Kaygisiz, Kübra" userId="4bfbf330-8776-4086-a830-2184b07ba8db" providerId="ADAL" clId="{1BB04EDD-A3E3-453A-B4B6-6AA1C24487B8}" dt="2022-08-23T12:04:57.776" v="266"/>
          <ac:graphicFrameMkLst>
            <pc:docMk/>
            <pc:sldMk cId="1096788961" sldId="335"/>
            <ac:graphicFrameMk id="3" creationId="{667EB70F-F25D-2A31-CFFE-6CBB5B151244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05:01.585" v="268"/>
        <pc:sldMkLst>
          <pc:docMk/>
          <pc:sldMk cId="3804239503" sldId="336"/>
        </pc:sldMkLst>
        <pc:graphicFrameChg chg="mod">
          <ac:chgData name="Kaygisiz, Kübra" userId="4bfbf330-8776-4086-a830-2184b07ba8db" providerId="ADAL" clId="{1BB04EDD-A3E3-453A-B4B6-6AA1C24487B8}" dt="2022-08-23T12:05:01.585" v="268"/>
          <ac:graphicFrameMkLst>
            <pc:docMk/>
            <pc:sldMk cId="3804239503" sldId="336"/>
            <ac:graphicFrameMk id="3" creationId="{3EFCAF93-C30B-4FB4-D489-3EFFD08E1BFA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2:09:00.195" v="271"/>
        <pc:sldMkLst>
          <pc:docMk/>
          <pc:sldMk cId="1222299476" sldId="337"/>
        </pc:sldMkLst>
        <pc:graphicFrameChg chg="add mod">
          <ac:chgData name="Kaygisiz, Kübra" userId="4bfbf330-8776-4086-a830-2184b07ba8db" providerId="ADAL" clId="{1BB04EDD-A3E3-453A-B4B6-6AA1C24487B8}" dt="2022-08-23T12:09:00.195" v="271"/>
          <ac:graphicFrameMkLst>
            <pc:docMk/>
            <pc:sldMk cId="1222299476" sldId="337"/>
            <ac:graphicFrameMk id="3" creationId="{27BF0AC5-A31B-3A69-2D76-8B9A59772B89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2:09:05.826" v="274"/>
        <pc:sldMkLst>
          <pc:docMk/>
          <pc:sldMk cId="3512817995" sldId="338"/>
        </pc:sldMkLst>
        <pc:graphicFrameChg chg="add mod">
          <ac:chgData name="Kaygisiz, Kübra" userId="4bfbf330-8776-4086-a830-2184b07ba8db" providerId="ADAL" clId="{1BB04EDD-A3E3-453A-B4B6-6AA1C24487B8}" dt="2022-08-23T12:09:05.826" v="274"/>
          <ac:graphicFrameMkLst>
            <pc:docMk/>
            <pc:sldMk cId="3512817995" sldId="338"/>
            <ac:graphicFrameMk id="3" creationId="{94AC87E8-41DA-F193-D2D7-6F693B0D6353}"/>
          </ac:graphicFrameMkLst>
        </pc:graphicFrameChg>
        <pc:graphicFrameChg chg="add mod">
          <ac:chgData name="Kaygisiz, Kübra" userId="4bfbf330-8776-4086-a830-2184b07ba8db" providerId="ADAL" clId="{1BB04EDD-A3E3-453A-B4B6-6AA1C24487B8}" dt="2022-08-21T11:43:52.203" v="45" actId="1076"/>
          <ac:graphicFrameMkLst>
            <pc:docMk/>
            <pc:sldMk cId="3512817995" sldId="338"/>
            <ac:graphicFrameMk id="4" creationId="{8F013963-07C4-F334-5C69-73B97D91A2FC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2:09:11.135" v="277"/>
        <pc:sldMkLst>
          <pc:docMk/>
          <pc:sldMk cId="917755002" sldId="339"/>
        </pc:sldMkLst>
        <pc:graphicFrameChg chg="add mod">
          <ac:chgData name="Kaygisiz, Kübra" userId="4bfbf330-8776-4086-a830-2184b07ba8db" providerId="ADAL" clId="{1BB04EDD-A3E3-453A-B4B6-6AA1C24487B8}" dt="2022-08-23T12:09:11.135" v="277"/>
          <ac:graphicFrameMkLst>
            <pc:docMk/>
            <pc:sldMk cId="917755002" sldId="339"/>
            <ac:graphicFrameMk id="3" creationId="{19FE7DF3-FD76-E1A6-FF54-F156B87DD863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2:09:16.263" v="280"/>
        <pc:sldMkLst>
          <pc:docMk/>
          <pc:sldMk cId="3316588487" sldId="340"/>
        </pc:sldMkLst>
        <pc:graphicFrameChg chg="add mod">
          <ac:chgData name="Kaygisiz, Kübra" userId="4bfbf330-8776-4086-a830-2184b07ba8db" providerId="ADAL" clId="{1BB04EDD-A3E3-453A-B4B6-6AA1C24487B8}" dt="2022-08-23T12:09:16.263" v="280"/>
          <ac:graphicFrameMkLst>
            <pc:docMk/>
            <pc:sldMk cId="3316588487" sldId="340"/>
            <ac:graphicFrameMk id="3" creationId="{1E6A3179-70F6-B321-D305-701E47950048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2:09:21.205" v="283"/>
        <pc:sldMkLst>
          <pc:docMk/>
          <pc:sldMk cId="2590626734" sldId="341"/>
        </pc:sldMkLst>
        <pc:graphicFrameChg chg="mod">
          <ac:chgData name="Kaygisiz, Kübra" userId="4bfbf330-8776-4086-a830-2184b07ba8db" providerId="ADAL" clId="{1BB04EDD-A3E3-453A-B4B6-6AA1C24487B8}" dt="2022-08-23T12:09:21.205" v="283"/>
          <ac:graphicFrameMkLst>
            <pc:docMk/>
            <pc:sldMk cId="2590626734" sldId="341"/>
            <ac:graphicFrameMk id="3" creationId="{BD7206E8-29AA-7769-51EF-1275FF19C94C}"/>
          </ac:graphicFrameMkLst>
        </pc:graphicFrameChg>
        <pc:graphicFrameChg chg="add mod">
          <ac:chgData name="Kaygisiz, Kübra" userId="4bfbf330-8776-4086-a830-2184b07ba8db" providerId="ADAL" clId="{1BB04EDD-A3E3-453A-B4B6-6AA1C24487B8}" dt="2022-08-21T11:43:30.735" v="43" actId="1076"/>
          <ac:graphicFrameMkLst>
            <pc:docMk/>
            <pc:sldMk cId="2590626734" sldId="341"/>
            <ac:graphicFrameMk id="4" creationId="{4D19A840-9C13-E950-84B5-ACE9B9B35900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09:26.560" v="286"/>
        <pc:sldMkLst>
          <pc:docMk/>
          <pc:sldMk cId="1898536240" sldId="342"/>
        </pc:sldMkLst>
        <pc:graphicFrameChg chg="mod">
          <ac:chgData name="Kaygisiz, Kübra" userId="4bfbf330-8776-4086-a830-2184b07ba8db" providerId="ADAL" clId="{1BB04EDD-A3E3-453A-B4B6-6AA1C24487B8}" dt="2022-08-23T12:09:26.560" v="286"/>
          <ac:graphicFrameMkLst>
            <pc:docMk/>
            <pc:sldMk cId="1898536240" sldId="342"/>
            <ac:graphicFrameMk id="3" creationId="{0601A052-EEE1-BCBE-11CE-F719F9AE7462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09:32.360" v="289"/>
        <pc:sldMkLst>
          <pc:docMk/>
          <pc:sldMk cId="3408435681" sldId="343"/>
        </pc:sldMkLst>
        <pc:graphicFrameChg chg="mod">
          <ac:chgData name="Kaygisiz, Kübra" userId="4bfbf330-8776-4086-a830-2184b07ba8db" providerId="ADAL" clId="{1BB04EDD-A3E3-453A-B4B6-6AA1C24487B8}" dt="2022-08-23T12:09:32.360" v="289"/>
          <ac:graphicFrameMkLst>
            <pc:docMk/>
            <pc:sldMk cId="3408435681" sldId="343"/>
            <ac:graphicFrameMk id="3" creationId="{8FC483F1-D96B-C931-EDC1-1439D289561D}"/>
          </ac:graphicFrameMkLst>
        </pc:graphicFrameChg>
      </pc:sldChg>
      <pc:sldChg chg="modSp mod">
        <pc:chgData name="Kaygisiz, Kübra" userId="4bfbf330-8776-4086-a830-2184b07ba8db" providerId="ADAL" clId="{1BB04EDD-A3E3-453A-B4B6-6AA1C24487B8}" dt="2022-08-24T01:13:33.442" v="834" actId="1076"/>
        <pc:sldMkLst>
          <pc:docMk/>
          <pc:sldMk cId="2732038377" sldId="344"/>
        </pc:sldMkLst>
        <pc:graphicFrameChg chg="mod">
          <ac:chgData name="Kaygisiz, Kübra" userId="4bfbf330-8776-4086-a830-2184b07ba8db" providerId="ADAL" clId="{1BB04EDD-A3E3-453A-B4B6-6AA1C24487B8}" dt="2022-08-24T01:13:33.442" v="834" actId="1076"/>
          <ac:graphicFrameMkLst>
            <pc:docMk/>
            <pc:sldMk cId="2732038377" sldId="344"/>
            <ac:graphicFrameMk id="3" creationId="{2B4FAC3C-851F-7C26-84DE-C6232A11A626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09:43.757" v="295"/>
        <pc:sldMkLst>
          <pc:docMk/>
          <pc:sldMk cId="1949823724" sldId="345"/>
        </pc:sldMkLst>
        <pc:graphicFrameChg chg="mod">
          <ac:chgData name="Kaygisiz, Kübra" userId="4bfbf330-8776-4086-a830-2184b07ba8db" providerId="ADAL" clId="{1BB04EDD-A3E3-453A-B4B6-6AA1C24487B8}" dt="2022-08-23T12:09:43.757" v="295"/>
          <ac:graphicFrameMkLst>
            <pc:docMk/>
            <pc:sldMk cId="1949823724" sldId="345"/>
            <ac:graphicFrameMk id="3" creationId="{469EFA4B-12EF-A0BF-B393-FFDA1E5F04CE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09:49.063" v="298"/>
        <pc:sldMkLst>
          <pc:docMk/>
          <pc:sldMk cId="2170761285" sldId="346"/>
        </pc:sldMkLst>
        <pc:graphicFrameChg chg="mod">
          <ac:chgData name="Kaygisiz, Kübra" userId="4bfbf330-8776-4086-a830-2184b07ba8db" providerId="ADAL" clId="{1BB04EDD-A3E3-453A-B4B6-6AA1C24487B8}" dt="2022-08-23T12:09:49.063" v="298"/>
          <ac:graphicFrameMkLst>
            <pc:docMk/>
            <pc:sldMk cId="2170761285" sldId="346"/>
            <ac:graphicFrameMk id="3" creationId="{19017CC0-7629-B8D2-CE78-0036AD3017A0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09:54.411" v="301"/>
        <pc:sldMkLst>
          <pc:docMk/>
          <pc:sldMk cId="1071448602" sldId="347"/>
        </pc:sldMkLst>
        <pc:graphicFrameChg chg="mod">
          <ac:chgData name="Kaygisiz, Kübra" userId="4bfbf330-8776-4086-a830-2184b07ba8db" providerId="ADAL" clId="{1BB04EDD-A3E3-453A-B4B6-6AA1C24487B8}" dt="2022-08-23T12:09:54.411" v="301"/>
          <ac:graphicFrameMkLst>
            <pc:docMk/>
            <pc:sldMk cId="1071448602" sldId="347"/>
            <ac:graphicFrameMk id="3" creationId="{CB669263-DA24-D1CC-DACC-C5327A3E0DF4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09:59.236" v="304"/>
        <pc:sldMkLst>
          <pc:docMk/>
          <pc:sldMk cId="1423417698" sldId="348"/>
        </pc:sldMkLst>
        <pc:graphicFrameChg chg="mod">
          <ac:chgData name="Kaygisiz, Kübra" userId="4bfbf330-8776-4086-a830-2184b07ba8db" providerId="ADAL" clId="{1BB04EDD-A3E3-453A-B4B6-6AA1C24487B8}" dt="2022-08-23T12:09:59.236" v="304"/>
          <ac:graphicFrameMkLst>
            <pc:docMk/>
            <pc:sldMk cId="1423417698" sldId="348"/>
            <ac:graphicFrameMk id="3" creationId="{950DFCE5-BB35-3C1F-1CF8-696D7AE7CDDE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0:04.104" v="307"/>
        <pc:sldMkLst>
          <pc:docMk/>
          <pc:sldMk cId="2229018126" sldId="349"/>
        </pc:sldMkLst>
        <pc:graphicFrameChg chg="mod">
          <ac:chgData name="Kaygisiz, Kübra" userId="4bfbf330-8776-4086-a830-2184b07ba8db" providerId="ADAL" clId="{1BB04EDD-A3E3-453A-B4B6-6AA1C24487B8}" dt="2022-08-23T12:10:04.104" v="307"/>
          <ac:graphicFrameMkLst>
            <pc:docMk/>
            <pc:sldMk cId="2229018126" sldId="349"/>
            <ac:graphicFrameMk id="3" creationId="{2FFD85CD-F19E-5604-FFF9-272F2CB0E570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2:10:09.940" v="310"/>
        <pc:sldMkLst>
          <pc:docMk/>
          <pc:sldMk cId="2524499919" sldId="350"/>
        </pc:sldMkLst>
        <pc:graphicFrameChg chg="add mod">
          <ac:chgData name="Kaygisiz, Kübra" userId="4bfbf330-8776-4086-a830-2184b07ba8db" providerId="ADAL" clId="{1BB04EDD-A3E3-453A-B4B6-6AA1C24487B8}" dt="2022-08-23T12:10:09.940" v="310"/>
          <ac:graphicFrameMkLst>
            <pc:docMk/>
            <pc:sldMk cId="2524499919" sldId="350"/>
            <ac:graphicFrameMk id="3" creationId="{54FBD57C-C392-05F9-D005-926525589137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0:15.132" v="313"/>
        <pc:sldMkLst>
          <pc:docMk/>
          <pc:sldMk cId="3878398416" sldId="351"/>
        </pc:sldMkLst>
        <pc:graphicFrameChg chg="mod">
          <ac:chgData name="Kaygisiz, Kübra" userId="4bfbf330-8776-4086-a830-2184b07ba8db" providerId="ADAL" clId="{1BB04EDD-A3E3-453A-B4B6-6AA1C24487B8}" dt="2022-08-23T12:10:15.132" v="313"/>
          <ac:graphicFrameMkLst>
            <pc:docMk/>
            <pc:sldMk cId="3878398416" sldId="351"/>
            <ac:graphicFrameMk id="3" creationId="{8EC8BF19-5191-03E7-5553-6D2054749D62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0:19.896" v="316"/>
        <pc:sldMkLst>
          <pc:docMk/>
          <pc:sldMk cId="4268443313" sldId="352"/>
        </pc:sldMkLst>
        <pc:graphicFrameChg chg="mod">
          <ac:chgData name="Kaygisiz, Kübra" userId="4bfbf330-8776-4086-a830-2184b07ba8db" providerId="ADAL" clId="{1BB04EDD-A3E3-453A-B4B6-6AA1C24487B8}" dt="2022-08-23T12:10:19.896" v="316"/>
          <ac:graphicFrameMkLst>
            <pc:docMk/>
            <pc:sldMk cId="4268443313" sldId="352"/>
            <ac:graphicFrameMk id="3" creationId="{16795839-2AC1-ED72-32DF-2C486CC77266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0:24.102" v="319"/>
        <pc:sldMkLst>
          <pc:docMk/>
          <pc:sldMk cId="2150953503" sldId="353"/>
        </pc:sldMkLst>
        <pc:graphicFrameChg chg="mod">
          <ac:chgData name="Kaygisiz, Kübra" userId="4bfbf330-8776-4086-a830-2184b07ba8db" providerId="ADAL" clId="{1BB04EDD-A3E3-453A-B4B6-6AA1C24487B8}" dt="2022-08-23T12:10:24.102" v="319"/>
          <ac:graphicFrameMkLst>
            <pc:docMk/>
            <pc:sldMk cId="2150953503" sldId="353"/>
            <ac:graphicFrameMk id="3" creationId="{59F2FECD-D560-119B-0458-7D5C8C2ACE09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0:29.062" v="322"/>
        <pc:sldMkLst>
          <pc:docMk/>
          <pc:sldMk cId="3303159571" sldId="354"/>
        </pc:sldMkLst>
        <pc:graphicFrameChg chg="mod">
          <ac:chgData name="Kaygisiz, Kübra" userId="4bfbf330-8776-4086-a830-2184b07ba8db" providerId="ADAL" clId="{1BB04EDD-A3E3-453A-B4B6-6AA1C24487B8}" dt="2022-08-23T12:10:29.062" v="322"/>
          <ac:graphicFrameMkLst>
            <pc:docMk/>
            <pc:sldMk cId="3303159571" sldId="354"/>
            <ac:graphicFrameMk id="3" creationId="{DFD1B1F2-AFFD-DE1D-73C2-0A6828C132AB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0:34.071" v="325"/>
        <pc:sldMkLst>
          <pc:docMk/>
          <pc:sldMk cId="3754417479" sldId="355"/>
        </pc:sldMkLst>
        <pc:graphicFrameChg chg="mod">
          <ac:chgData name="Kaygisiz, Kübra" userId="4bfbf330-8776-4086-a830-2184b07ba8db" providerId="ADAL" clId="{1BB04EDD-A3E3-453A-B4B6-6AA1C24487B8}" dt="2022-08-23T12:10:34.071" v="325"/>
          <ac:graphicFrameMkLst>
            <pc:docMk/>
            <pc:sldMk cId="3754417479" sldId="355"/>
            <ac:graphicFrameMk id="3" creationId="{C01352EB-A412-F8D8-EC4A-E898D5BE091E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0:38.789" v="328"/>
        <pc:sldMkLst>
          <pc:docMk/>
          <pc:sldMk cId="4261912029" sldId="356"/>
        </pc:sldMkLst>
        <pc:graphicFrameChg chg="mod">
          <ac:chgData name="Kaygisiz, Kübra" userId="4bfbf330-8776-4086-a830-2184b07ba8db" providerId="ADAL" clId="{1BB04EDD-A3E3-453A-B4B6-6AA1C24487B8}" dt="2022-08-23T12:10:38.789" v="328"/>
          <ac:graphicFrameMkLst>
            <pc:docMk/>
            <pc:sldMk cId="4261912029" sldId="356"/>
            <ac:graphicFrameMk id="3" creationId="{417F5534-F94F-DF11-368B-6E8C4FAF69B4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0:44.125" v="331"/>
        <pc:sldMkLst>
          <pc:docMk/>
          <pc:sldMk cId="3849830204" sldId="357"/>
        </pc:sldMkLst>
        <pc:graphicFrameChg chg="mod">
          <ac:chgData name="Kaygisiz, Kübra" userId="4bfbf330-8776-4086-a830-2184b07ba8db" providerId="ADAL" clId="{1BB04EDD-A3E3-453A-B4B6-6AA1C24487B8}" dt="2022-08-23T12:10:44.125" v="331"/>
          <ac:graphicFrameMkLst>
            <pc:docMk/>
            <pc:sldMk cId="3849830204" sldId="357"/>
            <ac:graphicFrameMk id="3" creationId="{93070E35-FFB5-29D7-183F-DD0D023F275D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0:49.268" v="334"/>
        <pc:sldMkLst>
          <pc:docMk/>
          <pc:sldMk cId="2325294879" sldId="358"/>
        </pc:sldMkLst>
        <pc:graphicFrameChg chg="mod">
          <ac:chgData name="Kaygisiz, Kübra" userId="4bfbf330-8776-4086-a830-2184b07ba8db" providerId="ADAL" clId="{1BB04EDD-A3E3-453A-B4B6-6AA1C24487B8}" dt="2022-08-23T12:10:49.268" v="334"/>
          <ac:graphicFrameMkLst>
            <pc:docMk/>
            <pc:sldMk cId="2325294879" sldId="358"/>
            <ac:graphicFrameMk id="3" creationId="{5576CC9E-7A70-BB43-166C-38F3FC471B5D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0:54.471" v="337"/>
        <pc:sldMkLst>
          <pc:docMk/>
          <pc:sldMk cId="832366075" sldId="359"/>
        </pc:sldMkLst>
        <pc:graphicFrameChg chg="mod">
          <ac:chgData name="Kaygisiz, Kübra" userId="4bfbf330-8776-4086-a830-2184b07ba8db" providerId="ADAL" clId="{1BB04EDD-A3E3-453A-B4B6-6AA1C24487B8}" dt="2022-08-23T12:10:54.471" v="337"/>
          <ac:graphicFrameMkLst>
            <pc:docMk/>
            <pc:sldMk cId="832366075" sldId="359"/>
            <ac:graphicFrameMk id="3" creationId="{406D8059-D3CA-1850-D15E-A28381C67CB7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0:59.613" v="340"/>
        <pc:sldMkLst>
          <pc:docMk/>
          <pc:sldMk cId="1166448720" sldId="360"/>
        </pc:sldMkLst>
        <pc:graphicFrameChg chg="mod">
          <ac:chgData name="Kaygisiz, Kübra" userId="4bfbf330-8776-4086-a830-2184b07ba8db" providerId="ADAL" clId="{1BB04EDD-A3E3-453A-B4B6-6AA1C24487B8}" dt="2022-08-23T12:10:59.613" v="340"/>
          <ac:graphicFrameMkLst>
            <pc:docMk/>
            <pc:sldMk cId="1166448720" sldId="360"/>
            <ac:graphicFrameMk id="3" creationId="{DBBFC1CF-8F69-6EEB-F29B-D2FCA646B36E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1:04.424" v="343"/>
        <pc:sldMkLst>
          <pc:docMk/>
          <pc:sldMk cId="3818165673" sldId="361"/>
        </pc:sldMkLst>
        <pc:graphicFrameChg chg="mod">
          <ac:chgData name="Kaygisiz, Kübra" userId="4bfbf330-8776-4086-a830-2184b07ba8db" providerId="ADAL" clId="{1BB04EDD-A3E3-453A-B4B6-6AA1C24487B8}" dt="2022-08-23T12:11:04.424" v="343"/>
          <ac:graphicFrameMkLst>
            <pc:docMk/>
            <pc:sldMk cId="3818165673" sldId="361"/>
            <ac:graphicFrameMk id="3" creationId="{7A47B578-36B6-CB4A-C062-62F97098A8F5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1:09.462" v="346"/>
        <pc:sldMkLst>
          <pc:docMk/>
          <pc:sldMk cId="2111211650" sldId="362"/>
        </pc:sldMkLst>
        <pc:graphicFrameChg chg="mod">
          <ac:chgData name="Kaygisiz, Kübra" userId="4bfbf330-8776-4086-a830-2184b07ba8db" providerId="ADAL" clId="{1BB04EDD-A3E3-453A-B4B6-6AA1C24487B8}" dt="2022-08-23T12:11:09.462" v="346"/>
          <ac:graphicFrameMkLst>
            <pc:docMk/>
            <pc:sldMk cId="2111211650" sldId="362"/>
            <ac:graphicFrameMk id="3" creationId="{07FE2699-10A8-6654-DC28-DD96DDB1C3FB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2:11:21.191" v="349"/>
        <pc:sldMkLst>
          <pc:docMk/>
          <pc:sldMk cId="3321173272" sldId="363"/>
        </pc:sldMkLst>
        <pc:graphicFrameChg chg="add mod">
          <ac:chgData name="Kaygisiz, Kübra" userId="4bfbf330-8776-4086-a830-2184b07ba8db" providerId="ADAL" clId="{1BB04EDD-A3E3-453A-B4B6-6AA1C24487B8}" dt="2022-08-23T12:11:21.191" v="349"/>
          <ac:graphicFrameMkLst>
            <pc:docMk/>
            <pc:sldMk cId="3321173272" sldId="363"/>
            <ac:graphicFrameMk id="3" creationId="{533F8CE2-3706-EF85-816A-601A98D7259F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1:26.073" v="352"/>
        <pc:sldMkLst>
          <pc:docMk/>
          <pc:sldMk cId="2176846643" sldId="364"/>
        </pc:sldMkLst>
        <pc:graphicFrameChg chg="mod">
          <ac:chgData name="Kaygisiz, Kübra" userId="4bfbf330-8776-4086-a830-2184b07ba8db" providerId="ADAL" clId="{1BB04EDD-A3E3-453A-B4B6-6AA1C24487B8}" dt="2022-08-23T12:11:26.073" v="352"/>
          <ac:graphicFrameMkLst>
            <pc:docMk/>
            <pc:sldMk cId="2176846643" sldId="364"/>
            <ac:graphicFrameMk id="3" creationId="{026241E1-CE80-47CB-98CE-4B17DAD26132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1:31.808" v="355"/>
        <pc:sldMkLst>
          <pc:docMk/>
          <pc:sldMk cId="2678723006" sldId="365"/>
        </pc:sldMkLst>
        <pc:graphicFrameChg chg="mod">
          <ac:chgData name="Kaygisiz, Kübra" userId="4bfbf330-8776-4086-a830-2184b07ba8db" providerId="ADAL" clId="{1BB04EDD-A3E3-453A-B4B6-6AA1C24487B8}" dt="2022-08-23T12:11:31.808" v="355"/>
          <ac:graphicFrameMkLst>
            <pc:docMk/>
            <pc:sldMk cId="2678723006" sldId="365"/>
            <ac:graphicFrameMk id="3" creationId="{C062D2C8-A389-BA4F-8351-E603BDDC2A79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1:39.629" v="358"/>
        <pc:sldMkLst>
          <pc:docMk/>
          <pc:sldMk cId="2179992125" sldId="366"/>
        </pc:sldMkLst>
        <pc:graphicFrameChg chg="mod">
          <ac:chgData name="Kaygisiz, Kübra" userId="4bfbf330-8776-4086-a830-2184b07ba8db" providerId="ADAL" clId="{1BB04EDD-A3E3-453A-B4B6-6AA1C24487B8}" dt="2022-08-23T12:11:39.629" v="358"/>
          <ac:graphicFrameMkLst>
            <pc:docMk/>
            <pc:sldMk cId="2179992125" sldId="366"/>
            <ac:graphicFrameMk id="3" creationId="{34CA6013-FE78-732E-013A-EA2F5C381F7A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1:44.947" v="361"/>
        <pc:sldMkLst>
          <pc:docMk/>
          <pc:sldMk cId="3819945086" sldId="367"/>
        </pc:sldMkLst>
        <pc:graphicFrameChg chg="mod">
          <ac:chgData name="Kaygisiz, Kübra" userId="4bfbf330-8776-4086-a830-2184b07ba8db" providerId="ADAL" clId="{1BB04EDD-A3E3-453A-B4B6-6AA1C24487B8}" dt="2022-08-23T12:11:44.947" v="361"/>
          <ac:graphicFrameMkLst>
            <pc:docMk/>
            <pc:sldMk cId="3819945086" sldId="367"/>
            <ac:graphicFrameMk id="3" creationId="{02E79350-6140-2E70-BF98-C8CC53CF03C4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1:51.093" v="364"/>
        <pc:sldMkLst>
          <pc:docMk/>
          <pc:sldMk cId="99275166" sldId="368"/>
        </pc:sldMkLst>
        <pc:graphicFrameChg chg="mod">
          <ac:chgData name="Kaygisiz, Kübra" userId="4bfbf330-8776-4086-a830-2184b07ba8db" providerId="ADAL" clId="{1BB04EDD-A3E3-453A-B4B6-6AA1C24487B8}" dt="2022-08-23T12:11:51.093" v="364"/>
          <ac:graphicFrameMkLst>
            <pc:docMk/>
            <pc:sldMk cId="99275166" sldId="368"/>
            <ac:graphicFrameMk id="3" creationId="{844304D3-F325-650B-1C82-8D40925D9CCF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1:56.756" v="367"/>
        <pc:sldMkLst>
          <pc:docMk/>
          <pc:sldMk cId="3064084829" sldId="369"/>
        </pc:sldMkLst>
        <pc:graphicFrameChg chg="mod">
          <ac:chgData name="Kaygisiz, Kübra" userId="4bfbf330-8776-4086-a830-2184b07ba8db" providerId="ADAL" clId="{1BB04EDD-A3E3-453A-B4B6-6AA1C24487B8}" dt="2022-08-23T12:11:56.756" v="367"/>
          <ac:graphicFrameMkLst>
            <pc:docMk/>
            <pc:sldMk cId="3064084829" sldId="369"/>
            <ac:graphicFrameMk id="3" creationId="{D6D51C7B-2D55-04BB-A007-D97561FBC2A8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2:01.618" v="370"/>
        <pc:sldMkLst>
          <pc:docMk/>
          <pc:sldMk cId="608786648" sldId="370"/>
        </pc:sldMkLst>
        <pc:graphicFrameChg chg="mod">
          <ac:chgData name="Kaygisiz, Kübra" userId="4bfbf330-8776-4086-a830-2184b07ba8db" providerId="ADAL" clId="{1BB04EDD-A3E3-453A-B4B6-6AA1C24487B8}" dt="2022-08-23T12:12:01.618" v="370"/>
          <ac:graphicFrameMkLst>
            <pc:docMk/>
            <pc:sldMk cId="608786648" sldId="370"/>
            <ac:graphicFrameMk id="3" creationId="{78E836C9-EAF1-8259-EA9D-6904D78B8A3F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2:06.252" v="373"/>
        <pc:sldMkLst>
          <pc:docMk/>
          <pc:sldMk cId="1618217978" sldId="371"/>
        </pc:sldMkLst>
        <pc:graphicFrameChg chg="mod">
          <ac:chgData name="Kaygisiz, Kübra" userId="4bfbf330-8776-4086-a830-2184b07ba8db" providerId="ADAL" clId="{1BB04EDD-A3E3-453A-B4B6-6AA1C24487B8}" dt="2022-08-23T12:12:06.252" v="373"/>
          <ac:graphicFrameMkLst>
            <pc:docMk/>
            <pc:sldMk cId="1618217978" sldId="371"/>
            <ac:graphicFrameMk id="3" creationId="{544F0FD0-C822-4E35-5291-E9D5DCF4A1D9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2:11.190" v="376"/>
        <pc:sldMkLst>
          <pc:docMk/>
          <pc:sldMk cId="2697685813" sldId="372"/>
        </pc:sldMkLst>
        <pc:graphicFrameChg chg="mod">
          <ac:chgData name="Kaygisiz, Kübra" userId="4bfbf330-8776-4086-a830-2184b07ba8db" providerId="ADAL" clId="{1BB04EDD-A3E3-453A-B4B6-6AA1C24487B8}" dt="2022-08-23T12:12:11.190" v="376"/>
          <ac:graphicFrameMkLst>
            <pc:docMk/>
            <pc:sldMk cId="2697685813" sldId="372"/>
            <ac:graphicFrameMk id="3" creationId="{36A20E1E-A5F5-4577-7F30-09C81507800D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2:16.580" v="379"/>
        <pc:sldMkLst>
          <pc:docMk/>
          <pc:sldMk cId="2720200602" sldId="373"/>
        </pc:sldMkLst>
        <pc:graphicFrameChg chg="mod">
          <ac:chgData name="Kaygisiz, Kübra" userId="4bfbf330-8776-4086-a830-2184b07ba8db" providerId="ADAL" clId="{1BB04EDD-A3E3-453A-B4B6-6AA1C24487B8}" dt="2022-08-23T12:12:16.580" v="379"/>
          <ac:graphicFrameMkLst>
            <pc:docMk/>
            <pc:sldMk cId="2720200602" sldId="373"/>
            <ac:graphicFrameMk id="3" creationId="{B5A2A739-4AFA-0197-2830-E5E6CAC4BDA2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2:21.372" v="382"/>
        <pc:sldMkLst>
          <pc:docMk/>
          <pc:sldMk cId="2045961550" sldId="374"/>
        </pc:sldMkLst>
        <pc:graphicFrameChg chg="mod">
          <ac:chgData name="Kaygisiz, Kübra" userId="4bfbf330-8776-4086-a830-2184b07ba8db" providerId="ADAL" clId="{1BB04EDD-A3E3-453A-B4B6-6AA1C24487B8}" dt="2022-08-23T12:12:21.372" v="382"/>
          <ac:graphicFrameMkLst>
            <pc:docMk/>
            <pc:sldMk cId="2045961550" sldId="374"/>
            <ac:graphicFrameMk id="3" creationId="{77A20623-CC0C-4E13-C1AA-484864A6B2CF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2:26.424" v="385"/>
        <pc:sldMkLst>
          <pc:docMk/>
          <pc:sldMk cId="3876734693" sldId="375"/>
        </pc:sldMkLst>
        <pc:graphicFrameChg chg="mod">
          <ac:chgData name="Kaygisiz, Kübra" userId="4bfbf330-8776-4086-a830-2184b07ba8db" providerId="ADAL" clId="{1BB04EDD-A3E3-453A-B4B6-6AA1C24487B8}" dt="2022-08-23T12:12:26.424" v="385"/>
          <ac:graphicFrameMkLst>
            <pc:docMk/>
            <pc:sldMk cId="3876734693" sldId="375"/>
            <ac:graphicFrameMk id="3" creationId="{64A0FA0F-A10B-E0D2-2FAB-011FD06FFBD6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2:31.554" v="388"/>
        <pc:sldMkLst>
          <pc:docMk/>
          <pc:sldMk cId="1071747513" sldId="376"/>
        </pc:sldMkLst>
        <pc:graphicFrameChg chg="mod">
          <ac:chgData name="Kaygisiz, Kübra" userId="4bfbf330-8776-4086-a830-2184b07ba8db" providerId="ADAL" clId="{1BB04EDD-A3E3-453A-B4B6-6AA1C24487B8}" dt="2022-08-23T12:12:31.554" v="388"/>
          <ac:graphicFrameMkLst>
            <pc:docMk/>
            <pc:sldMk cId="1071747513" sldId="376"/>
            <ac:graphicFrameMk id="3" creationId="{1CA3F885-C939-9DD2-36DE-B0BB1D8B50BA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2:36.859" v="391"/>
        <pc:sldMkLst>
          <pc:docMk/>
          <pc:sldMk cId="1204606270" sldId="377"/>
        </pc:sldMkLst>
        <pc:graphicFrameChg chg="mod">
          <ac:chgData name="Kaygisiz, Kübra" userId="4bfbf330-8776-4086-a830-2184b07ba8db" providerId="ADAL" clId="{1BB04EDD-A3E3-453A-B4B6-6AA1C24487B8}" dt="2022-08-23T12:12:36.859" v="391"/>
          <ac:graphicFrameMkLst>
            <pc:docMk/>
            <pc:sldMk cId="1204606270" sldId="377"/>
            <ac:graphicFrameMk id="3" creationId="{B0BEDD2B-218E-4653-82F1-69486D0A2595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2:43.534" v="394"/>
        <pc:sldMkLst>
          <pc:docMk/>
          <pc:sldMk cId="179580946" sldId="378"/>
        </pc:sldMkLst>
        <pc:graphicFrameChg chg="mod">
          <ac:chgData name="Kaygisiz, Kübra" userId="4bfbf330-8776-4086-a830-2184b07ba8db" providerId="ADAL" clId="{1BB04EDD-A3E3-453A-B4B6-6AA1C24487B8}" dt="2022-08-23T12:12:43.534" v="394"/>
          <ac:graphicFrameMkLst>
            <pc:docMk/>
            <pc:sldMk cId="179580946" sldId="378"/>
            <ac:graphicFrameMk id="3" creationId="{891FFCDD-FC19-E410-C7E8-3EBEE8B1FB90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2:49.408" v="397"/>
        <pc:sldMkLst>
          <pc:docMk/>
          <pc:sldMk cId="2232646112" sldId="379"/>
        </pc:sldMkLst>
        <pc:graphicFrameChg chg="mod">
          <ac:chgData name="Kaygisiz, Kübra" userId="4bfbf330-8776-4086-a830-2184b07ba8db" providerId="ADAL" clId="{1BB04EDD-A3E3-453A-B4B6-6AA1C24487B8}" dt="2022-08-23T12:12:49.408" v="397"/>
          <ac:graphicFrameMkLst>
            <pc:docMk/>
            <pc:sldMk cId="2232646112" sldId="379"/>
            <ac:graphicFrameMk id="3" creationId="{EA817F66-5C01-3034-AE38-587B3250B344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2:54.891" v="400"/>
        <pc:sldMkLst>
          <pc:docMk/>
          <pc:sldMk cId="650392294" sldId="380"/>
        </pc:sldMkLst>
        <pc:graphicFrameChg chg="mod">
          <ac:chgData name="Kaygisiz, Kübra" userId="4bfbf330-8776-4086-a830-2184b07ba8db" providerId="ADAL" clId="{1BB04EDD-A3E3-453A-B4B6-6AA1C24487B8}" dt="2022-08-23T12:12:54.891" v="400"/>
          <ac:graphicFrameMkLst>
            <pc:docMk/>
            <pc:sldMk cId="650392294" sldId="380"/>
            <ac:graphicFrameMk id="3" creationId="{57E88353-FE9E-27B3-A261-59735FE0096C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3:00.124" v="403"/>
        <pc:sldMkLst>
          <pc:docMk/>
          <pc:sldMk cId="3366987078" sldId="381"/>
        </pc:sldMkLst>
        <pc:graphicFrameChg chg="mod">
          <ac:chgData name="Kaygisiz, Kübra" userId="4bfbf330-8776-4086-a830-2184b07ba8db" providerId="ADAL" clId="{1BB04EDD-A3E3-453A-B4B6-6AA1C24487B8}" dt="2022-08-23T12:13:00.124" v="403"/>
          <ac:graphicFrameMkLst>
            <pc:docMk/>
            <pc:sldMk cId="3366987078" sldId="381"/>
            <ac:graphicFrameMk id="3" creationId="{DB4932A2-D87F-4FF0-72BA-B5B5663D43D6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3:04.907" v="406"/>
        <pc:sldMkLst>
          <pc:docMk/>
          <pc:sldMk cId="877363637" sldId="382"/>
        </pc:sldMkLst>
        <pc:graphicFrameChg chg="mod">
          <ac:chgData name="Kaygisiz, Kübra" userId="4bfbf330-8776-4086-a830-2184b07ba8db" providerId="ADAL" clId="{1BB04EDD-A3E3-453A-B4B6-6AA1C24487B8}" dt="2022-08-23T12:13:04.907" v="406"/>
          <ac:graphicFrameMkLst>
            <pc:docMk/>
            <pc:sldMk cId="877363637" sldId="382"/>
            <ac:graphicFrameMk id="3" creationId="{C062B61E-F311-C9F6-F5FC-A767C07B8AEA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3:11.012" v="409"/>
        <pc:sldMkLst>
          <pc:docMk/>
          <pc:sldMk cId="1663590013" sldId="383"/>
        </pc:sldMkLst>
        <pc:graphicFrameChg chg="mod">
          <ac:chgData name="Kaygisiz, Kübra" userId="4bfbf330-8776-4086-a830-2184b07ba8db" providerId="ADAL" clId="{1BB04EDD-A3E3-453A-B4B6-6AA1C24487B8}" dt="2022-08-23T12:13:11.012" v="409"/>
          <ac:graphicFrameMkLst>
            <pc:docMk/>
            <pc:sldMk cId="1663590013" sldId="383"/>
            <ac:graphicFrameMk id="3" creationId="{522B65F5-A242-99E5-4E9E-ADA9AFE4568D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3:16.727" v="412"/>
        <pc:sldMkLst>
          <pc:docMk/>
          <pc:sldMk cId="2789172170" sldId="384"/>
        </pc:sldMkLst>
        <pc:graphicFrameChg chg="mod">
          <ac:chgData name="Kaygisiz, Kübra" userId="4bfbf330-8776-4086-a830-2184b07ba8db" providerId="ADAL" clId="{1BB04EDD-A3E3-453A-B4B6-6AA1C24487B8}" dt="2022-08-23T12:13:16.727" v="412"/>
          <ac:graphicFrameMkLst>
            <pc:docMk/>
            <pc:sldMk cId="2789172170" sldId="384"/>
            <ac:graphicFrameMk id="3" creationId="{CFD261DB-423E-7172-9C1E-2A43428F2B59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3:21.544" v="415"/>
        <pc:sldMkLst>
          <pc:docMk/>
          <pc:sldMk cId="91761761" sldId="385"/>
        </pc:sldMkLst>
        <pc:graphicFrameChg chg="mod">
          <ac:chgData name="Kaygisiz, Kübra" userId="4bfbf330-8776-4086-a830-2184b07ba8db" providerId="ADAL" clId="{1BB04EDD-A3E3-453A-B4B6-6AA1C24487B8}" dt="2022-08-23T12:13:21.544" v="415"/>
          <ac:graphicFrameMkLst>
            <pc:docMk/>
            <pc:sldMk cId="91761761" sldId="385"/>
            <ac:graphicFrameMk id="3" creationId="{DE89D620-5FB9-1FD3-E385-258096F551A3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3:26.883" v="418"/>
        <pc:sldMkLst>
          <pc:docMk/>
          <pc:sldMk cId="2552790150" sldId="386"/>
        </pc:sldMkLst>
        <pc:graphicFrameChg chg="mod">
          <ac:chgData name="Kaygisiz, Kübra" userId="4bfbf330-8776-4086-a830-2184b07ba8db" providerId="ADAL" clId="{1BB04EDD-A3E3-453A-B4B6-6AA1C24487B8}" dt="2022-08-23T12:13:26.883" v="418"/>
          <ac:graphicFrameMkLst>
            <pc:docMk/>
            <pc:sldMk cId="2552790150" sldId="386"/>
            <ac:graphicFrameMk id="3" creationId="{84B26D40-9601-1BDE-57B1-8A0F44D2AE75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2:13:31.786" v="421"/>
        <pc:sldMkLst>
          <pc:docMk/>
          <pc:sldMk cId="1009842015" sldId="387"/>
        </pc:sldMkLst>
        <pc:graphicFrameChg chg="add mod">
          <ac:chgData name="Kaygisiz, Kübra" userId="4bfbf330-8776-4086-a830-2184b07ba8db" providerId="ADAL" clId="{1BB04EDD-A3E3-453A-B4B6-6AA1C24487B8}" dt="2022-08-23T12:13:31.786" v="421"/>
          <ac:graphicFrameMkLst>
            <pc:docMk/>
            <pc:sldMk cId="1009842015" sldId="387"/>
            <ac:graphicFrameMk id="3" creationId="{CEB8E6F3-393D-8B98-CEC1-01049E314C60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3:37.086" v="424"/>
        <pc:sldMkLst>
          <pc:docMk/>
          <pc:sldMk cId="3305633320" sldId="388"/>
        </pc:sldMkLst>
        <pc:graphicFrameChg chg="mod">
          <ac:chgData name="Kaygisiz, Kübra" userId="4bfbf330-8776-4086-a830-2184b07ba8db" providerId="ADAL" clId="{1BB04EDD-A3E3-453A-B4B6-6AA1C24487B8}" dt="2022-08-23T12:13:37.086" v="424"/>
          <ac:graphicFrameMkLst>
            <pc:docMk/>
            <pc:sldMk cId="3305633320" sldId="388"/>
            <ac:graphicFrameMk id="3" creationId="{9E7ECDA4-524A-D2D3-92A7-2DDB41D39F6F}"/>
          </ac:graphicFrameMkLst>
        </pc:graphicFrameChg>
      </pc:sldChg>
      <pc:sldChg chg="modSp mod">
        <pc:chgData name="Kaygisiz, Kübra" userId="4bfbf330-8776-4086-a830-2184b07ba8db" providerId="ADAL" clId="{1BB04EDD-A3E3-453A-B4B6-6AA1C24487B8}" dt="2022-08-23T12:13:43.036" v="428" actId="1076"/>
        <pc:sldMkLst>
          <pc:docMk/>
          <pc:sldMk cId="2885565990" sldId="389"/>
        </pc:sldMkLst>
        <pc:graphicFrameChg chg="mod">
          <ac:chgData name="Kaygisiz, Kübra" userId="4bfbf330-8776-4086-a830-2184b07ba8db" providerId="ADAL" clId="{1BB04EDD-A3E3-453A-B4B6-6AA1C24487B8}" dt="2022-08-23T12:13:43.036" v="428" actId="1076"/>
          <ac:graphicFrameMkLst>
            <pc:docMk/>
            <pc:sldMk cId="2885565990" sldId="389"/>
            <ac:graphicFrameMk id="3" creationId="{59EC98DB-20A4-D94C-338A-4A1B01856946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3:47.876" v="431"/>
        <pc:sldMkLst>
          <pc:docMk/>
          <pc:sldMk cId="1439394317" sldId="390"/>
        </pc:sldMkLst>
        <pc:graphicFrameChg chg="mod">
          <ac:chgData name="Kaygisiz, Kübra" userId="4bfbf330-8776-4086-a830-2184b07ba8db" providerId="ADAL" clId="{1BB04EDD-A3E3-453A-B4B6-6AA1C24487B8}" dt="2022-08-23T12:13:47.876" v="431"/>
          <ac:graphicFrameMkLst>
            <pc:docMk/>
            <pc:sldMk cId="1439394317" sldId="390"/>
            <ac:graphicFrameMk id="3" creationId="{0A7A2E6D-B4A7-DF08-1381-F9DCCD41C00B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3:53.540" v="434"/>
        <pc:sldMkLst>
          <pc:docMk/>
          <pc:sldMk cId="2225765529" sldId="391"/>
        </pc:sldMkLst>
        <pc:graphicFrameChg chg="mod">
          <ac:chgData name="Kaygisiz, Kübra" userId="4bfbf330-8776-4086-a830-2184b07ba8db" providerId="ADAL" clId="{1BB04EDD-A3E3-453A-B4B6-6AA1C24487B8}" dt="2022-08-23T12:13:53.540" v="434"/>
          <ac:graphicFrameMkLst>
            <pc:docMk/>
            <pc:sldMk cId="2225765529" sldId="391"/>
            <ac:graphicFrameMk id="3" creationId="{B913EE11-DAAA-9446-B043-753A912757C7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3:59.789" v="437"/>
        <pc:sldMkLst>
          <pc:docMk/>
          <pc:sldMk cId="1879692678" sldId="392"/>
        </pc:sldMkLst>
        <pc:graphicFrameChg chg="mod">
          <ac:chgData name="Kaygisiz, Kübra" userId="4bfbf330-8776-4086-a830-2184b07ba8db" providerId="ADAL" clId="{1BB04EDD-A3E3-453A-B4B6-6AA1C24487B8}" dt="2022-08-23T12:13:59.789" v="437"/>
          <ac:graphicFrameMkLst>
            <pc:docMk/>
            <pc:sldMk cId="1879692678" sldId="392"/>
            <ac:graphicFrameMk id="3" creationId="{EA6DFFF4-2426-97B9-F0FD-96C07A919AE9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4:06.089" v="440"/>
        <pc:sldMkLst>
          <pc:docMk/>
          <pc:sldMk cId="3571392797" sldId="395"/>
        </pc:sldMkLst>
        <pc:graphicFrameChg chg="mod">
          <ac:chgData name="Kaygisiz, Kübra" userId="4bfbf330-8776-4086-a830-2184b07ba8db" providerId="ADAL" clId="{1BB04EDD-A3E3-453A-B4B6-6AA1C24487B8}" dt="2022-08-23T12:14:06.089" v="440"/>
          <ac:graphicFrameMkLst>
            <pc:docMk/>
            <pc:sldMk cId="3571392797" sldId="395"/>
            <ac:graphicFrameMk id="3" creationId="{B4D0657C-087E-6B4A-8944-61889931F23D}"/>
          </ac:graphicFrameMkLst>
        </pc:graphicFrameChg>
      </pc:sldChg>
      <pc:sldChg chg="modSp mod">
        <pc:chgData name="Kaygisiz, Kübra" userId="4bfbf330-8776-4086-a830-2184b07ba8db" providerId="ADAL" clId="{1BB04EDD-A3E3-453A-B4B6-6AA1C24487B8}" dt="2022-08-24T01:52:09.273" v="835" actId="1076"/>
        <pc:sldMkLst>
          <pc:docMk/>
          <pc:sldMk cId="4203967550" sldId="396"/>
        </pc:sldMkLst>
        <pc:graphicFrameChg chg="mod">
          <ac:chgData name="Kaygisiz, Kübra" userId="4bfbf330-8776-4086-a830-2184b07ba8db" providerId="ADAL" clId="{1BB04EDD-A3E3-453A-B4B6-6AA1C24487B8}" dt="2022-08-24T01:52:09.273" v="835" actId="1076"/>
          <ac:graphicFrameMkLst>
            <pc:docMk/>
            <pc:sldMk cId="4203967550" sldId="396"/>
            <ac:graphicFrameMk id="3" creationId="{5DE79435-6D3D-6A21-29F8-7AF8F96E19A0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2:14:15.455" v="446"/>
        <pc:sldMkLst>
          <pc:docMk/>
          <pc:sldMk cId="1386297517" sldId="397"/>
        </pc:sldMkLst>
        <pc:graphicFrameChg chg="add mod">
          <ac:chgData name="Kaygisiz, Kübra" userId="4bfbf330-8776-4086-a830-2184b07ba8db" providerId="ADAL" clId="{1BB04EDD-A3E3-453A-B4B6-6AA1C24487B8}" dt="2022-08-23T12:14:15.455" v="446"/>
          <ac:graphicFrameMkLst>
            <pc:docMk/>
            <pc:sldMk cId="1386297517" sldId="397"/>
            <ac:graphicFrameMk id="3" creationId="{CB274125-A68A-DE49-DB7E-645A8C79D6CC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4:20.621" v="449"/>
        <pc:sldMkLst>
          <pc:docMk/>
          <pc:sldMk cId="2902756814" sldId="398"/>
        </pc:sldMkLst>
        <pc:graphicFrameChg chg="mod">
          <ac:chgData name="Kaygisiz, Kübra" userId="4bfbf330-8776-4086-a830-2184b07ba8db" providerId="ADAL" clId="{1BB04EDD-A3E3-453A-B4B6-6AA1C24487B8}" dt="2022-08-23T12:14:20.621" v="449"/>
          <ac:graphicFrameMkLst>
            <pc:docMk/>
            <pc:sldMk cId="2902756814" sldId="398"/>
            <ac:graphicFrameMk id="3" creationId="{074DBB06-E4B9-AF80-E55D-88FB5C6705E0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4:25.452" v="452"/>
        <pc:sldMkLst>
          <pc:docMk/>
          <pc:sldMk cId="3428080603" sldId="399"/>
        </pc:sldMkLst>
        <pc:graphicFrameChg chg="mod">
          <ac:chgData name="Kaygisiz, Kübra" userId="4bfbf330-8776-4086-a830-2184b07ba8db" providerId="ADAL" clId="{1BB04EDD-A3E3-453A-B4B6-6AA1C24487B8}" dt="2022-08-23T12:14:25.452" v="452"/>
          <ac:graphicFrameMkLst>
            <pc:docMk/>
            <pc:sldMk cId="3428080603" sldId="399"/>
            <ac:graphicFrameMk id="3" creationId="{4FBEC474-0885-3690-80F8-5533C07827FD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4:30.822" v="455"/>
        <pc:sldMkLst>
          <pc:docMk/>
          <pc:sldMk cId="2483818101" sldId="400"/>
        </pc:sldMkLst>
        <pc:graphicFrameChg chg="mod">
          <ac:chgData name="Kaygisiz, Kübra" userId="4bfbf330-8776-4086-a830-2184b07ba8db" providerId="ADAL" clId="{1BB04EDD-A3E3-453A-B4B6-6AA1C24487B8}" dt="2022-08-23T12:14:30.822" v="455"/>
          <ac:graphicFrameMkLst>
            <pc:docMk/>
            <pc:sldMk cId="2483818101" sldId="400"/>
            <ac:graphicFrameMk id="3" creationId="{99B228AE-CEA1-A369-4FCB-F7C54FC42472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4:36.046" v="458"/>
        <pc:sldMkLst>
          <pc:docMk/>
          <pc:sldMk cId="2164342502" sldId="401"/>
        </pc:sldMkLst>
        <pc:graphicFrameChg chg="mod">
          <ac:chgData name="Kaygisiz, Kübra" userId="4bfbf330-8776-4086-a830-2184b07ba8db" providerId="ADAL" clId="{1BB04EDD-A3E3-453A-B4B6-6AA1C24487B8}" dt="2022-08-23T12:14:36.046" v="458"/>
          <ac:graphicFrameMkLst>
            <pc:docMk/>
            <pc:sldMk cId="2164342502" sldId="401"/>
            <ac:graphicFrameMk id="3" creationId="{C63EA86D-206A-2C0A-2C92-4C6F015F0EAC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4:40.906" v="461"/>
        <pc:sldMkLst>
          <pc:docMk/>
          <pc:sldMk cId="220549203" sldId="402"/>
        </pc:sldMkLst>
        <pc:graphicFrameChg chg="mod">
          <ac:chgData name="Kaygisiz, Kübra" userId="4bfbf330-8776-4086-a830-2184b07ba8db" providerId="ADAL" clId="{1BB04EDD-A3E3-453A-B4B6-6AA1C24487B8}" dt="2022-08-23T12:14:40.906" v="461"/>
          <ac:graphicFrameMkLst>
            <pc:docMk/>
            <pc:sldMk cId="220549203" sldId="402"/>
            <ac:graphicFrameMk id="3" creationId="{EDE97483-4388-EF7B-2635-4768B6EEC813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4:46.210" v="464"/>
        <pc:sldMkLst>
          <pc:docMk/>
          <pc:sldMk cId="1372757893" sldId="403"/>
        </pc:sldMkLst>
        <pc:graphicFrameChg chg="mod">
          <ac:chgData name="Kaygisiz, Kübra" userId="4bfbf330-8776-4086-a830-2184b07ba8db" providerId="ADAL" clId="{1BB04EDD-A3E3-453A-B4B6-6AA1C24487B8}" dt="2022-08-23T12:14:46.210" v="464"/>
          <ac:graphicFrameMkLst>
            <pc:docMk/>
            <pc:sldMk cId="1372757893" sldId="403"/>
            <ac:graphicFrameMk id="3" creationId="{3952C9D8-6493-1656-FDD6-F4C0B56FE2FF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4:51.162" v="467"/>
        <pc:sldMkLst>
          <pc:docMk/>
          <pc:sldMk cId="3039709633" sldId="404"/>
        </pc:sldMkLst>
        <pc:graphicFrameChg chg="mod">
          <ac:chgData name="Kaygisiz, Kübra" userId="4bfbf330-8776-4086-a830-2184b07ba8db" providerId="ADAL" clId="{1BB04EDD-A3E3-453A-B4B6-6AA1C24487B8}" dt="2022-08-23T12:14:51.162" v="467"/>
          <ac:graphicFrameMkLst>
            <pc:docMk/>
            <pc:sldMk cId="3039709633" sldId="404"/>
            <ac:graphicFrameMk id="3" creationId="{3111138B-7B5A-AD6F-0BF9-E333504E4C4A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4:57.156" v="470"/>
        <pc:sldMkLst>
          <pc:docMk/>
          <pc:sldMk cId="3064510982" sldId="405"/>
        </pc:sldMkLst>
        <pc:graphicFrameChg chg="mod">
          <ac:chgData name="Kaygisiz, Kübra" userId="4bfbf330-8776-4086-a830-2184b07ba8db" providerId="ADAL" clId="{1BB04EDD-A3E3-453A-B4B6-6AA1C24487B8}" dt="2022-08-23T12:14:57.156" v="470"/>
          <ac:graphicFrameMkLst>
            <pc:docMk/>
            <pc:sldMk cId="3064510982" sldId="405"/>
            <ac:graphicFrameMk id="3" creationId="{B7A416EB-DA32-F35B-FAE1-8B7B2C2D65A1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5:02.731" v="473"/>
        <pc:sldMkLst>
          <pc:docMk/>
          <pc:sldMk cId="1041487721" sldId="406"/>
        </pc:sldMkLst>
        <pc:graphicFrameChg chg="mod">
          <ac:chgData name="Kaygisiz, Kübra" userId="4bfbf330-8776-4086-a830-2184b07ba8db" providerId="ADAL" clId="{1BB04EDD-A3E3-453A-B4B6-6AA1C24487B8}" dt="2022-08-23T12:15:02.731" v="473"/>
          <ac:graphicFrameMkLst>
            <pc:docMk/>
            <pc:sldMk cId="1041487721" sldId="406"/>
            <ac:graphicFrameMk id="3" creationId="{D2D8CB2A-1B50-1E1A-78A0-2AC32A4A20EA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5:08.617" v="476"/>
        <pc:sldMkLst>
          <pc:docMk/>
          <pc:sldMk cId="3794329460" sldId="407"/>
        </pc:sldMkLst>
        <pc:graphicFrameChg chg="mod">
          <ac:chgData name="Kaygisiz, Kübra" userId="4bfbf330-8776-4086-a830-2184b07ba8db" providerId="ADAL" clId="{1BB04EDD-A3E3-453A-B4B6-6AA1C24487B8}" dt="2022-08-23T12:15:08.617" v="476"/>
          <ac:graphicFrameMkLst>
            <pc:docMk/>
            <pc:sldMk cId="3794329460" sldId="407"/>
            <ac:graphicFrameMk id="3" creationId="{43CB897F-B96E-41F8-FAB5-199719FA9E06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2:15:13.634" v="479"/>
        <pc:sldMkLst>
          <pc:docMk/>
          <pc:sldMk cId="1395803242" sldId="408"/>
        </pc:sldMkLst>
        <pc:graphicFrameChg chg="add mod">
          <ac:chgData name="Kaygisiz, Kübra" userId="4bfbf330-8776-4086-a830-2184b07ba8db" providerId="ADAL" clId="{1BB04EDD-A3E3-453A-B4B6-6AA1C24487B8}" dt="2022-08-23T12:15:13.634" v="479"/>
          <ac:graphicFrameMkLst>
            <pc:docMk/>
            <pc:sldMk cId="1395803242" sldId="408"/>
            <ac:graphicFrameMk id="3" creationId="{23E7F519-674E-477C-CB8B-B53048E487A2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2:15:18.838" v="482"/>
        <pc:sldMkLst>
          <pc:docMk/>
          <pc:sldMk cId="3238007092" sldId="409"/>
        </pc:sldMkLst>
        <pc:graphicFrameChg chg="add mod">
          <ac:chgData name="Kaygisiz, Kübra" userId="4bfbf330-8776-4086-a830-2184b07ba8db" providerId="ADAL" clId="{1BB04EDD-A3E3-453A-B4B6-6AA1C24487B8}" dt="2022-08-23T12:15:18.838" v="482"/>
          <ac:graphicFrameMkLst>
            <pc:docMk/>
            <pc:sldMk cId="3238007092" sldId="409"/>
            <ac:graphicFrameMk id="3" creationId="{8CA497F4-8C72-22F9-D0C4-94227953BD86}"/>
          </ac:graphicFrameMkLst>
        </pc:graphicFrameChg>
      </pc:sldChg>
      <pc:sldChg chg="addSp delSp modSp mod">
        <pc:chgData name="Kaygisiz, Kübra" userId="4bfbf330-8776-4086-a830-2184b07ba8db" providerId="ADAL" clId="{1BB04EDD-A3E3-453A-B4B6-6AA1C24487B8}" dt="2022-08-24T04:26:35.721" v="841" actId="478"/>
        <pc:sldMkLst>
          <pc:docMk/>
          <pc:sldMk cId="3677518539" sldId="410"/>
        </pc:sldMkLst>
        <pc:graphicFrameChg chg="mod">
          <ac:chgData name="Kaygisiz, Kübra" userId="4bfbf330-8776-4086-a830-2184b07ba8db" providerId="ADAL" clId="{1BB04EDD-A3E3-453A-B4B6-6AA1C24487B8}" dt="2022-08-23T12:15:24.185" v="485"/>
          <ac:graphicFrameMkLst>
            <pc:docMk/>
            <pc:sldMk cId="3677518539" sldId="410"/>
            <ac:graphicFrameMk id="3" creationId="{F9CD9DB5-5E4C-7C63-AB56-DD79895E2667}"/>
          </ac:graphicFrameMkLst>
        </pc:graphicFrameChg>
        <pc:graphicFrameChg chg="add del mod">
          <ac:chgData name="Kaygisiz, Kübra" userId="4bfbf330-8776-4086-a830-2184b07ba8db" providerId="ADAL" clId="{1BB04EDD-A3E3-453A-B4B6-6AA1C24487B8}" dt="2022-08-24T04:26:35.721" v="841" actId="478"/>
          <ac:graphicFrameMkLst>
            <pc:docMk/>
            <pc:sldMk cId="3677518539" sldId="410"/>
            <ac:graphicFrameMk id="4" creationId="{499CACE4-1091-6F72-902D-55964B528310}"/>
          </ac:graphicFrameMkLst>
        </pc:graphicFrameChg>
      </pc:sldChg>
      <pc:sldChg chg="modSp mod">
        <pc:chgData name="Kaygisiz, Kübra" userId="4bfbf330-8776-4086-a830-2184b07ba8db" providerId="ADAL" clId="{1BB04EDD-A3E3-453A-B4B6-6AA1C24487B8}" dt="2022-08-23T12:15:29.879" v="489"/>
        <pc:sldMkLst>
          <pc:docMk/>
          <pc:sldMk cId="804652707" sldId="411"/>
        </pc:sldMkLst>
        <pc:graphicFrameChg chg="mod">
          <ac:chgData name="Kaygisiz, Kübra" userId="4bfbf330-8776-4086-a830-2184b07ba8db" providerId="ADAL" clId="{1BB04EDD-A3E3-453A-B4B6-6AA1C24487B8}" dt="2022-08-23T12:15:29.879" v="489"/>
          <ac:graphicFrameMkLst>
            <pc:docMk/>
            <pc:sldMk cId="804652707" sldId="411"/>
            <ac:graphicFrameMk id="3" creationId="{D529E586-8632-F65E-57C0-C6AE906A5116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5:35.139" v="492"/>
        <pc:sldMkLst>
          <pc:docMk/>
          <pc:sldMk cId="854743519" sldId="412"/>
        </pc:sldMkLst>
        <pc:graphicFrameChg chg="mod">
          <ac:chgData name="Kaygisiz, Kübra" userId="4bfbf330-8776-4086-a830-2184b07ba8db" providerId="ADAL" clId="{1BB04EDD-A3E3-453A-B4B6-6AA1C24487B8}" dt="2022-08-23T12:15:35.139" v="492"/>
          <ac:graphicFrameMkLst>
            <pc:docMk/>
            <pc:sldMk cId="854743519" sldId="412"/>
            <ac:graphicFrameMk id="3" creationId="{2DD6D308-ED15-9A3C-2FA9-56F5792154BF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5:40.191" v="495"/>
        <pc:sldMkLst>
          <pc:docMk/>
          <pc:sldMk cId="1488576310" sldId="413"/>
        </pc:sldMkLst>
        <pc:graphicFrameChg chg="mod">
          <ac:chgData name="Kaygisiz, Kübra" userId="4bfbf330-8776-4086-a830-2184b07ba8db" providerId="ADAL" clId="{1BB04EDD-A3E3-453A-B4B6-6AA1C24487B8}" dt="2022-08-23T12:15:40.191" v="495"/>
          <ac:graphicFrameMkLst>
            <pc:docMk/>
            <pc:sldMk cId="1488576310" sldId="413"/>
            <ac:graphicFrameMk id="3" creationId="{B23640F9-7EF4-E510-45DC-4BC9840FADEE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2:15:45.727" v="498"/>
        <pc:sldMkLst>
          <pc:docMk/>
          <pc:sldMk cId="796462839" sldId="414"/>
        </pc:sldMkLst>
        <pc:graphicFrameChg chg="add mod">
          <ac:chgData name="Kaygisiz, Kübra" userId="4bfbf330-8776-4086-a830-2184b07ba8db" providerId="ADAL" clId="{1BB04EDD-A3E3-453A-B4B6-6AA1C24487B8}" dt="2022-08-23T12:15:45.727" v="498"/>
          <ac:graphicFrameMkLst>
            <pc:docMk/>
            <pc:sldMk cId="796462839" sldId="414"/>
            <ac:graphicFrameMk id="3" creationId="{EE12C99D-BAA7-3C8A-82E4-DE1C0EEDA64C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5:50.816" v="501"/>
        <pc:sldMkLst>
          <pc:docMk/>
          <pc:sldMk cId="2699220586" sldId="415"/>
        </pc:sldMkLst>
        <pc:graphicFrameChg chg="mod">
          <ac:chgData name="Kaygisiz, Kübra" userId="4bfbf330-8776-4086-a830-2184b07ba8db" providerId="ADAL" clId="{1BB04EDD-A3E3-453A-B4B6-6AA1C24487B8}" dt="2022-08-23T12:15:50.816" v="501"/>
          <ac:graphicFrameMkLst>
            <pc:docMk/>
            <pc:sldMk cId="2699220586" sldId="415"/>
            <ac:graphicFrameMk id="3" creationId="{C2014162-15DB-DD15-BF60-C1AF2C4993D2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2:15:56.636" v="504"/>
        <pc:sldMkLst>
          <pc:docMk/>
          <pc:sldMk cId="3455880494" sldId="416"/>
        </pc:sldMkLst>
        <pc:graphicFrameChg chg="add mod">
          <ac:chgData name="Kaygisiz, Kübra" userId="4bfbf330-8776-4086-a830-2184b07ba8db" providerId="ADAL" clId="{1BB04EDD-A3E3-453A-B4B6-6AA1C24487B8}" dt="2022-08-23T12:15:56.636" v="504"/>
          <ac:graphicFrameMkLst>
            <pc:docMk/>
            <pc:sldMk cId="3455880494" sldId="416"/>
            <ac:graphicFrameMk id="3" creationId="{864F184D-D422-3745-3250-327EED674252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2:16:01.370" v="507"/>
        <pc:sldMkLst>
          <pc:docMk/>
          <pc:sldMk cId="2550044285" sldId="417"/>
        </pc:sldMkLst>
        <pc:graphicFrameChg chg="add mod">
          <ac:chgData name="Kaygisiz, Kübra" userId="4bfbf330-8776-4086-a830-2184b07ba8db" providerId="ADAL" clId="{1BB04EDD-A3E3-453A-B4B6-6AA1C24487B8}" dt="2022-08-23T12:16:01.370" v="507"/>
          <ac:graphicFrameMkLst>
            <pc:docMk/>
            <pc:sldMk cId="2550044285" sldId="417"/>
            <ac:graphicFrameMk id="3" creationId="{351599C0-1F38-276B-52E5-A36F840A1CAF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6:07.021" v="510"/>
        <pc:sldMkLst>
          <pc:docMk/>
          <pc:sldMk cId="4289956802" sldId="418"/>
        </pc:sldMkLst>
        <pc:graphicFrameChg chg="mod">
          <ac:chgData name="Kaygisiz, Kübra" userId="4bfbf330-8776-4086-a830-2184b07ba8db" providerId="ADAL" clId="{1BB04EDD-A3E3-453A-B4B6-6AA1C24487B8}" dt="2022-08-23T12:16:07.021" v="510"/>
          <ac:graphicFrameMkLst>
            <pc:docMk/>
            <pc:sldMk cId="4289956802" sldId="418"/>
            <ac:graphicFrameMk id="3" creationId="{22BFD98D-3717-02BF-6374-133686BE88A8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6:12.613" v="513"/>
        <pc:sldMkLst>
          <pc:docMk/>
          <pc:sldMk cId="1741208271" sldId="419"/>
        </pc:sldMkLst>
        <pc:graphicFrameChg chg="mod">
          <ac:chgData name="Kaygisiz, Kübra" userId="4bfbf330-8776-4086-a830-2184b07ba8db" providerId="ADAL" clId="{1BB04EDD-A3E3-453A-B4B6-6AA1C24487B8}" dt="2022-08-23T12:16:12.613" v="513"/>
          <ac:graphicFrameMkLst>
            <pc:docMk/>
            <pc:sldMk cId="1741208271" sldId="419"/>
            <ac:graphicFrameMk id="3" creationId="{231EEBE4-BBF1-F679-3753-A53B86A81FF8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6:26.151" v="516"/>
        <pc:sldMkLst>
          <pc:docMk/>
          <pc:sldMk cId="2786292224" sldId="420"/>
        </pc:sldMkLst>
        <pc:graphicFrameChg chg="mod">
          <ac:chgData name="Kaygisiz, Kübra" userId="4bfbf330-8776-4086-a830-2184b07ba8db" providerId="ADAL" clId="{1BB04EDD-A3E3-453A-B4B6-6AA1C24487B8}" dt="2022-08-23T12:16:26.151" v="516"/>
          <ac:graphicFrameMkLst>
            <pc:docMk/>
            <pc:sldMk cId="2786292224" sldId="420"/>
            <ac:graphicFrameMk id="3" creationId="{05412847-F446-0153-DE88-15797C000936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2:16:31.465" v="519"/>
        <pc:sldMkLst>
          <pc:docMk/>
          <pc:sldMk cId="3932385421" sldId="421"/>
        </pc:sldMkLst>
        <pc:graphicFrameChg chg="add mod">
          <ac:chgData name="Kaygisiz, Kübra" userId="4bfbf330-8776-4086-a830-2184b07ba8db" providerId="ADAL" clId="{1BB04EDD-A3E3-453A-B4B6-6AA1C24487B8}" dt="2022-08-23T12:16:31.465" v="519"/>
          <ac:graphicFrameMkLst>
            <pc:docMk/>
            <pc:sldMk cId="3932385421" sldId="421"/>
            <ac:graphicFrameMk id="3" creationId="{07F809E5-91DE-DC72-F1BF-E27D63435520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6:39.704" v="522"/>
        <pc:sldMkLst>
          <pc:docMk/>
          <pc:sldMk cId="999979765" sldId="422"/>
        </pc:sldMkLst>
        <pc:graphicFrameChg chg="mod">
          <ac:chgData name="Kaygisiz, Kübra" userId="4bfbf330-8776-4086-a830-2184b07ba8db" providerId="ADAL" clId="{1BB04EDD-A3E3-453A-B4B6-6AA1C24487B8}" dt="2022-08-23T12:16:39.704" v="522"/>
          <ac:graphicFrameMkLst>
            <pc:docMk/>
            <pc:sldMk cId="999979765" sldId="422"/>
            <ac:graphicFrameMk id="3" creationId="{1C0CE87B-1C75-A424-1DFC-EFF138135508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6:46.009" v="525"/>
        <pc:sldMkLst>
          <pc:docMk/>
          <pc:sldMk cId="2776356415" sldId="423"/>
        </pc:sldMkLst>
        <pc:graphicFrameChg chg="mod">
          <ac:chgData name="Kaygisiz, Kübra" userId="4bfbf330-8776-4086-a830-2184b07ba8db" providerId="ADAL" clId="{1BB04EDD-A3E3-453A-B4B6-6AA1C24487B8}" dt="2022-08-23T12:16:46.009" v="525"/>
          <ac:graphicFrameMkLst>
            <pc:docMk/>
            <pc:sldMk cId="2776356415" sldId="423"/>
            <ac:graphicFrameMk id="3" creationId="{276E0151-DA7F-34A0-031D-9596DBCDD66B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6:51.149" v="528"/>
        <pc:sldMkLst>
          <pc:docMk/>
          <pc:sldMk cId="3655847628" sldId="424"/>
        </pc:sldMkLst>
        <pc:graphicFrameChg chg="mod">
          <ac:chgData name="Kaygisiz, Kübra" userId="4bfbf330-8776-4086-a830-2184b07ba8db" providerId="ADAL" clId="{1BB04EDD-A3E3-453A-B4B6-6AA1C24487B8}" dt="2022-08-23T12:16:51.149" v="528"/>
          <ac:graphicFrameMkLst>
            <pc:docMk/>
            <pc:sldMk cId="3655847628" sldId="424"/>
            <ac:graphicFrameMk id="3" creationId="{BD801BB6-9E62-F43C-4F8D-7E7BDC7543B9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2:16:56.835" v="531"/>
        <pc:sldMkLst>
          <pc:docMk/>
          <pc:sldMk cId="2275618644" sldId="425"/>
        </pc:sldMkLst>
        <pc:graphicFrameChg chg="add mod">
          <ac:chgData name="Kaygisiz, Kübra" userId="4bfbf330-8776-4086-a830-2184b07ba8db" providerId="ADAL" clId="{1BB04EDD-A3E3-453A-B4B6-6AA1C24487B8}" dt="2022-08-23T12:16:56.835" v="531"/>
          <ac:graphicFrameMkLst>
            <pc:docMk/>
            <pc:sldMk cId="2275618644" sldId="425"/>
            <ac:graphicFrameMk id="3" creationId="{2213C63E-3B61-8492-B0AD-494AE8F5425B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7:01.674" v="534"/>
        <pc:sldMkLst>
          <pc:docMk/>
          <pc:sldMk cId="3143404012" sldId="426"/>
        </pc:sldMkLst>
        <pc:graphicFrameChg chg="mod">
          <ac:chgData name="Kaygisiz, Kübra" userId="4bfbf330-8776-4086-a830-2184b07ba8db" providerId="ADAL" clId="{1BB04EDD-A3E3-453A-B4B6-6AA1C24487B8}" dt="2022-08-23T12:17:01.674" v="534"/>
          <ac:graphicFrameMkLst>
            <pc:docMk/>
            <pc:sldMk cId="3143404012" sldId="426"/>
            <ac:graphicFrameMk id="3" creationId="{DEE38030-69E7-A57D-56BA-A36EA40E188E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7:07.931" v="537"/>
        <pc:sldMkLst>
          <pc:docMk/>
          <pc:sldMk cId="633915184" sldId="427"/>
        </pc:sldMkLst>
        <pc:graphicFrameChg chg="mod">
          <ac:chgData name="Kaygisiz, Kübra" userId="4bfbf330-8776-4086-a830-2184b07ba8db" providerId="ADAL" clId="{1BB04EDD-A3E3-453A-B4B6-6AA1C24487B8}" dt="2022-08-23T12:17:07.931" v="537"/>
          <ac:graphicFrameMkLst>
            <pc:docMk/>
            <pc:sldMk cId="633915184" sldId="427"/>
            <ac:graphicFrameMk id="3" creationId="{8F4313D6-A6A9-E28C-B52A-DDEE7B35CC3B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2:17:13.405" v="540"/>
        <pc:sldMkLst>
          <pc:docMk/>
          <pc:sldMk cId="2438697961" sldId="428"/>
        </pc:sldMkLst>
        <pc:graphicFrameChg chg="add mod">
          <ac:chgData name="Kaygisiz, Kübra" userId="4bfbf330-8776-4086-a830-2184b07ba8db" providerId="ADAL" clId="{1BB04EDD-A3E3-453A-B4B6-6AA1C24487B8}" dt="2022-08-23T12:17:13.405" v="540"/>
          <ac:graphicFrameMkLst>
            <pc:docMk/>
            <pc:sldMk cId="2438697961" sldId="428"/>
            <ac:graphicFrameMk id="3" creationId="{9C90D6B9-5535-687E-DC97-3150A5905745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7:19.122" v="543"/>
        <pc:sldMkLst>
          <pc:docMk/>
          <pc:sldMk cId="739058583" sldId="429"/>
        </pc:sldMkLst>
        <pc:graphicFrameChg chg="mod">
          <ac:chgData name="Kaygisiz, Kübra" userId="4bfbf330-8776-4086-a830-2184b07ba8db" providerId="ADAL" clId="{1BB04EDD-A3E3-453A-B4B6-6AA1C24487B8}" dt="2022-08-23T12:17:19.122" v="543"/>
          <ac:graphicFrameMkLst>
            <pc:docMk/>
            <pc:sldMk cId="739058583" sldId="429"/>
            <ac:graphicFrameMk id="3" creationId="{96EDA655-9F65-D140-1380-974BB84AF5B2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7:26.169" v="546"/>
        <pc:sldMkLst>
          <pc:docMk/>
          <pc:sldMk cId="3924494893" sldId="430"/>
        </pc:sldMkLst>
        <pc:graphicFrameChg chg="mod">
          <ac:chgData name="Kaygisiz, Kübra" userId="4bfbf330-8776-4086-a830-2184b07ba8db" providerId="ADAL" clId="{1BB04EDD-A3E3-453A-B4B6-6AA1C24487B8}" dt="2022-08-23T12:17:26.169" v="546"/>
          <ac:graphicFrameMkLst>
            <pc:docMk/>
            <pc:sldMk cId="3924494893" sldId="430"/>
            <ac:graphicFrameMk id="3" creationId="{C50FABB3-A87B-5BF8-73C3-47096F5A8E88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2:17:31.377" v="549"/>
        <pc:sldMkLst>
          <pc:docMk/>
          <pc:sldMk cId="2416058671" sldId="431"/>
        </pc:sldMkLst>
        <pc:graphicFrameChg chg="add mod">
          <ac:chgData name="Kaygisiz, Kübra" userId="4bfbf330-8776-4086-a830-2184b07ba8db" providerId="ADAL" clId="{1BB04EDD-A3E3-453A-B4B6-6AA1C24487B8}" dt="2022-08-23T12:17:31.377" v="549"/>
          <ac:graphicFrameMkLst>
            <pc:docMk/>
            <pc:sldMk cId="2416058671" sldId="431"/>
            <ac:graphicFrameMk id="3" creationId="{885A1C28-19DE-DEF4-AFCC-F26D45301B74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2:17:36.648" v="552"/>
        <pc:sldMkLst>
          <pc:docMk/>
          <pc:sldMk cId="2607142310" sldId="432"/>
        </pc:sldMkLst>
        <pc:graphicFrameChg chg="add mod">
          <ac:chgData name="Kaygisiz, Kübra" userId="4bfbf330-8776-4086-a830-2184b07ba8db" providerId="ADAL" clId="{1BB04EDD-A3E3-453A-B4B6-6AA1C24487B8}" dt="2022-08-23T12:17:36.648" v="552"/>
          <ac:graphicFrameMkLst>
            <pc:docMk/>
            <pc:sldMk cId="2607142310" sldId="432"/>
            <ac:graphicFrameMk id="3" creationId="{7A758369-BD2C-6207-77F6-37504DDFA5BE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7:42.284" v="555"/>
        <pc:sldMkLst>
          <pc:docMk/>
          <pc:sldMk cId="2202585896" sldId="433"/>
        </pc:sldMkLst>
        <pc:graphicFrameChg chg="mod">
          <ac:chgData name="Kaygisiz, Kübra" userId="4bfbf330-8776-4086-a830-2184b07ba8db" providerId="ADAL" clId="{1BB04EDD-A3E3-453A-B4B6-6AA1C24487B8}" dt="2022-08-23T12:17:42.284" v="555"/>
          <ac:graphicFrameMkLst>
            <pc:docMk/>
            <pc:sldMk cId="2202585896" sldId="433"/>
            <ac:graphicFrameMk id="3" creationId="{941D8568-CC43-6603-922A-8A58170911E7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7:48.048" v="558"/>
        <pc:sldMkLst>
          <pc:docMk/>
          <pc:sldMk cId="2237347613" sldId="434"/>
        </pc:sldMkLst>
        <pc:graphicFrameChg chg="mod">
          <ac:chgData name="Kaygisiz, Kübra" userId="4bfbf330-8776-4086-a830-2184b07ba8db" providerId="ADAL" clId="{1BB04EDD-A3E3-453A-B4B6-6AA1C24487B8}" dt="2022-08-23T12:17:48.048" v="558"/>
          <ac:graphicFrameMkLst>
            <pc:docMk/>
            <pc:sldMk cId="2237347613" sldId="434"/>
            <ac:graphicFrameMk id="3" creationId="{A549F4CE-A93C-4F4C-D2D5-D32648CF1291}"/>
          </ac:graphicFrameMkLst>
        </pc:graphicFrameChg>
      </pc:sldChg>
      <pc:sldChg chg="addSp modSp mod">
        <pc:chgData name="Kaygisiz, Kübra" userId="4bfbf330-8776-4086-a830-2184b07ba8db" providerId="ADAL" clId="{1BB04EDD-A3E3-453A-B4B6-6AA1C24487B8}" dt="2022-08-23T12:17:53.717" v="561"/>
        <pc:sldMkLst>
          <pc:docMk/>
          <pc:sldMk cId="230741147" sldId="435"/>
        </pc:sldMkLst>
        <pc:graphicFrameChg chg="add mod">
          <ac:chgData name="Kaygisiz, Kübra" userId="4bfbf330-8776-4086-a830-2184b07ba8db" providerId="ADAL" clId="{1BB04EDD-A3E3-453A-B4B6-6AA1C24487B8}" dt="2022-08-23T12:17:53.717" v="561"/>
          <ac:graphicFrameMkLst>
            <pc:docMk/>
            <pc:sldMk cId="230741147" sldId="435"/>
            <ac:graphicFrameMk id="3" creationId="{CCA3A649-6702-23F6-AB39-BF86B5A637AD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8:00.302" v="564"/>
        <pc:sldMkLst>
          <pc:docMk/>
          <pc:sldMk cId="2425966623" sldId="436"/>
        </pc:sldMkLst>
        <pc:graphicFrameChg chg="mod">
          <ac:chgData name="Kaygisiz, Kübra" userId="4bfbf330-8776-4086-a830-2184b07ba8db" providerId="ADAL" clId="{1BB04EDD-A3E3-453A-B4B6-6AA1C24487B8}" dt="2022-08-23T12:18:00.302" v="564"/>
          <ac:graphicFrameMkLst>
            <pc:docMk/>
            <pc:sldMk cId="2425966623" sldId="436"/>
            <ac:graphicFrameMk id="3" creationId="{86B07337-3EE0-A024-F7D3-425E41E1A16C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8:05.900" v="567"/>
        <pc:sldMkLst>
          <pc:docMk/>
          <pc:sldMk cId="1442506015" sldId="437"/>
        </pc:sldMkLst>
        <pc:graphicFrameChg chg="mod">
          <ac:chgData name="Kaygisiz, Kübra" userId="4bfbf330-8776-4086-a830-2184b07ba8db" providerId="ADAL" clId="{1BB04EDD-A3E3-453A-B4B6-6AA1C24487B8}" dt="2022-08-23T12:18:05.900" v="567"/>
          <ac:graphicFrameMkLst>
            <pc:docMk/>
            <pc:sldMk cId="1442506015" sldId="437"/>
            <ac:graphicFrameMk id="3" creationId="{30AA2302-8F9E-DC84-FDC6-27BFCB389706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8:11.160" v="570"/>
        <pc:sldMkLst>
          <pc:docMk/>
          <pc:sldMk cId="2819304349" sldId="438"/>
        </pc:sldMkLst>
        <pc:graphicFrameChg chg="mod">
          <ac:chgData name="Kaygisiz, Kübra" userId="4bfbf330-8776-4086-a830-2184b07ba8db" providerId="ADAL" clId="{1BB04EDD-A3E3-453A-B4B6-6AA1C24487B8}" dt="2022-08-23T12:18:11.160" v="570"/>
          <ac:graphicFrameMkLst>
            <pc:docMk/>
            <pc:sldMk cId="2819304349" sldId="438"/>
            <ac:graphicFrameMk id="3" creationId="{4FC7F079-0FE3-4E40-7381-94F0BF8D4D2D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8:17.891" v="573"/>
        <pc:sldMkLst>
          <pc:docMk/>
          <pc:sldMk cId="241617016" sldId="439"/>
        </pc:sldMkLst>
        <pc:graphicFrameChg chg="mod">
          <ac:chgData name="Kaygisiz, Kübra" userId="4bfbf330-8776-4086-a830-2184b07ba8db" providerId="ADAL" clId="{1BB04EDD-A3E3-453A-B4B6-6AA1C24487B8}" dt="2022-08-23T12:18:17.891" v="573"/>
          <ac:graphicFrameMkLst>
            <pc:docMk/>
            <pc:sldMk cId="241617016" sldId="439"/>
            <ac:graphicFrameMk id="3" creationId="{52978788-8D24-395A-1ECB-B30EE845A3AC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8:23.565" v="576"/>
        <pc:sldMkLst>
          <pc:docMk/>
          <pc:sldMk cId="1356194684" sldId="440"/>
        </pc:sldMkLst>
        <pc:graphicFrameChg chg="mod">
          <ac:chgData name="Kaygisiz, Kübra" userId="4bfbf330-8776-4086-a830-2184b07ba8db" providerId="ADAL" clId="{1BB04EDD-A3E3-453A-B4B6-6AA1C24487B8}" dt="2022-08-23T12:18:23.565" v="576"/>
          <ac:graphicFrameMkLst>
            <pc:docMk/>
            <pc:sldMk cId="1356194684" sldId="440"/>
            <ac:graphicFrameMk id="3" creationId="{04012620-4885-102F-A9C4-02D7E8DD06A4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8:29.927" v="579"/>
        <pc:sldMkLst>
          <pc:docMk/>
          <pc:sldMk cId="4124821120" sldId="441"/>
        </pc:sldMkLst>
        <pc:graphicFrameChg chg="mod">
          <ac:chgData name="Kaygisiz, Kübra" userId="4bfbf330-8776-4086-a830-2184b07ba8db" providerId="ADAL" clId="{1BB04EDD-A3E3-453A-B4B6-6AA1C24487B8}" dt="2022-08-23T12:18:29.927" v="579"/>
          <ac:graphicFrameMkLst>
            <pc:docMk/>
            <pc:sldMk cId="4124821120" sldId="441"/>
            <ac:graphicFrameMk id="3" creationId="{1965FC0E-714B-7AB8-9018-ED1B320C9BA9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8:36.604" v="582"/>
        <pc:sldMkLst>
          <pc:docMk/>
          <pc:sldMk cId="1252098238" sldId="442"/>
        </pc:sldMkLst>
        <pc:graphicFrameChg chg="mod">
          <ac:chgData name="Kaygisiz, Kübra" userId="4bfbf330-8776-4086-a830-2184b07ba8db" providerId="ADAL" clId="{1BB04EDD-A3E3-453A-B4B6-6AA1C24487B8}" dt="2022-08-23T12:18:36.604" v="582"/>
          <ac:graphicFrameMkLst>
            <pc:docMk/>
            <pc:sldMk cId="1252098238" sldId="442"/>
            <ac:graphicFrameMk id="3" creationId="{594DC7F4-6F82-994D-AEA1-BA61E29DD075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8:43.080" v="585"/>
        <pc:sldMkLst>
          <pc:docMk/>
          <pc:sldMk cId="4083636769" sldId="443"/>
        </pc:sldMkLst>
        <pc:graphicFrameChg chg="mod">
          <ac:chgData name="Kaygisiz, Kübra" userId="4bfbf330-8776-4086-a830-2184b07ba8db" providerId="ADAL" clId="{1BB04EDD-A3E3-453A-B4B6-6AA1C24487B8}" dt="2022-08-23T12:18:43.080" v="585"/>
          <ac:graphicFrameMkLst>
            <pc:docMk/>
            <pc:sldMk cId="4083636769" sldId="443"/>
            <ac:graphicFrameMk id="3" creationId="{D96C33D6-3A9B-98A5-6543-7EE1D7B0771E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8:48.547" v="588"/>
        <pc:sldMkLst>
          <pc:docMk/>
          <pc:sldMk cId="2446753213" sldId="444"/>
        </pc:sldMkLst>
        <pc:graphicFrameChg chg="mod">
          <ac:chgData name="Kaygisiz, Kübra" userId="4bfbf330-8776-4086-a830-2184b07ba8db" providerId="ADAL" clId="{1BB04EDD-A3E3-453A-B4B6-6AA1C24487B8}" dt="2022-08-23T12:18:48.547" v="588"/>
          <ac:graphicFrameMkLst>
            <pc:docMk/>
            <pc:sldMk cId="2446753213" sldId="444"/>
            <ac:graphicFrameMk id="5" creationId="{8C034DA7-937A-967A-5087-A91631C74B5C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8:53.429" v="591"/>
        <pc:sldMkLst>
          <pc:docMk/>
          <pc:sldMk cId="1266816577" sldId="445"/>
        </pc:sldMkLst>
        <pc:graphicFrameChg chg="mod">
          <ac:chgData name="Kaygisiz, Kübra" userId="4bfbf330-8776-4086-a830-2184b07ba8db" providerId="ADAL" clId="{1BB04EDD-A3E3-453A-B4B6-6AA1C24487B8}" dt="2022-08-23T12:18:53.429" v="591"/>
          <ac:graphicFrameMkLst>
            <pc:docMk/>
            <pc:sldMk cId="1266816577" sldId="445"/>
            <ac:graphicFrameMk id="3" creationId="{7C483C47-208D-D07D-0B12-FC04A164A9F7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8:58.754" v="594"/>
        <pc:sldMkLst>
          <pc:docMk/>
          <pc:sldMk cId="1847673940" sldId="446"/>
        </pc:sldMkLst>
        <pc:graphicFrameChg chg="mod">
          <ac:chgData name="Kaygisiz, Kübra" userId="4bfbf330-8776-4086-a830-2184b07ba8db" providerId="ADAL" clId="{1BB04EDD-A3E3-453A-B4B6-6AA1C24487B8}" dt="2022-08-23T12:18:58.754" v="594"/>
          <ac:graphicFrameMkLst>
            <pc:docMk/>
            <pc:sldMk cId="1847673940" sldId="446"/>
            <ac:graphicFrameMk id="3" creationId="{2B67A0B9-0598-4669-0C64-E46E2A657EB9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9:04.370" v="597"/>
        <pc:sldMkLst>
          <pc:docMk/>
          <pc:sldMk cId="477770089" sldId="447"/>
        </pc:sldMkLst>
        <pc:graphicFrameChg chg="mod">
          <ac:chgData name="Kaygisiz, Kübra" userId="4bfbf330-8776-4086-a830-2184b07ba8db" providerId="ADAL" clId="{1BB04EDD-A3E3-453A-B4B6-6AA1C24487B8}" dt="2022-08-23T12:19:04.370" v="597"/>
          <ac:graphicFrameMkLst>
            <pc:docMk/>
            <pc:sldMk cId="477770089" sldId="447"/>
            <ac:graphicFrameMk id="3" creationId="{8BD9D24F-053A-0CFA-B948-6D55387F2F5F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19:09.957" v="600"/>
        <pc:sldMkLst>
          <pc:docMk/>
          <pc:sldMk cId="3274997653" sldId="448"/>
        </pc:sldMkLst>
        <pc:graphicFrameChg chg="mod">
          <ac:chgData name="Kaygisiz, Kübra" userId="4bfbf330-8776-4086-a830-2184b07ba8db" providerId="ADAL" clId="{1BB04EDD-A3E3-453A-B4B6-6AA1C24487B8}" dt="2022-08-23T12:19:09.957" v="600"/>
          <ac:graphicFrameMkLst>
            <pc:docMk/>
            <pc:sldMk cId="3274997653" sldId="448"/>
            <ac:graphicFrameMk id="3" creationId="{6EBD037C-5055-0B33-3A56-301A18FDEA39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0:19.393" v="732"/>
        <pc:sldMkLst>
          <pc:docMk/>
          <pc:sldMk cId="3268225756" sldId="450"/>
        </pc:sldMkLst>
        <pc:graphicFrameChg chg="mod">
          <ac:chgData name="Kaygisiz, Kübra" userId="4bfbf330-8776-4086-a830-2184b07ba8db" providerId="ADAL" clId="{1BB04EDD-A3E3-453A-B4B6-6AA1C24487B8}" dt="2022-08-23T12:30:19.393" v="732"/>
          <ac:graphicFrameMkLst>
            <pc:docMk/>
            <pc:sldMk cId="3268225756" sldId="450"/>
            <ac:graphicFrameMk id="3" creationId="{2F1E8D4E-CC4D-E34D-59C3-A5296790F199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0:24.345" v="735"/>
        <pc:sldMkLst>
          <pc:docMk/>
          <pc:sldMk cId="1020192741" sldId="451"/>
        </pc:sldMkLst>
        <pc:graphicFrameChg chg="mod">
          <ac:chgData name="Kaygisiz, Kübra" userId="4bfbf330-8776-4086-a830-2184b07ba8db" providerId="ADAL" clId="{1BB04EDD-A3E3-453A-B4B6-6AA1C24487B8}" dt="2022-08-23T12:30:24.345" v="735"/>
          <ac:graphicFrameMkLst>
            <pc:docMk/>
            <pc:sldMk cId="1020192741" sldId="451"/>
            <ac:graphicFrameMk id="3" creationId="{CF5A494B-CE3B-C79E-6978-8C247A4535BB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0:34.216" v="741"/>
        <pc:sldMkLst>
          <pc:docMk/>
          <pc:sldMk cId="3320063209" sldId="452"/>
        </pc:sldMkLst>
        <pc:graphicFrameChg chg="mod">
          <ac:chgData name="Kaygisiz, Kübra" userId="4bfbf330-8776-4086-a830-2184b07ba8db" providerId="ADAL" clId="{1BB04EDD-A3E3-453A-B4B6-6AA1C24487B8}" dt="2022-08-23T12:30:34.216" v="741"/>
          <ac:graphicFrameMkLst>
            <pc:docMk/>
            <pc:sldMk cId="3320063209" sldId="452"/>
            <ac:graphicFrameMk id="3" creationId="{5BBA8795-E97B-DEB7-AB5C-EF2202CE5FE1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0:38.730" v="744"/>
        <pc:sldMkLst>
          <pc:docMk/>
          <pc:sldMk cId="3944776280" sldId="453"/>
        </pc:sldMkLst>
        <pc:graphicFrameChg chg="mod">
          <ac:chgData name="Kaygisiz, Kübra" userId="4bfbf330-8776-4086-a830-2184b07ba8db" providerId="ADAL" clId="{1BB04EDD-A3E3-453A-B4B6-6AA1C24487B8}" dt="2022-08-23T12:30:38.730" v="744"/>
          <ac:graphicFrameMkLst>
            <pc:docMk/>
            <pc:sldMk cId="3944776280" sldId="453"/>
            <ac:graphicFrameMk id="3" creationId="{86999E90-2167-7AAB-5A15-3B7CB1D471E0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0:44.370" v="747"/>
        <pc:sldMkLst>
          <pc:docMk/>
          <pc:sldMk cId="4079554333" sldId="454"/>
        </pc:sldMkLst>
        <pc:graphicFrameChg chg="mod">
          <ac:chgData name="Kaygisiz, Kübra" userId="4bfbf330-8776-4086-a830-2184b07ba8db" providerId="ADAL" clId="{1BB04EDD-A3E3-453A-B4B6-6AA1C24487B8}" dt="2022-08-23T12:30:44.370" v="747"/>
          <ac:graphicFrameMkLst>
            <pc:docMk/>
            <pc:sldMk cId="4079554333" sldId="454"/>
            <ac:graphicFrameMk id="3" creationId="{7A3FEC20-2854-23E5-0CA4-D47DA0CF8E31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0:58.774" v="753"/>
        <pc:sldMkLst>
          <pc:docMk/>
          <pc:sldMk cId="2915459117" sldId="455"/>
        </pc:sldMkLst>
        <pc:graphicFrameChg chg="mod">
          <ac:chgData name="Kaygisiz, Kübra" userId="4bfbf330-8776-4086-a830-2184b07ba8db" providerId="ADAL" clId="{1BB04EDD-A3E3-453A-B4B6-6AA1C24487B8}" dt="2022-08-23T12:30:58.774" v="753"/>
          <ac:graphicFrameMkLst>
            <pc:docMk/>
            <pc:sldMk cId="2915459117" sldId="455"/>
            <ac:graphicFrameMk id="3" creationId="{5622D0AB-5AD8-D5B4-B3F5-1C98BB92B1BD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1:04.617" v="756"/>
        <pc:sldMkLst>
          <pc:docMk/>
          <pc:sldMk cId="2197159243" sldId="456"/>
        </pc:sldMkLst>
        <pc:graphicFrameChg chg="mod">
          <ac:chgData name="Kaygisiz, Kübra" userId="4bfbf330-8776-4086-a830-2184b07ba8db" providerId="ADAL" clId="{1BB04EDD-A3E3-453A-B4B6-6AA1C24487B8}" dt="2022-08-23T12:31:04.617" v="756"/>
          <ac:graphicFrameMkLst>
            <pc:docMk/>
            <pc:sldMk cId="2197159243" sldId="456"/>
            <ac:graphicFrameMk id="3" creationId="{16612341-2FA2-EB18-E5BE-BC4D44AD413B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1:09.709" v="759"/>
        <pc:sldMkLst>
          <pc:docMk/>
          <pc:sldMk cId="3325073965" sldId="457"/>
        </pc:sldMkLst>
        <pc:graphicFrameChg chg="mod">
          <ac:chgData name="Kaygisiz, Kübra" userId="4bfbf330-8776-4086-a830-2184b07ba8db" providerId="ADAL" clId="{1BB04EDD-A3E3-453A-B4B6-6AA1C24487B8}" dt="2022-08-23T12:31:09.709" v="759"/>
          <ac:graphicFrameMkLst>
            <pc:docMk/>
            <pc:sldMk cId="3325073965" sldId="457"/>
            <ac:graphicFrameMk id="3" creationId="{851BBF8B-0961-05C5-D471-A2935578C642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1:20.175" v="765"/>
        <pc:sldMkLst>
          <pc:docMk/>
          <pc:sldMk cId="2536143135" sldId="458"/>
        </pc:sldMkLst>
        <pc:graphicFrameChg chg="mod">
          <ac:chgData name="Kaygisiz, Kübra" userId="4bfbf330-8776-4086-a830-2184b07ba8db" providerId="ADAL" clId="{1BB04EDD-A3E3-453A-B4B6-6AA1C24487B8}" dt="2022-08-23T12:31:20.175" v="765"/>
          <ac:graphicFrameMkLst>
            <pc:docMk/>
            <pc:sldMk cId="2536143135" sldId="458"/>
            <ac:graphicFrameMk id="3" creationId="{8BFDA809-99B7-7174-FE6B-7E3E6FDA0E0F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1:25.002" v="768"/>
        <pc:sldMkLst>
          <pc:docMk/>
          <pc:sldMk cId="2659747753" sldId="459"/>
        </pc:sldMkLst>
        <pc:graphicFrameChg chg="mod">
          <ac:chgData name="Kaygisiz, Kübra" userId="4bfbf330-8776-4086-a830-2184b07ba8db" providerId="ADAL" clId="{1BB04EDD-A3E3-453A-B4B6-6AA1C24487B8}" dt="2022-08-23T12:31:25.002" v="768"/>
          <ac:graphicFrameMkLst>
            <pc:docMk/>
            <pc:sldMk cId="2659747753" sldId="459"/>
            <ac:graphicFrameMk id="3" creationId="{64F0B379-31B5-0D13-384C-F80930DFE29E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1:35.734" v="771"/>
        <pc:sldMkLst>
          <pc:docMk/>
          <pc:sldMk cId="2539225582" sldId="460"/>
        </pc:sldMkLst>
        <pc:graphicFrameChg chg="mod">
          <ac:chgData name="Kaygisiz, Kübra" userId="4bfbf330-8776-4086-a830-2184b07ba8db" providerId="ADAL" clId="{1BB04EDD-A3E3-453A-B4B6-6AA1C24487B8}" dt="2022-08-23T12:31:35.734" v="771"/>
          <ac:graphicFrameMkLst>
            <pc:docMk/>
            <pc:sldMk cId="2539225582" sldId="460"/>
            <ac:graphicFrameMk id="3" creationId="{DE81403B-81B5-4444-E0CE-CB947E445DE3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1:51.465" v="774"/>
        <pc:sldMkLst>
          <pc:docMk/>
          <pc:sldMk cId="1832263747" sldId="461"/>
        </pc:sldMkLst>
        <pc:graphicFrameChg chg="mod">
          <ac:chgData name="Kaygisiz, Kübra" userId="4bfbf330-8776-4086-a830-2184b07ba8db" providerId="ADAL" clId="{1BB04EDD-A3E3-453A-B4B6-6AA1C24487B8}" dt="2022-08-23T12:31:51.465" v="774"/>
          <ac:graphicFrameMkLst>
            <pc:docMk/>
            <pc:sldMk cId="1832263747" sldId="461"/>
            <ac:graphicFrameMk id="3" creationId="{F0E1EC38-588F-F6D9-53DC-B7B3F5241D50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1:56.839" v="777"/>
        <pc:sldMkLst>
          <pc:docMk/>
          <pc:sldMk cId="644598879" sldId="462"/>
        </pc:sldMkLst>
        <pc:graphicFrameChg chg="mod">
          <ac:chgData name="Kaygisiz, Kübra" userId="4bfbf330-8776-4086-a830-2184b07ba8db" providerId="ADAL" clId="{1BB04EDD-A3E3-453A-B4B6-6AA1C24487B8}" dt="2022-08-23T12:31:56.839" v="777"/>
          <ac:graphicFrameMkLst>
            <pc:docMk/>
            <pc:sldMk cId="644598879" sldId="462"/>
            <ac:graphicFrameMk id="3" creationId="{0852E2E2-2A9B-1E77-020A-8F68DC82E7A3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2:02.746" v="780"/>
        <pc:sldMkLst>
          <pc:docMk/>
          <pc:sldMk cId="1217276297" sldId="463"/>
        </pc:sldMkLst>
        <pc:graphicFrameChg chg="mod">
          <ac:chgData name="Kaygisiz, Kübra" userId="4bfbf330-8776-4086-a830-2184b07ba8db" providerId="ADAL" clId="{1BB04EDD-A3E3-453A-B4B6-6AA1C24487B8}" dt="2022-08-23T12:32:02.746" v="780"/>
          <ac:graphicFrameMkLst>
            <pc:docMk/>
            <pc:sldMk cId="1217276297" sldId="463"/>
            <ac:graphicFrameMk id="3" creationId="{8B79FF27-54B3-F566-41A6-0FF1B433B691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2:09.510" v="783"/>
        <pc:sldMkLst>
          <pc:docMk/>
          <pc:sldMk cId="3882373646" sldId="464"/>
        </pc:sldMkLst>
        <pc:graphicFrameChg chg="mod">
          <ac:chgData name="Kaygisiz, Kübra" userId="4bfbf330-8776-4086-a830-2184b07ba8db" providerId="ADAL" clId="{1BB04EDD-A3E3-453A-B4B6-6AA1C24487B8}" dt="2022-08-23T12:32:09.510" v="783"/>
          <ac:graphicFrameMkLst>
            <pc:docMk/>
            <pc:sldMk cId="3882373646" sldId="464"/>
            <ac:graphicFrameMk id="3" creationId="{00D84317-BA66-5960-73CF-C17E15547E43}"/>
          </ac:graphicFrameMkLst>
        </pc:graphicFrameChg>
      </pc:sldChg>
      <pc:sldChg chg="modSp mod">
        <pc:chgData name="Kaygisiz, Kübra" userId="4bfbf330-8776-4086-a830-2184b07ba8db" providerId="ADAL" clId="{1BB04EDD-A3E3-453A-B4B6-6AA1C24487B8}" dt="2022-08-23T12:32:15.149" v="787"/>
        <pc:sldMkLst>
          <pc:docMk/>
          <pc:sldMk cId="189820617" sldId="465"/>
        </pc:sldMkLst>
        <pc:graphicFrameChg chg="mod">
          <ac:chgData name="Kaygisiz, Kübra" userId="4bfbf330-8776-4086-a830-2184b07ba8db" providerId="ADAL" clId="{1BB04EDD-A3E3-453A-B4B6-6AA1C24487B8}" dt="2022-08-23T12:32:15.149" v="787"/>
          <ac:graphicFrameMkLst>
            <pc:docMk/>
            <pc:sldMk cId="189820617" sldId="465"/>
            <ac:graphicFrameMk id="3" creationId="{C153D3CD-C1B3-9467-0B2C-8F9267E1930B}"/>
          </ac:graphicFrameMkLst>
        </pc:graphicFrameChg>
      </pc:sldChg>
      <pc:sldChg chg="modSp mod">
        <pc:chgData name="Kaygisiz, Kübra" userId="4bfbf330-8776-4086-a830-2184b07ba8db" providerId="ADAL" clId="{1BB04EDD-A3E3-453A-B4B6-6AA1C24487B8}" dt="2022-08-23T12:32:21.194" v="791"/>
        <pc:sldMkLst>
          <pc:docMk/>
          <pc:sldMk cId="2890709503" sldId="466"/>
        </pc:sldMkLst>
        <pc:graphicFrameChg chg="mod">
          <ac:chgData name="Kaygisiz, Kübra" userId="4bfbf330-8776-4086-a830-2184b07ba8db" providerId="ADAL" clId="{1BB04EDD-A3E3-453A-B4B6-6AA1C24487B8}" dt="2022-08-23T12:32:21.194" v="791"/>
          <ac:graphicFrameMkLst>
            <pc:docMk/>
            <pc:sldMk cId="2890709503" sldId="466"/>
            <ac:graphicFrameMk id="3" creationId="{E8F47143-0E79-BA80-6443-0CD58E8612BA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2:26.474" v="794"/>
        <pc:sldMkLst>
          <pc:docMk/>
          <pc:sldMk cId="751934346" sldId="467"/>
        </pc:sldMkLst>
        <pc:graphicFrameChg chg="mod">
          <ac:chgData name="Kaygisiz, Kübra" userId="4bfbf330-8776-4086-a830-2184b07ba8db" providerId="ADAL" clId="{1BB04EDD-A3E3-453A-B4B6-6AA1C24487B8}" dt="2022-08-23T12:32:26.474" v="794"/>
          <ac:graphicFrameMkLst>
            <pc:docMk/>
            <pc:sldMk cId="751934346" sldId="467"/>
            <ac:graphicFrameMk id="3" creationId="{67151486-7062-3C90-EDA1-2695F5C84C77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2:32.082" v="797"/>
        <pc:sldMkLst>
          <pc:docMk/>
          <pc:sldMk cId="3588625897" sldId="468"/>
        </pc:sldMkLst>
        <pc:graphicFrameChg chg="mod">
          <ac:chgData name="Kaygisiz, Kübra" userId="4bfbf330-8776-4086-a830-2184b07ba8db" providerId="ADAL" clId="{1BB04EDD-A3E3-453A-B4B6-6AA1C24487B8}" dt="2022-08-23T12:32:32.082" v="797"/>
          <ac:graphicFrameMkLst>
            <pc:docMk/>
            <pc:sldMk cId="3588625897" sldId="468"/>
            <ac:graphicFrameMk id="3" creationId="{98C3C48E-F4B9-9591-43FF-4BADFF130359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2:36.722" v="800"/>
        <pc:sldMkLst>
          <pc:docMk/>
          <pc:sldMk cId="1144400893" sldId="469"/>
        </pc:sldMkLst>
        <pc:graphicFrameChg chg="mod">
          <ac:chgData name="Kaygisiz, Kübra" userId="4bfbf330-8776-4086-a830-2184b07ba8db" providerId="ADAL" clId="{1BB04EDD-A3E3-453A-B4B6-6AA1C24487B8}" dt="2022-08-23T12:32:36.722" v="800"/>
          <ac:graphicFrameMkLst>
            <pc:docMk/>
            <pc:sldMk cId="1144400893" sldId="469"/>
            <ac:graphicFrameMk id="3" creationId="{B6FBF74A-8E66-AF16-88EE-9CF0AC208588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2:42.299" v="803"/>
        <pc:sldMkLst>
          <pc:docMk/>
          <pc:sldMk cId="2896684177" sldId="470"/>
        </pc:sldMkLst>
        <pc:graphicFrameChg chg="mod">
          <ac:chgData name="Kaygisiz, Kübra" userId="4bfbf330-8776-4086-a830-2184b07ba8db" providerId="ADAL" clId="{1BB04EDD-A3E3-453A-B4B6-6AA1C24487B8}" dt="2022-08-23T12:32:42.299" v="803"/>
          <ac:graphicFrameMkLst>
            <pc:docMk/>
            <pc:sldMk cId="2896684177" sldId="470"/>
            <ac:graphicFrameMk id="3" creationId="{22D80BAB-1B71-4693-56B2-7A4B50CD4D2C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2:46.860" v="806"/>
        <pc:sldMkLst>
          <pc:docMk/>
          <pc:sldMk cId="419698809" sldId="471"/>
        </pc:sldMkLst>
        <pc:graphicFrameChg chg="mod">
          <ac:chgData name="Kaygisiz, Kübra" userId="4bfbf330-8776-4086-a830-2184b07ba8db" providerId="ADAL" clId="{1BB04EDD-A3E3-453A-B4B6-6AA1C24487B8}" dt="2022-08-23T12:32:46.860" v="806"/>
          <ac:graphicFrameMkLst>
            <pc:docMk/>
            <pc:sldMk cId="419698809" sldId="471"/>
            <ac:graphicFrameMk id="3" creationId="{D7351502-B0E4-1164-4D81-2193F51F53BC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2:53.249" v="809"/>
        <pc:sldMkLst>
          <pc:docMk/>
          <pc:sldMk cId="39428503" sldId="472"/>
        </pc:sldMkLst>
        <pc:graphicFrameChg chg="mod">
          <ac:chgData name="Kaygisiz, Kübra" userId="4bfbf330-8776-4086-a830-2184b07ba8db" providerId="ADAL" clId="{1BB04EDD-A3E3-453A-B4B6-6AA1C24487B8}" dt="2022-08-23T12:32:53.249" v="809"/>
          <ac:graphicFrameMkLst>
            <pc:docMk/>
            <pc:sldMk cId="39428503" sldId="472"/>
            <ac:graphicFrameMk id="3" creationId="{866056D0-14BA-B51C-F6D4-EE01AFA0BEE9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2:58.217" v="812"/>
        <pc:sldMkLst>
          <pc:docMk/>
          <pc:sldMk cId="3659388234" sldId="473"/>
        </pc:sldMkLst>
        <pc:graphicFrameChg chg="mod">
          <ac:chgData name="Kaygisiz, Kübra" userId="4bfbf330-8776-4086-a830-2184b07ba8db" providerId="ADAL" clId="{1BB04EDD-A3E3-453A-B4B6-6AA1C24487B8}" dt="2022-08-23T12:32:58.217" v="812"/>
          <ac:graphicFrameMkLst>
            <pc:docMk/>
            <pc:sldMk cId="3659388234" sldId="473"/>
            <ac:graphicFrameMk id="3" creationId="{A1938167-0883-410F-CA04-0DCC8CE90C7D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3:03.842" v="815"/>
        <pc:sldMkLst>
          <pc:docMk/>
          <pc:sldMk cId="1530853510" sldId="474"/>
        </pc:sldMkLst>
        <pc:graphicFrameChg chg="mod">
          <ac:chgData name="Kaygisiz, Kübra" userId="4bfbf330-8776-4086-a830-2184b07ba8db" providerId="ADAL" clId="{1BB04EDD-A3E3-453A-B4B6-6AA1C24487B8}" dt="2022-08-23T12:33:03.842" v="815"/>
          <ac:graphicFrameMkLst>
            <pc:docMk/>
            <pc:sldMk cId="1530853510" sldId="474"/>
            <ac:graphicFrameMk id="3" creationId="{22EEF7F9-34FE-3C6B-9A09-DD0BC9C4B859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3:11.434" v="818"/>
        <pc:sldMkLst>
          <pc:docMk/>
          <pc:sldMk cId="3082231621" sldId="475"/>
        </pc:sldMkLst>
        <pc:graphicFrameChg chg="mod">
          <ac:chgData name="Kaygisiz, Kübra" userId="4bfbf330-8776-4086-a830-2184b07ba8db" providerId="ADAL" clId="{1BB04EDD-A3E3-453A-B4B6-6AA1C24487B8}" dt="2022-08-23T12:33:11.434" v="818"/>
          <ac:graphicFrameMkLst>
            <pc:docMk/>
            <pc:sldMk cId="3082231621" sldId="475"/>
            <ac:graphicFrameMk id="3" creationId="{530260F5-C3C0-DCBB-A8FB-4448B28383D2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3:17.463" v="821"/>
        <pc:sldMkLst>
          <pc:docMk/>
          <pc:sldMk cId="2464123735" sldId="476"/>
        </pc:sldMkLst>
        <pc:graphicFrameChg chg="mod">
          <ac:chgData name="Kaygisiz, Kübra" userId="4bfbf330-8776-4086-a830-2184b07ba8db" providerId="ADAL" clId="{1BB04EDD-A3E3-453A-B4B6-6AA1C24487B8}" dt="2022-08-23T12:33:17.463" v="821"/>
          <ac:graphicFrameMkLst>
            <pc:docMk/>
            <pc:sldMk cId="2464123735" sldId="476"/>
            <ac:graphicFrameMk id="3" creationId="{879E0506-7E8A-C67B-5A48-47984CA7B44A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3:24.977" v="824"/>
        <pc:sldMkLst>
          <pc:docMk/>
          <pc:sldMk cId="520262732" sldId="477"/>
        </pc:sldMkLst>
        <pc:graphicFrameChg chg="mod">
          <ac:chgData name="Kaygisiz, Kübra" userId="4bfbf330-8776-4086-a830-2184b07ba8db" providerId="ADAL" clId="{1BB04EDD-A3E3-453A-B4B6-6AA1C24487B8}" dt="2022-08-23T12:33:24.977" v="824"/>
          <ac:graphicFrameMkLst>
            <pc:docMk/>
            <pc:sldMk cId="520262732" sldId="477"/>
            <ac:graphicFrameMk id="3" creationId="{05B4CBA1-5BA7-5733-AC28-7431E36FA1AE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3:29.976" v="827"/>
        <pc:sldMkLst>
          <pc:docMk/>
          <pc:sldMk cId="726334426" sldId="478"/>
        </pc:sldMkLst>
        <pc:graphicFrameChg chg="mod">
          <ac:chgData name="Kaygisiz, Kübra" userId="4bfbf330-8776-4086-a830-2184b07ba8db" providerId="ADAL" clId="{1BB04EDD-A3E3-453A-B4B6-6AA1C24487B8}" dt="2022-08-23T12:33:29.976" v="827"/>
          <ac:graphicFrameMkLst>
            <pc:docMk/>
            <pc:sldMk cId="726334426" sldId="478"/>
            <ac:graphicFrameMk id="3" creationId="{DFAAF874-9912-225F-1744-9FD1256B9E53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3:35.116" v="830"/>
        <pc:sldMkLst>
          <pc:docMk/>
          <pc:sldMk cId="4166951486" sldId="479"/>
        </pc:sldMkLst>
        <pc:graphicFrameChg chg="mod">
          <ac:chgData name="Kaygisiz, Kübra" userId="4bfbf330-8776-4086-a830-2184b07ba8db" providerId="ADAL" clId="{1BB04EDD-A3E3-453A-B4B6-6AA1C24487B8}" dt="2022-08-23T12:33:35.116" v="830"/>
          <ac:graphicFrameMkLst>
            <pc:docMk/>
            <pc:sldMk cId="4166951486" sldId="479"/>
            <ac:graphicFrameMk id="3" creationId="{AA821C5C-A017-61D1-5E2D-615F684662DE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3:40.786" v="833"/>
        <pc:sldMkLst>
          <pc:docMk/>
          <pc:sldMk cId="306648616" sldId="480"/>
        </pc:sldMkLst>
        <pc:graphicFrameChg chg="mod">
          <ac:chgData name="Kaygisiz, Kübra" userId="4bfbf330-8776-4086-a830-2184b07ba8db" providerId="ADAL" clId="{1BB04EDD-A3E3-453A-B4B6-6AA1C24487B8}" dt="2022-08-23T12:33:40.786" v="833"/>
          <ac:graphicFrameMkLst>
            <pc:docMk/>
            <pc:sldMk cId="306648616" sldId="480"/>
            <ac:graphicFrameMk id="3" creationId="{39374C9D-165D-DD8E-D4CC-4F69351A138A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29:41.890" v="711"/>
        <pc:sldMkLst>
          <pc:docMk/>
          <pc:sldMk cId="1379774886" sldId="481"/>
        </pc:sldMkLst>
        <pc:graphicFrameChg chg="mod">
          <ac:chgData name="Kaygisiz, Kübra" userId="4bfbf330-8776-4086-a830-2184b07ba8db" providerId="ADAL" clId="{1BB04EDD-A3E3-453A-B4B6-6AA1C24487B8}" dt="2022-08-23T12:29:41.890" v="711"/>
          <ac:graphicFrameMkLst>
            <pc:docMk/>
            <pc:sldMk cId="1379774886" sldId="481"/>
            <ac:graphicFrameMk id="3" creationId="{A80712C3-F7A0-5E09-B3DE-3E3652F9B3D1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0:09.785" v="726"/>
        <pc:sldMkLst>
          <pc:docMk/>
          <pc:sldMk cId="1479216872" sldId="482"/>
        </pc:sldMkLst>
        <pc:graphicFrameChg chg="mod">
          <ac:chgData name="Kaygisiz, Kübra" userId="4bfbf330-8776-4086-a830-2184b07ba8db" providerId="ADAL" clId="{1BB04EDD-A3E3-453A-B4B6-6AA1C24487B8}" dt="2022-08-23T12:30:09.785" v="726"/>
          <ac:graphicFrameMkLst>
            <pc:docMk/>
            <pc:sldMk cId="1479216872" sldId="482"/>
            <ac:graphicFrameMk id="3" creationId="{3A4DA96A-7599-32AA-AB2A-10BB8D2D550A}"/>
          </ac:graphicFrameMkLst>
        </pc:graphicFrameChg>
      </pc:sldChg>
      <pc:sldChg chg="modSp">
        <pc:chgData name="Kaygisiz, Kübra" userId="4bfbf330-8776-4086-a830-2184b07ba8db" providerId="ADAL" clId="{1BB04EDD-A3E3-453A-B4B6-6AA1C24487B8}" dt="2022-08-23T12:30:14.441" v="729"/>
        <pc:sldMkLst>
          <pc:docMk/>
          <pc:sldMk cId="1225807883" sldId="483"/>
        </pc:sldMkLst>
        <pc:graphicFrameChg chg="mod">
          <ac:chgData name="Kaygisiz, Kübra" userId="4bfbf330-8776-4086-a830-2184b07ba8db" providerId="ADAL" clId="{1BB04EDD-A3E3-453A-B4B6-6AA1C24487B8}" dt="2022-08-23T12:30:14.441" v="729"/>
          <ac:graphicFrameMkLst>
            <pc:docMk/>
            <pc:sldMk cId="1225807883" sldId="483"/>
            <ac:graphicFrameMk id="3" creationId="{F8746310-210A-3327-7FA6-44EEF20F98EF}"/>
          </ac:graphicFrameMkLst>
        </pc:graphicFrameChg>
      </pc:sldChg>
    </pc:docChg>
  </pc:docChgLst>
  <pc:docChgLst>
    <pc:chgData name="Kaygisiz, Kübra" userId="4bfbf330-8776-4086-a830-2184b07ba8db" providerId="ADAL" clId="{3BADC0B2-0F94-45F6-B552-1A87FB5F996F}"/>
    <pc:docChg chg="undo custSel addSld delSld modSld">
      <pc:chgData name="Kaygisiz, Kübra" userId="4bfbf330-8776-4086-a830-2184b07ba8db" providerId="ADAL" clId="{3BADC0B2-0F94-45F6-B552-1A87FB5F996F}" dt="2022-08-21T03:36:42.576" v="1190" actId="1076"/>
      <pc:docMkLst>
        <pc:docMk/>
      </pc:docMkLst>
      <pc:sldChg chg="new del">
        <pc:chgData name="Kaygisiz, Kübra" userId="4bfbf330-8776-4086-a830-2184b07ba8db" providerId="ADAL" clId="{3BADC0B2-0F94-45F6-B552-1A87FB5F996F}" dt="2022-08-19T08:21:35.136" v="2" actId="47"/>
        <pc:sldMkLst>
          <pc:docMk/>
          <pc:sldMk cId="1823457193" sldId="256"/>
        </pc:sldMkLst>
      </pc:sldChg>
      <pc:sldChg chg="addSp delSp modSp new mod">
        <pc:chgData name="Kaygisiz, Kübra" userId="4bfbf330-8776-4086-a830-2184b07ba8db" providerId="ADAL" clId="{3BADC0B2-0F94-45F6-B552-1A87FB5F996F}" dt="2022-08-19T09:17:43.165" v="269" actId="1076"/>
        <pc:sldMkLst>
          <pc:docMk/>
          <pc:sldMk cId="3709697322" sldId="257"/>
        </pc:sldMkLst>
        <pc:spChg chg="mod">
          <ac:chgData name="Kaygisiz, Kübra" userId="4bfbf330-8776-4086-a830-2184b07ba8db" providerId="ADAL" clId="{3BADC0B2-0F94-45F6-B552-1A87FB5F996F}" dt="2022-08-19T08:34:25.860" v="14" actId="20577"/>
          <ac:spMkLst>
            <pc:docMk/>
            <pc:sldMk cId="3709697322" sldId="257"/>
            <ac:spMk id="2" creationId="{DD224004-A10B-BB2E-D57E-FBC4980C4C7E}"/>
          </ac:spMkLst>
        </pc:spChg>
        <pc:spChg chg="add mod">
          <ac:chgData name="Kaygisiz, Kübra" userId="4bfbf330-8776-4086-a830-2184b07ba8db" providerId="ADAL" clId="{3BADC0B2-0F94-45F6-B552-1A87FB5F996F}" dt="2022-08-19T09:17:43.165" v="269" actId="1076"/>
          <ac:spMkLst>
            <pc:docMk/>
            <pc:sldMk cId="3709697322" sldId="257"/>
            <ac:spMk id="7" creationId="{4D4489DE-F75F-C79E-DDA7-6E2468876CB5}"/>
          </ac:spMkLst>
        </pc:spChg>
        <pc:graphicFrameChg chg="add del mod">
          <ac:chgData name="Kaygisiz, Kübra" userId="4bfbf330-8776-4086-a830-2184b07ba8db" providerId="ADAL" clId="{3BADC0B2-0F94-45F6-B552-1A87FB5F996F}" dt="2022-08-19T08:34:44.936" v="15" actId="478"/>
          <ac:graphicFrameMkLst>
            <pc:docMk/>
            <pc:sldMk cId="3709697322" sldId="257"/>
            <ac:graphicFrameMk id="3" creationId="{116B78FD-8EAA-1E30-902F-C6F4E8AF4C48}"/>
          </ac:graphicFrameMkLst>
        </pc:graphicFrameChg>
        <pc:graphicFrameChg chg="add del mod">
          <ac:chgData name="Kaygisiz, Kübra" userId="4bfbf330-8776-4086-a830-2184b07ba8db" providerId="ADAL" clId="{3BADC0B2-0F94-45F6-B552-1A87FB5F996F}" dt="2022-08-19T08:34:59.259" v="18" actId="478"/>
          <ac:graphicFrameMkLst>
            <pc:docMk/>
            <pc:sldMk cId="3709697322" sldId="257"/>
            <ac:graphicFrameMk id="4" creationId="{B3045E72-C0D0-9F8C-30B4-29B6AA9C8FA8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19T08:35:03.234" v="22" actId="1076"/>
          <ac:graphicFrameMkLst>
            <pc:docMk/>
            <pc:sldMk cId="3709697322" sldId="257"/>
            <ac:graphicFrameMk id="5" creationId="{9598A848-6988-DFBC-6317-EF5FC0B056AD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19T09:17:38.834" v="264" actId="1076"/>
          <ac:graphicFrameMkLst>
            <pc:docMk/>
            <pc:sldMk cId="3709697322" sldId="257"/>
            <ac:graphicFrameMk id="6" creationId="{856BF660-8C66-F835-CC5A-AB4AC80A3C7D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09:18:37.650" v="292" actId="1076"/>
        <pc:sldMkLst>
          <pc:docMk/>
          <pc:sldMk cId="3448490834" sldId="258"/>
        </pc:sldMkLst>
        <pc:spChg chg="mod">
          <ac:chgData name="Kaygisiz, Kübra" userId="4bfbf330-8776-4086-a830-2184b07ba8db" providerId="ADAL" clId="{3BADC0B2-0F94-45F6-B552-1A87FB5F996F}" dt="2022-08-19T08:38:23.850" v="26" actId="20577"/>
          <ac:spMkLst>
            <pc:docMk/>
            <pc:sldMk cId="3448490834" sldId="258"/>
            <ac:spMk id="2" creationId="{46A5994D-C1C8-B305-1E90-2B0F05BD51B2}"/>
          </ac:spMkLst>
        </pc:spChg>
        <pc:spChg chg="add mod">
          <ac:chgData name="Kaygisiz, Kübra" userId="4bfbf330-8776-4086-a830-2184b07ba8db" providerId="ADAL" clId="{3BADC0B2-0F94-45F6-B552-1A87FB5F996F}" dt="2022-08-19T09:17:44.630" v="270"/>
          <ac:spMkLst>
            <pc:docMk/>
            <pc:sldMk cId="3448490834" sldId="258"/>
            <ac:spMk id="4" creationId="{75D7CCA4-DDD4-B10E-DB57-0CCD676F1EBF}"/>
          </ac:spMkLst>
        </pc:spChg>
        <pc:graphicFrameChg chg="add mod">
          <ac:chgData name="Kaygisiz, Kübra" userId="4bfbf330-8776-4086-a830-2184b07ba8db" providerId="ADAL" clId="{3BADC0B2-0F94-45F6-B552-1A87FB5F996F}" dt="2022-08-19T08:38:27.616" v="29" actId="1076"/>
          <ac:graphicFrameMkLst>
            <pc:docMk/>
            <pc:sldMk cId="3448490834" sldId="258"/>
            <ac:graphicFrameMk id="3" creationId="{9C2AD32A-2B87-78AD-C822-3CF649D4C623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19T09:18:37.650" v="292" actId="1076"/>
          <ac:graphicFrameMkLst>
            <pc:docMk/>
            <pc:sldMk cId="3448490834" sldId="258"/>
            <ac:graphicFrameMk id="5" creationId="{9D144CA1-CBDE-5053-25C2-6EBC7ABAE7D7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09:17:45.605" v="271"/>
        <pc:sldMkLst>
          <pc:docMk/>
          <pc:sldMk cId="4170109118" sldId="259"/>
        </pc:sldMkLst>
        <pc:spChg chg="mod">
          <ac:chgData name="Kaygisiz, Kübra" userId="4bfbf330-8776-4086-a830-2184b07ba8db" providerId="ADAL" clId="{3BADC0B2-0F94-45F6-B552-1A87FB5F996F}" dt="2022-08-19T08:39:28.394" v="36" actId="20577"/>
          <ac:spMkLst>
            <pc:docMk/>
            <pc:sldMk cId="4170109118" sldId="259"/>
            <ac:spMk id="2" creationId="{C6E22ACC-58DE-957A-485C-FAC3CD5AD00B}"/>
          </ac:spMkLst>
        </pc:spChg>
        <pc:spChg chg="add mod">
          <ac:chgData name="Kaygisiz, Kübra" userId="4bfbf330-8776-4086-a830-2184b07ba8db" providerId="ADAL" clId="{3BADC0B2-0F94-45F6-B552-1A87FB5F996F}" dt="2022-08-19T09:17:45.605" v="271"/>
          <ac:spMkLst>
            <pc:docMk/>
            <pc:sldMk cId="4170109118" sldId="259"/>
            <ac:spMk id="4" creationId="{2D6B007C-7C19-DF5C-E2E2-C30C2648262D}"/>
          </ac:spMkLst>
        </pc:spChg>
        <pc:graphicFrameChg chg="add mod">
          <ac:chgData name="Kaygisiz, Kübra" userId="4bfbf330-8776-4086-a830-2184b07ba8db" providerId="ADAL" clId="{3BADC0B2-0F94-45F6-B552-1A87FB5F996F}" dt="2022-08-19T08:39:33.414" v="37" actId="1076"/>
          <ac:graphicFrameMkLst>
            <pc:docMk/>
            <pc:sldMk cId="4170109118" sldId="259"/>
            <ac:graphicFrameMk id="3" creationId="{012EBF41-B7D4-9D2C-4A45-329EEA3CC952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09:21:31.980" v="295" actId="1076"/>
        <pc:sldMkLst>
          <pc:docMk/>
          <pc:sldMk cId="1431922808" sldId="260"/>
        </pc:sldMkLst>
        <pc:spChg chg="mod">
          <ac:chgData name="Kaygisiz, Kübra" userId="4bfbf330-8776-4086-a830-2184b07ba8db" providerId="ADAL" clId="{3BADC0B2-0F94-45F6-B552-1A87FB5F996F}" dt="2022-08-19T08:40:34.153" v="41" actId="20577"/>
          <ac:spMkLst>
            <pc:docMk/>
            <pc:sldMk cId="1431922808" sldId="260"/>
            <ac:spMk id="2" creationId="{F538D61D-2768-4B43-2A12-F68611980136}"/>
          </ac:spMkLst>
        </pc:spChg>
        <pc:spChg chg="add mod">
          <ac:chgData name="Kaygisiz, Kübra" userId="4bfbf330-8776-4086-a830-2184b07ba8db" providerId="ADAL" clId="{3BADC0B2-0F94-45F6-B552-1A87FB5F996F}" dt="2022-08-19T09:17:46.429" v="272"/>
          <ac:spMkLst>
            <pc:docMk/>
            <pc:sldMk cId="1431922808" sldId="260"/>
            <ac:spMk id="4" creationId="{A14A7F61-06C6-42EF-3D05-3CA0DBFFAD68}"/>
          </ac:spMkLst>
        </pc:spChg>
        <pc:graphicFrameChg chg="add mod">
          <ac:chgData name="Kaygisiz, Kübra" userId="4bfbf330-8776-4086-a830-2184b07ba8db" providerId="ADAL" clId="{3BADC0B2-0F94-45F6-B552-1A87FB5F996F}" dt="2022-08-19T08:40:39.579" v="45" actId="1076"/>
          <ac:graphicFrameMkLst>
            <pc:docMk/>
            <pc:sldMk cId="1431922808" sldId="260"/>
            <ac:graphicFrameMk id="3" creationId="{5781A883-D93D-D814-CBAC-2B920ADF72D0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19T09:21:31.980" v="295" actId="1076"/>
          <ac:graphicFrameMkLst>
            <pc:docMk/>
            <pc:sldMk cId="1431922808" sldId="260"/>
            <ac:graphicFrameMk id="5" creationId="{C854EF07-69E9-5204-C931-0DA1C45B1BD2}"/>
          </ac:graphicFrameMkLst>
        </pc:graphicFrameChg>
      </pc:sldChg>
      <pc:sldChg chg="addSp delSp modSp new mod">
        <pc:chgData name="Kaygisiz, Kübra" userId="4bfbf330-8776-4086-a830-2184b07ba8db" providerId="ADAL" clId="{3BADC0B2-0F94-45F6-B552-1A87FB5F996F}" dt="2022-08-19T10:26:48.462" v="849" actId="1076"/>
        <pc:sldMkLst>
          <pc:docMk/>
          <pc:sldMk cId="3658403204" sldId="261"/>
        </pc:sldMkLst>
        <pc:spChg chg="mod">
          <ac:chgData name="Kaygisiz, Kübra" userId="4bfbf330-8776-4086-a830-2184b07ba8db" providerId="ADAL" clId="{3BADC0B2-0F94-45F6-B552-1A87FB5F996F}" dt="2022-08-19T08:44:05.440" v="49" actId="20577"/>
          <ac:spMkLst>
            <pc:docMk/>
            <pc:sldMk cId="3658403204" sldId="261"/>
            <ac:spMk id="2" creationId="{CB5E3A83-712F-A188-D12A-E4C622C671F7}"/>
          </ac:spMkLst>
        </pc:spChg>
        <pc:spChg chg="add mod">
          <ac:chgData name="Kaygisiz, Kübra" userId="4bfbf330-8776-4086-a830-2184b07ba8db" providerId="ADAL" clId="{3BADC0B2-0F94-45F6-B552-1A87FB5F996F}" dt="2022-08-19T09:17:47.146" v="273"/>
          <ac:spMkLst>
            <pc:docMk/>
            <pc:sldMk cId="3658403204" sldId="261"/>
            <ac:spMk id="4" creationId="{2952F886-F80E-223B-0A1C-D0E15BFF2C41}"/>
          </ac:spMkLst>
        </pc:spChg>
        <pc:graphicFrameChg chg="add del mod">
          <ac:chgData name="Kaygisiz, Kübra" userId="4bfbf330-8776-4086-a830-2184b07ba8db" providerId="ADAL" clId="{3BADC0B2-0F94-45F6-B552-1A87FB5F996F}" dt="2022-08-19T10:26:47.282" v="848" actId="478"/>
          <ac:graphicFrameMkLst>
            <pc:docMk/>
            <pc:sldMk cId="3658403204" sldId="261"/>
            <ac:graphicFrameMk id="3" creationId="{791F694D-64C7-701F-76D7-B4C100707EE0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19T09:23:12.111" v="297" actId="1076"/>
          <ac:graphicFrameMkLst>
            <pc:docMk/>
            <pc:sldMk cId="3658403204" sldId="261"/>
            <ac:graphicFrameMk id="5" creationId="{CE39D2A4-C425-470D-070C-1DB7B4580FEF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19T10:26:48.462" v="849" actId="1076"/>
          <ac:graphicFrameMkLst>
            <pc:docMk/>
            <pc:sldMk cId="3658403204" sldId="261"/>
            <ac:graphicFrameMk id="6" creationId="{8CB58870-95FA-CF82-EAFA-8AC9FF9A9F4F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09:23:51.358" v="299" actId="1076"/>
        <pc:sldMkLst>
          <pc:docMk/>
          <pc:sldMk cId="2878210316" sldId="262"/>
        </pc:sldMkLst>
        <pc:spChg chg="mod">
          <ac:chgData name="Kaygisiz, Kübra" userId="4bfbf330-8776-4086-a830-2184b07ba8db" providerId="ADAL" clId="{3BADC0B2-0F94-45F6-B552-1A87FB5F996F}" dt="2022-08-19T08:45:05.603" v="57" actId="20577"/>
          <ac:spMkLst>
            <pc:docMk/>
            <pc:sldMk cId="2878210316" sldId="262"/>
            <ac:spMk id="2" creationId="{456E3565-9B65-6E98-33EC-6E9FC3C5F8E4}"/>
          </ac:spMkLst>
        </pc:spChg>
        <pc:spChg chg="add mod">
          <ac:chgData name="Kaygisiz, Kübra" userId="4bfbf330-8776-4086-a830-2184b07ba8db" providerId="ADAL" clId="{3BADC0B2-0F94-45F6-B552-1A87FB5F996F}" dt="2022-08-19T09:17:47.685" v="274"/>
          <ac:spMkLst>
            <pc:docMk/>
            <pc:sldMk cId="2878210316" sldId="262"/>
            <ac:spMk id="4" creationId="{0A38BAAC-0628-4DE5-DA14-B5349009715E}"/>
          </ac:spMkLst>
        </pc:spChg>
        <pc:graphicFrameChg chg="add mod">
          <ac:chgData name="Kaygisiz, Kübra" userId="4bfbf330-8776-4086-a830-2184b07ba8db" providerId="ADAL" clId="{3BADC0B2-0F94-45F6-B552-1A87FB5F996F}" dt="2022-08-19T08:45:16.719" v="61" actId="1076"/>
          <ac:graphicFrameMkLst>
            <pc:docMk/>
            <pc:sldMk cId="2878210316" sldId="262"/>
            <ac:graphicFrameMk id="3" creationId="{F870D1C8-184E-6001-7338-BA0399938D02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19T09:23:51.358" v="299" actId="1076"/>
          <ac:graphicFrameMkLst>
            <pc:docMk/>
            <pc:sldMk cId="2878210316" sldId="262"/>
            <ac:graphicFrameMk id="5" creationId="{4F08B011-A543-C786-B2BE-96BE967B524D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09:24:20.015" v="301" actId="1076"/>
        <pc:sldMkLst>
          <pc:docMk/>
          <pc:sldMk cId="104774107" sldId="263"/>
        </pc:sldMkLst>
        <pc:spChg chg="mod">
          <ac:chgData name="Kaygisiz, Kübra" userId="4bfbf330-8776-4086-a830-2184b07ba8db" providerId="ADAL" clId="{3BADC0B2-0F94-45F6-B552-1A87FB5F996F}" dt="2022-08-19T08:46:24.764" v="65" actId="20577"/>
          <ac:spMkLst>
            <pc:docMk/>
            <pc:sldMk cId="104774107" sldId="263"/>
            <ac:spMk id="2" creationId="{70EE830C-7750-D443-4667-6836255D9A85}"/>
          </ac:spMkLst>
        </pc:spChg>
        <pc:spChg chg="add mod">
          <ac:chgData name="Kaygisiz, Kübra" userId="4bfbf330-8776-4086-a830-2184b07ba8db" providerId="ADAL" clId="{3BADC0B2-0F94-45F6-B552-1A87FB5F996F}" dt="2022-08-19T09:17:48.671" v="275"/>
          <ac:spMkLst>
            <pc:docMk/>
            <pc:sldMk cId="104774107" sldId="263"/>
            <ac:spMk id="4" creationId="{FD1FF362-782A-F94A-C729-225812923FD3}"/>
          </ac:spMkLst>
        </pc:spChg>
        <pc:graphicFrameChg chg="add mod">
          <ac:chgData name="Kaygisiz, Kübra" userId="4bfbf330-8776-4086-a830-2184b07ba8db" providerId="ADAL" clId="{3BADC0B2-0F94-45F6-B552-1A87FB5F996F}" dt="2022-08-19T08:46:27.786" v="68" actId="14100"/>
          <ac:graphicFrameMkLst>
            <pc:docMk/>
            <pc:sldMk cId="104774107" sldId="263"/>
            <ac:graphicFrameMk id="3" creationId="{CFB50CA3-FD73-6A78-B319-17AD4B1E708C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19T09:24:20.015" v="301" actId="1076"/>
          <ac:graphicFrameMkLst>
            <pc:docMk/>
            <pc:sldMk cId="104774107" sldId="263"/>
            <ac:graphicFrameMk id="5" creationId="{2671258B-EBE7-2013-D0A9-95DA85C6DDC4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09:24:46.714" v="303" actId="1076"/>
        <pc:sldMkLst>
          <pc:docMk/>
          <pc:sldMk cId="519245554" sldId="264"/>
        </pc:sldMkLst>
        <pc:spChg chg="mod">
          <ac:chgData name="Kaygisiz, Kübra" userId="4bfbf330-8776-4086-a830-2184b07ba8db" providerId="ADAL" clId="{3BADC0B2-0F94-45F6-B552-1A87FB5F996F}" dt="2022-08-19T08:47:06.866" v="78" actId="20577"/>
          <ac:spMkLst>
            <pc:docMk/>
            <pc:sldMk cId="519245554" sldId="264"/>
            <ac:spMk id="2" creationId="{527843DD-8AAF-ABAC-C7BB-39A2903516A1}"/>
          </ac:spMkLst>
        </pc:spChg>
        <pc:spChg chg="add mod">
          <ac:chgData name="Kaygisiz, Kübra" userId="4bfbf330-8776-4086-a830-2184b07ba8db" providerId="ADAL" clId="{3BADC0B2-0F94-45F6-B552-1A87FB5F996F}" dt="2022-08-19T09:17:49.235" v="276"/>
          <ac:spMkLst>
            <pc:docMk/>
            <pc:sldMk cId="519245554" sldId="264"/>
            <ac:spMk id="4" creationId="{E87DC42A-ECAC-4D1D-0D3C-5A2E73507CD7}"/>
          </ac:spMkLst>
        </pc:spChg>
        <pc:graphicFrameChg chg="add mod">
          <ac:chgData name="Kaygisiz, Kübra" userId="4bfbf330-8776-4086-a830-2184b07ba8db" providerId="ADAL" clId="{3BADC0B2-0F94-45F6-B552-1A87FB5F996F}" dt="2022-08-19T08:47:11.522" v="82" actId="1076"/>
          <ac:graphicFrameMkLst>
            <pc:docMk/>
            <pc:sldMk cId="519245554" sldId="264"/>
            <ac:graphicFrameMk id="3" creationId="{8002B9A2-D110-DEE8-0024-28ADA583481E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19T09:24:46.714" v="303" actId="1076"/>
          <ac:graphicFrameMkLst>
            <pc:docMk/>
            <pc:sldMk cId="519245554" sldId="264"/>
            <ac:graphicFrameMk id="5" creationId="{FB484AF1-5689-BB96-F8DD-264BE0B256A2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09:25:31.145" v="307" actId="1076"/>
        <pc:sldMkLst>
          <pc:docMk/>
          <pc:sldMk cId="3314426039" sldId="265"/>
        </pc:sldMkLst>
        <pc:spChg chg="mod">
          <ac:chgData name="Kaygisiz, Kübra" userId="4bfbf330-8776-4086-a830-2184b07ba8db" providerId="ADAL" clId="{3BADC0B2-0F94-45F6-B552-1A87FB5F996F}" dt="2022-08-19T08:47:54.881" v="86" actId="20577"/>
          <ac:spMkLst>
            <pc:docMk/>
            <pc:sldMk cId="3314426039" sldId="265"/>
            <ac:spMk id="2" creationId="{00300BAD-C3B9-A558-D719-78463836A9ED}"/>
          </ac:spMkLst>
        </pc:spChg>
        <pc:spChg chg="add mod">
          <ac:chgData name="Kaygisiz, Kübra" userId="4bfbf330-8776-4086-a830-2184b07ba8db" providerId="ADAL" clId="{3BADC0B2-0F94-45F6-B552-1A87FB5F996F}" dt="2022-08-19T09:17:50.150" v="277"/>
          <ac:spMkLst>
            <pc:docMk/>
            <pc:sldMk cId="3314426039" sldId="265"/>
            <ac:spMk id="4" creationId="{02DFC7BF-0905-4517-B7F7-ABC5E3E72B90}"/>
          </ac:spMkLst>
        </pc:spChg>
        <pc:graphicFrameChg chg="add mod">
          <ac:chgData name="Kaygisiz, Kübra" userId="4bfbf330-8776-4086-a830-2184b07ba8db" providerId="ADAL" clId="{3BADC0B2-0F94-45F6-B552-1A87FB5F996F}" dt="2022-08-19T08:47:58.958" v="90" actId="1076"/>
          <ac:graphicFrameMkLst>
            <pc:docMk/>
            <pc:sldMk cId="3314426039" sldId="265"/>
            <ac:graphicFrameMk id="3" creationId="{154D3A0C-81BC-106A-BC28-A4EC58E520BB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19T09:25:31.145" v="307" actId="1076"/>
          <ac:graphicFrameMkLst>
            <pc:docMk/>
            <pc:sldMk cId="3314426039" sldId="265"/>
            <ac:graphicFrameMk id="5" creationId="{C1133F88-E3B1-B52E-D6C1-8FC93FDE46FA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09:26:53.541" v="309" actId="1076"/>
        <pc:sldMkLst>
          <pc:docMk/>
          <pc:sldMk cId="1323477964" sldId="266"/>
        </pc:sldMkLst>
        <pc:spChg chg="mod">
          <ac:chgData name="Kaygisiz, Kübra" userId="4bfbf330-8776-4086-a830-2184b07ba8db" providerId="ADAL" clId="{3BADC0B2-0F94-45F6-B552-1A87FB5F996F}" dt="2022-08-19T08:48:32.026" v="95" actId="20577"/>
          <ac:spMkLst>
            <pc:docMk/>
            <pc:sldMk cId="1323477964" sldId="266"/>
            <ac:spMk id="2" creationId="{E8081B74-518C-04C1-25EC-7ED273905D4C}"/>
          </ac:spMkLst>
        </pc:spChg>
        <pc:spChg chg="add mod">
          <ac:chgData name="Kaygisiz, Kübra" userId="4bfbf330-8776-4086-a830-2184b07ba8db" providerId="ADAL" clId="{3BADC0B2-0F94-45F6-B552-1A87FB5F996F}" dt="2022-08-19T09:17:50.933" v="278"/>
          <ac:spMkLst>
            <pc:docMk/>
            <pc:sldMk cId="1323477964" sldId="266"/>
            <ac:spMk id="4" creationId="{F39E8FCE-623E-6135-C65C-62138CDFBDED}"/>
          </ac:spMkLst>
        </pc:spChg>
        <pc:graphicFrameChg chg="add mod">
          <ac:chgData name="Kaygisiz, Kübra" userId="4bfbf330-8776-4086-a830-2184b07ba8db" providerId="ADAL" clId="{3BADC0B2-0F94-45F6-B552-1A87FB5F996F}" dt="2022-08-19T08:49:30.108" v="102"/>
          <ac:graphicFrameMkLst>
            <pc:docMk/>
            <pc:sldMk cId="1323477964" sldId="266"/>
            <ac:graphicFrameMk id="3" creationId="{68C253E2-E1AF-B950-604C-44EEF399FC7D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19T09:26:53.541" v="309" actId="1076"/>
          <ac:graphicFrameMkLst>
            <pc:docMk/>
            <pc:sldMk cId="1323477964" sldId="266"/>
            <ac:graphicFrameMk id="5" creationId="{0E63375F-CC09-B095-7523-564CDA594A59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09:27:20.934" v="311" actId="1076"/>
        <pc:sldMkLst>
          <pc:docMk/>
          <pc:sldMk cId="3493876726" sldId="267"/>
        </pc:sldMkLst>
        <pc:spChg chg="mod">
          <ac:chgData name="Kaygisiz, Kübra" userId="4bfbf330-8776-4086-a830-2184b07ba8db" providerId="ADAL" clId="{3BADC0B2-0F94-45F6-B552-1A87FB5F996F}" dt="2022-08-19T08:49:41.240" v="107" actId="20577"/>
          <ac:spMkLst>
            <pc:docMk/>
            <pc:sldMk cId="3493876726" sldId="267"/>
            <ac:spMk id="2" creationId="{125334BF-6393-01E1-4C76-D58FDBBAE6AE}"/>
          </ac:spMkLst>
        </pc:spChg>
        <pc:spChg chg="add mod">
          <ac:chgData name="Kaygisiz, Kübra" userId="4bfbf330-8776-4086-a830-2184b07ba8db" providerId="ADAL" clId="{3BADC0B2-0F94-45F6-B552-1A87FB5F996F}" dt="2022-08-19T09:17:51.959" v="279"/>
          <ac:spMkLst>
            <pc:docMk/>
            <pc:sldMk cId="3493876726" sldId="267"/>
            <ac:spMk id="4" creationId="{C17F1FE7-6732-2E42-4F89-1D7101C86643}"/>
          </ac:spMkLst>
        </pc:spChg>
        <pc:graphicFrameChg chg="add mod">
          <ac:chgData name="Kaygisiz, Kübra" userId="4bfbf330-8776-4086-a830-2184b07ba8db" providerId="ADAL" clId="{3BADC0B2-0F94-45F6-B552-1A87FB5F996F}" dt="2022-08-19T08:50:39.863" v="111" actId="1076"/>
          <ac:graphicFrameMkLst>
            <pc:docMk/>
            <pc:sldMk cId="3493876726" sldId="267"/>
            <ac:graphicFrameMk id="3" creationId="{CA2B8A02-D028-D752-87A6-AFDCE4589CFE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19T09:27:20.934" v="311" actId="1076"/>
          <ac:graphicFrameMkLst>
            <pc:docMk/>
            <pc:sldMk cId="3493876726" sldId="267"/>
            <ac:graphicFrameMk id="5" creationId="{E3686079-5496-F3DB-D331-FEAD96114ABF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09:27:46.662" v="313" actId="1076"/>
        <pc:sldMkLst>
          <pc:docMk/>
          <pc:sldMk cId="3621259937" sldId="268"/>
        </pc:sldMkLst>
        <pc:spChg chg="mod">
          <ac:chgData name="Kaygisiz, Kübra" userId="4bfbf330-8776-4086-a830-2184b07ba8db" providerId="ADAL" clId="{3BADC0B2-0F94-45F6-B552-1A87FB5F996F}" dt="2022-08-19T08:51:26.812" v="116" actId="20577"/>
          <ac:spMkLst>
            <pc:docMk/>
            <pc:sldMk cId="3621259937" sldId="268"/>
            <ac:spMk id="2" creationId="{43C97F67-D736-6592-B265-387A771BDAFC}"/>
          </ac:spMkLst>
        </pc:spChg>
        <pc:spChg chg="add mod">
          <ac:chgData name="Kaygisiz, Kübra" userId="4bfbf330-8776-4086-a830-2184b07ba8db" providerId="ADAL" clId="{3BADC0B2-0F94-45F6-B552-1A87FB5F996F}" dt="2022-08-19T09:17:52.738" v="280"/>
          <ac:spMkLst>
            <pc:docMk/>
            <pc:sldMk cId="3621259937" sldId="268"/>
            <ac:spMk id="4" creationId="{4CD42CD6-F513-3DF6-E333-B750C85DD63B}"/>
          </ac:spMkLst>
        </pc:spChg>
        <pc:graphicFrameChg chg="add mod">
          <ac:chgData name="Kaygisiz, Kübra" userId="4bfbf330-8776-4086-a830-2184b07ba8db" providerId="ADAL" clId="{3BADC0B2-0F94-45F6-B552-1A87FB5F996F}" dt="2022-08-19T08:51:31.475" v="121" actId="14100"/>
          <ac:graphicFrameMkLst>
            <pc:docMk/>
            <pc:sldMk cId="3621259937" sldId="268"/>
            <ac:graphicFrameMk id="3" creationId="{313DACC5-4C42-35BE-9FCF-1357981C1BB0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19T09:27:46.662" v="313" actId="1076"/>
          <ac:graphicFrameMkLst>
            <pc:docMk/>
            <pc:sldMk cId="3621259937" sldId="268"/>
            <ac:graphicFrameMk id="5" creationId="{552C6901-7EEB-507E-51E1-CA03E162E1B1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09:17:53.800" v="281"/>
        <pc:sldMkLst>
          <pc:docMk/>
          <pc:sldMk cId="770258183" sldId="269"/>
        </pc:sldMkLst>
        <pc:spChg chg="mod">
          <ac:chgData name="Kaygisiz, Kübra" userId="4bfbf330-8776-4086-a830-2184b07ba8db" providerId="ADAL" clId="{3BADC0B2-0F94-45F6-B552-1A87FB5F996F}" dt="2022-08-19T08:52:25.531" v="126" actId="20577"/>
          <ac:spMkLst>
            <pc:docMk/>
            <pc:sldMk cId="770258183" sldId="269"/>
            <ac:spMk id="2" creationId="{BBF2F61C-F9B7-D3B2-900C-0BB645CD559C}"/>
          </ac:spMkLst>
        </pc:spChg>
        <pc:spChg chg="add mod">
          <ac:chgData name="Kaygisiz, Kübra" userId="4bfbf330-8776-4086-a830-2184b07ba8db" providerId="ADAL" clId="{3BADC0B2-0F94-45F6-B552-1A87FB5F996F}" dt="2022-08-19T09:17:53.800" v="281"/>
          <ac:spMkLst>
            <pc:docMk/>
            <pc:sldMk cId="770258183" sldId="269"/>
            <ac:spMk id="4" creationId="{0AF8E50B-A309-9BF7-7064-1FF071BF5181}"/>
          </ac:spMkLst>
        </pc:spChg>
        <pc:graphicFrameChg chg="add mod">
          <ac:chgData name="Kaygisiz, Kübra" userId="4bfbf330-8776-4086-a830-2184b07ba8db" providerId="ADAL" clId="{3BADC0B2-0F94-45F6-B552-1A87FB5F996F}" dt="2022-08-19T08:52:29.542" v="130" actId="1076"/>
          <ac:graphicFrameMkLst>
            <pc:docMk/>
            <pc:sldMk cId="770258183" sldId="269"/>
            <ac:graphicFrameMk id="3" creationId="{D25435BF-DDCD-4A2C-7BCA-436E2F69E98F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09:28:13.835" v="315" actId="1076"/>
        <pc:sldMkLst>
          <pc:docMk/>
          <pc:sldMk cId="1899709365" sldId="270"/>
        </pc:sldMkLst>
        <pc:spChg chg="mod">
          <ac:chgData name="Kaygisiz, Kübra" userId="4bfbf330-8776-4086-a830-2184b07ba8db" providerId="ADAL" clId="{3BADC0B2-0F94-45F6-B552-1A87FB5F996F}" dt="2022-08-19T08:53:13.439" v="135" actId="20577"/>
          <ac:spMkLst>
            <pc:docMk/>
            <pc:sldMk cId="1899709365" sldId="270"/>
            <ac:spMk id="2" creationId="{D0B71C4A-7209-3A18-2616-AF80F64D168F}"/>
          </ac:spMkLst>
        </pc:spChg>
        <pc:spChg chg="add mod">
          <ac:chgData name="Kaygisiz, Kübra" userId="4bfbf330-8776-4086-a830-2184b07ba8db" providerId="ADAL" clId="{3BADC0B2-0F94-45F6-B552-1A87FB5F996F}" dt="2022-08-19T09:17:54.833" v="282"/>
          <ac:spMkLst>
            <pc:docMk/>
            <pc:sldMk cId="1899709365" sldId="270"/>
            <ac:spMk id="4" creationId="{7853A18C-18F6-B50C-2335-1E702EF69454}"/>
          </ac:spMkLst>
        </pc:spChg>
        <pc:graphicFrameChg chg="add mod">
          <ac:chgData name="Kaygisiz, Kübra" userId="4bfbf330-8776-4086-a830-2184b07ba8db" providerId="ADAL" clId="{3BADC0B2-0F94-45F6-B552-1A87FB5F996F}" dt="2022-08-19T08:53:17.089" v="139" actId="1076"/>
          <ac:graphicFrameMkLst>
            <pc:docMk/>
            <pc:sldMk cId="1899709365" sldId="270"/>
            <ac:graphicFrameMk id="3" creationId="{8CC16FAB-C433-E4E8-CC86-155B936E4A86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19T09:28:13.835" v="315" actId="1076"/>
          <ac:graphicFrameMkLst>
            <pc:docMk/>
            <pc:sldMk cId="1899709365" sldId="270"/>
            <ac:graphicFrameMk id="5" creationId="{8CCB2249-7320-0447-4C16-C62AF9CB79D1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09:17:55.772" v="283"/>
        <pc:sldMkLst>
          <pc:docMk/>
          <pc:sldMk cId="2437039918" sldId="271"/>
        </pc:sldMkLst>
        <pc:spChg chg="mod">
          <ac:chgData name="Kaygisiz, Kübra" userId="4bfbf330-8776-4086-a830-2184b07ba8db" providerId="ADAL" clId="{3BADC0B2-0F94-45F6-B552-1A87FB5F996F}" dt="2022-08-19T08:54:04.445" v="144" actId="20577"/>
          <ac:spMkLst>
            <pc:docMk/>
            <pc:sldMk cId="2437039918" sldId="271"/>
            <ac:spMk id="2" creationId="{545AF185-8B52-90C1-FBAB-C7522B943DAE}"/>
          </ac:spMkLst>
        </pc:spChg>
        <pc:spChg chg="add mod">
          <ac:chgData name="Kaygisiz, Kübra" userId="4bfbf330-8776-4086-a830-2184b07ba8db" providerId="ADAL" clId="{3BADC0B2-0F94-45F6-B552-1A87FB5F996F}" dt="2022-08-19T09:17:55.772" v="283"/>
          <ac:spMkLst>
            <pc:docMk/>
            <pc:sldMk cId="2437039918" sldId="271"/>
            <ac:spMk id="4" creationId="{727063DF-CD02-25A1-FCC8-AC8A06F6C693}"/>
          </ac:spMkLst>
        </pc:spChg>
        <pc:graphicFrameChg chg="add mod">
          <ac:chgData name="Kaygisiz, Kübra" userId="4bfbf330-8776-4086-a830-2184b07ba8db" providerId="ADAL" clId="{3BADC0B2-0F94-45F6-B552-1A87FB5F996F}" dt="2022-08-19T08:54:08.412" v="148" actId="1076"/>
          <ac:graphicFrameMkLst>
            <pc:docMk/>
            <pc:sldMk cId="2437039918" sldId="271"/>
            <ac:graphicFrameMk id="3" creationId="{A2791670-238E-B8FA-F3CC-DF6A9382AA73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09:17:57.087" v="284"/>
        <pc:sldMkLst>
          <pc:docMk/>
          <pc:sldMk cId="326007136" sldId="272"/>
        </pc:sldMkLst>
        <pc:spChg chg="mod">
          <ac:chgData name="Kaygisiz, Kübra" userId="4bfbf330-8776-4086-a830-2184b07ba8db" providerId="ADAL" clId="{3BADC0B2-0F94-45F6-B552-1A87FB5F996F}" dt="2022-08-19T08:54:44.443" v="153" actId="20577"/>
          <ac:spMkLst>
            <pc:docMk/>
            <pc:sldMk cId="326007136" sldId="272"/>
            <ac:spMk id="2" creationId="{704F88BD-9572-7999-BC65-F868C178C5A6}"/>
          </ac:spMkLst>
        </pc:spChg>
        <pc:spChg chg="add mod">
          <ac:chgData name="Kaygisiz, Kübra" userId="4bfbf330-8776-4086-a830-2184b07ba8db" providerId="ADAL" clId="{3BADC0B2-0F94-45F6-B552-1A87FB5F996F}" dt="2022-08-19T09:17:57.087" v="284"/>
          <ac:spMkLst>
            <pc:docMk/>
            <pc:sldMk cId="326007136" sldId="272"/>
            <ac:spMk id="4" creationId="{12FE00E4-8AEB-0D44-68B1-0ADB0D59F100}"/>
          </ac:spMkLst>
        </pc:spChg>
        <pc:graphicFrameChg chg="add mod">
          <ac:chgData name="Kaygisiz, Kübra" userId="4bfbf330-8776-4086-a830-2184b07ba8db" providerId="ADAL" clId="{3BADC0B2-0F94-45F6-B552-1A87FB5F996F}" dt="2022-08-19T08:54:49.138" v="157" actId="1076"/>
          <ac:graphicFrameMkLst>
            <pc:docMk/>
            <pc:sldMk cId="326007136" sldId="272"/>
            <ac:graphicFrameMk id="3" creationId="{78C13780-7BAA-CC82-C411-0B23C07BBE9F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09:17:57.846" v="285"/>
        <pc:sldMkLst>
          <pc:docMk/>
          <pc:sldMk cId="373315249" sldId="273"/>
        </pc:sldMkLst>
        <pc:spChg chg="mod">
          <ac:chgData name="Kaygisiz, Kübra" userId="4bfbf330-8776-4086-a830-2184b07ba8db" providerId="ADAL" clId="{3BADC0B2-0F94-45F6-B552-1A87FB5F996F}" dt="2022-08-19T08:55:27.905" v="162" actId="20577"/>
          <ac:spMkLst>
            <pc:docMk/>
            <pc:sldMk cId="373315249" sldId="273"/>
            <ac:spMk id="2" creationId="{CBA9D285-9D41-44D3-D091-9F919D9C07D3}"/>
          </ac:spMkLst>
        </pc:spChg>
        <pc:spChg chg="add mod">
          <ac:chgData name="Kaygisiz, Kübra" userId="4bfbf330-8776-4086-a830-2184b07ba8db" providerId="ADAL" clId="{3BADC0B2-0F94-45F6-B552-1A87FB5F996F}" dt="2022-08-19T09:17:57.846" v="285"/>
          <ac:spMkLst>
            <pc:docMk/>
            <pc:sldMk cId="373315249" sldId="273"/>
            <ac:spMk id="4" creationId="{9E2300AF-A69D-C4EA-6BFF-15FAD0D0EEAD}"/>
          </ac:spMkLst>
        </pc:spChg>
        <pc:graphicFrameChg chg="add mod">
          <ac:chgData name="Kaygisiz, Kübra" userId="4bfbf330-8776-4086-a830-2184b07ba8db" providerId="ADAL" clId="{3BADC0B2-0F94-45F6-B552-1A87FB5F996F}" dt="2022-08-19T08:55:31.691" v="166" actId="1076"/>
          <ac:graphicFrameMkLst>
            <pc:docMk/>
            <pc:sldMk cId="373315249" sldId="273"/>
            <ac:graphicFrameMk id="3" creationId="{BDFE954A-D566-E8AE-ADE2-86091278C531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09:28:45.383" v="317" actId="1076"/>
        <pc:sldMkLst>
          <pc:docMk/>
          <pc:sldMk cId="2847818880" sldId="274"/>
        </pc:sldMkLst>
        <pc:spChg chg="mod">
          <ac:chgData name="Kaygisiz, Kübra" userId="4bfbf330-8776-4086-a830-2184b07ba8db" providerId="ADAL" clId="{3BADC0B2-0F94-45F6-B552-1A87FB5F996F}" dt="2022-08-19T08:56:04.876" v="171" actId="20577"/>
          <ac:spMkLst>
            <pc:docMk/>
            <pc:sldMk cId="2847818880" sldId="274"/>
            <ac:spMk id="2" creationId="{9A57DD60-0A6C-88BA-684B-4078E4E22763}"/>
          </ac:spMkLst>
        </pc:spChg>
        <pc:spChg chg="add mod">
          <ac:chgData name="Kaygisiz, Kübra" userId="4bfbf330-8776-4086-a830-2184b07ba8db" providerId="ADAL" clId="{3BADC0B2-0F94-45F6-B552-1A87FB5F996F}" dt="2022-08-19T09:17:58.494" v="286"/>
          <ac:spMkLst>
            <pc:docMk/>
            <pc:sldMk cId="2847818880" sldId="274"/>
            <ac:spMk id="4" creationId="{D71C53C2-9271-C105-3107-0C070B33F00D}"/>
          </ac:spMkLst>
        </pc:spChg>
        <pc:graphicFrameChg chg="add mod">
          <ac:chgData name="Kaygisiz, Kübra" userId="4bfbf330-8776-4086-a830-2184b07ba8db" providerId="ADAL" clId="{3BADC0B2-0F94-45F6-B552-1A87FB5F996F}" dt="2022-08-19T08:56:09.763" v="175" actId="1076"/>
          <ac:graphicFrameMkLst>
            <pc:docMk/>
            <pc:sldMk cId="2847818880" sldId="274"/>
            <ac:graphicFrameMk id="3" creationId="{78C048C6-E7ED-D0B0-24FE-C93EA8F2F217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19T09:28:45.383" v="317" actId="1076"/>
          <ac:graphicFrameMkLst>
            <pc:docMk/>
            <pc:sldMk cId="2847818880" sldId="274"/>
            <ac:graphicFrameMk id="5" creationId="{4FE9C41A-653D-F713-4C7E-0F88F78E3867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09:29:09.849" v="319" actId="1076"/>
        <pc:sldMkLst>
          <pc:docMk/>
          <pc:sldMk cId="1948445893" sldId="275"/>
        </pc:sldMkLst>
        <pc:spChg chg="mod">
          <ac:chgData name="Kaygisiz, Kübra" userId="4bfbf330-8776-4086-a830-2184b07ba8db" providerId="ADAL" clId="{3BADC0B2-0F94-45F6-B552-1A87FB5F996F}" dt="2022-08-19T09:08:19.031" v="180" actId="20577"/>
          <ac:spMkLst>
            <pc:docMk/>
            <pc:sldMk cId="1948445893" sldId="275"/>
            <ac:spMk id="2" creationId="{493315C8-CA28-05A7-5C0B-3CD2C506B830}"/>
          </ac:spMkLst>
        </pc:spChg>
        <pc:spChg chg="add mod">
          <ac:chgData name="Kaygisiz, Kübra" userId="4bfbf330-8776-4086-a830-2184b07ba8db" providerId="ADAL" clId="{3BADC0B2-0F94-45F6-B552-1A87FB5F996F}" dt="2022-08-19T09:17:59.169" v="287"/>
          <ac:spMkLst>
            <pc:docMk/>
            <pc:sldMk cId="1948445893" sldId="275"/>
            <ac:spMk id="4" creationId="{57A5E78B-4A1B-082F-4871-E738225DFD09}"/>
          </ac:spMkLst>
        </pc:spChg>
        <pc:graphicFrameChg chg="add mod">
          <ac:chgData name="Kaygisiz, Kübra" userId="4bfbf330-8776-4086-a830-2184b07ba8db" providerId="ADAL" clId="{3BADC0B2-0F94-45F6-B552-1A87FB5F996F}" dt="2022-08-19T09:08:48.481" v="184" actId="14100"/>
          <ac:graphicFrameMkLst>
            <pc:docMk/>
            <pc:sldMk cId="1948445893" sldId="275"/>
            <ac:graphicFrameMk id="3" creationId="{F5DF9242-8188-8B28-50E6-A3FF5BE88177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19T09:29:09.849" v="319" actId="1076"/>
          <ac:graphicFrameMkLst>
            <pc:docMk/>
            <pc:sldMk cId="1948445893" sldId="275"/>
            <ac:graphicFrameMk id="5" creationId="{B33E8DF4-407B-694A-60A6-433F78F122CE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09:18:00.589" v="288"/>
        <pc:sldMkLst>
          <pc:docMk/>
          <pc:sldMk cId="1287938043" sldId="276"/>
        </pc:sldMkLst>
        <pc:spChg chg="mod">
          <ac:chgData name="Kaygisiz, Kübra" userId="4bfbf330-8776-4086-a830-2184b07ba8db" providerId="ADAL" clId="{3BADC0B2-0F94-45F6-B552-1A87FB5F996F}" dt="2022-08-19T09:09:51.100" v="189" actId="20577"/>
          <ac:spMkLst>
            <pc:docMk/>
            <pc:sldMk cId="1287938043" sldId="276"/>
            <ac:spMk id="2" creationId="{3C880052-8241-E232-C015-2484F3A9EFBE}"/>
          </ac:spMkLst>
        </pc:spChg>
        <pc:spChg chg="add mod">
          <ac:chgData name="Kaygisiz, Kübra" userId="4bfbf330-8776-4086-a830-2184b07ba8db" providerId="ADAL" clId="{3BADC0B2-0F94-45F6-B552-1A87FB5F996F}" dt="2022-08-19T09:18:00.589" v="288"/>
          <ac:spMkLst>
            <pc:docMk/>
            <pc:sldMk cId="1287938043" sldId="276"/>
            <ac:spMk id="4" creationId="{387B7225-B8C7-1FED-DDA9-05D4F43FF9E8}"/>
          </ac:spMkLst>
        </pc:spChg>
        <pc:graphicFrameChg chg="add mod">
          <ac:chgData name="Kaygisiz, Kübra" userId="4bfbf330-8776-4086-a830-2184b07ba8db" providerId="ADAL" clId="{3BADC0B2-0F94-45F6-B552-1A87FB5F996F}" dt="2022-08-19T09:09:55.453" v="193" actId="1076"/>
          <ac:graphicFrameMkLst>
            <pc:docMk/>
            <pc:sldMk cId="1287938043" sldId="276"/>
            <ac:graphicFrameMk id="3" creationId="{70B99AB6-7F82-7257-8FEE-3AFD43D9220C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1:45:51.702" v="978" actId="1076"/>
        <pc:sldMkLst>
          <pc:docMk/>
          <pc:sldMk cId="4003129706" sldId="277"/>
        </pc:sldMkLst>
        <pc:spChg chg="mod">
          <ac:chgData name="Kaygisiz, Kübra" userId="4bfbf330-8776-4086-a830-2184b07ba8db" providerId="ADAL" clId="{3BADC0B2-0F94-45F6-B552-1A87FB5F996F}" dt="2022-08-19T09:10:41.395" v="199" actId="20577"/>
          <ac:spMkLst>
            <pc:docMk/>
            <pc:sldMk cId="4003129706" sldId="277"/>
            <ac:spMk id="2" creationId="{FDCB6AB1-ED0A-14B9-939D-F4BE7D2AD989}"/>
          </ac:spMkLst>
        </pc:spChg>
        <pc:graphicFrameChg chg="add mod">
          <ac:chgData name="Kaygisiz, Kübra" userId="4bfbf330-8776-4086-a830-2184b07ba8db" providerId="ADAL" clId="{3BADC0B2-0F94-45F6-B552-1A87FB5F996F}" dt="2022-08-19T09:10:45.187" v="202" actId="14100"/>
          <ac:graphicFrameMkLst>
            <pc:docMk/>
            <pc:sldMk cId="4003129706" sldId="277"/>
            <ac:graphicFrameMk id="3" creationId="{3EC4075D-4811-17C5-937B-C6DE9276D943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21T01:45:51.702" v="978" actId="1076"/>
          <ac:graphicFrameMkLst>
            <pc:docMk/>
            <pc:sldMk cId="4003129706" sldId="277"/>
            <ac:graphicFrameMk id="4" creationId="{5937F94C-8D4B-8A86-D7FF-0D7E424BE47A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1:47:06.227" v="982" actId="1076"/>
        <pc:sldMkLst>
          <pc:docMk/>
          <pc:sldMk cId="3258684061" sldId="278"/>
        </pc:sldMkLst>
        <pc:spChg chg="mod">
          <ac:chgData name="Kaygisiz, Kübra" userId="4bfbf330-8776-4086-a830-2184b07ba8db" providerId="ADAL" clId="{3BADC0B2-0F94-45F6-B552-1A87FB5F996F}" dt="2022-08-19T09:11:33.808" v="208" actId="20577"/>
          <ac:spMkLst>
            <pc:docMk/>
            <pc:sldMk cId="3258684061" sldId="278"/>
            <ac:spMk id="2" creationId="{301E977C-6411-D853-8A96-A42F790519D0}"/>
          </ac:spMkLst>
        </pc:spChg>
        <pc:graphicFrameChg chg="add mod">
          <ac:chgData name="Kaygisiz, Kübra" userId="4bfbf330-8776-4086-a830-2184b07ba8db" providerId="ADAL" clId="{3BADC0B2-0F94-45F6-B552-1A87FB5F996F}" dt="2022-08-19T09:11:37.316" v="211" actId="14100"/>
          <ac:graphicFrameMkLst>
            <pc:docMk/>
            <pc:sldMk cId="3258684061" sldId="278"/>
            <ac:graphicFrameMk id="3" creationId="{02D19A7D-1863-202C-DA52-98F0047B46FC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21T01:47:06.227" v="982" actId="1076"/>
          <ac:graphicFrameMkLst>
            <pc:docMk/>
            <pc:sldMk cId="3258684061" sldId="278"/>
            <ac:graphicFrameMk id="4" creationId="{88BEF63E-F76C-BFFB-403B-F7A7B9521DB1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09:29:45.323" v="322"/>
        <pc:sldMkLst>
          <pc:docMk/>
          <pc:sldMk cId="2974409549" sldId="279"/>
        </pc:sldMkLst>
        <pc:spChg chg="mod">
          <ac:chgData name="Kaygisiz, Kübra" userId="4bfbf330-8776-4086-a830-2184b07ba8db" providerId="ADAL" clId="{3BADC0B2-0F94-45F6-B552-1A87FB5F996F}" dt="2022-08-19T09:12:11.985" v="217" actId="20577"/>
          <ac:spMkLst>
            <pc:docMk/>
            <pc:sldMk cId="2974409549" sldId="279"/>
            <ac:spMk id="2" creationId="{8AA95231-33F6-2B34-4259-4AB69A8115A5}"/>
          </ac:spMkLst>
        </pc:spChg>
        <pc:spChg chg="add mod">
          <ac:chgData name="Kaygisiz, Kübra" userId="4bfbf330-8776-4086-a830-2184b07ba8db" providerId="ADAL" clId="{3BADC0B2-0F94-45F6-B552-1A87FB5F996F}" dt="2022-08-19T09:29:45.323" v="322"/>
          <ac:spMkLst>
            <pc:docMk/>
            <pc:sldMk cId="2974409549" sldId="279"/>
            <ac:spMk id="5" creationId="{055C0E78-2753-F2F9-23E9-F858D13C0C02}"/>
          </ac:spMkLst>
        </pc:spChg>
        <pc:graphicFrameChg chg="add mod">
          <ac:chgData name="Kaygisiz, Kübra" userId="4bfbf330-8776-4086-a830-2184b07ba8db" providerId="ADAL" clId="{3BADC0B2-0F94-45F6-B552-1A87FB5F996F}" dt="2022-08-19T09:12:15.440" v="221" actId="1076"/>
          <ac:graphicFrameMkLst>
            <pc:docMk/>
            <pc:sldMk cId="2974409549" sldId="279"/>
            <ac:graphicFrameMk id="3" creationId="{02E56959-CD39-2CD2-EE37-EB9B3D314E77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19T09:29:41.175" v="321" actId="1076"/>
          <ac:graphicFrameMkLst>
            <pc:docMk/>
            <pc:sldMk cId="2974409549" sldId="279"/>
            <ac:graphicFrameMk id="4" creationId="{8ED53B63-9C62-114C-27C5-13E9DE928979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1:48:49.121" v="993" actId="1076"/>
        <pc:sldMkLst>
          <pc:docMk/>
          <pc:sldMk cId="3384423603" sldId="280"/>
        </pc:sldMkLst>
        <pc:spChg chg="mod">
          <ac:chgData name="Kaygisiz, Kübra" userId="4bfbf330-8776-4086-a830-2184b07ba8db" providerId="ADAL" clId="{3BADC0B2-0F94-45F6-B552-1A87FB5F996F}" dt="2022-08-19T09:12:47.385" v="227" actId="20577"/>
          <ac:spMkLst>
            <pc:docMk/>
            <pc:sldMk cId="3384423603" sldId="280"/>
            <ac:spMk id="2" creationId="{6552E8D1-B09E-CC96-C402-0EB3874B11E2}"/>
          </ac:spMkLst>
        </pc:spChg>
        <pc:spChg chg="add mod">
          <ac:chgData name="Kaygisiz, Kübra" userId="4bfbf330-8776-4086-a830-2184b07ba8db" providerId="ADAL" clId="{3BADC0B2-0F94-45F6-B552-1A87FB5F996F}" dt="2022-08-19T09:29:46.647" v="323"/>
          <ac:spMkLst>
            <pc:docMk/>
            <pc:sldMk cId="3384423603" sldId="280"/>
            <ac:spMk id="4" creationId="{2681664B-D958-0B5B-1E90-B7C270E32BB9}"/>
          </ac:spMkLst>
        </pc:spChg>
        <pc:graphicFrameChg chg="add mod">
          <ac:chgData name="Kaygisiz, Kübra" userId="4bfbf330-8776-4086-a830-2184b07ba8db" providerId="ADAL" clId="{3BADC0B2-0F94-45F6-B552-1A87FB5F996F}" dt="2022-08-19T09:12:52.477" v="231" actId="1076"/>
          <ac:graphicFrameMkLst>
            <pc:docMk/>
            <pc:sldMk cId="3384423603" sldId="280"/>
            <ac:graphicFrameMk id="3" creationId="{37633C7D-85A8-104A-1536-C30567B415E0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19T09:30:19.137" v="325" actId="1076"/>
          <ac:graphicFrameMkLst>
            <pc:docMk/>
            <pc:sldMk cId="3384423603" sldId="280"/>
            <ac:graphicFrameMk id="5" creationId="{BA11648F-6610-AD21-8690-E2E5D19F7092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21T01:48:49.121" v="993" actId="1076"/>
          <ac:graphicFrameMkLst>
            <pc:docMk/>
            <pc:sldMk cId="3384423603" sldId="280"/>
            <ac:graphicFrameMk id="6" creationId="{B16414CD-835F-723A-26F8-06A229535EB8}"/>
          </ac:graphicFrameMkLst>
        </pc:graphicFrameChg>
      </pc:sldChg>
      <pc:sldChg chg="addSp delSp modSp new mod">
        <pc:chgData name="Kaygisiz, Kübra" userId="4bfbf330-8776-4086-a830-2184b07ba8db" providerId="ADAL" clId="{3BADC0B2-0F94-45F6-B552-1A87FB5F996F}" dt="2022-08-19T10:28:08.590" v="862" actId="478"/>
        <pc:sldMkLst>
          <pc:docMk/>
          <pc:sldMk cId="499453516" sldId="281"/>
        </pc:sldMkLst>
        <pc:spChg chg="mod">
          <ac:chgData name="Kaygisiz, Kübra" userId="4bfbf330-8776-4086-a830-2184b07ba8db" providerId="ADAL" clId="{3BADC0B2-0F94-45F6-B552-1A87FB5F996F}" dt="2022-08-19T09:14:28.223" v="241" actId="20577"/>
          <ac:spMkLst>
            <pc:docMk/>
            <pc:sldMk cId="499453516" sldId="281"/>
            <ac:spMk id="2" creationId="{C1F43CED-7963-6BF7-CE0F-7C1F2EFCAE6D}"/>
          </ac:spMkLst>
        </pc:spChg>
        <pc:graphicFrameChg chg="add mod">
          <ac:chgData name="Kaygisiz, Kübra" userId="4bfbf330-8776-4086-a830-2184b07ba8db" providerId="ADAL" clId="{3BADC0B2-0F94-45F6-B552-1A87FB5F996F}" dt="2022-08-19T09:14:31.995" v="244" actId="14100"/>
          <ac:graphicFrameMkLst>
            <pc:docMk/>
            <pc:sldMk cId="499453516" sldId="281"/>
            <ac:graphicFrameMk id="3" creationId="{2D0C0B03-3EA2-336C-A998-467DAFADF957}"/>
          </ac:graphicFrameMkLst>
        </pc:graphicFrameChg>
        <pc:graphicFrameChg chg="add del mod">
          <ac:chgData name="Kaygisiz, Kübra" userId="4bfbf330-8776-4086-a830-2184b07ba8db" providerId="ADAL" clId="{3BADC0B2-0F94-45F6-B552-1A87FB5F996F}" dt="2022-08-19T10:28:08.590" v="862" actId="478"/>
          <ac:graphicFrameMkLst>
            <pc:docMk/>
            <pc:sldMk cId="499453516" sldId="281"/>
            <ac:graphicFrameMk id="4" creationId="{05F4BC1F-3398-F1C0-0EFF-73350FA8CF1D}"/>
          </ac:graphicFrameMkLst>
        </pc:graphicFrameChg>
      </pc:sldChg>
      <pc:sldChg chg="addSp delSp modSp new mod">
        <pc:chgData name="Kaygisiz, Kübra" userId="4bfbf330-8776-4086-a830-2184b07ba8db" providerId="ADAL" clId="{3BADC0B2-0F94-45F6-B552-1A87FB5F996F}" dt="2022-08-19T10:29:56.407" v="871" actId="478"/>
        <pc:sldMkLst>
          <pc:docMk/>
          <pc:sldMk cId="602044471" sldId="282"/>
        </pc:sldMkLst>
        <pc:spChg chg="mod">
          <ac:chgData name="Kaygisiz, Kübra" userId="4bfbf330-8776-4086-a830-2184b07ba8db" providerId="ADAL" clId="{3BADC0B2-0F94-45F6-B552-1A87FB5F996F}" dt="2022-08-19T09:15:05.845" v="249" actId="20577"/>
          <ac:spMkLst>
            <pc:docMk/>
            <pc:sldMk cId="602044471" sldId="282"/>
            <ac:spMk id="2" creationId="{4DE55D43-B525-0DEA-3907-B5E41B0C7E00}"/>
          </ac:spMkLst>
        </pc:spChg>
        <pc:graphicFrameChg chg="add mod">
          <ac:chgData name="Kaygisiz, Kübra" userId="4bfbf330-8776-4086-a830-2184b07ba8db" providerId="ADAL" clId="{3BADC0B2-0F94-45F6-B552-1A87FB5F996F}" dt="2022-08-19T09:15:08.742" v="252" actId="1076"/>
          <ac:graphicFrameMkLst>
            <pc:docMk/>
            <pc:sldMk cId="602044471" sldId="282"/>
            <ac:graphicFrameMk id="3" creationId="{CCCF0F9C-9600-0CA4-DADF-E4E4B502E7B7}"/>
          </ac:graphicFrameMkLst>
        </pc:graphicFrameChg>
        <pc:graphicFrameChg chg="add del mod">
          <ac:chgData name="Kaygisiz, Kübra" userId="4bfbf330-8776-4086-a830-2184b07ba8db" providerId="ADAL" clId="{3BADC0B2-0F94-45F6-B552-1A87FB5F996F}" dt="2022-08-19T10:29:56.407" v="871" actId="478"/>
          <ac:graphicFrameMkLst>
            <pc:docMk/>
            <pc:sldMk cId="602044471" sldId="282"/>
            <ac:graphicFrameMk id="4" creationId="{328D059F-FF92-1A90-3310-D6187A2FA63D}"/>
          </ac:graphicFrameMkLst>
        </pc:graphicFrameChg>
      </pc:sldChg>
      <pc:sldChg chg="addSp delSp modSp new mod">
        <pc:chgData name="Kaygisiz, Kübra" userId="4bfbf330-8776-4086-a830-2184b07ba8db" providerId="ADAL" clId="{3BADC0B2-0F94-45F6-B552-1A87FB5F996F}" dt="2022-08-19T10:31:30.389" v="880" actId="478"/>
        <pc:sldMkLst>
          <pc:docMk/>
          <pc:sldMk cId="2177583764" sldId="283"/>
        </pc:sldMkLst>
        <pc:spChg chg="mod">
          <ac:chgData name="Kaygisiz, Kübra" userId="4bfbf330-8776-4086-a830-2184b07ba8db" providerId="ADAL" clId="{3BADC0B2-0F94-45F6-B552-1A87FB5F996F}" dt="2022-08-19T09:15:36.311" v="257" actId="20577"/>
          <ac:spMkLst>
            <pc:docMk/>
            <pc:sldMk cId="2177583764" sldId="283"/>
            <ac:spMk id="2" creationId="{986916DB-3DB2-E73D-359B-856C2639F9DB}"/>
          </ac:spMkLst>
        </pc:spChg>
        <pc:graphicFrameChg chg="add mod">
          <ac:chgData name="Kaygisiz, Kübra" userId="4bfbf330-8776-4086-a830-2184b07ba8db" providerId="ADAL" clId="{3BADC0B2-0F94-45F6-B552-1A87FB5F996F}" dt="2022-08-19T09:15:38.510" v="259" actId="1076"/>
          <ac:graphicFrameMkLst>
            <pc:docMk/>
            <pc:sldMk cId="2177583764" sldId="283"/>
            <ac:graphicFrameMk id="3" creationId="{2B6FD32D-98D7-1798-EF4D-AF58EE30C7F6}"/>
          </ac:graphicFrameMkLst>
        </pc:graphicFrameChg>
        <pc:graphicFrameChg chg="add del mod">
          <ac:chgData name="Kaygisiz, Kübra" userId="4bfbf330-8776-4086-a830-2184b07ba8db" providerId="ADAL" clId="{3BADC0B2-0F94-45F6-B552-1A87FB5F996F}" dt="2022-08-19T10:31:30.389" v="880" actId="478"/>
          <ac:graphicFrameMkLst>
            <pc:docMk/>
            <pc:sldMk cId="2177583764" sldId="283"/>
            <ac:graphicFrameMk id="4" creationId="{2895577E-1E91-67B0-A1F9-C8EC9198DC39}"/>
          </ac:graphicFrameMkLst>
        </pc:graphicFrameChg>
      </pc:sldChg>
      <pc:sldChg chg="new del">
        <pc:chgData name="Kaygisiz, Kübra" userId="4bfbf330-8776-4086-a830-2184b07ba8db" providerId="ADAL" clId="{3BADC0B2-0F94-45F6-B552-1A87FB5F996F}" dt="2022-08-19T09:32:52.063" v="327" actId="47"/>
        <pc:sldMkLst>
          <pc:docMk/>
          <pc:sldMk cId="712690798" sldId="284"/>
        </pc:sldMkLst>
      </pc:sldChg>
      <pc:sldChg chg="addSp modSp new mod">
        <pc:chgData name="Kaygisiz, Kübra" userId="4bfbf330-8776-4086-a830-2184b07ba8db" providerId="ADAL" clId="{3BADC0B2-0F94-45F6-B552-1A87FB5F996F}" dt="2022-08-21T02:11:39.540" v="1085" actId="1076"/>
        <pc:sldMkLst>
          <pc:docMk/>
          <pc:sldMk cId="1537632101" sldId="284"/>
        </pc:sldMkLst>
        <pc:spChg chg="mod">
          <ac:chgData name="Kaygisiz, Kübra" userId="4bfbf330-8776-4086-a830-2184b07ba8db" providerId="ADAL" clId="{3BADC0B2-0F94-45F6-B552-1A87FB5F996F}" dt="2022-08-19T09:34:11.550" v="475"/>
          <ac:spMkLst>
            <pc:docMk/>
            <pc:sldMk cId="1537632101" sldId="284"/>
            <ac:spMk id="2" creationId="{DDE5091D-7B77-C958-6D1E-3BFBEBDA7C1A}"/>
          </ac:spMkLst>
        </pc:spChg>
        <pc:graphicFrameChg chg="add mod">
          <ac:chgData name="Kaygisiz, Kübra" userId="4bfbf330-8776-4086-a830-2184b07ba8db" providerId="ADAL" clId="{3BADC0B2-0F94-45F6-B552-1A87FB5F996F}" dt="2022-08-21T02:11:39.540" v="1085" actId="1076"/>
          <ac:graphicFrameMkLst>
            <pc:docMk/>
            <pc:sldMk cId="1537632101" sldId="284"/>
            <ac:graphicFrameMk id="3" creationId="{15944574-0C88-192E-9923-2217E78D7546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3:22:15.109" v="1182" actId="1076"/>
        <pc:sldMkLst>
          <pc:docMk/>
          <pc:sldMk cId="2546421780" sldId="285"/>
        </pc:sldMkLst>
        <pc:spChg chg="mod">
          <ac:chgData name="Kaygisiz, Kübra" userId="4bfbf330-8776-4086-a830-2184b07ba8db" providerId="ADAL" clId="{3BADC0B2-0F94-45F6-B552-1A87FB5F996F}" dt="2022-08-19T09:34:16.603" v="476"/>
          <ac:spMkLst>
            <pc:docMk/>
            <pc:sldMk cId="2546421780" sldId="285"/>
            <ac:spMk id="2" creationId="{9EF2AEEC-BD8A-2293-0B5A-4A5D7B282947}"/>
          </ac:spMkLst>
        </pc:spChg>
        <pc:graphicFrameChg chg="add mod">
          <ac:chgData name="Kaygisiz, Kübra" userId="4bfbf330-8776-4086-a830-2184b07ba8db" providerId="ADAL" clId="{3BADC0B2-0F94-45F6-B552-1A87FB5F996F}" dt="2022-08-21T02:11:59.808" v="1087" actId="1076"/>
          <ac:graphicFrameMkLst>
            <pc:docMk/>
            <pc:sldMk cId="2546421780" sldId="285"/>
            <ac:graphicFrameMk id="3" creationId="{D4CB603E-3E50-020A-1AE0-36D991A8DB13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21T03:22:15.109" v="1182" actId="1076"/>
          <ac:graphicFrameMkLst>
            <pc:docMk/>
            <pc:sldMk cId="2546421780" sldId="285"/>
            <ac:graphicFrameMk id="4" creationId="{7C40838B-7BA5-525B-B2D3-AEF9671AFA91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2:39:45.187" v="1121" actId="1076"/>
        <pc:sldMkLst>
          <pc:docMk/>
          <pc:sldMk cId="865975180" sldId="286"/>
        </pc:sldMkLst>
        <pc:spChg chg="mod">
          <ac:chgData name="Kaygisiz, Kübra" userId="4bfbf330-8776-4086-a830-2184b07ba8db" providerId="ADAL" clId="{3BADC0B2-0F94-45F6-B552-1A87FB5F996F}" dt="2022-08-19T09:34:20.769" v="477"/>
          <ac:spMkLst>
            <pc:docMk/>
            <pc:sldMk cId="865975180" sldId="286"/>
            <ac:spMk id="2" creationId="{C707F721-004F-1849-FE09-F4EEACD08154}"/>
          </ac:spMkLst>
        </pc:spChg>
        <pc:graphicFrameChg chg="add mod">
          <ac:chgData name="Kaygisiz, Kübra" userId="4bfbf330-8776-4086-a830-2184b07ba8db" providerId="ADAL" clId="{3BADC0B2-0F94-45F6-B552-1A87FB5F996F}" dt="2022-08-21T02:39:45.187" v="1121" actId="1076"/>
          <ac:graphicFrameMkLst>
            <pc:docMk/>
            <pc:sldMk cId="865975180" sldId="286"/>
            <ac:graphicFrameMk id="3" creationId="{9F42F0FA-FF40-E1B2-21C6-73F63B1C549B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2:50:14.819" v="1131" actId="1076"/>
        <pc:sldMkLst>
          <pc:docMk/>
          <pc:sldMk cId="4284137325" sldId="287"/>
        </pc:sldMkLst>
        <pc:spChg chg="mod">
          <ac:chgData name="Kaygisiz, Kübra" userId="4bfbf330-8776-4086-a830-2184b07ba8db" providerId="ADAL" clId="{3BADC0B2-0F94-45F6-B552-1A87FB5F996F}" dt="2022-08-19T09:34:24.860" v="478"/>
          <ac:spMkLst>
            <pc:docMk/>
            <pc:sldMk cId="4284137325" sldId="287"/>
            <ac:spMk id="2" creationId="{6147FB5C-7192-8345-0BD6-26F1689C6FC6}"/>
          </ac:spMkLst>
        </pc:spChg>
        <pc:graphicFrameChg chg="add mod">
          <ac:chgData name="Kaygisiz, Kübra" userId="4bfbf330-8776-4086-a830-2184b07ba8db" providerId="ADAL" clId="{3BADC0B2-0F94-45F6-B552-1A87FB5F996F}" dt="2022-08-21T02:40:48.120" v="1123" actId="1076"/>
          <ac:graphicFrameMkLst>
            <pc:docMk/>
            <pc:sldMk cId="4284137325" sldId="287"/>
            <ac:graphicFrameMk id="3" creationId="{346B088D-8CB3-57F2-5BEE-C181F3EE31CD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21T02:50:14.819" v="1131" actId="1076"/>
          <ac:graphicFrameMkLst>
            <pc:docMk/>
            <pc:sldMk cId="4284137325" sldId="287"/>
            <ac:graphicFrameMk id="4" creationId="{B3B423DB-46D9-2E51-A011-93B1B44C495E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2:51:15.908" v="1133" actId="1076"/>
        <pc:sldMkLst>
          <pc:docMk/>
          <pc:sldMk cId="331403962" sldId="288"/>
        </pc:sldMkLst>
        <pc:spChg chg="mod">
          <ac:chgData name="Kaygisiz, Kübra" userId="4bfbf330-8776-4086-a830-2184b07ba8db" providerId="ADAL" clId="{3BADC0B2-0F94-45F6-B552-1A87FB5F996F}" dt="2022-08-19T09:34:31.347" v="479"/>
          <ac:spMkLst>
            <pc:docMk/>
            <pc:sldMk cId="331403962" sldId="288"/>
            <ac:spMk id="2" creationId="{68A54E58-C94C-29B6-687A-717C4334591D}"/>
          </ac:spMkLst>
        </pc:spChg>
        <pc:graphicFrameChg chg="add mod">
          <ac:chgData name="Kaygisiz, Kübra" userId="4bfbf330-8776-4086-a830-2184b07ba8db" providerId="ADAL" clId="{3BADC0B2-0F94-45F6-B552-1A87FB5F996F}" dt="2022-08-21T02:41:58.727" v="1125" actId="1076"/>
          <ac:graphicFrameMkLst>
            <pc:docMk/>
            <pc:sldMk cId="331403962" sldId="288"/>
            <ac:graphicFrameMk id="3" creationId="{E4DA1A9F-D00B-2F3B-8ADE-BA3F267754EF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21T02:51:15.908" v="1133" actId="1076"/>
          <ac:graphicFrameMkLst>
            <pc:docMk/>
            <pc:sldMk cId="331403962" sldId="288"/>
            <ac:graphicFrameMk id="4" creationId="{0F93C089-6286-D270-6D1B-343A5D5EF994}"/>
          </ac:graphicFrameMkLst>
        </pc:graphicFrameChg>
      </pc:sldChg>
      <pc:sldChg chg="addSp delSp modSp new mod">
        <pc:chgData name="Kaygisiz, Kübra" userId="4bfbf330-8776-4086-a830-2184b07ba8db" providerId="ADAL" clId="{3BADC0B2-0F94-45F6-B552-1A87FB5F996F}" dt="2022-08-21T03:22:06.771" v="1180" actId="1076"/>
        <pc:sldMkLst>
          <pc:docMk/>
          <pc:sldMk cId="1480316319" sldId="289"/>
        </pc:sldMkLst>
        <pc:spChg chg="mod">
          <ac:chgData name="Kaygisiz, Kübra" userId="4bfbf330-8776-4086-a830-2184b07ba8db" providerId="ADAL" clId="{3BADC0B2-0F94-45F6-B552-1A87FB5F996F}" dt="2022-08-19T09:34:35.451" v="480"/>
          <ac:spMkLst>
            <pc:docMk/>
            <pc:sldMk cId="1480316319" sldId="289"/>
            <ac:spMk id="2" creationId="{CEBEFCF2-ADC0-A5FE-EE67-7A216ABA1C84}"/>
          </ac:spMkLst>
        </pc:spChg>
        <pc:graphicFrameChg chg="add del mod">
          <ac:chgData name="Kaygisiz, Kübra" userId="4bfbf330-8776-4086-a830-2184b07ba8db" providerId="ADAL" clId="{3BADC0B2-0F94-45F6-B552-1A87FB5F996F}" dt="2022-08-21T03:22:05.254" v="1179" actId="478"/>
          <ac:graphicFrameMkLst>
            <pc:docMk/>
            <pc:sldMk cId="1480316319" sldId="289"/>
            <ac:graphicFrameMk id="3" creationId="{DD235C75-6005-F092-4170-3E55E0192B52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21T03:22:06.771" v="1180" actId="1076"/>
          <ac:graphicFrameMkLst>
            <pc:docMk/>
            <pc:sldMk cId="1480316319" sldId="289"/>
            <ac:graphicFrameMk id="4" creationId="{BD0DC6EC-8E6B-4456-6AA5-E7EE91D246D5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2:12:20.490" v="1089" actId="1076"/>
        <pc:sldMkLst>
          <pc:docMk/>
          <pc:sldMk cId="4059308301" sldId="290"/>
        </pc:sldMkLst>
        <pc:spChg chg="mod">
          <ac:chgData name="Kaygisiz, Kübra" userId="4bfbf330-8776-4086-a830-2184b07ba8db" providerId="ADAL" clId="{3BADC0B2-0F94-45F6-B552-1A87FB5F996F}" dt="2022-08-19T09:34:39.569" v="481"/>
          <ac:spMkLst>
            <pc:docMk/>
            <pc:sldMk cId="4059308301" sldId="290"/>
            <ac:spMk id="2" creationId="{FC495B61-5926-505C-5286-FC71C66D543C}"/>
          </ac:spMkLst>
        </pc:spChg>
        <pc:graphicFrameChg chg="add mod">
          <ac:chgData name="Kaygisiz, Kübra" userId="4bfbf330-8776-4086-a830-2184b07ba8db" providerId="ADAL" clId="{3BADC0B2-0F94-45F6-B552-1A87FB5F996F}" dt="2022-08-21T02:12:20.490" v="1089" actId="1076"/>
          <ac:graphicFrameMkLst>
            <pc:docMk/>
            <pc:sldMk cId="4059308301" sldId="290"/>
            <ac:graphicFrameMk id="3" creationId="{EB9500F5-0599-D9FC-0AA9-1AE413FA4471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2:46:56.951" v="1129" actId="1076"/>
        <pc:sldMkLst>
          <pc:docMk/>
          <pc:sldMk cId="2298076905" sldId="291"/>
        </pc:sldMkLst>
        <pc:spChg chg="mod">
          <ac:chgData name="Kaygisiz, Kübra" userId="4bfbf330-8776-4086-a830-2184b07ba8db" providerId="ADAL" clId="{3BADC0B2-0F94-45F6-B552-1A87FB5F996F}" dt="2022-08-19T09:34:43.360" v="482"/>
          <ac:spMkLst>
            <pc:docMk/>
            <pc:sldMk cId="2298076905" sldId="291"/>
            <ac:spMk id="2" creationId="{F9C93502-72B2-0AC0-BA04-FDF9F8AEBB18}"/>
          </ac:spMkLst>
        </pc:spChg>
        <pc:graphicFrameChg chg="add mod">
          <ac:chgData name="Kaygisiz, Kübra" userId="4bfbf330-8776-4086-a830-2184b07ba8db" providerId="ADAL" clId="{3BADC0B2-0F94-45F6-B552-1A87FB5F996F}" dt="2022-08-21T02:46:56.951" v="1129" actId="1076"/>
          <ac:graphicFrameMkLst>
            <pc:docMk/>
            <pc:sldMk cId="2298076905" sldId="291"/>
            <ac:graphicFrameMk id="3" creationId="{45D34166-909E-80A5-C3D4-4811E3180698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10:10:47.708" v="787" actId="1076"/>
        <pc:sldMkLst>
          <pc:docMk/>
          <pc:sldMk cId="2063604901" sldId="292"/>
        </pc:sldMkLst>
        <pc:spChg chg="mod">
          <ac:chgData name="Kaygisiz, Kübra" userId="4bfbf330-8776-4086-a830-2184b07ba8db" providerId="ADAL" clId="{3BADC0B2-0F94-45F6-B552-1A87FB5F996F}" dt="2022-08-19T09:34:52.032" v="483"/>
          <ac:spMkLst>
            <pc:docMk/>
            <pc:sldMk cId="2063604901" sldId="292"/>
            <ac:spMk id="2" creationId="{D83D47F5-14A6-6CA8-A510-5EE18DAAF534}"/>
          </ac:spMkLst>
        </pc:spChg>
        <pc:graphicFrameChg chg="add mod">
          <ac:chgData name="Kaygisiz, Kübra" userId="4bfbf330-8776-4086-a830-2184b07ba8db" providerId="ADAL" clId="{3BADC0B2-0F94-45F6-B552-1A87FB5F996F}" dt="2022-08-19T10:10:47.708" v="787" actId="1076"/>
          <ac:graphicFrameMkLst>
            <pc:docMk/>
            <pc:sldMk cId="2063604901" sldId="292"/>
            <ac:graphicFrameMk id="3" creationId="{D36D3617-DD46-9E60-F8EF-9D594A5DCD58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3:17:17.571" v="1172" actId="1076"/>
        <pc:sldMkLst>
          <pc:docMk/>
          <pc:sldMk cId="2855801071" sldId="293"/>
        </pc:sldMkLst>
        <pc:spChg chg="mod">
          <ac:chgData name="Kaygisiz, Kübra" userId="4bfbf330-8776-4086-a830-2184b07ba8db" providerId="ADAL" clId="{3BADC0B2-0F94-45F6-B552-1A87FB5F996F}" dt="2022-08-19T09:34:56.787" v="484"/>
          <ac:spMkLst>
            <pc:docMk/>
            <pc:sldMk cId="2855801071" sldId="293"/>
            <ac:spMk id="2" creationId="{26D98E40-EC50-6BEB-B809-CEAFB3B0E056}"/>
          </ac:spMkLst>
        </pc:spChg>
        <pc:graphicFrameChg chg="add mod">
          <ac:chgData name="Kaygisiz, Kübra" userId="4bfbf330-8776-4086-a830-2184b07ba8db" providerId="ADAL" clId="{3BADC0B2-0F94-45F6-B552-1A87FB5F996F}" dt="2022-08-19T10:11:13.206" v="789" actId="1076"/>
          <ac:graphicFrameMkLst>
            <pc:docMk/>
            <pc:sldMk cId="2855801071" sldId="293"/>
            <ac:graphicFrameMk id="3" creationId="{2F977E70-FEFE-4112-2E77-8692776A3814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21T03:17:17.571" v="1172" actId="1076"/>
          <ac:graphicFrameMkLst>
            <pc:docMk/>
            <pc:sldMk cId="2855801071" sldId="293"/>
            <ac:graphicFrameMk id="4" creationId="{BB21150F-FA19-7297-094C-0051A604B382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3:17:59.171" v="1174" actId="1076"/>
        <pc:sldMkLst>
          <pc:docMk/>
          <pc:sldMk cId="2886679313" sldId="294"/>
        </pc:sldMkLst>
        <pc:spChg chg="mod">
          <ac:chgData name="Kaygisiz, Kübra" userId="4bfbf330-8776-4086-a830-2184b07ba8db" providerId="ADAL" clId="{3BADC0B2-0F94-45F6-B552-1A87FB5F996F}" dt="2022-08-19T09:35:00.684" v="485"/>
          <ac:spMkLst>
            <pc:docMk/>
            <pc:sldMk cId="2886679313" sldId="294"/>
            <ac:spMk id="2" creationId="{95E2D633-0CB9-068A-944F-07CBD3A341C6}"/>
          </ac:spMkLst>
        </pc:spChg>
        <pc:graphicFrameChg chg="add mod">
          <ac:chgData name="Kaygisiz, Kübra" userId="4bfbf330-8776-4086-a830-2184b07ba8db" providerId="ADAL" clId="{3BADC0B2-0F94-45F6-B552-1A87FB5F996F}" dt="2022-08-19T10:11:37.513" v="791" actId="1076"/>
          <ac:graphicFrameMkLst>
            <pc:docMk/>
            <pc:sldMk cId="2886679313" sldId="294"/>
            <ac:graphicFrameMk id="3" creationId="{F4B8E875-44C3-728C-6B1E-7CB0E3DB3BC6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21T03:17:59.171" v="1174" actId="1076"/>
          <ac:graphicFrameMkLst>
            <pc:docMk/>
            <pc:sldMk cId="2886679313" sldId="294"/>
            <ac:graphicFrameMk id="4" creationId="{98AB232A-CF58-BBEC-DF8B-507B3DB345A4}"/>
          </ac:graphicFrameMkLst>
        </pc:graphicFrameChg>
      </pc:sldChg>
      <pc:sldChg chg="modSp new mod">
        <pc:chgData name="Kaygisiz, Kübra" userId="4bfbf330-8776-4086-a830-2184b07ba8db" providerId="ADAL" clId="{3BADC0B2-0F94-45F6-B552-1A87FB5F996F}" dt="2022-08-19T09:35:04.734" v="486"/>
        <pc:sldMkLst>
          <pc:docMk/>
          <pc:sldMk cId="2197959177" sldId="295"/>
        </pc:sldMkLst>
        <pc:spChg chg="mod">
          <ac:chgData name="Kaygisiz, Kübra" userId="4bfbf330-8776-4086-a830-2184b07ba8db" providerId="ADAL" clId="{3BADC0B2-0F94-45F6-B552-1A87FB5F996F}" dt="2022-08-19T09:35:04.734" v="486"/>
          <ac:spMkLst>
            <pc:docMk/>
            <pc:sldMk cId="2197959177" sldId="295"/>
            <ac:spMk id="2" creationId="{2625F68C-1F71-E767-7BA1-F256109CEC6E}"/>
          </ac:spMkLst>
        </pc:spChg>
      </pc:sldChg>
      <pc:sldChg chg="addSp modSp new mod">
        <pc:chgData name="Kaygisiz, Kübra" userId="4bfbf330-8776-4086-a830-2184b07ba8db" providerId="ADAL" clId="{3BADC0B2-0F94-45F6-B552-1A87FB5F996F}" dt="2022-08-21T03:36:08.155" v="1188" actId="1076"/>
        <pc:sldMkLst>
          <pc:docMk/>
          <pc:sldMk cId="3987638391" sldId="296"/>
        </pc:sldMkLst>
        <pc:spChg chg="mod">
          <ac:chgData name="Kaygisiz, Kübra" userId="4bfbf330-8776-4086-a830-2184b07ba8db" providerId="ADAL" clId="{3BADC0B2-0F94-45F6-B552-1A87FB5F996F}" dt="2022-08-19T09:35:09.176" v="487"/>
          <ac:spMkLst>
            <pc:docMk/>
            <pc:sldMk cId="3987638391" sldId="296"/>
            <ac:spMk id="2" creationId="{1D834E42-D84B-7277-7135-AAD9984D7FE0}"/>
          </ac:spMkLst>
        </pc:spChg>
        <pc:graphicFrameChg chg="add mod">
          <ac:chgData name="Kaygisiz, Kübra" userId="4bfbf330-8776-4086-a830-2184b07ba8db" providerId="ADAL" clId="{3BADC0B2-0F94-45F6-B552-1A87FB5F996F}" dt="2022-08-21T03:36:08.155" v="1188" actId="1076"/>
          <ac:graphicFrameMkLst>
            <pc:docMk/>
            <pc:sldMk cId="3987638391" sldId="296"/>
            <ac:graphicFrameMk id="3" creationId="{9B0AA601-E4C9-45D5-5B81-EAE783E413C7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10:17:53.827" v="809" actId="1076"/>
        <pc:sldMkLst>
          <pc:docMk/>
          <pc:sldMk cId="3343825750" sldId="297"/>
        </pc:sldMkLst>
        <pc:spChg chg="mod">
          <ac:chgData name="Kaygisiz, Kübra" userId="4bfbf330-8776-4086-a830-2184b07ba8db" providerId="ADAL" clId="{3BADC0B2-0F94-45F6-B552-1A87FB5F996F}" dt="2022-08-19T09:35:15.818" v="488"/>
          <ac:spMkLst>
            <pc:docMk/>
            <pc:sldMk cId="3343825750" sldId="297"/>
            <ac:spMk id="2" creationId="{2BC42C73-25BC-481B-9A22-85D60E391F99}"/>
          </ac:spMkLst>
        </pc:spChg>
        <pc:graphicFrameChg chg="add mod">
          <ac:chgData name="Kaygisiz, Kübra" userId="4bfbf330-8776-4086-a830-2184b07ba8db" providerId="ADAL" clId="{3BADC0B2-0F94-45F6-B552-1A87FB5F996F}" dt="2022-08-19T10:17:53.827" v="809" actId="1076"/>
          <ac:graphicFrameMkLst>
            <pc:docMk/>
            <pc:sldMk cId="3343825750" sldId="297"/>
            <ac:graphicFrameMk id="3" creationId="{53914EA1-6FF0-C5BF-D3BE-F593A89E9479}"/>
          </ac:graphicFrameMkLst>
        </pc:graphicFrameChg>
      </pc:sldChg>
      <pc:sldChg chg="modSp new mod">
        <pc:chgData name="Kaygisiz, Kübra" userId="4bfbf330-8776-4086-a830-2184b07ba8db" providerId="ADAL" clId="{3BADC0B2-0F94-45F6-B552-1A87FB5F996F}" dt="2022-08-19T09:35:19.325" v="489"/>
        <pc:sldMkLst>
          <pc:docMk/>
          <pc:sldMk cId="2851249939" sldId="298"/>
        </pc:sldMkLst>
        <pc:spChg chg="mod">
          <ac:chgData name="Kaygisiz, Kübra" userId="4bfbf330-8776-4086-a830-2184b07ba8db" providerId="ADAL" clId="{3BADC0B2-0F94-45F6-B552-1A87FB5F996F}" dt="2022-08-19T09:35:19.325" v="489"/>
          <ac:spMkLst>
            <pc:docMk/>
            <pc:sldMk cId="2851249939" sldId="298"/>
            <ac:spMk id="2" creationId="{9C3071F1-DAB2-0F60-EE6C-2FF3A19143FA}"/>
          </ac:spMkLst>
        </pc:spChg>
      </pc:sldChg>
      <pc:sldChg chg="addSp modSp new mod">
        <pc:chgData name="Kaygisiz, Kübra" userId="4bfbf330-8776-4086-a830-2184b07ba8db" providerId="ADAL" clId="{3BADC0B2-0F94-45F6-B552-1A87FB5F996F}" dt="2022-08-19T10:18:16.364" v="811" actId="1076"/>
        <pc:sldMkLst>
          <pc:docMk/>
          <pc:sldMk cId="3683274127" sldId="299"/>
        </pc:sldMkLst>
        <pc:spChg chg="mod">
          <ac:chgData name="Kaygisiz, Kübra" userId="4bfbf330-8776-4086-a830-2184b07ba8db" providerId="ADAL" clId="{3BADC0B2-0F94-45F6-B552-1A87FB5F996F}" dt="2022-08-19T09:35:24.077" v="490"/>
          <ac:spMkLst>
            <pc:docMk/>
            <pc:sldMk cId="3683274127" sldId="299"/>
            <ac:spMk id="2" creationId="{EAFF1B0A-A631-264A-055B-AAD578E599F9}"/>
          </ac:spMkLst>
        </pc:spChg>
        <pc:graphicFrameChg chg="add mod">
          <ac:chgData name="Kaygisiz, Kübra" userId="4bfbf330-8776-4086-a830-2184b07ba8db" providerId="ADAL" clId="{3BADC0B2-0F94-45F6-B552-1A87FB5F996F}" dt="2022-08-19T10:18:16.364" v="811" actId="1076"/>
          <ac:graphicFrameMkLst>
            <pc:docMk/>
            <pc:sldMk cId="3683274127" sldId="299"/>
            <ac:graphicFrameMk id="3" creationId="{C5669C77-A2B5-F13A-D84C-5FCA0608B623}"/>
          </ac:graphicFrameMkLst>
        </pc:graphicFrameChg>
      </pc:sldChg>
      <pc:sldChg chg="modSp new mod">
        <pc:chgData name="Kaygisiz, Kübra" userId="4bfbf330-8776-4086-a830-2184b07ba8db" providerId="ADAL" clId="{3BADC0B2-0F94-45F6-B552-1A87FB5F996F}" dt="2022-08-19T09:35:27.293" v="491"/>
        <pc:sldMkLst>
          <pc:docMk/>
          <pc:sldMk cId="2299203109" sldId="300"/>
        </pc:sldMkLst>
        <pc:spChg chg="mod">
          <ac:chgData name="Kaygisiz, Kübra" userId="4bfbf330-8776-4086-a830-2184b07ba8db" providerId="ADAL" clId="{3BADC0B2-0F94-45F6-B552-1A87FB5F996F}" dt="2022-08-19T09:35:27.293" v="491"/>
          <ac:spMkLst>
            <pc:docMk/>
            <pc:sldMk cId="2299203109" sldId="300"/>
            <ac:spMk id="2" creationId="{EB35F032-E07B-C8B4-80CB-25980FCCB0CF}"/>
          </ac:spMkLst>
        </pc:spChg>
      </pc:sldChg>
      <pc:sldChg chg="addSp delSp modSp new mod">
        <pc:chgData name="Kaygisiz, Kübra" userId="4bfbf330-8776-4086-a830-2184b07ba8db" providerId="ADAL" clId="{3BADC0B2-0F94-45F6-B552-1A87FB5F996F}" dt="2022-08-19T10:12:59.925" v="795" actId="1076"/>
        <pc:sldMkLst>
          <pc:docMk/>
          <pc:sldMk cId="2742778679" sldId="301"/>
        </pc:sldMkLst>
        <pc:spChg chg="mod">
          <ac:chgData name="Kaygisiz, Kübra" userId="4bfbf330-8776-4086-a830-2184b07ba8db" providerId="ADAL" clId="{3BADC0B2-0F94-45F6-B552-1A87FB5F996F}" dt="2022-08-19T09:35:33.199" v="494"/>
          <ac:spMkLst>
            <pc:docMk/>
            <pc:sldMk cId="2742778679" sldId="301"/>
            <ac:spMk id="2" creationId="{30ED3738-6252-313D-6776-CE8B210DC7E8}"/>
          </ac:spMkLst>
        </pc:spChg>
        <pc:spChg chg="add del">
          <ac:chgData name="Kaygisiz, Kübra" userId="4bfbf330-8776-4086-a830-2184b07ba8db" providerId="ADAL" clId="{3BADC0B2-0F94-45F6-B552-1A87FB5F996F}" dt="2022-08-19T09:35:32.337" v="493" actId="22"/>
          <ac:spMkLst>
            <pc:docMk/>
            <pc:sldMk cId="2742778679" sldId="301"/>
            <ac:spMk id="4" creationId="{4B98AD7E-838A-1DF8-735D-6E80F95787FF}"/>
          </ac:spMkLst>
        </pc:spChg>
        <pc:graphicFrameChg chg="add mod">
          <ac:chgData name="Kaygisiz, Kübra" userId="4bfbf330-8776-4086-a830-2184b07ba8db" providerId="ADAL" clId="{3BADC0B2-0F94-45F6-B552-1A87FB5F996F}" dt="2022-08-19T10:12:59.925" v="795" actId="1076"/>
          <ac:graphicFrameMkLst>
            <pc:docMk/>
            <pc:sldMk cId="2742778679" sldId="301"/>
            <ac:graphicFrameMk id="5" creationId="{F9250C84-3361-58E9-3959-1EC257DE5F48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10:18:41.798" v="813" actId="1076"/>
        <pc:sldMkLst>
          <pc:docMk/>
          <pc:sldMk cId="2016114902" sldId="302"/>
        </pc:sldMkLst>
        <pc:spChg chg="mod">
          <ac:chgData name="Kaygisiz, Kübra" userId="4bfbf330-8776-4086-a830-2184b07ba8db" providerId="ADAL" clId="{3BADC0B2-0F94-45F6-B552-1A87FB5F996F}" dt="2022-08-19T09:35:37.498" v="495"/>
          <ac:spMkLst>
            <pc:docMk/>
            <pc:sldMk cId="2016114902" sldId="302"/>
            <ac:spMk id="2" creationId="{F88E0BE8-EA9A-FC4E-0B3E-F5DBF914D88A}"/>
          </ac:spMkLst>
        </pc:spChg>
        <pc:graphicFrameChg chg="add mod">
          <ac:chgData name="Kaygisiz, Kübra" userId="4bfbf330-8776-4086-a830-2184b07ba8db" providerId="ADAL" clId="{3BADC0B2-0F94-45F6-B552-1A87FB5F996F}" dt="2022-08-19T10:18:41.798" v="813" actId="1076"/>
          <ac:graphicFrameMkLst>
            <pc:docMk/>
            <pc:sldMk cId="2016114902" sldId="302"/>
            <ac:graphicFrameMk id="3" creationId="{A1C6BF0E-94B5-E79D-11F0-0DE6A56D05C8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10:18:59.362" v="815" actId="1076"/>
        <pc:sldMkLst>
          <pc:docMk/>
          <pc:sldMk cId="2405711615" sldId="303"/>
        </pc:sldMkLst>
        <pc:spChg chg="mod">
          <ac:chgData name="Kaygisiz, Kübra" userId="4bfbf330-8776-4086-a830-2184b07ba8db" providerId="ADAL" clId="{3BADC0B2-0F94-45F6-B552-1A87FB5F996F}" dt="2022-08-19T09:35:40.959" v="496"/>
          <ac:spMkLst>
            <pc:docMk/>
            <pc:sldMk cId="2405711615" sldId="303"/>
            <ac:spMk id="2" creationId="{3078DFC0-AE40-BEFD-DE7E-E68DD405DF14}"/>
          </ac:spMkLst>
        </pc:spChg>
        <pc:graphicFrameChg chg="add mod">
          <ac:chgData name="Kaygisiz, Kübra" userId="4bfbf330-8776-4086-a830-2184b07ba8db" providerId="ADAL" clId="{3BADC0B2-0F94-45F6-B552-1A87FB5F996F}" dt="2022-08-19T10:18:59.362" v="815" actId="1076"/>
          <ac:graphicFrameMkLst>
            <pc:docMk/>
            <pc:sldMk cId="2405711615" sldId="303"/>
            <ac:graphicFrameMk id="3" creationId="{C02FC30C-74AC-BBD8-94EC-AD58FF376118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10:19:18.318" v="817" actId="1076"/>
        <pc:sldMkLst>
          <pc:docMk/>
          <pc:sldMk cId="4114209786" sldId="304"/>
        </pc:sldMkLst>
        <pc:spChg chg="mod">
          <ac:chgData name="Kaygisiz, Kübra" userId="4bfbf330-8776-4086-a830-2184b07ba8db" providerId="ADAL" clId="{3BADC0B2-0F94-45F6-B552-1A87FB5F996F}" dt="2022-08-19T09:35:45.102" v="497"/>
          <ac:spMkLst>
            <pc:docMk/>
            <pc:sldMk cId="4114209786" sldId="304"/>
            <ac:spMk id="2" creationId="{3EE52CB8-F7A0-5DF8-D9CC-835663D63134}"/>
          </ac:spMkLst>
        </pc:spChg>
        <pc:graphicFrameChg chg="add mod">
          <ac:chgData name="Kaygisiz, Kübra" userId="4bfbf330-8776-4086-a830-2184b07ba8db" providerId="ADAL" clId="{3BADC0B2-0F94-45F6-B552-1A87FB5F996F}" dt="2022-08-19T10:19:18.318" v="817" actId="1076"/>
          <ac:graphicFrameMkLst>
            <pc:docMk/>
            <pc:sldMk cId="4114209786" sldId="304"/>
            <ac:graphicFrameMk id="3" creationId="{CCB15E3C-1DB0-D9BE-D9BC-C6C1CA46132E}"/>
          </ac:graphicFrameMkLst>
        </pc:graphicFrameChg>
      </pc:sldChg>
      <pc:sldChg chg="addSp delSp modSp new mod">
        <pc:chgData name="Kaygisiz, Kübra" userId="4bfbf330-8776-4086-a830-2184b07ba8db" providerId="ADAL" clId="{3BADC0B2-0F94-45F6-B552-1A87FB5F996F}" dt="2022-08-19T10:13:26.108" v="797" actId="1076"/>
        <pc:sldMkLst>
          <pc:docMk/>
          <pc:sldMk cId="2441172026" sldId="305"/>
        </pc:sldMkLst>
        <pc:spChg chg="mod">
          <ac:chgData name="Kaygisiz, Kübra" userId="4bfbf330-8776-4086-a830-2184b07ba8db" providerId="ADAL" clId="{3BADC0B2-0F94-45F6-B552-1A87FB5F996F}" dt="2022-08-19T09:35:50.104" v="500"/>
          <ac:spMkLst>
            <pc:docMk/>
            <pc:sldMk cId="2441172026" sldId="305"/>
            <ac:spMk id="2" creationId="{FD9B1FAC-D732-53C4-B109-3F45B87618E8}"/>
          </ac:spMkLst>
        </pc:spChg>
        <pc:spChg chg="add del">
          <ac:chgData name="Kaygisiz, Kübra" userId="4bfbf330-8776-4086-a830-2184b07ba8db" providerId="ADAL" clId="{3BADC0B2-0F94-45F6-B552-1A87FB5F996F}" dt="2022-08-19T09:35:49.260" v="499" actId="22"/>
          <ac:spMkLst>
            <pc:docMk/>
            <pc:sldMk cId="2441172026" sldId="305"/>
            <ac:spMk id="4" creationId="{2FE26BCA-D442-3AFD-562D-0ACDD66AB88C}"/>
          </ac:spMkLst>
        </pc:spChg>
        <pc:graphicFrameChg chg="add mod">
          <ac:chgData name="Kaygisiz, Kübra" userId="4bfbf330-8776-4086-a830-2184b07ba8db" providerId="ADAL" clId="{3BADC0B2-0F94-45F6-B552-1A87FB5F996F}" dt="2022-08-19T10:13:26.108" v="797" actId="1076"/>
          <ac:graphicFrameMkLst>
            <pc:docMk/>
            <pc:sldMk cId="2441172026" sldId="305"/>
            <ac:graphicFrameMk id="5" creationId="{F65A1131-DB1B-0A3C-50E9-12946A24F84E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10:14:31.998" v="801" actId="1076"/>
        <pc:sldMkLst>
          <pc:docMk/>
          <pc:sldMk cId="4067679584" sldId="306"/>
        </pc:sldMkLst>
        <pc:spChg chg="mod">
          <ac:chgData name="Kaygisiz, Kübra" userId="4bfbf330-8776-4086-a830-2184b07ba8db" providerId="ADAL" clId="{3BADC0B2-0F94-45F6-B552-1A87FB5F996F}" dt="2022-08-19T09:35:56.476" v="501"/>
          <ac:spMkLst>
            <pc:docMk/>
            <pc:sldMk cId="4067679584" sldId="306"/>
            <ac:spMk id="2" creationId="{0E6F27D1-2750-3189-0582-F7D14BA1C2D6}"/>
          </ac:spMkLst>
        </pc:spChg>
        <pc:graphicFrameChg chg="add mod">
          <ac:chgData name="Kaygisiz, Kübra" userId="4bfbf330-8776-4086-a830-2184b07ba8db" providerId="ADAL" clId="{3BADC0B2-0F94-45F6-B552-1A87FB5F996F}" dt="2022-08-19T10:14:31.998" v="801" actId="1076"/>
          <ac:graphicFrameMkLst>
            <pc:docMk/>
            <pc:sldMk cId="4067679584" sldId="306"/>
            <ac:graphicFrameMk id="3" creationId="{F8512932-B216-CD4A-B959-FCEE03AF85B8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10:14:52.170" v="803" actId="1076"/>
        <pc:sldMkLst>
          <pc:docMk/>
          <pc:sldMk cId="763965190" sldId="307"/>
        </pc:sldMkLst>
        <pc:spChg chg="mod">
          <ac:chgData name="Kaygisiz, Kübra" userId="4bfbf330-8776-4086-a830-2184b07ba8db" providerId="ADAL" clId="{3BADC0B2-0F94-45F6-B552-1A87FB5F996F}" dt="2022-08-19T09:36:02.994" v="502"/>
          <ac:spMkLst>
            <pc:docMk/>
            <pc:sldMk cId="763965190" sldId="307"/>
            <ac:spMk id="2" creationId="{3EBBFC39-ED22-44E8-6836-9CFB3BA61D2E}"/>
          </ac:spMkLst>
        </pc:spChg>
        <pc:graphicFrameChg chg="add mod">
          <ac:chgData name="Kaygisiz, Kübra" userId="4bfbf330-8776-4086-a830-2184b07ba8db" providerId="ADAL" clId="{3BADC0B2-0F94-45F6-B552-1A87FB5F996F}" dt="2022-08-19T10:14:52.170" v="803" actId="1076"/>
          <ac:graphicFrameMkLst>
            <pc:docMk/>
            <pc:sldMk cId="763965190" sldId="307"/>
            <ac:graphicFrameMk id="3" creationId="{20C47D5B-4459-7B1C-635A-53212593B0EF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3:35:36.446" v="1186" actId="1076"/>
        <pc:sldMkLst>
          <pc:docMk/>
          <pc:sldMk cId="987594625" sldId="308"/>
        </pc:sldMkLst>
        <pc:spChg chg="mod">
          <ac:chgData name="Kaygisiz, Kübra" userId="4bfbf330-8776-4086-a830-2184b07ba8db" providerId="ADAL" clId="{3BADC0B2-0F94-45F6-B552-1A87FB5F996F}" dt="2022-08-19T09:36:07.333" v="503"/>
          <ac:spMkLst>
            <pc:docMk/>
            <pc:sldMk cId="987594625" sldId="308"/>
            <ac:spMk id="2" creationId="{EFB3B1FF-F2E6-CC5D-E30C-29AF4B30D82F}"/>
          </ac:spMkLst>
        </pc:spChg>
        <pc:graphicFrameChg chg="add mod">
          <ac:chgData name="Kaygisiz, Kübra" userId="4bfbf330-8776-4086-a830-2184b07ba8db" providerId="ADAL" clId="{3BADC0B2-0F94-45F6-B552-1A87FB5F996F}" dt="2022-08-21T03:35:36.446" v="1186" actId="1076"/>
          <ac:graphicFrameMkLst>
            <pc:docMk/>
            <pc:sldMk cId="987594625" sldId="308"/>
            <ac:graphicFrameMk id="3" creationId="{FB751166-C1F8-23D0-D9CD-A5AB22D27543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10:15:16.104" v="805" actId="1076"/>
        <pc:sldMkLst>
          <pc:docMk/>
          <pc:sldMk cId="2310401326" sldId="309"/>
        </pc:sldMkLst>
        <pc:spChg chg="mod">
          <ac:chgData name="Kaygisiz, Kübra" userId="4bfbf330-8776-4086-a830-2184b07ba8db" providerId="ADAL" clId="{3BADC0B2-0F94-45F6-B552-1A87FB5F996F}" dt="2022-08-19T09:42:22.746" v="504"/>
          <ac:spMkLst>
            <pc:docMk/>
            <pc:sldMk cId="2310401326" sldId="309"/>
            <ac:spMk id="2" creationId="{B05A940D-02B2-B975-474A-BDFD9CEFDC8C}"/>
          </ac:spMkLst>
        </pc:spChg>
        <pc:graphicFrameChg chg="add mod">
          <ac:chgData name="Kaygisiz, Kübra" userId="4bfbf330-8776-4086-a830-2184b07ba8db" providerId="ADAL" clId="{3BADC0B2-0F94-45F6-B552-1A87FB5F996F}" dt="2022-08-19T10:15:16.104" v="805" actId="1076"/>
          <ac:graphicFrameMkLst>
            <pc:docMk/>
            <pc:sldMk cId="2310401326" sldId="309"/>
            <ac:graphicFrameMk id="3" creationId="{98DF8AB7-29AE-0F61-20FA-9298A0A5FFC6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10:17:28.300" v="807" actId="1076"/>
        <pc:sldMkLst>
          <pc:docMk/>
          <pc:sldMk cId="1689812694" sldId="310"/>
        </pc:sldMkLst>
        <pc:spChg chg="mod">
          <ac:chgData name="Kaygisiz, Kübra" userId="4bfbf330-8776-4086-a830-2184b07ba8db" providerId="ADAL" clId="{3BADC0B2-0F94-45F6-B552-1A87FB5F996F}" dt="2022-08-19T09:42:26.975" v="505"/>
          <ac:spMkLst>
            <pc:docMk/>
            <pc:sldMk cId="1689812694" sldId="310"/>
            <ac:spMk id="2" creationId="{C4829743-BA43-6F53-C635-CE8ECB655627}"/>
          </ac:spMkLst>
        </pc:spChg>
        <pc:graphicFrameChg chg="add mod">
          <ac:chgData name="Kaygisiz, Kübra" userId="4bfbf330-8776-4086-a830-2184b07ba8db" providerId="ADAL" clId="{3BADC0B2-0F94-45F6-B552-1A87FB5F996F}" dt="2022-08-19T10:17:28.300" v="807" actId="1076"/>
          <ac:graphicFrameMkLst>
            <pc:docMk/>
            <pc:sldMk cId="1689812694" sldId="310"/>
            <ac:graphicFrameMk id="3" creationId="{B4E6F0D2-E5C1-9461-2220-D28A3E40418B}"/>
          </ac:graphicFrameMkLst>
        </pc:graphicFrameChg>
      </pc:sldChg>
      <pc:sldChg chg="modSp new mod">
        <pc:chgData name="Kaygisiz, Kübra" userId="4bfbf330-8776-4086-a830-2184b07ba8db" providerId="ADAL" clId="{3BADC0B2-0F94-45F6-B552-1A87FB5F996F}" dt="2022-08-19T09:42:30.768" v="506"/>
        <pc:sldMkLst>
          <pc:docMk/>
          <pc:sldMk cId="419106980" sldId="311"/>
        </pc:sldMkLst>
        <pc:spChg chg="mod">
          <ac:chgData name="Kaygisiz, Kübra" userId="4bfbf330-8776-4086-a830-2184b07ba8db" providerId="ADAL" clId="{3BADC0B2-0F94-45F6-B552-1A87FB5F996F}" dt="2022-08-19T09:42:30.768" v="506"/>
          <ac:spMkLst>
            <pc:docMk/>
            <pc:sldMk cId="419106980" sldId="311"/>
            <ac:spMk id="2" creationId="{5F297DE2-35D9-ECA8-C59C-EC716D6DE955}"/>
          </ac:spMkLst>
        </pc:spChg>
      </pc:sldChg>
      <pc:sldChg chg="modSp new mod">
        <pc:chgData name="Kaygisiz, Kübra" userId="4bfbf330-8776-4086-a830-2184b07ba8db" providerId="ADAL" clId="{3BADC0B2-0F94-45F6-B552-1A87FB5F996F}" dt="2022-08-19T09:42:34.889" v="507"/>
        <pc:sldMkLst>
          <pc:docMk/>
          <pc:sldMk cId="1431698952" sldId="312"/>
        </pc:sldMkLst>
        <pc:spChg chg="mod">
          <ac:chgData name="Kaygisiz, Kübra" userId="4bfbf330-8776-4086-a830-2184b07ba8db" providerId="ADAL" clId="{3BADC0B2-0F94-45F6-B552-1A87FB5F996F}" dt="2022-08-19T09:42:34.889" v="507"/>
          <ac:spMkLst>
            <pc:docMk/>
            <pc:sldMk cId="1431698952" sldId="312"/>
            <ac:spMk id="2" creationId="{EE623804-1C7C-4DD2-88E6-2CE212B2A673}"/>
          </ac:spMkLst>
        </pc:spChg>
      </pc:sldChg>
      <pc:sldChg chg="addSp delSp modSp new mod">
        <pc:chgData name="Kaygisiz, Kübra" userId="4bfbf330-8776-4086-a830-2184b07ba8db" providerId="ADAL" clId="{3BADC0B2-0F94-45F6-B552-1A87FB5F996F}" dt="2022-08-19T09:42:40.792" v="510"/>
        <pc:sldMkLst>
          <pc:docMk/>
          <pc:sldMk cId="3859182696" sldId="313"/>
        </pc:sldMkLst>
        <pc:spChg chg="mod">
          <ac:chgData name="Kaygisiz, Kübra" userId="4bfbf330-8776-4086-a830-2184b07ba8db" providerId="ADAL" clId="{3BADC0B2-0F94-45F6-B552-1A87FB5F996F}" dt="2022-08-19T09:42:40.792" v="510"/>
          <ac:spMkLst>
            <pc:docMk/>
            <pc:sldMk cId="3859182696" sldId="313"/>
            <ac:spMk id="2" creationId="{6D5A1643-E50B-5260-C7B8-46E652DC8102}"/>
          </ac:spMkLst>
        </pc:spChg>
        <pc:spChg chg="add del">
          <ac:chgData name="Kaygisiz, Kübra" userId="4bfbf330-8776-4086-a830-2184b07ba8db" providerId="ADAL" clId="{3BADC0B2-0F94-45F6-B552-1A87FB5F996F}" dt="2022-08-19T09:42:39.943" v="509" actId="22"/>
          <ac:spMkLst>
            <pc:docMk/>
            <pc:sldMk cId="3859182696" sldId="313"/>
            <ac:spMk id="4" creationId="{4AFCC695-F39E-6ABE-DC4E-62F14CFA514C}"/>
          </ac:spMkLst>
        </pc:spChg>
      </pc:sldChg>
      <pc:sldChg chg="modSp new mod">
        <pc:chgData name="Kaygisiz, Kübra" userId="4bfbf330-8776-4086-a830-2184b07ba8db" providerId="ADAL" clId="{3BADC0B2-0F94-45F6-B552-1A87FB5F996F}" dt="2022-08-19T09:42:46.626" v="511"/>
        <pc:sldMkLst>
          <pc:docMk/>
          <pc:sldMk cId="113699548" sldId="314"/>
        </pc:sldMkLst>
        <pc:spChg chg="mod">
          <ac:chgData name="Kaygisiz, Kübra" userId="4bfbf330-8776-4086-a830-2184b07ba8db" providerId="ADAL" clId="{3BADC0B2-0F94-45F6-B552-1A87FB5F996F}" dt="2022-08-19T09:42:46.626" v="511"/>
          <ac:spMkLst>
            <pc:docMk/>
            <pc:sldMk cId="113699548" sldId="314"/>
            <ac:spMk id="2" creationId="{509FBF19-8BD8-1D65-EAFA-6FA9D6562579}"/>
          </ac:spMkLst>
        </pc:spChg>
      </pc:sldChg>
      <pc:sldChg chg="modSp new mod">
        <pc:chgData name="Kaygisiz, Kübra" userId="4bfbf330-8776-4086-a830-2184b07ba8db" providerId="ADAL" clId="{3BADC0B2-0F94-45F6-B552-1A87FB5F996F}" dt="2022-08-19T09:42:52.084" v="512"/>
        <pc:sldMkLst>
          <pc:docMk/>
          <pc:sldMk cId="2559766795" sldId="315"/>
        </pc:sldMkLst>
        <pc:spChg chg="mod">
          <ac:chgData name="Kaygisiz, Kübra" userId="4bfbf330-8776-4086-a830-2184b07ba8db" providerId="ADAL" clId="{3BADC0B2-0F94-45F6-B552-1A87FB5F996F}" dt="2022-08-19T09:42:52.084" v="512"/>
          <ac:spMkLst>
            <pc:docMk/>
            <pc:sldMk cId="2559766795" sldId="315"/>
            <ac:spMk id="2" creationId="{2E00A3E7-7630-E6F6-4265-DA6870BBE660}"/>
          </ac:spMkLst>
        </pc:spChg>
      </pc:sldChg>
      <pc:sldChg chg="addSp modSp new mod">
        <pc:chgData name="Kaygisiz, Kübra" userId="4bfbf330-8776-4086-a830-2184b07ba8db" providerId="ADAL" clId="{3BADC0B2-0F94-45F6-B552-1A87FB5F996F}" dt="2022-08-19T10:21:00.965" v="823" actId="1076"/>
        <pc:sldMkLst>
          <pc:docMk/>
          <pc:sldMk cId="1545965503" sldId="316"/>
        </pc:sldMkLst>
        <pc:spChg chg="mod">
          <ac:chgData name="Kaygisiz, Kübra" userId="4bfbf330-8776-4086-a830-2184b07ba8db" providerId="ADAL" clId="{3BADC0B2-0F94-45F6-B552-1A87FB5F996F}" dt="2022-08-19T09:42:56.651" v="513"/>
          <ac:spMkLst>
            <pc:docMk/>
            <pc:sldMk cId="1545965503" sldId="316"/>
            <ac:spMk id="2" creationId="{42076106-EF53-8C5F-320F-07B778624D1D}"/>
          </ac:spMkLst>
        </pc:spChg>
        <pc:graphicFrameChg chg="add mod">
          <ac:chgData name="Kaygisiz, Kübra" userId="4bfbf330-8776-4086-a830-2184b07ba8db" providerId="ADAL" clId="{3BADC0B2-0F94-45F6-B552-1A87FB5F996F}" dt="2022-08-19T10:21:00.965" v="823" actId="1076"/>
          <ac:graphicFrameMkLst>
            <pc:docMk/>
            <pc:sldMk cId="1545965503" sldId="316"/>
            <ac:graphicFrameMk id="3" creationId="{CC70E3E1-624B-979A-996A-95ADB5957BF7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10:21:20.158" v="825" actId="1076"/>
        <pc:sldMkLst>
          <pc:docMk/>
          <pc:sldMk cId="2041474977" sldId="317"/>
        </pc:sldMkLst>
        <pc:spChg chg="mod">
          <ac:chgData name="Kaygisiz, Kübra" userId="4bfbf330-8776-4086-a830-2184b07ba8db" providerId="ADAL" clId="{3BADC0B2-0F94-45F6-B552-1A87FB5F996F}" dt="2022-08-19T09:43:00.662" v="514"/>
          <ac:spMkLst>
            <pc:docMk/>
            <pc:sldMk cId="2041474977" sldId="317"/>
            <ac:spMk id="2" creationId="{878E42CA-E62A-EAF4-F222-28EAA4379F0E}"/>
          </ac:spMkLst>
        </pc:spChg>
        <pc:graphicFrameChg chg="add mod">
          <ac:chgData name="Kaygisiz, Kübra" userId="4bfbf330-8776-4086-a830-2184b07ba8db" providerId="ADAL" clId="{3BADC0B2-0F94-45F6-B552-1A87FB5F996F}" dt="2022-08-19T10:21:20.158" v="825" actId="1076"/>
          <ac:graphicFrameMkLst>
            <pc:docMk/>
            <pc:sldMk cId="2041474977" sldId="317"/>
            <ac:graphicFrameMk id="3" creationId="{17250403-2DD8-17A2-A469-5EE18AA2C766}"/>
          </ac:graphicFrameMkLst>
        </pc:graphicFrameChg>
      </pc:sldChg>
      <pc:sldChg chg="modSp new mod">
        <pc:chgData name="Kaygisiz, Kübra" userId="4bfbf330-8776-4086-a830-2184b07ba8db" providerId="ADAL" clId="{3BADC0B2-0F94-45F6-B552-1A87FB5F996F}" dt="2022-08-19T09:43:04.993" v="515"/>
        <pc:sldMkLst>
          <pc:docMk/>
          <pc:sldMk cId="2351088502" sldId="318"/>
        </pc:sldMkLst>
        <pc:spChg chg="mod">
          <ac:chgData name="Kaygisiz, Kübra" userId="4bfbf330-8776-4086-a830-2184b07ba8db" providerId="ADAL" clId="{3BADC0B2-0F94-45F6-B552-1A87FB5F996F}" dt="2022-08-19T09:43:04.993" v="515"/>
          <ac:spMkLst>
            <pc:docMk/>
            <pc:sldMk cId="2351088502" sldId="318"/>
            <ac:spMk id="2" creationId="{6B9E6AA4-7D0C-D6D8-6F0F-4A92D5595956}"/>
          </ac:spMkLst>
        </pc:spChg>
      </pc:sldChg>
      <pc:sldChg chg="addSp modSp new mod">
        <pc:chgData name="Kaygisiz, Kübra" userId="4bfbf330-8776-4086-a830-2184b07ba8db" providerId="ADAL" clId="{3BADC0B2-0F94-45F6-B552-1A87FB5F996F}" dt="2022-08-19T10:22:02.194" v="827" actId="1076"/>
        <pc:sldMkLst>
          <pc:docMk/>
          <pc:sldMk cId="3991689879" sldId="319"/>
        </pc:sldMkLst>
        <pc:spChg chg="mod">
          <ac:chgData name="Kaygisiz, Kübra" userId="4bfbf330-8776-4086-a830-2184b07ba8db" providerId="ADAL" clId="{3BADC0B2-0F94-45F6-B552-1A87FB5F996F}" dt="2022-08-19T09:43:11.294" v="516"/>
          <ac:spMkLst>
            <pc:docMk/>
            <pc:sldMk cId="3991689879" sldId="319"/>
            <ac:spMk id="2" creationId="{B28D219D-6D17-B93E-B534-E2D17DEC5377}"/>
          </ac:spMkLst>
        </pc:spChg>
        <pc:graphicFrameChg chg="add mod">
          <ac:chgData name="Kaygisiz, Kübra" userId="4bfbf330-8776-4086-a830-2184b07ba8db" providerId="ADAL" clId="{3BADC0B2-0F94-45F6-B552-1A87FB5F996F}" dt="2022-08-19T10:22:02.194" v="827" actId="1076"/>
          <ac:graphicFrameMkLst>
            <pc:docMk/>
            <pc:sldMk cId="3991689879" sldId="319"/>
            <ac:graphicFrameMk id="3" creationId="{C709CED4-15BC-9476-6F2C-AC6EE5118CAA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10:22:18.940" v="829" actId="1076"/>
        <pc:sldMkLst>
          <pc:docMk/>
          <pc:sldMk cId="177861567" sldId="320"/>
        </pc:sldMkLst>
        <pc:spChg chg="mod">
          <ac:chgData name="Kaygisiz, Kübra" userId="4bfbf330-8776-4086-a830-2184b07ba8db" providerId="ADAL" clId="{3BADC0B2-0F94-45F6-B552-1A87FB5F996F}" dt="2022-08-19T09:43:15.358" v="517"/>
          <ac:spMkLst>
            <pc:docMk/>
            <pc:sldMk cId="177861567" sldId="320"/>
            <ac:spMk id="2" creationId="{0FCAC3C7-D63F-5C0B-99D8-442A5974AE5F}"/>
          </ac:spMkLst>
        </pc:spChg>
        <pc:graphicFrameChg chg="add mod">
          <ac:chgData name="Kaygisiz, Kübra" userId="4bfbf330-8776-4086-a830-2184b07ba8db" providerId="ADAL" clId="{3BADC0B2-0F94-45F6-B552-1A87FB5F996F}" dt="2022-08-19T10:22:18.940" v="829" actId="1076"/>
          <ac:graphicFrameMkLst>
            <pc:docMk/>
            <pc:sldMk cId="177861567" sldId="320"/>
            <ac:graphicFrameMk id="3" creationId="{88CB67B6-5576-DA24-C04D-72A8C4224FAA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10:22:41.482" v="831" actId="1076"/>
        <pc:sldMkLst>
          <pc:docMk/>
          <pc:sldMk cId="2153042501" sldId="321"/>
        </pc:sldMkLst>
        <pc:spChg chg="mod">
          <ac:chgData name="Kaygisiz, Kübra" userId="4bfbf330-8776-4086-a830-2184b07ba8db" providerId="ADAL" clId="{3BADC0B2-0F94-45F6-B552-1A87FB5F996F}" dt="2022-08-19T09:43:21.006" v="518"/>
          <ac:spMkLst>
            <pc:docMk/>
            <pc:sldMk cId="2153042501" sldId="321"/>
            <ac:spMk id="2" creationId="{80BA0A41-E771-76C4-F94C-FD62150C024B}"/>
          </ac:spMkLst>
        </pc:spChg>
        <pc:graphicFrameChg chg="add mod">
          <ac:chgData name="Kaygisiz, Kübra" userId="4bfbf330-8776-4086-a830-2184b07ba8db" providerId="ADAL" clId="{3BADC0B2-0F94-45F6-B552-1A87FB5F996F}" dt="2022-08-19T10:22:41.482" v="831" actId="1076"/>
          <ac:graphicFrameMkLst>
            <pc:docMk/>
            <pc:sldMk cId="2153042501" sldId="321"/>
            <ac:graphicFrameMk id="3" creationId="{BE3F8CF9-94DD-40C5-01AD-BA18D06D75FE}"/>
          </ac:graphicFrameMkLst>
        </pc:graphicFrameChg>
      </pc:sldChg>
      <pc:sldChg chg="modSp new mod">
        <pc:chgData name="Kaygisiz, Kübra" userId="4bfbf330-8776-4086-a830-2184b07ba8db" providerId="ADAL" clId="{3BADC0B2-0F94-45F6-B552-1A87FB5F996F}" dt="2022-08-19T09:43:25.070" v="519"/>
        <pc:sldMkLst>
          <pc:docMk/>
          <pc:sldMk cId="2688409802" sldId="322"/>
        </pc:sldMkLst>
        <pc:spChg chg="mod">
          <ac:chgData name="Kaygisiz, Kübra" userId="4bfbf330-8776-4086-a830-2184b07ba8db" providerId="ADAL" clId="{3BADC0B2-0F94-45F6-B552-1A87FB5F996F}" dt="2022-08-19T09:43:25.070" v="519"/>
          <ac:spMkLst>
            <pc:docMk/>
            <pc:sldMk cId="2688409802" sldId="322"/>
            <ac:spMk id="2" creationId="{3570168D-A334-7B69-6430-52B7E655F9BD}"/>
          </ac:spMkLst>
        </pc:spChg>
      </pc:sldChg>
      <pc:sldChg chg="addSp modSp new mod">
        <pc:chgData name="Kaygisiz, Kübra" userId="4bfbf330-8776-4086-a830-2184b07ba8db" providerId="ADAL" clId="{3BADC0B2-0F94-45F6-B552-1A87FB5F996F}" dt="2022-08-19T10:22:59.245" v="833" actId="1076"/>
        <pc:sldMkLst>
          <pc:docMk/>
          <pc:sldMk cId="1920020108" sldId="323"/>
        </pc:sldMkLst>
        <pc:spChg chg="mod">
          <ac:chgData name="Kaygisiz, Kübra" userId="4bfbf330-8776-4086-a830-2184b07ba8db" providerId="ADAL" clId="{3BADC0B2-0F94-45F6-B552-1A87FB5F996F}" dt="2022-08-19T09:43:30.107" v="520"/>
          <ac:spMkLst>
            <pc:docMk/>
            <pc:sldMk cId="1920020108" sldId="323"/>
            <ac:spMk id="2" creationId="{182BD26F-77E3-2148-79C8-8E18F879F8FF}"/>
          </ac:spMkLst>
        </pc:spChg>
        <pc:graphicFrameChg chg="add mod">
          <ac:chgData name="Kaygisiz, Kübra" userId="4bfbf330-8776-4086-a830-2184b07ba8db" providerId="ADAL" clId="{3BADC0B2-0F94-45F6-B552-1A87FB5F996F}" dt="2022-08-19T10:22:59.245" v="833" actId="1076"/>
          <ac:graphicFrameMkLst>
            <pc:docMk/>
            <pc:sldMk cId="1920020108" sldId="323"/>
            <ac:graphicFrameMk id="3" creationId="{8A8CB048-90F9-CB30-3370-BFD140CAB733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10:23:20.219" v="835" actId="1076"/>
        <pc:sldMkLst>
          <pc:docMk/>
          <pc:sldMk cId="1727516209" sldId="324"/>
        </pc:sldMkLst>
        <pc:spChg chg="mod">
          <ac:chgData name="Kaygisiz, Kübra" userId="4bfbf330-8776-4086-a830-2184b07ba8db" providerId="ADAL" clId="{3BADC0B2-0F94-45F6-B552-1A87FB5F996F}" dt="2022-08-19T09:43:35.084" v="521"/>
          <ac:spMkLst>
            <pc:docMk/>
            <pc:sldMk cId="1727516209" sldId="324"/>
            <ac:spMk id="2" creationId="{38D8BAE6-D069-ADBD-EDAC-6C5004530D93}"/>
          </ac:spMkLst>
        </pc:spChg>
        <pc:graphicFrameChg chg="add mod">
          <ac:chgData name="Kaygisiz, Kübra" userId="4bfbf330-8776-4086-a830-2184b07ba8db" providerId="ADAL" clId="{3BADC0B2-0F94-45F6-B552-1A87FB5F996F}" dt="2022-08-19T10:23:20.219" v="835" actId="1076"/>
          <ac:graphicFrameMkLst>
            <pc:docMk/>
            <pc:sldMk cId="1727516209" sldId="324"/>
            <ac:graphicFrameMk id="3" creationId="{FFF8AD63-E72F-4786-932C-B644638F10C6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10:23:42.258" v="837" actId="1076"/>
        <pc:sldMkLst>
          <pc:docMk/>
          <pc:sldMk cId="111667840" sldId="325"/>
        </pc:sldMkLst>
        <pc:spChg chg="mod">
          <ac:chgData name="Kaygisiz, Kübra" userId="4bfbf330-8776-4086-a830-2184b07ba8db" providerId="ADAL" clId="{3BADC0B2-0F94-45F6-B552-1A87FB5F996F}" dt="2022-08-19T09:43:39.853" v="522"/>
          <ac:spMkLst>
            <pc:docMk/>
            <pc:sldMk cId="111667840" sldId="325"/>
            <ac:spMk id="2" creationId="{33C7CEB4-863F-4D06-55B9-3D9411B426E3}"/>
          </ac:spMkLst>
        </pc:spChg>
        <pc:graphicFrameChg chg="add mod">
          <ac:chgData name="Kaygisiz, Kübra" userId="4bfbf330-8776-4086-a830-2184b07ba8db" providerId="ADAL" clId="{3BADC0B2-0F94-45F6-B552-1A87FB5F996F}" dt="2022-08-19T10:23:42.258" v="837" actId="1076"/>
          <ac:graphicFrameMkLst>
            <pc:docMk/>
            <pc:sldMk cId="111667840" sldId="325"/>
            <ac:graphicFrameMk id="3" creationId="{A2B8719F-8685-4D65-8D20-21338BB33AB2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10:25:02.101" v="839" actId="1076"/>
        <pc:sldMkLst>
          <pc:docMk/>
          <pc:sldMk cId="1460808408" sldId="326"/>
        </pc:sldMkLst>
        <pc:spChg chg="mod">
          <ac:chgData name="Kaygisiz, Kübra" userId="4bfbf330-8776-4086-a830-2184b07ba8db" providerId="ADAL" clId="{3BADC0B2-0F94-45F6-B552-1A87FB5F996F}" dt="2022-08-19T09:43:44.650" v="523"/>
          <ac:spMkLst>
            <pc:docMk/>
            <pc:sldMk cId="1460808408" sldId="326"/>
            <ac:spMk id="2" creationId="{0D2124FC-D62E-BCA2-FC63-2913EBF6C507}"/>
          </ac:spMkLst>
        </pc:spChg>
        <pc:graphicFrameChg chg="add mod">
          <ac:chgData name="Kaygisiz, Kübra" userId="4bfbf330-8776-4086-a830-2184b07ba8db" providerId="ADAL" clId="{3BADC0B2-0F94-45F6-B552-1A87FB5F996F}" dt="2022-08-19T10:25:02.101" v="839" actId="1076"/>
          <ac:graphicFrameMkLst>
            <pc:docMk/>
            <pc:sldMk cId="1460808408" sldId="326"/>
            <ac:graphicFrameMk id="3" creationId="{C47A0BC4-71BC-5B6D-2C8D-A0F03D9F979F}"/>
          </ac:graphicFrameMkLst>
        </pc:graphicFrameChg>
      </pc:sldChg>
      <pc:sldChg chg="modSp new mod">
        <pc:chgData name="Kaygisiz, Kübra" userId="4bfbf330-8776-4086-a830-2184b07ba8db" providerId="ADAL" clId="{3BADC0B2-0F94-45F6-B552-1A87FB5F996F}" dt="2022-08-19T09:43:49.491" v="524"/>
        <pc:sldMkLst>
          <pc:docMk/>
          <pc:sldMk cId="475343453" sldId="327"/>
        </pc:sldMkLst>
        <pc:spChg chg="mod">
          <ac:chgData name="Kaygisiz, Kübra" userId="4bfbf330-8776-4086-a830-2184b07ba8db" providerId="ADAL" clId="{3BADC0B2-0F94-45F6-B552-1A87FB5F996F}" dt="2022-08-19T09:43:49.491" v="524"/>
          <ac:spMkLst>
            <pc:docMk/>
            <pc:sldMk cId="475343453" sldId="327"/>
            <ac:spMk id="2" creationId="{2E2D330C-824D-285D-6049-3409A98CC559}"/>
          </ac:spMkLst>
        </pc:spChg>
      </pc:sldChg>
      <pc:sldChg chg="modSp new mod">
        <pc:chgData name="Kaygisiz, Kübra" userId="4bfbf330-8776-4086-a830-2184b07ba8db" providerId="ADAL" clId="{3BADC0B2-0F94-45F6-B552-1A87FB5F996F}" dt="2022-08-19T09:43:55.961" v="525"/>
        <pc:sldMkLst>
          <pc:docMk/>
          <pc:sldMk cId="3262892428" sldId="328"/>
        </pc:sldMkLst>
        <pc:spChg chg="mod">
          <ac:chgData name="Kaygisiz, Kübra" userId="4bfbf330-8776-4086-a830-2184b07ba8db" providerId="ADAL" clId="{3BADC0B2-0F94-45F6-B552-1A87FB5F996F}" dt="2022-08-19T09:43:55.961" v="525"/>
          <ac:spMkLst>
            <pc:docMk/>
            <pc:sldMk cId="3262892428" sldId="328"/>
            <ac:spMk id="2" creationId="{1431E2D8-2908-E90C-1F57-4264D30297F9}"/>
          </ac:spMkLst>
        </pc:spChg>
      </pc:sldChg>
      <pc:sldChg chg="modSp new mod">
        <pc:chgData name="Kaygisiz, Kübra" userId="4bfbf330-8776-4086-a830-2184b07ba8db" providerId="ADAL" clId="{3BADC0B2-0F94-45F6-B552-1A87FB5F996F}" dt="2022-08-19T09:44:00.292" v="526"/>
        <pc:sldMkLst>
          <pc:docMk/>
          <pc:sldMk cId="3031801590" sldId="329"/>
        </pc:sldMkLst>
        <pc:spChg chg="mod">
          <ac:chgData name="Kaygisiz, Kübra" userId="4bfbf330-8776-4086-a830-2184b07ba8db" providerId="ADAL" clId="{3BADC0B2-0F94-45F6-B552-1A87FB5F996F}" dt="2022-08-19T09:44:00.292" v="526"/>
          <ac:spMkLst>
            <pc:docMk/>
            <pc:sldMk cId="3031801590" sldId="329"/>
            <ac:spMk id="2" creationId="{468EFF9C-BDDE-DE81-0A48-20BF04373BB6}"/>
          </ac:spMkLst>
        </pc:spChg>
      </pc:sldChg>
      <pc:sldChg chg="addSp modSp new mod">
        <pc:chgData name="Kaygisiz, Kübra" userId="4bfbf330-8776-4086-a830-2184b07ba8db" providerId="ADAL" clId="{3BADC0B2-0F94-45F6-B552-1A87FB5F996F}" dt="2022-08-19T10:25:23.360" v="841" actId="1076"/>
        <pc:sldMkLst>
          <pc:docMk/>
          <pc:sldMk cId="3853370157" sldId="330"/>
        </pc:sldMkLst>
        <pc:spChg chg="mod">
          <ac:chgData name="Kaygisiz, Kübra" userId="4bfbf330-8776-4086-a830-2184b07ba8db" providerId="ADAL" clId="{3BADC0B2-0F94-45F6-B552-1A87FB5F996F}" dt="2022-08-19T09:44:05.762" v="527"/>
          <ac:spMkLst>
            <pc:docMk/>
            <pc:sldMk cId="3853370157" sldId="330"/>
            <ac:spMk id="2" creationId="{E68BD14B-5E83-7412-A2B3-75B12F303E61}"/>
          </ac:spMkLst>
        </pc:spChg>
        <pc:graphicFrameChg chg="add mod">
          <ac:chgData name="Kaygisiz, Kübra" userId="4bfbf330-8776-4086-a830-2184b07ba8db" providerId="ADAL" clId="{3BADC0B2-0F94-45F6-B552-1A87FB5F996F}" dt="2022-08-19T10:25:23.360" v="841" actId="1076"/>
          <ac:graphicFrameMkLst>
            <pc:docMk/>
            <pc:sldMk cId="3853370157" sldId="330"/>
            <ac:graphicFrameMk id="3" creationId="{63E2FB85-C666-5C39-BA2C-B74F2DD4CA37}"/>
          </ac:graphicFrameMkLst>
        </pc:graphicFrameChg>
      </pc:sldChg>
      <pc:sldChg chg="modSp new mod">
        <pc:chgData name="Kaygisiz, Kübra" userId="4bfbf330-8776-4086-a830-2184b07ba8db" providerId="ADAL" clId="{3BADC0B2-0F94-45F6-B552-1A87FB5F996F}" dt="2022-08-19T09:44:10.685" v="528"/>
        <pc:sldMkLst>
          <pc:docMk/>
          <pc:sldMk cId="1962231915" sldId="331"/>
        </pc:sldMkLst>
        <pc:spChg chg="mod">
          <ac:chgData name="Kaygisiz, Kübra" userId="4bfbf330-8776-4086-a830-2184b07ba8db" providerId="ADAL" clId="{3BADC0B2-0F94-45F6-B552-1A87FB5F996F}" dt="2022-08-19T09:44:10.685" v="528"/>
          <ac:spMkLst>
            <pc:docMk/>
            <pc:sldMk cId="1962231915" sldId="331"/>
            <ac:spMk id="2" creationId="{CD250E49-3C42-7872-FC52-8BA174883E34}"/>
          </ac:spMkLst>
        </pc:spChg>
      </pc:sldChg>
      <pc:sldChg chg="addSp modSp new mod">
        <pc:chgData name="Kaygisiz, Kübra" userId="4bfbf330-8776-4086-a830-2184b07ba8db" providerId="ADAL" clId="{3BADC0B2-0F94-45F6-B552-1A87FB5F996F}" dt="2022-08-19T10:25:45.067" v="843" actId="1076"/>
        <pc:sldMkLst>
          <pc:docMk/>
          <pc:sldMk cId="3901561466" sldId="332"/>
        </pc:sldMkLst>
        <pc:spChg chg="mod">
          <ac:chgData name="Kaygisiz, Kübra" userId="4bfbf330-8776-4086-a830-2184b07ba8db" providerId="ADAL" clId="{3BADC0B2-0F94-45F6-B552-1A87FB5F996F}" dt="2022-08-19T09:44:15.852" v="529"/>
          <ac:spMkLst>
            <pc:docMk/>
            <pc:sldMk cId="3901561466" sldId="332"/>
            <ac:spMk id="2" creationId="{9CBDDC57-77FE-152F-FCC6-4F51E42AB1EC}"/>
          </ac:spMkLst>
        </pc:spChg>
        <pc:graphicFrameChg chg="add mod">
          <ac:chgData name="Kaygisiz, Kübra" userId="4bfbf330-8776-4086-a830-2184b07ba8db" providerId="ADAL" clId="{3BADC0B2-0F94-45F6-B552-1A87FB5F996F}" dt="2022-08-19T10:25:45.067" v="843" actId="1076"/>
          <ac:graphicFrameMkLst>
            <pc:docMk/>
            <pc:sldMk cId="3901561466" sldId="332"/>
            <ac:graphicFrameMk id="3" creationId="{BDAD28CC-A52F-B9DC-308C-C256C623BD98}"/>
          </ac:graphicFrameMkLst>
        </pc:graphicFrameChg>
      </pc:sldChg>
      <pc:sldChg chg="modSp new mod">
        <pc:chgData name="Kaygisiz, Kübra" userId="4bfbf330-8776-4086-a830-2184b07ba8db" providerId="ADAL" clId="{3BADC0B2-0F94-45F6-B552-1A87FB5F996F}" dt="2022-08-19T09:44:22.468" v="530"/>
        <pc:sldMkLst>
          <pc:docMk/>
          <pc:sldMk cId="3003807109" sldId="333"/>
        </pc:sldMkLst>
        <pc:spChg chg="mod">
          <ac:chgData name="Kaygisiz, Kübra" userId="4bfbf330-8776-4086-a830-2184b07ba8db" providerId="ADAL" clId="{3BADC0B2-0F94-45F6-B552-1A87FB5F996F}" dt="2022-08-19T09:44:22.468" v="530"/>
          <ac:spMkLst>
            <pc:docMk/>
            <pc:sldMk cId="3003807109" sldId="333"/>
            <ac:spMk id="2" creationId="{AB074187-624E-C886-AB90-63F261F97CC0}"/>
          </ac:spMkLst>
        </pc:spChg>
      </pc:sldChg>
      <pc:sldChg chg="modSp new mod">
        <pc:chgData name="Kaygisiz, Kübra" userId="4bfbf330-8776-4086-a830-2184b07ba8db" providerId="ADAL" clId="{3BADC0B2-0F94-45F6-B552-1A87FB5F996F}" dt="2022-08-19T09:44:28.351" v="531"/>
        <pc:sldMkLst>
          <pc:docMk/>
          <pc:sldMk cId="3461780314" sldId="334"/>
        </pc:sldMkLst>
        <pc:spChg chg="mod">
          <ac:chgData name="Kaygisiz, Kübra" userId="4bfbf330-8776-4086-a830-2184b07ba8db" providerId="ADAL" clId="{3BADC0B2-0F94-45F6-B552-1A87FB5F996F}" dt="2022-08-19T09:44:28.351" v="531"/>
          <ac:spMkLst>
            <pc:docMk/>
            <pc:sldMk cId="3461780314" sldId="334"/>
            <ac:spMk id="2" creationId="{0E847B9E-CCDF-772A-FA9A-029F47A82A43}"/>
          </ac:spMkLst>
        </pc:spChg>
      </pc:sldChg>
      <pc:sldChg chg="addSp modSp new mod">
        <pc:chgData name="Kaygisiz, Kübra" userId="4bfbf330-8776-4086-a830-2184b07ba8db" providerId="ADAL" clId="{3BADC0B2-0F94-45F6-B552-1A87FB5F996F}" dt="2022-08-19T10:19:43.046" v="819" actId="1076"/>
        <pc:sldMkLst>
          <pc:docMk/>
          <pc:sldMk cId="1096788961" sldId="335"/>
        </pc:sldMkLst>
        <pc:spChg chg="mod">
          <ac:chgData name="Kaygisiz, Kübra" userId="4bfbf330-8776-4086-a830-2184b07ba8db" providerId="ADAL" clId="{3BADC0B2-0F94-45F6-B552-1A87FB5F996F}" dt="2022-08-19T09:44:37.225" v="532"/>
          <ac:spMkLst>
            <pc:docMk/>
            <pc:sldMk cId="1096788961" sldId="335"/>
            <ac:spMk id="2" creationId="{04C1DAC5-87EC-A703-1E70-B6EE2B618DB7}"/>
          </ac:spMkLst>
        </pc:spChg>
        <pc:graphicFrameChg chg="add mod">
          <ac:chgData name="Kaygisiz, Kübra" userId="4bfbf330-8776-4086-a830-2184b07ba8db" providerId="ADAL" clId="{3BADC0B2-0F94-45F6-B552-1A87FB5F996F}" dt="2022-08-19T10:19:43.046" v="819" actId="1076"/>
          <ac:graphicFrameMkLst>
            <pc:docMk/>
            <pc:sldMk cId="1096788961" sldId="335"/>
            <ac:graphicFrameMk id="3" creationId="{667EB70F-F25D-2A31-CFFE-6CBB5B151244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10:20:04.813" v="821" actId="1076"/>
        <pc:sldMkLst>
          <pc:docMk/>
          <pc:sldMk cId="3804239503" sldId="336"/>
        </pc:sldMkLst>
        <pc:spChg chg="mod">
          <ac:chgData name="Kaygisiz, Kübra" userId="4bfbf330-8776-4086-a830-2184b07ba8db" providerId="ADAL" clId="{3BADC0B2-0F94-45F6-B552-1A87FB5F996F}" dt="2022-08-19T09:44:42.031" v="533"/>
          <ac:spMkLst>
            <pc:docMk/>
            <pc:sldMk cId="3804239503" sldId="336"/>
            <ac:spMk id="2" creationId="{590F431B-6173-C457-AB59-BCCDC08E304A}"/>
          </ac:spMkLst>
        </pc:spChg>
        <pc:graphicFrameChg chg="add mod">
          <ac:chgData name="Kaygisiz, Kübra" userId="4bfbf330-8776-4086-a830-2184b07ba8db" providerId="ADAL" clId="{3BADC0B2-0F94-45F6-B552-1A87FB5F996F}" dt="2022-08-19T10:20:04.813" v="821" actId="1076"/>
          <ac:graphicFrameMkLst>
            <pc:docMk/>
            <pc:sldMk cId="3804239503" sldId="336"/>
            <ac:graphicFrameMk id="3" creationId="{3EFCAF93-C30B-4FB4-D489-3EFFD08E1BFA}"/>
          </ac:graphicFrameMkLst>
        </pc:graphicFrameChg>
      </pc:sldChg>
      <pc:sldChg chg="modSp new mod">
        <pc:chgData name="Kaygisiz, Kübra" userId="4bfbf330-8776-4086-a830-2184b07ba8db" providerId="ADAL" clId="{3BADC0B2-0F94-45F6-B552-1A87FB5F996F}" dt="2022-08-19T09:44:47.946" v="534"/>
        <pc:sldMkLst>
          <pc:docMk/>
          <pc:sldMk cId="1222299476" sldId="337"/>
        </pc:sldMkLst>
        <pc:spChg chg="mod">
          <ac:chgData name="Kaygisiz, Kübra" userId="4bfbf330-8776-4086-a830-2184b07ba8db" providerId="ADAL" clId="{3BADC0B2-0F94-45F6-B552-1A87FB5F996F}" dt="2022-08-19T09:44:47.946" v="534"/>
          <ac:spMkLst>
            <pc:docMk/>
            <pc:sldMk cId="1222299476" sldId="337"/>
            <ac:spMk id="2" creationId="{12A83FF0-472D-74B2-6CD5-BC1121FB7C35}"/>
          </ac:spMkLst>
        </pc:spChg>
      </pc:sldChg>
      <pc:sldChg chg="modSp new mod">
        <pc:chgData name="Kaygisiz, Kübra" userId="4bfbf330-8776-4086-a830-2184b07ba8db" providerId="ADAL" clId="{3BADC0B2-0F94-45F6-B552-1A87FB5F996F}" dt="2022-08-19T09:44:51.486" v="535"/>
        <pc:sldMkLst>
          <pc:docMk/>
          <pc:sldMk cId="3512817995" sldId="338"/>
        </pc:sldMkLst>
        <pc:spChg chg="mod">
          <ac:chgData name="Kaygisiz, Kübra" userId="4bfbf330-8776-4086-a830-2184b07ba8db" providerId="ADAL" clId="{3BADC0B2-0F94-45F6-B552-1A87FB5F996F}" dt="2022-08-19T09:44:51.486" v="535"/>
          <ac:spMkLst>
            <pc:docMk/>
            <pc:sldMk cId="3512817995" sldId="338"/>
            <ac:spMk id="2" creationId="{56CBB909-2DBA-9955-6121-576BFD862FB0}"/>
          </ac:spMkLst>
        </pc:spChg>
      </pc:sldChg>
      <pc:sldChg chg="modSp new mod">
        <pc:chgData name="Kaygisiz, Kübra" userId="4bfbf330-8776-4086-a830-2184b07ba8db" providerId="ADAL" clId="{3BADC0B2-0F94-45F6-B552-1A87FB5F996F}" dt="2022-08-19T09:44:56.183" v="536"/>
        <pc:sldMkLst>
          <pc:docMk/>
          <pc:sldMk cId="917755002" sldId="339"/>
        </pc:sldMkLst>
        <pc:spChg chg="mod">
          <ac:chgData name="Kaygisiz, Kübra" userId="4bfbf330-8776-4086-a830-2184b07ba8db" providerId="ADAL" clId="{3BADC0B2-0F94-45F6-B552-1A87FB5F996F}" dt="2022-08-19T09:44:56.183" v="536"/>
          <ac:spMkLst>
            <pc:docMk/>
            <pc:sldMk cId="917755002" sldId="339"/>
            <ac:spMk id="2" creationId="{291EBE72-8AFF-6CB9-4AF6-20F555B3EFC3}"/>
          </ac:spMkLst>
        </pc:spChg>
      </pc:sldChg>
      <pc:sldChg chg="modSp new mod">
        <pc:chgData name="Kaygisiz, Kübra" userId="4bfbf330-8776-4086-a830-2184b07ba8db" providerId="ADAL" clId="{3BADC0B2-0F94-45F6-B552-1A87FB5F996F}" dt="2022-08-19T09:45:00.291" v="537"/>
        <pc:sldMkLst>
          <pc:docMk/>
          <pc:sldMk cId="3316588487" sldId="340"/>
        </pc:sldMkLst>
        <pc:spChg chg="mod">
          <ac:chgData name="Kaygisiz, Kübra" userId="4bfbf330-8776-4086-a830-2184b07ba8db" providerId="ADAL" clId="{3BADC0B2-0F94-45F6-B552-1A87FB5F996F}" dt="2022-08-19T09:45:00.291" v="537"/>
          <ac:spMkLst>
            <pc:docMk/>
            <pc:sldMk cId="3316588487" sldId="340"/>
            <ac:spMk id="2" creationId="{DAD146AE-AAD3-8827-20D3-3B195FF0FFD1}"/>
          </ac:spMkLst>
        </pc:spChg>
      </pc:sldChg>
      <pc:sldChg chg="addSp modSp new mod">
        <pc:chgData name="Kaygisiz, Kübra" userId="4bfbf330-8776-4086-a830-2184b07ba8db" providerId="ADAL" clId="{3BADC0B2-0F94-45F6-B552-1A87FB5F996F}" dt="2022-08-21T03:36:42.576" v="1190" actId="1076"/>
        <pc:sldMkLst>
          <pc:docMk/>
          <pc:sldMk cId="2590626734" sldId="341"/>
        </pc:sldMkLst>
        <pc:spChg chg="mod">
          <ac:chgData name="Kaygisiz, Kübra" userId="4bfbf330-8776-4086-a830-2184b07ba8db" providerId="ADAL" clId="{3BADC0B2-0F94-45F6-B552-1A87FB5F996F}" dt="2022-08-19T09:45:05.322" v="538"/>
          <ac:spMkLst>
            <pc:docMk/>
            <pc:sldMk cId="2590626734" sldId="341"/>
            <ac:spMk id="2" creationId="{F88BE150-7114-F046-46C0-D3B4580D655F}"/>
          </ac:spMkLst>
        </pc:spChg>
        <pc:graphicFrameChg chg="add mod">
          <ac:chgData name="Kaygisiz, Kübra" userId="4bfbf330-8776-4086-a830-2184b07ba8db" providerId="ADAL" clId="{3BADC0B2-0F94-45F6-B552-1A87FB5F996F}" dt="2022-08-21T03:36:42.576" v="1190" actId="1076"/>
          <ac:graphicFrameMkLst>
            <pc:docMk/>
            <pc:sldMk cId="2590626734" sldId="341"/>
            <ac:graphicFrameMk id="3" creationId="{BD7206E8-29AA-7769-51EF-1275FF19C94C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10:12:28.577" v="793" actId="1076"/>
        <pc:sldMkLst>
          <pc:docMk/>
          <pc:sldMk cId="1898536240" sldId="342"/>
        </pc:sldMkLst>
        <pc:spChg chg="mod">
          <ac:chgData name="Kaygisiz, Kübra" userId="4bfbf330-8776-4086-a830-2184b07ba8db" providerId="ADAL" clId="{3BADC0B2-0F94-45F6-B552-1A87FB5F996F}" dt="2022-08-19T09:45:11.246" v="539"/>
          <ac:spMkLst>
            <pc:docMk/>
            <pc:sldMk cId="1898536240" sldId="342"/>
            <ac:spMk id="2" creationId="{1DCA59E8-991D-D150-8047-7ACC16E7586E}"/>
          </ac:spMkLst>
        </pc:spChg>
        <pc:graphicFrameChg chg="add mod">
          <ac:chgData name="Kaygisiz, Kübra" userId="4bfbf330-8776-4086-a830-2184b07ba8db" providerId="ADAL" clId="{3BADC0B2-0F94-45F6-B552-1A87FB5F996F}" dt="2022-08-19T10:12:28.577" v="793" actId="1076"/>
          <ac:graphicFrameMkLst>
            <pc:docMk/>
            <pc:sldMk cId="1898536240" sldId="342"/>
            <ac:graphicFrameMk id="3" creationId="{0601A052-EEE1-BCBE-11CE-F719F9AE7462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10:14:00.069" v="799" actId="1076"/>
        <pc:sldMkLst>
          <pc:docMk/>
          <pc:sldMk cId="3408435681" sldId="343"/>
        </pc:sldMkLst>
        <pc:spChg chg="mod">
          <ac:chgData name="Kaygisiz, Kübra" userId="4bfbf330-8776-4086-a830-2184b07ba8db" providerId="ADAL" clId="{3BADC0B2-0F94-45F6-B552-1A87FB5F996F}" dt="2022-08-19T09:45:17.008" v="540"/>
          <ac:spMkLst>
            <pc:docMk/>
            <pc:sldMk cId="3408435681" sldId="343"/>
            <ac:spMk id="2" creationId="{407616AC-8A5E-2AD9-27BE-477EB5D3288B}"/>
          </ac:spMkLst>
        </pc:spChg>
        <pc:graphicFrameChg chg="add mod">
          <ac:chgData name="Kaygisiz, Kübra" userId="4bfbf330-8776-4086-a830-2184b07ba8db" providerId="ADAL" clId="{3BADC0B2-0F94-45F6-B552-1A87FB5F996F}" dt="2022-08-19T10:14:00.069" v="799" actId="1076"/>
          <ac:graphicFrameMkLst>
            <pc:docMk/>
            <pc:sldMk cId="3408435681" sldId="343"/>
            <ac:graphicFrameMk id="3" creationId="{8FC483F1-D96B-C931-EDC1-1439D289561D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2:54:17.778" v="1137" actId="1076"/>
        <pc:sldMkLst>
          <pc:docMk/>
          <pc:sldMk cId="2732038377" sldId="344"/>
        </pc:sldMkLst>
        <pc:spChg chg="mod">
          <ac:chgData name="Kaygisiz, Kübra" userId="4bfbf330-8776-4086-a830-2184b07ba8db" providerId="ADAL" clId="{3BADC0B2-0F94-45F6-B552-1A87FB5F996F}" dt="2022-08-19T09:45:23.229" v="541"/>
          <ac:spMkLst>
            <pc:docMk/>
            <pc:sldMk cId="2732038377" sldId="344"/>
            <ac:spMk id="2" creationId="{9A7E0525-8E5B-903A-AD4D-495672281466}"/>
          </ac:spMkLst>
        </pc:spChg>
        <pc:graphicFrameChg chg="add mod">
          <ac:chgData name="Kaygisiz, Kübra" userId="4bfbf330-8776-4086-a830-2184b07ba8db" providerId="ADAL" clId="{3BADC0B2-0F94-45F6-B552-1A87FB5F996F}" dt="2022-08-21T02:54:17.778" v="1137" actId="1076"/>
          <ac:graphicFrameMkLst>
            <pc:docMk/>
            <pc:sldMk cId="2732038377" sldId="344"/>
            <ac:graphicFrameMk id="3" creationId="{2B4FAC3C-851F-7C26-84DE-C6232A11A626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12:33:54.111" v="938" actId="1076"/>
        <pc:sldMkLst>
          <pc:docMk/>
          <pc:sldMk cId="1949823724" sldId="345"/>
        </pc:sldMkLst>
        <pc:spChg chg="mod">
          <ac:chgData name="Kaygisiz, Kübra" userId="4bfbf330-8776-4086-a830-2184b07ba8db" providerId="ADAL" clId="{3BADC0B2-0F94-45F6-B552-1A87FB5F996F}" dt="2022-08-19T09:45:27.063" v="542"/>
          <ac:spMkLst>
            <pc:docMk/>
            <pc:sldMk cId="1949823724" sldId="345"/>
            <ac:spMk id="2" creationId="{BBB618F2-2EE5-F2DC-E992-94C232B9D4B8}"/>
          </ac:spMkLst>
        </pc:spChg>
        <pc:graphicFrameChg chg="add mod">
          <ac:chgData name="Kaygisiz, Kübra" userId="4bfbf330-8776-4086-a830-2184b07ba8db" providerId="ADAL" clId="{3BADC0B2-0F94-45F6-B552-1A87FB5F996F}" dt="2022-08-19T12:33:54.111" v="938" actId="1076"/>
          <ac:graphicFrameMkLst>
            <pc:docMk/>
            <pc:sldMk cId="1949823724" sldId="345"/>
            <ac:graphicFrameMk id="3" creationId="{469EFA4B-12EF-A0BF-B393-FFDA1E5F04CE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12:34:18.133" v="940" actId="1076"/>
        <pc:sldMkLst>
          <pc:docMk/>
          <pc:sldMk cId="2170761285" sldId="346"/>
        </pc:sldMkLst>
        <pc:spChg chg="mod">
          <ac:chgData name="Kaygisiz, Kübra" userId="4bfbf330-8776-4086-a830-2184b07ba8db" providerId="ADAL" clId="{3BADC0B2-0F94-45F6-B552-1A87FB5F996F}" dt="2022-08-19T09:45:30.775" v="543"/>
          <ac:spMkLst>
            <pc:docMk/>
            <pc:sldMk cId="2170761285" sldId="346"/>
            <ac:spMk id="2" creationId="{A40482C0-72A6-C1AA-84A4-9B7B7D72AFD9}"/>
          </ac:spMkLst>
        </pc:spChg>
        <pc:graphicFrameChg chg="add mod">
          <ac:chgData name="Kaygisiz, Kübra" userId="4bfbf330-8776-4086-a830-2184b07ba8db" providerId="ADAL" clId="{3BADC0B2-0F94-45F6-B552-1A87FB5F996F}" dt="2022-08-19T12:34:18.133" v="940" actId="1076"/>
          <ac:graphicFrameMkLst>
            <pc:docMk/>
            <pc:sldMk cId="2170761285" sldId="346"/>
            <ac:graphicFrameMk id="3" creationId="{19017CC0-7629-B8D2-CE78-0036AD3017A0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12:34:41.893" v="942" actId="1076"/>
        <pc:sldMkLst>
          <pc:docMk/>
          <pc:sldMk cId="1071448602" sldId="347"/>
        </pc:sldMkLst>
        <pc:spChg chg="mod">
          <ac:chgData name="Kaygisiz, Kübra" userId="4bfbf330-8776-4086-a830-2184b07ba8db" providerId="ADAL" clId="{3BADC0B2-0F94-45F6-B552-1A87FB5F996F}" dt="2022-08-19T09:45:36.711" v="544"/>
          <ac:spMkLst>
            <pc:docMk/>
            <pc:sldMk cId="1071448602" sldId="347"/>
            <ac:spMk id="2" creationId="{52AA0428-275C-60FC-E8AE-AFC4DA3E6DA7}"/>
          </ac:spMkLst>
        </pc:spChg>
        <pc:graphicFrameChg chg="add mod">
          <ac:chgData name="Kaygisiz, Kübra" userId="4bfbf330-8776-4086-a830-2184b07ba8db" providerId="ADAL" clId="{3BADC0B2-0F94-45F6-B552-1A87FB5F996F}" dt="2022-08-19T12:34:41.893" v="942" actId="1076"/>
          <ac:graphicFrameMkLst>
            <pc:docMk/>
            <pc:sldMk cId="1071448602" sldId="347"/>
            <ac:graphicFrameMk id="3" creationId="{CB669263-DA24-D1CC-DACC-C5327A3E0DF4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2:55:42.949" v="1139" actId="1076"/>
        <pc:sldMkLst>
          <pc:docMk/>
          <pc:sldMk cId="1423417698" sldId="348"/>
        </pc:sldMkLst>
        <pc:spChg chg="mod">
          <ac:chgData name="Kaygisiz, Kübra" userId="4bfbf330-8776-4086-a830-2184b07ba8db" providerId="ADAL" clId="{3BADC0B2-0F94-45F6-B552-1A87FB5F996F}" dt="2022-08-19T09:45:41.379" v="545"/>
          <ac:spMkLst>
            <pc:docMk/>
            <pc:sldMk cId="1423417698" sldId="348"/>
            <ac:spMk id="2" creationId="{34C9DA80-CA6B-4460-6AE7-A5AA1ACCDF3A}"/>
          </ac:spMkLst>
        </pc:spChg>
        <pc:graphicFrameChg chg="add mod">
          <ac:chgData name="Kaygisiz, Kübra" userId="4bfbf330-8776-4086-a830-2184b07ba8db" providerId="ADAL" clId="{3BADC0B2-0F94-45F6-B552-1A87FB5F996F}" dt="2022-08-21T02:55:42.949" v="1139" actId="1076"/>
          <ac:graphicFrameMkLst>
            <pc:docMk/>
            <pc:sldMk cId="1423417698" sldId="348"/>
            <ac:graphicFrameMk id="3" creationId="{950DFCE5-BB35-3C1F-1CF8-696D7AE7CDDE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3:09:41.019" v="1162" actId="1076"/>
        <pc:sldMkLst>
          <pc:docMk/>
          <pc:sldMk cId="2229018126" sldId="349"/>
        </pc:sldMkLst>
        <pc:spChg chg="mod">
          <ac:chgData name="Kaygisiz, Kübra" userId="4bfbf330-8776-4086-a830-2184b07ba8db" providerId="ADAL" clId="{3BADC0B2-0F94-45F6-B552-1A87FB5F996F}" dt="2022-08-19T09:45:45.496" v="546"/>
          <ac:spMkLst>
            <pc:docMk/>
            <pc:sldMk cId="2229018126" sldId="349"/>
            <ac:spMk id="2" creationId="{849AAE79-E26B-FFB4-98BF-E553AB3A6BA1}"/>
          </ac:spMkLst>
        </pc:spChg>
        <pc:graphicFrameChg chg="add mod">
          <ac:chgData name="Kaygisiz, Kübra" userId="4bfbf330-8776-4086-a830-2184b07ba8db" providerId="ADAL" clId="{3BADC0B2-0F94-45F6-B552-1A87FB5F996F}" dt="2022-08-21T03:09:41.019" v="1162" actId="1076"/>
          <ac:graphicFrameMkLst>
            <pc:docMk/>
            <pc:sldMk cId="2229018126" sldId="349"/>
            <ac:graphicFrameMk id="3" creationId="{2FFD85CD-F19E-5604-FFF9-272F2CB0E570}"/>
          </ac:graphicFrameMkLst>
        </pc:graphicFrameChg>
      </pc:sldChg>
      <pc:sldChg chg="modSp new mod">
        <pc:chgData name="Kaygisiz, Kübra" userId="4bfbf330-8776-4086-a830-2184b07ba8db" providerId="ADAL" clId="{3BADC0B2-0F94-45F6-B552-1A87FB5F996F}" dt="2022-08-19T09:45:49.433" v="547"/>
        <pc:sldMkLst>
          <pc:docMk/>
          <pc:sldMk cId="2524499919" sldId="350"/>
        </pc:sldMkLst>
        <pc:spChg chg="mod">
          <ac:chgData name="Kaygisiz, Kübra" userId="4bfbf330-8776-4086-a830-2184b07ba8db" providerId="ADAL" clId="{3BADC0B2-0F94-45F6-B552-1A87FB5F996F}" dt="2022-08-19T09:45:49.433" v="547"/>
          <ac:spMkLst>
            <pc:docMk/>
            <pc:sldMk cId="2524499919" sldId="350"/>
            <ac:spMk id="2" creationId="{01B78CD1-4D33-EB6B-2E34-2328A465B314}"/>
          </ac:spMkLst>
        </pc:spChg>
      </pc:sldChg>
      <pc:sldChg chg="addSp modSp new mod">
        <pc:chgData name="Kaygisiz, Kübra" userId="4bfbf330-8776-4086-a830-2184b07ba8db" providerId="ADAL" clId="{3BADC0B2-0F94-45F6-B552-1A87FB5F996F}" dt="2022-08-19T12:29:28.651" v="928" actId="1076"/>
        <pc:sldMkLst>
          <pc:docMk/>
          <pc:sldMk cId="3878398416" sldId="351"/>
        </pc:sldMkLst>
        <pc:spChg chg="mod">
          <ac:chgData name="Kaygisiz, Kübra" userId="4bfbf330-8776-4086-a830-2184b07ba8db" providerId="ADAL" clId="{3BADC0B2-0F94-45F6-B552-1A87FB5F996F}" dt="2022-08-19T09:45:53.280" v="548"/>
          <ac:spMkLst>
            <pc:docMk/>
            <pc:sldMk cId="3878398416" sldId="351"/>
            <ac:spMk id="2" creationId="{41EC6B8F-B30E-6C1D-487D-78CB50852A07}"/>
          </ac:spMkLst>
        </pc:spChg>
        <pc:graphicFrameChg chg="add mod">
          <ac:chgData name="Kaygisiz, Kübra" userId="4bfbf330-8776-4086-a830-2184b07ba8db" providerId="ADAL" clId="{3BADC0B2-0F94-45F6-B552-1A87FB5F996F}" dt="2022-08-19T12:29:28.651" v="928" actId="1076"/>
          <ac:graphicFrameMkLst>
            <pc:docMk/>
            <pc:sldMk cId="3878398416" sldId="351"/>
            <ac:graphicFrameMk id="3" creationId="{8EC8BF19-5191-03E7-5553-6D2054749D62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12:30:07.533" v="930" actId="1076"/>
        <pc:sldMkLst>
          <pc:docMk/>
          <pc:sldMk cId="4268443313" sldId="352"/>
        </pc:sldMkLst>
        <pc:spChg chg="mod">
          <ac:chgData name="Kaygisiz, Kübra" userId="4bfbf330-8776-4086-a830-2184b07ba8db" providerId="ADAL" clId="{3BADC0B2-0F94-45F6-B552-1A87FB5F996F}" dt="2022-08-19T09:45:58.767" v="549"/>
          <ac:spMkLst>
            <pc:docMk/>
            <pc:sldMk cId="4268443313" sldId="352"/>
            <ac:spMk id="2" creationId="{2BE5B3B9-0774-FC13-61C2-1AA84FE7F538}"/>
          </ac:spMkLst>
        </pc:spChg>
        <pc:graphicFrameChg chg="add mod">
          <ac:chgData name="Kaygisiz, Kübra" userId="4bfbf330-8776-4086-a830-2184b07ba8db" providerId="ADAL" clId="{3BADC0B2-0F94-45F6-B552-1A87FB5F996F}" dt="2022-08-19T12:30:07.533" v="930" actId="1076"/>
          <ac:graphicFrameMkLst>
            <pc:docMk/>
            <pc:sldMk cId="4268443313" sldId="352"/>
            <ac:graphicFrameMk id="3" creationId="{16795839-2AC1-ED72-32DF-2C486CC77266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12:30:27.697" v="932" actId="1076"/>
        <pc:sldMkLst>
          <pc:docMk/>
          <pc:sldMk cId="2150953503" sldId="353"/>
        </pc:sldMkLst>
        <pc:spChg chg="mod">
          <ac:chgData name="Kaygisiz, Kübra" userId="4bfbf330-8776-4086-a830-2184b07ba8db" providerId="ADAL" clId="{3BADC0B2-0F94-45F6-B552-1A87FB5F996F}" dt="2022-08-19T09:46:02.602" v="550"/>
          <ac:spMkLst>
            <pc:docMk/>
            <pc:sldMk cId="2150953503" sldId="353"/>
            <ac:spMk id="2" creationId="{F2B35FD1-2E53-AAF5-56C0-42BA5B96506D}"/>
          </ac:spMkLst>
        </pc:spChg>
        <pc:graphicFrameChg chg="add mod">
          <ac:chgData name="Kaygisiz, Kübra" userId="4bfbf330-8776-4086-a830-2184b07ba8db" providerId="ADAL" clId="{3BADC0B2-0F94-45F6-B552-1A87FB5F996F}" dt="2022-08-19T12:30:27.697" v="932" actId="1076"/>
          <ac:graphicFrameMkLst>
            <pc:docMk/>
            <pc:sldMk cId="2150953503" sldId="353"/>
            <ac:graphicFrameMk id="3" creationId="{59F2FECD-D560-119B-0458-7D5C8C2ACE09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12:30:52.266" v="934" actId="1076"/>
        <pc:sldMkLst>
          <pc:docMk/>
          <pc:sldMk cId="3303159571" sldId="354"/>
        </pc:sldMkLst>
        <pc:spChg chg="mod">
          <ac:chgData name="Kaygisiz, Kübra" userId="4bfbf330-8776-4086-a830-2184b07ba8db" providerId="ADAL" clId="{3BADC0B2-0F94-45F6-B552-1A87FB5F996F}" dt="2022-08-19T09:46:06.424" v="551"/>
          <ac:spMkLst>
            <pc:docMk/>
            <pc:sldMk cId="3303159571" sldId="354"/>
            <ac:spMk id="2" creationId="{2F9A166E-7FCD-4B64-9184-98AB67F13672}"/>
          </ac:spMkLst>
        </pc:spChg>
        <pc:graphicFrameChg chg="add mod">
          <ac:chgData name="Kaygisiz, Kübra" userId="4bfbf330-8776-4086-a830-2184b07ba8db" providerId="ADAL" clId="{3BADC0B2-0F94-45F6-B552-1A87FB5F996F}" dt="2022-08-19T12:30:52.266" v="934" actId="1076"/>
          <ac:graphicFrameMkLst>
            <pc:docMk/>
            <pc:sldMk cId="3303159571" sldId="354"/>
            <ac:graphicFrameMk id="3" creationId="{DFD1B1F2-AFFD-DE1D-73C2-0A6828C132AB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12:32:52.745" v="936" actId="1076"/>
        <pc:sldMkLst>
          <pc:docMk/>
          <pc:sldMk cId="3754417479" sldId="355"/>
        </pc:sldMkLst>
        <pc:spChg chg="mod">
          <ac:chgData name="Kaygisiz, Kübra" userId="4bfbf330-8776-4086-a830-2184b07ba8db" providerId="ADAL" clId="{3BADC0B2-0F94-45F6-B552-1A87FB5F996F}" dt="2022-08-19T09:46:10.001" v="552"/>
          <ac:spMkLst>
            <pc:docMk/>
            <pc:sldMk cId="3754417479" sldId="355"/>
            <ac:spMk id="2" creationId="{149AE044-3EA9-68C0-934B-BCE22156A3D5}"/>
          </ac:spMkLst>
        </pc:spChg>
        <pc:graphicFrameChg chg="add mod">
          <ac:chgData name="Kaygisiz, Kübra" userId="4bfbf330-8776-4086-a830-2184b07ba8db" providerId="ADAL" clId="{3BADC0B2-0F94-45F6-B552-1A87FB5F996F}" dt="2022-08-19T12:32:52.745" v="936" actId="1076"/>
          <ac:graphicFrameMkLst>
            <pc:docMk/>
            <pc:sldMk cId="3754417479" sldId="355"/>
            <ac:graphicFrameMk id="3" creationId="{C01352EB-A412-F8D8-EC4A-E898D5BE091E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2:58:24.904" v="1141" actId="1076"/>
        <pc:sldMkLst>
          <pc:docMk/>
          <pc:sldMk cId="4261912029" sldId="356"/>
        </pc:sldMkLst>
        <pc:spChg chg="mod">
          <ac:chgData name="Kaygisiz, Kübra" userId="4bfbf330-8776-4086-a830-2184b07ba8db" providerId="ADAL" clId="{3BADC0B2-0F94-45F6-B552-1A87FB5F996F}" dt="2022-08-19T09:46:15.478" v="553"/>
          <ac:spMkLst>
            <pc:docMk/>
            <pc:sldMk cId="4261912029" sldId="356"/>
            <ac:spMk id="2" creationId="{747BEB76-C882-B63E-4449-E49799F15DB7}"/>
          </ac:spMkLst>
        </pc:spChg>
        <pc:graphicFrameChg chg="add mod">
          <ac:chgData name="Kaygisiz, Kübra" userId="4bfbf330-8776-4086-a830-2184b07ba8db" providerId="ADAL" clId="{3BADC0B2-0F94-45F6-B552-1A87FB5F996F}" dt="2022-08-21T02:58:24.904" v="1141" actId="1076"/>
          <ac:graphicFrameMkLst>
            <pc:docMk/>
            <pc:sldMk cId="4261912029" sldId="356"/>
            <ac:graphicFrameMk id="3" creationId="{417F5534-F94F-DF11-368B-6E8C4FAF69B4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12:35:09.160" v="944" actId="1076"/>
        <pc:sldMkLst>
          <pc:docMk/>
          <pc:sldMk cId="3849830204" sldId="357"/>
        </pc:sldMkLst>
        <pc:spChg chg="mod">
          <ac:chgData name="Kaygisiz, Kübra" userId="4bfbf330-8776-4086-a830-2184b07ba8db" providerId="ADAL" clId="{3BADC0B2-0F94-45F6-B552-1A87FB5F996F}" dt="2022-08-19T09:46:19.844" v="554"/>
          <ac:spMkLst>
            <pc:docMk/>
            <pc:sldMk cId="3849830204" sldId="357"/>
            <ac:spMk id="2" creationId="{8F4CCE40-4759-E82D-0050-1566355B286E}"/>
          </ac:spMkLst>
        </pc:spChg>
        <pc:graphicFrameChg chg="add mod">
          <ac:chgData name="Kaygisiz, Kübra" userId="4bfbf330-8776-4086-a830-2184b07ba8db" providerId="ADAL" clId="{3BADC0B2-0F94-45F6-B552-1A87FB5F996F}" dt="2022-08-19T12:35:09.160" v="944" actId="1076"/>
          <ac:graphicFrameMkLst>
            <pc:docMk/>
            <pc:sldMk cId="3849830204" sldId="357"/>
            <ac:graphicFrameMk id="3" creationId="{93070E35-FFB5-29D7-183F-DD0D023F275D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12:38:09.511" v="946" actId="1076"/>
        <pc:sldMkLst>
          <pc:docMk/>
          <pc:sldMk cId="2325294879" sldId="358"/>
        </pc:sldMkLst>
        <pc:spChg chg="mod">
          <ac:chgData name="Kaygisiz, Kübra" userId="4bfbf330-8776-4086-a830-2184b07ba8db" providerId="ADAL" clId="{3BADC0B2-0F94-45F6-B552-1A87FB5F996F}" dt="2022-08-19T09:46:23.917" v="555"/>
          <ac:spMkLst>
            <pc:docMk/>
            <pc:sldMk cId="2325294879" sldId="358"/>
            <ac:spMk id="2" creationId="{52BFA73D-D79F-A55C-7C89-A7F16284C685}"/>
          </ac:spMkLst>
        </pc:spChg>
        <pc:graphicFrameChg chg="add mod">
          <ac:chgData name="Kaygisiz, Kübra" userId="4bfbf330-8776-4086-a830-2184b07ba8db" providerId="ADAL" clId="{3BADC0B2-0F94-45F6-B552-1A87FB5F996F}" dt="2022-08-19T12:38:09.511" v="946" actId="1076"/>
          <ac:graphicFrameMkLst>
            <pc:docMk/>
            <pc:sldMk cId="2325294879" sldId="358"/>
            <ac:graphicFrameMk id="3" creationId="{5576CC9E-7A70-BB43-166C-38F3FC471B5D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2:59:31.113" v="1143" actId="1076"/>
        <pc:sldMkLst>
          <pc:docMk/>
          <pc:sldMk cId="832366075" sldId="359"/>
        </pc:sldMkLst>
        <pc:spChg chg="mod">
          <ac:chgData name="Kaygisiz, Kübra" userId="4bfbf330-8776-4086-a830-2184b07ba8db" providerId="ADAL" clId="{3BADC0B2-0F94-45F6-B552-1A87FB5F996F}" dt="2022-08-19T09:46:30.557" v="556"/>
          <ac:spMkLst>
            <pc:docMk/>
            <pc:sldMk cId="832366075" sldId="359"/>
            <ac:spMk id="2" creationId="{F53F22F1-819C-19AB-707A-2880F7455382}"/>
          </ac:spMkLst>
        </pc:spChg>
        <pc:graphicFrameChg chg="add mod">
          <ac:chgData name="Kaygisiz, Kübra" userId="4bfbf330-8776-4086-a830-2184b07ba8db" providerId="ADAL" clId="{3BADC0B2-0F94-45F6-B552-1A87FB5F996F}" dt="2022-08-21T02:59:31.113" v="1143" actId="1076"/>
          <ac:graphicFrameMkLst>
            <pc:docMk/>
            <pc:sldMk cId="832366075" sldId="359"/>
            <ac:graphicFrameMk id="3" creationId="{406D8059-D3CA-1850-D15E-A28381C67CB7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3:12:38.695" v="1166" actId="1076"/>
        <pc:sldMkLst>
          <pc:docMk/>
          <pc:sldMk cId="1166448720" sldId="360"/>
        </pc:sldMkLst>
        <pc:spChg chg="mod">
          <ac:chgData name="Kaygisiz, Kübra" userId="4bfbf330-8776-4086-a830-2184b07ba8db" providerId="ADAL" clId="{3BADC0B2-0F94-45F6-B552-1A87FB5F996F}" dt="2022-08-19T09:46:35.582" v="557"/>
          <ac:spMkLst>
            <pc:docMk/>
            <pc:sldMk cId="1166448720" sldId="360"/>
            <ac:spMk id="2" creationId="{89DA2CB5-881C-1D6D-E303-FE0A6C899C41}"/>
          </ac:spMkLst>
        </pc:spChg>
        <pc:graphicFrameChg chg="add mod">
          <ac:chgData name="Kaygisiz, Kübra" userId="4bfbf330-8776-4086-a830-2184b07ba8db" providerId="ADAL" clId="{3BADC0B2-0F94-45F6-B552-1A87FB5F996F}" dt="2022-08-19T12:38:33.284" v="948" actId="1076"/>
          <ac:graphicFrameMkLst>
            <pc:docMk/>
            <pc:sldMk cId="1166448720" sldId="360"/>
            <ac:graphicFrameMk id="3" creationId="{DBBFC1CF-8F69-6EEB-F29B-D2FCA646B36E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21T03:12:38.695" v="1166" actId="1076"/>
          <ac:graphicFrameMkLst>
            <pc:docMk/>
            <pc:sldMk cId="1166448720" sldId="360"/>
            <ac:graphicFrameMk id="4" creationId="{D7E47360-C40F-B479-84A8-E7653BDFE778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3:14:07.913" v="1168" actId="1076"/>
        <pc:sldMkLst>
          <pc:docMk/>
          <pc:sldMk cId="3818165673" sldId="361"/>
        </pc:sldMkLst>
        <pc:spChg chg="mod">
          <ac:chgData name="Kaygisiz, Kübra" userId="4bfbf330-8776-4086-a830-2184b07ba8db" providerId="ADAL" clId="{3BADC0B2-0F94-45F6-B552-1A87FB5F996F}" dt="2022-08-19T09:46:39.831" v="558"/>
          <ac:spMkLst>
            <pc:docMk/>
            <pc:sldMk cId="3818165673" sldId="361"/>
            <ac:spMk id="2" creationId="{442C9787-5B85-D805-DC04-362AAD9ADF2C}"/>
          </ac:spMkLst>
        </pc:spChg>
        <pc:graphicFrameChg chg="add mod">
          <ac:chgData name="Kaygisiz, Kübra" userId="4bfbf330-8776-4086-a830-2184b07ba8db" providerId="ADAL" clId="{3BADC0B2-0F94-45F6-B552-1A87FB5F996F}" dt="2022-08-21T03:14:07.913" v="1168" actId="1076"/>
          <ac:graphicFrameMkLst>
            <pc:docMk/>
            <pc:sldMk cId="3818165673" sldId="361"/>
            <ac:graphicFrameMk id="3" creationId="{7A47B578-36B6-CB4A-C062-62F97098A8F5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3:00:30.182" v="1145" actId="1076"/>
        <pc:sldMkLst>
          <pc:docMk/>
          <pc:sldMk cId="2111211650" sldId="362"/>
        </pc:sldMkLst>
        <pc:spChg chg="mod">
          <ac:chgData name="Kaygisiz, Kübra" userId="4bfbf330-8776-4086-a830-2184b07ba8db" providerId="ADAL" clId="{3BADC0B2-0F94-45F6-B552-1A87FB5F996F}" dt="2022-08-19T09:46:46.091" v="559"/>
          <ac:spMkLst>
            <pc:docMk/>
            <pc:sldMk cId="2111211650" sldId="362"/>
            <ac:spMk id="2" creationId="{D050D42A-4618-A9FC-1938-3DFEAD5D4608}"/>
          </ac:spMkLst>
        </pc:spChg>
        <pc:graphicFrameChg chg="add mod">
          <ac:chgData name="Kaygisiz, Kübra" userId="4bfbf330-8776-4086-a830-2184b07ba8db" providerId="ADAL" clId="{3BADC0B2-0F94-45F6-B552-1A87FB5F996F}" dt="2022-08-21T03:00:30.182" v="1145" actId="1076"/>
          <ac:graphicFrameMkLst>
            <pc:docMk/>
            <pc:sldMk cId="2111211650" sldId="362"/>
            <ac:graphicFrameMk id="3" creationId="{07FE2699-10A8-6654-DC28-DD96DDB1C3FB}"/>
          </ac:graphicFrameMkLst>
        </pc:graphicFrameChg>
      </pc:sldChg>
      <pc:sldChg chg="modSp new mod">
        <pc:chgData name="Kaygisiz, Kübra" userId="4bfbf330-8776-4086-a830-2184b07ba8db" providerId="ADAL" clId="{3BADC0B2-0F94-45F6-B552-1A87FB5F996F}" dt="2022-08-19T09:46:50.913" v="560"/>
        <pc:sldMkLst>
          <pc:docMk/>
          <pc:sldMk cId="3321173272" sldId="363"/>
        </pc:sldMkLst>
        <pc:spChg chg="mod">
          <ac:chgData name="Kaygisiz, Kübra" userId="4bfbf330-8776-4086-a830-2184b07ba8db" providerId="ADAL" clId="{3BADC0B2-0F94-45F6-B552-1A87FB5F996F}" dt="2022-08-19T09:46:50.913" v="560"/>
          <ac:spMkLst>
            <pc:docMk/>
            <pc:sldMk cId="3321173272" sldId="363"/>
            <ac:spMk id="2" creationId="{EE717E49-A1EE-4D60-BCDD-98485B7F8B5E}"/>
          </ac:spMkLst>
        </pc:spChg>
      </pc:sldChg>
      <pc:sldChg chg="addSp modSp new mod">
        <pc:chgData name="Kaygisiz, Kübra" userId="4bfbf330-8776-4086-a830-2184b07ba8db" providerId="ADAL" clId="{3BADC0B2-0F94-45F6-B552-1A87FB5F996F}" dt="2022-08-19T12:39:40.866" v="952" actId="1076"/>
        <pc:sldMkLst>
          <pc:docMk/>
          <pc:sldMk cId="2176846643" sldId="364"/>
        </pc:sldMkLst>
        <pc:spChg chg="mod">
          <ac:chgData name="Kaygisiz, Kübra" userId="4bfbf330-8776-4086-a830-2184b07ba8db" providerId="ADAL" clId="{3BADC0B2-0F94-45F6-B552-1A87FB5F996F}" dt="2022-08-19T09:46:54.538" v="561"/>
          <ac:spMkLst>
            <pc:docMk/>
            <pc:sldMk cId="2176846643" sldId="364"/>
            <ac:spMk id="2" creationId="{C6C4B1F0-1E28-9969-8C03-05A9B19C984F}"/>
          </ac:spMkLst>
        </pc:spChg>
        <pc:graphicFrameChg chg="add mod">
          <ac:chgData name="Kaygisiz, Kübra" userId="4bfbf330-8776-4086-a830-2184b07ba8db" providerId="ADAL" clId="{3BADC0B2-0F94-45F6-B552-1A87FB5F996F}" dt="2022-08-19T12:39:40.866" v="952" actId="1076"/>
          <ac:graphicFrameMkLst>
            <pc:docMk/>
            <pc:sldMk cId="2176846643" sldId="364"/>
            <ac:graphicFrameMk id="3" creationId="{026241E1-CE80-47CB-98CE-4B17DAD26132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1:42:41.165" v="962" actId="1076"/>
        <pc:sldMkLst>
          <pc:docMk/>
          <pc:sldMk cId="2678723006" sldId="365"/>
        </pc:sldMkLst>
        <pc:spChg chg="mod">
          <ac:chgData name="Kaygisiz, Kübra" userId="4bfbf330-8776-4086-a830-2184b07ba8db" providerId="ADAL" clId="{3BADC0B2-0F94-45F6-B552-1A87FB5F996F}" dt="2022-08-19T09:46:59.153" v="562"/>
          <ac:spMkLst>
            <pc:docMk/>
            <pc:sldMk cId="2678723006" sldId="365"/>
            <ac:spMk id="2" creationId="{EC510700-6BBE-5819-E9E3-ED43E6C37665}"/>
          </ac:spMkLst>
        </pc:spChg>
        <pc:graphicFrameChg chg="add mod">
          <ac:chgData name="Kaygisiz, Kübra" userId="4bfbf330-8776-4086-a830-2184b07ba8db" providerId="ADAL" clId="{3BADC0B2-0F94-45F6-B552-1A87FB5F996F}" dt="2022-08-21T01:42:41.165" v="962" actId="1076"/>
          <ac:graphicFrameMkLst>
            <pc:docMk/>
            <pc:sldMk cId="2678723006" sldId="365"/>
            <ac:graphicFrameMk id="3" creationId="{C062D2C8-A389-BA4F-8351-E603BDDC2A79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12:40:39.663" v="954" actId="1076"/>
        <pc:sldMkLst>
          <pc:docMk/>
          <pc:sldMk cId="2179992125" sldId="366"/>
        </pc:sldMkLst>
        <pc:spChg chg="mod">
          <ac:chgData name="Kaygisiz, Kübra" userId="4bfbf330-8776-4086-a830-2184b07ba8db" providerId="ADAL" clId="{3BADC0B2-0F94-45F6-B552-1A87FB5F996F}" dt="2022-08-19T09:47:04.794" v="563"/>
          <ac:spMkLst>
            <pc:docMk/>
            <pc:sldMk cId="2179992125" sldId="366"/>
            <ac:spMk id="2" creationId="{9453F0A9-72C5-81EE-6E79-7C53328ABF07}"/>
          </ac:spMkLst>
        </pc:spChg>
        <pc:graphicFrameChg chg="add mod">
          <ac:chgData name="Kaygisiz, Kübra" userId="4bfbf330-8776-4086-a830-2184b07ba8db" providerId="ADAL" clId="{3BADC0B2-0F94-45F6-B552-1A87FB5F996F}" dt="2022-08-19T12:40:39.663" v="954" actId="1076"/>
          <ac:graphicFrameMkLst>
            <pc:docMk/>
            <pc:sldMk cId="2179992125" sldId="366"/>
            <ac:graphicFrameMk id="3" creationId="{34CA6013-FE78-732E-013A-EA2F5C381F7A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12:41:02.092" v="956" actId="1076"/>
        <pc:sldMkLst>
          <pc:docMk/>
          <pc:sldMk cId="3819945086" sldId="367"/>
        </pc:sldMkLst>
        <pc:spChg chg="mod">
          <ac:chgData name="Kaygisiz, Kübra" userId="4bfbf330-8776-4086-a830-2184b07ba8db" providerId="ADAL" clId="{3BADC0B2-0F94-45F6-B552-1A87FB5F996F}" dt="2022-08-19T09:47:11.742" v="564"/>
          <ac:spMkLst>
            <pc:docMk/>
            <pc:sldMk cId="3819945086" sldId="367"/>
            <ac:spMk id="2" creationId="{95DF1D59-C822-2C06-51AE-F34D94598EC5}"/>
          </ac:spMkLst>
        </pc:spChg>
        <pc:graphicFrameChg chg="add mod">
          <ac:chgData name="Kaygisiz, Kübra" userId="4bfbf330-8776-4086-a830-2184b07ba8db" providerId="ADAL" clId="{3BADC0B2-0F94-45F6-B552-1A87FB5F996F}" dt="2022-08-19T12:41:02.092" v="956" actId="1076"/>
          <ac:graphicFrameMkLst>
            <pc:docMk/>
            <pc:sldMk cId="3819945086" sldId="367"/>
            <ac:graphicFrameMk id="3" creationId="{02E79350-6140-2E70-BF98-C8CC53CF03C4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1:41:19.287" v="958" actId="1076"/>
        <pc:sldMkLst>
          <pc:docMk/>
          <pc:sldMk cId="99275166" sldId="368"/>
        </pc:sldMkLst>
        <pc:spChg chg="mod">
          <ac:chgData name="Kaygisiz, Kübra" userId="4bfbf330-8776-4086-a830-2184b07ba8db" providerId="ADAL" clId="{3BADC0B2-0F94-45F6-B552-1A87FB5F996F}" dt="2022-08-19T09:47:15.768" v="565"/>
          <ac:spMkLst>
            <pc:docMk/>
            <pc:sldMk cId="99275166" sldId="368"/>
            <ac:spMk id="2" creationId="{79B5FF24-FAE8-4659-BA04-2D3C57C00B9E}"/>
          </ac:spMkLst>
        </pc:spChg>
        <pc:graphicFrameChg chg="add mod">
          <ac:chgData name="Kaygisiz, Kübra" userId="4bfbf330-8776-4086-a830-2184b07ba8db" providerId="ADAL" clId="{3BADC0B2-0F94-45F6-B552-1A87FB5F996F}" dt="2022-08-21T01:41:19.287" v="958" actId="1076"/>
          <ac:graphicFrameMkLst>
            <pc:docMk/>
            <pc:sldMk cId="99275166" sldId="368"/>
            <ac:graphicFrameMk id="3" creationId="{844304D3-F325-650B-1C82-8D40925D9CCF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2:15:45.816" v="1091" actId="1076"/>
        <pc:sldMkLst>
          <pc:docMk/>
          <pc:sldMk cId="3064084829" sldId="369"/>
        </pc:sldMkLst>
        <pc:spChg chg="mod">
          <ac:chgData name="Kaygisiz, Kübra" userId="4bfbf330-8776-4086-a830-2184b07ba8db" providerId="ADAL" clId="{3BADC0B2-0F94-45F6-B552-1A87FB5F996F}" dt="2022-08-19T09:47:19.639" v="566"/>
          <ac:spMkLst>
            <pc:docMk/>
            <pc:sldMk cId="3064084829" sldId="369"/>
            <ac:spMk id="2" creationId="{40522603-9FB2-8092-FE10-62BCD7FD7E0E}"/>
          </ac:spMkLst>
        </pc:spChg>
        <pc:graphicFrameChg chg="add mod">
          <ac:chgData name="Kaygisiz, Kübra" userId="4bfbf330-8776-4086-a830-2184b07ba8db" providerId="ADAL" clId="{3BADC0B2-0F94-45F6-B552-1A87FB5F996F}" dt="2022-08-21T02:15:45.816" v="1091" actId="1076"/>
          <ac:graphicFrameMkLst>
            <pc:docMk/>
            <pc:sldMk cId="3064084829" sldId="369"/>
            <ac:graphicFrameMk id="3" creationId="{D6D51C7B-2D55-04BB-A007-D97561FBC2A8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1:41:56.931" v="960" actId="1076"/>
        <pc:sldMkLst>
          <pc:docMk/>
          <pc:sldMk cId="608786648" sldId="370"/>
        </pc:sldMkLst>
        <pc:spChg chg="mod">
          <ac:chgData name="Kaygisiz, Kübra" userId="4bfbf330-8776-4086-a830-2184b07ba8db" providerId="ADAL" clId="{3BADC0B2-0F94-45F6-B552-1A87FB5F996F}" dt="2022-08-19T09:47:24.480" v="567"/>
          <ac:spMkLst>
            <pc:docMk/>
            <pc:sldMk cId="608786648" sldId="370"/>
            <ac:spMk id="2" creationId="{8B1AAB6E-5A54-D3BF-BB7B-FF1A5CDF814B}"/>
          </ac:spMkLst>
        </pc:spChg>
        <pc:graphicFrameChg chg="add mod">
          <ac:chgData name="Kaygisiz, Kübra" userId="4bfbf330-8776-4086-a830-2184b07ba8db" providerId="ADAL" clId="{3BADC0B2-0F94-45F6-B552-1A87FB5F996F}" dt="2022-08-21T01:41:56.931" v="960" actId="1076"/>
          <ac:graphicFrameMkLst>
            <pc:docMk/>
            <pc:sldMk cId="608786648" sldId="370"/>
            <ac:graphicFrameMk id="3" creationId="{78E836C9-EAF1-8259-EA9D-6904D78B8A3F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1:43:05.788" v="964" actId="1076"/>
        <pc:sldMkLst>
          <pc:docMk/>
          <pc:sldMk cId="1618217978" sldId="371"/>
        </pc:sldMkLst>
        <pc:spChg chg="mod">
          <ac:chgData name="Kaygisiz, Kübra" userId="4bfbf330-8776-4086-a830-2184b07ba8db" providerId="ADAL" clId="{3BADC0B2-0F94-45F6-B552-1A87FB5F996F}" dt="2022-08-19T09:47:28.577" v="568"/>
          <ac:spMkLst>
            <pc:docMk/>
            <pc:sldMk cId="1618217978" sldId="371"/>
            <ac:spMk id="2" creationId="{ECE1CDF1-BD46-31C7-063D-F0DB04D34F83}"/>
          </ac:spMkLst>
        </pc:spChg>
        <pc:graphicFrameChg chg="add mod">
          <ac:chgData name="Kaygisiz, Kübra" userId="4bfbf330-8776-4086-a830-2184b07ba8db" providerId="ADAL" clId="{3BADC0B2-0F94-45F6-B552-1A87FB5F996F}" dt="2022-08-21T01:43:05.788" v="964" actId="1076"/>
          <ac:graphicFrameMkLst>
            <pc:docMk/>
            <pc:sldMk cId="1618217978" sldId="371"/>
            <ac:graphicFrameMk id="3" creationId="{544F0FD0-C822-4E35-5291-E9D5DCF4A1D9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1:44:49.978" v="972" actId="1076"/>
        <pc:sldMkLst>
          <pc:docMk/>
          <pc:sldMk cId="2697685813" sldId="372"/>
        </pc:sldMkLst>
        <pc:spChg chg="mod">
          <ac:chgData name="Kaygisiz, Kübra" userId="4bfbf330-8776-4086-a830-2184b07ba8db" providerId="ADAL" clId="{3BADC0B2-0F94-45F6-B552-1A87FB5F996F}" dt="2022-08-19T09:47:33.945" v="569"/>
          <ac:spMkLst>
            <pc:docMk/>
            <pc:sldMk cId="2697685813" sldId="372"/>
            <ac:spMk id="2" creationId="{2338236C-BA12-0907-AB2A-FD9035F5CC75}"/>
          </ac:spMkLst>
        </pc:spChg>
        <pc:graphicFrameChg chg="add mod">
          <ac:chgData name="Kaygisiz, Kübra" userId="4bfbf330-8776-4086-a830-2184b07ba8db" providerId="ADAL" clId="{3BADC0B2-0F94-45F6-B552-1A87FB5F996F}" dt="2022-08-21T01:44:49.978" v="972" actId="1076"/>
          <ac:graphicFrameMkLst>
            <pc:docMk/>
            <pc:sldMk cId="2697685813" sldId="372"/>
            <ac:graphicFrameMk id="3" creationId="{36A20E1E-A5F5-4577-7F30-09C81507800D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2:30:25.495" v="1115" actId="1076"/>
        <pc:sldMkLst>
          <pc:docMk/>
          <pc:sldMk cId="2720200602" sldId="373"/>
        </pc:sldMkLst>
        <pc:spChg chg="mod">
          <ac:chgData name="Kaygisiz, Kübra" userId="4bfbf330-8776-4086-a830-2184b07ba8db" providerId="ADAL" clId="{3BADC0B2-0F94-45F6-B552-1A87FB5F996F}" dt="2022-08-19T09:47:38.974" v="570"/>
          <ac:spMkLst>
            <pc:docMk/>
            <pc:sldMk cId="2720200602" sldId="373"/>
            <ac:spMk id="2" creationId="{F41ABA42-5DDD-BF63-9C29-7C0761234F97}"/>
          </ac:spMkLst>
        </pc:spChg>
        <pc:graphicFrameChg chg="add mod">
          <ac:chgData name="Kaygisiz, Kübra" userId="4bfbf330-8776-4086-a830-2184b07ba8db" providerId="ADAL" clId="{3BADC0B2-0F94-45F6-B552-1A87FB5F996F}" dt="2022-08-21T02:30:25.495" v="1115" actId="1076"/>
          <ac:graphicFrameMkLst>
            <pc:docMk/>
            <pc:sldMk cId="2720200602" sldId="373"/>
            <ac:graphicFrameMk id="3" creationId="{B5A2A739-4AFA-0197-2830-E5E6CAC4BDA2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1:45:12.085" v="974" actId="1076"/>
        <pc:sldMkLst>
          <pc:docMk/>
          <pc:sldMk cId="2045961550" sldId="374"/>
        </pc:sldMkLst>
        <pc:spChg chg="mod">
          <ac:chgData name="Kaygisiz, Kübra" userId="4bfbf330-8776-4086-a830-2184b07ba8db" providerId="ADAL" clId="{3BADC0B2-0F94-45F6-B552-1A87FB5F996F}" dt="2022-08-19T09:47:45.629" v="571"/>
          <ac:spMkLst>
            <pc:docMk/>
            <pc:sldMk cId="2045961550" sldId="374"/>
            <ac:spMk id="2" creationId="{A0D16D43-DF91-AAC8-4220-FA6D1FB3E5D3}"/>
          </ac:spMkLst>
        </pc:spChg>
        <pc:graphicFrameChg chg="add mod">
          <ac:chgData name="Kaygisiz, Kübra" userId="4bfbf330-8776-4086-a830-2184b07ba8db" providerId="ADAL" clId="{3BADC0B2-0F94-45F6-B552-1A87FB5F996F}" dt="2022-08-21T01:45:12.085" v="974" actId="1076"/>
          <ac:graphicFrameMkLst>
            <pc:docMk/>
            <pc:sldMk cId="2045961550" sldId="374"/>
            <ac:graphicFrameMk id="3" creationId="{77A20623-CC0C-4E13-C1AA-484864A6B2CF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1:43:39.189" v="966" actId="1076"/>
        <pc:sldMkLst>
          <pc:docMk/>
          <pc:sldMk cId="3876734693" sldId="375"/>
        </pc:sldMkLst>
        <pc:spChg chg="mod">
          <ac:chgData name="Kaygisiz, Kübra" userId="4bfbf330-8776-4086-a830-2184b07ba8db" providerId="ADAL" clId="{3BADC0B2-0F94-45F6-B552-1A87FB5F996F}" dt="2022-08-19T09:47:51.212" v="572"/>
          <ac:spMkLst>
            <pc:docMk/>
            <pc:sldMk cId="3876734693" sldId="375"/>
            <ac:spMk id="2" creationId="{A35A9283-6A31-2502-41AB-30AC8A62434F}"/>
          </ac:spMkLst>
        </pc:spChg>
        <pc:graphicFrameChg chg="add mod">
          <ac:chgData name="Kaygisiz, Kübra" userId="4bfbf330-8776-4086-a830-2184b07ba8db" providerId="ADAL" clId="{3BADC0B2-0F94-45F6-B552-1A87FB5F996F}" dt="2022-08-21T01:43:39.189" v="966" actId="1076"/>
          <ac:graphicFrameMkLst>
            <pc:docMk/>
            <pc:sldMk cId="3876734693" sldId="375"/>
            <ac:graphicFrameMk id="3" creationId="{64A0FA0F-A10B-E0D2-2FAB-011FD06FFBD6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1:44:03.196" v="968" actId="1076"/>
        <pc:sldMkLst>
          <pc:docMk/>
          <pc:sldMk cId="1071747513" sldId="376"/>
        </pc:sldMkLst>
        <pc:spChg chg="mod">
          <ac:chgData name="Kaygisiz, Kübra" userId="4bfbf330-8776-4086-a830-2184b07ba8db" providerId="ADAL" clId="{3BADC0B2-0F94-45F6-B552-1A87FB5F996F}" dt="2022-08-19T09:47:54.851" v="573"/>
          <ac:spMkLst>
            <pc:docMk/>
            <pc:sldMk cId="1071747513" sldId="376"/>
            <ac:spMk id="2" creationId="{6663BA26-5417-FF21-FD1A-B59A82392950}"/>
          </ac:spMkLst>
        </pc:spChg>
        <pc:graphicFrameChg chg="add mod">
          <ac:chgData name="Kaygisiz, Kübra" userId="4bfbf330-8776-4086-a830-2184b07ba8db" providerId="ADAL" clId="{3BADC0B2-0F94-45F6-B552-1A87FB5F996F}" dt="2022-08-21T01:44:03.196" v="968" actId="1076"/>
          <ac:graphicFrameMkLst>
            <pc:docMk/>
            <pc:sldMk cId="1071747513" sldId="376"/>
            <ac:graphicFrameMk id="3" creationId="{1CA3F885-C939-9DD2-36DE-B0BB1D8B50BA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2:16:11.932" v="1095" actId="1076"/>
        <pc:sldMkLst>
          <pc:docMk/>
          <pc:sldMk cId="1204606270" sldId="377"/>
        </pc:sldMkLst>
        <pc:spChg chg="mod">
          <ac:chgData name="Kaygisiz, Kübra" userId="4bfbf330-8776-4086-a830-2184b07ba8db" providerId="ADAL" clId="{3BADC0B2-0F94-45F6-B552-1A87FB5F996F}" dt="2022-08-19T09:47:59.039" v="574"/>
          <ac:spMkLst>
            <pc:docMk/>
            <pc:sldMk cId="1204606270" sldId="377"/>
            <ac:spMk id="2" creationId="{82399A37-F13D-512E-2E36-02F385A21C86}"/>
          </ac:spMkLst>
        </pc:spChg>
        <pc:graphicFrameChg chg="add mod">
          <ac:chgData name="Kaygisiz, Kübra" userId="4bfbf330-8776-4086-a830-2184b07ba8db" providerId="ADAL" clId="{3BADC0B2-0F94-45F6-B552-1A87FB5F996F}" dt="2022-08-21T01:44:23.952" v="970" actId="1076"/>
          <ac:graphicFrameMkLst>
            <pc:docMk/>
            <pc:sldMk cId="1204606270" sldId="377"/>
            <ac:graphicFrameMk id="3" creationId="{B0BEDD2B-218E-4653-82F1-69486D0A2595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21T02:16:11.932" v="1095" actId="1076"/>
          <ac:graphicFrameMkLst>
            <pc:docMk/>
            <pc:sldMk cId="1204606270" sldId="377"/>
            <ac:graphicFrameMk id="4" creationId="{258F99C2-DF1C-02D9-EB9F-1FA9EA112CBA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1:50:45.132" v="1012" actId="1076"/>
        <pc:sldMkLst>
          <pc:docMk/>
          <pc:sldMk cId="179580946" sldId="378"/>
        </pc:sldMkLst>
        <pc:spChg chg="mod">
          <ac:chgData name="Kaygisiz, Kübra" userId="4bfbf330-8776-4086-a830-2184b07ba8db" providerId="ADAL" clId="{3BADC0B2-0F94-45F6-B552-1A87FB5F996F}" dt="2022-08-19T09:48:02.893" v="575"/>
          <ac:spMkLst>
            <pc:docMk/>
            <pc:sldMk cId="179580946" sldId="378"/>
            <ac:spMk id="2" creationId="{1BAF2605-17BB-20F6-EDCF-AB8A7162D77D}"/>
          </ac:spMkLst>
        </pc:spChg>
        <pc:graphicFrameChg chg="add mod">
          <ac:chgData name="Kaygisiz, Kübra" userId="4bfbf330-8776-4086-a830-2184b07ba8db" providerId="ADAL" clId="{3BADC0B2-0F94-45F6-B552-1A87FB5F996F}" dt="2022-08-21T01:50:45.132" v="1012" actId="1076"/>
          <ac:graphicFrameMkLst>
            <pc:docMk/>
            <pc:sldMk cId="179580946" sldId="378"/>
            <ac:graphicFrameMk id="3" creationId="{891FFCDD-FC19-E410-C7E8-3EBEE8B1FB90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3:03:10.304" v="1149" actId="1076"/>
        <pc:sldMkLst>
          <pc:docMk/>
          <pc:sldMk cId="2232646112" sldId="379"/>
        </pc:sldMkLst>
        <pc:spChg chg="mod">
          <ac:chgData name="Kaygisiz, Kübra" userId="4bfbf330-8776-4086-a830-2184b07ba8db" providerId="ADAL" clId="{3BADC0B2-0F94-45F6-B552-1A87FB5F996F}" dt="2022-08-19T09:48:08.091" v="576"/>
          <ac:spMkLst>
            <pc:docMk/>
            <pc:sldMk cId="2232646112" sldId="379"/>
            <ac:spMk id="2" creationId="{F9BD519B-D92F-EB59-C426-B15A671AA7A7}"/>
          </ac:spMkLst>
        </pc:spChg>
        <pc:graphicFrameChg chg="add mod">
          <ac:chgData name="Kaygisiz, Kübra" userId="4bfbf330-8776-4086-a830-2184b07ba8db" providerId="ADAL" clId="{3BADC0B2-0F94-45F6-B552-1A87FB5F996F}" dt="2022-08-21T03:03:10.304" v="1149" actId="1076"/>
          <ac:graphicFrameMkLst>
            <pc:docMk/>
            <pc:sldMk cId="2232646112" sldId="379"/>
            <ac:graphicFrameMk id="3" creationId="{EA817F66-5C01-3034-AE38-587B3250B344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1:52:04.121" v="1018" actId="1076"/>
        <pc:sldMkLst>
          <pc:docMk/>
          <pc:sldMk cId="650392294" sldId="380"/>
        </pc:sldMkLst>
        <pc:spChg chg="mod">
          <ac:chgData name="Kaygisiz, Kübra" userId="4bfbf330-8776-4086-a830-2184b07ba8db" providerId="ADAL" clId="{3BADC0B2-0F94-45F6-B552-1A87FB5F996F}" dt="2022-08-19T09:48:12.060" v="577"/>
          <ac:spMkLst>
            <pc:docMk/>
            <pc:sldMk cId="650392294" sldId="380"/>
            <ac:spMk id="2" creationId="{E6D83E22-8867-D275-38CA-6D3B5B8E8272}"/>
          </ac:spMkLst>
        </pc:spChg>
        <pc:graphicFrameChg chg="add mod">
          <ac:chgData name="Kaygisiz, Kübra" userId="4bfbf330-8776-4086-a830-2184b07ba8db" providerId="ADAL" clId="{3BADC0B2-0F94-45F6-B552-1A87FB5F996F}" dt="2022-08-21T01:52:04.121" v="1018" actId="1076"/>
          <ac:graphicFrameMkLst>
            <pc:docMk/>
            <pc:sldMk cId="650392294" sldId="380"/>
            <ac:graphicFrameMk id="3" creationId="{57E88353-FE9E-27B3-A261-59735FE0096C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3:04:02.406" v="1152" actId="1076"/>
        <pc:sldMkLst>
          <pc:docMk/>
          <pc:sldMk cId="3366987078" sldId="381"/>
        </pc:sldMkLst>
        <pc:spChg chg="mod">
          <ac:chgData name="Kaygisiz, Kübra" userId="4bfbf330-8776-4086-a830-2184b07ba8db" providerId="ADAL" clId="{3BADC0B2-0F94-45F6-B552-1A87FB5F996F}" dt="2022-08-19T09:48:16.105" v="578"/>
          <ac:spMkLst>
            <pc:docMk/>
            <pc:sldMk cId="3366987078" sldId="381"/>
            <ac:spMk id="2" creationId="{AEE60D79-B27E-769E-3D95-899A6C3BADA1}"/>
          </ac:spMkLst>
        </pc:spChg>
        <pc:graphicFrameChg chg="add mod">
          <ac:chgData name="Kaygisiz, Kübra" userId="4bfbf330-8776-4086-a830-2184b07ba8db" providerId="ADAL" clId="{3BADC0B2-0F94-45F6-B552-1A87FB5F996F}" dt="2022-08-21T03:04:02.406" v="1152" actId="1076"/>
          <ac:graphicFrameMkLst>
            <pc:docMk/>
            <pc:sldMk cId="3366987078" sldId="381"/>
            <ac:graphicFrameMk id="3" creationId="{DB4932A2-D87F-4FF0-72BA-B5B5663D43D6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3:05:04.735" v="1154" actId="1076"/>
        <pc:sldMkLst>
          <pc:docMk/>
          <pc:sldMk cId="877363637" sldId="382"/>
        </pc:sldMkLst>
        <pc:spChg chg="mod">
          <ac:chgData name="Kaygisiz, Kübra" userId="4bfbf330-8776-4086-a830-2184b07ba8db" providerId="ADAL" clId="{3BADC0B2-0F94-45F6-B552-1A87FB5F996F}" dt="2022-08-19T09:48:20.224" v="579"/>
          <ac:spMkLst>
            <pc:docMk/>
            <pc:sldMk cId="877363637" sldId="382"/>
            <ac:spMk id="2" creationId="{D0C49CAB-EDB9-B74D-9C23-F5B882CE2A9F}"/>
          </ac:spMkLst>
        </pc:spChg>
        <pc:graphicFrameChg chg="add mod">
          <ac:chgData name="Kaygisiz, Kübra" userId="4bfbf330-8776-4086-a830-2184b07ba8db" providerId="ADAL" clId="{3BADC0B2-0F94-45F6-B552-1A87FB5F996F}" dt="2022-08-21T03:05:04.735" v="1154" actId="1076"/>
          <ac:graphicFrameMkLst>
            <pc:docMk/>
            <pc:sldMk cId="877363637" sldId="382"/>
            <ac:graphicFrameMk id="3" creationId="{C062B61E-F311-C9F6-F5FC-A767C07B8AEA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3:05:59.836" v="1156" actId="1076"/>
        <pc:sldMkLst>
          <pc:docMk/>
          <pc:sldMk cId="1663590013" sldId="383"/>
        </pc:sldMkLst>
        <pc:spChg chg="mod">
          <ac:chgData name="Kaygisiz, Kübra" userId="4bfbf330-8776-4086-a830-2184b07ba8db" providerId="ADAL" clId="{3BADC0B2-0F94-45F6-B552-1A87FB5F996F}" dt="2022-08-19T09:48:26.442" v="580"/>
          <ac:spMkLst>
            <pc:docMk/>
            <pc:sldMk cId="1663590013" sldId="383"/>
            <ac:spMk id="2" creationId="{8DCF05B9-E281-F7F4-1ED4-00914D558393}"/>
          </ac:spMkLst>
        </pc:spChg>
        <pc:graphicFrameChg chg="add mod">
          <ac:chgData name="Kaygisiz, Kübra" userId="4bfbf330-8776-4086-a830-2184b07ba8db" providerId="ADAL" clId="{3BADC0B2-0F94-45F6-B552-1A87FB5F996F}" dt="2022-08-21T03:05:59.836" v="1156" actId="1076"/>
          <ac:graphicFrameMkLst>
            <pc:docMk/>
            <pc:sldMk cId="1663590013" sldId="383"/>
            <ac:graphicFrameMk id="3" creationId="{522B65F5-A242-99E5-4E9E-ADA9AFE4568D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3:07:13.368" v="1158" actId="1076"/>
        <pc:sldMkLst>
          <pc:docMk/>
          <pc:sldMk cId="2789172170" sldId="384"/>
        </pc:sldMkLst>
        <pc:spChg chg="mod">
          <ac:chgData name="Kaygisiz, Kübra" userId="4bfbf330-8776-4086-a830-2184b07ba8db" providerId="ADAL" clId="{3BADC0B2-0F94-45F6-B552-1A87FB5F996F}" dt="2022-08-19T09:48:31.076" v="581"/>
          <ac:spMkLst>
            <pc:docMk/>
            <pc:sldMk cId="2789172170" sldId="384"/>
            <ac:spMk id="2" creationId="{B0D620CB-3C16-523F-ED21-010C3ACD39D4}"/>
          </ac:spMkLst>
        </pc:spChg>
        <pc:graphicFrameChg chg="add mod">
          <ac:chgData name="Kaygisiz, Kübra" userId="4bfbf330-8776-4086-a830-2184b07ba8db" providerId="ADAL" clId="{3BADC0B2-0F94-45F6-B552-1A87FB5F996F}" dt="2022-08-21T03:07:13.368" v="1158" actId="1076"/>
          <ac:graphicFrameMkLst>
            <pc:docMk/>
            <pc:sldMk cId="2789172170" sldId="384"/>
            <ac:graphicFrameMk id="3" creationId="{CFD261DB-423E-7172-9C1E-2A43428F2B59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1:51:12.792" v="1014" actId="1076"/>
        <pc:sldMkLst>
          <pc:docMk/>
          <pc:sldMk cId="91761761" sldId="385"/>
        </pc:sldMkLst>
        <pc:spChg chg="mod">
          <ac:chgData name="Kaygisiz, Kübra" userId="4bfbf330-8776-4086-a830-2184b07ba8db" providerId="ADAL" clId="{3BADC0B2-0F94-45F6-B552-1A87FB5F996F}" dt="2022-08-19T09:48:35.928" v="582"/>
          <ac:spMkLst>
            <pc:docMk/>
            <pc:sldMk cId="91761761" sldId="385"/>
            <ac:spMk id="2" creationId="{77ED208D-9EE0-E282-955B-851A95934128}"/>
          </ac:spMkLst>
        </pc:spChg>
        <pc:graphicFrameChg chg="add mod">
          <ac:chgData name="Kaygisiz, Kübra" userId="4bfbf330-8776-4086-a830-2184b07ba8db" providerId="ADAL" clId="{3BADC0B2-0F94-45F6-B552-1A87FB5F996F}" dt="2022-08-21T01:51:12.792" v="1014" actId="1076"/>
          <ac:graphicFrameMkLst>
            <pc:docMk/>
            <pc:sldMk cId="91761761" sldId="385"/>
            <ac:graphicFrameMk id="3" creationId="{DE89D620-5FB9-1FD3-E385-258096F551A3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1:51:33.970" v="1016" actId="1076"/>
        <pc:sldMkLst>
          <pc:docMk/>
          <pc:sldMk cId="2552790150" sldId="386"/>
        </pc:sldMkLst>
        <pc:spChg chg="mod">
          <ac:chgData name="Kaygisiz, Kübra" userId="4bfbf330-8776-4086-a830-2184b07ba8db" providerId="ADAL" clId="{3BADC0B2-0F94-45F6-B552-1A87FB5F996F}" dt="2022-08-19T09:48:39.805" v="583"/>
          <ac:spMkLst>
            <pc:docMk/>
            <pc:sldMk cId="2552790150" sldId="386"/>
            <ac:spMk id="2" creationId="{3BBF4FC8-3646-12D9-6085-CDDFD8A17817}"/>
          </ac:spMkLst>
        </pc:spChg>
        <pc:graphicFrameChg chg="add mod">
          <ac:chgData name="Kaygisiz, Kübra" userId="4bfbf330-8776-4086-a830-2184b07ba8db" providerId="ADAL" clId="{3BADC0B2-0F94-45F6-B552-1A87FB5F996F}" dt="2022-08-21T01:51:33.970" v="1016" actId="1076"/>
          <ac:graphicFrameMkLst>
            <pc:docMk/>
            <pc:sldMk cId="2552790150" sldId="386"/>
            <ac:graphicFrameMk id="3" creationId="{84B26D40-9601-1BDE-57B1-8A0F44D2AE75}"/>
          </ac:graphicFrameMkLst>
        </pc:graphicFrameChg>
      </pc:sldChg>
      <pc:sldChg chg="modSp new mod">
        <pc:chgData name="Kaygisiz, Kübra" userId="4bfbf330-8776-4086-a830-2184b07ba8db" providerId="ADAL" clId="{3BADC0B2-0F94-45F6-B552-1A87FB5F996F}" dt="2022-08-19T09:48:45.191" v="584"/>
        <pc:sldMkLst>
          <pc:docMk/>
          <pc:sldMk cId="1009842015" sldId="387"/>
        </pc:sldMkLst>
        <pc:spChg chg="mod">
          <ac:chgData name="Kaygisiz, Kübra" userId="4bfbf330-8776-4086-a830-2184b07ba8db" providerId="ADAL" clId="{3BADC0B2-0F94-45F6-B552-1A87FB5F996F}" dt="2022-08-19T09:48:45.191" v="584"/>
          <ac:spMkLst>
            <pc:docMk/>
            <pc:sldMk cId="1009842015" sldId="387"/>
            <ac:spMk id="2" creationId="{4C779838-84F4-60C2-D1DA-0B620D9B1F6B}"/>
          </ac:spMkLst>
        </pc:spChg>
      </pc:sldChg>
      <pc:sldChg chg="addSp modSp new mod">
        <pc:chgData name="Kaygisiz, Kübra" userId="4bfbf330-8776-4086-a830-2184b07ba8db" providerId="ADAL" clId="{3BADC0B2-0F94-45F6-B552-1A87FB5F996F}" dt="2022-08-21T02:16:53.304" v="1097" actId="1076"/>
        <pc:sldMkLst>
          <pc:docMk/>
          <pc:sldMk cId="3305633320" sldId="388"/>
        </pc:sldMkLst>
        <pc:spChg chg="mod">
          <ac:chgData name="Kaygisiz, Kübra" userId="4bfbf330-8776-4086-a830-2184b07ba8db" providerId="ADAL" clId="{3BADC0B2-0F94-45F6-B552-1A87FB5F996F}" dt="2022-08-19T09:48:52.166" v="585"/>
          <ac:spMkLst>
            <pc:docMk/>
            <pc:sldMk cId="3305633320" sldId="388"/>
            <ac:spMk id="2" creationId="{E50C20F9-1A35-EB44-55FD-68B3B5635BCD}"/>
          </ac:spMkLst>
        </pc:spChg>
        <pc:graphicFrameChg chg="add mod">
          <ac:chgData name="Kaygisiz, Kübra" userId="4bfbf330-8776-4086-a830-2184b07ba8db" providerId="ADAL" clId="{3BADC0B2-0F94-45F6-B552-1A87FB5F996F}" dt="2022-08-21T02:16:53.304" v="1097" actId="1076"/>
          <ac:graphicFrameMkLst>
            <pc:docMk/>
            <pc:sldMk cId="3305633320" sldId="388"/>
            <ac:graphicFrameMk id="3" creationId="{9E7ECDA4-524A-D2D3-92A7-2DDB41D39F6F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1:52:28.754" v="1020" actId="1076"/>
        <pc:sldMkLst>
          <pc:docMk/>
          <pc:sldMk cId="2885565990" sldId="389"/>
        </pc:sldMkLst>
        <pc:spChg chg="mod">
          <ac:chgData name="Kaygisiz, Kübra" userId="4bfbf330-8776-4086-a830-2184b07ba8db" providerId="ADAL" clId="{3BADC0B2-0F94-45F6-B552-1A87FB5F996F}" dt="2022-08-19T09:48:56.292" v="586"/>
          <ac:spMkLst>
            <pc:docMk/>
            <pc:sldMk cId="2885565990" sldId="389"/>
            <ac:spMk id="2" creationId="{49921DAA-2F28-A87E-C501-00C5F8204D06}"/>
          </ac:spMkLst>
        </pc:spChg>
        <pc:graphicFrameChg chg="add mod">
          <ac:chgData name="Kaygisiz, Kübra" userId="4bfbf330-8776-4086-a830-2184b07ba8db" providerId="ADAL" clId="{3BADC0B2-0F94-45F6-B552-1A87FB5F996F}" dt="2022-08-21T01:52:28.754" v="1020" actId="1076"/>
          <ac:graphicFrameMkLst>
            <pc:docMk/>
            <pc:sldMk cId="2885565990" sldId="389"/>
            <ac:graphicFrameMk id="3" creationId="{59EC98DB-20A4-D94C-338A-4A1B01856946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3:08:32.008" v="1160" actId="1076"/>
        <pc:sldMkLst>
          <pc:docMk/>
          <pc:sldMk cId="1439394317" sldId="390"/>
        </pc:sldMkLst>
        <pc:spChg chg="mod">
          <ac:chgData name="Kaygisiz, Kübra" userId="4bfbf330-8776-4086-a830-2184b07ba8db" providerId="ADAL" clId="{3BADC0B2-0F94-45F6-B552-1A87FB5F996F}" dt="2022-08-19T09:49:00.915" v="587"/>
          <ac:spMkLst>
            <pc:docMk/>
            <pc:sldMk cId="1439394317" sldId="390"/>
            <ac:spMk id="2" creationId="{418C371E-826D-7601-23D3-5D073B69B5C5}"/>
          </ac:spMkLst>
        </pc:spChg>
        <pc:graphicFrameChg chg="add mod">
          <ac:chgData name="Kaygisiz, Kübra" userId="4bfbf330-8776-4086-a830-2184b07ba8db" providerId="ADAL" clId="{3BADC0B2-0F94-45F6-B552-1A87FB5F996F}" dt="2022-08-21T03:08:32.008" v="1160" actId="1076"/>
          <ac:graphicFrameMkLst>
            <pc:docMk/>
            <pc:sldMk cId="1439394317" sldId="390"/>
            <ac:graphicFrameMk id="3" creationId="{0A7A2E6D-B4A7-DF08-1381-F9DCCD41C00B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1:52:51.629" v="1022" actId="1076"/>
        <pc:sldMkLst>
          <pc:docMk/>
          <pc:sldMk cId="2225765529" sldId="391"/>
        </pc:sldMkLst>
        <pc:spChg chg="mod">
          <ac:chgData name="Kaygisiz, Kübra" userId="4bfbf330-8776-4086-a830-2184b07ba8db" providerId="ADAL" clId="{3BADC0B2-0F94-45F6-B552-1A87FB5F996F}" dt="2022-08-19T09:49:05.060" v="588"/>
          <ac:spMkLst>
            <pc:docMk/>
            <pc:sldMk cId="2225765529" sldId="391"/>
            <ac:spMk id="2" creationId="{2C2A87CB-CDDB-F1DD-18B6-A0492CF047D1}"/>
          </ac:spMkLst>
        </pc:spChg>
        <pc:graphicFrameChg chg="add mod">
          <ac:chgData name="Kaygisiz, Kübra" userId="4bfbf330-8776-4086-a830-2184b07ba8db" providerId="ADAL" clId="{3BADC0B2-0F94-45F6-B552-1A87FB5F996F}" dt="2022-08-21T01:52:51.629" v="1022" actId="1076"/>
          <ac:graphicFrameMkLst>
            <pc:docMk/>
            <pc:sldMk cId="2225765529" sldId="391"/>
            <ac:graphicFrameMk id="3" creationId="{B913EE11-DAAA-9446-B043-753A912757C7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2:18:07.342" v="1099" actId="1076"/>
        <pc:sldMkLst>
          <pc:docMk/>
          <pc:sldMk cId="1879692678" sldId="392"/>
        </pc:sldMkLst>
        <pc:spChg chg="mod">
          <ac:chgData name="Kaygisiz, Kübra" userId="4bfbf330-8776-4086-a830-2184b07ba8db" providerId="ADAL" clId="{3BADC0B2-0F94-45F6-B552-1A87FB5F996F}" dt="2022-08-19T09:49:11.447" v="589"/>
          <ac:spMkLst>
            <pc:docMk/>
            <pc:sldMk cId="1879692678" sldId="392"/>
            <ac:spMk id="2" creationId="{B01533F7-9A5D-F51D-CA9A-744F12A475BC}"/>
          </ac:spMkLst>
        </pc:spChg>
        <pc:graphicFrameChg chg="add mod">
          <ac:chgData name="Kaygisiz, Kübra" userId="4bfbf330-8776-4086-a830-2184b07ba8db" providerId="ADAL" clId="{3BADC0B2-0F94-45F6-B552-1A87FB5F996F}" dt="2022-08-21T02:18:07.342" v="1099" actId="1076"/>
          <ac:graphicFrameMkLst>
            <pc:docMk/>
            <pc:sldMk cId="1879692678" sldId="392"/>
            <ac:graphicFrameMk id="3" creationId="{EA6DFFF4-2426-97B9-F0FD-96C07A919AE9}"/>
          </ac:graphicFrameMkLst>
        </pc:graphicFrameChg>
      </pc:sldChg>
      <pc:sldChg chg="modSp new mod">
        <pc:chgData name="Kaygisiz, Kübra" userId="4bfbf330-8776-4086-a830-2184b07ba8db" providerId="ADAL" clId="{3BADC0B2-0F94-45F6-B552-1A87FB5F996F}" dt="2022-08-19T09:49:17.466" v="590"/>
        <pc:sldMkLst>
          <pc:docMk/>
          <pc:sldMk cId="3771467310" sldId="393"/>
        </pc:sldMkLst>
        <pc:spChg chg="mod">
          <ac:chgData name="Kaygisiz, Kübra" userId="4bfbf330-8776-4086-a830-2184b07ba8db" providerId="ADAL" clId="{3BADC0B2-0F94-45F6-B552-1A87FB5F996F}" dt="2022-08-19T09:49:17.466" v="590"/>
          <ac:spMkLst>
            <pc:docMk/>
            <pc:sldMk cId="3771467310" sldId="393"/>
            <ac:spMk id="2" creationId="{9DD6514E-26B5-21E3-2893-E5AE61E4F869}"/>
          </ac:spMkLst>
        </pc:spChg>
      </pc:sldChg>
      <pc:sldChg chg="modSp new mod">
        <pc:chgData name="Kaygisiz, Kübra" userId="4bfbf330-8776-4086-a830-2184b07ba8db" providerId="ADAL" clId="{3BADC0B2-0F94-45F6-B552-1A87FB5F996F}" dt="2022-08-19T09:49:24.444" v="591"/>
        <pc:sldMkLst>
          <pc:docMk/>
          <pc:sldMk cId="568242235" sldId="394"/>
        </pc:sldMkLst>
        <pc:spChg chg="mod">
          <ac:chgData name="Kaygisiz, Kübra" userId="4bfbf330-8776-4086-a830-2184b07ba8db" providerId="ADAL" clId="{3BADC0B2-0F94-45F6-B552-1A87FB5F996F}" dt="2022-08-19T09:49:24.444" v="591"/>
          <ac:spMkLst>
            <pc:docMk/>
            <pc:sldMk cId="568242235" sldId="394"/>
            <ac:spMk id="2" creationId="{BAB22CE7-CB51-9A19-319D-41CB7EDA9B82}"/>
          </ac:spMkLst>
        </pc:spChg>
      </pc:sldChg>
      <pc:sldChg chg="addSp modSp new mod">
        <pc:chgData name="Kaygisiz, Kübra" userId="4bfbf330-8776-4086-a830-2184b07ba8db" providerId="ADAL" clId="{3BADC0B2-0F94-45F6-B552-1A87FB5F996F}" dt="2022-08-21T01:54:26.016" v="1026" actId="1076"/>
        <pc:sldMkLst>
          <pc:docMk/>
          <pc:sldMk cId="3571392797" sldId="395"/>
        </pc:sldMkLst>
        <pc:spChg chg="mod">
          <ac:chgData name="Kaygisiz, Kübra" userId="4bfbf330-8776-4086-a830-2184b07ba8db" providerId="ADAL" clId="{3BADC0B2-0F94-45F6-B552-1A87FB5F996F}" dt="2022-08-19T09:49:28.092" v="592"/>
          <ac:spMkLst>
            <pc:docMk/>
            <pc:sldMk cId="3571392797" sldId="395"/>
            <ac:spMk id="2" creationId="{4462E833-2C66-6669-1F62-4061ED3B8989}"/>
          </ac:spMkLst>
        </pc:spChg>
        <pc:graphicFrameChg chg="add mod">
          <ac:chgData name="Kaygisiz, Kübra" userId="4bfbf330-8776-4086-a830-2184b07ba8db" providerId="ADAL" clId="{3BADC0B2-0F94-45F6-B552-1A87FB5F996F}" dt="2022-08-21T01:54:26.016" v="1026" actId="1076"/>
          <ac:graphicFrameMkLst>
            <pc:docMk/>
            <pc:sldMk cId="3571392797" sldId="395"/>
            <ac:graphicFrameMk id="3" creationId="{B4D0657C-087E-6B4A-8944-61889931F23D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1:54:58.321" v="1028" actId="1076"/>
        <pc:sldMkLst>
          <pc:docMk/>
          <pc:sldMk cId="4203967550" sldId="396"/>
        </pc:sldMkLst>
        <pc:spChg chg="mod">
          <ac:chgData name="Kaygisiz, Kübra" userId="4bfbf330-8776-4086-a830-2184b07ba8db" providerId="ADAL" clId="{3BADC0B2-0F94-45F6-B552-1A87FB5F996F}" dt="2022-08-19T09:49:32.759" v="593"/>
          <ac:spMkLst>
            <pc:docMk/>
            <pc:sldMk cId="4203967550" sldId="396"/>
            <ac:spMk id="2" creationId="{84480783-B6C6-24D3-CDDC-7C009BA4F9A5}"/>
          </ac:spMkLst>
        </pc:spChg>
        <pc:graphicFrameChg chg="add mod">
          <ac:chgData name="Kaygisiz, Kübra" userId="4bfbf330-8776-4086-a830-2184b07ba8db" providerId="ADAL" clId="{3BADC0B2-0F94-45F6-B552-1A87FB5F996F}" dt="2022-08-21T01:54:58.321" v="1028" actId="1076"/>
          <ac:graphicFrameMkLst>
            <pc:docMk/>
            <pc:sldMk cId="4203967550" sldId="396"/>
            <ac:graphicFrameMk id="3" creationId="{5DE79435-6D3D-6A21-29F8-7AF8F96E19A0}"/>
          </ac:graphicFrameMkLst>
        </pc:graphicFrameChg>
      </pc:sldChg>
      <pc:sldChg chg="modSp new mod">
        <pc:chgData name="Kaygisiz, Kübra" userId="4bfbf330-8776-4086-a830-2184b07ba8db" providerId="ADAL" clId="{3BADC0B2-0F94-45F6-B552-1A87FB5F996F}" dt="2022-08-19T09:49:36.468" v="594"/>
        <pc:sldMkLst>
          <pc:docMk/>
          <pc:sldMk cId="1386297517" sldId="397"/>
        </pc:sldMkLst>
        <pc:spChg chg="mod">
          <ac:chgData name="Kaygisiz, Kübra" userId="4bfbf330-8776-4086-a830-2184b07ba8db" providerId="ADAL" clId="{3BADC0B2-0F94-45F6-B552-1A87FB5F996F}" dt="2022-08-19T09:49:36.468" v="594"/>
          <ac:spMkLst>
            <pc:docMk/>
            <pc:sldMk cId="1386297517" sldId="397"/>
            <ac:spMk id="2" creationId="{56449612-40E1-2038-408E-B43170A2BF2D}"/>
          </ac:spMkLst>
        </pc:spChg>
      </pc:sldChg>
      <pc:sldChg chg="addSp modSp new mod">
        <pc:chgData name="Kaygisiz, Kübra" userId="4bfbf330-8776-4086-a830-2184b07ba8db" providerId="ADAL" clId="{3BADC0B2-0F94-45F6-B552-1A87FB5F996F}" dt="2022-08-21T01:57:20.665" v="1038" actId="1076"/>
        <pc:sldMkLst>
          <pc:docMk/>
          <pc:sldMk cId="2902756814" sldId="398"/>
        </pc:sldMkLst>
        <pc:spChg chg="mod">
          <ac:chgData name="Kaygisiz, Kübra" userId="4bfbf330-8776-4086-a830-2184b07ba8db" providerId="ADAL" clId="{3BADC0B2-0F94-45F6-B552-1A87FB5F996F}" dt="2022-08-19T09:49:42.719" v="595"/>
          <ac:spMkLst>
            <pc:docMk/>
            <pc:sldMk cId="2902756814" sldId="398"/>
            <ac:spMk id="2" creationId="{8E02C8AF-5395-BF65-9D4A-6608A263998B}"/>
          </ac:spMkLst>
        </pc:spChg>
        <pc:graphicFrameChg chg="add mod">
          <ac:chgData name="Kaygisiz, Kübra" userId="4bfbf330-8776-4086-a830-2184b07ba8db" providerId="ADAL" clId="{3BADC0B2-0F94-45F6-B552-1A87FB5F996F}" dt="2022-08-21T01:57:20.665" v="1038" actId="1076"/>
          <ac:graphicFrameMkLst>
            <pc:docMk/>
            <pc:sldMk cId="2902756814" sldId="398"/>
            <ac:graphicFrameMk id="3" creationId="{074DBB06-E4B9-AF80-E55D-88FB5C6705E0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1:57:44.473" v="1040" actId="1076"/>
        <pc:sldMkLst>
          <pc:docMk/>
          <pc:sldMk cId="3428080603" sldId="399"/>
        </pc:sldMkLst>
        <pc:spChg chg="mod">
          <ac:chgData name="Kaygisiz, Kübra" userId="4bfbf330-8776-4086-a830-2184b07ba8db" providerId="ADAL" clId="{3BADC0B2-0F94-45F6-B552-1A87FB5F996F}" dt="2022-08-19T09:49:47.075" v="596"/>
          <ac:spMkLst>
            <pc:docMk/>
            <pc:sldMk cId="3428080603" sldId="399"/>
            <ac:spMk id="2" creationId="{6A104055-9CB6-CC03-45B4-7649E2D20214}"/>
          </ac:spMkLst>
        </pc:spChg>
        <pc:graphicFrameChg chg="add mod">
          <ac:chgData name="Kaygisiz, Kübra" userId="4bfbf330-8776-4086-a830-2184b07ba8db" providerId="ADAL" clId="{3BADC0B2-0F94-45F6-B552-1A87FB5F996F}" dt="2022-08-21T01:57:44.473" v="1040" actId="1076"/>
          <ac:graphicFrameMkLst>
            <pc:docMk/>
            <pc:sldMk cId="3428080603" sldId="399"/>
            <ac:graphicFrameMk id="3" creationId="{4FBEC474-0885-3690-80F8-5533C07827FD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2:31:25.955" v="1117" actId="1076"/>
        <pc:sldMkLst>
          <pc:docMk/>
          <pc:sldMk cId="2483818101" sldId="400"/>
        </pc:sldMkLst>
        <pc:spChg chg="mod">
          <ac:chgData name="Kaygisiz, Kübra" userId="4bfbf330-8776-4086-a830-2184b07ba8db" providerId="ADAL" clId="{3BADC0B2-0F94-45F6-B552-1A87FB5F996F}" dt="2022-08-19T09:49:51.402" v="597"/>
          <ac:spMkLst>
            <pc:docMk/>
            <pc:sldMk cId="2483818101" sldId="400"/>
            <ac:spMk id="2" creationId="{91380799-5A0E-6C70-5583-36520C3D5428}"/>
          </ac:spMkLst>
        </pc:spChg>
        <pc:graphicFrameChg chg="add mod">
          <ac:chgData name="Kaygisiz, Kübra" userId="4bfbf330-8776-4086-a830-2184b07ba8db" providerId="ADAL" clId="{3BADC0B2-0F94-45F6-B552-1A87FB5F996F}" dt="2022-08-21T02:31:25.955" v="1117" actId="1076"/>
          <ac:graphicFrameMkLst>
            <pc:docMk/>
            <pc:sldMk cId="2483818101" sldId="400"/>
            <ac:graphicFrameMk id="3" creationId="{99B228AE-CEA1-A369-4FCB-F7C54FC42472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1:58:14.035" v="1042" actId="1076"/>
        <pc:sldMkLst>
          <pc:docMk/>
          <pc:sldMk cId="2164342502" sldId="401"/>
        </pc:sldMkLst>
        <pc:spChg chg="mod">
          <ac:chgData name="Kaygisiz, Kübra" userId="4bfbf330-8776-4086-a830-2184b07ba8db" providerId="ADAL" clId="{3BADC0B2-0F94-45F6-B552-1A87FB5F996F}" dt="2022-08-19T09:49:55.399" v="598"/>
          <ac:spMkLst>
            <pc:docMk/>
            <pc:sldMk cId="2164342502" sldId="401"/>
            <ac:spMk id="2" creationId="{F80AC8C1-82D6-AE20-1632-A57F7C3E21C9}"/>
          </ac:spMkLst>
        </pc:spChg>
        <pc:graphicFrameChg chg="add mod">
          <ac:chgData name="Kaygisiz, Kübra" userId="4bfbf330-8776-4086-a830-2184b07ba8db" providerId="ADAL" clId="{3BADC0B2-0F94-45F6-B552-1A87FB5F996F}" dt="2022-08-21T01:58:14.035" v="1042" actId="1076"/>
          <ac:graphicFrameMkLst>
            <pc:docMk/>
            <pc:sldMk cId="2164342502" sldId="401"/>
            <ac:graphicFrameMk id="3" creationId="{C63EA86D-206A-2C0A-2C92-4C6F015F0EAC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1:55:26.589" v="1030" actId="1076"/>
        <pc:sldMkLst>
          <pc:docMk/>
          <pc:sldMk cId="220549203" sldId="402"/>
        </pc:sldMkLst>
        <pc:spChg chg="mod">
          <ac:chgData name="Kaygisiz, Kübra" userId="4bfbf330-8776-4086-a830-2184b07ba8db" providerId="ADAL" clId="{3BADC0B2-0F94-45F6-B552-1A87FB5F996F}" dt="2022-08-19T09:49:59.470" v="599"/>
          <ac:spMkLst>
            <pc:docMk/>
            <pc:sldMk cId="220549203" sldId="402"/>
            <ac:spMk id="2" creationId="{FC7CDDA8-D968-85F7-C499-43DDC8E3377D}"/>
          </ac:spMkLst>
        </pc:spChg>
        <pc:graphicFrameChg chg="add mod">
          <ac:chgData name="Kaygisiz, Kübra" userId="4bfbf330-8776-4086-a830-2184b07ba8db" providerId="ADAL" clId="{3BADC0B2-0F94-45F6-B552-1A87FB5F996F}" dt="2022-08-21T01:55:26.589" v="1030" actId="1076"/>
          <ac:graphicFrameMkLst>
            <pc:docMk/>
            <pc:sldMk cId="220549203" sldId="402"/>
            <ac:graphicFrameMk id="3" creationId="{EDE97483-4388-EF7B-2635-4768B6EEC813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1:55:52.384" v="1032" actId="1076"/>
        <pc:sldMkLst>
          <pc:docMk/>
          <pc:sldMk cId="1372757893" sldId="403"/>
        </pc:sldMkLst>
        <pc:spChg chg="mod">
          <ac:chgData name="Kaygisiz, Kübra" userId="4bfbf330-8776-4086-a830-2184b07ba8db" providerId="ADAL" clId="{3BADC0B2-0F94-45F6-B552-1A87FB5F996F}" dt="2022-08-19T09:50:03.496" v="600"/>
          <ac:spMkLst>
            <pc:docMk/>
            <pc:sldMk cId="1372757893" sldId="403"/>
            <ac:spMk id="2" creationId="{A0DC1A4F-CE8A-B5F1-0E68-8C42E9E1BD3F}"/>
          </ac:spMkLst>
        </pc:spChg>
        <pc:graphicFrameChg chg="add mod">
          <ac:chgData name="Kaygisiz, Kübra" userId="4bfbf330-8776-4086-a830-2184b07ba8db" providerId="ADAL" clId="{3BADC0B2-0F94-45F6-B552-1A87FB5F996F}" dt="2022-08-21T01:55:52.384" v="1032" actId="1076"/>
          <ac:graphicFrameMkLst>
            <pc:docMk/>
            <pc:sldMk cId="1372757893" sldId="403"/>
            <ac:graphicFrameMk id="3" creationId="{3952C9D8-6493-1656-FDD6-F4C0B56FE2FF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2:31:47.139" v="1119" actId="1076"/>
        <pc:sldMkLst>
          <pc:docMk/>
          <pc:sldMk cId="3039709633" sldId="404"/>
        </pc:sldMkLst>
        <pc:spChg chg="mod">
          <ac:chgData name="Kaygisiz, Kübra" userId="4bfbf330-8776-4086-a830-2184b07ba8db" providerId="ADAL" clId="{3BADC0B2-0F94-45F6-B552-1A87FB5F996F}" dt="2022-08-19T09:50:08.168" v="601"/>
          <ac:spMkLst>
            <pc:docMk/>
            <pc:sldMk cId="3039709633" sldId="404"/>
            <ac:spMk id="2" creationId="{17B6A907-4FCD-8219-3E5A-AB0981709351}"/>
          </ac:spMkLst>
        </pc:spChg>
        <pc:graphicFrameChg chg="add mod">
          <ac:chgData name="Kaygisiz, Kübra" userId="4bfbf330-8776-4086-a830-2184b07ba8db" providerId="ADAL" clId="{3BADC0B2-0F94-45F6-B552-1A87FB5F996F}" dt="2022-08-21T02:31:47.139" v="1119" actId="1076"/>
          <ac:graphicFrameMkLst>
            <pc:docMk/>
            <pc:sldMk cId="3039709633" sldId="404"/>
            <ac:graphicFrameMk id="3" creationId="{3111138B-7B5A-AD6F-0BF9-E333504E4C4A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1:56:22.536" v="1034" actId="1076"/>
        <pc:sldMkLst>
          <pc:docMk/>
          <pc:sldMk cId="3064510982" sldId="405"/>
        </pc:sldMkLst>
        <pc:spChg chg="mod">
          <ac:chgData name="Kaygisiz, Kübra" userId="4bfbf330-8776-4086-a830-2184b07ba8db" providerId="ADAL" clId="{3BADC0B2-0F94-45F6-B552-1A87FB5F996F}" dt="2022-08-19T09:50:11.892" v="602"/>
          <ac:spMkLst>
            <pc:docMk/>
            <pc:sldMk cId="3064510982" sldId="405"/>
            <ac:spMk id="2" creationId="{2A2A00DC-C296-183F-BD66-6DD4771267E4}"/>
          </ac:spMkLst>
        </pc:spChg>
        <pc:graphicFrameChg chg="add mod">
          <ac:chgData name="Kaygisiz, Kübra" userId="4bfbf330-8776-4086-a830-2184b07ba8db" providerId="ADAL" clId="{3BADC0B2-0F94-45F6-B552-1A87FB5F996F}" dt="2022-08-21T01:56:22.536" v="1034" actId="1076"/>
          <ac:graphicFrameMkLst>
            <pc:docMk/>
            <pc:sldMk cId="3064510982" sldId="405"/>
            <ac:graphicFrameMk id="3" creationId="{B7A416EB-DA32-F35B-FAE1-8B7B2C2D65A1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1:56:46.953" v="1036" actId="1076"/>
        <pc:sldMkLst>
          <pc:docMk/>
          <pc:sldMk cId="1041487721" sldId="406"/>
        </pc:sldMkLst>
        <pc:spChg chg="mod">
          <ac:chgData name="Kaygisiz, Kübra" userId="4bfbf330-8776-4086-a830-2184b07ba8db" providerId="ADAL" clId="{3BADC0B2-0F94-45F6-B552-1A87FB5F996F}" dt="2022-08-19T09:50:16.097" v="603"/>
          <ac:spMkLst>
            <pc:docMk/>
            <pc:sldMk cId="1041487721" sldId="406"/>
            <ac:spMk id="2" creationId="{9FD20186-4210-533F-DCE2-D282DDCA7D9B}"/>
          </ac:spMkLst>
        </pc:spChg>
        <pc:graphicFrameChg chg="add mod">
          <ac:chgData name="Kaygisiz, Kübra" userId="4bfbf330-8776-4086-a830-2184b07ba8db" providerId="ADAL" clId="{3BADC0B2-0F94-45F6-B552-1A87FB5F996F}" dt="2022-08-21T01:56:46.953" v="1036" actId="1076"/>
          <ac:graphicFrameMkLst>
            <pc:docMk/>
            <pc:sldMk cId="1041487721" sldId="406"/>
            <ac:graphicFrameMk id="3" creationId="{D2D8CB2A-1B50-1E1A-78A0-2AC32A4A20EA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1:59:08.495" v="1046" actId="1076"/>
        <pc:sldMkLst>
          <pc:docMk/>
          <pc:sldMk cId="3794329460" sldId="407"/>
        </pc:sldMkLst>
        <pc:spChg chg="mod">
          <ac:chgData name="Kaygisiz, Kübra" userId="4bfbf330-8776-4086-a830-2184b07ba8db" providerId="ADAL" clId="{3BADC0B2-0F94-45F6-B552-1A87FB5F996F}" dt="2022-08-19T09:50:22.685" v="604"/>
          <ac:spMkLst>
            <pc:docMk/>
            <pc:sldMk cId="3794329460" sldId="407"/>
            <ac:spMk id="2" creationId="{D16A0658-DD67-44CE-5FAB-E7405C7F3A48}"/>
          </ac:spMkLst>
        </pc:spChg>
        <pc:graphicFrameChg chg="add mod">
          <ac:chgData name="Kaygisiz, Kübra" userId="4bfbf330-8776-4086-a830-2184b07ba8db" providerId="ADAL" clId="{3BADC0B2-0F94-45F6-B552-1A87FB5F996F}" dt="2022-08-21T01:59:08.495" v="1046" actId="1076"/>
          <ac:graphicFrameMkLst>
            <pc:docMk/>
            <pc:sldMk cId="3794329460" sldId="407"/>
            <ac:graphicFrameMk id="3" creationId="{43CB897F-B96E-41F8-FAB5-199719FA9E06}"/>
          </ac:graphicFrameMkLst>
        </pc:graphicFrameChg>
      </pc:sldChg>
      <pc:sldChg chg="modSp new mod">
        <pc:chgData name="Kaygisiz, Kübra" userId="4bfbf330-8776-4086-a830-2184b07ba8db" providerId="ADAL" clId="{3BADC0B2-0F94-45F6-B552-1A87FB5F996F}" dt="2022-08-19T09:50:35.292" v="605"/>
        <pc:sldMkLst>
          <pc:docMk/>
          <pc:sldMk cId="1395803242" sldId="408"/>
        </pc:sldMkLst>
        <pc:spChg chg="mod">
          <ac:chgData name="Kaygisiz, Kübra" userId="4bfbf330-8776-4086-a830-2184b07ba8db" providerId="ADAL" clId="{3BADC0B2-0F94-45F6-B552-1A87FB5F996F}" dt="2022-08-19T09:50:35.292" v="605"/>
          <ac:spMkLst>
            <pc:docMk/>
            <pc:sldMk cId="1395803242" sldId="408"/>
            <ac:spMk id="2" creationId="{D5119683-79AD-5566-1A95-09240BB28841}"/>
          </ac:spMkLst>
        </pc:spChg>
      </pc:sldChg>
      <pc:sldChg chg="modSp new mod">
        <pc:chgData name="Kaygisiz, Kübra" userId="4bfbf330-8776-4086-a830-2184b07ba8db" providerId="ADAL" clId="{3BADC0B2-0F94-45F6-B552-1A87FB5F996F}" dt="2022-08-19T09:50:40.112" v="606"/>
        <pc:sldMkLst>
          <pc:docMk/>
          <pc:sldMk cId="3238007092" sldId="409"/>
        </pc:sldMkLst>
        <pc:spChg chg="mod">
          <ac:chgData name="Kaygisiz, Kübra" userId="4bfbf330-8776-4086-a830-2184b07ba8db" providerId="ADAL" clId="{3BADC0B2-0F94-45F6-B552-1A87FB5F996F}" dt="2022-08-19T09:50:40.112" v="606"/>
          <ac:spMkLst>
            <pc:docMk/>
            <pc:sldMk cId="3238007092" sldId="409"/>
            <ac:spMk id="2" creationId="{8262F4E8-27AA-2140-5C05-B820CD44D375}"/>
          </ac:spMkLst>
        </pc:spChg>
      </pc:sldChg>
      <pc:sldChg chg="addSp modSp new mod">
        <pc:chgData name="Kaygisiz, Kübra" userId="4bfbf330-8776-4086-a830-2184b07ba8db" providerId="ADAL" clId="{3BADC0B2-0F94-45F6-B552-1A87FB5F996F}" dt="2022-08-21T02:05:34.774" v="1069" actId="1076"/>
        <pc:sldMkLst>
          <pc:docMk/>
          <pc:sldMk cId="3677518539" sldId="410"/>
        </pc:sldMkLst>
        <pc:spChg chg="mod">
          <ac:chgData name="Kaygisiz, Kübra" userId="4bfbf330-8776-4086-a830-2184b07ba8db" providerId="ADAL" clId="{3BADC0B2-0F94-45F6-B552-1A87FB5F996F}" dt="2022-08-19T09:50:44.176" v="607"/>
          <ac:spMkLst>
            <pc:docMk/>
            <pc:sldMk cId="3677518539" sldId="410"/>
            <ac:spMk id="2" creationId="{2A2DBF8E-0C3F-896B-15A8-161AFF6C1ECE}"/>
          </ac:spMkLst>
        </pc:spChg>
        <pc:graphicFrameChg chg="add mod">
          <ac:chgData name="Kaygisiz, Kübra" userId="4bfbf330-8776-4086-a830-2184b07ba8db" providerId="ADAL" clId="{3BADC0B2-0F94-45F6-B552-1A87FB5F996F}" dt="2022-08-21T02:05:34.774" v="1069" actId="1076"/>
          <ac:graphicFrameMkLst>
            <pc:docMk/>
            <pc:sldMk cId="3677518539" sldId="410"/>
            <ac:graphicFrameMk id="3" creationId="{F9CD9DB5-5E4C-7C63-AB56-DD79895E2667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2:05:03.825" v="1067" actId="1076"/>
        <pc:sldMkLst>
          <pc:docMk/>
          <pc:sldMk cId="804652707" sldId="411"/>
        </pc:sldMkLst>
        <pc:spChg chg="mod">
          <ac:chgData name="Kaygisiz, Kübra" userId="4bfbf330-8776-4086-a830-2184b07ba8db" providerId="ADAL" clId="{3BADC0B2-0F94-45F6-B552-1A87FB5F996F}" dt="2022-08-19T09:50:49.528" v="608"/>
          <ac:spMkLst>
            <pc:docMk/>
            <pc:sldMk cId="804652707" sldId="411"/>
            <ac:spMk id="2" creationId="{1967B3F5-6FE0-2BE1-A45C-8D794580D15F}"/>
          </ac:spMkLst>
        </pc:spChg>
        <pc:graphicFrameChg chg="add mod">
          <ac:chgData name="Kaygisiz, Kübra" userId="4bfbf330-8776-4086-a830-2184b07ba8db" providerId="ADAL" clId="{3BADC0B2-0F94-45F6-B552-1A87FB5F996F}" dt="2022-08-21T02:05:03.825" v="1067" actId="1076"/>
          <ac:graphicFrameMkLst>
            <pc:docMk/>
            <pc:sldMk cId="804652707" sldId="411"/>
            <ac:graphicFrameMk id="3" creationId="{D529E586-8632-F65E-57C0-C6AE906A5116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1:59:39.754" v="1048" actId="1076"/>
        <pc:sldMkLst>
          <pc:docMk/>
          <pc:sldMk cId="854743519" sldId="412"/>
        </pc:sldMkLst>
        <pc:spChg chg="mod">
          <ac:chgData name="Kaygisiz, Kübra" userId="4bfbf330-8776-4086-a830-2184b07ba8db" providerId="ADAL" clId="{3BADC0B2-0F94-45F6-B552-1A87FB5F996F}" dt="2022-08-19T09:50:53.855" v="609"/>
          <ac:spMkLst>
            <pc:docMk/>
            <pc:sldMk cId="854743519" sldId="412"/>
            <ac:spMk id="2" creationId="{6949E26B-3AA8-407A-1D0F-04844A2482ED}"/>
          </ac:spMkLst>
        </pc:spChg>
        <pc:graphicFrameChg chg="add mod">
          <ac:chgData name="Kaygisiz, Kübra" userId="4bfbf330-8776-4086-a830-2184b07ba8db" providerId="ADAL" clId="{3BADC0B2-0F94-45F6-B552-1A87FB5F996F}" dt="2022-08-21T01:59:39.754" v="1048" actId="1076"/>
          <ac:graphicFrameMkLst>
            <pc:docMk/>
            <pc:sldMk cId="854743519" sldId="412"/>
            <ac:graphicFrameMk id="3" creationId="{2DD6D308-ED15-9A3C-2FA9-56F5792154BF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2:00:13.762" v="1050" actId="1076"/>
        <pc:sldMkLst>
          <pc:docMk/>
          <pc:sldMk cId="1488576310" sldId="413"/>
        </pc:sldMkLst>
        <pc:spChg chg="mod">
          <ac:chgData name="Kaygisiz, Kübra" userId="4bfbf330-8776-4086-a830-2184b07ba8db" providerId="ADAL" clId="{3BADC0B2-0F94-45F6-B552-1A87FB5F996F}" dt="2022-08-19T09:50:58.220" v="610"/>
          <ac:spMkLst>
            <pc:docMk/>
            <pc:sldMk cId="1488576310" sldId="413"/>
            <ac:spMk id="2" creationId="{CF1469C6-3CD3-7599-D1E8-8322EC3B377C}"/>
          </ac:spMkLst>
        </pc:spChg>
        <pc:graphicFrameChg chg="add mod">
          <ac:chgData name="Kaygisiz, Kübra" userId="4bfbf330-8776-4086-a830-2184b07ba8db" providerId="ADAL" clId="{3BADC0B2-0F94-45F6-B552-1A87FB5F996F}" dt="2022-08-21T02:00:13.762" v="1050" actId="1076"/>
          <ac:graphicFrameMkLst>
            <pc:docMk/>
            <pc:sldMk cId="1488576310" sldId="413"/>
            <ac:graphicFrameMk id="3" creationId="{B23640F9-7EF4-E510-45DC-4BC9840FADEE}"/>
          </ac:graphicFrameMkLst>
        </pc:graphicFrameChg>
      </pc:sldChg>
      <pc:sldChg chg="modSp new mod">
        <pc:chgData name="Kaygisiz, Kübra" userId="4bfbf330-8776-4086-a830-2184b07ba8db" providerId="ADAL" clId="{3BADC0B2-0F94-45F6-B552-1A87FB5F996F}" dt="2022-08-19T09:51:02.339" v="611"/>
        <pc:sldMkLst>
          <pc:docMk/>
          <pc:sldMk cId="796462839" sldId="414"/>
        </pc:sldMkLst>
        <pc:spChg chg="mod">
          <ac:chgData name="Kaygisiz, Kübra" userId="4bfbf330-8776-4086-a830-2184b07ba8db" providerId="ADAL" clId="{3BADC0B2-0F94-45F6-B552-1A87FB5F996F}" dt="2022-08-19T09:51:02.339" v="611"/>
          <ac:spMkLst>
            <pc:docMk/>
            <pc:sldMk cId="796462839" sldId="414"/>
            <ac:spMk id="2" creationId="{981698BF-AA44-7363-C31B-35154E146D5F}"/>
          </ac:spMkLst>
        </pc:spChg>
      </pc:sldChg>
      <pc:sldChg chg="addSp modSp new mod">
        <pc:chgData name="Kaygisiz, Kübra" userId="4bfbf330-8776-4086-a830-2184b07ba8db" providerId="ADAL" clId="{3BADC0B2-0F94-45F6-B552-1A87FB5F996F}" dt="2022-08-21T02:52:21.770" v="1135" actId="1076"/>
        <pc:sldMkLst>
          <pc:docMk/>
          <pc:sldMk cId="2699220586" sldId="415"/>
        </pc:sldMkLst>
        <pc:spChg chg="mod">
          <ac:chgData name="Kaygisiz, Kübra" userId="4bfbf330-8776-4086-a830-2184b07ba8db" providerId="ADAL" clId="{3BADC0B2-0F94-45F6-B552-1A87FB5F996F}" dt="2022-08-19T09:51:09.868" v="612"/>
          <ac:spMkLst>
            <pc:docMk/>
            <pc:sldMk cId="2699220586" sldId="415"/>
            <ac:spMk id="2" creationId="{D1FA3238-C1F5-AFC3-DA4B-FB738AD05EB6}"/>
          </ac:spMkLst>
        </pc:spChg>
        <pc:graphicFrameChg chg="add mod">
          <ac:chgData name="Kaygisiz, Kübra" userId="4bfbf330-8776-4086-a830-2184b07ba8db" providerId="ADAL" clId="{3BADC0B2-0F94-45F6-B552-1A87FB5F996F}" dt="2022-08-21T02:52:21.770" v="1135" actId="1076"/>
          <ac:graphicFrameMkLst>
            <pc:docMk/>
            <pc:sldMk cId="2699220586" sldId="415"/>
            <ac:graphicFrameMk id="3" creationId="{C2014162-15DB-DD15-BF60-C1AF2C4993D2}"/>
          </ac:graphicFrameMkLst>
        </pc:graphicFrameChg>
      </pc:sldChg>
      <pc:sldChg chg="modSp new mod">
        <pc:chgData name="Kaygisiz, Kübra" userId="4bfbf330-8776-4086-a830-2184b07ba8db" providerId="ADAL" clId="{3BADC0B2-0F94-45F6-B552-1A87FB5F996F}" dt="2022-08-19T09:51:15.226" v="613"/>
        <pc:sldMkLst>
          <pc:docMk/>
          <pc:sldMk cId="3455880494" sldId="416"/>
        </pc:sldMkLst>
        <pc:spChg chg="mod">
          <ac:chgData name="Kaygisiz, Kübra" userId="4bfbf330-8776-4086-a830-2184b07ba8db" providerId="ADAL" clId="{3BADC0B2-0F94-45F6-B552-1A87FB5F996F}" dt="2022-08-19T09:51:15.226" v="613"/>
          <ac:spMkLst>
            <pc:docMk/>
            <pc:sldMk cId="3455880494" sldId="416"/>
            <ac:spMk id="2" creationId="{21072D23-BE09-34C1-6BC1-7D4E38F6E6F9}"/>
          </ac:spMkLst>
        </pc:spChg>
      </pc:sldChg>
      <pc:sldChg chg="modSp new mod">
        <pc:chgData name="Kaygisiz, Kübra" userId="4bfbf330-8776-4086-a830-2184b07ba8db" providerId="ADAL" clId="{3BADC0B2-0F94-45F6-B552-1A87FB5F996F}" dt="2022-08-19T09:51:19.271" v="614"/>
        <pc:sldMkLst>
          <pc:docMk/>
          <pc:sldMk cId="2550044285" sldId="417"/>
        </pc:sldMkLst>
        <pc:spChg chg="mod">
          <ac:chgData name="Kaygisiz, Kübra" userId="4bfbf330-8776-4086-a830-2184b07ba8db" providerId="ADAL" clId="{3BADC0B2-0F94-45F6-B552-1A87FB5F996F}" dt="2022-08-19T09:51:19.271" v="614"/>
          <ac:spMkLst>
            <pc:docMk/>
            <pc:sldMk cId="2550044285" sldId="417"/>
            <ac:spMk id="2" creationId="{07BE5C8C-5DC2-604A-184F-4EDF859F937B}"/>
          </ac:spMkLst>
        </pc:spChg>
      </pc:sldChg>
      <pc:sldChg chg="addSp modSp new mod">
        <pc:chgData name="Kaygisiz, Kübra" userId="4bfbf330-8776-4086-a830-2184b07ba8db" providerId="ADAL" clId="{3BADC0B2-0F94-45F6-B552-1A87FB5F996F}" dt="2022-08-21T03:01:41.602" v="1147" actId="1076"/>
        <pc:sldMkLst>
          <pc:docMk/>
          <pc:sldMk cId="4289956802" sldId="418"/>
        </pc:sldMkLst>
        <pc:spChg chg="mod">
          <ac:chgData name="Kaygisiz, Kübra" userId="4bfbf330-8776-4086-a830-2184b07ba8db" providerId="ADAL" clId="{3BADC0B2-0F94-45F6-B552-1A87FB5F996F}" dt="2022-08-19T09:51:23.981" v="615"/>
          <ac:spMkLst>
            <pc:docMk/>
            <pc:sldMk cId="4289956802" sldId="418"/>
            <ac:spMk id="2" creationId="{B0B146AB-DB09-FB9F-10E3-6CA148029108}"/>
          </ac:spMkLst>
        </pc:spChg>
        <pc:graphicFrameChg chg="add mod">
          <ac:chgData name="Kaygisiz, Kübra" userId="4bfbf330-8776-4086-a830-2184b07ba8db" providerId="ADAL" clId="{3BADC0B2-0F94-45F6-B552-1A87FB5F996F}" dt="2022-08-21T02:25:59.257" v="1107" actId="1076"/>
          <ac:graphicFrameMkLst>
            <pc:docMk/>
            <pc:sldMk cId="4289956802" sldId="418"/>
            <ac:graphicFrameMk id="3" creationId="{22BFD98D-3717-02BF-6374-133686BE88A8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21T03:01:41.602" v="1147" actId="1076"/>
          <ac:graphicFrameMkLst>
            <pc:docMk/>
            <pc:sldMk cId="4289956802" sldId="418"/>
            <ac:graphicFrameMk id="4" creationId="{170F60C6-6486-AC94-6FAE-D9B8310CF46F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3:18:45.263" v="1176" actId="1076"/>
        <pc:sldMkLst>
          <pc:docMk/>
          <pc:sldMk cId="1741208271" sldId="419"/>
        </pc:sldMkLst>
        <pc:spChg chg="mod">
          <ac:chgData name="Kaygisiz, Kübra" userId="4bfbf330-8776-4086-a830-2184b07ba8db" providerId="ADAL" clId="{3BADC0B2-0F94-45F6-B552-1A87FB5F996F}" dt="2022-08-19T09:51:28.190" v="616"/>
          <ac:spMkLst>
            <pc:docMk/>
            <pc:sldMk cId="1741208271" sldId="419"/>
            <ac:spMk id="2" creationId="{2B0C7067-FE34-2B4D-82EF-E4747A23F173}"/>
          </ac:spMkLst>
        </pc:spChg>
        <pc:graphicFrameChg chg="add mod">
          <ac:chgData name="Kaygisiz, Kübra" userId="4bfbf330-8776-4086-a830-2184b07ba8db" providerId="ADAL" clId="{3BADC0B2-0F94-45F6-B552-1A87FB5F996F}" dt="2022-08-21T02:06:06.576" v="1071" actId="1076"/>
          <ac:graphicFrameMkLst>
            <pc:docMk/>
            <pc:sldMk cId="1741208271" sldId="419"/>
            <ac:graphicFrameMk id="3" creationId="{231EEBE4-BBF1-F679-3753-A53B86A81FF8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21T03:18:45.263" v="1176" actId="1076"/>
          <ac:graphicFrameMkLst>
            <pc:docMk/>
            <pc:sldMk cId="1741208271" sldId="419"/>
            <ac:graphicFrameMk id="4" creationId="{182781EC-194F-937C-FC35-D6CAAF58102D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3:16:34.825" v="1170" actId="1076"/>
        <pc:sldMkLst>
          <pc:docMk/>
          <pc:sldMk cId="2786292224" sldId="420"/>
        </pc:sldMkLst>
        <pc:spChg chg="mod">
          <ac:chgData name="Kaygisiz, Kübra" userId="4bfbf330-8776-4086-a830-2184b07ba8db" providerId="ADAL" clId="{3BADC0B2-0F94-45F6-B552-1A87FB5F996F}" dt="2022-08-19T09:51:35.254" v="617"/>
          <ac:spMkLst>
            <pc:docMk/>
            <pc:sldMk cId="2786292224" sldId="420"/>
            <ac:spMk id="2" creationId="{E3BD801D-92B1-620E-AA9F-A644E2381DC7}"/>
          </ac:spMkLst>
        </pc:spChg>
        <pc:graphicFrameChg chg="add mod">
          <ac:chgData name="Kaygisiz, Kübra" userId="4bfbf330-8776-4086-a830-2184b07ba8db" providerId="ADAL" clId="{3BADC0B2-0F94-45F6-B552-1A87FB5F996F}" dt="2022-08-21T02:06:32.390" v="1073" actId="1076"/>
          <ac:graphicFrameMkLst>
            <pc:docMk/>
            <pc:sldMk cId="2786292224" sldId="420"/>
            <ac:graphicFrameMk id="3" creationId="{05412847-F446-0153-DE88-15797C000936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21T03:16:34.825" v="1170" actId="1076"/>
          <ac:graphicFrameMkLst>
            <pc:docMk/>
            <pc:sldMk cId="2786292224" sldId="420"/>
            <ac:graphicFrameMk id="4" creationId="{6CE28A81-AB07-D21D-EA01-DF85C6F43F52}"/>
          </ac:graphicFrameMkLst>
        </pc:graphicFrameChg>
      </pc:sldChg>
      <pc:sldChg chg="modSp new mod">
        <pc:chgData name="Kaygisiz, Kübra" userId="4bfbf330-8776-4086-a830-2184b07ba8db" providerId="ADAL" clId="{3BADC0B2-0F94-45F6-B552-1A87FB5F996F}" dt="2022-08-19T09:51:38.667" v="618"/>
        <pc:sldMkLst>
          <pc:docMk/>
          <pc:sldMk cId="3932385421" sldId="421"/>
        </pc:sldMkLst>
        <pc:spChg chg="mod">
          <ac:chgData name="Kaygisiz, Kübra" userId="4bfbf330-8776-4086-a830-2184b07ba8db" providerId="ADAL" clId="{3BADC0B2-0F94-45F6-B552-1A87FB5F996F}" dt="2022-08-19T09:51:38.667" v="618"/>
          <ac:spMkLst>
            <pc:docMk/>
            <pc:sldMk cId="3932385421" sldId="421"/>
            <ac:spMk id="2" creationId="{9F97D59F-2B08-52EA-0E5F-556312C3C311}"/>
          </ac:spMkLst>
        </pc:spChg>
      </pc:sldChg>
      <pc:sldChg chg="addSp modSp new mod">
        <pc:chgData name="Kaygisiz, Kübra" userId="4bfbf330-8776-4086-a830-2184b07ba8db" providerId="ADAL" clId="{3BADC0B2-0F94-45F6-B552-1A87FB5F996F}" dt="2022-08-21T02:25:23.436" v="1105" actId="1076"/>
        <pc:sldMkLst>
          <pc:docMk/>
          <pc:sldMk cId="999979765" sldId="422"/>
        </pc:sldMkLst>
        <pc:spChg chg="mod">
          <ac:chgData name="Kaygisiz, Kübra" userId="4bfbf330-8776-4086-a830-2184b07ba8db" providerId="ADAL" clId="{3BADC0B2-0F94-45F6-B552-1A87FB5F996F}" dt="2022-08-19T09:51:42.196" v="619"/>
          <ac:spMkLst>
            <pc:docMk/>
            <pc:sldMk cId="999979765" sldId="422"/>
            <ac:spMk id="2" creationId="{1898BD58-58B9-88F4-C1C9-F274077A3823}"/>
          </ac:spMkLst>
        </pc:spChg>
        <pc:graphicFrameChg chg="add mod">
          <ac:chgData name="Kaygisiz, Kübra" userId="4bfbf330-8776-4086-a830-2184b07ba8db" providerId="ADAL" clId="{3BADC0B2-0F94-45F6-B552-1A87FB5F996F}" dt="2022-08-21T02:25:23.436" v="1105" actId="1076"/>
          <ac:graphicFrameMkLst>
            <pc:docMk/>
            <pc:sldMk cId="999979765" sldId="422"/>
            <ac:graphicFrameMk id="3" creationId="{1C0CE87B-1C75-A424-1DFC-EFF138135508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2:18:34.336" v="1101" actId="1076"/>
        <pc:sldMkLst>
          <pc:docMk/>
          <pc:sldMk cId="2776356415" sldId="423"/>
        </pc:sldMkLst>
        <pc:spChg chg="mod">
          <ac:chgData name="Kaygisiz, Kübra" userId="4bfbf330-8776-4086-a830-2184b07ba8db" providerId="ADAL" clId="{3BADC0B2-0F94-45F6-B552-1A87FB5F996F}" dt="2022-08-19T09:51:46.973" v="620"/>
          <ac:spMkLst>
            <pc:docMk/>
            <pc:sldMk cId="2776356415" sldId="423"/>
            <ac:spMk id="2" creationId="{DB46BEEE-F6DE-5369-B1B2-829E1B032151}"/>
          </ac:spMkLst>
        </pc:spChg>
        <pc:graphicFrameChg chg="add mod">
          <ac:chgData name="Kaygisiz, Kübra" userId="4bfbf330-8776-4086-a830-2184b07ba8db" providerId="ADAL" clId="{3BADC0B2-0F94-45F6-B552-1A87FB5F996F}" dt="2022-08-21T02:18:34.336" v="1101" actId="1076"/>
          <ac:graphicFrameMkLst>
            <pc:docMk/>
            <pc:sldMk cId="2776356415" sldId="423"/>
            <ac:graphicFrameMk id="3" creationId="{276E0151-DA7F-34A0-031D-9596DBCDD66B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2:00:37.313" v="1052" actId="1076"/>
        <pc:sldMkLst>
          <pc:docMk/>
          <pc:sldMk cId="3655847628" sldId="424"/>
        </pc:sldMkLst>
        <pc:spChg chg="mod">
          <ac:chgData name="Kaygisiz, Kübra" userId="4bfbf330-8776-4086-a830-2184b07ba8db" providerId="ADAL" clId="{3BADC0B2-0F94-45F6-B552-1A87FB5F996F}" dt="2022-08-19T09:51:50.556" v="621"/>
          <ac:spMkLst>
            <pc:docMk/>
            <pc:sldMk cId="3655847628" sldId="424"/>
            <ac:spMk id="2" creationId="{544F3577-7D6D-545B-DFA3-4CF2A3FC86CC}"/>
          </ac:spMkLst>
        </pc:spChg>
        <pc:graphicFrameChg chg="add mod">
          <ac:chgData name="Kaygisiz, Kübra" userId="4bfbf330-8776-4086-a830-2184b07ba8db" providerId="ADAL" clId="{3BADC0B2-0F94-45F6-B552-1A87FB5F996F}" dt="2022-08-21T02:00:37.313" v="1052" actId="1076"/>
          <ac:graphicFrameMkLst>
            <pc:docMk/>
            <pc:sldMk cId="3655847628" sldId="424"/>
            <ac:graphicFrameMk id="3" creationId="{BD801BB6-9E62-F43C-4F8D-7E7BDC7543B9}"/>
          </ac:graphicFrameMkLst>
        </pc:graphicFrameChg>
      </pc:sldChg>
      <pc:sldChg chg="modSp new mod">
        <pc:chgData name="Kaygisiz, Kübra" userId="4bfbf330-8776-4086-a830-2184b07ba8db" providerId="ADAL" clId="{3BADC0B2-0F94-45F6-B552-1A87FB5F996F}" dt="2022-08-19T09:51:55.965" v="622"/>
        <pc:sldMkLst>
          <pc:docMk/>
          <pc:sldMk cId="2275618644" sldId="425"/>
        </pc:sldMkLst>
        <pc:spChg chg="mod">
          <ac:chgData name="Kaygisiz, Kübra" userId="4bfbf330-8776-4086-a830-2184b07ba8db" providerId="ADAL" clId="{3BADC0B2-0F94-45F6-B552-1A87FB5F996F}" dt="2022-08-19T09:51:55.965" v="622"/>
          <ac:spMkLst>
            <pc:docMk/>
            <pc:sldMk cId="2275618644" sldId="425"/>
            <ac:spMk id="2" creationId="{3E1AE083-138F-4740-E6E5-4D2C59707161}"/>
          </ac:spMkLst>
        </pc:spChg>
      </pc:sldChg>
      <pc:sldChg chg="addSp modSp new mod">
        <pc:chgData name="Kaygisiz, Kübra" userId="4bfbf330-8776-4086-a830-2184b07ba8db" providerId="ADAL" clId="{3BADC0B2-0F94-45F6-B552-1A87FB5F996F}" dt="2022-08-21T02:00:57.567" v="1054" actId="1076"/>
        <pc:sldMkLst>
          <pc:docMk/>
          <pc:sldMk cId="3143404012" sldId="426"/>
        </pc:sldMkLst>
        <pc:spChg chg="mod">
          <ac:chgData name="Kaygisiz, Kübra" userId="4bfbf330-8776-4086-a830-2184b07ba8db" providerId="ADAL" clId="{3BADC0B2-0F94-45F6-B552-1A87FB5F996F}" dt="2022-08-19T09:52:00.162" v="623"/>
          <ac:spMkLst>
            <pc:docMk/>
            <pc:sldMk cId="3143404012" sldId="426"/>
            <ac:spMk id="2" creationId="{8C78CD2B-BB3F-6A09-FF78-229CE6E88F54}"/>
          </ac:spMkLst>
        </pc:spChg>
        <pc:graphicFrameChg chg="add mod">
          <ac:chgData name="Kaygisiz, Kübra" userId="4bfbf330-8776-4086-a830-2184b07ba8db" providerId="ADAL" clId="{3BADC0B2-0F94-45F6-B552-1A87FB5F996F}" dt="2022-08-21T02:00:57.567" v="1054" actId="1076"/>
          <ac:graphicFrameMkLst>
            <pc:docMk/>
            <pc:sldMk cId="3143404012" sldId="426"/>
            <ac:graphicFrameMk id="3" creationId="{DEE38030-69E7-A57D-56BA-A36EA40E188E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2:24:59.141" v="1103" actId="1076"/>
        <pc:sldMkLst>
          <pc:docMk/>
          <pc:sldMk cId="633915184" sldId="427"/>
        </pc:sldMkLst>
        <pc:spChg chg="mod">
          <ac:chgData name="Kaygisiz, Kübra" userId="4bfbf330-8776-4086-a830-2184b07ba8db" providerId="ADAL" clId="{3BADC0B2-0F94-45F6-B552-1A87FB5F996F}" dt="2022-08-19T09:52:03.950" v="624"/>
          <ac:spMkLst>
            <pc:docMk/>
            <pc:sldMk cId="633915184" sldId="427"/>
            <ac:spMk id="2" creationId="{F904775E-9E53-8081-181F-D2D26BC5A203}"/>
          </ac:spMkLst>
        </pc:spChg>
        <pc:graphicFrameChg chg="add mod">
          <ac:chgData name="Kaygisiz, Kübra" userId="4bfbf330-8776-4086-a830-2184b07ba8db" providerId="ADAL" clId="{3BADC0B2-0F94-45F6-B552-1A87FB5F996F}" dt="2022-08-21T02:24:59.141" v="1103" actId="1076"/>
          <ac:graphicFrameMkLst>
            <pc:docMk/>
            <pc:sldMk cId="633915184" sldId="427"/>
            <ac:graphicFrameMk id="3" creationId="{8F4313D6-A6A9-E28C-B52A-DDEE7B35CC3B}"/>
          </ac:graphicFrameMkLst>
        </pc:graphicFrameChg>
      </pc:sldChg>
      <pc:sldChg chg="modSp new mod">
        <pc:chgData name="Kaygisiz, Kübra" userId="4bfbf330-8776-4086-a830-2184b07ba8db" providerId="ADAL" clId="{3BADC0B2-0F94-45F6-B552-1A87FB5F996F}" dt="2022-08-19T09:52:25.992" v="647"/>
        <pc:sldMkLst>
          <pc:docMk/>
          <pc:sldMk cId="2438697961" sldId="428"/>
        </pc:sldMkLst>
        <pc:spChg chg="mod">
          <ac:chgData name="Kaygisiz, Kübra" userId="4bfbf330-8776-4086-a830-2184b07ba8db" providerId="ADAL" clId="{3BADC0B2-0F94-45F6-B552-1A87FB5F996F}" dt="2022-08-19T09:52:25.992" v="647"/>
          <ac:spMkLst>
            <pc:docMk/>
            <pc:sldMk cId="2438697961" sldId="428"/>
            <ac:spMk id="2" creationId="{739449C8-95D2-999F-663F-F096E19ED092}"/>
          </ac:spMkLst>
        </pc:spChg>
      </pc:sldChg>
      <pc:sldChg chg="addSp modSp new mod">
        <pc:chgData name="Kaygisiz, Kübra" userId="4bfbf330-8776-4086-a830-2184b07ba8db" providerId="ADAL" clId="{3BADC0B2-0F94-45F6-B552-1A87FB5F996F}" dt="2022-08-21T02:01:25.357" v="1056" actId="1076"/>
        <pc:sldMkLst>
          <pc:docMk/>
          <pc:sldMk cId="739058583" sldId="429"/>
        </pc:sldMkLst>
        <pc:spChg chg="mod">
          <ac:chgData name="Kaygisiz, Kübra" userId="4bfbf330-8776-4086-a830-2184b07ba8db" providerId="ADAL" clId="{3BADC0B2-0F94-45F6-B552-1A87FB5F996F}" dt="2022-08-19T09:52:29.700" v="648"/>
          <ac:spMkLst>
            <pc:docMk/>
            <pc:sldMk cId="739058583" sldId="429"/>
            <ac:spMk id="2" creationId="{51AE8ED6-515C-4B96-1080-3751D20DF469}"/>
          </ac:spMkLst>
        </pc:spChg>
        <pc:graphicFrameChg chg="add mod">
          <ac:chgData name="Kaygisiz, Kübra" userId="4bfbf330-8776-4086-a830-2184b07ba8db" providerId="ADAL" clId="{3BADC0B2-0F94-45F6-B552-1A87FB5F996F}" dt="2022-08-21T02:01:25.357" v="1056" actId="1076"/>
          <ac:graphicFrameMkLst>
            <pc:docMk/>
            <pc:sldMk cId="739058583" sldId="429"/>
            <ac:graphicFrameMk id="3" creationId="{96EDA655-9F65-D140-1380-974BB84AF5B2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2:03:10.530" v="1058" actId="1076"/>
        <pc:sldMkLst>
          <pc:docMk/>
          <pc:sldMk cId="3924494893" sldId="430"/>
        </pc:sldMkLst>
        <pc:spChg chg="mod">
          <ac:chgData name="Kaygisiz, Kübra" userId="4bfbf330-8776-4086-a830-2184b07ba8db" providerId="ADAL" clId="{3BADC0B2-0F94-45F6-B552-1A87FB5F996F}" dt="2022-08-19T09:53:38.053" v="649"/>
          <ac:spMkLst>
            <pc:docMk/>
            <pc:sldMk cId="3924494893" sldId="430"/>
            <ac:spMk id="2" creationId="{39098DFB-C356-ED90-BC63-9DD83699BAD8}"/>
          </ac:spMkLst>
        </pc:spChg>
        <pc:graphicFrameChg chg="add mod">
          <ac:chgData name="Kaygisiz, Kübra" userId="4bfbf330-8776-4086-a830-2184b07ba8db" providerId="ADAL" clId="{3BADC0B2-0F94-45F6-B552-1A87FB5F996F}" dt="2022-08-21T02:03:10.530" v="1058" actId="1076"/>
          <ac:graphicFrameMkLst>
            <pc:docMk/>
            <pc:sldMk cId="3924494893" sldId="430"/>
            <ac:graphicFrameMk id="3" creationId="{C50FABB3-A87B-5BF8-73C3-47096F5A8E88}"/>
          </ac:graphicFrameMkLst>
        </pc:graphicFrameChg>
      </pc:sldChg>
      <pc:sldChg chg="modSp new mod">
        <pc:chgData name="Kaygisiz, Kübra" userId="4bfbf330-8776-4086-a830-2184b07ba8db" providerId="ADAL" clId="{3BADC0B2-0F94-45F6-B552-1A87FB5F996F}" dt="2022-08-19T09:53:45.242" v="650"/>
        <pc:sldMkLst>
          <pc:docMk/>
          <pc:sldMk cId="2416058671" sldId="431"/>
        </pc:sldMkLst>
        <pc:spChg chg="mod">
          <ac:chgData name="Kaygisiz, Kübra" userId="4bfbf330-8776-4086-a830-2184b07ba8db" providerId="ADAL" clId="{3BADC0B2-0F94-45F6-B552-1A87FB5F996F}" dt="2022-08-19T09:53:45.242" v="650"/>
          <ac:spMkLst>
            <pc:docMk/>
            <pc:sldMk cId="2416058671" sldId="431"/>
            <ac:spMk id="2" creationId="{BAA70016-4523-5FC2-06B8-ECAB468B7B94}"/>
          </ac:spMkLst>
        </pc:spChg>
      </pc:sldChg>
      <pc:sldChg chg="modSp new mod">
        <pc:chgData name="Kaygisiz, Kübra" userId="4bfbf330-8776-4086-a830-2184b07ba8db" providerId="ADAL" clId="{3BADC0B2-0F94-45F6-B552-1A87FB5F996F}" dt="2022-08-19T09:53:50.971" v="651"/>
        <pc:sldMkLst>
          <pc:docMk/>
          <pc:sldMk cId="2607142310" sldId="432"/>
        </pc:sldMkLst>
        <pc:spChg chg="mod">
          <ac:chgData name="Kaygisiz, Kübra" userId="4bfbf330-8776-4086-a830-2184b07ba8db" providerId="ADAL" clId="{3BADC0B2-0F94-45F6-B552-1A87FB5F996F}" dt="2022-08-19T09:53:50.971" v="651"/>
          <ac:spMkLst>
            <pc:docMk/>
            <pc:sldMk cId="2607142310" sldId="432"/>
            <ac:spMk id="2" creationId="{A080FF24-2047-7B28-38B0-654A22B4B051}"/>
          </ac:spMkLst>
        </pc:spChg>
      </pc:sldChg>
      <pc:sldChg chg="addSp modSp new mod">
        <pc:chgData name="Kaygisiz, Kübra" userId="4bfbf330-8776-4086-a830-2184b07ba8db" providerId="ADAL" clId="{3BADC0B2-0F94-45F6-B552-1A87FB5F996F}" dt="2022-08-21T02:03:30.376" v="1060" actId="1076"/>
        <pc:sldMkLst>
          <pc:docMk/>
          <pc:sldMk cId="2202585896" sldId="433"/>
        </pc:sldMkLst>
        <pc:spChg chg="mod">
          <ac:chgData name="Kaygisiz, Kübra" userId="4bfbf330-8776-4086-a830-2184b07ba8db" providerId="ADAL" clId="{3BADC0B2-0F94-45F6-B552-1A87FB5F996F}" dt="2022-08-19T09:53:55.793" v="652"/>
          <ac:spMkLst>
            <pc:docMk/>
            <pc:sldMk cId="2202585896" sldId="433"/>
            <ac:spMk id="2" creationId="{B9A227C2-D5B6-AADB-A884-C779E5BC1457}"/>
          </ac:spMkLst>
        </pc:spChg>
        <pc:graphicFrameChg chg="add mod">
          <ac:chgData name="Kaygisiz, Kübra" userId="4bfbf330-8776-4086-a830-2184b07ba8db" providerId="ADAL" clId="{3BADC0B2-0F94-45F6-B552-1A87FB5F996F}" dt="2022-08-21T02:03:30.376" v="1060" actId="1076"/>
          <ac:graphicFrameMkLst>
            <pc:docMk/>
            <pc:sldMk cId="2202585896" sldId="433"/>
            <ac:graphicFrameMk id="3" creationId="{941D8568-CC43-6603-922A-8A58170911E7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1:58:37.358" v="1044" actId="1076"/>
        <pc:sldMkLst>
          <pc:docMk/>
          <pc:sldMk cId="2237347613" sldId="434"/>
        </pc:sldMkLst>
        <pc:spChg chg="mod">
          <ac:chgData name="Kaygisiz, Kübra" userId="4bfbf330-8776-4086-a830-2184b07ba8db" providerId="ADAL" clId="{3BADC0B2-0F94-45F6-B552-1A87FB5F996F}" dt="2022-08-19T09:54:03.336" v="653"/>
          <ac:spMkLst>
            <pc:docMk/>
            <pc:sldMk cId="2237347613" sldId="434"/>
            <ac:spMk id="2" creationId="{68A57469-0686-5762-049F-8E267C6142E5}"/>
          </ac:spMkLst>
        </pc:spChg>
        <pc:graphicFrameChg chg="add mod">
          <ac:chgData name="Kaygisiz, Kübra" userId="4bfbf330-8776-4086-a830-2184b07ba8db" providerId="ADAL" clId="{3BADC0B2-0F94-45F6-B552-1A87FB5F996F}" dt="2022-08-21T01:58:37.358" v="1044" actId="1076"/>
          <ac:graphicFrameMkLst>
            <pc:docMk/>
            <pc:sldMk cId="2237347613" sldId="434"/>
            <ac:graphicFrameMk id="3" creationId="{A549F4CE-A93C-4F4C-D2D5-D32648CF1291}"/>
          </ac:graphicFrameMkLst>
        </pc:graphicFrameChg>
      </pc:sldChg>
      <pc:sldChg chg="modSp new mod">
        <pc:chgData name="Kaygisiz, Kübra" userId="4bfbf330-8776-4086-a830-2184b07ba8db" providerId="ADAL" clId="{3BADC0B2-0F94-45F6-B552-1A87FB5F996F}" dt="2022-08-19T09:54:08.831" v="654"/>
        <pc:sldMkLst>
          <pc:docMk/>
          <pc:sldMk cId="230741147" sldId="435"/>
        </pc:sldMkLst>
        <pc:spChg chg="mod">
          <ac:chgData name="Kaygisiz, Kübra" userId="4bfbf330-8776-4086-a830-2184b07ba8db" providerId="ADAL" clId="{3BADC0B2-0F94-45F6-B552-1A87FB5F996F}" dt="2022-08-19T09:54:08.831" v="654"/>
          <ac:spMkLst>
            <pc:docMk/>
            <pc:sldMk cId="230741147" sldId="435"/>
            <ac:spMk id="2" creationId="{D3A4237E-B334-407D-EE5B-2DE0DC61EE03}"/>
          </ac:spMkLst>
        </pc:spChg>
      </pc:sldChg>
      <pc:sldChg chg="addSp modSp new mod">
        <pc:chgData name="Kaygisiz, Kübra" userId="4bfbf330-8776-4086-a830-2184b07ba8db" providerId="ADAL" clId="{3BADC0B2-0F94-45F6-B552-1A87FB5F996F}" dt="2022-08-21T02:04:10.725" v="1062" actId="1076"/>
        <pc:sldMkLst>
          <pc:docMk/>
          <pc:sldMk cId="2425966623" sldId="436"/>
        </pc:sldMkLst>
        <pc:spChg chg="mod">
          <ac:chgData name="Kaygisiz, Kübra" userId="4bfbf330-8776-4086-a830-2184b07ba8db" providerId="ADAL" clId="{3BADC0B2-0F94-45F6-B552-1A87FB5F996F}" dt="2022-08-19T09:54:13.261" v="655"/>
          <ac:spMkLst>
            <pc:docMk/>
            <pc:sldMk cId="2425966623" sldId="436"/>
            <ac:spMk id="2" creationId="{21D233EC-0FFC-0EF9-F22E-C9A21FF46A0A}"/>
          </ac:spMkLst>
        </pc:spChg>
        <pc:graphicFrameChg chg="add mod">
          <ac:chgData name="Kaygisiz, Kübra" userId="4bfbf330-8776-4086-a830-2184b07ba8db" providerId="ADAL" clId="{3BADC0B2-0F94-45F6-B552-1A87FB5F996F}" dt="2022-08-21T02:04:10.725" v="1062" actId="1076"/>
          <ac:graphicFrameMkLst>
            <pc:docMk/>
            <pc:sldMk cId="2425966623" sldId="436"/>
            <ac:graphicFrameMk id="3" creationId="{86B07337-3EE0-A024-F7D3-425E41E1A16C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2:04:31.739" v="1065" actId="1076"/>
        <pc:sldMkLst>
          <pc:docMk/>
          <pc:sldMk cId="1442506015" sldId="437"/>
        </pc:sldMkLst>
        <pc:spChg chg="mod">
          <ac:chgData name="Kaygisiz, Kübra" userId="4bfbf330-8776-4086-a830-2184b07ba8db" providerId="ADAL" clId="{3BADC0B2-0F94-45F6-B552-1A87FB5F996F}" dt="2022-08-19T09:54:18.108" v="656"/>
          <ac:spMkLst>
            <pc:docMk/>
            <pc:sldMk cId="1442506015" sldId="437"/>
            <ac:spMk id="2" creationId="{A98EE9F1-E508-8C3E-13D4-49556401550F}"/>
          </ac:spMkLst>
        </pc:spChg>
        <pc:graphicFrameChg chg="add mod">
          <ac:chgData name="Kaygisiz, Kübra" userId="4bfbf330-8776-4086-a830-2184b07ba8db" providerId="ADAL" clId="{3BADC0B2-0F94-45F6-B552-1A87FB5F996F}" dt="2022-08-21T02:04:31.739" v="1065" actId="1076"/>
          <ac:graphicFrameMkLst>
            <pc:docMk/>
            <pc:sldMk cId="1442506015" sldId="437"/>
            <ac:graphicFrameMk id="3" creationId="{30AA2302-8F9E-DC84-FDC6-27BFCB389706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3:10:40.655" v="1164" actId="1076"/>
        <pc:sldMkLst>
          <pc:docMk/>
          <pc:sldMk cId="2819304349" sldId="438"/>
        </pc:sldMkLst>
        <pc:spChg chg="mod">
          <ac:chgData name="Kaygisiz, Kübra" userId="4bfbf330-8776-4086-a830-2184b07ba8db" providerId="ADAL" clId="{3BADC0B2-0F94-45F6-B552-1A87FB5F996F}" dt="2022-08-19T09:54:22.271" v="657"/>
          <ac:spMkLst>
            <pc:docMk/>
            <pc:sldMk cId="2819304349" sldId="438"/>
            <ac:spMk id="2" creationId="{A726E2BE-74BB-14DD-98F5-CCC6D62948A3}"/>
          </ac:spMkLst>
        </pc:spChg>
        <pc:graphicFrameChg chg="add mod">
          <ac:chgData name="Kaygisiz, Kübra" userId="4bfbf330-8776-4086-a830-2184b07ba8db" providerId="ADAL" clId="{3BADC0B2-0F94-45F6-B552-1A87FB5F996F}" dt="2022-08-21T03:10:40.655" v="1164" actId="1076"/>
          <ac:graphicFrameMkLst>
            <pc:docMk/>
            <pc:sldMk cId="2819304349" sldId="438"/>
            <ac:graphicFrameMk id="3" creationId="{4FC7F079-0FE3-4E40-7381-94F0BF8D4D2D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2:26:53.875" v="1111" actId="1076"/>
        <pc:sldMkLst>
          <pc:docMk/>
          <pc:sldMk cId="241617016" sldId="439"/>
        </pc:sldMkLst>
        <pc:spChg chg="mod">
          <ac:chgData name="Kaygisiz, Kübra" userId="4bfbf330-8776-4086-a830-2184b07ba8db" providerId="ADAL" clId="{3BADC0B2-0F94-45F6-B552-1A87FB5F996F}" dt="2022-08-19T09:54:25.903" v="658"/>
          <ac:spMkLst>
            <pc:docMk/>
            <pc:sldMk cId="241617016" sldId="439"/>
            <ac:spMk id="2" creationId="{AF04BF6F-D34A-A84F-1254-81687CBCD99E}"/>
          </ac:spMkLst>
        </pc:spChg>
        <pc:graphicFrameChg chg="add mod">
          <ac:chgData name="Kaygisiz, Kübra" userId="4bfbf330-8776-4086-a830-2184b07ba8db" providerId="ADAL" clId="{3BADC0B2-0F94-45F6-B552-1A87FB5F996F}" dt="2022-08-21T02:26:53.875" v="1111" actId="1076"/>
          <ac:graphicFrameMkLst>
            <pc:docMk/>
            <pc:sldMk cId="241617016" sldId="439"/>
            <ac:graphicFrameMk id="3" creationId="{52978788-8D24-395A-1ECB-B30EE845A3AC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2:27:19.280" v="1113" actId="1076"/>
        <pc:sldMkLst>
          <pc:docMk/>
          <pc:sldMk cId="1356194684" sldId="440"/>
        </pc:sldMkLst>
        <pc:spChg chg="mod">
          <ac:chgData name="Kaygisiz, Kübra" userId="4bfbf330-8776-4086-a830-2184b07ba8db" providerId="ADAL" clId="{3BADC0B2-0F94-45F6-B552-1A87FB5F996F}" dt="2022-08-19T09:54:30.032" v="659"/>
          <ac:spMkLst>
            <pc:docMk/>
            <pc:sldMk cId="1356194684" sldId="440"/>
            <ac:spMk id="2" creationId="{E34E883D-DB63-0230-1925-218D481B26A8}"/>
          </ac:spMkLst>
        </pc:spChg>
        <pc:graphicFrameChg chg="add mod">
          <ac:chgData name="Kaygisiz, Kübra" userId="4bfbf330-8776-4086-a830-2184b07ba8db" providerId="ADAL" clId="{3BADC0B2-0F94-45F6-B552-1A87FB5F996F}" dt="2022-08-21T02:27:19.280" v="1113" actId="1076"/>
          <ac:graphicFrameMkLst>
            <pc:docMk/>
            <pc:sldMk cId="1356194684" sldId="440"/>
            <ac:graphicFrameMk id="3" creationId="{04012620-4885-102F-A9C4-02D7E8DD06A4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2:08:59.380" v="1077" actId="1076"/>
        <pc:sldMkLst>
          <pc:docMk/>
          <pc:sldMk cId="4124821120" sldId="441"/>
        </pc:sldMkLst>
        <pc:spChg chg="mod">
          <ac:chgData name="Kaygisiz, Kübra" userId="4bfbf330-8776-4086-a830-2184b07ba8db" providerId="ADAL" clId="{3BADC0B2-0F94-45F6-B552-1A87FB5F996F}" dt="2022-08-19T09:54:33.985" v="660"/>
          <ac:spMkLst>
            <pc:docMk/>
            <pc:sldMk cId="4124821120" sldId="441"/>
            <ac:spMk id="2" creationId="{04DD754C-C387-D970-9334-7175122353AB}"/>
          </ac:spMkLst>
        </pc:spChg>
        <pc:graphicFrameChg chg="add mod">
          <ac:chgData name="Kaygisiz, Kübra" userId="4bfbf330-8776-4086-a830-2184b07ba8db" providerId="ADAL" clId="{3BADC0B2-0F94-45F6-B552-1A87FB5F996F}" dt="2022-08-21T02:08:59.380" v="1077" actId="1076"/>
          <ac:graphicFrameMkLst>
            <pc:docMk/>
            <pc:sldMk cId="4124821120" sldId="441"/>
            <ac:graphicFrameMk id="3" creationId="{1965FC0E-714B-7AB8-9018-ED1B320C9BA9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2:09:20.703" v="1079" actId="1076"/>
        <pc:sldMkLst>
          <pc:docMk/>
          <pc:sldMk cId="1252098238" sldId="442"/>
        </pc:sldMkLst>
        <pc:spChg chg="mod">
          <ac:chgData name="Kaygisiz, Kübra" userId="4bfbf330-8776-4086-a830-2184b07ba8db" providerId="ADAL" clId="{3BADC0B2-0F94-45F6-B552-1A87FB5F996F}" dt="2022-08-19T09:54:37.426" v="661"/>
          <ac:spMkLst>
            <pc:docMk/>
            <pc:sldMk cId="1252098238" sldId="442"/>
            <ac:spMk id="2" creationId="{E2FEDB23-CDAA-5CA7-E91F-CAEBD8900EC9}"/>
          </ac:spMkLst>
        </pc:spChg>
        <pc:graphicFrameChg chg="add mod">
          <ac:chgData name="Kaygisiz, Kübra" userId="4bfbf330-8776-4086-a830-2184b07ba8db" providerId="ADAL" clId="{3BADC0B2-0F94-45F6-B552-1A87FB5F996F}" dt="2022-08-21T02:09:20.703" v="1079" actId="1076"/>
          <ac:graphicFrameMkLst>
            <pc:docMk/>
            <pc:sldMk cId="1252098238" sldId="442"/>
            <ac:graphicFrameMk id="3" creationId="{594DC7F4-6F82-994D-AEA1-BA61E29DD075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2:09:38.461" v="1081" actId="1076"/>
        <pc:sldMkLst>
          <pc:docMk/>
          <pc:sldMk cId="4083636769" sldId="443"/>
        </pc:sldMkLst>
        <pc:spChg chg="mod">
          <ac:chgData name="Kaygisiz, Kübra" userId="4bfbf330-8776-4086-a830-2184b07ba8db" providerId="ADAL" clId="{3BADC0B2-0F94-45F6-B552-1A87FB5F996F}" dt="2022-08-19T09:54:41.519" v="662"/>
          <ac:spMkLst>
            <pc:docMk/>
            <pc:sldMk cId="4083636769" sldId="443"/>
            <ac:spMk id="2" creationId="{0D0210B3-4F42-C5EA-F614-AC40EF93ECCF}"/>
          </ac:spMkLst>
        </pc:spChg>
        <pc:graphicFrameChg chg="add mod">
          <ac:chgData name="Kaygisiz, Kübra" userId="4bfbf330-8776-4086-a830-2184b07ba8db" providerId="ADAL" clId="{3BADC0B2-0F94-45F6-B552-1A87FB5F996F}" dt="2022-08-21T02:09:38.461" v="1081" actId="1076"/>
          <ac:graphicFrameMkLst>
            <pc:docMk/>
            <pc:sldMk cId="4083636769" sldId="443"/>
            <ac:graphicFrameMk id="3" creationId="{D96C33D6-3A9B-98A5-6543-7EE1D7B0771E}"/>
          </ac:graphicFrameMkLst>
        </pc:graphicFrameChg>
      </pc:sldChg>
      <pc:sldChg chg="addSp delSp modSp new mod">
        <pc:chgData name="Kaygisiz, Kübra" userId="4bfbf330-8776-4086-a830-2184b07ba8db" providerId="ADAL" clId="{3BADC0B2-0F94-45F6-B552-1A87FB5F996F}" dt="2022-08-21T02:09:58.818" v="1083" actId="1076"/>
        <pc:sldMkLst>
          <pc:docMk/>
          <pc:sldMk cId="2446753213" sldId="444"/>
        </pc:sldMkLst>
        <pc:spChg chg="mod">
          <ac:chgData name="Kaygisiz, Kübra" userId="4bfbf330-8776-4086-a830-2184b07ba8db" providerId="ADAL" clId="{3BADC0B2-0F94-45F6-B552-1A87FB5F996F}" dt="2022-08-19T09:54:51.740" v="665"/>
          <ac:spMkLst>
            <pc:docMk/>
            <pc:sldMk cId="2446753213" sldId="444"/>
            <ac:spMk id="2" creationId="{AB820D2D-FC5E-2DC8-6F53-8569D7CF20B7}"/>
          </ac:spMkLst>
        </pc:spChg>
        <pc:spChg chg="add del">
          <ac:chgData name="Kaygisiz, Kübra" userId="4bfbf330-8776-4086-a830-2184b07ba8db" providerId="ADAL" clId="{3BADC0B2-0F94-45F6-B552-1A87FB5F996F}" dt="2022-08-19T09:54:50.600" v="664" actId="478"/>
          <ac:spMkLst>
            <pc:docMk/>
            <pc:sldMk cId="2446753213" sldId="444"/>
            <ac:spMk id="4" creationId="{0FFBA9D2-2295-F193-9831-94EF2A58C0DE}"/>
          </ac:spMkLst>
        </pc:spChg>
        <pc:graphicFrameChg chg="add mod">
          <ac:chgData name="Kaygisiz, Kübra" userId="4bfbf330-8776-4086-a830-2184b07ba8db" providerId="ADAL" clId="{3BADC0B2-0F94-45F6-B552-1A87FB5F996F}" dt="2022-08-21T02:09:58.818" v="1083" actId="1076"/>
          <ac:graphicFrameMkLst>
            <pc:docMk/>
            <pc:sldMk cId="2446753213" sldId="444"/>
            <ac:graphicFrameMk id="5" creationId="{8C034DA7-937A-967A-5087-A91631C74B5C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3:23:13.850" v="1184" actId="1076"/>
        <pc:sldMkLst>
          <pc:docMk/>
          <pc:sldMk cId="1266816577" sldId="445"/>
        </pc:sldMkLst>
        <pc:spChg chg="mod">
          <ac:chgData name="Kaygisiz, Kübra" userId="4bfbf330-8776-4086-a830-2184b07ba8db" providerId="ADAL" clId="{3BADC0B2-0F94-45F6-B552-1A87FB5F996F}" dt="2022-08-19T09:54:58.070" v="666"/>
          <ac:spMkLst>
            <pc:docMk/>
            <pc:sldMk cId="1266816577" sldId="445"/>
            <ac:spMk id="2" creationId="{5D835022-81B5-ED9B-B5FF-9DD665E8F1B3}"/>
          </ac:spMkLst>
        </pc:spChg>
        <pc:graphicFrameChg chg="add mod">
          <ac:chgData name="Kaygisiz, Kübra" userId="4bfbf330-8776-4086-a830-2184b07ba8db" providerId="ADAL" clId="{3BADC0B2-0F94-45F6-B552-1A87FB5F996F}" dt="2022-08-21T02:26:27.081" v="1109" actId="1076"/>
          <ac:graphicFrameMkLst>
            <pc:docMk/>
            <pc:sldMk cId="1266816577" sldId="445"/>
            <ac:graphicFrameMk id="3" creationId="{7C483C47-208D-D07D-0B12-FC04A164A9F7}"/>
          </ac:graphicFrameMkLst>
        </pc:graphicFrameChg>
        <pc:graphicFrameChg chg="add mod">
          <ac:chgData name="Kaygisiz, Kübra" userId="4bfbf330-8776-4086-a830-2184b07ba8db" providerId="ADAL" clId="{3BADC0B2-0F94-45F6-B552-1A87FB5F996F}" dt="2022-08-21T03:23:13.850" v="1184" actId="1076"/>
          <ac:graphicFrameMkLst>
            <pc:docMk/>
            <pc:sldMk cId="1266816577" sldId="445"/>
            <ac:graphicFrameMk id="4" creationId="{67DAC882-D5E7-B039-F671-032C18D50106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2:08:33.939" v="1075" actId="1076"/>
        <pc:sldMkLst>
          <pc:docMk/>
          <pc:sldMk cId="1847673940" sldId="446"/>
        </pc:sldMkLst>
        <pc:spChg chg="mod">
          <ac:chgData name="Kaygisiz, Kübra" userId="4bfbf330-8776-4086-a830-2184b07ba8db" providerId="ADAL" clId="{3BADC0B2-0F94-45F6-B552-1A87FB5F996F}" dt="2022-08-19T09:55:03.245" v="667"/>
          <ac:spMkLst>
            <pc:docMk/>
            <pc:sldMk cId="1847673940" sldId="446"/>
            <ac:spMk id="2" creationId="{4F315A51-23C6-FCF9-9CC4-BF114E393399}"/>
          </ac:spMkLst>
        </pc:spChg>
        <pc:graphicFrameChg chg="add mod">
          <ac:chgData name="Kaygisiz, Kübra" userId="4bfbf330-8776-4086-a830-2184b07ba8db" providerId="ADAL" clId="{3BADC0B2-0F94-45F6-B552-1A87FB5F996F}" dt="2022-08-21T02:08:33.939" v="1075" actId="1076"/>
          <ac:graphicFrameMkLst>
            <pc:docMk/>
            <pc:sldMk cId="1847673940" sldId="446"/>
            <ac:graphicFrameMk id="3" creationId="{2B67A0B9-0598-4669-0C64-E46E2A657EB9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1:53:18.840" v="1024" actId="1076"/>
        <pc:sldMkLst>
          <pc:docMk/>
          <pc:sldMk cId="477770089" sldId="447"/>
        </pc:sldMkLst>
        <pc:spChg chg="mod">
          <ac:chgData name="Kaygisiz, Kübra" userId="4bfbf330-8776-4086-a830-2184b07ba8db" providerId="ADAL" clId="{3BADC0B2-0F94-45F6-B552-1A87FB5F996F}" dt="2022-08-19T09:55:10.063" v="668"/>
          <ac:spMkLst>
            <pc:docMk/>
            <pc:sldMk cId="477770089" sldId="447"/>
            <ac:spMk id="2" creationId="{2D220118-6687-E185-B00F-F7D94E6327F7}"/>
          </ac:spMkLst>
        </pc:spChg>
        <pc:graphicFrameChg chg="add mod">
          <ac:chgData name="Kaygisiz, Kübra" userId="4bfbf330-8776-4086-a830-2184b07ba8db" providerId="ADAL" clId="{3BADC0B2-0F94-45F6-B552-1A87FB5F996F}" dt="2022-08-21T01:53:18.840" v="1024" actId="1076"/>
          <ac:graphicFrameMkLst>
            <pc:docMk/>
            <pc:sldMk cId="477770089" sldId="447"/>
            <ac:graphicFrameMk id="3" creationId="{8BD9D24F-053A-0CFA-B948-6D55387F2F5F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19T12:39:07.579" v="950" actId="1076"/>
        <pc:sldMkLst>
          <pc:docMk/>
          <pc:sldMk cId="3274997653" sldId="448"/>
        </pc:sldMkLst>
        <pc:spChg chg="mod">
          <ac:chgData name="Kaygisiz, Kübra" userId="4bfbf330-8776-4086-a830-2184b07ba8db" providerId="ADAL" clId="{3BADC0B2-0F94-45F6-B552-1A87FB5F996F}" dt="2022-08-19T09:55:16.822" v="669"/>
          <ac:spMkLst>
            <pc:docMk/>
            <pc:sldMk cId="3274997653" sldId="448"/>
            <ac:spMk id="2" creationId="{9D864198-0650-DE32-21E9-F2FD96E5372A}"/>
          </ac:spMkLst>
        </pc:spChg>
        <pc:graphicFrameChg chg="add mod">
          <ac:chgData name="Kaygisiz, Kübra" userId="4bfbf330-8776-4086-a830-2184b07ba8db" providerId="ADAL" clId="{3BADC0B2-0F94-45F6-B552-1A87FB5F996F}" dt="2022-08-19T12:39:07.579" v="950" actId="1076"/>
          <ac:graphicFrameMkLst>
            <pc:docMk/>
            <pc:sldMk cId="3274997653" sldId="448"/>
            <ac:graphicFrameMk id="3" creationId="{6EBD037C-5055-0B33-3A56-301A18FDEA39}"/>
          </ac:graphicFrameMkLst>
        </pc:graphicFrameChg>
      </pc:sldChg>
      <pc:sldChg chg="new">
        <pc:chgData name="Kaygisiz, Kübra" userId="4bfbf330-8776-4086-a830-2184b07ba8db" providerId="ADAL" clId="{3BADC0B2-0F94-45F6-B552-1A87FB5F996F}" dt="2022-08-19T09:52:10.067" v="645" actId="680"/>
        <pc:sldMkLst>
          <pc:docMk/>
          <pc:sldMk cId="3378599809" sldId="449"/>
        </pc:sldMkLst>
      </pc:sldChg>
      <pc:sldChg chg="new del">
        <pc:chgData name="Kaygisiz, Kübra" userId="4bfbf330-8776-4086-a830-2184b07ba8db" providerId="ADAL" clId="{3BADC0B2-0F94-45F6-B552-1A87FB5F996F}" dt="2022-08-19T09:55:23.677" v="670" actId="47"/>
        <pc:sldMkLst>
          <pc:docMk/>
          <pc:sldMk cId="1317427591" sldId="450"/>
        </pc:sldMkLst>
      </pc:sldChg>
      <pc:sldChg chg="addSp modSp new mod">
        <pc:chgData name="Kaygisiz, Kübra" userId="4bfbf330-8776-4086-a830-2184b07ba8db" providerId="ADAL" clId="{3BADC0B2-0F94-45F6-B552-1A87FB5F996F}" dt="2022-08-19T10:26:53.307" v="851" actId="1076"/>
        <pc:sldMkLst>
          <pc:docMk/>
          <pc:sldMk cId="3268225756" sldId="450"/>
        </pc:sldMkLst>
        <pc:spChg chg="mod">
          <ac:chgData name="Kaygisiz, Kübra" userId="4bfbf330-8776-4086-a830-2184b07ba8db" providerId="ADAL" clId="{3BADC0B2-0F94-45F6-B552-1A87FB5F996F}" dt="2022-08-19T09:55:55.888" v="677" actId="20577"/>
          <ac:spMkLst>
            <pc:docMk/>
            <pc:sldMk cId="3268225756" sldId="450"/>
            <ac:spMk id="2" creationId="{5F96DAF7-D3B1-6749-A076-E72604562408}"/>
          </ac:spMkLst>
        </pc:spChg>
        <pc:graphicFrameChg chg="add mod">
          <ac:chgData name="Kaygisiz, Kübra" userId="4bfbf330-8776-4086-a830-2184b07ba8db" providerId="ADAL" clId="{3BADC0B2-0F94-45F6-B552-1A87FB5F996F}" dt="2022-08-19T10:26:53.307" v="851" actId="1076"/>
          <ac:graphicFrameMkLst>
            <pc:docMk/>
            <pc:sldMk cId="3268225756" sldId="450"/>
            <ac:graphicFrameMk id="3" creationId="{2F1E8D4E-CC4D-E34D-59C3-A5296790F199}"/>
          </ac:graphicFrameMkLst>
        </pc:graphicFrameChg>
      </pc:sldChg>
      <pc:sldChg chg="addSp modSp add mod">
        <pc:chgData name="Kaygisiz, Kübra" userId="4bfbf330-8776-4086-a830-2184b07ba8db" providerId="ADAL" clId="{3BADC0B2-0F94-45F6-B552-1A87FB5F996F}" dt="2022-08-19T10:27:17.442" v="853" actId="1076"/>
        <pc:sldMkLst>
          <pc:docMk/>
          <pc:sldMk cId="1020192741" sldId="451"/>
        </pc:sldMkLst>
        <pc:spChg chg="mod">
          <ac:chgData name="Kaygisiz, Kübra" userId="4bfbf330-8776-4086-a830-2184b07ba8db" providerId="ADAL" clId="{3BADC0B2-0F94-45F6-B552-1A87FB5F996F}" dt="2022-08-19T09:56:03.225" v="682" actId="20577"/>
          <ac:spMkLst>
            <pc:docMk/>
            <pc:sldMk cId="1020192741" sldId="451"/>
            <ac:spMk id="2" creationId="{5F96DAF7-D3B1-6749-A076-E72604562408}"/>
          </ac:spMkLst>
        </pc:spChg>
        <pc:graphicFrameChg chg="add mod">
          <ac:chgData name="Kaygisiz, Kübra" userId="4bfbf330-8776-4086-a830-2184b07ba8db" providerId="ADAL" clId="{3BADC0B2-0F94-45F6-B552-1A87FB5F996F}" dt="2022-08-19T10:27:17.442" v="853" actId="1076"/>
          <ac:graphicFrameMkLst>
            <pc:docMk/>
            <pc:sldMk cId="1020192741" sldId="451"/>
            <ac:graphicFrameMk id="3" creationId="{CF5A494B-CE3B-C79E-6978-8C247A4535BB}"/>
          </ac:graphicFrameMkLst>
        </pc:graphicFrameChg>
      </pc:sldChg>
      <pc:sldChg chg="addSp modSp add mod">
        <pc:chgData name="Kaygisiz, Kübra" userId="4bfbf330-8776-4086-a830-2184b07ba8db" providerId="ADAL" clId="{3BADC0B2-0F94-45F6-B552-1A87FB5F996F}" dt="2022-08-19T10:28:30.742" v="864" actId="1076"/>
        <pc:sldMkLst>
          <pc:docMk/>
          <pc:sldMk cId="3320063209" sldId="452"/>
        </pc:sldMkLst>
        <pc:spChg chg="mod">
          <ac:chgData name="Kaygisiz, Kübra" userId="4bfbf330-8776-4086-a830-2184b07ba8db" providerId="ADAL" clId="{3BADC0B2-0F94-45F6-B552-1A87FB5F996F}" dt="2022-08-19T09:56:15.072" v="686" actId="20577"/>
          <ac:spMkLst>
            <pc:docMk/>
            <pc:sldMk cId="3320063209" sldId="452"/>
            <ac:spMk id="2" creationId="{5F96DAF7-D3B1-6749-A076-E72604562408}"/>
          </ac:spMkLst>
        </pc:spChg>
        <pc:graphicFrameChg chg="add mod">
          <ac:chgData name="Kaygisiz, Kübra" userId="4bfbf330-8776-4086-a830-2184b07ba8db" providerId="ADAL" clId="{3BADC0B2-0F94-45F6-B552-1A87FB5F996F}" dt="2022-08-19T10:28:30.742" v="864" actId="1076"/>
          <ac:graphicFrameMkLst>
            <pc:docMk/>
            <pc:sldMk cId="3320063209" sldId="452"/>
            <ac:graphicFrameMk id="3" creationId="{5BBA8795-E97B-DEB7-AB5C-EF2202CE5FE1}"/>
          </ac:graphicFrameMkLst>
        </pc:graphicFrameChg>
      </pc:sldChg>
      <pc:sldChg chg="addSp modSp add mod">
        <pc:chgData name="Kaygisiz, Kübra" userId="4bfbf330-8776-4086-a830-2184b07ba8db" providerId="ADAL" clId="{3BADC0B2-0F94-45F6-B552-1A87FB5F996F}" dt="2022-08-19T10:29:07.268" v="866" actId="1076"/>
        <pc:sldMkLst>
          <pc:docMk/>
          <pc:sldMk cId="3944776280" sldId="453"/>
        </pc:sldMkLst>
        <pc:spChg chg="mod">
          <ac:chgData name="Kaygisiz, Kübra" userId="4bfbf330-8776-4086-a830-2184b07ba8db" providerId="ADAL" clId="{3BADC0B2-0F94-45F6-B552-1A87FB5F996F}" dt="2022-08-19T09:56:18.695" v="688" actId="20577"/>
          <ac:spMkLst>
            <pc:docMk/>
            <pc:sldMk cId="3944776280" sldId="453"/>
            <ac:spMk id="2" creationId="{5F96DAF7-D3B1-6749-A076-E72604562408}"/>
          </ac:spMkLst>
        </pc:spChg>
        <pc:graphicFrameChg chg="add mod">
          <ac:chgData name="Kaygisiz, Kübra" userId="4bfbf330-8776-4086-a830-2184b07ba8db" providerId="ADAL" clId="{3BADC0B2-0F94-45F6-B552-1A87FB5F996F}" dt="2022-08-19T10:29:07.268" v="866" actId="1076"/>
          <ac:graphicFrameMkLst>
            <pc:docMk/>
            <pc:sldMk cId="3944776280" sldId="453"/>
            <ac:graphicFrameMk id="3" creationId="{86999E90-2167-7AAB-5A15-3B7CB1D471E0}"/>
          </ac:graphicFrameMkLst>
        </pc:graphicFrameChg>
      </pc:sldChg>
      <pc:sldChg chg="addSp modSp add mod">
        <pc:chgData name="Kaygisiz, Kübra" userId="4bfbf330-8776-4086-a830-2184b07ba8db" providerId="ADAL" clId="{3BADC0B2-0F94-45F6-B552-1A87FB5F996F}" dt="2022-08-19T10:29:33.776" v="868" actId="1076"/>
        <pc:sldMkLst>
          <pc:docMk/>
          <pc:sldMk cId="4079554333" sldId="454"/>
        </pc:sldMkLst>
        <pc:spChg chg="mod">
          <ac:chgData name="Kaygisiz, Kübra" userId="4bfbf330-8776-4086-a830-2184b07ba8db" providerId="ADAL" clId="{3BADC0B2-0F94-45F6-B552-1A87FB5F996F}" dt="2022-08-19T09:56:32.709" v="693" actId="20577"/>
          <ac:spMkLst>
            <pc:docMk/>
            <pc:sldMk cId="4079554333" sldId="454"/>
            <ac:spMk id="2" creationId="{5F96DAF7-D3B1-6749-A076-E72604562408}"/>
          </ac:spMkLst>
        </pc:spChg>
        <pc:graphicFrameChg chg="add mod">
          <ac:chgData name="Kaygisiz, Kübra" userId="4bfbf330-8776-4086-a830-2184b07ba8db" providerId="ADAL" clId="{3BADC0B2-0F94-45F6-B552-1A87FB5F996F}" dt="2022-08-19T10:29:33.776" v="868" actId="1076"/>
          <ac:graphicFrameMkLst>
            <pc:docMk/>
            <pc:sldMk cId="4079554333" sldId="454"/>
            <ac:graphicFrameMk id="3" creationId="{7A3FEC20-2854-23E5-0CA4-D47DA0CF8E31}"/>
          </ac:graphicFrameMkLst>
        </pc:graphicFrameChg>
      </pc:sldChg>
      <pc:sldChg chg="addSp modSp add mod">
        <pc:chgData name="Kaygisiz, Kübra" userId="4bfbf330-8776-4086-a830-2184b07ba8db" providerId="ADAL" clId="{3BADC0B2-0F94-45F6-B552-1A87FB5F996F}" dt="2022-08-19T10:30:20.042" v="873" actId="1076"/>
        <pc:sldMkLst>
          <pc:docMk/>
          <pc:sldMk cId="2915459117" sldId="455"/>
        </pc:sldMkLst>
        <pc:spChg chg="mod">
          <ac:chgData name="Kaygisiz, Kübra" userId="4bfbf330-8776-4086-a830-2184b07ba8db" providerId="ADAL" clId="{3BADC0B2-0F94-45F6-B552-1A87FB5F996F}" dt="2022-08-19T09:56:43.257" v="696" actId="20577"/>
          <ac:spMkLst>
            <pc:docMk/>
            <pc:sldMk cId="2915459117" sldId="455"/>
            <ac:spMk id="2" creationId="{5F96DAF7-D3B1-6749-A076-E72604562408}"/>
          </ac:spMkLst>
        </pc:spChg>
        <pc:graphicFrameChg chg="add mod">
          <ac:chgData name="Kaygisiz, Kübra" userId="4bfbf330-8776-4086-a830-2184b07ba8db" providerId="ADAL" clId="{3BADC0B2-0F94-45F6-B552-1A87FB5F996F}" dt="2022-08-19T10:30:20.042" v="873" actId="1076"/>
          <ac:graphicFrameMkLst>
            <pc:docMk/>
            <pc:sldMk cId="2915459117" sldId="455"/>
            <ac:graphicFrameMk id="3" creationId="{5622D0AB-5AD8-D5B4-B3F5-1C98BB92B1BD}"/>
          </ac:graphicFrameMkLst>
        </pc:graphicFrameChg>
      </pc:sldChg>
      <pc:sldChg chg="addSp modSp add mod">
        <pc:chgData name="Kaygisiz, Kübra" userId="4bfbf330-8776-4086-a830-2184b07ba8db" providerId="ADAL" clId="{3BADC0B2-0F94-45F6-B552-1A87FB5F996F}" dt="2022-08-19T10:30:42.915" v="875" actId="1076"/>
        <pc:sldMkLst>
          <pc:docMk/>
          <pc:sldMk cId="2197159243" sldId="456"/>
        </pc:sldMkLst>
        <pc:spChg chg="mod">
          <ac:chgData name="Kaygisiz, Kübra" userId="4bfbf330-8776-4086-a830-2184b07ba8db" providerId="ADAL" clId="{3BADC0B2-0F94-45F6-B552-1A87FB5F996F}" dt="2022-08-19T09:56:50.620" v="700" actId="20577"/>
          <ac:spMkLst>
            <pc:docMk/>
            <pc:sldMk cId="2197159243" sldId="456"/>
            <ac:spMk id="2" creationId="{5F96DAF7-D3B1-6749-A076-E72604562408}"/>
          </ac:spMkLst>
        </pc:spChg>
        <pc:graphicFrameChg chg="add mod">
          <ac:chgData name="Kaygisiz, Kübra" userId="4bfbf330-8776-4086-a830-2184b07ba8db" providerId="ADAL" clId="{3BADC0B2-0F94-45F6-B552-1A87FB5F996F}" dt="2022-08-19T10:30:42.915" v="875" actId="1076"/>
          <ac:graphicFrameMkLst>
            <pc:docMk/>
            <pc:sldMk cId="2197159243" sldId="456"/>
            <ac:graphicFrameMk id="3" creationId="{16612341-2FA2-EB18-E5BE-BC4D44AD413B}"/>
          </ac:graphicFrameMkLst>
        </pc:graphicFrameChg>
      </pc:sldChg>
      <pc:sldChg chg="addSp modSp add mod">
        <pc:chgData name="Kaygisiz, Kübra" userId="4bfbf330-8776-4086-a830-2184b07ba8db" providerId="ADAL" clId="{3BADC0B2-0F94-45F6-B552-1A87FB5F996F}" dt="2022-08-19T10:31:02.829" v="877" actId="1076"/>
        <pc:sldMkLst>
          <pc:docMk/>
          <pc:sldMk cId="3325073965" sldId="457"/>
        </pc:sldMkLst>
        <pc:spChg chg="mod">
          <ac:chgData name="Kaygisiz, Kübra" userId="4bfbf330-8776-4086-a830-2184b07ba8db" providerId="ADAL" clId="{3BADC0B2-0F94-45F6-B552-1A87FB5F996F}" dt="2022-08-19T09:56:54.012" v="704" actId="20577"/>
          <ac:spMkLst>
            <pc:docMk/>
            <pc:sldMk cId="3325073965" sldId="457"/>
            <ac:spMk id="2" creationId="{5F96DAF7-D3B1-6749-A076-E72604562408}"/>
          </ac:spMkLst>
        </pc:spChg>
        <pc:graphicFrameChg chg="add mod">
          <ac:chgData name="Kaygisiz, Kübra" userId="4bfbf330-8776-4086-a830-2184b07ba8db" providerId="ADAL" clId="{3BADC0B2-0F94-45F6-B552-1A87FB5F996F}" dt="2022-08-19T10:31:02.829" v="877" actId="1076"/>
          <ac:graphicFrameMkLst>
            <pc:docMk/>
            <pc:sldMk cId="3325073965" sldId="457"/>
            <ac:graphicFrameMk id="3" creationId="{851BBF8B-0961-05C5-D471-A2935578C642}"/>
          </ac:graphicFrameMkLst>
        </pc:graphicFrameChg>
      </pc:sldChg>
      <pc:sldChg chg="addSp modSp add mod">
        <pc:chgData name="Kaygisiz, Kübra" userId="4bfbf330-8776-4086-a830-2184b07ba8db" providerId="ADAL" clId="{3BADC0B2-0F94-45F6-B552-1A87FB5F996F}" dt="2022-08-19T10:31:51.617" v="882" actId="1076"/>
        <pc:sldMkLst>
          <pc:docMk/>
          <pc:sldMk cId="2536143135" sldId="458"/>
        </pc:sldMkLst>
        <pc:spChg chg="mod">
          <ac:chgData name="Kaygisiz, Kübra" userId="4bfbf330-8776-4086-a830-2184b07ba8db" providerId="ADAL" clId="{3BADC0B2-0F94-45F6-B552-1A87FB5F996F}" dt="2022-08-19T09:57:09.242" v="709" actId="20577"/>
          <ac:spMkLst>
            <pc:docMk/>
            <pc:sldMk cId="2536143135" sldId="458"/>
            <ac:spMk id="2" creationId="{5F96DAF7-D3B1-6749-A076-E72604562408}"/>
          </ac:spMkLst>
        </pc:spChg>
        <pc:graphicFrameChg chg="add mod">
          <ac:chgData name="Kaygisiz, Kübra" userId="4bfbf330-8776-4086-a830-2184b07ba8db" providerId="ADAL" clId="{3BADC0B2-0F94-45F6-B552-1A87FB5F996F}" dt="2022-08-19T10:31:51.617" v="882" actId="1076"/>
          <ac:graphicFrameMkLst>
            <pc:docMk/>
            <pc:sldMk cId="2536143135" sldId="458"/>
            <ac:graphicFrameMk id="3" creationId="{8BFDA809-99B7-7174-FE6B-7E3E6FDA0E0F}"/>
          </ac:graphicFrameMkLst>
        </pc:graphicFrameChg>
      </pc:sldChg>
      <pc:sldChg chg="addSp modSp add mod">
        <pc:chgData name="Kaygisiz, Kübra" userId="4bfbf330-8776-4086-a830-2184b07ba8db" providerId="ADAL" clId="{3BADC0B2-0F94-45F6-B552-1A87FB5F996F}" dt="2022-08-19T10:32:14.098" v="884" actId="1076"/>
        <pc:sldMkLst>
          <pc:docMk/>
          <pc:sldMk cId="2659747753" sldId="459"/>
        </pc:sldMkLst>
        <pc:spChg chg="mod">
          <ac:chgData name="Kaygisiz, Kübra" userId="4bfbf330-8776-4086-a830-2184b07ba8db" providerId="ADAL" clId="{3BADC0B2-0F94-45F6-B552-1A87FB5F996F}" dt="2022-08-19T10:01:50.375" v="712" actId="20577"/>
          <ac:spMkLst>
            <pc:docMk/>
            <pc:sldMk cId="2659747753" sldId="459"/>
            <ac:spMk id="2" creationId="{5F96DAF7-D3B1-6749-A076-E72604562408}"/>
          </ac:spMkLst>
        </pc:spChg>
        <pc:graphicFrameChg chg="add mod">
          <ac:chgData name="Kaygisiz, Kübra" userId="4bfbf330-8776-4086-a830-2184b07ba8db" providerId="ADAL" clId="{3BADC0B2-0F94-45F6-B552-1A87FB5F996F}" dt="2022-08-19T10:32:14.098" v="884" actId="1076"/>
          <ac:graphicFrameMkLst>
            <pc:docMk/>
            <pc:sldMk cId="2659747753" sldId="459"/>
            <ac:graphicFrameMk id="3" creationId="{64F0B379-31B5-0D13-384C-F80930DFE29E}"/>
          </ac:graphicFrameMkLst>
        </pc:graphicFrameChg>
      </pc:sldChg>
      <pc:sldChg chg="addSp modSp add mod">
        <pc:chgData name="Kaygisiz, Kübra" userId="4bfbf330-8776-4086-a830-2184b07ba8db" providerId="ADAL" clId="{3BADC0B2-0F94-45F6-B552-1A87FB5F996F}" dt="2022-08-19T10:32:35.470" v="886" actId="1076"/>
        <pc:sldMkLst>
          <pc:docMk/>
          <pc:sldMk cId="2539225582" sldId="460"/>
        </pc:sldMkLst>
        <pc:spChg chg="mod">
          <ac:chgData name="Kaygisiz, Kübra" userId="4bfbf330-8776-4086-a830-2184b07ba8db" providerId="ADAL" clId="{3BADC0B2-0F94-45F6-B552-1A87FB5F996F}" dt="2022-08-19T10:01:55.002" v="715" actId="20577"/>
          <ac:spMkLst>
            <pc:docMk/>
            <pc:sldMk cId="2539225582" sldId="460"/>
            <ac:spMk id="2" creationId="{5F96DAF7-D3B1-6749-A076-E72604562408}"/>
          </ac:spMkLst>
        </pc:spChg>
        <pc:graphicFrameChg chg="add mod">
          <ac:chgData name="Kaygisiz, Kübra" userId="4bfbf330-8776-4086-a830-2184b07ba8db" providerId="ADAL" clId="{3BADC0B2-0F94-45F6-B552-1A87FB5F996F}" dt="2022-08-19T10:32:35.470" v="886" actId="1076"/>
          <ac:graphicFrameMkLst>
            <pc:docMk/>
            <pc:sldMk cId="2539225582" sldId="460"/>
            <ac:graphicFrameMk id="3" creationId="{DE81403B-81B5-4444-E0CE-CB947E445DE3}"/>
          </ac:graphicFrameMkLst>
        </pc:graphicFrameChg>
      </pc:sldChg>
      <pc:sldChg chg="addSp modSp add mod">
        <pc:chgData name="Kaygisiz, Kübra" userId="4bfbf330-8776-4086-a830-2184b07ba8db" providerId="ADAL" clId="{3BADC0B2-0F94-45F6-B552-1A87FB5F996F}" dt="2022-08-19T10:33:03.040" v="888" actId="1076"/>
        <pc:sldMkLst>
          <pc:docMk/>
          <pc:sldMk cId="1832263747" sldId="461"/>
        </pc:sldMkLst>
        <pc:spChg chg="mod">
          <ac:chgData name="Kaygisiz, Kübra" userId="4bfbf330-8776-4086-a830-2184b07ba8db" providerId="ADAL" clId="{3BADC0B2-0F94-45F6-B552-1A87FB5F996F}" dt="2022-08-19T10:02:06.497" v="718" actId="20577"/>
          <ac:spMkLst>
            <pc:docMk/>
            <pc:sldMk cId="1832263747" sldId="461"/>
            <ac:spMk id="2" creationId="{5F96DAF7-D3B1-6749-A076-E72604562408}"/>
          </ac:spMkLst>
        </pc:spChg>
        <pc:graphicFrameChg chg="add mod">
          <ac:chgData name="Kaygisiz, Kübra" userId="4bfbf330-8776-4086-a830-2184b07ba8db" providerId="ADAL" clId="{3BADC0B2-0F94-45F6-B552-1A87FB5F996F}" dt="2022-08-19T10:33:03.040" v="888" actId="1076"/>
          <ac:graphicFrameMkLst>
            <pc:docMk/>
            <pc:sldMk cId="1832263747" sldId="461"/>
            <ac:graphicFrameMk id="3" creationId="{F0E1EC38-588F-F6D9-53DC-B7B3F5241D50}"/>
          </ac:graphicFrameMkLst>
        </pc:graphicFrameChg>
      </pc:sldChg>
      <pc:sldChg chg="addSp modSp add mod">
        <pc:chgData name="Kaygisiz, Kübra" userId="4bfbf330-8776-4086-a830-2184b07ba8db" providerId="ADAL" clId="{3BADC0B2-0F94-45F6-B552-1A87FB5F996F}" dt="2022-08-19T10:34:01.447" v="890" actId="1076"/>
        <pc:sldMkLst>
          <pc:docMk/>
          <pc:sldMk cId="644598879" sldId="462"/>
        </pc:sldMkLst>
        <pc:spChg chg="mod">
          <ac:chgData name="Kaygisiz, Kübra" userId="4bfbf330-8776-4086-a830-2184b07ba8db" providerId="ADAL" clId="{3BADC0B2-0F94-45F6-B552-1A87FB5F996F}" dt="2022-08-19T10:02:10.927" v="721" actId="20577"/>
          <ac:spMkLst>
            <pc:docMk/>
            <pc:sldMk cId="644598879" sldId="462"/>
            <ac:spMk id="2" creationId="{5F96DAF7-D3B1-6749-A076-E72604562408}"/>
          </ac:spMkLst>
        </pc:spChg>
        <pc:graphicFrameChg chg="add mod">
          <ac:chgData name="Kaygisiz, Kübra" userId="4bfbf330-8776-4086-a830-2184b07ba8db" providerId="ADAL" clId="{3BADC0B2-0F94-45F6-B552-1A87FB5F996F}" dt="2022-08-19T10:34:01.447" v="890" actId="1076"/>
          <ac:graphicFrameMkLst>
            <pc:docMk/>
            <pc:sldMk cId="644598879" sldId="462"/>
            <ac:graphicFrameMk id="3" creationId="{0852E2E2-2A9B-1E77-020A-8F68DC82E7A3}"/>
          </ac:graphicFrameMkLst>
        </pc:graphicFrameChg>
      </pc:sldChg>
      <pc:sldChg chg="addSp modSp add mod">
        <pc:chgData name="Kaygisiz, Kübra" userId="4bfbf330-8776-4086-a830-2184b07ba8db" providerId="ADAL" clId="{3BADC0B2-0F94-45F6-B552-1A87FB5F996F}" dt="2022-08-19T10:34:32.088" v="892" actId="1076"/>
        <pc:sldMkLst>
          <pc:docMk/>
          <pc:sldMk cId="1217276297" sldId="463"/>
        </pc:sldMkLst>
        <pc:spChg chg="mod">
          <ac:chgData name="Kaygisiz, Kübra" userId="4bfbf330-8776-4086-a830-2184b07ba8db" providerId="ADAL" clId="{3BADC0B2-0F94-45F6-B552-1A87FB5F996F}" dt="2022-08-19T10:02:14.719" v="724" actId="20577"/>
          <ac:spMkLst>
            <pc:docMk/>
            <pc:sldMk cId="1217276297" sldId="463"/>
            <ac:spMk id="2" creationId="{5F96DAF7-D3B1-6749-A076-E72604562408}"/>
          </ac:spMkLst>
        </pc:spChg>
        <pc:graphicFrameChg chg="add mod">
          <ac:chgData name="Kaygisiz, Kübra" userId="4bfbf330-8776-4086-a830-2184b07ba8db" providerId="ADAL" clId="{3BADC0B2-0F94-45F6-B552-1A87FB5F996F}" dt="2022-08-19T10:34:32.088" v="892" actId="1076"/>
          <ac:graphicFrameMkLst>
            <pc:docMk/>
            <pc:sldMk cId="1217276297" sldId="463"/>
            <ac:graphicFrameMk id="3" creationId="{8B79FF27-54B3-F566-41A6-0FF1B433B691}"/>
          </ac:graphicFrameMkLst>
        </pc:graphicFrameChg>
      </pc:sldChg>
      <pc:sldChg chg="addSp modSp add mod">
        <pc:chgData name="Kaygisiz, Kübra" userId="4bfbf330-8776-4086-a830-2184b07ba8db" providerId="ADAL" clId="{3BADC0B2-0F94-45F6-B552-1A87FB5F996F}" dt="2022-08-19T10:34:51.867" v="894" actId="1076"/>
        <pc:sldMkLst>
          <pc:docMk/>
          <pc:sldMk cId="3882373646" sldId="464"/>
        </pc:sldMkLst>
        <pc:spChg chg="mod">
          <ac:chgData name="Kaygisiz, Kübra" userId="4bfbf330-8776-4086-a830-2184b07ba8db" providerId="ADAL" clId="{3BADC0B2-0F94-45F6-B552-1A87FB5F996F}" dt="2022-08-19T10:02:18.425" v="727" actId="20577"/>
          <ac:spMkLst>
            <pc:docMk/>
            <pc:sldMk cId="3882373646" sldId="464"/>
            <ac:spMk id="2" creationId="{5F96DAF7-D3B1-6749-A076-E72604562408}"/>
          </ac:spMkLst>
        </pc:spChg>
        <pc:graphicFrameChg chg="add mod">
          <ac:chgData name="Kaygisiz, Kübra" userId="4bfbf330-8776-4086-a830-2184b07ba8db" providerId="ADAL" clId="{3BADC0B2-0F94-45F6-B552-1A87FB5F996F}" dt="2022-08-19T10:34:51.867" v="894" actId="1076"/>
          <ac:graphicFrameMkLst>
            <pc:docMk/>
            <pc:sldMk cId="3882373646" sldId="464"/>
            <ac:graphicFrameMk id="3" creationId="{00D84317-BA66-5960-73CF-C17E15547E43}"/>
          </ac:graphicFrameMkLst>
        </pc:graphicFrameChg>
      </pc:sldChg>
      <pc:sldChg chg="addSp modSp add mod">
        <pc:chgData name="Kaygisiz, Kübra" userId="4bfbf330-8776-4086-a830-2184b07ba8db" providerId="ADAL" clId="{3BADC0B2-0F94-45F6-B552-1A87FB5F996F}" dt="2022-08-19T10:35:12.629" v="896" actId="1076"/>
        <pc:sldMkLst>
          <pc:docMk/>
          <pc:sldMk cId="189820617" sldId="465"/>
        </pc:sldMkLst>
        <pc:spChg chg="mod">
          <ac:chgData name="Kaygisiz, Kübra" userId="4bfbf330-8776-4086-a830-2184b07ba8db" providerId="ADAL" clId="{3BADC0B2-0F94-45F6-B552-1A87FB5F996F}" dt="2022-08-19T10:02:26.198" v="732" actId="20577"/>
          <ac:spMkLst>
            <pc:docMk/>
            <pc:sldMk cId="189820617" sldId="465"/>
            <ac:spMk id="2" creationId="{5F96DAF7-D3B1-6749-A076-E72604562408}"/>
          </ac:spMkLst>
        </pc:spChg>
        <pc:graphicFrameChg chg="add mod">
          <ac:chgData name="Kaygisiz, Kübra" userId="4bfbf330-8776-4086-a830-2184b07ba8db" providerId="ADAL" clId="{3BADC0B2-0F94-45F6-B552-1A87FB5F996F}" dt="2022-08-19T10:35:12.629" v="896" actId="1076"/>
          <ac:graphicFrameMkLst>
            <pc:docMk/>
            <pc:sldMk cId="189820617" sldId="465"/>
            <ac:graphicFrameMk id="3" creationId="{C153D3CD-C1B3-9467-0B2C-8F9267E1930B}"/>
          </ac:graphicFrameMkLst>
        </pc:graphicFrameChg>
      </pc:sldChg>
      <pc:sldChg chg="addSp modSp add mod">
        <pc:chgData name="Kaygisiz, Kübra" userId="4bfbf330-8776-4086-a830-2184b07ba8db" providerId="ADAL" clId="{3BADC0B2-0F94-45F6-B552-1A87FB5F996F}" dt="2022-08-19T10:35:31.904" v="898" actId="1076"/>
        <pc:sldMkLst>
          <pc:docMk/>
          <pc:sldMk cId="2890709503" sldId="466"/>
        </pc:sldMkLst>
        <pc:spChg chg="mod">
          <ac:chgData name="Kaygisiz, Kübra" userId="4bfbf330-8776-4086-a830-2184b07ba8db" providerId="ADAL" clId="{3BADC0B2-0F94-45F6-B552-1A87FB5F996F}" dt="2022-08-19T10:02:31.477" v="737" actId="20577"/>
          <ac:spMkLst>
            <pc:docMk/>
            <pc:sldMk cId="2890709503" sldId="466"/>
            <ac:spMk id="2" creationId="{5F96DAF7-D3B1-6749-A076-E72604562408}"/>
          </ac:spMkLst>
        </pc:spChg>
        <pc:graphicFrameChg chg="add mod">
          <ac:chgData name="Kaygisiz, Kübra" userId="4bfbf330-8776-4086-a830-2184b07ba8db" providerId="ADAL" clId="{3BADC0B2-0F94-45F6-B552-1A87FB5F996F}" dt="2022-08-19T10:35:31.904" v="898" actId="1076"/>
          <ac:graphicFrameMkLst>
            <pc:docMk/>
            <pc:sldMk cId="2890709503" sldId="466"/>
            <ac:graphicFrameMk id="3" creationId="{E8F47143-0E79-BA80-6443-0CD58E8612BA}"/>
          </ac:graphicFrameMkLst>
        </pc:graphicFrameChg>
      </pc:sldChg>
      <pc:sldChg chg="addSp modSp add mod">
        <pc:chgData name="Kaygisiz, Kübra" userId="4bfbf330-8776-4086-a830-2184b07ba8db" providerId="ADAL" clId="{3BADC0B2-0F94-45F6-B552-1A87FB5F996F}" dt="2022-08-19T12:21:44.240" v="900" actId="1076"/>
        <pc:sldMkLst>
          <pc:docMk/>
          <pc:sldMk cId="751934346" sldId="467"/>
        </pc:sldMkLst>
        <pc:spChg chg="mod">
          <ac:chgData name="Kaygisiz, Kübra" userId="4bfbf330-8776-4086-a830-2184b07ba8db" providerId="ADAL" clId="{3BADC0B2-0F94-45F6-B552-1A87FB5F996F}" dt="2022-08-19T10:02:36.881" v="742" actId="20577"/>
          <ac:spMkLst>
            <pc:docMk/>
            <pc:sldMk cId="751934346" sldId="467"/>
            <ac:spMk id="2" creationId="{5F96DAF7-D3B1-6749-A076-E72604562408}"/>
          </ac:spMkLst>
        </pc:spChg>
        <pc:graphicFrameChg chg="add mod">
          <ac:chgData name="Kaygisiz, Kübra" userId="4bfbf330-8776-4086-a830-2184b07ba8db" providerId="ADAL" clId="{3BADC0B2-0F94-45F6-B552-1A87FB5F996F}" dt="2022-08-19T12:21:44.240" v="900" actId="1076"/>
          <ac:graphicFrameMkLst>
            <pc:docMk/>
            <pc:sldMk cId="751934346" sldId="467"/>
            <ac:graphicFrameMk id="3" creationId="{67151486-7062-3C90-EDA1-2695F5C84C77}"/>
          </ac:graphicFrameMkLst>
        </pc:graphicFrameChg>
      </pc:sldChg>
      <pc:sldChg chg="addSp modSp add mod">
        <pc:chgData name="Kaygisiz, Kübra" userId="4bfbf330-8776-4086-a830-2184b07ba8db" providerId="ADAL" clId="{3BADC0B2-0F94-45F6-B552-1A87FB5F996F}" dt="2022-08-19T12:22:11.606" v="902" actId="1076"/>
        <pc:sldMkLst>
          <pc:docMk/>
          <pc:sldMk cId="3588625897" sldId="468"/>
        </pc:sldMkLst>
        <pc:spChg chg="mod">
          <ac:chgData name="Kaygisiz, Kübra" userId="4bfbf330-8776-4086-a830-2184b07ba8db" providerId="ADAL" clId="{3BADC0B2-0F94-45F6-B552-1A87FB5F996F}" dt="2022-08-19T10:02:40.629" v="745" actId="20577"/>
          <ac:spMkLst>
            <pc:docMk/>
            <pc:sldMk cId="3588625897" sldId="468"/>
            <ac:spMk id="2" creationId="{5F96DAF7-D3B1-6749-A076-E72604562408}"/>
          </ac:spMkLst>
        </pc:spChg>
        <pc:graphicFrameChg chg="add mod">
          <ac:chgData name="Kaygisiz, Kübra" userId="4bfbf330-8776-4086-a830-2184b07ba8db" providerId="ADAL" clId="{3BADC0B2-0F94-45F6-B552-1A87FB5F996F}" dt="2022-08-19T12:22:11.606" v="902" actId="1076"/>
          <ac:graphicFrameMkLst>
            <pc:docMk/>
            <pc:sldMk cId="3588625897" sldId="468"/>
            <ac:graphicFrameMk id="3" creationId="{98C3C48E-F4B9-9591-43FF-4BADFF130359}"/>
          </ac:graphicFrameMkLst>
        </pc:graphicFrameChg>
      </pc:sldChg>
      <pc:sldChg chg="addSp modSp add mod">
        <pc:chgData name="Kaygisiz, Kübra" userId="4bfbf330-8776-4086-a830-2184b07ba8db" providerId="ADAL" clId="{3BADC0B2-0F94-45F6-B552-1A87FB5F996F}" dt="2022-08-19T12:22:41.510" v="904" actId="1076"/>
        <pc:sldMkLst>
          <pc:docMk/>
          <pc:sldMk cId="1144400893" sldId="469"/>
        </pc:sldMkLst>
        <pc:spChg chg="mod">
          <ac:chgData name="Kaygisiz, Kübra" userId="4bfbf330-8776-4086-a830-2184b07ba8db" providerId="ADAL" clId="{3BADC0B2-0F94-45F6-B552-1A87FB5F996F}" dt="2022-08-19T10:02:45.335" v="748" actId="20577"/>
          <ac:spMkLst>
            <pc:docMk/>
            <pc:sldMk cId="1144400893" sldId="469"/>
            <ac:spMk id="2" creationId="{5F96DAF7-D3B1-6749-A076-E72604562408}"/>
          </ac:spMkLst>
        </pc:spChg>
        <pc:graphicFrameChg chg="add mod">
          <ac:chgData name="Kaygisiz, Kübra" userId="4bfbf330-8776-4086-a830-2184b07ba8db" providerId="ADAL" clId="{3BADC0B2-0F94-45F6-B552-1A87FB5F996F}" dt="2022-08-19T12:22:41.510" v="904" actId="1076"/>
          <ac:graphicFrameMkLst>
            <pc:docMk/>
            <pc:sldMk cId="1144400893" sldId="469"/>
            <ac:graphicFrameMk id="3" creationId="{B6FBF74A-8E66-AF16-88EE-9CF0AC208588}"/>
          </ac:graphicFrameMkLst>
        </pc:graphicFrameChg>
      </pc:sldChg>
      <pc:sldChg chg="addSp modSp add mod">
        <pc:chgData name="Kaygisiz, Kübra" userId="4bfbf330-8776-4086-a830-2184b07ba8db" providerId="ADAL" clId="{3BADC0B2-0F94-45F6-B552-1A87FB5F996F}" dt="2022-08-19T12:23:04.325" v="906" actId="1076"/>
        <pc:sldMkLst>
          <pc:docMk/>
          <pc:sldMk cId="2896684177" sldId="470"/>
        </pc:sldMkLst>
        <pc:spChg chg="mod">
          <ac:chgData name="Kaygisiz, Kübra" userId="4bfbf330-8776-4086-a830-2184b07ba8db" providerId="ADAL" clId="{3BADC0B2-0F94-45F6-B552-1A87FB5F996F}" dt="2022-08-19T10:02:50.082" v="753" actId="20577"/>
          <ac:spMkLst>
            <pc:docMk/>
            <pc:sldMk cId="2896684177" sldId="470"/>
            <ac:spMk id="2" creationId="{5F96DAF7-D3B1-6749-A076-E72604562408}"/>
          </ac:spMkLst>
        </pc:spChg>
        <pc:graphicFrameChg chg="add mod">
          <ac:chgData name="Kaygisiz, Kübra" userId="4bfbf330-8776-4086-a830-2184b07ba8db" providerId="ADAL" clId="{3BADC0B2-0F94-45F6-B552-1A87FB5F996F}" dt="2022-08-19T12:23:04.325" v="906" actId="1076"/>
          <ac:graphicFrameMkLst>
            <pc:docMk/>
            <pc:sldMk cId="2896684177" sldId="470"/>
            <ac:graphicFrameMk id="3" creationId="{22D80BAB-1B71-4693-56B2-7A4B50CD4D2C}"/>
          </ac:graphicFrameMkLst>
        </pc:graphicFrameChg>
      </pc:sldChg>
      <pc:sldChg chg="addSp modSp add mod">
        <pc:chgData name="Kaygisiz, Kübra" userId="4bfbf330-8776-4086-a830-2184b07ba8db" providerId="ADAL" clId="{3BADC0B2-0F94-45F6-B552-1A87FB5F996F}" dt="2022-08-19T12:23:22.602" v="908" actId="1076"/>
        <pc:sldMkLst>
          <pc:docMk/>
          <pc:sldMk cId="419698809" sldId="471"/>
        </pc:sldMkLst>
        <pc:spChg chg="mod">
          <ac:chgData name="Kaygisiz, Kübra" userId="4bfbf330-8776-4086-a830-2184b07ba8db" providerId="ADAL" clId="{3BADC0B2-0F94-45F6-B552-1A87FB5F996F}" dt="2022-08-19T10:02:54.473" v="756" actId="20577"/>
          <ac:spMkLst>
            <pc:docMk/>
            <pc:sldMk cId="419698809" sldId="471"/>
            <ac:spMk id="2" creationId="{5F96DAF7-D3B1-6749-A076-E72604562408}"/>
          </ac:spMkLst>
        </pc:spChg>
        <pc:graphicFrameChg chg="add mod">
          <ac:chgData name="Kaygisiz, Kübra" userId="4bfbf330-8776-4086-a830-2184b07ba8db" providerId="ADAL" clId="{3BADC0B2-0F94-45F6-B552-1A87FB5F996F}" dt="2022-08-19T12:23:22.602" v="908" actId="1076"/>
          <ac:graphicFrameMkLst>
            <pc:docMk/>
            <pc:sldMk cId="419698809" sldId="471"/>
            <ac:graphicFrameMk id="3" creationId="{D7351502-B0E4-1164-4D81-2193F51F53BC}"/>
          </ac:graphicFrameMkLst>
        </pc:graphicFrameChg>
      </pc:sldChg>
      <pc:sldChg chg="addSp modSp add mod">
        <pc:chgData name="Kaygisiz, Kübra" userId="4bfbf330-8776-4086-a830-2184b07ba8db" providerId="ADAL" clId="{3BADC0B2-0F94-45F6-B552-1A87FB5F996F}" dt="2022-08-19T12:23:41.371" v="910" actId="1076"/>
        <pc:sldMkLst>
          <pc:docMk/>
          <pc:sldMk cId="39428503" sldId="472"/>
        </pc:sldMkLst>
        <pc:spChg chg="mod">
          <ac:chgData name="Kaygisiz, Kübra" userId="4bfbf330-8776-4086-a830-2184b07ba8db" providerId="ADAL" clId="{3BADC0B2-0F94-45F6-B552-1A87FB5F996F}" dt="2022-08-19T10:02:59.221" v="759" actId="20577"/>
          <ac:spMkLst>
            <pc:docMk/>
            <pc:sldMk cId="39428503" sldId="472"/>
            <ac:spMk id="2" creationId="{5F96DAF7-D3B1-6749-A076-E72604562408}"/>
          </ac:spMkLst>
        </pc:spChg>
        <pc:graphicFrameChg chg="add mod">
          <ac:chgData name="Kaygisiz, Kübra" userId="4bfbf330-8776-4086-a830-2184b07ba8db" providerId="ADAL" clId="{3BADC0B2-0F94-45F6-B552-1A87FB5F996F}" dt="2022-08-19T12:23:41.371" v="910" actId="1076"/>
          <ac:graphicFrameMkLst>
            <pc:docMk/>
            <pc:sldMk cId="39428503" sldId="472"/>
            <ac:graphicFrameMk id="3" creationId="{866056D0-14BA-B51C-F6D4-EE01AFA0BEE9}"/>
          </ac:graphicFrameMkLst>
        </pc:graphicFrameChg>
      </pc:sldChg>
      <pc:sldChg chg="addSp modSp add mod">
        <pc:chgData name="Kaygisiz, Kübra" userId="4bfbf330-8776-4086-a830-2184b07ba8db" providerId="ADAL" clId="{3BADC0B2-0F94-45F6-B552-1A87FB5F996F}" dt="2022-08-19T12:24:10.360" v="912" actId="1076"/>
        <pc:sldMkLst>
          <pc:docMk/>
          <pc:sldMk cId="3659388234" sldId="473"/>
        </pc:sldMkLst>
        <pc:spChg chg="mod">
          <ac:chgData name="Kaygisiz, Kübra" userId="4bfbf330-8776-4086-a830-2184b07ba8db" providerId="ADAL" clId="{3BADC0B2-0F94-45F6-B552-1A87FB5F996F}" dt="2022-08-19T10:03:02.712" v="762" actId="20577"/>
          <ac:spMkLst>
            <pc:docMk/>
            <pc:sldMk cId="3659388234" sldId="473"/>
            <ac:spMk id="2" creationId="{5F96DAF7-D3B1-6749-A076-E72604562408}"/>
          </ac:spMkLst>
        </pc:spChg>
        <pc:graphicFrameChg chg="add mod">
          <ac:chgData name="Kaygisiz, Kübra" userId="4bfbf330-8776-4086-a830-2184b07ba8db" providerId="ADAL" clId="{3BADC0B2-0F94-45F6-B552-1A87FB5F996F}" dt="2022-08-19T12:24:10.360" v="912" actId="1076"/>
          <ac:graphicFrameMkLst>
            <pc:docMk/>
            <pc:sldMk cId="3659388234" sldId="473"/>
            <ac:graphicFrameMk id="3" creationId="{A1938167-0883-410F-CA04-0DCC8CE90C7D}"/>
          </ac:graphicFrameMkLst>
        </pc:graphicFrameChg>
      </pc:sldChg>
      <pc:sldChg chg="addSp modSp add mod">
        <pc:chgData name="Kaygisiz, Kübra" userId="4bfbf330-8776-4086-a830-2184b07ba8db" providerId="ADAL" clId="{3BADC0B2-0F94-45F6-B552-1A87FB5F996F}" dt="2022-08-19T12:24:45.408" v="914" actId="1076"/>
        <pc:sldMkLst>
          <pc:docMk/>
          <pc:sldMk cId="1530853510" sldId="474"/>
        </pc:sldMkLst>
        <pc:spChg chg="mod">
          <ac:chgData name="Kaygisiz, Kübra" userId="4bfbf330-8776-4086-a830-2184b07ba8db" providerId="ADAL" clId="{3BADC0B2-0F94-45F6-B552-1A87FB5F996F}" dt="2022-08-19T10:03:08.485" v="765" actId="20577"/>
          <ac:spMkLst>
            <pc:docMk/>
            <pc:sldMk cId="1530853510" sldId="474"/>
            <ac:spMk id="2" creationId="{5F96DAF7-D3B1-6749-A076-E72604562408}"/>
          </ac:spMkLst>
        </pc:spChg>
        <pc:graphicFrameChg chg="add mod">
          <ac:chgData name="Kaygisiz, Kübra" userId="4bfbf330-8776-4086-a830-2184b07ba8db" providerId="ADAL" clId="{3BADC0B2-0F94-45F6-B552-1A87FB5F996F}" dt="2022-08-19T12:24:45.408" v="914" actId="1076"/>
          <ac:graphicFrameMkLst>
            <pc:docMk/>
            <pc:sldMk cId="1530853510" sldId="474"/>
            <ac:graphicFrameMk id="3" creationId="{22EEF7F9-34FE-3C6B-9A09-DD0BC9C4B859}"/>
          </ac:graphicFrameMkLst>
        </pc:graphicFrameChg>
      </pc:sldChg>
      <pc:sldChg chg="addSp modSp add mod">
        <pc:chgData name="Kaygisiz, Kübra" userId="4bfbf330-8776-4086-a830-2184b07ba8db" providerId="ADAL" clId="{3BADC0B2-0F94-45F6-B552-1A87FB5F996F}" dt="2022-08-19T12:25:06.152" v="916" actId="1076"/>
        <pc:sldMkLst>
          <pc:docMk/>
          <pc:sldMk cId="3082231621" sldId="475"/>
        </pc:sldMkLst>
        <pc:spChg chg="mod">
          <ac:chgData name="Kaygisiz, Kübra" userId="4bfbf330-8776-4086-a830-2184b07ba8db" providerId="ADAL" clId="{3BADC0B2-0F94-45F6-B552-1A87FB5F996F}" dt="2022-08-19T10:03:13.114" v="768" actId="20577"/>
          <ac:spMkLst>
            <pc:docMk/>
            <pc:sldMk cId="3082231621" sldId="475"/>
            <ac:spMk id="2" creationId="{5F96DAF7-D3B1-6749-A076-E72604562408}"/>
          </ac:spMkLst>
        </pc:spChg>
        <pc:graphicFrameChg chg="add mod">
          <ac:chgData name="Kaygisiz, Kübra" userId="4bfbf330-8776-4086-a830-2184b07ba8db" providerId="ADAL" clId="{3BADC0B2-0F94-45F6-B552-1A87FB5F996F}" dt="2022-08-19T12:25:06.152" v="916" actId="1076"/>
          <ac:graphicFrameMkLst>
            <pc:docMk/>
            <pc:sldMk cId="3082231621" sldId="475"/>
            <ac:graphicFrameMk id="3" creationId="{530260F5-C3C0-DCBB-A8FB-4448B28383D2}"/>
          </ac:graphicFrameMkLst>
        </pc:graphicFrameChg>
      </pc:sldChg>
      <pc:sldChg chg="addSp modSp add mod">
        <pc:chgData name="Kaygisiz, Kübra" userId="4bfbf330-8776-4086-a830-2184b07ba8db" providerId="ADAL" clId="{3BADC0B2-0F94-45F6-B552-1A87FB5F996F}" dt="2022-08-19T12:25:28.273" v="918" actId="1076"/>
        <pc:sldMkLst>
          <pc:docMk/>
          <pc:sldMk cId="2464123735" sldId="476"/>
        </pc:sldMkLst>
        <pc:spChg chg="mod">
          <ac:chgData name="Kaygisiz, Kübra" userId="4bfbf330-8776-4086-a830-2184b07ba8db" providerId="ADAL" clId="{3BADC0B2-0F94-45F6-B552-1A87FB5F996F}" dt="2022-08-19T10:03:19.646" v="773" actId="20577"/>
          <ac:spMkLst>
            <pc:docMk/>
            <pc:sldMk cId="2464123735" sldId="476"/>
            <ac:spMk id="2" creationId="{5F96DAF7-D3B1-6749-A076-E72604562408}"/>
          </ac:spMkLst>
        </pc:spChg>
        <pc:graphicFrameChg chg="add mod">
          <ac:chgData name="Kaygisiz, Kübra" userId="4bfbf330-8776-4086-a830-2184b07ba8db" providerId="ADAL" clId="{3BADC0B2-0F94-45F6-B552-1A87FB5F996F}" dt="2022-08-19T12:25:28.273" v="918" actId="1076"/>
          <ac:graphicFrameMkLst>
            <pc:docMk/>
            <pc:sldMk cId="2464123735" sldId="476"/>
            <ac:graphicFrameMk id="3" creationId="{879E0506-7E8A-C67B-5A48-47984CA7B44A}"/>
          </ac:graphicFrameMkLst>
        </pc:graphicFrameChg>
      </pc:sldChg>
      <pc:sldChg chg="addSp modSp add mod">
        <pc:chgData name="Kaygisiz, Kübra" userId="4bfbf330-8776-4086-a830-2184b07ba8db" providerId="ADAL" clId="{3BADC0B2-0F94-45F6-B552-1A87FB5F996F}" dt="2022-08-19T12:26:06.929" v="920" actId="1076"/>
        <pc:sldMkLst>
          <pc:docMk/>
          <pc:sldMk cId="520262732" sldId="477"/>
        </pc:sldMkLst>
        <pc:spChg chg="mod">
          <ac:chgData name="Kaygisiz, Kübra" userId="4bfbf330-8776-4086-a830-2184b07ba8db" providerId="ADAL" clId="{3BADC0B2-0F94-45F6-B552-1A87FB5F996F}" dt="2022-08-19T10:03:25.818" v="776" actId="20577"/>
          <ac:spMkLst>
            <pc:docMk/>
            <pc:sldMk cId="520262732" sldId="477"/>
            <ac:spMk id="2" creationId="{5F96DAF7-D3B1-6749-A076-E72604562408}"/>
          </ac:spMkLst>
        </pc:spChg>
        <pc:graphicFrameChg chg="add mod">
          <ac:chgData name="Kaygisiz, Kübra" userId="4bfbf330-8776-4086-a830-2184b07ba8db" providerId="ADAL" clId="{3BADC0B2-0F94-45F6-B552-1A87FB5F996F}" dt="2022-08-19T12:26:06.929" v="920" actId="1076"/>
          <ac:graphicFrameMkLst>
            <pc:docMk/>
            <pc:sldMk cId="520262732" sldId="477"/>
            <ac:graphicFrameMk id="3" creationId="{05B4CBA1-5BA7-5733-AC28-7431E36FA1AE}"/>
          </ac:graphicFrameMkLst>
        </pc:graphicFrameChg>
      </pc:sldChg>
      <pc:sldChg chg="addSp modSp add mod">
        <pc:chgData name="Kaygisiz, Kübra" userId="4bfbf330-8776-4086-a830-2184b07ba8db" providerId="ADAL" clId="{3BADC0B2-0F94-45F6-B552-1A87FB5F996F}" dt="2022-08-19T12:26:28.778" v="922" actId="1076"/>
        <pc:sldMkLst>
          <pc:docMk/>
          <pc:sldMk cId="726334426" sldId="478"/>
        </pc:sldMkLst>
        <pc:spChg chg="mod">
          <ac:chgData name="Kaygisiz, Kübra" userId="4bfbf330-8776-4086-a830-2184b07ba8db" providerId="ADAL" clId="{3BADC0B2-0F94-45F6-B552-1A87FB5F996F}" dt="2022-08-19T10:03:30.649" v="779" actId="20577"/>
          <ac:spMkLst>
            <pc:docMk/>
            <pc:sldMk cId="726334426" sldId="478"/>
            <ac:spMk id="2" creationId="{5F96DAF7-D3B1-6749-A076-E72604562408}"/>
          </ac:spMkLst>
        </pc:spChg>
        <pc:graphicFrameChg chg="add mod">
          <ac:chgData name="Kaygisiz, Kübra" userId="4bfbf330-8776-4086-a830-2184b07ba8db" providerId="ADAL" clId="{3BADC0B2-0F94-45F6-B552-1A87FB5F996F}" dt="2022-08-19T12:26:28.778" v="922" actId="1076"/>
          <ac:graphicFrameMkLst>
            <pc:docMk/>
            <pc:sldMk cId="726334426" sldId="478"/>
            <ac:graphicFrameMk id="3" creationId="{DFAAF874-9912-225F-1744-9FD1256B9E53}"/>
          </ac:graphicFrameMkLst>
        </pc:graphicFrameChg>
      </pc:sldChg>
      <pc:sldChg chg="addSp modSp add mod">
        <pc:chgData name="Kaygisiz, Kübra" userId="4bfbf330-8776-4086-a830-2184b07ba8db" providerId="ADAL" clId="{3BADC0B2-0F94-45F6-B552-1A87FB5F996F}" dt="2022-08-19T12:26:51.610" v="924" actId="1076"/>
        <pc:sldMkLst>
          <pc:docMk/>
          <pc:sldMk cId="4166951486" sldId="479"/>
        </pc:sldMkLst>
        <pc:spChg chg="mod">
          <ac:chgData name="Kaygisiz, Kübra" userId="4bfbf330-8776-4086-a830-2184b07ba8db" providerId="ADAL" clId="{3BADC0B2-0F94-45F6-B552-1A87FB5F996F}" dt="2022-08-19T10:03:44.968" v="783" actId="20577"/>
          <ac:spMkLst>
            <pc:docMk/>
            <pc:sldMk cId="4166951486" sldId="479"/>
            <ac:spMk id="2" creationId="{5F96DAF7-D3B1-6749-A076-E72604562408}"/>
          </ac:spMkLst>
        </pc:spChg>
        <pc:graphicFrameChg chg="add mod">
          <ac:chgData name="Kaygisiz, Kübra" userId="4bfbf330-8776-4086-a830-2184b07ba8db" providerId="ADAL" clId="{3BADC0B2-0F94-45F6-B552-1A87FB5F996F}" dt="2022-08-19T12:26:51.610" v="924" actId="1076"/>
          <ac:graphicFrameMkLst>
            <pc:docMk/>
            <pc:sldMk cId="4166951486" sldId="479"/>
            <ac:graphicFrameMk id="3" creationId="{AA821C5C-A017-61D1-5E2D-615F684662DE}"/>
          </ac:graphicFrameMkLst>
        </pc:graphicFrameChg>
      </pc:sldChg>
      <pc:sldChg chg="addSp modSp add mod">
        <pc:chgData name="Kaygisiz, Kübra" userId="4bfbf330-8776-4086-a830-2184b07ba8db" providerId="ADAL" clId="{3BADC0B2-0F94-45F6-B552-1A87FB5F996F}" dt="2022-08-19T12:27:10.025" v="926" actId="1076"/>
        <pc:sldMkLst>
          <pc:docMk/>
          <pc:sldMk cId="306648616" sldId="480"/>
        </pc:sldMkLst>
        <pc:spChg chg="mod">
          <ac:chgData name="Kaygisiz, Kübra" userId="4bfbf330-8776-4086-a830-2184b07ba8db" providerId="ADAL" clId="{3BADC0B2-0F94-45F6-B552-1A87FB5F996F}" dt="2022-08-19T10:03:47.581" v="785" actId="20577"/>
          <ac:spMkLst>
            <pc:docMk/>
            <pc:sldMk cId="306648616" sldId="480"/>
            <ac:spMk id="2" creationId="{5F96DAF7-D3B1-6749-A076-E72604562408}"/>
          </ac:spMkLst>
        </pc:spChg>
        <pc:graphicFrameChg chg="add mod">
          <ac:chgData name="Kaygisiz, Kübra" userId="4bfbf330-8776-4086-a830-2184b07ba8db" providerId="ADAL" clId="{3BADC0B2-0F94-45F6-B552-1A87FB5F996F}" dt="2022-08-19T12:27:10.025" v="926" actId="1076"/>
          <ac:graphicFrameMkLst>
            <pc:docMk/>
            <pc:sldMk cId="306648616" sldId="480"/>
            <ac:graphicFrameMk id="3" creationId="{39374C9D-165D-DD8E-D4CC-4F69351A138A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1:47:49.295" v="990" actId="1076"/>
        <pc:sldMkLst>
          <pc:docMk/>
          <pc:sldMk cId="1379774886" sldId="481"/>
        </pc:sldMkLst>
        <pc:spChg chg="mod">
          <ac:chgData name="Kaygisiz, Kübra" userId="4bfbf330-8776-4086-a830-2184b07ba8db" providerId="ADAL" clId="{3BADC0B2-0F94-45F6-B552-1A87FB5F996F}" dt="2022-08-21T01:47:46.741" v="988" actId="20577"/>
          <ac:spMkLst>
            <pc:docMk/>
            <pc:sldMk cId="1379774886" sldId="481"/>
            <ac:spMk id="2" creationId="{DA8C2D63-8243-B2A4-2F93-662B0C52562F}"/>
          </ac:spMkLst>
        </pc:spChg>
        <pc:graphicFrameChg chg="add mod">
          <ac:chgData name="Kaygisiz, Kübra" userId="4bfbf330-8776-4086-a830-2184b07ba8db" providerId="ADAL" clId="{3BADC0B2-0F94-45F6-B552-1A87FB5F996F}" dt="2022-08-21T01:47:49.295" v="990" actId="1076"/>
          <ac:graphicFrameMkLst>
            <pc:docMk/>
            <pc:sldMk cId="1379774886" sldId="481"/>
            <ac:graphicFrameMk id="3" creationId="{A80712C3-F7A0-5E09-B3DE-3E3652F9B3D1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1:49:36.132" v="1001" actId="1076"/>
        <pc:sldMkLst>
          <pc:docMk/>
          <pc:sldMk cId="1479216872" sldId="482"/>
        </pc:sldMkLst>
        <pc:spChg chg="mod">
          <ac:chgData name="Kaygisiz, Kübra" userId="4bfbf330-8776-4086-a830-2184b07ba8db" providerId="ADAL" clId="{3BADC0B2-0F94-45F6-B552-1A87FB5F996F}" dt="2022-08-21T01:49:32.897" v="999" actId="20577"/>
          <ac:spMkLst>
            <pc:docMk/>
            <pc:sldMk cId="1479216872" sldId="482"/>
            <ac:spMk id="2" creationId="{EF93788C-BC96-C811-D9C7-A2A1B731D86A}"/>
          </ac:spMkLst>
        </pc:spChg>
        <pc:graphicFrameChg chg="add mod">
          <ac:chgData name="Kaygisiz, Kübra" userId="4bfbf330-8776-4086-a830-2184b07ba8db" providerId="ADAL" clId="{3BADC0B2-0F94-45F6-B552-1A87FB5F996F}" dt="2022-08-21T01:49:36.132" v="1001" actId="1076"/>
          <ac:graphicFrameMkLst>
            <pc:docMk/>
            <pc:sldMk cId="1479216872" sldId="482"/>
            <ac:graphicFrameMk id="3" creationId="{3A4DA96A-7599-32AA-AB2A-10BB8D2D550A}"/>
          </ac:graphicFrameMkLst>
        </pc:graphicFrameChg>
      </pc:sldChg>
      <pc:sldChg chg="addSp modSp new mod">
        <pc:chgData name="Kaygisiz, Kübra" userId="4bfbf330-8776-4086-a830-2184b07ba8db" providerId="ADAL" clId="{3BADC0B2-0F94-45F6-B552-1A87FB5F996F}" dt="2022-08-21T01:50:16.237" v="1009" actId="1076"/>
        <pc:sldMkLst>
          <pc:docMk/>
          <pc:sldMk cId="1225807883" sldId="483"/>
        </pc:sldMkLst>
        <pc:spChg chg="mod">
          <ac:chgData name="Kaygisiz, Kübra" userId="4bfbf330-8776-4086-a830-2184b07ba8db" providerId="ADAL" clId="{3BADC0B2-0F94-45F6-B552-1A87FB5F996F}" dt="2022-08-21T01:50:13.265" v="1007" actId="20577"/>
          <ac:spMkLst>
            <pc:docMk/>
            <pc:sldMk cId="1225807883" sldId="483"/>
            <ac:spMk id="2" creationId="{0D6E8157-0A06-6134-94F2-836F5749B31E}"/>
          </ac:spMkLst>
        </pc:spChg>
        <pc:graphicFrameChg chg="add mod">
          <ac:chgData name="Kaygisiz, Kübra" userId="4bfbf330-8776-4086-a830-2184b07ba8db" providerId="ADAL" clId="{3BADC0B2-0F94-45F6-B552-1A87FB5F996F}" dt="2022-08-21T01:50:16.237" v="1009" actId="1076"/>
          <ac:graphicFrameMkLst>
            <pc:docMk/>
            <pc:sldMk cId="1225807883" sldId="483"/>
            <ac:graphicFrameMk id="3" creationId="{F8746310-210A-3327-7FA6-44EEF20F98EF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FE8E45-8A33-58AF-32B2-8A717CB0DCB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7A77EC3-725E-5816-E8DC-13FCAC77667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0064E1-BE0C-5537-A738-475F65E64A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BB77C-9DB8-4226-A88E-F49645B3469D}" type="datetimeFigureOut">
              <a:rPr lang="de-DE" smtClean="0"/>
              <a:t>24.08.2022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A9034A-368A-DA4B-1991-4573815CC8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E0252D-2562-5AA3-276F-629C8D143F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567FC-B80D-4A6A-B23D-C13CFBC78F4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245668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B28A02-C54B-79ED-3C9B-26048D76C0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389C6B-633A-32C9-AB13-DBF03D7833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87752A-86E6-0296-6249-8C9E320ECA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BB77C-9DB8-4226-A88E-F49645B3469D}" type="datetimeFigureOut">
              <a:rPr lang="de-DE" smtClean="0"/>
              <a:t>24.08.2022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AE2F3B-5D87-AB92-F8FA-D1E57653F9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A753CC-337A-FB65-CE10-5263D0F4E0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567FC-B80D-4A6A-B23D-C13CFBC78F4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369643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6FA453A-021E-BEDC-9863-D2F5F894CB7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EC98263-C2E1-1A0A-B845-E967DA0B3C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A21EFC-4CF8-6F9C-B838-E281DCC41C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BB77C-9DB8-4226-A88E-F49645B3469D}" type="datetimeFigureOut">
              <a:rPr lang="de-DE" smtClean="0"/>
              <a:t>24.08.2022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89E554-5C5A-085F-9EDF-80B30EC4F8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A6CF3C-C110-CAA6-3A3A-295CF9CA85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567FC-B80D-4A6A-B23D-C13CFBC78F4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712035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61DCBA-5117-7453-B486-46423E487F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13D6C4-DFF0-1C58-F2BB-E77E279F62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0D2EEF-D5F1-B48F-261A-7E45E4F600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BB77C-9DB8-4226-A88E-F49645B3469D}" type="datetimeFigureOut">
              <a:rPr lang="de-DE" smtClean="0"/>
              <a:t>24.08.2022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B72C66-BC77-7814-1F46-5D2785FCF5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FD448F-76F6-26D4-C5B1-2DF60849A0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567FC-B80D-4A6A-B23D-C13CFBC78F4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592571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231F25-2302-C027-7350-2B39577254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B8C5C03-07B4-4EEC-7A90-B6822BB7A0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C554AF-1E22-91AA-C0F4-ADE2BC7646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BB77C-9DB8-4226-A88E-F49645B3469D}" type="datetimeFigureOut">
              <a:rPr lang="de-DE" smtClean="0"/>
              <a:t>24.08.2022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3A738F-A4E8-BCAF-20BC-F865279622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58322F-D670-B529-786B-42B7FF247F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567FC-B80D-4A6A-B23D-C13CFBC78F4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83486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91B22B-8DD3-4667-674E-C37201026C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CB4BDAF-961A-F0CC-0822-8823C72B5F7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07A330A-4B98-B3DD-FFA1-E2B62A2F404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82A3B9F-02EA-AC52-0E94-0AEC68BFD3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BB77C-9DB8-4226-A88E-F49645B3469D}" type="datetimeFigureOut">
              <a:rPr lang="de-DE" smtClean="0"/>
              <a:t>24.08.2022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8682DD-13FA-3B3E-CA57-619D7157B8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B8C360-6D01-3DEA-7B21-B10013E55C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567FC-B80D-4A6A-B23D-C13CFBC78F4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18704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86404A-25EE-6111-7386-1F3AE1C0AD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5E1EA3-18B5-5047-57BE-1AC0ECA84B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1D9715B-6EFB-AC4B-F96F-78343C2164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65B4156-2A68-E21E-CA8F-C8DA1A2033A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D7DC98B-8E4F-B55C-D343-09060E3E4DD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46FAF73-F435-6489-39C6-BCAD1B9090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BB77C-9DB8-4226-A88E-F49645B3469D}" type="datetimeFigureOut">
              <a:rPr lang="de-DE" smtClean="0"/>
              <a:t>24.08.2022</a:t>
            </a:fld>
            <a:endParaRPr lang="de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85DAAD2-454D-01FD-3672-D5935B38BD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B845902-712E-88D1-E10C-B27BF0C19C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567FC-B80D-4A6A-B23D-C13CFBC78F4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530674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99BD44-D7BC-9E59-F8DB-57CECE39FF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54F22A1-B657-D63B-58BC-E8E043845C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BB77C-9DB8-4226-A88E-F49645B3469D}" type="datetimeFigureOut">
              <a:rPr lang="de-DE" smtClean="0"/>
              <a:t>24.08.2022</a:t>
            </a:fld>
            <a:endParaRPr lang="de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CCCA80E-D796-F338-09D3-DC296E4C3E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4B22E34-A927-944B-843E-7349CDEE1F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567FC-B80D-4A6A-B23D-C13CFBC78F4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350904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F4590D3-9A28-FBEC-A16D-D2A7D76838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BB77C-9DB8-4226-A88E-F49645B3469D}" type="datetimeFigureOut">
              <a:rPr lang="de-DE" smtClean="0"/>
              <a:t>24.08.2022</a:t>
            </a:fld>
            <a:endParaRPr lang="de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893F1AF-210E-D09D-B145-B4BD372FEB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E3A155D-C519-FB35-6FAF-E3D4453200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567FC-B80D-4A6A-B23D-C13CFBC78F4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12024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9450CB-AB1E-426C-2D8C-E453208D10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8FD836-A713-60D1-9B0B-BA63E1444B5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567F198-A061-4E5E-5183-58C45D32E6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77EED9A-9A25-0130-76FA-5F14DF52FC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BB77C-9DB8-4226-A88E-F49645B3469D}" type="datetimeFigureOut">
              <a:rPr lang="de-DE" smtClean="0"/>
              <a:t>24.08.2022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DA6417-B440-D3D4-3FF0-01624233F4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FE5E6B-5D21-E9CF-442C-F15E341E29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567FC-B80D-4A6A-B23D-C13CFBC78F4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154009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F58070-2646-1B4A-EAE7-764DF93692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723AE0B-1026-C0B9-2AD7-BCD81FCEF2C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E3E7073-B5A8-19E6-F2CE-EEADFEB9F5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B590215-146E-00EB-D996-D6BD4801D1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BB77C-9DB8-4226-A88E-F49645B3469D}" type="datetimeFigureOut">
              <a:rPr lang="de-DE" smtClean="0"/>
              <a:t>24.08.2022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F4F653-8B67-D633-58AF-FAF5F209B3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1FE069-EF31-41BD-A231-041D82739C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567FC-B80D-4A6A-B23D-C13CFBC78F4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260558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4D47486-6EE6-4C05-5301-6CCA9AF4D7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3FE565-AB7E-8597-2756-4ABEDA7510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568502-842A-BB9C-2325-CCDD14E1668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8BB77C-9DB8-4226-A88E-F49645B3469D}" type="datetimeFigureOut">
              <a:rPr lang="de-DE" smtClean="0"/>
              <a:t>24.08.2022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9E4CCB-2D41-637D-509F-2ACA5EE4CBF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47420B-07FA-85F3-08F7-4C3052DCC3D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7567FC-B80D-4A6A-B23D-C13CFBC78F4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4065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w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6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wmf"/><Relationship Id="rId2" Type="http://schemas.openxmlformats.org/officeDocument/2006/relationships/oleObject" Target="../embeddings/oleObject15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16.wmf"/><Relationship Id="rId4" Type="http://schemas.openxmlformats.org/officeDocument/2006/relationships/oleObject" Target="../embeddings/oleObject16.bin"/></Relationships>
</file>

<file path=ppt/slides/_rels/slide10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4.wmf"/><Relationship Id="rId2" Type="http://schemas.openxmlformats.org/officeDocument/2006/relationships/oleObject" Target="../embeddings/oleObject114.bin"/><Relationship Id="rId1" Type="http://schemas.openxmlformats.org/officeDocument/2006/relationships/slideLayout" Target="../slideLayouts/slideLayout6.xml"/></Relationships>
</file>

<file path=ppt/slides/_rels/slide10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5.wmf"/><Relationship Id="rId2" Type="http://schemas.openxmlformats.org/officeDocument/2006/relationships/oleObject" Target="../embeddings/oleObject115.bin"/><Relationship Id="rId1" Type="http://schemas.openxmlformats.org/officeDocument/2006/relationships/slideLayout" Target="../slideLayouts/slideLayout6.xml"/></Relationships>
</file>

<file path=ppt/slides/_rels/slide10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6.wmf"/><Relationship Id="rId2" Type="http://schemas.openxmlformats.org/officeDocument/2006/relationships/oleObject" Target="../embeddings/oleObject116.bin"/><Relationship Id="rId1" Type="http://schemas.openxmlformats.org/officeDocument/2006/relationships/slideLayout" Target="../slideLayouts/slideLayout6.xml"/></Relationships>
</file>

<file path=ppt/slides/_rels/slide10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7.wmf"/><Relationship Id="rId2" Type="http://schemas.openxmlformats.org/officeDocument/2006/relationships/oleObject" Target="../embeddings/oleObject117.bin"/><Relationship Id="rId1" Type="http://schemas.openxmlformats.org/officeDocument/2006/relationships/slideLayout" Target="../slideLayouts/slideLayout6.xml"/></Relationships>
</file>

<file path=ppt/slides/_rels/slide10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8.wmf"/><Relationship Id="rId2" Type="http://schemas.openxmlformats.org/officeDocument/2006/relationships/oleObject" Target="../embeddings/oleObject118.bin"/><Relationship Id="rId1" Type="http://schemas.openxmlformats.org/officeDocument/2006/relationships/slideLayout" Target="../slideLayouts/slideLayout6.xml"/></Relationships>
</file>

<file path=ppt/slides/_rels/slide10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9.wmf"/><Relationship Id="rId2" Type="http://schemas.openxmlformats.org/officeDocument/2006/relationships/oleObject" Target="../embeddings/oleObject119.bin"/><Relationship Id="rId1" Type="http://schemas.openxmlformats.org/officeDocument/2006/relationships/slideLayout" Target="../slideLayouts/slideLayout6.xml"/></Relationships>
</file>

<file path=ppt/slides/_rels/slide10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0.wmf"/><Relationship Id="rId2" Type="http://schemas.openxmlformats.org/officeDocument/2006/relationships/oleObject" Target="../embeddings/oleObject120.bin"/><Relationship Id="rId1" Type="http://schemas.openxmlformats.org/officeDocument/2006/relationships/slideLayout" Target="../slideLayouts/slideLayout6.xml"/></Relationships>
</file>

<file path=ppt/slides/_rels/slide10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1.wmf"/><Relationship Id="rId2" Type="http://schemas.openxmlformats.org/officeDocument/2006/relationships/oleObject" Target="../embeddings/oleObject121.bin"/><Relationship Id="rId1" Type="http://schemas.openxmlformats.org/officeDocument/2006/relationships/slideLayout" Target="../slideLayouts/slideLayout6.xml"/></Relationships>
</file>

<file path=ppt/slides/_rels/slide10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2.wmf"/><Relationship Id="rId2" Type="http://schemas.openxmlformats.org/officeDocument/2006/relationships/oleObject" Target="../embeddings/oleObject122.bin"/><Relationship Id="rId1" Type="http://schemas.openxmlformats.org/officeDocument/2006/relationships/slideLayout" Target="../slideLayouts/slideLayout6.xml"/></Relationships>
</file>

<file path=ppt/slides/_rels/slide10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3.wmf"/><Relationship Id="rId2" Type="http://schemas.openxmlformats.org/officeDocument/2006/relationships/oleObject" Target="../embeddings/oleObject123.bin"/><Relationship Id="rId1" Type="http://schemas.openxmlformats.org/officeDocument/2006/relationships/slideLayout" Target="../slideLayouts/slideLayout6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wmf"/><Relationship Id="rId2" Type="http://schemas.openxmlformats.org/officeDocument/2006/relationships/oleObject" Target="../embeddings/oleObject17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18.wmf"/><Relationship Id="rId4" Type="http://schemas.openxmlformats.org/officeDocument/2006/relationships/oleObject" Target="../embeddings/oleObject18.bin"/></Relationships>
</file>

<file path=ppt/slides/_rels/slide1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4.wmf"/><Relationship Id="rId2" Type="http://schemas.openxmlformats.org/officeDocument/2006/relationships/oleObject" Target="../embeddings/oleObject124.bin"/><Relationship Id="rId1" Type="http://schemas.openxmlformats.org/officeDocument/2006/relationships/slideLayout" Target="../slideLayouts/slideLayout6.xml"/></Relationships>
</file>

<file path=ppt/slides/_rels/slide1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5.wmf"/><Relationship Id="rId2" Type="http://schemas.openxmlformats.org/officeDocument/2006/relationships/oleObject" Target="../embeddings/oleObject125.bin"/><Relationship Id="rId1" Type="http://schemas.openxmlformats.org/officeDocument/2006/relationships/slideLayout" Target="../slideLayouts/slideLayout6.xml"/></Relationships>
</file>

<file path=ppt/slides/_rels/slide1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6.wmf"/><Relationship Id="rId2" Type="http://schemas.openxmlformats.org/officeDocument/2006/relationships/oleObject" Target="../embeddings/oleObject126.bin"/><Relationship Id="rId1" Type="http://schemas.openxmlformats.org/officeDocument/2006/relationships/slideLayout" Target="../slideLayouts/slideLayout6.xml"/></Relationships>
</file>

<file path=ppt/slides/_rels/slide1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7.wmf"/><Relationship Id="rId2" Type="http://schemas.openxmlformats.org/officeDocument/2006/relationships/oleObject" Target="../embeddings/oleObject127.bin"/><Relationship Id="rId1" Type="http://schemas.openxmlformats.org/officeDocument/2006/relationships/slideLayout" Target="../slideLayouts/slideLayout6.xml"/></Relationships>
</file>

<file path=ppt/slides/_rels/slide1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8.wmf"/><Relationship Id="rId2" Type="http://schemas.openxmlformats.org/officeDocument/2006/relationships/oleObject" Target="../embeddings/oleObject128.bin"/><Relationship Id="rId1" Type="http://schemas.openxmlformats.org/officeDocument/2006/relationships/slideLayout" Target="../slideLayouts/slideLayout6.xml"/></Relationships>
</file>

<file path=ppt/slides/_rels/slide1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9.wmf"/><Relationship Id="rId2" Type="http://schemas.openxmlformats.org/officeDocument/2006/relationships/oleObject" Target="../embeddings/oleObject129.bin"/><Relationship Id="rId1" Type="http://schemas.openxmlformats.org/officeDocument/2006/relationships/slideLayout" Target="../slideLayouts/slideLayout6.xml"/></Relationships>
</file>

<file path=ppt/slides/_rels/slide1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0.wmf"/><Relationship Id="rId2" Type="http://schemas.openxmlformats.org/officeDocument/2006/relationships/oleObject" Target="../embeddings/oleObject130.bin"/><Relationship Id="rId1" Type="http://schemas.openxmlformats.org/officeDocument/2006/relationships/slideLayout" Target="../slideLayouts/slideLayout6.xml"/></Relationships>
</file>

<file path=ppt/slides/_rels/slide1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1.wmf"/><Relationship Id="rId2" Type="http://schemas.openxmlformats.org/officeDocument/2006/relationships/oleObject" Target="../embeddings/oleObject131.bin"/><Relationship Id="rId1" Type="http://schemas.openxmlformats.org/officeDocument/2006/relationships/slideLayout" Target="../slideLayouts/slideLayout6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wmf"/><Relationship Id="rId2" Type="http://schemas.openxmlformats.org/officeDocument/2006/relationships/oleObject" Target="../embeddings/oleObject19.bin"/><Relationship Id="rId1" Type="http://schemas.openxmlformats.org/officeDocument/2006/relationships/slideLayout" Target="../slideLayouts/slideLayout6.xml"/></Relationships>
</file>

<file path=ppt/slides/_rels/slide1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2.wmf"/><Relationship Id="rId2" Type="http://schemas.openxmlformats.org/officeDocument/2006/relationships/oleObject" Target="../embeddings/oleObject132.bin"/><Relationship Id="rId1" Type="http://schemas.openxmlformats.org/officeDocument/2006/relationships/slideLayout" Target="../slideLayouts/slideLayout6.xml"/></Relationships>
</file>

<file path=ppt/slides/_rels/slide1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3.wmf"/><Relationship Id="rId2" Type="http://schemas.openxmlformats.org/officeDocument/2006/relationships/oleObject" Target="../embeddings/oleObject133.bin"/><Relationship Id="rId1" Type="http://schemas.openxmlformats.org/officeDocument/2006/relationships/slideLayout" Target="../slideLayouts/slideLayout6.xml"/></Relationships>
</file>

<file path=ppt/slides/_rels/slide1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4.wmf"/><Relationship Id="rId2" Type="http://schemas.openxmlformats.org/officeDocument/2006/relationships/oleObject" Target="../embeddings/oleObject134.bin"/><Relationship Id="rId1" Type="http://schemas.openxmlformats.org/officeDocument/2006/relationships/slideLayout" Target="../slideLayouts/slideLayout6.xml"/></Relationships>
</file>

<file path=ppt/slides/_rels/slide1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5.wmf"/><Relationship Id="rId2" Type="http://schemas.openxmlformats.org/officeDocument/2006/relationships/oleObject" Target="../embeddings/oleObject135.bin"/><Relationship Id="rId1" Type="http://schemas.openxmlformats.org/officeDocument/2006/relationships/slideLayout" Target="../slideLayouts/slideLayout6.xml"/></Relationships>
</file>

<file path=ppt/slides/_rels/slide1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6.wmf"/><Relationship Id="rId2" Type="http://schemas.openxmlformats.org/officeDocument/2006/relationships/oleObject" Target="../embeddings/oleObject136.bin"/><Relationship Id="rId1" Type="http://schemas.openxmlformats.org/officeDocument/2006/relationships/slideLayout" Target="../slideLayouts/slideLayout6.xml"/></Relationships>
</file>

<file path=ppt/slides/_rels/slide1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7.wmf"/><Relationship Id="rId2" Type="http://schemas.openxmlformats.org/officeDocument/2006/relationships/oleObject" Target="../embeddings/oleObject137.bin"/><Relationship Id="rId1" Type="http://schemas.openxmlformats.org/officeDocument/2006/relationships/slideLayout" Target="../slideLayouts/slideLayout6.xml"/></Relationships>
</file>

<file path=ppt/slides/_rels/slide1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8.wmf"/><Relationship Id="rId2" Type="http://schemas.openxmlformats.org/officeDocument/2006/relationships/oleObject" Target="../embeddings/oleObject138.bin"/><Relationship Id="rId1" Type="http://schemas.openxmlformats.org/officeDocument/2006/relationships/slideLayout" Target="../slideLayouts/slideLayout6.xml"/></Relationships>
</file>

<file path=ppt/slides/_rels/slide1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9.wmf"/><Relationship Id="rId2" Type="http://schemas.openxmlformats.org/officeDocument/2006/relationships/oleObject" Target="../embeddings/oleObject139.bin"/><Relationship Id="rId1" Type="http://schemas.openxmlformats.org/officeDocument/2006/relationships/slideLayout" Target="../slideLayouts/slideLayout6.xml"/></Relationships>
</file>

<file path=ppt/slides/_rels/slide1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0.wmf"/><Relationship Id="rId2" Type="http://schemas.openxmlformats.org/officeDocument/2006/relationships/oleObject" Target="../embeddings/oleObject140.bin"/><Relationship Id="rId1" Type="http://schemas.openxmlformats.org/officeDocument/2006/relationships/slideLayout" Target="../slideLayouts/slideLayout6.xml"/></Relationships>
</file>

<file path=ppt/slides/_rels/slide1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1.wmf"/><Relationship Id="rId2" Type="http://schemas.openxmlformats.org/officeDocument/2006/relationships/oleObject" Target="../embeddings/oleObject141.bin"/><Relationship Id="rId1" Type="http://schemas.openxmlformats.org/officeDocument/2006/relationships/slideLayout" Target="../slideLayouts/slideLayout6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wmf"/><Relationship Id="rId2" Type="http://schemas.openxmlformats.org/officeDocument/2006/relationships/oleObject" Target="../embeddings/oleObject20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21.wmf"/><Relationship Id="rId4" Type="http://schemas.openxmlformats.org/officeDocument/2006/relationships/oleObject" Target="../embeddings/oleObject21.bin"/></Relationships>
</file>

<file path=ppt/slides/_rels/slide1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2.wmf"/><Relationship Id="rId2" Type="http://schemas.openxmlformats.org/officeDocument/2006/relationships/oleObject" Target="../embeddings/oleObject142.bin"/><Relationship Id="rId1" Type="http://schemas.openxmlformats.org/officeDocument/2006/relationships/slideLayout" Target="../slideLayouts/slideLayout6.xml"/></Relationships>
</file>

<file path=ppt/slides/_rels/slide1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3.wmf"/><Relationship Id="rId2" Type="http://schemas.openxmlformats.org/officeDocument/2006/relationships/oleObject" Target="../embeddings/oleObject143.bin"/><Relationship Id="rId1" Type="http://schemas.openxmlformats.org/officeDocument/2006/relationships/slideLayout" Target="../slideLayouts/slideLayout6.xml"/></Relationships>
</file>

<file path=ppt/slides/_rels/slide1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4.wmf"/><Relationship Id="rId2" Type="http://schemas.openxmlformats.org/officeDocument/2006/relationships/oleObject" Target="../embeddings/oleObject144.bin"/><Relationship Id="rId1" Type="http://schemas.openxmlformats.org/officeDocument/2006/relationships/slideLayout" Target="../slideLayouts/slideLayout6.xml"/></Relationships>
</file>

<file path=ppt/slides/_rels/slide1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5.wmf"/><Relationship Id="rId2" Type="http://schemas.openxmlformats.org/officeDocument/2006/relationships/oleObject" Target="../embeddings/oleObject145.bin"/><Relationship Id="rId1" Type="http://schemas.openxmlformats.org/officeDocument/2006/relationships/slideLayout" Target="../slideLayouts/slideLayout6.xml"/></Relationships>
</file>

<file path=ppt/slides/_rels/slide1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6.wmf"/><Relationship Id="rId2" Type="http://schemas.openxmlformats.org/officeDocument/2006/relationships/oleObject" Target="../embeddings/oleObject146.bin"/><Relationship Id="rId1" Type="http://schemas.openxmlformats.org/officeDocument/2006/relationships/slideLayout" Target="../slideLayouts/slideLayout6.xml"/></Relationships>
</file>

<file path=ppt/slides/_rels/slide1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7.wmf"/><Relationship Id="rId2" Type="http://schemas.openxmlformats.org/officeDocument/2006/relationships/oleObject" Target="../embeddings/oleObject147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148.wmf"/><Relationship Id="rId4" Type="http://schemas.openxmlformats.org/officeDocument/2006/relationships/oleObject" Target="../embeddings/oleObject148.bin"/></Relationships>
</file>

<file path=ppt/slides/_rels/slide1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9.wmf"/><Relationship Id="rId2" Type="http://schemas.openxmlformats.org/officeDocument/2006/relationships/oleObject" Target="../embeddings/oleObject149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150.wmf"/><Relationship Id="rId4" Type="http://schemas.openxmlformats.org/officeDocument/2006/relationships/oleObject" Target="../embeddings/oleObject150.bin"/></Relationships>
</file>

<file path=ppt/slides/_rels/slide1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1.wmf"/><Relationship Id="rId2" Type="http://schemas.openxmlformats.org/officeDocument/2006/relationships/oleObject" Target="../embeddings/oleObject151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152.wmf"/><Relationship Id="rId4" Type="http://schemas.openxmlformats.org/officeDocument/2006/relationships/oleObject" Target="../embeddings/oleObject152.bin"/></Relationships>
</file>

<file path=ppt/slides/_rels/slide13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3.wmf"/><Relationship Id="rId2" Type="http://schemas.openxmlformats.org/officeDocument/2006/relationships/oleObject" Target="../embeddings/oleObject153.bin"/><Relationship Id="rId1" Type="http://schemas.openxmlformats.org/officeDocument/2006/relationships/slideLayout" Target="../slideLayouts/slideLayout6.xml"/></Relationships>
</file>

<file path=ppt/slides/_rels/slide1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4.wmf"/><Relationship Id="rId2" Type="http://schemas.openxmlformats.org/officeDocument/2006/relationships/oleObject" Target="../embeddings/oleObject154.bin"/><Relationship Id="rId1" Type="http://schemas.openxmlformats.org/officeDocument/2006/relationships/slideLayout" Target="../slideLayouts/slideLayout6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wmf"/><Relationship Id="rId2" Type="http://schemas.openxmlformats.org/officeDocument/2006/relationships/oleObject" Target="../embeddings/oleObject22.bin"/><Relationship Id="rId1" Type="http://schemas.openxmlformats.org/officeDocument/2006/relationships/slideLayout" Target="../slideLayouts/slideLayout6.xml"/></Relationships>
</file>

<file path=ppt/slides/_rels/slide14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5.wmf"/><Relationship Id="rId2" Type="http://schemas.openxmlformats.org/officeDocument/2006/relationships/oleObject" Target="../embeddings/oleObject155.bin"/><Relationship Id="rId1" Type="http://schemas.openxmlformats.org/officeDocument/2006/relationships/slideLayout" Target="../slideLayouts/slideLayout6.xml"/></Relationships>
</file>

<file path=ppt/slides/_rels/slide14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6.wmf"/><Relationship Id="rId2" Type="http://schemas.openxmlformats.org/officeDocument/2006/relationships/oleObject" Target="../embeddings/oleObject156.bin"/><Relationship Id="rId1" Type="http://schemas.openxmlformats.org/officeDocument/2006/relationships/slideLayout" Target="../slideLayouts/slideLayout6.xml"/></Relationships>
</file>

<file path=ppt/slides/_rels/slide14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7.wmf"/><Relationship Id="rId2" Type="http://schemas.openxmlformats.org/officeDocument/2006/relationships/oleObject" Target="../embeddings/oleObject157.bin"/><Relationship Id="rId1" Type="http://schemas.openxmlformats.org/officeDocument/2006/relationships/slideLayout" Target="../slideLayouts/slideLayout6.xml"/></Relationships>
</file>

<file path=ppt/slides/_rels/slide14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8.wmf"/><Relationship Id="rId2" Type="http://schemas.openxmlformats.org/officeDocument/2006/relationships/oleObject" Target="../embeddings/oleObject158.bin"/><Relationship Id="rId1" Type="http://schemas.openxmlformats.org/officeDocument/2006/relationships/slideLayout" Target="../slideLayouts/slideLayout6.xml"/></Relationships>
</file>

<file path=ppt/slides/_rels/slide14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9.wmf"/><Relationship Id="rId2" Type="http://schemas.openxmlformats.org/officeDocument/2006/relationships/oleObject" Target="../embeddings/oleObject159.bin"/><Relationship Id="rId1" Type="http://schemas.openxmlformats.org/officeDocument/2006/relationships/slideLayout" Target="../slideLayouts/slideLayout6.xml"/></Relationships>
</file>

<file path=ppt/slides/_rels/slide14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0.wmf"/><Relationship Id="rId2" Type="http://schemas.openxmlformats.org/officeDocument/2006/relationships/oleObject" Target="../embeddings/oleObject160.bin"/><Relationship Id="rId1" Type="http://schemas.openxmlformats.org/officeDocument/2006/relationships/slideLayout" Target="../slideLayouts/slideLayout6.xml"/></Relationships>
</file>

<file path=ppt/slides/_rels/slide14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1.wmf"/><Relationship Id="rId2" Type="http://schemas.openxmlformats.org/officeDocument/2006/relationships/oleObject" Target="../embeddings/oleObject161.bin"/><Relationship Id="rId1" Type="http://schemas.openxmlformats.org/officeDocument/2006/relationships/slideLayout" Target="../slideLayouts/slideLayout6.xml"/></Relationships>
</file>

<file path=ppt/slides/_rels/slide14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2.wmf"/><Relationship Id="rId2" Type="http://schemas.openxmlformats.org/officeDocument/2006/relationships/oleObject" Target="../embeddings/oleObject162.bin"/><Relationship Id="rId1" Type="http://schemas.openxmlformats.org/officeDocument/2006/relationships/slideLayout" Target="../slideLayouts/slideLayout6.xml"/></Relationships>
</file>

<file path=ppt/slides/_rels/slide14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3.wmf"/><Relationship Id="rId2" Type="http://schemas.openxmlformats.org/officeDocument/2006/relationships/oleObject" Target="../embeddings/oleObject163.bin"/><Relationship Id="rId1" Type="http://schemas.openxmlformats.org/officeDocument/2006/relationships/slideLayout" Target="../slideLayouts/slideLayout6.xml"/></Relationships>
</file>

<file path=ppt/slides/_rels/slide14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4.wmf"/><Relationship Id="rId2" Type="http://schemas.openxmlformats.org/officeDocument/2006/relationships/oleObject" Target="../embeddings/oleObject164.bin"/><Relationship Id="rId1" Type="http://schemas.openxmlformats.org/officeDocument/2006/relationships/slideLayout" Target="../slideLayouts/slideLayout6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wmf"/><Relationship Id="rId2" Type="http://schemas.openxmlformats.org/officeDocument/2006/relationships/oleObject" Target="../embeddings/oleObject23.bin"/><Relationship Id="rId1" Type="http://schemas.openxmlformats.org/officeDocument/2006/relationships/slideLayout" Target="../slideLayouts/slideLayout6.xml"/></Relationships>
</file>

<file path=ppt/slides/_rels/slide15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5.wmf"/><Relationship Id="rId2" Type="http://schemas.openxmlformats.org/officeDocument/2006/relationships/oleObject" Target="../embeddings/oleObject165.bin"/><Relationship Id="rId1" Type="http://schemas.openxmlformats.org/officeDocument/2006/relationships/slideLayout" Target="../slideLayouts/slideLayout6.xml"/></Relationships>
</file>

<file path=ppt/slides/_rels/slide15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6.wmf"/><Relationship Id="rId2" Type="http://schemas.openxmlformats.org/officeDocument/2006/relationships/oleObject" Target="../embeddings/oleObject166.bin"/><Relationship Id="rId1" Type="http://schemas.openxmlformats.org/officeDocument/2006/relationships/slideLayout" Target="../slideLayouts/slideLayout6.xml"/></Relationships>
</file>

<file path=ppt/slides/_rels/slide15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7.wmf"/><Relationship Id="rId2" Type="http://schemas.openxmlformats.org/officeDocument/2006/relationships/oleObject" Target="../embeddings/oleObject167.bin"/><Relationship Id="rId1" Type="http://schemas.openxmlformats.org/officeDocument/2006/relationships/slideLayout" Target="../slideLayouts/slideLayout6.xml"/></Relationships>
</file>

<file path=ppt/slides/_rels/slide15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8.wmf"/><Relationship Id="rId2" Type="http://schemas.openxmlformats.org/officeDocument/2006/relationships/oleObject" Target="../embeddings/oleObject168.bin"/><Relationship Id="rId1" Type="http://schemas.openxmlformats.org/officeDocument/2006/relationships/slideLayout" Target="../slideLayouts/slideLayout6.xml"/></Relationships>
</file>

<file path=ppt/slides/_rels/slide15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9.wmf"/><Relationship Id="rId2" Type="http://schemas.openxmlformats.org/officeDocument/2006/relationships/oleObject" Target="../embeddings/oleObject169.bin"/><Relationship Id="rId1" Type="http://schemas.openxmlformats.org/officeDocument/2006/relationships/slideLayout" Target="../slideLayouts/slideLayout6.xml"/></Relationships>
</file>

<file path=ppt/slides/_rels/slide15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0.wmf"/><Relationship Id="rId2" Type="http://schemas.openxmlformats.org/officeDocument/2006/relationships/oleObject" Target="../embeddings/oleObject170.bin"/><Relationship Id="rId1" Type="http://schemas.openxmlformats.org/officeDocument/2006/relationships/slideLayout" Target="../slideLayouts/slideLayout6.xml"/></Relationships>
</file>

<file path=ppt/slides/_rels/slide15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1.wmf"/><Relationship Id="rId2" Type="http://schemas.openxmlformats.org/officeDocument/2006/relationships/oleObject" Target="../embeddings/oleObject171.bin"/><Relationship Id="rId1" Type="http://schemas.openxmlformats.org/officeDocument/2006/relationships/slideLayout" Target="../slideLayouts/slideLayout6.xml"/></Relationships>
</file>

<file path=ppt/slides/_rels/slide15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2.wmf"/><Relationship Id="rId2" Type="http://schemas.openxmlformats.org/officeDocument/2006/relationships/oleObject" Target="../embeddings/oleObject172.bin"/><Relationship Id="rId1" Type="http://schemas.openxmlformats.org/officeDocument/2006/relationships/slideLayout" Target="../slideLayouts/slideLayout6.xml"/></Relationships>
</file>

<file path=ppt/slides/_rels/slide15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3.wmf"/><Relationship Id="rId2" Type="http://schemas.openxmlformats.org/officeDocument/2006/relationships/oleObject" Target="../embeddings/oleObject173.bin"/><Relationship Id="rId1" Type="http://schemas.openxmlformats.org/officeDocument/2006/relationships/slideLayout" Target="../slideLayouts/slideLayout6.xml"/></Relationships>
</file>

<file path=ppt/slides/_rels/slide15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4.wmf"/><Relationship Id="rId2" Type="http://schemas.openxmlformats.org/officeDocument/2006/relationships/oleObject" Target="../embeddings/oleObject174.bin"/><Relationship Id="rId1" Type="http://schemas.openxmlformats.org/officeDocument/2006/relationships/slideLayout" Target="../slideLayouts/slideLayout6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wmf"/><Relationship Id="rId2" Type="http://schemas.openxmlformats.org/officeDocument/2006/relationships/oleObject" Target="../embeddings/oleObject24.bin"/><Relationship Id="rId1" Type="http://schemas.openxmlformats.org/officeDocument/2006/relationships/slideLayout" Target="../slideLayouts/slideLayout6.xml"/></Relationships>
</file>

<file path=ppt/slides/_rels/slide16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5.wmf"/><Relationship Id="rId2" Type="http://schemas.openxmlformats.org/officeDocument/2006/relationships/oleObject" Target="../embeddings/oleObject175.bin"/><Relationship Id="rId1" Type="http://schemas.openxmlformats.org/officeDocument/2006/relationships/slideLayout" Target="../slideLayouts/slideLayout6.xml"/></Relationships>
</file>

<file path=ppt/slides/_rels/slide16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6.wmf"/><Relationship Id="rId2" Type="http://schemas.openxmlformats.org/officeDocument/2006/relationships/oleObject" Target="../embeddings/oleObject176.bin"/><Relationship Id="rId1" Type="http://schemas.openxmlformats.org/officeDocument/2006/relationships/slideLayout" Target="../slideLayouts/slideLayout6.xml"/></Relationships>
</file>

<file path=ppt/slides/_rels/slide16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7.wmf"/><Relationship Id="rId2" Type="http://schemas.openxmlformats.org/officeDocument/2006/relationships/oleObject" Target="../embeddings/oleObject177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178.wmf"/><Relationship Id="rId4" Type="http://schemas.openxmlformats.org/officeDocument/2006/relationships/oleObject" Target="../embeddings/oleObject178.bin"/></Relationships>
</file>

<file path=ppt/slides/_rels/slide16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9.wmf"/><Relationship Id="rId2" Type="http://schemas.openxmlformats.org/officeDocument/2006/relationships/oleObject" Target="../embeddings/oleObject179.bin"/><Relationship Id="rId1" Type="http://schemas.openxmlformats.org/officeDocument/2006/relationships/slideLayout" Target="../slideLayouts/slideLayout6.xml"/></Relationships>
</file>

<file path=ppt/slides/_rels/slide16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0.wmf"/><Relationship Id="rId2" Type="http://schemas.openxmlformats.org/officeDocument/2006/relationships/oleObject" Target="../embeddings/oleObject180.bin"/><Relationship Id="rId1" Type="http://schemas.openxmlformats.org/officeDocument/2006/relationships/slideLayout" Target="../slideLayouts/slideLayout6.xml"/></Relationships>
</file>

<file path=ppt/slides/_rels/slide16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1.wmf"/><Relationship Id="rId2" Type="http://schemas.openxmlformats.org/officeDocument/2006/relationships/oleObject" Target="../embeddings/oleObject181.bin"/><Relationship Id="rId1" Type="http://schemas.openxmlformats.org/officeDocument/2006/relationships/slideLayout" Target="../slideLayouts/slideLayout6.xml"/></Relationships>
</file>

<file path=ppt/slides/_rels/slide16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6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2.wmf"/><Relationship Id="rId2" Type="http://schemas.openxmlformats.org/officeDocument/2006/relationships/oleObject" Target="../embeddings/oleObject182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183.wmf"/><Relationship Id="rId4" Type="http://schemas.openxmlformats.org/officeDocument/2006/relationships/oleObject" Target="../embeddings/oleObject183.bin"/></Relationships>
</file>

<file path=ppt/slides/_rels/slide16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4.wmf"/><Relationship Id="rId2" Type="http://schemas.openxmlformats.org/officeDocument/2006/relationships/oleObject" Target="../embeddings/oleObject184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185.wmf"/><Relationship Id="rId4" Type="http://schemas.openxmlformats.org/officeDocument/2006/relationships/oleObject" Target="../embeddings/oleObject185.bin"/></Relationships>
</file>

<file path=ppt/slides/_rels/slide16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6.wmf"/><Relationship Id="rId2" Type="http://schemas.openxmlformats.org/officeDocument/2006/relationships/oleObject" Target="../embeddings/oleObject186.bin"/><Relationship Id="rId1" Type="http://schemas.openxmlformats.org/officeDocument/2006/relationships/slideLayout" Target="../slideLayouts/slideLayout6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wmf"/><Relationship Id="rId2" Type="http://schemas.openxmlformats.org/officeDocument/2006/relationships/oleObject" Target="../embeddings/oleObject25.bin"/><Relationship Id="rId1" Type="http://schemas.openxmlformats.org/officeDocument/2006/relationships/slideLayout" Target="../slideLayouts/slideLayout6.xml"/></Relationships>
</file>

<file path=ppt/slides/_rels/slide17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7.wmf"/><Relationship Id="rId2" Type="http://schemas.openxmlformats.org/officeDocument/2006/relationships/oleObject" Target="../embeddings/oleObject187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188.wmf"/><Relationship Id="rId4" Type="http://schemas.openxmlformats.org/officeDocument/2006/relationships/oleObject" Target="../embeddings/oleObject188.bin"/></Relationships>
</file>

<file path=ppt/slides/_rels/slide17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9.wmf"/><Relationship Id="rId2" Type="http://schemas.openxmlformats.org/officeDocument/2006/relationships/oleObject" Target="../embeddings/oleObject189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190.wmf"/><Relationship Id="rId4" Type="http://schemas.openxmlformats.org/officeDocument/2006/relationships/oleObject" Target="../embeddings/oleObject190.bin"/></Relationships>
</file>

<file path=ppt/slides/_rels/slide17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1.wmf"/><Relationship Id="rId2" Type="http://schemas.openxmlformats.org/officeDocument/2006/relationships/oleObject" Target="../embeddings/oleObject191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192.wmf"/><Relationship Id="rId4" Type="http://schemas.openxmlformats.org/officeDocument/2006/relationships/oleObject" Target="../embeddings/oleObject192.bin"/></Relationships>
</file>

<file path=ppt/slides/_rels/slide17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3.wmf"/><Relationship Id="rId2" Type="http://schemas.openxmlformats.org/officeDocument/2006/relationships/oleObject" Target="../embeddings/oleObject193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194.wmf"/><Relationship Id="rId4" Type="http://schemas.openxmlformats.org/officeDocument/2006/relationships/oleObject" Target="../embeddings/oleObject194.bin"/></Relationships>
</file>

<file path=ppt/slides/_rels/slide17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5.wmf"/><Relationship Id="rId2" Type="http://schemas.openxmlformats.org/officeDocument/2006/relationships/oleObject" Target="../embeddings/oleObject195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196.wmf"/><Relationship Id="rId4" Type="http://schemas.openxmlformats.org/officeDocument/2006/relationships/oleObject" Target="../embeddings/oleObject196.bin"/></Relationships>
</file>

<file path=ppt/slides/_rels/slide17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7.wmf"/><Relationship Id="rId2" Type="http://schemas.openxmlformats.org/officeDocument/2006/relationships/oleObject" Target="../embeddings/oleObject197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198.wmf"/><Relationship Id="rId4" Type="http://schemas.openxmlformats.org/officeDocument/2006/relationships/oleObject" Target="../embeddings/oleObject198.bin"/></Relationships>
</file>

<file path=ppt/slides/_rels/slide17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9.wmf"/><Relationship Id="rId2" Type="http://schemas.openxmlformats.org/officeDocument/2006/relationships/oleObject" Target="../embeddings/oleObject199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200.wmf"/><Relationship Id="rId4" Type="http://schemas.openxmlformats.org/officeDocument/2006/relationships/oleObject" Target="../embeddings/oleObject200.bin"/></Relationships>
</file>

<file path=ppt/slides/_rels/slide17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1.wmf"/><Relationship Id="rId2" Type="http://schemas.openxmlformats.org/officeDocument/2006/relationships/oleObject" Target="../embeddings/oleObject201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202.wmf"/><Relationship Id="rId4" Type="http://schemas.openxmlformats.org/officeDocument/2006/relationships/oleObject" Target="../embeddings/oleObject202.bin"/></Relationships>
</file>

<file path=ppt/slides/_rels/slide17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3.wmf"/><Relationship Id="rId2" Type="http://schemas.openxmlformats.org/officeDocument/2006/relationships/oleObject" Target="../embeddings/oleObject203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204.wmf"/><Relationship Id="rId4" Type="http://schemas.openxmlformats.org/officeDocument/2006/relationships/oleObject" Target="../embeddings/oleObject204.bin"/></Relationships>
</file>

<file path=ppt/slides/_rels/slide17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5.wmf"/><Relationship Id="rId2" Type="http://schemas.openxmlformats.org/officeDocument/2006/relationships/oleObject" Target="../embeddings/oleObject205.bin"/><Relationship Id="rId1" Type="http://schemas.openxmlformats.org/officeDocument/2006/relationships/slideLayout" Target="../slideLayouts/slideLayout6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wmf"/><Relationship Id="rId2" Type="http://schemas.openxmlformats.org/officeDocument/2006/relationships/oleObject" Target="../embeddings/oleObject26.bin"/><Relationship Id="rId1" Type="http://schemas.openxmlformats.org/officeDocument/2006/relationships/slideLayout" Target="../slideLayouts/slideLayout6.xml"/></Relationships>
</file>

<file path=ppt/slides/_rels/slide18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6.wmf"/><Relationship Id="rId2" Type="http://schemas.openxmlformats.org/officeDocument/2006/relationships/oleObject" Target="../embeddings/oleObject206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207.wmf"/><Relationship Id="rId4" Type="http://schemas.openxmlformats.org/officeDocument/2006/relationships/oleObject" Target="../embeddings/oleObject207.bin"/></Relationships>
</file>

<file path=ppt/slides/_rels/slide18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8.wmf"/><Relationship Id="rId2" Type="http://schemas.openxmlformats.org/officeDocument/2006/relationships/oleObject" Target="../embeddings/oleObject208.bin"/><Relationship Id="rId1" Type="http://schemas.openxmlformats.org/officeDocument/2006/relationships/slideLayout" Target="../slideLayouts/slideLayout6.xml"/></Relationships>
</file>

<file path=ppt/slides/_rels/slide18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9.wmf"/><Relationship Id="rId2" Type="http://schemas.openxmlformats.org/officeDocument/2006/relationships/oleObject" Target="../embeddings/oleObject209.bin"/><Relationship Id="rId1" Type="http://schemas.openxmlformats.org/officeDocument/2006/relationships/slideLayout" Target="../slideLayouts/slideLayout6.xml"/></Relationships>
</file>

<file path=ppt/slides/_rels/slide18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0.wmf"/><Relationship Id="rId2" Type="http://schemas.openxmlformats.org/officeDocument/2006/relationships/oleObject" Target="../embeddings/oleObject210.bin"/><Relationship Id="rId1" Type="http://schemas.openxmlformats.org/officeDocument/2006/relationships/slideLayout" Target="../slideLayouts/slideLayout6.xml"/></Relationships>
</file>

<file path=ppt/slides/_rels/slide18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1.wmf"/><Relationship Id="rId2" Type="http://schemas.openxmlformats.org/officeDocument/2006/relationships/oleObject" Target="../embeddings/oleObject211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212.wmf"/><Relationship Id="rId4" Type="http://schemas.openxmlformats.org/officeDocument/2006/relationships/oleObject" Target="../embeddings/oleObject212.bin"/></Relationships>
</file>

<file path=ppt/slides/_rels/slide18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3.wmf"/><Relationship Id="rId2" Type="http://schemas.openxmlformats.org/officeDocument/2006/relationships/oleObject" Target="../embeddings/oleObject213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214.wmf"/><Relationship Id="rId4" Type="http://schemas.openxmlformats.org/officeDocument/2006/relationships/oleObject" Target="../embeddings/oleObject214.bin"/></Relationships>
</file>

<file path=ppt/slides/_rels/slide18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5.wmf"/><Relationship Id="rId2" Type="http://schemas.openxmlformats.org/officeDocument/2006/relationships/oleObject" Target="../embeddings/oleObject215.bin"/><Relationship Id="rId1" Type="http://schemas.openxmlformats.org/officeDocument/2006/relationships/slideLayout" Target="../slideLayouts/slideLayout6.xml"/></Relationships>
</file>

<file path=ppt/slides/_rels/slide18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6.wmf"/><Relationship Id="rId2" Type="http://schemas.openxmlformats.org/officeDocument/2006/relationships/oleObject" Target="../embeddings/oleObject216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217.wmf"/><Relationship Id="rId4" Type="http://schemas.openxmlformats.org/officeDocument/2006/relationships/oleObject" Target="../embeddings/oleObject217.bin"/></Relationships>
</file>

<file path=ppt/slides/_rels/slide18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8.wmf"/><Relationship Id="rId2" Type="http://schemas.openxmlformats.org/officeDocument/2006/relationships/oleObject" Target="../embeddings/oleObject218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219.wmf"/><Relationship Id="rId4" Type="http://schemas.openxmlformats.org/officeDocument/2006/relationships/oleObject" Target="../embeddings/oleObject219.bin"/></Relationships>
</file>

<file path=ppt/slides/_rels/slide18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0.wmf"/><Relationship Id="rId2" Type="http://schemas.openxmlformats.org/officeDocument/2006/relationships/oleObject" Target="../embeddings/oleObject220.bin"/><Relationship Id="rId1" Type="http://schemas.openxmlformats.org/officeDocument/2006/relationships/slideLayout" Target="../slideLayouts/slideLayout6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wmf"/><Relationship Id="rId2" Type="http://schemas.openxmlformats.org/officeDocument/2006/relationships/oleObject" Target="../embeddings/oleObject27.bin"/><Relationship Id="rId1" Type="http://schemas.openxmlformats.org/officeDocument/2006/relationships/slideLayout" Target="../slideLayouts/slideLayout6.xml"/></Relationships>
</file>

<file path=ppt/slides/_rels/slide19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1.wmf"/><Relationship Id="rId2" Type="http://schemas.openxmlformats.org/officeDocument/2006/relationships/oleObject" Target="../embeddings/oleObject221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222.wmf"/><Relationship Id="rId4" Type="http://schemas.openxmlformats.org/officeDocument/2006/relationships/oleObject" Target="../embeddings/oleObject222.bin"/></Relationships>
</file>

<file path=ppt/slides/_rels/slide19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3.wmf"/><Relationship Id="rId2" Type="http://schemas.openxmlformats.org/officeDocument/2006/relationships/oleObject" Target="../embeddings/oleObject223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224.wmf"/><Relationship Id="rId4" Type="http://schemas.openxmlformats.org/officeDocument/2006/relationships/oleObject" Target="../embeddings/oleObject224.bin"/></Relationships>
</file>

<file path=ppt/slides/_rels/slide19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5.wmf"/><Relationship Id="rId2" Type="http://schemas.openxmlformats.org/officeDocument/2006/relationships/oleObject" Target="../embeddings/oleObject225.bin"/><Relationship Id="rId1" Type="http://schemas.openxmlformats.org/officeDocument/2006/relationships/slideLayout" Target="../slideLayouts/slideLayout6.xml"/></Relationships>
</file>

<file path=ppt/slides/_rels/slide19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6.wmf"/><Relationship Id="rId2" Type="http://schemas.openxmlformats.org/officeDocument/2006/relationships/oleObject" Target="../embeddings/oleObject226.bin"/><Relationship Id="rId1" Type="http://schemas.openxmlformats.org/officeDocument/2006/relationships/slideLayout" Target="../slideLayouts/slideLayout6.xml"/></Relationships>
</file>

<file path=ppt/slides/_rels/slide19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7.wmf"/><Relationship Id="rId2" Type="http://schemas.openxmlformats.org/officeDocument/2006/relationships/oleObject" Target="../embeddings/oleObject227.bin"/><Relationship Id="rId1" Type="http://schemas.openxmlformats.org/officeDocument/2006/relationships/slideLayout" Target="../slideLayouts/slideLayout6.xml"/></Relationships>
</file>

<file path=ppt/slides/_rels/slide19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8.wmf"/><Relationship Id="rId2" Type="http://schemas.openxmlformats.org/officeDocument/2006/relationships/oleObject" Target="../embeddings/oleObject228.bin"/><Relationship Id="rId1" Type="http://schemas.openxmlformats.org/officeDocument/2006/relationships/slideLayout" Target="../slideLayouts/slideLayout6.xml"/></Relationships>
</file>

<file path=ppt/slides/_rels/slide19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9.wmf"/><Relationship Id="rId2" Type="http://schemas.openxmlformats.org/officeDocument/2006/relationships/oleObject" Target="../embeddings/oleObject229.bin"/><Relationship Id="rId1" Type="http://schemas.openxmlformats.org/officeDocument/2006/relationships/slideLayout" Target="../slideLayouts/slideLayout6.xml"/></Relationships>
</file>

<file path=ppt/slides/_rels/slide19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0.wmf"/><Relationship Id="rId2" Type="http://schemas.openxmlformats.org/officeDocument/2006/relationships/oleObject" Target="../embeddings/oleObject230.bin"/><Relationship Id="rId1" Type="http://schemas.openxmlformats.org/officeDocument/2006/relationships/slideLayout" Target="../slideLayouts/slideLayout6.xml"/></Relationships>
</file>

<file path=ppt/slides/_rels/slide19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1.wmf"/><Relationship Id="rId2" Type="http://schemas.openxmlformats.org/officeDocument/2006/relationships/oleObject" Target="../embeddings/oleObject231.bin"/><Relationship Id="rId1" Type="http://schemas.openxmlformats.org/officeDocument/2006/relationships/slideLayout" Target="../slideLayouts/slideLayout6.xml"/></Relationships>
</file>

<file path=ppt/slides/_rels/slide19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2.wmf"/><Relationship Id="rId2" Type="http://schemas.openxmlformats.org/officeDocument/2006/relationships/oleObject" Target="../embeddings/oleObject232.bin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w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3.wmf"/><Relationship Id="rId4" Type="http://schemas.openxmlformats.org/officeDocument/2006/relationships/oleObject" Target="../embeddings/oleObject3.bin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wmf"/><Relationship Id="rId2" Type="http://schemas.openxmlformats.org/officeDocument/2006/relationships/oleObject" Target="../embeddings/oleObject28.bin"/><Relationship Id="rId1" Type="http://schemas.openxmlformats.org/officeDocument/2006/relationships/slideLayout" Target="../slideLayouts/slideLayout6.xml"/></Relationships>
</file>

<file path=ppt/slides/_rels/slide20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3.wmf"/><Relationship Id="rId2" Type="http://schemas.openxmlformats.org/officeDocument/2006/relationships/oleObject" Target="../embeddings/oleObject233.bin"/><Relationship Id="rId1" Type="http://schemas.openxmlformats.org/officeDocument/2006/relationships/slideLayout" Target="../slideLayouts/slideLayout6.xml"/></Relationships>
</file>

<file path=ppt/slides/_rels/slide20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4.wmf"/><Relationship Id="rId2" Type="http://schemas.openxmlformats.org/officeDocument/2006/relationships/oleObject" Target="../embeddings/oleObject234.bin"/><Relationship Id="rId1" Type="http://schemas.openxmlformats.org/officeDocument/2006/relationships/slideLayout" Target="../slideLayouts/slideLayout6.xml"/></Relationships>
</file>

<file path=ppt/slides/_rels/slide20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5.wmf"/><Relationship Id="rId2" Type="http://schemas.openxmlformats.org/officeDocument/2006/relationships/oleObject" Target="../embeddings/oleObject235.bin"/><Relationship Id="rId1" Type="http://schemas.openxmlformats.org/officeDocument/2006/relationships/slideLayout" Target="../slideLayouts/slideLayout6.xml"/></Relationships>
</file>

<file path=ppt/slides/_rels/slide20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6.wmf"/><Relationship Id="rId2" Type="http://schemas.openxmlformats.org/officeDocument/2006/relationships/oleObject" Target="../embeddings/oleObject236.bin"/><Relationship Id="rId1" Type="http://schemas.openxmlformats.org/officeDocument/2006/relationships/slideLayout" Target="../slideLayouts/slideLayout6.xml"/></Relationships>
</file>

<file path=ppt/slides/_rels/slide20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7.wmf"/><Relationship Id="rId2" Type="http://schemas.openxmlformats.org/officeDocument/2006/relationships/oleObject" Target="../embeddings/oleObject237.bin"/><Relationship Id="rId1" Type="http://schemas.openxmlformats.org/officeDocument/2006/relationships/slideLayout" Target="../slideLayouts/slideLayout6.xml"/></Relationships>
</file>

<file path=ppt/slides/_rels/slide20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8.wmf"/><Relationship Id="rId2" Type="http://schemas.openxmlformats.org/officeDocument/2006/relationships/oleObject" Target="../embeddings/oleObject238.bin"/><Relationship Id="rId1" Type="http://schemas.openxmlformats.org/officeDocument/2006/relationships/slideLayout" Target="../slideLayouts/slideLayout6.xml"/></Relationships>
</file>

<file path=ppt/slides/_rels/slide20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9.wmf"/><Relationship Id="rId2" Type="http://schemas.openxmlformats.org/officeDocument/2006/relationships/oleObject" Target="../embeddings/oleObject239.bin"/><Relationship Id="rId1" Type="http://schemas.openxmlformats.org/officeDocument/2006/relationships/slideLayout" Target="../slideLayouts/slideLayout6.xml"/></Relationships>
</file>

<file path=ppt/slides/_rels/slide20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0.wmf"/><Relationship Id="rId2" Type="http://schemas.openxmlformats.org/officeDocument/2006/relationships/oleObject" Target="../embeddings/oleObject240.bin"/><Relationship Id="rId1" Type="http://schemas.openxmlformats.org/officeDocument/2006/relationships/slideLayout" Target="../slideLayouts/slideLayout6.xml"/></Relationships>
</file>

<file path=ppt/slides/_rels/slide20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1.wmf"/><Relationship Id="rId2" Type="http://schemas.openxmlformats.org/officeDocument/2006/relationships/oleObject" Target="../embeddings/oleObject241.bin"/><Relationship Id="rId1" Type="http://schemas.openxmlformats.org/officeDocument/2006/relationships/slideLayout" Target="../slideLayouts/slideLayout6.xml"/></Relationships>
</file>

<file path=ppt/slides/_rels/slide20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2.wmf"/><Relationship Id="rId2" Type="http://schemas.openxmlformats.org/officeDocument/2006/relationships/oleObject" Target="../embeddings/oleObject242.bin"/><Relationship Id="rId1" Type="http://schemas.openxmlformats.org/officeDocument/2006/relationships/slideLayout" Target="../slideLayouts/slideLayout6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wmf"/><Relationship Id="rId2" Type="http://schemas.openxmlformats.org/officeDocument/2006/relationships/oleObject" Target="../embeddings/oleObject29.bin"/><Relationship Id="rId1" Type="http://schemas.openxmlformats.org/officeDocument/2006/relationships/slideLayout" Target="../slideLayouts/slideLayout6.xml"/></Relationships>
</file>

<file path=ppt/slides/_rels/slide2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3.wmf"/><Relationship Id="rId2" Type="http://schemas.openxmlformats.org/officeDocument/2006/relationships/oleObject" Target="../embeddings/oleObject243.bin"/><Relationship Id="rId1" Type="http://schemas.openxmlformats.org/officeDocument/2006/relationships/slideLayout" Target="../slideLayouts/slideLayout6.xml"/></Relationships>
</file>

<file path=ppt/slides/_rels/slide2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4.wmf"/><Relationship Id="rId2" Type="http://schemas.openxmlformats.org/officeDocument/2006/relationships/oleObject" Target="../embeddings/oleObject244.bin"/><Relationship Id="rId1" Type="http://schemas.openxmlformats.org/officeDocument/2006/relationships/slideLayout" Target="../slideLayouts/slideLayout6.xml"/></Relationships>
</file>

<file path=ppt/slides/_rels/slide2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5.wmf"/><Relationship Id="rId2" Type="http://schemas.openxmlformats.org/officeDocument/2006/relationships/oleObject" Target="../embeddings/oleObject245.bin"/><Relationship Id="rId1" Type="http://schemas.openxmlformats.org/officeDocument/2006/relationships/slideLayout" Target="../slideLayouts/slideLayout6.xml"/></Relationships>
</file>

<file path=ppt/slides/_rels/slide2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6.wmf"/><Relationship Id="rId2" Type="http://schemas.openxmlformats.org/officeDocument/2006/relationships/oleObject" Target="../embeddings/oleObject246.bin"/><Relationship Id="rId1" Type="http://schemas.openxmlformats.org/officeDocument/2006/relationships/slideLayout" Target="../slideLayouts/slideLayout6.xml"/></Relationships>
</file>

<file path=ppt/slides/_rels/slide2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7.wmf"/><Relationship Id="rId2" Type="http://schemas.openxmlformats.org/officeDocument/2006/relationships/oleObject" Target="../embeddings/oleObject247.bin"/><Relationship Id="rId1" Type="http://schemas.openxmlformats.org/officeDocument/2006/relationships/slideLayout" Target="../slideLayouts/slideLayout6.xml"/></Relationships>
</file>

<file path=ppt/slides/_rels/slide2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8.wmf"/><Relationship Id="rId2" Type="http://schemas.openxmlformats.org/officeDocument/2006/relationships/oleObject" Target="../embeddings/oleObject248.bin"/><Relationship Id="rId1" Type="http://schemas.openxmlformats.org/officeDocument/2006/relationships/slideLayout" Target="../slideLayouts/slideLayout6.xml"/></Relationships>
</file>

<file path=ppt/slides/_rels/slide2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9.wmf"/><Relationship Id="rId2" Type="http://schemas.openxmlformats.org/officeDocument/2006/relationships/oleObject" Target="../embeddings/oleObject249.bin"/><Relationship Id="rId1" Type="http://schemas.openxmlformats.org/officeDocument/2006/relationships/slideLayout" Target="../slideLayouts/slideLayout6.xml"/></Relationships>
</file>

<file path=ppt/slides/_rels/slide2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0.wmf"/><Relationship Id="rId2" Type="http://schemas.openxmlformats.org/officeDocument/2006/relationships/oleObject" Target="../embeddings/oleObject250.bin"/><Relationship Id="rId1" Type="http://schemas.openxmlformats.org/officeDocument/2006/relationships/slideLayout" Target="../slideLayouts/slideLayout6.xml"/></Relationships>
</file>

<file path=ppt/slides/_rels/slide2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1.wmf"/><Relationship Id="rId2" Type="http://schemas.openxmlformats.org/officeDocument/2006/relationships/oleObject" Target="../embeddings/oleObject251.bin"/><Relationship Id="rId1" Type="http://schemas.openxmlformats.org/officeDocument/2006/relationships/slideLayout" Target="../slideLayouts/slideLayout6.xml"/></Relationships>
</file>

<file path=ppt/slides/_rels/slide2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2.wmf"/><Relationship Id="rId2" Type="http://schemas.openxmlformats.org/officeDocument/2006/relationships/oleObject" Target="../embeddings/oleObject252.bin"/><Relationship Id="rId1" Type="http://schemas.openxmlformats.org/officeDocument/2006/relationships/slideLayout" Target="../slideLayouts/slideLayout6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wmf"/><Relationship Id="rId2" Type="http://schemas.openxmlformats.org/officeDocument/2006/relationships/oleObject" Target="../embeddings/oleObject30.bin"/><Relationship Id="rId1" Type="http://schemas.openxmlformats.org/officeDocument/2006/relationships/slideLayout" Target="../slideLayouts/slideLayout6.xml"/></Relationships>
</file>

<file path=ppt/slides/_rels/slide2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3.wmf"/><Relationship Id="rId2" Type="http://schemas.openxmlformats.org/officeDocument/2006/relationships/oleObject" Target="../embeddings/oleObject253.bin"/><Relationship Id="rId1" Type="http://schemas.openxmlformats.org/officeDocument/2006/relationships/slideLayout" Target="../slideLayouts/slideLayout6.xml"/></Relationships>
</file>

<file path=ppt/slides/_rels/slide2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4.wmf"/><Relationship Id="rId2" Type="http://schemas.openxmlformats.org/officeDocument/2006/relationships/oleObject" Target="../embeddings/oleObject254.bin"/><Relationship Id="rId1" Type="http://schemas.openxmlformats.org/officeDocument/2006/relationships/slideLayout" Target="../slideLayouts/slideLayout6.xml"/></Relationships>
</file>

<file path=ppt/slides/_rels/slide2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5.wmf"/><Relationship Id="rId2" Type="http://schemas.openxmlformats.org/officeDocument/2006/relationships/oleObject" Target="../embeddings/oleObject255.bin"/><Relationship Id="rId1" Type="http://schemas.openxmlformats.org/officeDocument/2006/relationships/slideLayout" Target="../slideLayouts/slideLayout6.xml"/></Relationships>
</file>

<file path=ppt/slides/_rels/slide2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6.wmf"/><Relationship Id="rId2" Type="http://schemas.openxmlformats.org/officeDocument/2006/relationships/oleObject" Target="../embeddings/oleObject256.bin"/><Relationship Id="rId1" Type="http://schemas.openxmlformats.org/officeDocument/2006/relationships/slideLayout" Target="../slideLayouts/slideLayout6.xml"/></Relationships>
</file>

<file path=ppt/slides/_rels/slide2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7.wmf"/><Relationship Id="rId2" Type="http://schemas.openxmlformats.org/officeDocument/2006/relationships/oleObject" Target="../embeddings/oleObject257.bin"/><Relationship Id="rId1" Type="http://schemas.openxmlformats.org/officeDocument/2006/relationships/slideLayout" Target="../slideLayouts/slideLayout6.xml"/></Relationships>
</file>

<file path=ppt/slides/_rels/slide2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8.wmf"/><Relationship Id="rId2" Type="http://schemas.openxmlformats.org/officeDocument/2006/relationships/oleObject" Target="../embeddings/oleObject258.bin"/><Relationship Id="rId1" Type="http://schemas.openxmlformats.org/officeDocument/2006/relationships/slideLayout" Target="../slideLayouts/slideLayout6.xml"/></Relationships>
</file>

<file path=ppt/slides/_rels/slide2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9.wmf"/><Relationship Id="rId2" Type="http://schemas.openxmlformats.org/officeDocument/2006/relationships/oleObject" Target="../embeddings/oleObject259.bin"/><Relationship Id="rId1" Type="http://schemas.openxmlformats.org/officeDocument/2006/relationships/slideLayout" Target="../slideLayouts/slideLayout6.xml"/></Relationships>
</file>

<file path=ppt/slides/_rels/slide2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0.wmf"/><Relationship Id="rId2" Type="http://schemas.openxmlformats.org/officeDocument/2006/relationships/oleObject" Target="../embeddings/oleObject260.bin"/><Relationship Id="rId1" Type="http://schemas.openxmlformats.org/officeDocument/2006/relationships/slideLayout" Target="../slideLayouts/slideLayout6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wmf"/><Relationship Id="rId2" Type="http://schemas.openxmlformats.org/officeDocument/2006/relationships/oleObject" Target="../embeddings/oleObject31.bin"/><Relationship Id="rId1" Type="http://schemas.openxmlformats.org/officeDocument/2006/relationships/slideLayout" Target="../slideLayouts/slideLayout6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wmf"/><Relationship Id="rId2" Type="http://schemas.openxmlformats.org/officeDocument/2006/relationships/oleObject" Target="../embeddings/oleObject32.bin"/><Relationship Id="rId1" Type="http://schemas.openxmlformats.org/officeDocument/2006/relationships/slideLayout" Target="../slideLayouts/slideLayout6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wmf"/><Relationship Id="rId2" Type="http://schemas.openxmlformats.org/officeDocument/2006/relationships/oleObject" Target="../embeddings/oleObject33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34.wmf"/><Relationship Id="rId4" Type="http://schemas.openxmlformats.org/officeDocument/2006/relationships/oleObject" Target="../embeddings/oleObject34.bin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wmf"/><Relationship Id="rId2" Type="http://schemas.openxmlformats.org/officeDocument/2006/relationships/oleObject" Target="../embeddings/oleObject35.bin"/><Relationship Id="rId1" Type="http://schemas.openxmlformats.org/officeDocument/2006/relationships/slideLayout" Target="../slideLayouts/slideLayout6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wmf"/><Relationship Id="rId2" Type="http://schemas.openxmlformats.org/officeDocument/2006/relationships/oleObject" Target="../embeddings/oleObject36.bin"/><Relationship Id="rId1" Type="http://schemas.openxmlformats.org/officeDocument/2006/relationships/slideLayout" Target="../slideLayouts/slideLayout6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wmf"/><Relationship Id="rId2" Type="http://schemas.openxmlformats.org/officeDocument/2006/relationships/oleObject" Target="../embeddings/oleObject37.bin"/><Relationship Id="rId1" Type="http://schemas.openxmlformats.org/officeDocument/2006/relationships/slideLayout" Target="../slideLayouts/slideLayout6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wmf"/><Relationship Id="rId2" Type="http://schemas.openxmlformats.org/officeDocument/2006/relationships/oleObject" Target="../embeddings/oleObject38.bin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w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6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wmf"/><Relationship Id="rId2" Type="http://schemas.openxmlformats.org/officeDocument/2006/relationships/oleObject" Target="../embeddings/oleObject39.bin"/><Relationship Id="rId1" Type="http://schemas.openxmlformats.org/officeDocument/2006/relationships/slideLayout" Target="../slideLayouts/slideLayout6.xml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wmf"/><Relationship Id="rId2" Type="http://schemas.openxmlformats.org/officeDocument/2006/relationships/oleObject" Target="../embeddings/oleObject40.bin"/><Relationship Id="rId1" Type="http://schemas.openxmlformats.org/officeDocument/2006/relationships/slideLayout" Target="../slideLayouts/slideLayout6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wmf"/><Relationship Id="rId2" Type="http://schemas.openxmlformats.org/officeDocument/2006/relationships/oleObject" Target="../embeddings/oleObject41.bin"/><Relationship Id="rId1" Type="http://schemas.openxmlformats.org/officeDocument/2006/relationships/slideLayout" Target="../slideLayouts/slideLayout6.xml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wmf"/><Relationship Id="rId2" Type="http://schemas.openxmlformats.org/officeDocument/2006/relationships/oleObject" Target="../embeddings/oleObject42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43.wmf"/><Relationship Id="rId4" Type="http://schemas.openxmlformats.org/officeDocument/2006/relationships/oleObject" Target="../embeddings/oleObject43.bin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wmf"/><Relationship Id="rId2" Type="http://schemas.openxmlformats.org/officeDocument/2006/relationships/oleObject" Target="../embeddings/oleObject44.bin"/><Relationship Id="rId1" Type="http://schemas.openxmlformats.org/officeDocument/2006/relationships/slideLayout" Target="../slideLayouts/slideLayout6.xml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wmf"/><Relationship Id="rId2" Type="http://schemas.openxmlformats.org/officeDocument/2006/relationships/oleObject" Target="../embeddings/oleObject45.bin"/><Relationship Id="rId1" Type="http://schemas.openxmlformats.org/officeDocument/2006/relationships/slideLayout" Target="../slideLayouts/slideLayout6.xml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wmf"/><Relationship Id="rId2" Type="http://schemas.openxmlformats.org/officeDocument/2006/relationships/oleObject" Target="../embeddings/oleObject46.bin"/><Relationship Id="rId1" Type="http://schemas.openxmlformats.org/officeDocument/2006/relationships/slideLayout" Target="../slideLayouts/slideLayout6.xml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wmf"/><Relationship Id="rId2" Type="http://schemas.openxmlformats.org/officeDocument/2006/relationships/oleObject" Target="../embeddings/oleObject47.bin"/><Relationship Id="rId1" Type="http://schemas.openxmlformats.org/officeDocument/2006/relationships/slideLayout" Target="../slideLayouts/slideLayout6.xml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wmf"/><Relationship Id="rId2" Type="http://schemas.openxmlformats.org/officeDocument/2006/relationships/oleObject" Target="../embeddings/oleObject48.bin"/><Relationship Id="rId1" Type="http://schemas.openxmlformats.org/officeDocument/2006/relationships/slideLayout" Target="../slideLayouts/slideLayout6.xml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wmf"/><Relationship Id="rId2" Type="http://schemas.openxmlformats.org/officeDocument/2006/relationships/oleObject" Target="../embeddings/oleObject49.bin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wmf"/><Relationship Id="rId7" Type="http://schemas.openxmlformats.org/officeDocument/2006/relationships/image" Target="../media/image7.w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6.xml"/><Relationship Id="rId6" Type="http://schemas.openxmlformats.org/officeDocument/2006/relationships/oleObject" Target="../embeddings/oleObject7.bin"/><Relationship Id="rId5" Type="http://schemas.openxmlformats.org/officeDocument/2006/relationships/image" Target="../media/image6.wmf"/><Relationship Id="rId4" Type="http://schemas.openxmlformats.org/officeDocument/2006/relationships/oleObject" Target="../embeddings/oleObject6.bin"/></Relationships>
</file>

<file path=ppt/slides/_rels/slide4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wmf"/><Relationship Id="rId2" Type="http://schemas.openxmlformats.org/officeDocument/2006/relationships/oleObject" Target="../embeddings/oleObject50.bin"/><Relationship Id="rId1" Type="http://schemas.openxmlformats.org/officeDocument/2006/relationships/slideLayout" Target="../slideLayouts/slideLayout6.xml"/></Relationships>
</file>

<file path=ppt/slides/_rels/slide4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wmf"/><Relationship Id="rId2" Type="http://schemas.openxmlformats.org/officeDocument/2006/relationships/oleObject" Target="../embeddings/oleObject51.bin"/><Relationship Id="rId1" Type="http://schemas.openxmlformats.org/officeDocument/2006/relationships/slideLayout" Target="../slideLayouts/slideLayout6.xml"/></Relationships>
</file>

<file path=ppt/slides/_rels/slide4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wmf"/><Relationship Id="rId2" Type="http://schemas.openxmlformats.org/officeDocument/2006/relationships/oleObject" Target="../embeddings/oleObject52.bin"/><Relationship Id="rId1" Type="http://schemas.openxmlformats.org/officeDocument/2006/relationships/slideLayout" Target="../slideLayouts/slideLayout6.xml"/></Relationships>
</file>

<file path=ppt/slides/_rels/slide4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wmf"/><Relationship Id="rId2" Type="http://schemas.openxmlformats.org/officeDocument/2006/relationships/oleObject" Target="../embeddings/oleObject53.bin"/><Relationship Id="rId1" Type="http://schemas.openxmlformats.org/officeDocument/2006/relationships/slideLayout" Target="../slideLayouts/slideLayout6.xml"/></Relationships>
</file>

<file path=ppt/slides/_rels/slide4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wmf"/><Relationship Id="rId2" Type="http://schemas.openxmlformats.org/officeDocument/2006/relationships/oleObject" Target="../embeddings/oleObject54.bin"/><Relationship Id="rId1" Type="http://schemas.openxmlformats.org/officeDocument/2006/relationships/slideLayout" Target="../slideLayouts/slideLayout6.xml"/></Relationships>
</file>

<file path=ppt/slides/_rels/slide4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wmf"/><Relationship Id="rId2" Type="http://schemas.openxmlformats.org/officeDocument/2006/relationships/oleObject" Target="../embeddings/oleObject55.bin"/><Relationship Id="rId1" Type="http://schemas.openxmlformats.org/officeDocument/2006/relationships/slideLayout" Target="../slideLayouts/slideLayout6.xml"/></Relationships>
</file>

<file path=ppt/slides/_rels/slide4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wmf"/><Relationship Id="rId2" Type="http://schemas.openxmlformats.org/officeDocument/2006/relationships/oleObject" Target="../embeddings/oleObject56.bin"/><Relationship Id="rId1" Type="http://schemas.openxmlformats.org/officeDocument/2006/relationships/slideLayout" Target="../slideLayouts/slideLayout6.xml"/></Relationships>
</file>

<file path=ppt/slides/_rels/slide4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7.wmf"/><Relationship Id="rId2" Type="http://schemas.openxmlformats.org/officeDocument/2006/relationships/oleObject" Target="../embeddings/oleObject57.bin"/><Relationship Id="rId1" Type="http://schemas.openxmlformats.org/officeDocument/2006/relationships/slideLayout" Target="../slideLayouts/slideLayout6.xml"/></Relationships>
</file>

<file path=ppt/slides/_rels/slide4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wmf"/><Relationship Id="rId2" Type="http://schemas.openxmlformats.org/officeDocument/2006/relationships/oleObject" Target="../embeddings/oleObject58.bin"/><Relationship Id="rId1" Type="http://schemas.openxmlformats.org/officeDocument/2006/relationships/slideLayout" Target="../slideLayouts/slideLayout6.xml"/></Relationships>
</file>

<file path=ppt/slides/_rels/slide4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9.wmf"/><Relationship Id="rId2" Type="http://schemas.openxmlformats.org/officeDocument/2006/relationships/oleObject" Target="../embeddings/oleObject59.bin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wmf"/><Relationship Id="rId2" Type="http://schemas.openxmlformats.org/officeDocument/2006/relationships/oleObject" Target="../embeddings/oleObject8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9.wmf"/><Relationship Id="rId4" Type="http://schemas.openxmlformats.org/officeDocument/2006/relationships/oleObject" Target="../embeddings/oleObject9.bin"/></Relationships>
</file>

<file path=ppt/slides/_rels/slide50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wmf"/><Relationship Id="rId2" Type="http://schemas.openxmlformats.org/officeDocument/2006/relationships/oleObject" Target="../embeddings/oleObject60.bin"/><Relationship Id="rId1" Type="http://schemas.openxmlformats.org/officeDocument/2006/relationships/slideLayout" Target="../slideLayouts/slideLayout6.xml"/></Relationships>
</file>

<file path=ppt/slides/_rels/slide5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1.wmf"/><Relationship Id="rId2" Type="http://schemas.openxmlformats.org/officeDocument/2006/relationships/oleObject" Target="../embeddings/oleObject61.bin"/><Relationship Id="rId1" Type="http://schemas.openxmlformats.org/officeDocument/2006/relationships/slideLayout" Target="../slideLayouts/slideLayout6.xml"/></Relationships>
</file>

<file path=ppt/slides/_rels/slide5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wmf"/><Relationship Id="rId2" Type="http://schemas.openxmlformats.org/officeDocument/2006/relationships/oleObject" Target="../embeddings/oleObject62.bin"/><Relationship Id="rId1" Type="http://schemas.openxmlformats.org/officeDocument/2006/relationships/slideLayout" Target="../slideLayouts/slideLayout6.xml"/></Relationships>
</file>

<file path=ppt/slides/_rels/slide5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3.wmf"/><Relationship Id="rId2" Type="http://schemas.openxmlformats.org/officeDocument/2006/relationships/oleObject" Target="../embeddings/oleObject63.bin"/><Relationship Id="rId1" Type="http://schemas.openxmlformats.org/officeDocument/2006/relationships/slideLayout" Target="../slideLayouts/slideLayout6.xml"/></Relationships>
</file>

<file path=ppt/slides/_rels/slide5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4.wmf"/><Relationship Id="rId2" Type="http://schemas.openxmlformats.org/officeDocument/2006/relationships/oleObject" Target="../embeddings/oleObject64.bin"/><Relationship Id="rId1" Type="http://schemas.openxmlformats.org/officeDocument/2006/relationships/slideLayout" Target="../slideLayouts/slideLayout6.xml"/></Relationships>
</file>

<file path=ppt/slides/_rels/slide5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5.wmf"/><Relationship Id="rId2" Type="http://schemas.openxmlformats.org/officeDocument/2006/relationships/oleObject" Target="../embeddings/oleObject65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66.wmf"/><Relationship Id="rId4" Type="http://schemas.openxmlformats.org/officeDocument/2006/relationships/oleObject" Target="../embeddings/oleObject66.bin"/></Relationships>
</file>

<file path=ppt/slides/_rels/slide5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7.wmf"/><Relationship Id="rId2" Type="http://schemas.openxmlformats.org/officeDocument/2006/relationships/oleObject" Target="../embeddings/oleObject67.bin"/><Relationship Id="rId1" Type="http://schemas.openxmlformats.org/officeDocument/2006/relationships/slideLayout" Target="../slideLayouts/slideLayout6.xml"/></Relationships>
</file>

<file path=ppt/slides/_rels/slide5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8.wmf"/><Relationship Id="rId2" Type="http://schemas.openxmlformats.org/officeDocument/2006/relationships/oleObject" Target="../embeddings/oleObject68.bin"/><Relationship Id="rId1" Type="http://schemas.openxmlformats.org/officeDocument/2006/relationships/slideLayout" Target="../slideLayouts/slideLayout6.xml"/></Relationships>
</file>

<file path=ppt/slides/_rels/slide5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9.wmf"/><Relationship Id="rId2" Type="http://schemas.openxmlformats.org/officeDocument/2006/relationships/oleObject" Target="../embeddings/oleObject69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70.wmf"/><Relationship Id="rId4" Type="http://schemas.openxmlformats.org/officeDocument/2006/relationships/oleObject" Target="../embeddings/oleObject70.bin"/></Relationships>
</file>

<file path=ppt/slides/_rels/slide59.xml.rels><?xml version="1.0" encoding="UTF-8" standalone="yes"?>
<Relationships xmlns="http://schemas.openxmlformats.org/package/2006/relationships"><Relationship Id="rId3" Type="http://schemas.openxmlformats.org/officeDocument/2006/relationships/image" Target="../media/image71.wmf"/><Relationship Id="rId2" Type="http://schemas.openxmlformats.org/officeDocument/2006/relationships/oleObject" Target="../embeddings/oleObject71.bin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wmf"/><Relationship Id="rId2" Type="http://schemas.openxmlformats.org/officeDocument/2006/relationships/oleObject" Target="../embeddings/oleObject10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11.wmf"/><Relationship Id="rId4" Type="http://schemas.openxmlformats.org/officeDocument/2006/relationships/oleObject" Target="../embeddings/oleObject11.bin"/></Relationships>
</file>

<file path=ppt/slides/_rels/slide60.xml.rels><?xml version="1.0" encoding="UTF-8" standalone="yes"?>
<Relationships xmlns="http://schemas.openxmlformats.org/package/2006/relationships"><Relationship Id="rId3" Type="http://schemas.openxmlformats.org/officeDocument/2006/relationships/image" Target="../media/image72.wmf"/><Relationship Id="rId2" Type="http://schemas.openxmlformats.org/officeDocument/2006/relationships/oleObject" Target="../embeddings/oleObject72.bin"/><Relationship Id="rId1" Type="http://schemas.openxmlformats.org/officeDocument/2006/relationships/slideLayout" Target="../slideLayouts/slideLayout6.xml"/></Relationships>
</file>

<file path=ppt/slides/_rels/slide61.xml.rels><?xml version="1.0" encoding="UTF-8" standalone="yes"?>
<Relationships xmlns="http://schemas.openxmlformats.org/package/2006/relationships"><Relationship Id="rId3" Type="http://schemas.openxmlformats.org/officeDocument/2006/relationships/image" Target="../media/image73.wmf"/><Relationship Id="rId2" Type="http://schemas.openxmlformats.org/officeDocument/2006/relationships/oleObject" Target="../embeddings/oleObject73.bin"/><Relationship Id="rId1" Type="http://schemas.openxmlformats.org/officeDocument/2006/relationships/slideLayout" Target="../slideLayouts/slideLayout6.xml"/></Relationships>
</file>

<file path=ppt/slides/_rels/slide6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4.wmf"/><Relationship Id="rId2" Type="http://schemas.openxmlformats.org/officeDocument/2006/relationships/oleObject" Target="../embeddings/oleObject74.bin"/><Relationship Id="rId1" Type="http://schemas.openxmlformats.org/officeDocument/2006/relationships/slideLayout" Target="../slideLayouts/slideLayout6.xml"/></Relationships>
</file>

<file path=ppt/slides/_rels/slide6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5.wmf"/><Relationship Id="rId2" Type="http://schemas.openxmlformats.org/officeDocument/2006/relationships/oleObject" Target="../embeddings/oleObject75.bin"/><Relationship Id="rId1" Type="http://schemas.openxmlformats.org/officeDocument/2006/relationships/slideLayout" Target="../slideLayouts/slideLayout6.xml"/></Relationships>
</file>

<file path=ppt/slides/_rels/slide6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6.wmf"/><Relationship Id="rId2" Type="http://schemas.openxmlformats.org/officeDocument/2006/relationships/oleObject" Target="../embeddings/oleObject76.bin"/><Relationship Id="rId1" Type="http://schemas.openxmlformats.org/officeDocument/2006/relationships/slideLayout" Target="../slideLayouts/slideLayout6.xml"/></Relationships>
</file>

<file path=ppt/slides/_rels/slide6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7.wmf"/><Relationship Id="rId2" Type="http://schemas.openxmlformats.org/officeDocument/2006/relationships/oleObject" Target="../embeddings/oleObject77.bin"/><Relationship Id="rId1" Type="http://schemas.openxmlformats.org/officeDocument/2006/relationships/slideLayout" Target="../slideLayouts/slideLayout6.xml"/></Relationships>
</file>

<file path=ppt/slides/_rels/slide6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8.wmf"/><Relationship Id="rId2" Type="http://schemas.openxmlformats.org/officeDocument/2006/relationships/oleObject" Target="../embeddings/oleObject78.bin"/><Relationship Id="rId1" Type="http://schemas.openxmlformats.org/officeDocument/2006/relationships/slideLayout" Target="../slideLayouts/slideLayout6.xml"/></Relationships>
</file>

<file path=ppt/slides/_rels/slide6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9.wmf"/><Relationship Id="rId2" Type="http://schemas.openxmlformats.org/officeDocument/2006/relationships/oleObject" Target="../embeddings/oleObject79.bin"/><Relationship Id="rId1" Type="http://schemas.openxmlformats.org/officeDocument/2006/relationships/slideLayout" Target="../slideLayouts/slideLayout6.xml"/></Relationships>
</file>

<file path=ppt/slides/_rels/slide6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0.wmf"/><Relationship Id="rId2" Type="http://schemas.openxmlformats.org/officeDocument/2006/relationships/oleObject" Target="../embeddings/oleObject80.bin"/><Relationship Id="rId1" Type="http://schemas.openxmlformats.org/officeDocument/2006/relationships/slideLayout" Target="../slideLayouts/slideLayout6.xml"/></Relationships>
</file>

<file path=ppt/slides/_rels/slide6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1.wmf"/><Relationship Id="rId2" Type="http://schemas.openxmlformats.org/officeDocument/2006/relationships/oleObject" Target="../embeddings/oleObject81.bin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wmf"/><Relationship Id="rId2" Type="http://schemas.openxmlformats.org/officeDocument/2006/relationships/oleObject" Target="../embeddings/oleObject12.bin"/><Relationship Id="rId1" Type="http://schemas.openxmlformats.org/officeDocument/2006/relationships/slideLayout" Target="../slideLayouts/slideLayout6.xml"/></Relationships>
</file>

<file path=ppt/slides/_rels/slide70.xml.rels><?xml version="1.0" encoding="UTF-8" standalone="yes"?>
<Relationships xmlns="http://schemas.openxmlformats.org/package/2006/relationships"><Relationship Id="rId3" Type="http://schemas.openxmlformats.org/officeDocument/2006/relationships/image" Target="../media/image82.wmf"/><Relationship Id="rId2" Type="http://schemas.openxmlformats.org/officeDocument/2006/relationships/oleObject" Target="../embeddings/oleObject82.bin"/><Relationship Id="rId1" Type="http://schemas.openxmlformats.org/officeDocument/2006/relationships/slideLayout" Target="../slideLayouts/slideLayout6.xml"/></Relationships>
</file>

<file path=ppt/slides/_rels/slide71.xml.rels><?xml version="1.0" encoding="UTF-8" standalone="yes"?>
<Relationships xmlns="http://schemas.openxmlformats.org/package/2006/relationships"><Relationship Id="rId3" Type="http://schemas.openxmlformats.org/officeDocument/2006/relationships/image" Target="../media/image83.wmf"/><Relationship Id="rId2" Type="http://schemas.openxmlformats.org/officeDocument/2006/relationships/oleObject" Target="../embeddings/oleObject83.bin"/><Relationship Id="rId1" Type="http://schemas.openxmlformats.org/officeDocument/2006/relationships/slideLayout" Target="../slideLayouts/slideLayout6.xml"/></Relationships>
</file>

<file path=ppt/slides/_rels/slide7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4.wmf"/><Relationship Id="rId2" Type="http://schemas.openxmlformats.org/officeDocument/2006/relationships/oleObject" Target="../embeddings/oleObject84.bin"/><Relationship Id="rId1" Type="http://schemas.openxmlformats.org/officeDocument/2006/relationships/slideLayout" Target="../slideLayouts/slideLayout6.xml"/></Relationships>
</file>

<file path=ppt/slides/_rels/slide7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5.wmf"/><Relationship Id="rId2" Type="http://schemas.openxmlformats.org/officeDocument/2006/relationships/oleObject" Target="../embeddings/oleObject85.bin"/><Relationship Id="rId1" Type="http://schemas.openxmlformats.org/officeDocument/2006/relationships/slideLayout" Target="../slideLayouts/slideLayout6.xml"/></Relationships>
</file>

<file path=ppt/slides/_rels/slide7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6.wmf"/><Relationship Id="rId2" Type="http://schemas.openxmlformats.org/officeDocument/2006/relationships/oleObject" Target="../embeddings/oleObject86.bin"/><Relationship Id="rId1" Type="http://schemas.openxmlformats.org/officeDocument/2006/relationships/slideLayout" Target="../slideLayouts/slideLayout6.xml"/></Relationships>
</file>

<file path=ppt/slides/_rels/slide7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7.wmf"/><Relationship Id="rId2" Type="http://schemas.openxmlformats.org/officeDocument/2006/relationships/oleObject" Target="../embeddings/oleObject87.bin"/><Relationship Id="rId1" Type="http://schemas.openxmlformats.org/officeDocument/2006/relationships/slideLayout" Target="../slideLayouts/slideLayout6.xml"/></Relationships>
</file>

<file path=ppt/slides/_rels/slide7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8.wmf"/><Relationship Id="rId2" Type="http://schemas.openxmlformats.org/officeDocument/2006/relationships/oleObject" Target="../embeddings/oleObject88.bin"/><Relationship Id="rId1" Type="http://schemas.openxmlformats.org/officeDocument/2006/relationships/slideLayout" Target="../slideLayouts/slideLayout6.xml"/></Relationships>
</file>

<file path=ppt/slides/_rels/slide7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9.wmf"/><Relationship Id="rId2" Type="http://schemas.openxmlformats.org/officeDocument/2006/relationships/oleObject" Target="../embeddings/oleObject89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90.wmf"/><Relationship Id="rId4" Type="http://schemas.openxmlformats.org/officeDocument/2006/relationships/oleObject" Target="../embeddings/oleObject90.bin"/></Relationships>
</file>

<file path=ppt/slides/_rels/slide7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1.wmf"/><Relationship Id="rId2" Type="http://schemas.openxmlformats.org/officeDocument/2006/relationships/oleObject" Target="../embeddings/oleObject91.bin"/><Relationship Id="rId1" Type="http://schemas.openxmlformats.org/officeDocument/2006/relationships/slideLayout" Target="../slideLayouts/slideLayout6.xml"/></Relationships>
</file>

<file path=ppt/slides/_rels/slide7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2.wmf"/><Relationship Id="rId2" Type="http://schemas.openxmlformats.org/officeDocument/2006/relationships/oleObject" Target="../embeddings/oleObject92.bin"/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wmf"/><Relationship Id="rId2" Type="http://schemas.openxmlformats.org/officeDocument/2006/relationships/oleObject" Target="../embeddings/oleObject13.bin"/><Relationship Id="rId1" Type="http://schemas.openxmlformats.org/officeDocument/2006/relationships/slideLayout" Target="../slideLayouts/slideLayout6.xml"/></Relationships>
</file>

<file path=ppt/slides/_rels/slide80.xml.rels><?xml version="1.0" encoding="UTF-8" standalone="yes"?>
<Relationships xmlns="http://schemas.openxmlformats.org/package/2006/relationships"><Relationship Id="rId3" Type="http://schemas.openxmlformats.org/officeDocument/2006/relationships/image" Target="../media/image93.wmf"/><Relationship Id="rId2" Type="http://schemas.openxmlformats.org/officeDocument/2006/relationships/oleObject" Target="../embeddings/oleObject93.bin"/><Relationship Id="rId1" Type="http://schemas.openxmlformats.org/officeDocument/2006/relationships/slideLayout" Target="../slideLayouts/slideLayout6.xml"/></Relationships>
</file>

<file path=ppt/slides/_rels/slide81.xml.rels><?xml version="1.0" encoding="UTF-8" standalone="yes"?>
<Relationships xmlns="http://schemas.openxmlformats.org/package/2006/relationships"><Relationship Id="rId3" Type="http://schemas.openxmlformats.org/officeDocument/2006/relationships/image" Target="../media/image94.wmf"/><Relationship Id="rId2" Type="http://schemas.openxmlformats.org/officeDocument/2006/relationships/oleObject" Target="../embeddings/oleObject94.bin"/><Relationship Id="rId1" Type="http://schemas.openxmlformats.org/officeDocument/2006/relationships/slideLayout" Target="../slideLayouts/slideLayout6.xml"/></Relationships>
</file>

<file path=ppt/slides/_rels/slide8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5.wmf"/><Relationship Id="rId2" Type="http://schemas.openxmlformats.org/officeDocument/2006/relationships/oleObject" Target="../embeddings/oleObject95.bin"/><Relationship Id="rId1" Type="http://schemas.openxmlformats.org/officeDocument/2006/relationships/slideLayout" Target="../slideLayouts/slideLayout6.xml"/></Relationships>
</file>

<file path=ppt/slides/_rels/slide8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6.wmf"/><Relationship Id="rId2" Type="http://schemas.openxmlformats.org/officeDocument/2006/relationships/oleObject" Target="../embeddings/oleObject96.bin"/><Relationship Id="rId1" Type="http://schemas.openxmlformats.org/officeDocument/2006/relationships/slideLayout" Target="../slideLayouts/slideLayout6.xml"/></Relationships>
</file>

<file path=ppt/slides/_rels/slide8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7.wmf"/><Relationship Id="rId2" Type="http://schemas.openxmlformats.org/officeDocument/2006/relationships/oleObject" Target="../embeddings/oleObject97.bin"/><Relationship Id="rId1" Type="http://schemas.openxmlformats.org/officeDocument/2006/relationships/slideLayout" Target="../slideLayouts/slideLayout6.xml"/></Relationships>
</file>

<file path=ppt/slides/_rels/slide8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8.wmf"/><Relationship Id="rId2" Type="http://schemas.openxmlformats.org/officeDocument/2006/relationships/oleObject" Target="../embeddings/oleObject98.bin"/><Relationship Id="rId1" Type="http://schemas.openxmlformats.org/officeDocument/2006/relationships/slideLayout" Target="../slideLayouts/slideLayout6.xml"/></Relationships>
</file>

<file path=ppt/slides/_rels/slide8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9.wmf"/><Relationship Id="rId2" Type="http://schemas.openxmlformats.org/officeDocument/2006/relationships/oleObject" Target="../embeddings/oleObject99.bin"/><Relationship Id="rId1" Type="http://schemas.openxmlformats.org/officeDocument/2006/relationships/slideLayout" Target="../slideLayouts/slideLayout6.xml"/></Relationships>
</file>

<file path=ppt/slides/_rels/slide8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0.wmf"/><Relationship Id="rId2" Type="http://schemas.openxmlformats.org/officeDocument/2006/relationships/oleObject" Target="../embeddings/oleObject100.bin"/><Relationship Id="rId1" Type="http://schemas.openxmlformats.org/officeDocument/2006/relationships/slideLayout" Target="../slideLayouts/slideLayout6.xml"/></Relationships>
</file>

<file path=ppt/slides/_rels/slide8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1.wmf"/><Relationship Id="rId2" Type="http://schemas.openxmlformats.org/officeDocument/2006/relationships/oleObject" Target="../embeddings/oleObject101.bin"/><Relationship Id="rId1" Type="http://schemas.openxmlformats.org/officeDocument/2006/relationships/slideLayout" Target="../slideLayouts/slideLayout6.xml"/></Relationships>
</file>

<file path=ppt/slides/_rels/slide8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2.wmf"/><Relationship Id="rId2" Type="http://schemas.openxmlformats.org/officeDocument/2006/relationships/oleObject" Target="../embeddings/oleObject102.bin"/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wmf"/><Relationship Id="rId2" Type="http://schemas.openxmlformats.org/officeDocument/2006/relationships/oleObject" Target="../embeddings/oleObject14.bin"/><Relationship Id="rId1" Type="http://schemas.openxmlformats.org/officeDocument/2006/relationships/slideLayout" Target="../slideLayouts/slideLayout6.xml"/></Relationships>
</file>

<file path=ppt/slides/_rels/slide9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3.wmf"/><Relationship Id="rId2" Type="http://schemas.openxmlformats.org/officeDocument/2006/relationships/oleObject" Target="../embeddings/oleObject103.bin"/><Relationship Id="rId1" Type="http://schemas.openxmlformats.org/officeDocument/2006/relationships/slideLayout" Target="../slideLayouts/slideLayout6.xml"/></Relationships>
</file>

<file path=ppt/slides/_rels/slide9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4.wmf"/><Relationship Id="rId2" Type="http://schemas.openxmlformats.org/officeDocument/2006/relationships/oleObject" Target="../embeddings/oleObject104.bin"/><Relationship Id="rId1" Type="http://schemas.openxmlformats.org/officeDocument/2006/relationships/slideLayout" Target="../slideLayouts/slideLayout6.xml"/></Relationships>
</file>

<file path=ppt/slides/_rels/slide9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5.wmf"/><Relationship Id="rId2" Type="http://schemas.openxmlformats.org/officeDocument/2006/relationships/oleObject" Target="../embeddings/oleObject105.bin"/><Relationship Id="rId1" Type="http://schemas.openxmlformats.org/officeDocument/2006/relationships/slideLayout" Target="../slideLayouts/slideLayout6.xml"/></Relationships>
</file>

<file path=ppt/slides/_rels/slide9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6.wmf"/><Relationship Id="rId2" Type="http://schemas.openxmlformats.org/officeDocument/2006/relationships/oleObject" Target="../embeddings/oleObject106.bin"/><Relationship Id="rId1" Type="http://schemas.openxmlformats.org/officeDocument/2006/relationships/slideLayout" Target="../slideLayouts/slideLayout6.xml"/></Relationships>
</file>

<file path=ppt/slides/_rels/slide9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7.wmf"/><Relationship Id="rId2" Type="http://schemas.openxmlformats.org/officeDocument/2006/relationships/oleObject" Target="../embeddings/oleObject107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108.wmf"/><Relationship Id="rId4" Type="http://schemas.openxmlformats.org/officeDocument/2006/relationships/oleObject" Target="../embeddings/oleObject108.bin"/></Relationships>
</file>

<file path=ppt/slides/_rels/slide9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9.wmf"/><Relationship Id="rId2" Type="http://schemas.openxmlformats.org/officeDocument/2006/relationships/oleObject" Target="../embeddings/oleObject109.bin"/><Relationship Id="rId1" Type="http://schemas.openxmlformats.org/officeDocument/2006/relationships/slideLayout" Target="../slideLayouts/slideLayout6.xml"/></Relationships>
</file>

<file path=ppt/slides/_rels/slide9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0.wmf"/><Relationship Id="rId2" Type="http://schemas.openxmlformats.org/officeDocument/2006/relationships/oleObject" Target="../embeddings/oleObject110.bin"/><Relationship Id="rId1" Type="http://schemas.openxmlformats.org/officeDocument/2006/relationships/slideLayout" Target="../slideLayouts/slideLayout6.xml"/></Relationships>
</file>

<file path=ppt/slides/_rels/slide9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1.wmf"/><Relationship Id="rId2" Type="http://schemas.openxmlformats.org/officeDocument/2006/relationships/oleObject" Target="../embeddings/oleObject111.bin"/><Relationship Id="rId1" Type="http://schemas.openxmlformats.org/officeDocument/2006/relationships/slideLayout" Target="../slideLayouts/slideLayout6.xml"/></Relationships>
</file>

<file path=ppt/slides/_rels/slide9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2.wmf"/><Relationship Id="rId2" Type="http://schemas.openxmlformats.org/officeDocument/2006/relationships/oleObject" Target="../embeddings/oleObject112.bin"/><Relationship Id="rId1" Type="http://schemas.openxmlformats.org/officeDocument/2006/relationships/slideLayout" Target="../slideLayouts/slideLayout6.xml"/></Relationships>
</file>

<file path=ppt/slides/_rels/slide9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3.wmf"/><Relationship Id="rId2" Type="http://schemas.openxmlformats.org/officeDocument/2006/relationships/oleObject" Target="../embeddings/oleObject113.bin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E5091D-7B77-C958-6D1E-3BFBEBDA7C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AR0 / F19</a:t>
            </a:r>
            <a:br>
              <a:rPr lang="de-DE"/>
            </a:br>
            <a:endParaRPr lang="de-DE"/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15944574-0C88-192E-9923-2217E78D754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39970919"/>
              </p:ext>
            </p:extLst>
          </p:nvPr>
        </p:nvGraphicFramePr>
        <p:xfrm>
          <a:off x="571787" y="1335996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15944574-0C88-192E-9923-2217E78D754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71787" y="1335996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53763210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D98E40-EC50-6BEB-B809-CEAFB3B0E0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BL8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2F977E70-FEFE-4112-2E77-8692776A381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24016138"/>
              </p:ext>
            </p:extLst>
          </p:nvPr>
        </p:nvGraphicFramePr>
        <p:xfrm>
          <a:off x="548105" y="1569370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2F977E70-FEFE-4112-2E77-8692776A381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48105" y="1569370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BB21150F-FA19-7297-094C-0051A604B38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80576596"/>
              </p:ext>
            </p:extLst>
          </p:nvPr>
        </p:nvGraphicFramePr>
        <p:xfrm>
          <a:off x="1109579" y="7264317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BB21150F-FA19-7297-094C-0051A604B38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109579" y="7264317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855801071"/>
      </p:ext>
    </p:extLst>
  </p:cSld>
  <p:clrMapOvr>
    <a:masterClrMapping/>
  </p:clrMapOvr>
</p:sld>
</file>

<file path=ppt/slides/slide10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CF05B9-E281-F7F4-1ED4-00914D5583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MG4a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22B65F5-A242-99E5-4E9E-ADA9AFE4568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83629371"/>
              </p:ext>
            </p:extLst>
          </p:nvPr>
        </p:nvGraphicFramePr>
        <p:xfrm>
          <a:off x="483937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522B65F5-A242-99E5-4E9E-ADA9AFE4568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83937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663590013"/>
      </p:ext>
    </p:extLst>
  </p:cSld>
  <p:clrMapOvr>
    <a:masterClrMapping/>
  </p:clrMapOvr>
</p:sld>
</file>

<file path=ppt/slides/slide10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D620CB-3C16-523F-ED21-010C3ACD39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MG5a / CK17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FD261DB-423E-7172-9C1E-2A43428F2B5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33927059"/>
              </p:ext>
            </p:extLst>
          </p:nvPr>
        </p:nvGraphicFramePr>
        <p:xfrm>
          <a:off x="838200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FD261DB-423E-7172-9C1E-2A43428F2B5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38200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789172170"/>
      </p:ext>
    </p:extLst>
  </p:cSld>
  <p:clrMapOvr>
    <a:masterClrMapping/>
  </p:clrMapOvr>
</p:sld>
</file>

<file path=ppt/slides/slide10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ED208D-9EE0-E282-955B-851A959341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MG6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DE89D620-5FB9-1FD3-E385-258096F551A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04373204"/>
              </p:ext>
            </p:extLst>
          </p:nvPr>
        </p:nvGraphicFramePr>
        <p:xfrm>
          <a:off x="403727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DE89D620-5FB9-1FD3-E385-258096F551A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03727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91761761"/>
      </p:ext>
    </p:extLst>
  </p:cSld>
  <p:clrMapOvr>
    <a:masterClrMapping/>
  </p:clrMapOvr>
</p:sld>
</file>

<file path=ppt/slides/slide10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BF4FC8-3646-12D9-6085-CDDFD8A178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MG7/CN1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4B26D40-9601-1BDE-57B1-8A0F44D2AE7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47914105"/>
              </p:ext>
            </p:extLst>
          </p:nvPr>
        </p:nvGraphicFramePr>
        <p:xfrm>
          <a:off x="355600" y="1248527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84B26D40-9601-1BDE-57B1-8A0F44D2AE7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55600" y="1248527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552790150"/>
      </p:ext>
    </p:extLst>
  </p:cSld>
  <p:clrMapOvr>
    <a:masterClrMapping/>
  </p:clrMapOvr>
</p:sld>
</file>

<file path=ppt/slides/slide10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779838-84F4-60C2-D1DA-0B620D9B1F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MG8a / CN17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EB8E6F3-393D-8B98-CEC1-01049E314C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5229793"/>
              </p:ext>
            </p:extLst>
          </p:nvPr>
        </p:nvGraphicFramePr>
        <p:xfrm>
          <a:off x="613053" y="1340575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EB8E6F3-393D-8B98-CEC1-01049E314C6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13053" y="1340575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009842015"/>
      </p:ext>
    </p:extLst>
  </p:cSld>
  <p:clrMapOvr>
    <a:masterClrMapping/>
  </p:clrMapOvr>
</p:sld>
</file>

<file path=ppt/slides/slide10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0C20F9-1A35-EB44-55FD-68B3B5635B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MG9a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E7ECDA4-524A-D2D3-92A7-2DDB41D39F6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29796946"/>
              </p:ext>
            </p:extLst>
          </p:nvPr>
        </p:nvGraphicFramePr>
        <p:xfrm>
          <a:off x="275389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9E7ECDA4-524A-D2D3-92A7-2DDB41D39F6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75389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305633320"/>
      </p:ext>
    </p:extLst>
  </p:cSld>
  <p:clrMapOvr>
    <a:masterClrMapping/>
  </p:clrMapOvr>
</p:sld>
</file>

<file path=ppt/slides/slide10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921DAA-2F28-A87E-C501-00C5F8204D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MGe01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9EC98DB-20A4-D94C-338A-4A1B0185694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00530523"/>
              </p:ext>
            </p:extLst>
          </p:nvPr>
        </p:nvGraphicFramePr>
        <p:xfrm>
          <a:off x="463689" y="1338549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59EC98DB-20A4-D94C-338A-4A1B0185694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63689" y="1338549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885565990"/>
      </p:ext>
    </p:extLst>
  </p:cSld>
  <p:clrMapOvr>
    <a:masterClrMapping/>
  </p:clrMapOvr>
</p:sld>
</file>

<file path=ppt/slides/slide10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8C371E-826D-7601-23D3-5D073B69B5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msis21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0A7A2E6D-B4A7-DF08-1381-F9DCCD41C00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90304625"/>
              </p:ext>
            </p:extLst>
          </p:nvPr>
        </p:nvGraphicFramePr>
        <p:xfrm>
          <a:off x="596231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0A7A2E6D-B4A7-DF08-1381-F9DCCD41C00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96231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39394317"/>
      </p:ext>
    </p:extLst>
  </p:cSld>
  <p:clrMapOvr>
    <a:masterClrMapping/>
  </p:clrMapOvr>
</p:sld>
</file>

<file path=ppt/slides/slide10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2A87CB-CDDB-F1DD-18B6-A0492CF047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NM6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B913EE11-DAAA-9446-B043-753A912757C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95952565"/>
              </p:ext>
            </p:extLst>
          </p:nvPr>
        </p:nvGraphicFramePr>
        <p:xfrm>
          <a:off x="243305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B913EE11-DAAA-9446-B043-753A912757C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43305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25765529"/>
      </p:ext>
    </p:extLst>
  </p:cSld>
  <p:clrMapOvr>
    <a:masterClrMapping/>
  </p:clrMapOvr>
</p:sld>
</file>

<file path=ppt/slides/slide10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1533F7-9A5D-F51D-CA9A-744F12A475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psis21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EA6DFFF4-2426-97B9-F0FD-96C07A919AE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56658763"/>
              </p:ext>
            </p:extLst>
          </p:nvPr>
        </p:nvGraphicFramePr>
        <p:xfrm>
          <a:off x="103187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EA6DFFF4-2426-97B9-F0FD-96C07A919AE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3187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87969267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E2D633-0CB9-068A-944F-07CBD3A341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BL9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F4B8E875-44C3-728C-6B1E-7CB0E3DB3BC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4378366"/>
              </p:ext>
            </p:extLst>
          </p:nvPr>
        </p:nvGraphicFramePr>
        <p:xfrm>
          <a:off x="371643" y="1296654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F4B8E875-44C3-728C-6B1E-7CB0E3DB3BC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71643" y="1296654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98AB232A-CF58-BBEC-DF8B-507B3DB345A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01620017"/>
              </p:ext>
            </p:extLst>
          </p:nvPr>
        </p:nvGraphicFramePr>
        <p:xfrm>
          <a:off x="838200" y="6492875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98AB232A-CF58-BBEC-DF8B-507B3DB345A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38200" y="6492875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886679313"/>
      </p:ext>
    </p:extLst>
  </p:cSld>
  <p:clrMapOvr>
    <a:masterClrMapping/>
  </p:clrMapOvr>
</p:sld>
</file>

<file path=ppt/slides/slide1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D6514E-26B5-21E3-2893-E5AE61E4F8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psis22</a:t>
            </a:r>
            <a:r>
              <a:rPr lang="de-DE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771467310"/>
      </p:ext>
    </p:extLst>
  </p:cSld>
  <p:clrMapOvr>
    <a:masterClrMapping/>
  </p:clrMapOvr>
</p:sld>
</file>

<file path=ppt/slides/slide1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B22CE7-CB51-9A19-319D-41CB7EDA9B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psis29</a:t>
            </a:r>
            <a:r>
              <a:rPr lang="de-DE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568242235"/>
      </p:ext>
    </p:extLst>
  </p:cSld>
  <p:clrMapOvr>
    <a:masterClrMapping/>
  </p:clrMapOvr>
</p:sld>
</file>

<file path=ppt/slides/slide1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62E833-2C66-6669-1F62-4061ED3B89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QBL4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B4D0657C-087E-6B4A-8944-61889931F23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79042808"/>
              </p:ext>
            </p:extLst>
          </p:nvPr>
        </p:nvGraphicFramePr>
        <p:xfrm>
          <a:off x="243305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B4D0657C-087E-6B4A-8944-61889931F23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43305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571392797"/>
      </p:ext>
    </p:extLst>
  </p:cSld>
  <p:clrMapOvr>
    <a:masterClrMapping/>
  </p:clrMapOvr>
</p:sld>
</file>

<file path=ppt/slides/slide1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480783-B6C6-24D3-CDDC-7C009BA4F9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G1 / (KM4)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DE79435-6D3D-6A21-29F8-7AF8F96E19A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01387748"/>
              </p:ext>
            </p:extLst>
          </p:nvPr>
        </p:nvGraphicFramePr>
        <p:xfrm>
          <a:off x="567489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5DE79435-6D3D-6A21-29F8-7AF8F96E19A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67489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203967550"/>
      </p:ext>
    </p:extLst>
  </p:cSld>
  <p:clrMapOvr>
    <a:masterClrMapping/>
  </p:clrMapOvr>
</p:sld>
</file>

<file path=ppt/slides/slide1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449612-40E1-2038-408E-B43170A2BF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G12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B274125-A68A-DE49-DB7E-645A8C79D6C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11456085"/>
              </p:ext>
            </p:extLst>
          </p:nvPr>
        </p:nvGraphicFramePr>
        <p:xfrm>
          <a:off x="326571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B274125-A68A-DE49-DB7E-645A8C79D6C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26571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386297517"/>
      </p:ext>
    </p:extLst>
  </p:cSld>
  <p:clrMapOvr>
    <a:masterClrMapping/>
  </p:clrMapOvr>
</p:sld>
</file>

<file path=ppt/slides/slide1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02C8AF-5395-BF65-9D4A-6608A26399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G13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074DBB06-E4B9-AF80-E55D-88FB5C6705E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96359894"/>
              </p:ext>
            </p:extLst>
          </p:nvPr>
        </p:nvGraphicFramePr>
        <p:xfrm>
          <a:off x="227264" y="1280612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074DBB06-E4B9-AF80-E55D-88FB5C6705E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27264" y="1280612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902756814"/>
      </p:ext>
    </p:extLst>
  </p:cSld>
  <p:clrMapOvr>
    <a:masterClrMapping/>
  </p:clrMapOvr>
</p:sld>
</file>

<file path=ppt/slides/slide1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104055-9CB6-CC03-45B4-7649E2D202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G15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4FBEC474-0885-3690-80F8-5533C07827F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5213712"/>
              </p:ext>
            </p:extLst>
          </p:nvPr>
        </p:nvGraphicFramePr>
        <p:xfrm>
          <a:off x="483937" y="1248528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4FBEC474-0885-3690-80F8-5533C07827F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83937" y="1248528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28080603"/>
      </p:ext>
    </p:extLst>
  </p:cSld>
  <p:clrMapOvr>
    <a:masterClrMapping/>
  </p:clrMapOvr>
</p:sld>
</file>

<file path=ppt/slides/slide1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380799-5A0E-6C70-5583-36520C3D54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G16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9B228AE-CEA1-A369-4FCB-F7C54FC4247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58521043"/>
              </p:ext>
            </p:extLst>
          </p:nvPr>
        </p:nvGraphicFramePr>
        <p:xfrm>
          <a:off x="838200" y="1296654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99B228AE-CEA1-A369-4FCB-F7C54FC4247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38200" y="1296654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483818101"/>
      </p:ext>
    </p:extLst>
  </p:cSld>
  <p:clrMapOvr>
    <a:masterClrMapping/>
  </p:clrMapOvr>
</p:sld>
</file>

<file path=ppt/slides/slide1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0AC8C1-82D6-AE20-1632-A57F7C3E21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G18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63EA86D-206A-2C0A-2C92-4C6F015F0EA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03909205"/>
              </p:ext>
            </p:extLst>
          </p:nvPr>
        </p:nvGraphicFramePr>
        <p:xfrm>
          <a:off x="435810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63EA86D-206A-2C0A-2C92-4C6F015F0EA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35810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164342502"/>
      </p:ext>
    </p:extLst>
  </p:cSld>
  <p:clrMapOvr>
    <a:masterClrMapping/>
  </p:clrMapOvr>
</p:sld>
</file>

<file path=ppt/slides/slide1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7CDDA8-D968-85F7-C499-43DDC8E337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G2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EDE97483-4388-EF7B-2635-4768B6EEC81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86697561"/>
              </p:ext>
            </p:extLst>
          </p:nvPr>
        </p:nvGraphicFramePr>
        <p:xfrm>
          <a:off x="419769" y="1232485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EDE97483-4388-EF7B-2635-4768B6EEC81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19769" y="1232485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054920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25F68C-1F71-E767-7BA1-F256109CEC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K10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4C98DDD-5398-22F8-96E8-587759A083E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93682128"/>
              </p:ext>
            </p:extLst>
          </p:nvPr>
        </p:nvGraphicFramePr>
        <p:xfrm>
          <a:off x="838200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94C98DDD-5398-22F8-96E8-587759A083E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38200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197959177"/>
      </p:ext>
    </p:extLst>
  </p:cSld>
  <p:clrMapOvr>
    <a:masterClrMapping/>
  </p:clrMapOvr>
</p:sld>
</file>

<file path=ppt/slides/slide1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DC1A4F-CE8A-B5F1-0E68-8C42E9E1BD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G4 / (KM2)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3952C9D8-6493-1656-FDD6-F4C0B56FE2F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3133451"/>
              </p:ext>
            </p:extLst>
          </p:nvPr>
        </p:nvGraphicFramePr>
        <p:xfrm>
          <a:off x="548105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3952C9D8-6493-1656-FDD6-F4C0B56FE2F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48105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372757893"/>
      </p:ext>
    </p:extLst>
  </p:cSld>
  <p:clrMapOvr>
    <a:masterClrMapping/>
  </p:clrMapOvr>
</p:sld>
</file>

<file path=ppt/slides/slide1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B6A907-4FCD-8219-3E5A-AB09817093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G6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3111138B-7B5A-AD6F-0BF9-E333504E4C4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3612785"/>
              </p:ext>
            </p:extLst>
          </p:nvPr>
        </p:nvGraphicFramePr>
        <p:xfrm>
          <a:off x="355600" y="1264569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3111138B-7B5A-AD6F-0BF9-E333504E4C4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55600" y="1264569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039709633"/>
      </p:ext>
    </p:extLst>
  </p:cSld>
  <p:clrMapOvr>
    <a:masterClrMapping/>
  </p:clrMapOvr>
</p:sld>
</file>

<file path=ppt/slides/slide1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2A00DC-C296-183F-BD66-6DD4771267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G7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B7A416EB-DA32-F35B-FAE1-8B7B2C2D65A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13939867"/>
              </p:ext>
            </p:extLst>
          </p:nvPr>
        </p:nvGraphicFramePr>
        <p:xfrm>
          <a:off x="580189" y="1312695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B7A416EB-DA32-F35B-FAE1-8B7B2C2D65A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80189" y="1312695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064510982"/>
      </p:ext>
    </p:extLst>
  </p:cSld>
  <p:clrMapOvr>
    <a:masterClrMapping/>
  </p:clrMapOvr>
</p:sld>
</file>

<file path=ppt/slides/slide1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D20186-4210-533F-DCE2-D282DDCA7D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G8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D2D8CB2A-1B50-1E1A-78A0-2AC32A4A20E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31486105"/>
              </p:ext>
            </p:extLst>
          </p:nvPr>
        </p:nvGraphicFramePr>
        <p:xfrm>
          <a:off x="243306" y="1690688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D2D8CB2A-1B50-1E1A-78A0-2AC32A4A20E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43306" y="1690688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041487721"/>
      </p:ext>
    </p:extLst>
  </p:cSld>
  <p:clrMapOvr>
    <a:masterClrMapping/>
  </p:clrMapOvr>
</p:sld>
</file>

<file path=ppt/slides/slide1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6A0658-DD67-44CE-5FAB-E7405C7F3A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M10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43CB897F-B96E-41F8-FAB5-199719FA9E0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71622383"/>
              </p:ext>
            </p:extLst>
          </p:nvPr>
        </p:nvGraphicFramePr>
        <p:xfrm>
          <a:off x="291432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43CB897F-B96E-41F8-FAB5-199719FA9E0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91432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794329460"/>
      </p:ext>
    </p:extLst>
  </p:cSld>
  <p:clrMapOvr>
    <a:masterClrMapping/>
  </p:clrMapOvr>
</p:sld>
</file>

<file path=ppt/slides/slide1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119683-79AD-5566-1A95-09240BB288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M112 / CN11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23E7F519-674E-477C-CB8B-B53048E487A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58490016"/>
              </p:ext>
            </p:extLst>
          </p:nvPr>
        </p:nvGraphicFramePr>
        <p:xfrm>
          <a:off x="384629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23E7F519-674E-477C-CB8B-B53048E487A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84629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395803242"/>
      </p:ext>
    </p:extLst>
  </p:cSld>
  <p:clrMapOvr>
    <a:masterClrMapping/>
  </p:clrMapOvr>
</p:sld>
</file>

<file path=ppt/slides/slide1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62F4E8-27AA-2140-5C05-B820CD44D3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M113 / RC11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CA497F4-8C72-22F9-D0C4-94227953BD8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25881414"/>
              </p:ext>
            </p:extLst>
          </p:nvPr>
        </p:nvGraphicFramePr>
        <p:xfrm>
          <a:off x="132216" y="1183595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8CA497F4-8C72-22F9-D0C4-94227953BD8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32216" y="1183595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238007092"/>
      </p:ext>
    </p:extLst>
  </p:cSld>
  <p:clrMapOvr>
    <a:masterClrMapping/>
  </p:clrMapOvr>
</p:sld>
</file>

<file path=ppt/slides/slide1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2DBF8E-0C3F-896B-15A8-161AFF6C1E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M114 / RC17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F9CD9DB5-5E4C-7C63-AB56-DD79895E266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02449438"/>
              </p:ext>
            </p:extLst>
          </p:nvPr>
        </p:nvGraphicFramePr>
        <p:xfrm>
          <a:off x="103187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F9CD9DB5-5E4C-7C63-AB56-DD79895E266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3187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77518539"/>
      </p:ext>
    </p:extLst>
  </p:cSld>
  <p:clrMapOvr>
    <a:masterClrMapping/>
  </p:clrMapOvr>
</p:sld>
</file>

<file path=ppt/slides/slide1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67B3F5-6FE0-2BE1-A45C-8D794580D1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M116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D529E586-8632-F65E-57C0-C6AE906A511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91678152"/>
              </p:ext>
            </p:extLst>
          </p:nvPr>
        </p:nvGraphicFramePr>
        <p:xfrm>
          <a:off x="676442" y="1466496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D529E586-8632-F65E-57C0-C6AE906A511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76442" y="1466496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804652707"/>
      </p:ext>
    </p:extLst>
  </p:cSld>
  <p:clrMapOvr>
    <a:masterClrMapping/>
  </p:clrMapOvr>
</p:sld>
</file>

<file path=ppt/slides/slide1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49E26B-3AA8-407A-1D0F-04844A2482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M12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2DD6D308-ED15-9A3C-2FA9-56F5792154B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69817567"/>
              </p:ext>
            </p:extLst>
          </p:nvPr>
        </p:nvGraphicFramePr>
        <p:xfrm>
          <a:off x="499979" y="1690688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2DD6D308-ED15-9A3C-2FA9-56F5792154B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99979" y="1690688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85474351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834E42-D84B-7277-7135-AAD9984D7F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K11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B0AA601-E4C9-45D5-5B81-EAE783E413C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65760872"/>
              </p:ext>
            </p:extLst>
          </p:nvPr>
        </p:nvGraphicFramePr>
        <p:xfrm>
          <a:off x="362765" y="1468715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9B0AA601-E4C9-45D5-5B81-EAE783E413C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62765" y="1468715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DCAA814C-0822-9454-345B-09B0AF5C313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20278856"/>
              </p:ext>
            </p:extLst>
          </p:nvPr>
        </p:nvGraphicFramePr>
        <p:xfrm>
          <a:off x="737340" y="6596156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DCAA814C-0822-9454-345B-09B0AF5C313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37340" y="6596156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987638391"/>
      </p:ext>
    </p:extLst>
  </p:cSld>
  <p:clrMapOvr>
    <a:masterClrMapping/>
  </p:clrMapOvr>
</p:sld>
</file>

<file path=ppt/slides/slide1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1469C6-3CD3-7599-D1E8-8322EC3B37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M13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B23640F9-7EF4-E510-45DC-4BC9840FADE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71288961"/>
              </p:ext>
            </p:extLst>
          </p:nvPr>
        </p:nvGraphicFramePr>
        <p:xfrm>
          <a:off x="291431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B23640F9-7EF4-E510-45DC-4BC9840FADE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91431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88576310"/>
      </p:ext>
    </p:extLst>
  </p:cSld>
  <p:clrMapOvr>
    <a:masterClrMapping/>
  </p:clrMapOvr>
</p:sld>
</file>

<file path=ppt/slides/slide1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1698BF-AA44-7363-C31B-35154E146D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M140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EE12C99D-BAA7-3C8A-82E4-DE1C0EEDA64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8857092"/>
              </p:ext>
            </p:extLst>
          </p:nvPr>
        </p:nvGraphicFramePr>
        <p:xfrm>
          <a:off x="355600" y="1285195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EE12C99D-BAA7-3C8A-82E4-DE1C0EEDA64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55600" y="1285195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796462839"/>
      </p:ext>
    </p:extLst>
  </p:cSld>
  <p:clrMapOvr>
    <a:masterClrMapping/>
  </p:clrMapOvr>
</p:sld>
</file>

<file path=ppt/slides/slide1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FA3238-C1F5-AFC3-DA4B-FB738AD05E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M141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2014162-15DB-DD15-BF60-C1AF2C4993D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6140517"/>
              </p:ext>
            </p:extLst>
          </p:nvPr>
        </p:nvGraphicFramePr>
        <p:xfrm>
          <a:off x="580190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2014162-15DB-DD15-BF60-C1AF2C4993D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80190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699220586"/>
      </p:ext>
    </p:extLst>
  </p:cSld>
  <p:clrMapOvr>
    <a:masterClrMapping/>
  </p:clrMapOvr>
</p:sld>
</file>

<file path=ppt/slides/slide1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072D23-BE09-34C1-6BC1-7D4E38F6E6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M143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64F184D-D422-3745-3250-327EED67425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76065968"/>
              </p:ext>
            </p:extLst>
          </p:nvPr>
        </p:nvGraphicFramePr>
        <p:xfrm>
          <a:off x="674915" y="1575480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864F184D-D422-3745-3250-327EED67425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74915" y="1575480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55880494"/>
      </p:ext>
    </p:extLst>
  </p:cSld>
  <p:clrMapOvr>
    <a:masterClrMapping/>
  </p:clrMapOvr>
</p:sld>
</file>

<file path=ppt/slides/slide1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BE5C8C-5DC2-604A-184F-4EDF859F93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M144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351599C0-1F38-276B-52E5-A36F840A1CA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00070375"/>
              </p:ext>
            </p:extLst>
          </p:nvPr>
        </p:nvGraphicFramePr>
        <p:xfrm>
          <a:off x="254000" y="1074738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351599C0-1F38-276B-52E5-A36F840A1CA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54000" y="1074738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550044285"/>
      </p:ext>
    </p:extLst>
  </p:cSld>
  <p:clrMapOvr>
    <a:masterClrMapping/>
  </p:clrMapOvr>
</p:sld>
</file>

<file path=ppt/slides/slide1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B146AB-DB09-FB9F-10E3-6CA1480291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M145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22BFD98D-3717-02BF-6374-133686BE88A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08500179"/>
              </p:ext>
            </p:extLst>
          </p:nvPr>
        </p:nvGraphicFramePr>
        <p:xfrm>
          <a:off x="-302127" y="1553327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22BFD98D-3717-02BF-6374-133686BE88A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-302127" y="1553327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170F60C6-6486-AC94-6FAE-D9B8310CF46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49615221"/>
              </p:ext>
            </p:extLst>
          </p:nvPr>
        </p:nvGraphicFramePr>
        <p:xfrm>
          <a:off x="103187" y="6606590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170F60C6-6486-AC94-6FAE-D9B8310CF46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03187" y="6606590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289956802"/>
      </p:ext>
    </p:extLst>
  </p:cSld>
  <p:clrMapOvr>
    <a:masterClrMapping/>
  </p:clrMapOvr>
</p:sld>
</file>

<file path=ppt/slides/slide1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0C7067-FE34-2B4D-82EF-E4747A23F1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M152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231EEBE4-BBF1-F679-3753-A53B86A81FF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38260678"/>
              </p:ext>
            </p:extLst>
          </p:nvPr>
        </p:nvGraphicFramePr>
        <p:xfrm>
          <a:off x="387684" y="1355642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231EEBE4-BBF1-F679-3753-A53B86A81FF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87684" y="1355642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182781EC-194F-937C-FC35-D6CAAF58102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21322064"/>
              </p:ext>
            </p:extLst>
          </p:nvPr>
        </p:nvGraphicFramePr>
        <p:xfrm>
          <a:off x="387684" y="6773779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182781EC-194F-937C-FC35-D6CAAF58102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87684" y="6773779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741208271"/>
      </p:ext>
    </p:extLst>
  </p:cSld>
  <p:clrMapOvr>
    <a:masterClrMapping/>
  </p:clrMapOvr>
</p:sld>
</file>

<file path=ppt/slides/slide1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BD801D-92B1-620E-AA9F-A644E2381D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M155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05412847-F446-0153-DE88-15797C00093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32565403"/>
              </p:ext>
            </p:extLst>
          </p:nvPr>
        </p:nvGraphicFramePr>
        <p:xfrm>
          <a:off x="403727" y="1690688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05412847-F446-0153-DE88-15797C00093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03727" y="1690688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6CE28A81-AB07-D21D-EA01-DF85C6F43F5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0397868"/>
              </p:ext>
            </p:extLst>
          </p:nvPr>
        </p:nvGraphicFramePr>
        <p:xfrm>
          <a:off x="403727" y="6858000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6CE28A81-AB07-D21D-EA01-DF85C6F43F5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03727" y="6858000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786292224"/>
      </p:ext>
    </p:extLst>
  </p:cSld>
  <p:clrMapOvr>
    <a:masterClrMapping/>
  </p:clrMapOvr>
</p:sld>
</file>

<file path=ppt/slides/slide1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97D59F-2B08-52EA-0E5F-556312C3C3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M16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07F809E5-91DE-DC72-F1BF-E27D6343552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73935760"/>
              </p:ext>
            </p:extLst>
          </p:nvPr>
        </p:nvGraphicFramePr>
        <p:xfrm>
          <a:off x="326572" y="1165452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07F809E5-91DE-DC72-F1BF-E27D6343552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26572" y="1165452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932385421"/>
      </p:ext>
    </p:extLst>
  </p:cSld>
  <p:clrMapOvr>
    <a:masterClrMapping/>
  </p:clrMapOvr>
</p:sld>
</file>

<file path=ppt/slides/slide1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98BD58-58B9-88F4-C1C9-F274077A38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M21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1C0CE87B-1C75-A424-1DFC-EFF13813550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40545750"/>
              </p:ext>
            </p:extLst>
          </p:nvPr>
        </p:nvGraphicFramePr>
        <p:xfrm>
          <a:off x="323516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1C0CE87B-1C75-A424-1DFC-EFF13813550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23516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99997976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C42C73-25BC-481B-9A22-85D60E391F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K12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3914EA1-6FF0-C5BF-D3BE-F593A89E947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3343925"/>
              </p:ext>
            </p:extLst>
          </p:nvPr>
        </p:nvGraphicFramePr>
        <p:xfrm>
          <a:off x="103187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53914EA1-6FF0-C5BF-D3BE-F593A89E947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3187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343825750"/>
      </p:ext>
    </p:extLst>
  </p:cSld>
  <p:clrMapOvr>
    <a:masterClrMapping/>
  </p:clrMapOvr>
</p:sld>
</file>

<file path=ppt/slides/slide1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46BEEE-F6DE-5369-B1B2-829E1B0321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M4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276E0151-DA7F-34A0-031D-9596DBCDD66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57762544"/>
              </p:ext>
            </p:extLst>
          </p:nvPr>
        </p:nvGraphicFramePr>
        <p:xfrm>
          <a:off x="355600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276E0151-DA7F-34A0-031D-9596DBCDD66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55600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776356415"/>
      </p:ext>
    </p:extLst>
  </p:cSld>
  <p:clrMapOvr>
    <a:masterClrMapping/>
  </p:clrMapOvr>
</p:sld>
</file>

<file path=ppt/slides/slide1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4F3577-7D6D-545B-DFA3-4CF2A3FC86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M41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BD801BB6-9E62-F43C-4F8D-7E7BDC7543B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69242358"/>
              </p:ext>
            </p:extLst>
          </p:nvPr>
        </p:nvGraphicFramePr>
        <p:xfrm>
          <a:off x="355600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BD801BB6-9E62-F43C-4F8D-7E7BDC7543B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55600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55847628"/>
      </p:ext>
    </p:extLst>
  </p:cSld>
  <p:clrMapOvr>
    <a:masterClrMapping/>
  </p:clrMapOvr>
</p:sld>
</file>

<file path=ppt/slides/slide1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1AE083-138F-4740-E6E5-4D2C597071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M45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2213C63E-3B61-8492-B0AD-494AE8F5425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24160091"/>
              </p:ext>
            </p:extLst>
          </p:nvPr>
        </p:nvGraphicFramePr>
        <p:xfrm>
          <a:off x="103187" y="1487034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2213C63E-3B61-8492-B0AD-494AE8F5425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3187" y="1487034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75618644"/>
      </p:ext>
    </p:extLst>
  </p:cSld>
  <p:clrMapOvr>
    <a:masterClrMapping/>
  </p:clrMapOvr>
</p:sld>
</file>

<file path=ppt/slides/slide1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78CD2B-BB3F-6A09-FF78-229CE6E88F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M52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DEE38030-69E7-A57D-56BA-A36EA40E188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55364229"/>
              </p:ext>
            </p:extLst>
          </p:nvPr>
        </p:nvGraphicFramePr>
        <p:xfrm>
          <a:off x="103187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DEE38030-69E7-A57D-56BA-A36EA40E188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3187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143404012"/>
      </p:ext>
    </p:extLst>
  </p:cSld>
  <p:clrMapOvr>
    <a:masterClrMapping/>
  </p:clrMapOvr>
</p:sld>
</file>

<file path=ppt/slides/slide1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04775E-9E53-8081-181F-D2D26BC5A2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M6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F4313D6-A6A9-E28C-B52A-DDEE7B35CC3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41167977"/>
              </p:ext>
            </p:extLst>
          </p:nvPr>
        </p:nvGraphicFramePr>
        <p:xfrm>
          <a:off x="103187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8F4313D6-A6A9-E28C-B52A-DDEE7B35CC3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3187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633915184"/>
      </p:ext>
    </p:extLst>
  </p:cSld>
  <p:clrMapOvr>
    <a:masterClrMapping/>
  </p:clrMapOvr>
</p:sld>
</file>

<file path=ppt/slides/slide1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9449C8-95D2-999F-663F-F096E19ED0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M64/ CN15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C90D6B9-5535-687E-DC97-3150A590574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78450164"/>
              </p:ext>
            </p:extLst>
          </p:nvPr>
        </p:nvGraphicFramePr>
        <p:xfrm>
          <a:off x="328967" y="1305064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9C90D6B9-5535-687E-DC97-3150A590574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28967" y="1305064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438697961"/>
      </p:ext>
    </p:extLst>
  </p:cSld>
  <p:clrMapOvr>
    <a:masterClrMapping/>
  </p:clrMapOvr>
</p:sld>
</file>

<file path=ppt/slides/slide1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AE8ED6-515C-4B96-1080-3751D20DF4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M69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6EDA655-9F65-D140-1380-974BB84AF5B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06841407"/>
              </p:ext>
            </p:extLst>
          </p:nvPr>
        </p:nvGraphicFramePr>
        <p:xfrm>
          <a:off x="103187" y="1296654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96EDA655-9F65-D140-1380-974BB84AF5B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3187" y="1296654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739058583"/>
      </p:ext>
    </p:extLst>
  </p:cSld>
  <p:clrMapOvr>
    <a:masterClrMapping/>
  </p:clrMapOvr>
</p:sld>
</file>

<file path=ppt/slides/slide1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098DFB-C356-ED90-BC63-9DD83699BA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M71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50FABB3-A87B-5BF8-73C3-47096F5A8E8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35828629"/>
              </p:ext>
            </p:extLst>
          </p:nvPr>
        </p:nvGraphicFramePr>
        <p:xfrm>
          <a:off x="0" y="1553327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50FABB3-A87B-5BF8-73C3-47096F5A8E8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0" y="1553327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924494893"/>
      </p:ext>
    </p:extLst>
  </p:cSld>
  <p:clrMapOvr>
    <a:masterClrMapping/>
  </p:clrMapOvr>
</p:sld>
</file>

<file path=ppt/slides/slide1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A70016-4523-5FC2-06B8-ECAB468B7B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M72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85A1C28-19DE-DEF4-AFCC-F26D45301B7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2562172"/>
              </p:ext>
            </p:extLst>
          </p:nvPr>
        </p:nvGraphicFramePr>
        <p:xfrm>
          <a:off x="103187" y="1074738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885A1C28-19DE-DEF4-AFCC-F26D45301B7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3187" y="1074738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416058671"/>
      </p:ext>
    </p:extLst>
  </p:cSld>
  <p:clrMapOvr>
    <a:masterClrMapping/>
  </p:clrMapOvr>
</p:sld>
</file>

<file path=ppt/slides/slide1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80FF24-2047-7B28-38B0-654A22B4B0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M73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7A758369-BD2C-6207-77F6-37504DDFA5B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95242492"/>
              </p:ext>
            </p:extLst>
          </p:nvPr>
        </p:nvGraphicFramePr>
        <p:xfrm>
          <a:off x="103187" y="1027906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7A758369-BD2C-6207-77F6-37504DDFA5B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3187" y="1027906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60714231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3071F1-DAB2-0F60-EE6C-2FF3A19143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K13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F356E024-BB70-46D3-AE78-B66822315B3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10199488"/>
              </p:ext>
            </p:extLst>
          </p:nvPr>
        </p:nvGraphicFramePr>
        <p:xfrm>
          <a:off x="515398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F356E024-BB70-46D3-AE78-B66822315B3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15398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851249939"/>
      </p:ext>
    </p:extLst>
  </p:cSld>
  <p:clrMapOvr>
    <a:masterClrMapping/>
  </p:clrMapOvr>
</p:sld>
</file>

<file path=ppt/slides/slide1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A227C2-D5B6-AADB-A884-C779E5BC14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M74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41D8568-CC43-6603-922A-8A58170911E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77883190"/>
              </p:ext>
            </p:extLst>
          </p:nvPr>
        </p:nvGraphicFramePr>
        <p:xfrm>
          <a:off x="291432" y="1606467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941D8568-CC43-6603-922A-8A58170911E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91432" y="1606467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02585896"/>
      </p:ext>
    </p:extLst>
  </p:cSld>
  <p:clrMapOvr>
    <a:masterClrMapping/>
  </p:clrMapOvr>
</p:sld>
</file>

<file path=ppt/slides/slide1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A57469-0686-5762-049F-8E267C6142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M8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A549F4CE-A93C-4F4C-D2D5-D32648CF129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76816795"/>
              </p:ext>
            </p:extLst>
          </p:nvPr>
        </p:nvGraphicFramePr>
        <p:xfrm>
          <a:off x="275390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A549F4CE-A93C-4F4C-D2D5-D32648CF129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75390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37347613"/>
      </p:ext>
    </p:extLst>
  </p:cSld>
  <p:clrMapOvr>
    <a:masterClrMapping/>
  </p:clrMapOvr>
</p:sld>
</file>

<file path=ppt/slides/slide1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A4237E-B334-407D-EE5B-2DE0DC61EE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M81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CA3A649-6702-23F6-AB39-BF86B5A637A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76348191"/>
              </p:ext>
            </p:extLst>
          </p:nvPr>
        </p:nvGraphicFramePr>
        <p:xfrm>
          <a:off x="0" y="1285195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CA3A649-6702-23F6-AB39-BF86B5A637A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0" y="1285195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30741147"/>
      </p:ext>
    </p:extLst>
  </p:cSld>
  <p:clrMapOvr>
    <a:masterClrMapping/>
  </p:clrMapOvr>
</p:sld>
</file>

<file path=ppt/slides/slide1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D233EC-0FFC-0EF9-F22E-C9A21FF46A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M86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6B07337-3EE0-A024-F7D3-425E41E1A16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63042621"/>
              </p:ext>
            </p:extLst>
          </p:nvPr>
        </p:nvGraphicFramePr>
        <p:xfrm>
          <a:off x="275389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86B07337-3EE0-A024-F7D3-425E41E1A16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75389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425966623"/>
      </p:ext>
    </p:extLst>
  </p:cSld>
  <p:clrMapOvr>
    <a:masterClrMapping/>
  </p:clrMapOvr>
</p:sld>
</file>

<file path=ppt/slides/slide1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8EE9F1-E508-8C3E-13D4-4955640155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M92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30AA2302-8F9E-DC84-FDC6-27BFCB38970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26365314"/>
              </p:ext>
            </p:extLst>
          </p:nvPr>
        </p:nvGraphicFramePr>
        <p:xfrm>
          <a:off x="339557" y="1231149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30AA2302-8F9E-DC84-FDC6-27BFCB38970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39557" y="1231149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42506015"/>
      </p:ext>
    </p:extLst>
  </p:cSld>
  <p:clrMapOvr>
    <a:masterClrMapping/>
  </p:clrMapOvr>
</p:sld>
</file>

<file path=ppt/slides/slide1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26E2BE-74BB-14DD-98F5-CCC6D62948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M95 / (TM75)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4FC7F079-0FE3-4E40-7381-94F0BF8D4D2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83052236"/>
              </p:ext>
            </p:extLst>
          </p:nvPr>
        </p:nvGraphicFramePr>
        <p:xfrm>
          <a:off x="564147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4FC7F079-0FE3-4E40-7381-94F0BF8D4D2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64147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819304349"/>
      </p:ext>
    </p:extLst>
  </p:cSld>
  <p:clrMapOvr>
    <a:masterClrMapping/>
  </p:clrMapOvr>
</p:sld>
</file>

<file path=ppt/slides/slide1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04BF6F-D34A-A84F-1254-81687CBCD9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VH11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2978788-8D24-395A-1ECB-B30EE845A3A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20951349"/>
              </p:ext>
            </p:extLst>
          </p:nvPr>
        </p:nvGraphicFramePr>
        <p:xfrm>
          <a:off x="307473" y="1638551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52978788-8D24-395A-1ECB-B30EE845A3A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07473" y="1638551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41617016"/>
      </p:ext>
    </p:extLst>
  </p:cSld>
  <p:clrMapOvr>
    <a:masterClrMapping/>
  </p:clrMapOvr>
</p:sld>
</file>

<file path=ppt/slides/slide1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4E883D-DB63-0230-1925-218D481B26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VH12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04012620-4885-102F-A9C4-02D7E8DD06A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3584541"/>
              </p:ext>
            </p:extLst>
          </p:nvPr>
        </p:nvGraphicFramePr>
        <p:xfrm>
          <a:off x="0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04012620-4885-102F-A9C4-02D7E8DD06A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0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356194684"/>
      </p:ext>
    </p:extLst>
  </p:cSld>
  <p:clrMapOvr>
    <a:masterClrMapping/>
  </p:clrMapOvr>
</p:sld>
</file>

<file path=ppt/slides/slide1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DD754C-C387-D970-9334-7175122353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VH14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1965FC0E-714B-7AB8-9018-ED1B320C9BA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70578992"/>
              </p:ext>
            </p:extLst>
          </p:nvPr>
        </p:nvGraphicFramePr>
        <p:xfrm>
          <a:off x="612274" y="1312695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1965FC0E-714B-7AB8-9018-ED1B320C9BA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12274" y="1312695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124821120"/>
      </p:ext>
    </p:extLst>
  </p:cSld>
  <p:clrMapOvr>
    <a:masterClrMapping/>
  </p:clrMapOvr>
</p:sld>
</file>

<file path=ppt/slides/slide1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FEDB23-CDAA-5CA7-E91F-CAEBD8900E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VH15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94DC7F4-6F82-994D-AEA1-BA61E29DD07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7000790"/>
              </p:ext>
            </p:extLst>
          </p:nvPr>
        </p:nvGraphicFramePr>
        <p:xfrm>
          <a:off x="103187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594DC7F4-6F82-994D-AEA1-BA61E29DD07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3187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25209823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FF1B0A-A631-264A-055B-AAD578E599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K14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5669C77-A2B5-F13A-D84C-5FCA0608B62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77729654"/>
              </p:ext>
            </p:extLst>
          </p:nvPr>
        </p:nvGraphicFramePr>
        <p:xfrm>
          <a:off x="451853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5669C77-A2B5-F13A-D84C-5FCA0608B62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51853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83274127"/>
      </p:ext>
    </p:extLst>
  </p:cSld>
  <p:clrMapOvr>
    <a:masterClrMapping/>
  </p:clrMapOvr>
</p:sld>
</file>

<file path=ppt/slides/slide1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0210B3-4F42-C5EA-F614-AC40EF93EC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VH16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D96C33D6-3A9B-98A5-6543-7EE1D7B0771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974607"/>
              </p:ext>
            </p:extLst>
          </p:nvPr>
        </p:nvGraphicFramePr>
        <p:xfrm>
          <a:off x="403727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D96C33D6-3A9B-98A5-6543-7EE1D7B0771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03727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083636769"/>
      </p:ext>
    </p:extLst>
  </p:cSld>
  <p:clrMapOvr>
    <a:masterClrMapping/>
  </p:clrMapOvr>
</p:sld>
</file>

<file path=ppt/slides/slide1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820D2D-FC5E-2DC8-6F53-8569D7CF20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VH17-II</a:t>
            </a:r>
            <a:r>
              <a:rPr lang="de-DE"/>
              <a:t> 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8C034DA7-937A-967A-5087-A91631C74B5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28582730"/>
              </p:ext>
            </p:extLst>
          </p:nvPr>
        </p:nvGraphicFramePr>
        <p:xfrm>
          <a:off x="275389" y="1606467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8C034DA7-937A-967A-5087-A91631C74B5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75389" y="1606467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446753213"/>
      </p:ext>
    </p:extLst>
  </p:cSld>
  <p:clrMapOvr>
    <a:masterClrMapping/>
  </p:clrMapOvr>
</p:sld>
</file>

<file path=ppt/slides/slide1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835022-81B5-ED9B-B5FF-9DD665E8F1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VH8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7C483C47-208D-D07D-0B12-FC04A164A9F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63672574"/>
              </p:ext>
            </p:extLst>
          </p:nvPr>
        </p:nvGraphicFramePr>
        <p:xfrm>
          <a:off x="419768" y="1690688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7C483C47-208D-D07D-0B12-FC04A164A9F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19768" y="1690688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67DAC882-D5E7-B039-F671-032C18D5010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27741423"/>
              </p:ext>
            </p:extLst>
          </p:nvPr>
        </p:nvGraphicFramePr>
        <p:xfrm>
          <a:off x="612274" y="7108825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67DAC882-D5E7-B039-F671-032C18D5010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12274" y="7108825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266816577"/>
      </p:ext>
    </p:extLst>
  </p:cSld>
  <p:clrMapOvr>
    <a:masterClrMapping/>
  </p:clrMapOvr>
</p:sld>
</file>

<file path=ppt/slides/slide1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315A51-23C6-FCF9-9CC4-BF114E3933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VH9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2B67A0B9-0598-4669-0C64-E46E2A657EB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74716105"/>
              </p:ext>
            </p:extLst>
          </p:nvPr>
        </p:nvGraphicFramePr>
        <p:xfrm>
          <a:off x="532063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2B67A0B9-0598-4669-0C64-E46E2A657EB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32063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847673940"/>
      </p:ext>
    </p:extLst>
  </p:cSld>
  <p:clrMapOvr>
    <a:masterClrMapping/>
  </p:clrMapOvr>
</p:sld>
</file>

<file path=ppt/slides/slide1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220118-6687-E185-B00F-F7D94E6327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PS07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BD9D24F-053A-0CFA-B948-6D55387F2F5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34610082"/>
              </p:ext>
            </p:extLst>
          </p:nvPr>
        </p:nvGraphicFramePr>
        <p:xfrm>
          <a:off x="419768" y="1690688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8BD9D24F-053A-0CFA-B948-6D55387F2F5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19768" y="1690688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77770089"/>
      </p:ext>
    </p:extLst>
  </p:cSld>
  <p:clrMapOvr>
    <a:masterClrMapping/>
  </p:clrMapOvr>
</p:sld>
</file>

<file path=ppt/slides/slide1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864198-0650-DE32-21E9-F2FD96E537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JH01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6EBD037C-5055-0B33-3A56-301A18FDEA3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12080881"/>
              </p:ext>
            </p:extLst>
          </p:nvPr>
        </p:nvGraphicFramePr>
        <p:xfrm>
          <a:off x="1045411" y="1690688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6EBD037C-5055-0B33-3A56-301A18FDEA3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45411" y="1690688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274997653"/>
      </p:ext>
    </p:extLst>
  </p:cSld>
  <p:clrMapOvr>
    <a:masterClrMapping/>
  </p:clrMapOvr>
</p:sld>
</file>

<file path=ppt/slides/slide1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657E6E-11CB-7B77-251B-107AA07A06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78599809"/>
      </p:ext>
    </p:extLst>
  </p:cSld>
  <p:clrMapOvr>
    <a:masterClrMapping/>
  </p:clrMapOvr>
</p:sld>
</file>

<file path=ppt/slides/slide1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224004-A10B-BB2E-D57E-FBC4980C4C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1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9598A848-6988-DFBC-6317-EF5FC0B056A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43920827"/>
              </p:ext>
            </p:extLst>
          </p:nvPr>
        </p:nvGraphicFramePr>
        <p:xfrm>
          <a:off x="355847" y="1690688"/>
          <a:ext cx="5040395" cy="4557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9598A848-6988-DFBC-6317-EF5FC0B056A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55847" y="1690688"/>
                        <a:ext cx="5040395" cy="4557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856BF660-8C66-F835-CC5A-AB4AC80A3C7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65502207"/>
              </p:ext>
            </p:extLst>
          </p:nvPr>
        </p:nvGraphicFramePr>
        <p:xfrm>
          <a:off x="6197107" y="1628544"/>
          <a:ext cx="5040395" cy="4557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856BF660-8C66-F835-CC5A-AB4AC80A3C7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197107" y="1628544"/>
                        <a:ext cx="5040395" cy="4557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4D4489DE-F75F-C79E-DDA7-6E2468876CB5}"/>
              </a:ext>
            </a:extLst>
          </p:cNvPr>
          <p:cNvSpPr txBox="1"/>
          <p:nvPr/>
        </p:nvSpPr>
        <p:spPr>
          <a:xfrm>
            <a:off x="7457242" y="812169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/>
              <a:t>lit</a:t>
            </a:r>
          </a:p>
        </p:txBody>
      </p:sp>
    </p:spTree>
    <p:extLst>
      <p:ext uri="{BB962C8B-B14F-4D97-AF65-F5344CB8AC3E}">
        <p14:creationId xmlns:p14="http://schemas.microsoft.com/office/powerpoint/2010/main" val="3709697322"/>
      </p:ext>
    </p:extLst>
  </p:cSld>
  <p:clrMapOvr>
    <a:masterClrMapping/>
  </p:clrMapOvr>
</p:sld>
</file>

<file path=ppt/slides/slide1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A5994D-C1C8-B305-1E90-2B0F05BD51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2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C2AD32A-2B87-78AD-C822-3CF649D4C62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76470069"/>
              </p:ext>
            </p:extLst>
          </p:nvPr>
        </p:nvGraphicFramePr>
        <p:xfrm>
          <a:off x="728462" y="2148396"/>
          <a:ext cx="4235213" cy="38290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9C2AD32A-2B87-78AD-C822-3CF649D4C62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28462" y="2148396"/>
                        <a:ext cx="4235213" cy="38290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75D7CCA4-DDD4-B10E-DB57-0CCD676F1EBF}"/>
              </a:ext>
            </a:extLst>
          </p:cNvPr>
          <p:cNvSpPr txBox="1"/>
          <p:nvPr/>
        </p:nvSpPr>
        <p:spPr>
          <a:xfrm>
            <a:off x="7457242" y="812169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/>
              <a:t>lit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9D144CA1-CBDE-5053-25C2-6EBC7ABAE7D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40604474"/>
              </p:ext>
            </p:extLst>
          </p:nvPr>
        </p:nvGraphicFramePr>
        <p:xfrm>
          <a:off x="5577258" y="1438182"/>
          <a:ext cx="5280762" cy="47743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9D144CA1-CBDE-5053-25C2-6EBC7ABAE7D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577258" y="1438182"/>
                        <a:ext cx="5280762" cy="47743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48490834"/>
      </p:ext>
    </p:extLst>
  </p:cSld>
  <p:clrMapOvr>
    <a:masterClrMapping/>
  </p:clrMapOvr>
</p:sld>
</file>

<file path=ppt/slides/slide1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E22ACC-58DE-957A-485C-FAC3CD5AD0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3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012EBF41-B7D4-9D2C-4A45-329EEA3CC95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58423010"/>
              </p:ext>
            </p:extLst>
          </p:nvPr>
        </p:nvGraphicFramePr>
        <p:xfrm>
          <a:off x="426622" y="2778711"/>
          <a:ext cx="3636237" cy="328754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012EBF41-B7D4-9D2C-4A45-329EEA3CC95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26622" y="2778711"/>
                        <a:ext cx="3636237" cy="328754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2D6B007C-7C19-DF5C-E2E2-C30C2648262D}"/>
              </a:ext>
            </a:extLst>
          </p:cNvPr>
          <p:cNvSpPr txBox="1"/>
          <p:nvPr/>
        </p:nvSpPr>
        <p:spPr>
          <a:xfrm>
            <a:off x="7457242" y="812169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/>
              <a:t>lit</a:t>
            </a:r>
          </a:p>
        </p:txBody>
      </p:sp>
    </p:spTree>
    <p:extLst>
      <p:ext uri="{BB962C8B-B14F-4D97-AF65-F5344CB8AC3E}">
        <p14:creationId xmlns:p14="http://schemas.microsoft.com/office/powerpoint/2010/main" val="417010911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35F032-E07B-C8B4-80CB-25980FCCB0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K15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EDB75FA1-76E3-52B6-B324-8A150A05E5C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20616556"/>
              </p:ext>
            </p:extLst>
          </p:nvPr>
        </p:nvGraphicFramePr>
        <p:xfrm>
          <a:off x="391111" y="1305064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EDB75FA1-76E3-52B6-B324-8A150A05E5C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91111" y="1305064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99203109"/>
      </p:ext>
    </p:extLst>
  </p:cSld>
  <p:clrMapOvr>
    <a:masterClrMapping/>
  </p:clrMapOvr>
</p:sld>
</file>

<file path=ppt/slides/slide17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38D61D-2768-4B43-2A12-F686119801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4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781A883-D93D-D814-CBAC-2B920ADF72D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66327728"/>
              </p:ext>
            </p:extLst>
          </p:nvPr>
        </p:nvGraphicFramePr>
        <p:xfrm>
          <a:off x="497643" y="1856820"/>
          <a:ext cx="4461058" cy="40332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5781A883-D93D-D814-CBAC-2B920ADF72D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97643" y="1856820"/>
                        <a:ext cx="4461058" cy="40332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A14A7F61-06C6-42EF-3D05-3CA0DBFFAD68}"/>
              </a:ext>
            </a:extLst>
          </p:cNvPr>
          <p:cNvSpPr txBox="1"/>
          <p:nvPr/>
        </p:nvSpPr>
        <p:spPr>
          <a:xfrm>
            <a:off x="7457242" y="812169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/>
              <a:t>lit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C854EF07-69E9-5204-C931-0DA1C45B1BD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88000129"/>
              </p:ext>
            </p:extLst>
          </p:nvPr>
        </p:nvGraphicFramePr>
        <p:xfrm>
          <a:off x="5833123" y="996835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C854EF07-69E9-5204-C931-0DA1C45B1BD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833123" y="996835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31922808"/>
      </p:ext>
    </p:extLst>
  </p:cSld>
  <p:clrMapOvr>
    <a:masterClrMapping/>
  </p:clrMapOvr>
</p:sld>
</file>

<file path=ppt/slides/slide17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5E3A83-712F-A188-D12A-E4C622C671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5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952F886-F80E-223B-0A1C-D0E15BFF2C41}"/>
              </a:ext>
            </a:extLst>
          </p:cNvPr>
          <p:cNvSpPr txBox="1"/>
          <p:nvPr/>
        </p:nvSpPr>
        <p:spPr>
          <a:xfrm>
            <a:off x="7457242" y="812169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/>
              <a:t>lit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CE39D2A4-C425-470D-070C-1DB7B4580FE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31260757"/>
              </p:ext>
            </p:extLst>
          </p:nvPr>
        </p:nvGraphicFramePr>
        <p:xfrm>
          <a:off x="5513526" y="1074738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CE39D2A4-C425-470D-070C-1DB7B4580FE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513526" y="1074738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8CB58870-95FA-CF82-EAFA-8AC9FF9A9F4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79495247"/>
              </p:ext>
            </p:extLst>
          </p:nvPr>
        </p:nvGraphicFramePr>
        <p:xfrm>
          <a:off x="546768" y="1538568"/>
          <a:ext cx="4966758" cy="4490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8CB58870-95FA-CF82-EAFA-8AC9FF9A9F4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46768" y="1538568"/>
                        <a:ext cx="4966758" cy="4490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58403204"/>
      </p:ext>
    </p:extLst>
  </p:cSld>
  <p:clrMapOvr>
    <a:masterClrMapping/>
  </p:clrMapOvr>
</p:sld>
</file>

<file path=ppt/slides/slide17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6E3565-9B65-6E98-33EC-6E9FC3C5F8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6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F870D1C8-184E-6001-7338-BA0399938D0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20769514"/>
              </p:ext>
            </p:extLst>
          </p:nvPr>
        </p:nvGraphicFramePr>
        <p:xfrm>
          <a:off x="240190" y="1766656"/>
          <a:ext cx="4547273" cy="41112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F870D1C8-184E-6001-7338-BA0399938D0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40190" y="1766656"/>
                        <a:ext cx="4547273" cy="41112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0A38BAAC-0628-4DE5-DA14-B5349009715E}"/>
              </a:ext>
            </a:extLst>
          </p:cNvPr>
          <p:cNvSpPr txBox="1"/>
          <p:nvPr/>
        </p:nvSpPr>
        <p:spPr>
          <a:xfrm>
            <a:off x="7457242" y="812169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/>
              <a:t>lit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4F08B011-A543-C786-B2BE-96BE967B524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69612202"/>
              </p:ext>
            </p:extLst>
          </p:nvPr>
        </p:nvGraphicFramePr>
        <p:xfrm>
          <a:off x="5360987" y="1181501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4F08B011-A543-C786-B2BE-96BE967B524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360987" y="1181501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878210316"/>
      </p:ext>
    </p:extLst>
  </p:cSld>
  <p:clrMapOvr>
    <a:masterClrMapping/>
  </p:clrMapOvr>
</p:sld>
</file>

<file path=ppt/slides/slide17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EE830C-7750-D443-4667-6836255D9A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7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FB50CA3-FD73-6A78-B319-17AD4B1E708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12829652"/>
              </p:ext>
            </p:extLst>
          </p:nvPr>
        </p:nvGraphicFramePr>
        <p:xfrm>
          <a:off x="559788" y="1953087"/>
          <a:ext cx="4628862" cy="41849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FB50CA3-FD73-6A78-B319-17AD4B1E708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59788" y="1953087"/>
                        <a:ext cx="4628862" cy="41849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FD1FF362-782A-F94A-C729-225812923FD3}"/>
              </a:ext>
            </a:extLst>
          </p:cNvPr>
          <p:cNvSpPr txBox="1"/>
          <p:nvPr/>
        </p:nvSpPr>
        <p:spPr>
          <a:xfrm>
            <a:off x="7457242" y="812169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/>
              <a:t>lit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2671258B-EBE7-2013-D0A9-95DA85C6DDC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0350116"/>
              </p:ext>
            </p:extLst>
          </p:nvPr>
        </p:nvGraphicFramePr>
        <p:xfrm>
          <a:off x="5639399" y="996835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2671258B-EBE7-2013-D0A9-95DA85C6DDC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639399" y="996835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04774107"/>
      </p:ext>
    </p:extLst>
  </p:cSld>
  <p:clrMapOvr>
    <a:masterClrMapping/>
  </p:clrMapOvr>
</p:sld>
</file>

<file path=ppt/slides/slide17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7843DD-8AAF-ABAC-C7BB-39A2903516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8 -std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002B9A2-D110-DEE8-0024-28ADA583481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09308619"/>
              </p:ext>
            </p:extLst>
          </p:nvPr>
        </p:nvGraphicFramePr>
        <p:xfrm>
          <a:off x="838200" y="1690688"/>
          <a:ext cx="4380345" cy="39602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8002B9A2-D110-DEE8-0024-28ADA583481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38200" y="1690688"/>
                        <a:ext cx="4380345" cy="39602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E87DC42A-ECAC-4D1D-0D3C-5A2E73507CD7}"/>
              </a:ext>
            </a:extLst>
          </p:cNvPr>
          <p:cNvSpPr txBox="1"/>
          <p:nvPr/>
        </p:nvSpPr>
        <p:spPr>
          <a:xfrm>
            <a:off x="7457242" y="812169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/>
              <a:t>lit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FB484AF1-5689-BB96-F8DD-264BE0B256A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57094305"/>
              </p:ext>
            </p:extLst>
          </p:nvPr>
        </p:nvGraphicFramePr>
        <p:xfrm>
          <a:off x="5682202" y="1181501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FB484AF1-5689-BB96-F8DD-264BE0B256A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682202" y="1181501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519245554"/>
      </p:ext>
    </p:extLst>
  </p:cSld>
  <p:clrMapOvr>
    <a:masterClrMapping/>
  </p:clrMapOvr>
</p:sld>
</file>

<file path=ppt/slides/slide17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300BAD-C3B9-A558-D719-78463836A9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9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154D3A0C-81BC-106A-BC28-A4EC58E520B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2968004"/>
              </p:ext>
            </p:extLst>
          </p:nvPr>
        </p:nvGraphicFramePr>
        <p:xfrm>
          <a:off x="728463" y="2059619"/>
          <a:ext cx="4303948" cy="38912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154D3A0C-81BC-106A-BC28-A4EC58E520B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28463" y="2059619"/>
                        <a:ext cx="4303948" cy="38912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02DFC7BF-0905-4517-B7F7-ABC5E3E72B90}"/>
              </a:ext>
            </a:extLst>
          </p:cNvPr>
          <p:cNvSpPr txBox="1"/>
          <p:nvPr/>
        </p:nvSpPr>
        <p:spPr>
          <a:xfrm>
            <a:off x="7457242" y="812169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/>
              <a:t>lit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C1133F88-E3B1-B52E-D6C1-8FC93FDE46F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53124944"/>
              </p:ext>
            </p:extLst>
          </p:nvPr>
        </p:nvGraphicFramePr>
        <p:xfrm>
          <a:off x="6096000" y="1507417"/>
          <a:ext cx="4817072" cy="435514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C1133F88-E3B1-B52E-D6C1-8FC93FDE46F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096000" y="1507417"/>
                        <a:ext cx="4817072" cy="435514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314426039"/>
      </p:ext>
    </p:extLst>
  </p:cSld>
  <p:clrMapOvr>
    <a:masterClrMapping/>
  </p:clrMapOvr>
</p:sld>
</file>

<file path=ppt/slides/slide17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081B74-518C-04C1-25EC-7ED273905D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10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68C253E2-E1AF-B950-604C-44EEF399FC7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7478676"/>
              </p:ext>
            </p:extLst>
          </p:nvPr>
        </p:nvGraphicFramePr>
        <p:xfrm>
          <a:off x="666750" y="1962150"/>
          <a:ext cx="4144963" cy="3746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68C253E2-E1AF-B950-604C-44EEF399FC7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66750" y="1962150"/>
                        <a:ext cx="4144963" cy="3746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F39E8FCE-623E-6135-C65C-62138CDFBDED}"/>
              </a:ext>
            </a:extLst>
          </p:cNvPr>
          <p:cNvSpPr txBox="1"/>
          <p:nvPr/>
        </p:nvSpPr>
        <p:spPr>
          <a:xfrm>
            <a:off x="7457242" y="812169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/>
              <a:t>lit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0E63375F-CC09-B095-7523-564CDA594A5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51909729"/>
              </p:ext>
            </p:extLst>
          </p:nvPr>
        </p:nvGraphicFramePr>
        <p:xfrm>
          <a:off x="5532868" y="996835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0E63375F-CC09-B095-7523-564CDA594A5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532868" y="996835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323477964"/>
      </p:ext>
    </p:extLst>
  </p:cSld>
  <p:clrMapOvr>
    <a:masterClrMapping/>
  </p:clrMapOvr>
</p:sld>
</file>

<file path=ppt/slides/slide17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5334BF-6393-01E1-4C76-D58FDBBAE6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11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A2B8A02-D028-D752-87A6-AFDCE4589CF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83765293"/>
              </p:ext>
            </p:extLst>
          </p:nvPr>
        </p:nvGraphicFramePr>
        <p:xfrm>
          <a:off x="749423" y="1882066"/>
          <a:ext cx="4441417" cy="40155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A2B8A02-D028-D752-87A6-AFDCE4589CF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49423" y="1882066"/>
                        <a:ext cx="4441417" cy="40155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C17F1FE7-6732-2E42-4F89-1D7101C86643}"/>
              </a:ext>
            </a:extLst>
          </p:cNvPr>
          <p:cNvSpPr txBox="1"/>
          <p:nvPr/>
        </p:nvSpPr>
        <p:spPr>
          <a:xfrm>
            <a:off x="7457242" y="812169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/>
              <a:t>lit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E3686079-5496-F3DB-D331-FEAD96114AB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00388982"/>
              </p:ext>
            </p:extLst>
          </p:nvPr>
        </p:nvGraphicFramePr>
        <p:xfrm>
          <a:off x="5753223" y="1181501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E3686079-5496-F3DB-D331-FEAD96114AB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753223" y="1181501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93876726"/>
      </p:ext>
    </p:extLst>
  </p:cSld>
  <p:clrMapOvr>
    <a:masterClrMapping/>
  </p:clrMapOvr>
</p:sld>
</file>

<file path=ppt/slides/slide17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C97F67-D736-6592-B265-387A771BDA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12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313DACC5-4C42-35BE-9FCF-1357981C1BB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08094164"/>
              </p:ext>
            </p:extLst>
          </p:nvPr>
        </p:nvGraphicFramePr>
        <p:xfrm>
          <a:off x="349929" y="2459115"/>
          <a:ext cx="4461602" cy="40337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313DACC5-4C42-35BE-9FCF-1357981C1BB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49929" y="2459115"/>
                        <a:ext cx="4461602" cy="40337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4CD42CD6-F513-3DF6-E333-B750C85DD63B}"/>
              </a:ext>
            </a:extLst>
          </p:cNvPr>
          <p:cNvSpPr txBox="1"/>
          <p:nvPr/>
        </p:nvSpPr>
        <p:spPr>
          <a:xfrm>
            <a:off x="7457242" y="812169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/>
              <a:t>lit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552C6901-7EEB-507E-51E1-CA03E162E1B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15257858"/>
              </p:ext>
            </p:extLst>
          </p:nvPr>
        </p:nvGraphicFramePr>
        <p:xfrm>
          <a:off x="5849258" y="1181501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552C6901-7EEB-507E-51E1-CA03E162E1B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849258" y="1181501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21259937"/>
      </p:ext>
    </p:extLst>
  </p:cSld>
  <p:clrMapOvr>
    <a:masterClrMapping/>
  </p:clrMapOvr>
</p:sld>
</file>

<file path=ppt/slides/slide17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F2F61C-F9B7-D3B2-900C-0BB645CD55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13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D25435BF-DDCD-4A2C-7BCA-436E2F69E98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92953351"/>
              </p:ext>
            </p:extLst>
          </p:nvPr>
        </p:nvGraphicFramePr>
        <p:xfrm>
          <a:off x="657441" y="2006353"/>
          <a:ext cx="4471421" cy="40426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D25435BF-DDCD-4A2C-7BCA-436E2F69E98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57441" y="2006353"/>
                        <a:ext cx="4471421" cy="40426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0AF8E50B-A309-9BF7-7064-1FF071BF5181}"/>
              </a:ext>
            </a:extLst>
          </p:cNvPr>
          <p:cNvSpPr txBox="1"/>
          <p:nvPr/>
        </p:nvSpPr>
        <p:spPr>
          <a:xfrm>
            <a:off x="7457242" y="812169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/>
              <a:t>lit</a:t>
            </a:r>
          </a:p>
        </p:txBody>
      </p:sp>
    </p:spTree>
    <p:extLst>
      <p:ext uri="{BB962C8B-B14F-4D97-AF65-F5344CB8AC3E}">
        <p14:creationId xmlns:p14="http://schemas.microsoft.com/office/powerpoint/2010/main" val="77025818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ED3738-6252-313D-6776-CE8B210DC7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K2</a:t>
            </a:r>
            <a:r>
              <a:rPr lang="de-DE"/>
              <a:t> 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F9250C84-3361-58E9-3959-1EC257DE5F4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91498817"/>
              </p:ext>
            </p:extLst>
          </p:nvPr>
        </p:nvGraphicFramePr>
        <p:xfrm>
          <a:off x="435811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F9250C84-3361-58E9-3959-1EC257DE5F4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35811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742778679"/>
      </p:ext>
    </p:extLst>
  </p:cSld>
  <p:clrMapOvr>
    <a:masterClrMapping/>
  </p:clrMapOvr>
</p:sld>
</file>

<file path=ppt/slides/slide18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B71C4A-7209-3A18-2616-AF80F64D16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14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CC16FAB-C433-E4E8-CC86-155B936E4A8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86832779"/>
              </p:ext>
            </p:extLst>
          </p:nvPr>
        </p:nvGraphicFramePr>
        <p:xfrm>
          <a:off x="527482" y="2148396"/>
          <a:ext cx="4441418" cy="40155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8CC16FAB-C433-E4E8-CC86-155B936E4A8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27482" y="2148396"/>
                        <a:ext cx="4441418" cy="40155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7853A18C-18F6-B50C-2335-1E702EF69454}"/>
              </a:ext>
            </a:extLst>
          </p:cNvPr>
          <p:cNvSpPr txBox="1"/>
          <p:nvPr/>
        </p:nvSpPr>
        <p:spPr>
          <a:xfrm>
            <a:off x="7457242" y="812169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/>
              <a:t>lit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8CCB2249-7320-0447-4C16-C62AF9CB79D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78395346"/>
              </p:ext>
            </p:extLst>
          </p:nvPr>
        </p:nvGraphicFramePr>
        <p:xfrm>
          <a:off x="6199187" y="1181501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8CCB2249-7320-0447-4C16-C62AF9CB79D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199187" y="1181501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899709365"/>
      </p:ext>
    </p:extLst>
  </p:cSld>
  <p:clrMapOvr>
    <a:masterClrMapping/>
  </p:clrMapOvr>
</p:sld>
</file>

<file path=ppt/slides/slide18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5AF185-8B52-90C1-FBAB-C7522B943D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15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A2791670-238E-B8FA-F3CC-DF6A9382AA7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2538019"/>
              </p:ext>
            </p:extLst>
          </p:nvPr>
        </p:nvGraphicFramePr>
        <p:xfrm>
          <a:off x="660647" y="1690688"/>
          <a:ext cx="4578888" cy="41397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A2791670-238E-B8FA-F3CC-DF6A9382AA7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60647" y="1690688"/>
                        <a:ext cx="4578888" cy="41397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727063DF-CD02-25A1-FCC8-AC8A06F6C693}"/>
              </a:ext>
            </a:extLst>
          </p:cNvPr>
          <p:cNvSpPr txBox="1"/>
          <p:nvPr/>
        </p:nvSpPr>
        <p:spPr>
          <a:xfrm>
            <a:off x="7457242" y="812169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/>
              <a:t>lit</a:t>
            </a:r>
          </a:p>
        </p:txBody>
      </p:sp>
    </p:spTree>
    <p:extLst>
      <p:ext uri="{BB962C8B-B14F-4D97-AF65-F5344CB8AC3E}">
        <p14:creationId xmlns:p14="http://schemas.microsoft.com/office/powerpoint/2010/main" val="2437039918"/>
      </p:ext>
    </p:extLst>
  </p:cSld>
  <p:clrMapOvr>
    <a:masterClrMapping/>
  </p:clrMapOvr>
</p:sld>
</file>

<file path=ppt/slides/slide18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4F88BD-9572-7999-BC65-F868C178C5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16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78C13780-7BAA-CC82-C411-0B23C07BBE9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30182281"/>
              </p:ext>
            </p:extLst>
          </p:nvPr>
        </p:nvGraphicFramePr>
        <p:xfrm>
          <a:off x="550909" y="1690688"/>
          <a:ext cx="4841851" cy="43775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78C13780-7BAA-CC82-C411-0B23C07BBE9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50909" y="1690688"/>
                        <a:ext cx="4841851" cy="437754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12FE00E4-8AEB-0D44-68B1-0ADB0D59F100}"/>
              </a:ext>
            </a:extLst>
          </p:cNvPr>
          <p:cNvSpPr txBox="1"/>
          <p:nvPr/>
        </p:nvSpPr>
        <p:spPr>
          <a:xfrm>
            <a:off x="7457242" y="812169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/>
              <a:t>lit</a:t>
            </a:r>
          </a:p>
        </p:txBody>
      </p:sp>
    </p:spTree>
    <p:extLst>
      <p:ext uri="{BB962C8B-B14F-4D97-AF65-F5344CB8AC3E}">
        <p14:creationId xmlns:p14="http://schemas.microsoft.com/office/powerpoint/2010/main" val="326007136"/>
      </p:ext>
    </p:extLst>
  </p:cSld>
  <p:clrMapOvr>
    <a:masterClrMapping/>
  </p:clrMapOvr>
</p:sld>
</file>

<file path=ppt/slides/slide18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A9D285-9D41-44D3-D091-9F919D9C07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17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BDFE954A-D566-E8AE-ADE2-86091278C53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6477939"/>
              </p:ext>
            </p:extLst>
          </p:nvPr>
        </p:nvGraphicFramePr>
        <p:xfrm>
          <a:off x="497643" y="1899821"/>
          <a:ext cx="3970093" cy="35893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BDFE954A-D566-E8AE-ADE2-86091278C53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97643" y="1899821"/>
                        <a:ext cx="3970093" cy="35893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9E2300AF-A69D-C4EA-6BFF-15FAD0D0EEAD}"/>
              </a:ext>
            </a:extLst>
          </p:cNvPr>
          <p:cNvSpPr txBox="1"/>
          <p:nvPr/>
        </p:nvSpPr>
        <p:spPr>
          <a:xfrm>
            <a:off x="7457242" y="812169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/>
              <a:t>lit</a:t>
            </a:r>
          </a:p>
        </p:txBody>
      </p:sp>
    </p:spTree>
    <p:extLst>
      <p:ext uri="{BB962C8B-B14F-4D97-AF65-F5344CB8AC3E}">
        <p14:creationId xmlns:p14="http://schemas.microsoft.com/office/powerpoint/2010/main" val="373315249"/>
      </p:ext>
    </p:extLst>
  </p:cSld>
  <p:clrMapOvr>
    <a:masterClrMapping/>
  </p:clrMapOvr>
</p:sld>
</file>

<file path=ppt/slides/slide18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57DD60-0A6C-88BA-684B-4078E4E227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18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78C048C6-E7ED-D0B0-24FE-C93EA8F2F21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83600320"/>
              </p:ext>
            </p:extLst>
          </p:nvPr>
        </p:nvGraphicFramePr>
        <p:xfrm>
          <a:off x="417743" y="1690688"/>
          <a:ext cx="4657443" cy="42108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78C048C6-E7ED-D0B0-24FE-C93EA8F2F21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17743" y="1690688"/>
                        <a:ext cx="4657443" cy="42108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D71C53C2-9271-C105-3107-0C070B33F00D}"/>
              </a:ext>
            </a:extLst>
          </p:cNvPr>
          <p:cNvSpPr txBox="1"/>
          <p:nvPr/>
        </p:nvSpPr>
        <p:spPr>
          <a:xfrm>
            <a:off x="7457242" y="812169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/>
              <a:t>lit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4FE9C41A-653D-F713-4C7E-0F88F78E386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60425816"/>
              </p:ext>
            </p:extLst>
          </p:nvPr>
        </p:nvGraphicFramePr>
        <p:xfrm>
          <a:off x="5218086" y="932202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4FE9C41A-653D-F713-4C7E-0F88F78E386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218086" y="932202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847818880"/>
      </p:ext>
    </p:extLst>
  </p:cSld>
  <p:clrMapOvr>
    <a:masterClrMapping/>
  </p:clrMapOvr>
</p:sld>
</file>

<file path=ppt/slides/slide18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3315C8-CA28-05A7-5C0B-3CD2C506B8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19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F5DF9242-8188-8B28-50E6-A3FF5BE8817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95576668"/>
              </p:ext>
            </p:extLst>
          </p:nvPr>
        </p:nvGraphicFramePr>
        <p:xfrm>
          <a:off x="591459" y="2361460"/>
          <a:ext cx="4517815" cy="40845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F5DF9242-8188-8B28-50E6-A3FF5BE8817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91459" y="2361460"/>
                        <a:ext cx="4517815" cy="40845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57A5E78B-4A1B-082F-4871-E738225DFD09}"/>
              </a:ext>
            </a:extLst>
          </p:cNvPr>
          <p:cNvSpPr txBox="1"/>
          <p:nvPr/>
        </p:nvSpPr>
        <p:spPr>
          <a:xfrm>
            <a:off x="7457242" y="812169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/>
              <a:t>lit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B33E8DF4-407B-694A-60A6-433F78F122C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97324326"/>
              </p:ext>
            </p:extLst>
          </p:nvPr>
        </p:nvGraphicFramePr>
        <p:xfrm>
          <a:off x="5708835" y="1181501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B33E8DF4-407B-694A-60A6-433F78F122C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708835" y="1181501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948445893"/>
      </p:ext>
    </p:extLst>
  </p:cSld>
  <p:clrMapOvr>
    <a:masterClrMapping/>
  </p:clrMapOvr>
</p:sld>
</file>

<file path=ppt/slides/slide18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880052-8241-E232-C015-2484F3A9EF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20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70B99AB6-7F82-7257-8FEE-3AFD43D9220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01165428"/>
              </p:ext>
            </p:extLst>
          </p:nvPr>
        </p:nvGraphicFramePr>
        <p:xfrm>
          <a:off x="838200" y="2104007"/>
          <a:ext cx="3810827" cy="34453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70B99AB6-7F82-7257-8FEE-3AFD43D9220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38200" y="2104007"/>
                        <a:ext cx="3810827" cy="344539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387B7225-B8C7-1FED-DDA9-05D4F43FF9E8}"/>
              </a:ext>
            </a:extLst>
          </p:cNvPr>
          <p:cNvSpPr txBox="1"/>
          <p:nvPr/>
        </p:nvSpPr>
        <p:spPr>
          <a:xfrm>
            <a:off x="7457242" y="812169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/>
              <a:t>lit</a:t>
            </a:r>
          </a:p>
        </p:txBody>
      </p:sp>
    </p:spTree>
    <p:extLst>
      <p:ext uri="{BB962C8B-B14F-4D97-AF65-F5344CB8AC3E}">
        <p14:creationId xmlns:p14="http://schemas.microsoft.com/office/powerpoint/2010/main" val="1287938043"/>
      </p:ext>
    </p:extLst>
  </p:cSld>
  <p:clrMapOvr>
    <a:masterClrMapping/>
  </p:clrMapOvr>
</p:sld>
</file>

<file path=ppt/slides/slide18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CB6AB1-ED0A-14B9-939D-F4BE7D2AD9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kk059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3EC4075D-4811-17C5-937B-C6DE9276D94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83932927"/>
              </p:ext>
            </p:extLst>
          </p:nvPr>
        </p:nvGraphicFramePr>
        <p:xfrm>
          <a:off x="302334" y="2237173"/>
          <a:ext cx="4480695" cy="40510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3EC4075D-4811-17C5-937B-C6DE9276D94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02334" y="2237173"/>
                        <a:ext cx="4480695" cy="40510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5937F94C-8D4B-8A86-D7FF-0D7E424BE47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65284434"/>
              </p:ext>
            </p:extLst>
          </p:nvPr>
        </p:nvGraphicFramePr>
        <p:xfrm>
          <a:off x="302334" y="6288195"/>
          <a:ext cx="4890169" cy="44212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5937F94C-8D4B-8A86-D7FF-0D7E424BE47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02334" y="6288195"/>
                        <a:ext cx="4890169" cy="442123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003129706"/>
      </p:ext>
    </p:extLst>
  </p:cSld>
  <p:clrMapOvr>
    <a:masterClrMapping/>
  </p:clrMapOvr>
</p:sld>
</file>

<file path=ppt/slides/slide18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1E977C-6411-D853-8A96-A42F790519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kk060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02D19A7D-1863-202C-DA52-98F0047B46F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12631350"/>
              </p:ext>
            </p:extLst>
          </p:nvPr>
        </p:nvGraphicFramePr>
        <p:xfrm>
          <a:off x="838200" y="2077375"/>
          <a:ext cx="4491391" cy="40606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02D19A7D-1863-202C-DA52-98F0047B46F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38200" y="2077375"/>
                        <a:ext cx="4491391" cy="40606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88BEF63E-F76C-BFFB-403B-F7A7B9521DB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42049720"/>
              </p:ext>
            </p:extLst>
          </p:nvPr>
        </p:nvGraphicFramePr>
        <p:xfrm>
          <a:off x="716905" y="6407951"/>
          <a:ext cx="4162172" cy="37630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88BEF63E-F76C-BFFB-403B-F7A7B9521DB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16905" y="6407951"/>
                        <a:ext cx="4162172" cy="37630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258684061"/>
      </p:ext>
    </p:extLst>
  </p:cSld>
  <p:clrMapOvr>
    <a:masterClrMapping/>
  </p:clrMapOvr>
</p:sld>
</file>

<file path=ppt/slides/slide18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8C2D63-8243-B2A4-2F93-662B0C5256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kk061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A80712C3-F7A0-5E09-B3DE-3E3652F9B3D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04849930"/>
              </p:ext>
            </p:extLst>
          </p:nvPr>
        </p:nvGraphicFramePr>
        <p:xfrm>
          <a:off x="419768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A80712C3-F7A0-5E09-B3DE-3E3652F9B3D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19768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37977488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8E0BE8-EA9A-FC4E-0B3E-F5DBF914D8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K22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A1C6BF0E-94B5-E79D-11F0-0DE6A56D05C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49095967"/>
              </p:ext>
            </p:extLst>
          </p:nvPr>
        </p:nvGraphicFramePr>
        <p:xfrm>
          <a:off x="0" y="1553328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A1C6BF0E-94B5-E79D-11F0-0DE6A56D05C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0" y="1553328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016114902"/>
      </p:ext>
    </p:extLst>
  </p:cSld>
  <p:clrMapOvr>
    <a:masterClrMapping/>
  </p:clrMapOvr>
</p:sld>
</file>

<file path=ppt/slides/slide19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A95231-33F6-2B34-4259-4AB69A8115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kk066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02E56959-CD39-2CD2-EE37-EB9B3D314E7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3942915"/>
              </p:ext>
            </p:extLst>
          </p:nvPr>
        </p:nvGraphicFramePr>
        <p:xfrm>
          <a:off x="838200" y="2139518"/>
          <a:ext cx="3666572" cy="33149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02E56959-CD39-2CD2-EE37-EB9B3D314E7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38200" y="2139518"/>
                        <a:ext cx="3666572" cy="33149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8ED53B63-9C62-114C-27C5-13E9DE92897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93229674"/>
              </p:ext>
            </p:extLst>
          </p:nvPr>
        </p:nvGraphicFramePr>
        <p:xfrm>
          <a:off x="4690823" y="1027906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8ED53B63-9C62-114C-27C5-13E9DE92897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690823" y="1027906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055C0E78-2753-F2F9-23E9-F858D13C0C02}"/>
              </a:ext>
            </a:extLst>
          </p:cNvPr>
          <p:cNvSpPr txBox="1"/>
          <p:nvPr/>
        </p:nvSpPr>
        <p:spPr>
          <a:xfrm>
            <a:off x="7457242" y="812169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/>
              <a:t>lit</a:t>
            </a:r>
          </a:p>
        </p:txBody>
      </p:sp>
    </p:spTree>
    <p:extLst>
      <p:ext uri="{BB962C8B-B14F-4D97-AF65-F5344CB8AC3E}">
        <p14:creationId xmlns:p14="http://schemas.microsoft.com/office/powerpoint/2010/main" val="2974409549"/>
      </p:ext>
    </p:extLst>
  </p:cSld>
  <p:clrMapOvr>
    <a:masterClrMapping/>
  </p:clrMapOvr>
</p:sld>
</file>

<file path=ppt/slides/slide19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52E8D1-B09E-CC96-C402-0EB3874B11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kk067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681664B-D958-0B5B-1E90-B7C270E32BB9}"/>
              </a:ext>
            </a:extLst>
          </p:cNvPr>
          <p:cNvSpPr txBox="1"/>
          <p:nvPr/>
        </p:nvSpPr>
        <p:spPr>
          <a:xfrm>
            <a:off x="7457242" y="812169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/>
              <a:t>lit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BA11648F-6610-AD21-8690-E2E5D19F709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90249204"/>
              </p:ext>
            </p:extLst>
          </p:nvPr>
        </p:nvGraphicFramePr>
        <p:xfrm>
          <a:off x="5708835" y="1031220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BA11648F-6610-AD21-8690-E2E5D19F709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708835" y="1031220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B16414CD-835F-723A-26F8-06A229535EB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89311248"/>
              </p:ext>
            </p:extLst>
          </p:nvPr>
        </p:nvGraphicFramePr>
        <p:xfrm>
          <a:off x="103187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B16414CD-835F-723A-26F8-06A229535EB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03187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384423603"/>
      </p:ext>
    </p:extLst>
  </p:cSld>
  <p:clrMapOvr>
    <a:masterClrMapping/>
  </p:clrMapOvr>
</p:sld>
</file>

<file path=ppt/slides/slide19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93788C-BC96-C811-D9C7-A2A1B731D8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kk068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3A4DA96A-7599-32AA-AB2A-10BB8D2D550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4400512"/>
              </p:ext>
            </p:extLst>
          </p:nvPr>
        </p:nvGraphicFramePr>
        <p:xfrm>
          <a:off x="838200" y="1553328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3A4DA96A-7599-32AA-AB2A-10BB8D2D550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38200" y="1553328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79216872"/>
      </p:ext>
    </p:extLst>
  </p:cSld>
  <p:clrMapOvr>
    <a:masterClrMapping/>
  </p:clrMapOvr>
</p:sld>
</file>

<file path=ppt/slides/slide19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6E8157-0A06-6134-94F2-836F5749B3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KK069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F8746310-210A-3327-7FA6-44EEF20F98E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90920320"/>
              </p:ext>
            </p:extLst>
          </p:nvPr>
        </p:nvGraphicFramePr>
        <p:xfrm>
          <a:off x="387684" y="1690688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F8746310-210A-3327-7FA6-44EEF20F98E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87684" y="1690688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225807883"/>
      </p:ext>
    </p:extLst>
  </p:cSld>
  <p:clrMapOvr>
    <a:masterClrMapping/>
  </p:clrMapOvr>
</p:sld>
</file>

<file path=ppt/slides/slide19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6DAF7-D3B1-6749-A076-E72604562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21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2F1E8D4E-CC4D-E34D-59C3-A5296790F19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67276844"/>
              </p:ext>
            </p:extLst>
          </p:nvPr>
        </p:nvGraphicFramePr>
        <p:xfrm>
          <a:off x="580189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2F1E8D4E-CC4D-E34D-59C3-A5296790F19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80189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268225756"/>
      </p:ext>
    </p:extLst>
  </p:cSld>
  <p:clrMapOvr>
    <a:masterClrMapping/>
  </p:clrMapOvr>
</p:sld>
</file>

<file path=ppt/slides/slide19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6DAF7-D3B1-6749-A076-E72604562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22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F5A494B-CE3B-C79E-6978-8C247A4535B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64455472"/>
              </p:ext>
            </p:extLst>
          </p:nvPr>
        </p:nvGraphicFramePr>
        <p:xfrm>
          <a:off x="644358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F5A494B-CE3B-C79E-6978-8C247A4535B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44358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020192741"/>
      </p:ext>
    </p:extLst>
  </p:cSld>
  <p:clrMapOvr>
    <a:masterClrMapping/>
  </p:clrMapOvr>
</p:sld>
</file>

<file path=ppt/slides/slide19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F43CED-7963-6BF7-CE0F-7C1F2EFCAE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23-std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2D0C0B03-3EA2-336C-A998-467DAFADF95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54914417"/>
              </p:ext>
            </p:extLst>
          </p:nvPr>
        </p:nvGraphicFramePr>
        <p:xfrm>
          <a:off x="328968" y="1864311"/>
          <a:ext cx="5119494" cy="46285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2D0C0B03-3EA2-336C-A998-467DAFADF95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28968" y="1864311"/>
                        <a:ext cx="5119494" cy="46285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99453516"/>
      </p:ext>
    </p:extLst>
  </p:cSld>
  <p:clrMapOvr>
    <a:masterClrMapping/>
  </p:clrMapOvr>
</p:sld>
</file>

<file path=ppt/slides/slide19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6DAF7-D3B1-6749-A076-E72604562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24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BBA8795-E97B-DEB7-AB5C-EF2202CE5FE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65364334"/>
              </p:ext>
            </p:extLst>
          </p:nvPr>
        </p:nvGraphicFramePr>
        <p:xfrm>
          <a:off x="435811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5BBA8795-E97B-DEB7-AB5C-EF2202CE5FE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35811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320063209"/>
      </p:ext>
    </p:extLst>
  </p:cSld>
  <p:clrMapOvr>
    <a:masterClrMapping/>
  </p:clrMapOvr>
</p:sld>
</file>

<file path=ppt/slides/slide19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6DAF7-D3B1-6749-A076-E72604562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25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6999E90-2167-7AAB-5A15-3B7CB1D471E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0128131"/>
              </p:ext>
            </p:extLst>
          </p:nvPr>
        </p:nvGraphicFramePr>
        <p:xfrm>
          <a:off x="103187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86999E90-2167-7AAB-5A15-3B7CB1D471E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3187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944776280"/>
      </p:ext>
    </p:extLst>
  </p:cSld>
  <p:clrMapOvr>
    <a:masterClrMapping/>
  </p:clrMapOvr>
</p:sld>
</file>

<file path=ppt/slides/slide19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6DAF7-D3B1-6749-A076-E72604562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26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7A3FEC20-2854-23E5-0CA4-D47DA0CF8E3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03075259"/>
              </p:ext>
            </p:extLst>
          </p:nvPr>
        </p:nvGraphicFramePr>
        <p:xfrm>
          <a:off x="103187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7A3FEC20-2854-23E5-0CA4-D47DA0CF8E3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3187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0795543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F2AEEC-BD8A-2293-0B5A-4A5D7B2829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R2/ TM142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D4CB603E-3E50-020A-1AE0-36D991A8DB1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04431779"/>
              </p:ext>
            </p:extLst>
          </p:nvPr>
        </p:nvGraphicFramePr>
        <p:xfrm>
          <a:off x="722085" y="7003228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D4CB603E-3E50-020A-1AE0-36D991A8DB1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22085" y="7003228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7C40838B-7BA5-525B-B2D3-AEF9671AFA9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66558289"/>
              </p:ext>
            </p:extLst>
          </p:nvPr>
        </p:nvGraphicFramePr>
        <p:xfrm>
          <a:off x="591457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7C40838B-7BA5-525B-B2D3-AEF9671AFA9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91457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546421780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78DFC0-AE40-BEFD-DE7E-E68DD405DF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K23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02FC30C-74AC-BBD8-94EC-AD58FF37611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30604895"/>
              </p:ext>
            </p:extLst>
          </p:nvPr>
        </p:nvGraphicFramePr>
        <p:xfrm>
          <a:off x="692484" y="1548147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02FC30C-74AC-BBD8-94EC-AD58FF37611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92484" y="1548147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405711615"/>
      </p:ext>
    </p:extLst>
  </p:cSld>
  <p:clrMapOvr>
    <a:masterClrMapping/>
  </p:clrMapOvr>
</p:sld>
</file>

<file path=ppt/slides/slide20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E55D43-B525-0DEA-3907-B5E41B0C7E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27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CCF0F9C-9600-0CA4-DADF-E4E4B502E7B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6382802"/>
              </p:ext>
            </p:extLst>
          </p:nvPr>
        </p:nvGraphicFramePr>
        <p:xfrm>
          <a:off x="382233" y="120904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CCF0F9C-9600-0CA4-DADF-E4E4B502E7B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82233" y="120904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602044471"/>
      </p:ext>
    </p:extLst>
  </p:cSld>
  <p:clrMapOvr>
    <a:masterClrMapping/>
  </p:clrMapOvr>
</p:sld>
</file>

<file path=ppt/slides/slide20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6DAF7-D3B1-6749-A076-E72604562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28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622D0AB-5AD8-D5B4-B3F5-1C98BB92B1B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82124237"/>
              </p:ext>
            </p:extLst>
          </p:nvPr>
        </p:nvGraphicFramePr>
        <p:xfrm>
          <a:off x="291432" y="1296654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5622D0AB-5AD8-D5B4-B3F5-1C98BB92B1B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91432" y="1296654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915459117"/>
      </p:ext>
    </p:extLst>
  </p:cSld>
  <p:clrMapOvr>
    <a:masterClrMapping/>
  </p:clrMapOvr>
</p:sld>
</file>

<file path=ppt/slides/slide20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6DAF7-D3B1-6749-A076-E72604562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29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16612341-2FA2-EB18-E5BE-BC4D44AD413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84927294"/>
              </p:ext>
            </p:extLst>
          </p:nvPr>
        </p:nvGraphicFramePr>
        <p:xfrm>
          <a:off x="516021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16612341-2FA2-EB18-E5BE-BC4D44AD413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16021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197159243"/>
      </p:ext>
    </p:extLst>
  </p:cSld>
  <p:clrMapOvr>
    <a:masterClrMapping/>
  </p:clrMapOvr>
</p:sld>
</file>

<file path=ppt/slides/slide20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6DAF7-D3B1-6749-A076-E72604562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30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51BBF8B-0961-05C5-D471-A2935578C64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52922872"/>
              </p:ext>
            </p:extLst>
          </p:nvPr>
        </p:nvGraphicFramePr>
        <p:xfrm>
          <a:off x="532063" y="1371684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851BBF8B-0961-05C5-D471-A2935578C64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32063" y="1371684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325073965"/>
      </p:ext>
    </p:extLst>
  </p:cSld>
  <p:clrMapOvr>
    <a:masterClrMapping/>
  </p:clrMapOvr>
</p:sld>
</file>

<file path=ppt/slides/slide20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6916DB-3DB2-E73D-359B-856C2639F9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31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2B6FD32D-98D7-1798-EF4D-AF58EE30C7F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21654619"/>
              </p:ext>
            </p:extLst>
          </p:nvPr>
        </p:nvGraphicFramePr>
        <p:xfrm>
          <a:off x="213557" y="1376086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2B6FD32D-98D7-1798-EF4D-AF58EE30C7F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13557" y="1376086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177583764"/>
      </p:ext>
    </p:extLst>
  </p:cSld>
  <p:clrMapOvr>
    <a:masterClrMapping/>
  </p:clrMapOvr>
</p:sld>
</file>

<file path=ppt/slides/slide20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6DAF7-D3B1-6749-A076-E72604562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32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BFDA809-99B7-7174-FE6B-7E3E6FDA0E0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34377209"/>
              </p:ext>
            </p:extLst>
          </p:nvPr>
        </p:nvGraphicFramePr>
        <p:xfrm>
          <a:off x="724568" y="1690688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8BFDA809-99B7-7174-FE6B-7E3E6FDA0E0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24568" y="1690688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536143135"/>
      </p:ext>
    </p:extLst>
  </p:cSld>
  <p:clrMapOvr>
    <a:masterClrMapping/>
  </p:clrMapOvr>
</p:sld>
</file>

<file path=ppt/slides/slide20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6DAF7-D3B1-6749-A076-E72604562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33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64F0B379-31B5-0D13-384C-F80930DFE29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48357041"/>
              </p:ext>
            </p:extLst>
          </p:nvPr>
        </p:nvGraphicFramePr>
        <p:xfrm>
          <a:off x="419769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64F0B379-31B5-0D13-384C-F80930DFE29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19769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659747753"/>
      </p:ext>
    </p:extLst>
  </p:cSld>
  <p:clrMapOvr>
    <a:masterClrMapping/>
  </p:clrMapOvr>
</p:sld>
</file>

<file path=ppt/slides/slide20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6DAF7-D3B1-6749-A076-E72604562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34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DE81403B-81B5-4444-E0CE-CB947E445DE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43540287"/>
              </p:ext>
            </p:extLst>
          </p:nvPr>
        </p:nvGraphicFramePr>
        <p:xfrm>
          <a:off x="676442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DE81403B-81B5-4444-E0CE-CB947E445DE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76442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539225582"/>
      </p:ext>
    </p:extLst>
  </p:cSld>
  <p:clrMapOvr>
    <a:masterClrMapping/>
  </p:clrMapOvr>
</p:sld>
</file>

<file path=ppt/slides/slide20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6DAF7-D3B1-6749-A076-E72604562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35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F0E1EC38-588F-F6D9-53DC-B7B3F5241D5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65025681"/>
              </p:ext>
            </p:extLst>
          </p:nvPr>
        </p:nvGraphicFramePr>
        <p:xfrm>
          <a:off x="243305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F0E1EC38-588F-F6D9-53DC-B7B3F5241D5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43305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832263747"/>
      </p:ext>
    </p:extLst>
  </p:cSld>
  <p:clrMapOvr>
    <a:masterClrMapping/>
  </p:clrMapOvr>
</p:sld>
</file>

<file path=ppt/slides/slide20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6DAF7-D3B1-6749-A076-E72604562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36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0852E2E2-2A9B-1E77-020A-8F68DC82E7A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24238889"/>
              </p:ext>
            </p:extLst>
          </p:nvPr>
        </p:nvGraphicFramePr>
        <p:xfrm>
          <a:off x="243306" y="1553327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0852E2E2-2A9B-1E77-020A-8F68DC82E7A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43306" y="1553327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644598879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E52CB8-F7A0-5DF8-D9CC-835663D631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K24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CB15E3C-1DB0-D9BE-D9BC-C6C1CA46132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26237545"/>
              </p:ext>
            </p:extLst>
          </p:nvPr>
        </p:nvGraphicFramePr>
        <p:xfrm>
          <a:off x="660400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CB15E3C-1DB0-D9BE-D9BC-C6C1CA46132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60400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114209786"/>
      </p:ext>
    </p:extLst>
  </p:cSld>
  <p:clrMapOvr>
    <a:masterClrMapping/>
  </p:clrMapOvr>
</p:sld>
</file>

<file path=ppt/slides/slide2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6DAF7-D3B1-6749-A076-E72604562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37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B79FF27-54B3-F566-41A6-0FF1B433B69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44226326"/>
              </p:ext>
            </p:extLst>
          </p:nvPr>
        </p:nvGraphicFramePr>
        <p:xfrm>
          <a:off x="676442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8B79FF27-54B3-F566-41A6-0FF1B433B69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76442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217276297"/>
      </p:ext>
    </p:extLst>
  </p:cSld>
  <p:clrMapOvr>
    <a:masterClrMapping/>
  </p:clrMapOvr>
</p:sld>
</file>

<file path=ppt/slides/slide2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6DAF7-D3B1-6749-A076-E72604562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38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00D84317-BA66-5960-73CF-C17E15547E4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61653056"/>
              </p:ext>
            </p:extLst>
          </p:nvPr>
        </p:nvGraphicFramePr>
        <p:xfrm>
          <a:off x="371642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00D84317-BA66-5960-73CF-C17E15547E4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71642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882373646"/>
      </p:ext>
    </p:extLst>
  </p:cSld>
  <p:clrMapOvr>
    <a:masterClrMapping/>
  </p:clrMapOvr>
</p:sld>
</file>

<file path=ppt/slides/slide2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6DAF7-D3B1-6749-A076-E72604562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39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153D3CD-C1B3-9467-0B2C-8F9267E1930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69828354"/>
              </p:ext>
            </p:extLst>
          </p:nvPr>
        </p:nvGraphicFramePr>
        <p:xfrm>
          <a:off x="516021" y="1466496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153D3CD-C1B3-9467-0B2C-8F9267E1930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16021" y="1466496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89820617"/>
      </p:ext>
    </p:extLst>
  </p:cSld>
  <p:clrMapOvr>
    <a:masterClrMapping/>
  </p:clrMapOvr>
</p:sld>
</file>

<file path=ppt/slides/slide2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6DAF7-D3B1-6749-A076-E72604562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40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E8F47143-0E79-BA80-6443-0CD58E8612B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54563136"/>
              </p:ext>
            </p:extLst>
          </p:nvPr>
        </p:nvGraphicFramePr>
        <p:xfrm>
          <a:off x="451853" y="1466496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E8F47143-0E79-BA80-6443-0CD58E8612B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51853" y="1466496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890709503"/>
      </p:ext>
    </p:extLst>
  </p:cSld>
  <p:clrMapOvr>
    <a:masterClrMapping/>
  </p:clrMapOvr>
</p:sld>
</file>

<file path=ppt/slides/slide2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6DAF7-D3B1-6749-A076-E72604562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41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67151486-7062-3C90-EDA1-2695F5C84C7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27122733"/>
              </p:ext>
            </p:extLst>
          </p:nvPr>
        </p:nvGraphicFramePr>
        <p:xfrm>
          <a:off x="612274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67151486-7062-3C90-EDA1-2695F5C84C7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12274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751934346"/>
      </p:ext>
    </p:extLst>
  </p:cSld>
  <p:clrMapOvr>
    <a:masterClrMapping/>
  </p:clrMapOvr>
</p:sld>
</file>

<file path=ppt/slides/slide2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6DAF7-D3B1-6749-A076-E72604562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42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8C3C48E-F4B9-9591-43FF-4BADFF13035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78348510"/>
              </p:ext>
            </p:extLst>
          </p:nvPr>
        </p:nvGraphicFramePr>
        <p:xfrm>
          <a:off x="323515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98C3C48E-F4B9-9591-43FF-4BADFF13035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23515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588625897"/>
      </p:ext>
    </p:extLst>
  </p:cSld>
  <p:clrMapOvr>
    <a:masterClrMapping/>
  </p:clrMapOvr>
</p:sld>
</file>

<file path=ppt/slides/slide2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6DAF7-D3B1-6749-A076-E72604562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43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B6FBF74A-8E66-AF16-88EE-9CF0AC20858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69351134"/>
              </p:ext>
            </p:extLst>
          </p:nvPr>
        </p:nvGraphicFramePr>
        <p:xfrm>
          <a:off x="227263" y="1232485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B6FBF74A-8E66-AF16-88EE-9CF0AC20858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27263" y="1232485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144400893"/>
      </p:ext>
    </p:extLst>
  </p:cSld>
  <p:clrMapOvr>
    <a:masterClrMapping/>
  </p:clrMapOvr>
</p:sld>
</file>

<file path=ppt/slides/slide2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6DAF7-D3B1-6749-A076-E72604562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44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22D80BAB-1B71-4693-56B2-7A4B50CD4D2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75518516"/>
              </p:ext>
            </p:extLst>
          </p:nvPr>
        </p:nvGraphicFramePr>
        <p:xfrm>
          <a:off x="548106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22D80BAB-1B71-4693-56B2-7A4B50CD4D2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48106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896684177"/>
      </p:ext>
    </p:extLst>
  </p:cSld>
  <p:clrMapOvr>
    <a:masterClrMapping/>
  </p:clrMapOvr>
</p:sld>
</file>

<file path=ppt/slides/slide2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6DAF7-D3B1-6749-A076-E72604562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45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D7351502-B0E4-1164-4D81-2193F51F53B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9694099"/>
              </p:ext>
            </p:extLst>
          </p:nvPr>
        </p:nvGraphicFramePr>
        <p:xfrm>
          <a:off x="307474" y="1690688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D7351502-B0E4-1164-4D81-2193F51F53B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07474" y="1690688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19698809"/>
      </p:ext>
    </p:extLst>
  </p:cSld>
  <p:clrMapOvr>
    <a:masterClrMapping/>
  </p:clrMapOvr>
</p:sld>
</file>

<file path=ppt/slides/slide2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6DAF7-D3B1-6749-A076-E72604562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46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66056D0-14BA-B51C-F6D4-EE01AFA0BEE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59908797"/>
              </p:ext>
            </p:extLst>
          </p:nvPr>
        </p:nvGraphicFramePr>
        <p:xfrm>
          <a:off x="516021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866056D0-14BA-B51C-F6D4-EE01AFA0BEE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16021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9428503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9B1FAC-D732-53C4-B109-3F45B87618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K3</a:t>
            </a:r>
            <a:r>
              <a:rPr lang="de-DE"/>
              <a:t> 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F65A1131-DB1B-0A3C-50E9-12946A24F84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74795534"/>
              </p:ext>
            </p:extLst>
          </p:nvPr>
        </p:nvGraphicFramePr>
        <p:xfrm>
          <a:off x="403726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F65A1131-DB1B-0A3C-50E9-12946A24F84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03726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441172026"/>
      </p:ext>
    </p:extLst>
  </p:cSld>
  <p:clrMapOvr>
    <a:masterClrMapping/>
  </p:clrMapOvr>
</p:sld>
</file>

<file path=ppt/slides/slide2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6DAF7-D3B1-6749-A076-E72604562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47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A1938167-0883-410F-CA04-0DCC8CE90C7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27880010"/>
              </p:ext>
            </p:extLst>
          </p:nvPr>
        </p:nvGraphicFramePr>
        <p:xfrm>
          <a:off x="307474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A1938167-0883-410F-CA04-0DCC8CE90C7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07474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59388234"/>
      </p:ext>
    </p:extLst>
  </p:cSld>
  <p:clrMapOvr>
    <a:masterClrMapping/>
  </p:clrMapOvr>
</p:sld>
</file>

<file path=ppt/slides/slide2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6DAF7-D3B1-6749-A076-E72604562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48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22EEF7F9-34FE-3C6B-9A09-DD0BC9C4B85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73125878"/>
              </p:ext>
            </p:extLst>
          </p:nvPr>
        </p:nvGraphicFramePr>
        <p:xfrm>
          <a:off x="387684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22EEF7F9-34FE-3C6B-9A09-DD0BC9C4B85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87684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530853510"/>
      </p:ext>
    </p:extLst>
  </p:cSld>
  <p:clrMapOvr>
    <a:masterClrMapping/>
  </p:clrMapOvr>
</p:sld>
</file>

<file path=ppt/slides/slide2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6DAF7-D3B1-6749-A076-E72604562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49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30260F5-C3C0-DCBB-A8FB-4448B28383D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090112"/>
              </p:ext>
            </p:extLst>
          </p:nvPr>
        </p:nvGraphicFramePr>
        <p:xfrm>
          <a:off x="371642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530260F5-C3C0-DCBB-A8FB-4448B28383D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71642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082231621"/>
      </p:ext>
    </p:extLst>
  </p:cSld>
  <p:clrMapOvr>
    <a:masterClrMapping/>
  </p:clrMapOvr>
</p:sld>
</file>

<file path=ppt/slides/slide2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6DAF7-D3B1-6749-A076-E72604562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50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79E0506-7E8A-C67B-5A48-47984CA7B44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97879470"/>
              </p:ext>
            </p:extLst>
          </p:nvPr>
        </p:nvGraphicFramePr>
        <p:xfrm>
          <a:off x="275390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879E0506-7E8A-C67B-5A48-47984CA7B44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75390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464123735"/>
      </p:ext>
    </p:extLst>
  </p:cSld>
  <p:clrMapOvr>
    <a:masterClrMapping/>
  </p:clrMapOvr>
</p:sld>
</file>

<file path=ppt/slides/slide2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6DAF7-D3B1-6749-A076-E72604562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51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05B4CBA1-5BA7-5733-AC28-7431E36FA1A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95110389"/>
              </p:ext>
            </p:extLst>
          </p:nvPr>
        </p:nvGraphicFramePr>
        <p:xfrm>
          <a:off x="838200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05B4CBA1-5BA7-5733-AC28-7431E36FA1A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38200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520262732"/>
      </p:ext>
    </p:extLst>
  </p:cSld>
  <p:clrMapOvr>
    <a:masterClrMapping/>
  </p:clrMapOvr>
</p:sld>
</file>

<file path=ppt/slides/slide2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6DAF7-D3B1-6749-A076-E72604562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52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DFAAF874-9912-225F-1744-9FD1256B9E5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59955668"/>
              </p:ext>
            </p:extLst>
          </p:nvPr>
        </p:nvGraphicFramePr>
        <p:xfrm>
          <a:off x="419769" y="1690688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DFAAF874-9912-225F-1744-9FD1256B9E5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19769" y="1690688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726334426"/>
      </p:ext>
    </p:extLst>
  </p:cSld>
  <p:clrMapOvr>
    <a:masterClrMapping/>
  </p:clrMapOvr>
</p:sld>
</file>

<file path=ppt/slides/slide2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6DAF7-D3B1-6749-A076-E72604562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53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AA821C5C-A017-61D1-5E2D-615F684662D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87194892"/>
              </p:ext>
            </p:extLst>
          </p:nvPr>
        </p:nvGraphicFramePr>
        <p:xfrm>
          <a:off x="419768" y="1312696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AA821C5C-A017-61D1-5E2D-615F684662D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19768" y="1312696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166951486"/>
      </p:ext>
    </p:extLst>
  </p:cSld>
  <p:clrMapOvr>
    <a:masterClrMapping/>
  </p:clrMapOvr>
</p:sld>
</file>

<file path=ppt/slides/slide2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6DAF7-D3B1-6749-A076-E72604562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DM54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39374C9D-165D-DD8E-D4CC-4F69351A138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04535852"/>
              </p:ext>
            </p:extLst>
          </p:nvPr>
        </p:nvGraphicFramePr>
        <p:xfrm>
          <a:off x="660400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39374C9D-165D-DD8E-D4CC-4F69351A138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60400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06648616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6F27D1-2750-3189-0582-F7D14BA1C2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K5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F8512932-B216-CD4A-B959-FCEE03AF85B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5737013"/>
              </p:ext>
            </p:extLst>
          </p:nvPr>
        </p:nvGraphicFramePr>
        <p:xfrm>
          <a:off x="403726" y="121644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F8512932-B216-CD4A-B959-FCEE03AF85B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03726" y="121644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067679584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BBFC39-ED22-44E8-6836-9CFB3BA61D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K6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20C47D5B-4459-7B1C-635A-53212593B0E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13652328"/>
              </p:ext>
            </p:extLst>
          </p:nvPr>
        </p:nvGraphicFramePr>
        <p:xfrm>
          <a:off x="516021" y="1569370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20C47D5B-4459-7B1C-635A-53212593B0E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16021" y="1569370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763965190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B3B1FF-F2E6-CC5D-E30C-29AF4B30D8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K7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FB751166-C1F8-23D0-D9CD-A5AB22D2754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35914976"/>
              </p:ext>
            </p:extLst>
          </p:nvPr>
        </p:nvGraphicFramePr>
        <p:xfrm>
          <a:off x="499979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FB751166-C1F8-23D0-D9CD-A5AB22D2754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99979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74DE949A-E36D-6AA7-8938-4D5209D7A40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86571891"/>
              </p:ext>
            </p:extLst>
          </p:nvPr>
        </p:nvGraphicFramePr>
        <p:xfrm>
          <a:off x="719585" y="6329826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74DE949A-E36D-6AA7-8938-4D5209D7A40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19585" y="6329826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987594625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5A940D-02B2-B975-474A-BDFD9CEFDC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K8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8DF8AB7-29AE-0F61-20FA-9298A0A5FFC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52762522"/>
              </p:ext>
            </p:extLst>
          </p:nvPr>
        </p:nvGraphicFramePr>
        <p:xfrm>
          <a:off x="965200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98DF8AB7-29AE-0F61-20FA-9298A0A5FFC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65200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310401326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829743-BA43-6F53-C635-CE8ECB6556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K9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B4E6F0D2-E5C1-9461-2220-D28A3E40418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60304902"/>
              </p:ext>
            </p:extLst>
          </p:nvPr>
        </p:nvGraphicFramePr>
        <p:xfrm>
          <a:off x="451853" y="1466496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B4E6F0D2-E5C1-9461-2220-D28A3E40418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51853" y="1466496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689812694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297DE2-35D9-ECA8-C59C-EC716D6DE9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N10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EE2D2F2-006D-F568-7F33-5092F3BE8F2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07305432"/>
              </p:ext>
            </p:extLst>
          </p:nvPr>
        </p:nvGraphicFramePr>
        <p:xfrm>
          <a:off x="103187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9EE2D2F2-006D-F568-7F33-5092F3BE8F2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3187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19106980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623804-1C7C-4DD2-88E6-2CE212B2A6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N12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B50C3C23-4BE0-D8C8-869A-58480BD2318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4429008"/>
              </p:ext>
            </p:extLst>
          </p:nvPr>
        </p:nvGraphicFramePr>
        <p:xfrm>
          <a:off x="399988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B50C3C23-4BE0-D8C8-869A-58480BD2318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99988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316989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07F721-004F-1849-FE09-F4EEACD081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BL1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F42F0FA-FF40-E1B2-21C6-73F63B1C549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3080901"/>
              </p:ext>
            </p:extLst>
          </p:nvPr>
        </p:nvGraphicFramePr>
        <p:xfrm>
          <a:off x="838200" y="1553327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9F42F0FA-FF40-E1B2-21C6-73F63B1C549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38200" y="1553327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865975180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5A1643-E50B-5260-C7B8-46E652DC81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N13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3030F4E-A0BD-9A75-47B1-1822CB401F4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13380364"/>
              </p:ext>
            </p:extLst>
          </p:nvPr>
        </p:nvGraphicFramePr>
        <p:xfrm>
          <a:off x="103187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53030F4E-A0BD-9A75-47B1-1822CB401F4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3187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859182696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9FBF19-8BD8-1D65-EAFA-6FA9D65625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N14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C6E1C5D-A648-83D6-63C8-52DAB799EB1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01110264"/>
              </p:ext>
            </p:extLst>
          </p:nvPr>
        </p:nvGraphicFramePr>
        <p:xfrm>
          <a:off x="204680" y="1367208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8C6E1C5D-A648-83D6-63C8-52DAB799EB1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04680" y="1367208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13699548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00A3E7-7630-E6F6-4265-DA6870BBE6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N16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DD461AB0-1002-C89D-90DA-7183BFE4008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65072341"/>
              </p:ext>
            </p:extLst>
          </p:nvPr>
        </p:nvGraphicFramePr>
        <p:xfrm>
          <a:off x="0" y="1376085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DD461AB0-1002-C89D-90DA-7183BFE4008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0" y="1376085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559766795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076106-EF53-8C5F-320F-07B778624D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N18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C70E3E1-624B-979A-996A-95ADB5957BF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81631711"/>
              </p:ext>
            </p:extLst>
          </p:nvPr>
        </p:nvGraphicFramePr>
        <p:xfrm>
          <a:off x="838200" y="6615544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C70E3E1-624B-979A-996A-95ADB5957BF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38200" y="6615544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9256F613-15D4-9465-B5F7-09D8EDDFAA1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72989402"/>
              </p:ext>
            </p:extLst>
          </p:nvPr>
        </p:nvGraphicFramePr>
        <p:xfrm>
          <a:off x="749423" y="1260675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9256F613-15D4-9465-B5F7-09D8EDDFAA1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49423" y="1260675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545965503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8E42CA-E62A-EAF4-F222-28EAA4379F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N19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17250403-2DD8-17A2-A469-5EE18AA2C76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51508134"/>
              </p:ext>
            </p:extLst>
          </p:nvPr>
        </p:nvGraphicFramePr>
        <p:xfrm>
          <a:off x="838200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17250403-2DD8-17A2-A469-5EE18AA2C76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38200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041474977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9E6AA4-7D0C-D6D8-6F0F-4A92D55959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N2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248C8BB-5769-6ACD-9357-BBE0E372276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04404144"/>
              </p:ext>
            </p:extLst>
          </p:nvPr>
        </p:nvGraphicFramePr>
        <p:xfrm>
          <a:off x="103187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248C8BB-5769-6ACD-9357-BBE0E372276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3187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351088502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8D219D-6D17-B93E-B534-E2D17DEC53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N20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709CED4-15BC-9476-6F2C-AC6EE5118CA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29421883"/>
              </p:ext>
            </p:extLst>
          </p:nvPr>
        </p:nvGraphicFramePr>
        <p:xfrm>
          <a:off x="838200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709CED4-15BC-9476-6F2C-AC6EE5118CA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38200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991689879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CAC3C7-D63F-5C0B-99D8-442A5974AE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N21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8CB67B6-5576-DA24-C04D-72A8C4224FA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1281754"/>
              </p:ext>
            </p:extLst>
          </p:nvPr>
        </p:nvGraphicFramePr>
        <p:xfrm>
          <a:off x="708526" y="129665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88CB67B6-5576-DA24-C04D-72A8C4224FA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08526" y="129665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77861567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BA0A41-E771-76C4-F94C-FD62150C02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N22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BE3F8CF9-94DD-40C5-01AD-BA18D06D75F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51195384"/>
              </p:ext>
            </p:extLst>
          </p:nvPr>
        </p:nvGraphicFramePr>
        <p:xfrm>
          <a:off x="467895" y="1264569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BE3F8CF9-94DD-40C5-01AD-BA18D06D75F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67895" y="1264569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153042501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70168D-A334-7B69-6430-52B7E655F9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N23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253DA81-4971-87A8-AF92-DAFD1905D8F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92812222"/>
              </p:ext>
            </p:extLst>
          </p:nvPr>
        </p:nvGraphicFramePr>
        <p:xfrm>
          <a:off x="103187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5253DA81-4971-87A8-AF92-DAFD1905D8F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3187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6884098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47FB5C-7192-8345-0BD6-26F1689C6F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BL2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346B088D-8CB3-57F2-5BEE-C181F3EE31C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50145676"/>
              </p:ext>
            </p:extLst>
          </p:nvPr>
        </p:nvGraphicFramePr>
        <p:xfrm>
          <a:off x="644358" y="1312696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346B088D-8CB3-57F2-5BEE-C181F3EE31C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44358" y="1312696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B3B423DB-46D9-2E51-A011-93B1B44C495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13372868"/>
              </p:ext>
            </p:extLst>
          </p:nvPr>
        </p:nvGraphicFramePr>
        <p:xfrm>
          <a:off x="838200" y="753703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B3B423DB-46D9-2E51-A011-93B1B44C495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38200" y="753703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EF6982A8-DD67-7133-5613-1ABEED969B1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84237822"/>
              </p:ext>
            </p:extLst>
          </p:nvPr>
        </p:nvGraphicFramePr>
        <p:xfrm>
          <a:off x="1270000" y="6544942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6" imgW="8616600" imgH="7790760" progId="Origin95.Graph">
                  <p:embed/>
                </p:oleObj>
              </mc:Choice>
              <mc:Fallback>
                <p:oleObj name="Graph" r:id="rId6" imgW="8616600" imgH="7790760" progId="Origin95.Graph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EF6982A8-DD67-7133-5613-1ABEED969B1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270000" y="6544942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284137325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2BD26F-77E3-2148-79C8-8E18F879F8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N24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A8CB048-90F9-CB30-3370-BFD140CAB73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10341525"/>
              </p:ext>
            </p:extLst>
          </p:nvPr>
        </p:nvGraphicFramePr>
        <p:xfrm>
          <a:off x="516022" y="1312696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8A8CB048-90F9-CB30-3370-BFD140CAB73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16022" y="1312696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920020108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D8BAE6-D069-ADBD-EDAC-6C5004530D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N25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FFF8AD63-E72F-4786-932C-B644638F10C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77572434"/>
              </p:ext>
            </p:extLst>
          </p:nvPr>
        </p:nvGraphicFramePr>
        <p:xfrm>
          <a:off x="103187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FFF8AD63-E72F-4786-932C-B644638F10C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3187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727516209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C7CEB4-863F-4D06-55B9-3D9411B426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N26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A2B8719F-8685-4D65-8D20-21338BB33AB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34370161"/>
              </p:ext>
            </p:extLst>
          </p:nvPr>
        </p:nvGraphicFramePr>
        <p:xfrm>
          <a:off x="838200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A2B8719F-8685-4D65-8D20-21338BB33AB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38200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11667840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2124FC-D62E-BCA2-FC63-2913EBF6C5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N27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47A0BC4-71BC-5B6D-2C8D-A0F03D9F979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55429874"/>
              </p:ext>
            </p:extLst>
          </p:nvPr>
        </p:nvGraphicFramePr>
        <p:xfrm>
          <a:off x="451853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47A0BC4-71BC-5B6D-2C8D-A0F03D9F979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51853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60808408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2D330C-824D-285D-6049-3409A98CC5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N28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AE5AD7B3-601A-5BFD-8A0C-75CBA020C7E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35049136"/>
              </p:ext>
            </p:extLst>
          </p:nvPr>
        </p:nvGraphicFramePr>
        <p:xfrm>
          <a:off x="103187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AE5AD7B3-601A-5BFD-8A0C-75CBA020C7E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3187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75343453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31E2D8-2908-E90C-1F57-4264D30297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N29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4E162DDE-EFE0-93E6-CCA0-005C8AE894D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45534045"/>
              </p:ext>
            </p:extLst>
          </p:nvPr>
        </p:nvGraphicFramePr>
        <p:xfrm>
          <a:off x="346722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4E162DDE-EFE0-93E6-CCA0-005C8AE894D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46722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262892428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8EFF9C-BDDE-DE81-0A48-20BF04373B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N3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183BC702-71D8-0B3F-79A2-E1A9BDDDF8E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34618564"/>
              </p:ext>
            </p:extLst>
          </p:nvPr>
        </p:nvGraphicFramePr>
        <p:xfrm>
          <a:off x="103187" y="1256167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183BC702-71D8-0B3F-79A2-E1A9BDDDF8E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3187" y="1256167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031801590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8BD14B-5E83-7412-A2B3-75B12F303E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N30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63E2FB85-C666-5C39-BA2C-B74F2DD4CA3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40298243"/>
              </p:ext>
            </p:extLst>
          </p:nvPr>
        </p:nvGraphicFramePr>
        <p:xfrm>
          <a:off x="419768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63E2FB85-C666-5C39-BA2C-B74F2DD4CA3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19768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853370157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250E49-3C42-7872-FC52-8BA174883E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N31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D824F1F0-8452-76A4-9B1A-2656D0F952B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15797845"/>
              </p:ext>
            </p:extLst>
          </p:nvPr>
        </p:nvGraphicFramePr>
        <p:xfrm>
          <a:off x="462132" y="1313942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D824F1F0-8452-76A4-9B1A-2656D0F952B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62132" y="1313942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962231915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BDDC57-77FE-152F-FCC6-4F51E42AB1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N32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BDAD28CC-A52F-B9DC-308C-C256C623BD9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20224320"/>
              </p:ext>
            </p:extLst>
          </p:nvPr>
        </p:nvGraphicFramePr>
        <p:xfrm>
          <a:off x="838200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BDAD28CC-A52F-B9DC-308C-C256C623BD9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38200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9015614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A54E58-C94C-29B6-687A-717C433459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BL3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E4DA1A9F-D00B-2F3B-8ADE-BA3F267754E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12586660"/>
              </p:ext>
            </p:extLst>
          </p:nvPr>
        </p:nvGraphicFramePr>
        <p:xfrm>
          <a:off x="339558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E4DA1A9F-D00B-2F3B-8ADE-BA3F267754E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39558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0F93C089-6286-D270-6D1B-343A5D5EF99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93122874"/>
              </p:ext>
            </p:extLst>
          </p:nvPr>
        </p:nvGraphicFramePr>
        <p:xfrm>
          <a:off x="660400" y="6301791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0F93C089-6286-D270-6D1B-343A5D5EF99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60400" y="6301791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31403962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074187-624E-C886-AB90-63F261F97C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N33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FABF5DF3-1ECC-7C6B-5772-010751BAF09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89722759"/>
              </p:ext>
            </p:extLst>
          </p:nvPr>
        </p:nvGraphicFramePr>
        <p:xfrm>
          <a:off x="595298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FABF5DF3-1ECC-7C6B-5772-010751BAF09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95298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003807109"/>
      </p:ext>
    </p:extLst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847B9E-CCDF-772A-FA9A-029F47A82A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N4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E897E94C-C84E-45C4-C319-6AE12739F6B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98513035"/>
              </p:ext>
            </p:extLst>
          </p:nvPr>
        </p:nvGraphicFramePr>
        <p:xfrm>
          <a:off x="224971" y="131422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E897E94C-C84E-45C4-C319-6AE12739F6B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24971" y="131422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61780314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C1DAC5-87EC-A703-1E70-B6EE2B618D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N5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667EB70F-F25D-2A31-CFFE-6CBB5B15124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72014446"/>
              </p:ext>
            </p:extLst>
          </p:nvPr>
        </p:nvGraphicFramePr>
        <p:xfrm>
          <a:off x="339558" y="1264569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667EB70F-F25D-2A31-CFFE-6CBB5B15124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39558" y="1264569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096788961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0F431B-6173-C457-AB59-BCCDC08E30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N6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3EFCAF93-C30B-4FB4-D489-3EFFD08E1BF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72569097"/>
              </p:ext>
            </p:extLst>
          </p:nvPr>
        </p:nvGraphicFramePr>
        <p:xfrm>
          <a:off x="451852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3EFCAF93-C30B-4FB4-D489-3EFFD08E1BF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51852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804239503"/>
      </p:ext>
    </p:extLst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A83FF0-472D-74B2-6CD5-BC1121FB7C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N7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27BF0AC5-A31B-3A69-2D76-8B9A59772B8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54378717"/>
              </p:ext>
            </p:extLst>
          </p:nvPr>
        </p:nvGraphicFramePr>
        <p:xfrm>
          <a:off x="529772" y="154645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27BF0AC5-A31B-3A69-2D76-8B9A59772B8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29772" y="154645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222299476"/>
      </p:ext>
    </p:extLst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CBB909-2DBA-9955-6121-576BFD862F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N8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4AC87E8-41DA-F193-D2D7-6F693B0D635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35323430"/>
              </p:ext>
            </p:extLst>
          </p:nvPr>
        </p:nvGraphicFramePr>
        <p:xfrm>
          <a:off x="257946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94AC87E8-41DA-F193-D2D7-6F693B0D635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57946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8F013963-07C4-F334-5C69-73B97D91A2F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68357724"/>
              </p:ext>
            </p:extLst>
          </p:nvPr>
        </p:nvGraphicFramePr>
        <p:xfrm>
          <a:off x="675197" y="6622788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8F013963-07C4-F334-5C69-73B97D91A2F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75197" y="6622788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512817995"/>
      </p:ext>
    </p:extLst>
  </p:cSld>
  <p:clrMapOvr>
    <a:masterClrMapping/>
  </p:clrMapOvr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1EBE72-8AFF-6CB9-4AF6-20F555B3EF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N9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19FE7DF3-FD76-E1A6-FF54-F156B87DD86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18064836"/>
              </p:ext>
            </p:extLst>
          </p:nvPr>
        </p:nvGraphicFramePr>
        <p:xfrm>
          <a:off x="645885" y="1270681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19FE7DF3-FD76-E1A6-FF54-F156B87DD86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45885" y="1270681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917755002"/>
      </p:ext>
    </p:extLst>
  </p:cSld>
  <p:clrMapOvr>
    <a:masterClrMapping/>
  </p:clrMapOvr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D146AE-AAD3-8827-20D3-3B195FF0FF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R16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1E6A3179-70F6-B321-D305-701E4795004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3255108"/>
              </p:ext>
            </p:extLst>
          </p:nvPr>
        </p:nvGraphicFramePr>
        <p:xfrm>
          <a:off x="103187" y="1314224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1E6A3179-70F6-B321-D305-701E4795004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3187" y="1314224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316588487"/>
      </p:ext>
    </p:extLst>
  </p:cSld>
  <p:clrMapOvr>
    <a:masterClrMapping/>
  </p:clrMapOvr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8BE150-7114-F046-46C0-D3B4580D65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DF5 / CK16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BD7206E8-29AA-7769-51EF-1275FF19C94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45558437"/>
              </p:ext>
            </p:extLst>
          </p:nvPr>
        </p:nvGraphicFramePr>
        <p:xfrm>
          <a:off x="516021" y="1312696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BD7206E8-29AA-7769-51EF-1275FF19C94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16021" y="1312696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4D19A840-9C13-E950-84B5-ACE9B9B3590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56848227"/>
              </p:ext>
            </p:extLst>
          </p:nvPr>
        </p:nvGraphicFramePr>
        <p:xfrm>
          <a:off x="959281" y="6658299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4D19A840-9C13-E950-84B5-ACE9B9B3590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59281" y="6658299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590626734"/>
      </p:ext>
    </p:extLst>
  </p:cSld>
  <p:clrMapOvr>
    <a:masterClrMapping/>
  </p:clrMapOvr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CA59E8-991D-D150-8047-7ACC16E758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EF-C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0601A052-EEE1-BCBE-11CE-F719F9AE746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91178855"/>
              </p:ext>
            </p:extLst>
          </p:nvPr>
        </p:nvGraphicFramePr>
        <p:xfrm>
          <a:off x="387684" y="1690688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0601A052-EEE1-BCBE-11CE-F719F9AE746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87684" y="1690688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89853624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BEFCF2-ADC0-A5FE-EE67-7A216ABA1C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BL4</a:t>
            </a:r>
            <a:r>
              <a:rPr lang="de-DE"/>
              <a:t> 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BD0DC6EC-8E6B-4456-6AA5-E7EE91D246D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54530239"/>
              </p:ext>
            </p:extLst>
          </p:nvPr>
        </p:nvGraphicFramePr>
        <p:xfrm>
          <a:off x="243306" y="1690688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BD0DC6EC-8E6B-4456-6AA5-E7EE91D246D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43306" y="1690688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D729D63-1DEA-9680-C111-4916B78BD34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3973920"/>
              </p:ext>
            </p:extLst>
          </p:nvPr>
        </p:nvGraphicFramePr>
        <p:xfrm>
          <a:off x="391111" y="7085490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9D729D63-1DEA-9680-C111-4916B78BD34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91111" y="7085490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80316319"/>
      </p:ext>
    </p:extLst>
  </p:cSld>
  <p:clrMapOvr>
    <a:masterClrMapping/>
  </p:clrMapOvr>
</p:sld>
</file>

<file path=ppt/slides/slide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7616AC-8A5E-2AD9-27BE-477EB5D328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EF-C opt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FC483F1-D96B-C931-EDC1-1439D289561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1912481"/>
              </p:ext>
            </p:extLst>
          </p:nvPr>
        </p:nvGraphicFramePr>
        <p:xfrm>
          <a:off x="307473" y="1690688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8FC483F1-D96B-C931-EDC1-1439D289561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07473" y="1690688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08435681"/>
      </p:ext>
    </p:extLst>
  </p:cSld>
  <p:clrMapOvr>
    <a:masterClrMapping/>
  </p:clrMapOvr>
</p:sld>
</file>

<file path=ppt/slides/slide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7E0525-8E5B-903A-AD4D-4956722814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JG1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2B4FAC3C-851F-7C26-84DE-C6232A11A62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45460668"/>
              </p:ext>
            </p:extLst>
          </p:nvPr>
        </p:nvGraphicFramePr>
        <p:xfrm>
          <a:off x="653716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2B4FAC3C-851F-7C26-84DE-C6232A11A62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53716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732038377"/>
      </p:ext>
    </p:extLst>
  </p:cSld>
  <p:clrMapOvr>
    <a:masterClrMapping/>
  </p:clrMapOvr>
</p:sld>
</file>

<file path=ppt/slides/slide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B618F2-2EE5-F2DC-E992-94C232B9D4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JG10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469EFA4B-12EF-A0BF-B393-FFDA1E5F04C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29753257"/>
              </p:ext>
            </p:extLst>
          </p:nvPr>
        </p:nvGraphicFramePr>
        <p:xfrm>
          <a:off x="997284" y="1371684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469EFA4B-12EF-A0BF-B393-FFDA1E5F04C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97284" y="1371684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949823724"/>
      </p:ext>
    </p:extLst>
  </p:cSld>
  <p:clrMapOvr>
    <a:masterClrMapping/>
  </p:clrMapOvr>
</p:sld>
</file>

<file path=ppt/slides/slide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0482C0-72A6-C1AA-84A4-9B7B7D72AF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JG11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19017CC0-7629-B8D2-CE78-0036AD3017A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98439539"/>
              </p:ext>
            </p:extLst>
          </p:nvPr>
        </p:nvGraphicFramePr>
        <p:xfrm>
          <a:off x="403727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19017CC0-7629-B8D2-CE78-0036AD3017A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03727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170761285"/>
      </p:ext>
    </p:extLst>
  </p:cSld>
  <p:clrMapOvr>
    <a:masterClrMapping/>
  </p:clrMapOvr>
</p:sld>
</file>

<file path=ppt/slides/slide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AA0428-275C-60FC-E8AE-AFC4DA3E6D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JG14 / TG14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B669263-DA24-D1CC-DACC-C5327A3E0DF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67885282"/>
              </p:ext>
            </p:extLst>
          </p:nvPr>
        </p:nvGraphicFramePr>
        <p:xfrm>
          <a:off x="838200" y="1553328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B669263-DA24-D1CC-DACC-C5327A3E0DF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38200" y="1553328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071448602"/>
      </p:ext>
    </p:extLst>
  </p:cSld>
  <p:clrMapOvr>
    <a:masterClrMapping/>
  </p:clrMapOvr>
</p:sld>
</file>

<file path=ppt/slides/slide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C9DA80-CA6B-4460-6AE7-A5AA1ACCDF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JG2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50DFCE5-BB35-3C1F-1CF8-696D7AE7CDD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20904826"/>
              </p:ext>
            </p:extLst>
          </p:nvPr>
        </p:nvGraphicFramePr>
        <p:xfrm>
          <a:off x="103187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950DFCE5-BB35-3C1F-1CF8-696D7AE7CDD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3187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23417698"/>
      </p:ext>
    </p:extLst>
  </p:cSld>
  <p:clrMapOvr>
    <a:masterClrMapping/>
  </p:clrMapOvr>
</p:sld>
</file>

<file path=ppt/slides/slide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9AAE79-E26B-FFB4-98BF-E553AB3A6B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JG3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2FFD85CD-F19E-5604-FFF9-272F2CB0E57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46365644"/>
              </p:ext>
            </p:extLst>
          </p:nvPr>
        </p:nvGraphicFramePr>
        <p:xfrm>
          <a:off x="371642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2FFD85CD-F19E-5604-FFF9-272F2CB0E57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71642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29018126"/>
      </p:ext>
    </p:extLst>
  </p:cSld>
  <p:clrMapOvr>
    <a:masterClrMapping/>
  </p:clrMapOvr>
</p:sld>
</file>

<file path=ppt/slides/slide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B78CD1-4D33-EB6B-2E34-2328A465B3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JG4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4FBD57C-C392-05F9-D005-92652558913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58255432"/>
              </p:ext>
            </p:extLst>
          </p:nvPr>
        </p:nvGraphicFramePr>
        <p:xfrm>
          <a:off x="370114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54FBD57C-C392-05F9-D005-92652558913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70114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524499919"/>
      </p:ext>
    </p:extLst>
  </p:cSld>
  <p:clrMapOvr>
    <a:masterClrMapping/>
  </p:clrMapOvr>
</p:sld>
</file>

<file path=ppt/slides/slide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EC6B8F-B30E-6C1D-487D-78CB50852A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JG5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EC8BF19-5191-03E7-5553-6D2054749D6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67051270"/>
              </p:ext>
            </p:extLst>
          </p:nvPr>
        </p:nvGraphicFramePr>
        <p:xfrm>
          <a:off x="275389" y="1690688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8EC8BF19-5191-03E7-5553-6D2054749D6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75389" y="1690688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878398416"/>
      </p:ext>
    </p:extLst>
  </p:cSld>
  <p:clrMapOvr>
    <a:masterClrMapping/>
  </p:clrMapOvr>
</p:sld>
</file>

<file path=ppt/slides/slide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E5B3B9-0774-FC13-61C2-1AA84FE7F5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JG6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16795839-2AC1-ED72-32DF-2C486CC7726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59750639"/>
              </p:ext>
            </p:extLst>
          </p:nvPr>
        </p:nvGraphicFramePr>
        <p:xfrm>
          <a:off x="724569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16795839-2AC1-ED72-32DF-2C486CC7726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24569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26844331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495B61-5926-505C-5286-FC71C66D54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BL5 / KB13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EB9500F5-0599-D9FC-0AA9-1AE413FA447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73728824"/>
              </p:ext>
            </p:extLst>
          </p:nvPr>
        </p:nvGraphicFramePr>
        <p:xfrm>
          <a:off x="692485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EB9500F5-0599-D9FC-0AA9-1AE413FA447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92485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059308301"/>
      </p:ext>
    </p:extLst>
  </p:cSld>
  <p:clrMapOvr>
    <a:masterClrMapping/>
  </p:clrMapOvr>
</p:sld>
</file>

<file path=ppt/slides/slide7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B35FD1-2E53-AAF5-56C0-42BA5B9650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JG7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9F2FECD-D560-119B-0458-7D5C8C2ACE0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45118814"/>
              </p:ext>
            </p:extLst>
          </p:nvPr>
        </p:nvGraphicFramePr>
        <p:xfrm>
          <a:off x="981242" y="1264569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59F2FECD-D560-119B-0458-7D5C8C2ACE0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81242" y="1264569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150953503"/>
      </p:ext>
    </p:extLst>
  </p:cSld>
  <p:clrMapOvr>
    <a:masterClrMapping/>
  </p:clrMapOvr>
</p:sld>
</file>

<file path=ppt/slides/slide7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9A166E-7FCD-4B64-9184-98AB67F136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JG8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DFD1B1F2-AFFD-DE1D-73C2-0A6828C132A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51297714"/>
              </p:ext>
            </p:extLst>
          </p:nvPr>
        </p:nvGraphicFramePr>
        <p:xfrm>
          <a:off x="0" y="1371684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DFD1B1F2-AFFD-DE1D-73C2-0A6828C132A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0" y="1371684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303159571"/>
      </p:ext>
    </p:extLst>
  </p:cSld>
  <p:clrMapOvr>
    <a:masterClrMapping/>
  </p:clrMapOvr>
</p:sld>
</file>

<file path=ppt/slides/slide7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9AE044-3EA9-68C0-934B-BCE22156A3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JG9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01352EB-A412-F8D8-EC4A-E898D5BE091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63226432"/>
              </p:ext>
            </p:extLst>
          </p:nvPr>
        </p:nvGraphicFramePr>
        <p:xfrm>
          <a:off x="532063" y="1312696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01352EB-A412-F8D8-EC4A-E898D5BE091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32063" y="1312696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754417479"/>
      </p:ext>
    </p:extLst>
  </p:cSld>
  <p:clrMapOvr>
    <a:masterClrMapping/>
  </p:clrMapOvr>
</p:sld>
</file>

<file path=ppt/slides/slide7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7BEB76-C882-B63E-4449-E49799F15D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JGA2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417F5534-F94F-DF11-368B-6E8C4FAF69B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1765799"/>
              </p:ext>
            </p:extLst>
          </p:nvPr>
        </p:nvGraphicFramePr>
        <p:xfrm>
          <a:off x="548105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417F5534-F94F-DF11-368B-6E8C4FAF69B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48105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261912029"/>
      </p:ext>
    </p:extLst>
  </p:cSld>
  <p:clrMapOvr>
    <a:masterClrMapping/>
  </p:clrMapOvr>
</p:sld>
</file>

<file path=ppt/slides/slide7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4CCE40-4759-E82D-0050-1566355B28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JGA3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3070E35-FFB5-29D7-183F-DD0D023F275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788157"/>
              </p:ext>
            </p:extLst>
          </p:nvPr>
        </p:nvGraphicFramePr>
        <p:xfrm>
          <a:off x="103187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93070E35-FFB5-29D7-183F-DD0D023F275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3187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849830204"/>
      </p:ext>
    </p:extLst>
  </p:cSld>
  <p:clrMapOvr>
    <a:masterClrMapping/>
  </p:clrMapOvr>
</p:sld>
</file>

<file path=ppt/slides/slide7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BFA73D-D79F-A55C-7C89-A7F16284C6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JGB1 /TM85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576CC9E-7A70-BB43-166C-38F3FC471B5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27286210"/>
              </p:ext>
            </p:extLst>
          </p:nvPr>
        </p:nvGraphicFramePr>
        <p:xfrm>
          <a:off x="838200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5576CC9E-7A70-BB43-166C-38F3FC471B5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38200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325294879"/>
      </p:ext>
    </p:extLst>
  </p:cSld>
  <p:clrMapOvr>
    <a:masterClrMapping/>
  </p:clrMapOvr>
</p:sld>
</file>

<file path=ppt/slides/slide7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3F22F1-819C-19AB-707A-2880F74553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JGB2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406D8059-D3CA-1850-D15E-A28381C67CB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94852564"/>
              </p:ext>
            </p:extLst>
          </p:nvPr>
        </p:nvGraphicFramePr>
        <p:xfrm>
          <a:off x="997284" y="1690688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406D8059-D3CA-1850-D15E-A28381C67CB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97284" y="1690688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832366075"/>
      </p:ext>
    </p:extLst>
  </p:cSld>
  <p:clrMapOvr>
    <a:masterClrMapping/>
  </p:clrMapOvr>
</p:sld>
</file>

<file path=ppt/slides/slide7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DA2CB5-881C-1D6D-E303-FE0A6C899C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JGB3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DBBFC1CF-8F69-6EEB-F29B-D2FCA646B36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66729022"/>
              </p:ext>
            </p:extLst>
          </p:nvPr>
        </p:nvGraphicFramePr>
        <p:xfrm>
          <a:off x="1253958" y="1074738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DBBFC1CF-8F69-6EEB-F29B-D2FCA646B36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253958" y="1074738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D7E47360-C40F-B479-84A8-E7653BDFE77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030062"/>
              </p:ext>
            </p:extLst>
          </p:nvPr>
        </p:nvGraphicFramePr>
        <p:xfrm>
          <a:off x="1446464" y="6492875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D7E47360-C40F-B479-84A8-E7653BDFE77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446464" y="6492875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166448720"/>
      </p:ext>
    </p:extLst>
  </p:cSld>
  <p:clrMapOvr>
    <a:masterClrMapping/>
  </p:clrMapOvr>
</p:sld>
</file>

<file path=ppt/slides/slide7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2C9787-5B85-D805-DC04-362AAD9ADF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JJA2 / TM153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7A47B578-36B6-CB4A-C062-62F97098A8F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45361342"/>
              </p:ext>
            </p:extLst>
          </p:nvPr>
        </p:nvGraphicFramePr>
        <p:xfrm>
          <a:off x="259347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7A47B578-36B6-CB4A-C062-62F97098A8F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59347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818165673"/>
      </p:ext>
    </p:extLst>
  </p:cSld>
  <p:clrMapOvr>
    <a:masterClrMapping/>
  </p:clrMapOvr>
</p:sld>
</file>

<file path=ppt/slides/slide7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50D42A-4618-A9FC-1938-3DFEAD5D46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JJA4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07FE2699-10A8-6654-DC28-DD96DDB1C3F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57631087"/>
              </p:ext>
            </p:extLst>
          </p:nvPr>
        </p:nvGraphicFramePr>
        <p:xfrm>
          <a:off x="467895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07FE2699-10A8-6654-DC28-DD96DDB1C3F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67895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11121165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C93502-72B2-0AC0-BA04-FDF9F8AEBB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BL6a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45D34166-909E-80A5-C3D4-4811E318069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73028127"/>
              </p:ext>
            </p:extLst>
          </p:nvPr>
        </p:nvGraphicFramePr>
        <p:xfrm>
          <a:off x="644358" y="1690688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45D34166-909E-80A5-C3D4-4811E318069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44358" y="1690688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98076905"/>
      </p:ext>
    </p:extLst>
  </p:cSld>
  <p:clrMapOvr>
    <a:masterClrMapping/>
  </p:clrMapOvr>
</p:sld>
</file>

<file path=ppt/slides/slide8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717E49-A1EE-4D60-BCDD-98485B7F8B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JJA6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33F8CE2-3706-EF85-816A-601A98D7259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34687269"/>
              </p:ext>
            </p:extLst>
          </p:nvPr>
        </p:nvGraphicFramePr>
        <p:xfrm>
          <a:off x="460829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533F8CE2-3706-EF85-816A-601A98D7259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60829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321173272"/>
      </p:ext>
    </p:extLst>
  </p:cSld>
  <p:clrMapOvr>
    <a:masterClrMapping/>
  </p:clrMapOvr>
</p:sld>
</file>

<file path=ppt/slides/slide8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C4B1F0-1E28-9969-8C03-05A9B19C98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JR1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026241E1-CE80-47CB-98CE-4B17DAD2613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35338691"/>
              </p:ext>
            </p:extLst>
          </p:nvPr>
        </p:nvGraphicFramePr>
        <p:xfrm>
          <a:off x="1622926" y="1312695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026241E1-CE80-47CB-98CE-4B17DAD2613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622926" y="1312695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176846643"/>
      </p:ext>
    </p:extLst>
  </p:cSld>
  <p:clrMapOvr>
    <a:masterClrMapping/>
  </p:clrMapOvr>
</p:sld>
</file>

<file path=ppt/slides/slide8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510700-6BBE-5819-E9E3-ED43E6C376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JR12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062D2C8-A389-BA4F-8351-E603BDDC2A7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9365913"/>
              </p:ext>
            </p:extLst>
          </p:nvPr>
        </p:nvGraphicFramePr>
        <p:xfrm>
          <a:off x="483937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062D2C8-A389-BA4F-8351-E603BDDC2A7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83937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678723006"/>
      </p:ext>
    </p:extLst>
  </p:cSld>
  <p:clrMapOvr>
    <a:masterClrMapping/>
  </p:clrMapOvr>
</p:sld>
</file>

<file path=ppt/slides/slide8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53F0A9-72C5-81EE-6E79-7C53328ABF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JR2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34CA6013-FE78-732E-013A-EA2F5C381F7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02300054"/>
              </p:ext>
            </p:extLst>
          </p:nvPr>
        </p:nvGraphicFramePr>
        <p:xfrm>
          <a:off x="1077495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34CA6013-FE78-732E-013A-EA2F5C381F7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77495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179992125"/>
      </p:ext>
    </p:extLst>
  </p:cSld>
  <p:clrMapOvr>
    <a:masterClrMapping/>
  </p:clrMapOvr>
</p:sld>
</file>

<file path=ppt/slides/slide8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DF1D59-C822-2C06-51AE-F34D94598E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JR3-II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02E79350-6140-2E70-BF98-C8CC53CF03C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90837654"/>
              </p:ext>
            </p:extLst>
          </p:nvPr>
        </p:nvGraphicFramePr>
        <p:xfrm>
          <a:off x="838200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02E79350-6140-2E70-BF98-C8CC53CF03C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38200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819945086"/>
      </p:ext>
    </p:extLst>
  </p:cSld>
  <p:clrMapOvr>
    <a:masterClrMapping/>
  </p:clrMapOvr>
</p:sld>
</file>

<file path=ppt/slides/slide8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B5FF24-FAE8-4659-BA04-2D3C57C00B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JR4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44304D3-F325-650B-1C82-8D40925D9CC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03820541"/>
              </p:ext>
            </p:extLst>
          </p:nvPr>
        </p:nvGraphicFramePr>
        <p:xfrm>
          <a:off x="387684" y="1500021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844304D3-F325-650B-1C82-8D40925D9CC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87684" y="1500021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99275166"/>
      </p:ext>
    </p:extLst>
  </p:cSld>
  <p:clrMapOvr>
    <a:masterClrMapping/>
  </p:clrMapOvr>
</p:sld>
</file>

<file path=ppt/slides/slide8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522603-9FB2-8092-FE10-62BCD7FD7E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JR7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D6D51C7B-2D55-04BB-A007-D97561FBC2A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7926932"/>
              </p:ext>
            </p:extLst>
          </p:nvPr>
        </p:nvGraphicFramePr>
        <p:xfrm>
          <a:off x="103187" y="1264569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D6D51C7B-2D55-04BB-A007-D97561FBC2A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3187" y="1264569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064084829"/>
      </p:ext>
    </p:extLst>
  </p:cSld>
  <p:clrMapOvr>
    <a:masterClrMapping/>
  </p:clrMapOvr>
</p:sld>
</file>

<file path=ppt/slides/slide8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1AAB6E-5A54-D3BF-BB7B-FF1A5CDF81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JR9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78E836C9-EAF1-8259-EA9D-6904D78B8A3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04179338"/>
              </p:ext>
            </p:extLst>
          </p:nvPr>
        </p:nvGraphicFramePr>
        <p:xfrm>
          <a:off x="227264" y="1074738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78E836C9-EAF1-8259-EA9D-6904D78B8A3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27264" y="1074738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608786648"/>
      </p:ext>
    </p:extLst>
  </p:cSld>
  <p:clrMapOvr>
    <a:masterClrMapping/>
  </p:clrMapOvr>
</p:sld>
</file>

<file path=ppt/slides/slide8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E1CDF1-BD46-31C7-063D-F0DB04D34F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KB1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44F0FD0-C822-4E35-5291-E9D5DCF4A1D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0727603"/>
              </p:ext>
            </p:extLst>
          </p:nvPr>
        </p:nvGraphicFramePr>
        <p:xfrm>
          <a:off x="403726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544F0FD0-C822-4E35-5291-E9D5DCF4A1D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03726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618217978"/>
      </p:ext>
    </p:extLst>
  </p:cSld>
  <p:clrMapOvr>
    <a:masterClrMapping/>
  </p:clrMapOvr>
</p:sld>
</file>

<file path=ppt/slides/slide8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38236C-BA12-0907-AB2A-FD9035F5CC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KB11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36A20E1E-A5F5-4577-7F30-09C81507800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4481978"/>
              </p:ext>
            </p:extLst>
          </p:nvPr>
        </p:nvGraphicFramePr>
        <p:xfrm>
          <a:off x="467895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36A20E1E-A5F5-4577-7F30-09C81507800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67895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69768581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3D47F5-14A6-6CA8-A510-5EE18DAAF5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BL7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D36D3617-DD46-9E60-F8EF-9D594A5DCD5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71966110"/>
              </p:ext>
            </p:extLst>
          </p:nvPr>
        </p:nvGraphicFramePr>
        <p:xfrm>
          <a:off x="596232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D36D3617-DD46-9E60-F8EF-9D594A5DCD5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96232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063604901"/>
      </p:ext>
    </p:extLst>
  </p:cSld>
  <p:clrMapOvr>
    <a:masterClrMapping/>
  </p:clrMapOvr>
</p:sld>
</file>

<file path=ppt/slides/slide9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1ABA42-5DDD-BF63-9C29-7C0761234F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KB12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B5A2A739-4AFA-0197-2830-E5E6CAC4BDA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92838069"/>
              </p:ext>
            </p:extLst>
          </p:nvPr>
        </p:nvGraphicFramePr>
        <p:xfrm>
          <a:off x="532063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B5A2A739-4AFA-0197-2830-E5E6CAC4BDA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32063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720200602"/>
      </p:ext>
    </p:extLst>
  </p:cSld>
  <p:clrMapOvr>
    <a:masterClrMapping/>
  </p:clrMapOvr>
</p:sld>
</file>

<file path=ppt/slides/slide9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D16D43-DF91-AAC8-4220-FA6D1FB3E5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KB14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77A20623-CC0C-4E13-C1AA-484864A6B2C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77943393"/>
              </p:ext>
            </p:extLst>
          </p:nvPr>
        </p:nvGraphicFramePr>
        <p:xfrm>
          <a:off x="259348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77A20623-CC0C-4E13-C1AA-484864A6B2C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59348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045961550"/>
      </p:ext>
    </p:extLst>
  </p:cSld>
  <p:clrMapOvr>
    <a:masterClrMapping/>
  </p:clrMapOvr>
</p:sld>
</file>

<file path=ppt/slides/slide9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5A9283-6A31-2502-41AB-30AC8A6243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KB2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64A0FA0F-A10B-E0D2-2FAB-011FD06FFBD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57702317"/>
              </p:ext>
            </p:extLst>
          </p:nvPr>
        </p:nvGraphicFramePr>
        <p:xfrm>
          <a:off x="103187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64A0FA0F-A10B-E0D2-2FAB-011FD06FFBD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3187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876734693"/>
      </p:ext>
    </p:extLst>
  </p:cSld>
  <p:clrMapOvr>
    <a:masterClrMapping/>
  </p:clrMapOvr>
</p:sld>
</file>

<file path=ppt/slides/slide9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63BA26-5417-FF21-FD1A-B59A823929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KB3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1CA3F885-C939-9DD2-36DE-B0BB1D8B50B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85836984"/>
              </p:ext>
            </p:extLst>
          </p:nvPr>
        </p:nvGraphicFramePr>
        <p:xfrm>
          <a:off x="419769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1CA3F885-C939-9DD2-36DE-B0BB1D8B50B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19769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071747513"/>
      </p:ext>
    </p:extLst>
  </p:cSld>
  <p:clrMapOvr>
    <a:masterClrMapping/>
  </p:clrMapOvr>
</p:sld>
</file>

<file path=ppt/slides/slide9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399A37-F13D-512E-2E36-02F385A21C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KB4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B0BEDD2B-218E-4653-82F1-69486D0A259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70403053"/>
              </p:ext>
            </p:extLst>
          </p:nvPr>
        </p:nvGraphicFramePr>
        <p:xfrm>
          <a:off x="243306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B0BEDD2B-218E-4653-82F1-69486D0A259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43306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258F99C2-DF1C-02D9-EB9F-1FA9EA112CB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51730821"/>
              </p:ext>
            </p:extLst>
          </p:nvPr>
        </p:nvGraphicFramePr>
        <p:xfrm>
          <a:off x="628316" y="6858000"/>
          <a:ext cx="5138070" cy="46453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8616600" imgH="7790760" progId="Origin95.Graph">
                  <p:embed/>
                </p:oleObj>
              </mc:Choice>
              <mc:Fallback>
                <p:oleObj name="Graph" r:id="rId4" imgW="8616600" imgH="7790760" progId="Origin95.Graph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258F99C2-DF1C-02D9-EB9F-1FA9EA112CB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28316" y="6858000"/>
                        <a:ext cx="5138070" cy="464535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204606270"/>
      </p:ext>
    </p:extLst>
  </p:cSld>
  <p:clrMapOvr>
    <a:masterClrMapping/>
  </p:clrMapOvr>
</p:sld>
</file>

<file path=ppt/slides/slide9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AF2605-17BB-20F6-EDCF-AB8A7162D7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KM27 / psis14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91FFCDD-FC19-E410-C7E8-3EBEE8B1FB9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32933744"/>
              </p:ext>
            </p:extLst>
          </p:nvPr>
        </p:nvGraphicFramePr>
        <p:xfrm>
          <a:off x="339557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891FFCDD-FC19-E410-C7E8-3EBEE8B1FB9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39557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79580946"/>
      </p:ext>
    </p:extLst>
  </p:cSld>
  <p:clrMapOvr>
    <a:masterClrMapping/>
  </p:clrMapOvr>
</p:sld>
</file>

<file path=ppt/slides/slide9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BD519B-D92F-EB59-C426-B15A671AA7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MG1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EA817F66-5C01-3034-AE38-587B3250B34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87351686"/>
              </p:ext>
            </p:extLst>
          </p:nvPr>
        </p:nvGraphicFramePr>
        <p:xfrm>
          <a:off x="0" y="1690688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EA817F66-5C01-3034-AE38-587B3250B34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0" y="1690688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32646112"/>
      </p:ext>
    </p:extLst>
  </p:cSld>
  <p:clrMapOvr>
    <a:masterClrMapping/>
  </p:clrMapOvr>
</p:sld>
</file>

<file path=ppt/slides/slide9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83E22-8867-D275-38CA-6D3B5B8E82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MG14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7E88353-FE9E-27B3-A261-59735FE0096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80626877"/>
              </p:ext>
            </p:extLst>
          </p:nvPr>
        </p:nvGraphicFramePr>
        <p:xfrm>
          <a:off x="371642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57E88353-FE9E-27B3-A261-59735FE0096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71642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650392294"/>
      </p:ext>
    </p:extLst>
  </p:cSld>
  <p:clrMapOvr>
    <a:masterClrMapping/>
  </p:clrMapOvr>
</p:sld>
</file>

<file path=ppt/slides/slide9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E60D79-B27E-769E-3D95-899A6C3BAD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MG2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DB4932A2-D87F-4FF0-72BA-B5B5663D43D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04002731"/>
              </p:ext>
            </p:extLst>
          </p:nvPr>
        </p:nvGraphicFramePr>
        <p:xfrm>
          <a:off x="103187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DB4932A2-D87F-4FF0-72BA-B5B5663D43D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3187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366987078"/>
      </p:ext>
    </p:extLst>
  </p:cSld>
  <p:clrMapOvr>
    <a:masterClrMapping/>
  </p:clrMapOvr>
</p:sld>
</file>

<file path=ppt/slides/slide9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C49CAB-EDB9-B74D-9C23-F5B882CE2A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MG3b</a:t>
            </a:r>
            <a:r>
              <a:rPr lang="de-DE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062B61E-F311-C9F6-F5FC-A767C07B8AE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31878390"/>
              </p:ext>
            </p:extLst>
          </p:nvPr>
        </p:nvGraphicFramePr>
        <p:xfrm>
          <a:off x="323516" y="1439863"/>
          <a:ext cx="59928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8616600" imgH="7790760" progId="Origin95.Graph">
                  <p:embed/>
                </p:oleObj>
              </mc:Choice>
              <mc:Fallback>
                <p:oleObj name="Graph" r:id="rId2" imgW="8616600" imgH="7790760" progId="Origin95.Graph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062B61E-F311-C9F6-F5FC-A767C07B8AE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23516" y="1439863"/>
                        <a:ext cx="59928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8773636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4</Words>
  <Application>Microsoft Office PowerPoint</Application>
  <PresentationFormat>Widescreen</PresentationFormat>
  <Paragraphs>248</Paragraphs>
  <Slides>22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27</vt:i4>
      </vt:variant>
    </vt:vector>
  </HeadingPairs>
  <TitlesOfParts>
    <vt:vector size="232" baseType="lpstr">
      <vt:lpstr>Arial</vt:lpstr>
      <vt:lpstr>Calibri</vt:lpstr>
      <vt:lpstr>Calibri Light</vt:lpstr>
      <vt:lpstr>Office Theme</vt:lpstr>
      <vt:lpstr>Graph</vt:lpstr>
      <vt:lpstr>AR0 / F19 </vt:lpstr>
      <vt:lpstr>AR2/ TM142 </vt:lpstr>
      <vt:lpstr>BL1 </vt:lpstr>
      <vt:lpstr>BL2 </vt:lpstr>
      <vt:lpstr>BL3 </vt:lpstr>
      <vt:lpstr>BL4 </vt:lpstr>
      <vt:lpstr>BL5 / KB13 </vt:lpstr>
      <vt:lpstr>BL6a </vt:lpstr>
      <vt:lpstr>BL7 </vt:lpstr>
      <vt:lpstr>BL8 </vt:lpstr>
      <vt:lpstr>BL9 </vt:lpstr>
      <vt:lpstr>CK10 </vt:lpstr>
      <vt:lpstr>CK11 </vt:lpstr>
      <vt:lpstr>CK12 </vt:lpstr>
      <vt:lpstr>CK13 </vt:lpstr>
      <vt:lpstr>CK14 </vt:lpstr>
      <vt:lpstr>CK15 </vt:lpstr>
      <vt:lpstr>CK2 </vt:lpstr>
      <vt:lpstr>CK22 </vt:lpstr>
      <vt:lpstr>CK23 </vt:lpstr>
      <vt:lpstr>CK24 </vt:lpstr>
      <vt:lpstr>CK3 </vt:lpstr>
      <vt:lpstr>CK5 </vt:lpstr>
      <vt:lpstr>CK6 </vt:lpstr>
      <vt:lpstr>CK7 </vt:lpstr>
      <vt:lpstr>CK8 </vt:lpstr>
      <vt:lpstr>CK9 </vt:lpstr>
      <vt:lpstr>CN10 </vt:lpstr>
      <vt:lpstr>CN12 </vt:lpstr>
      <vt:lpstr>CN13 </vt:lpstr>
      <vt:lpstr>CN14 </vt:lpstr>
      <vt:lpstr>CN16 </vt:lpstr>
      <vt:lpstr>CN18 </vt:lpstr>
      <vt:lpstr>CN19 </vt:lpstr>
      <vt:lpstr>CN2 </vt:lpstr>
      <vt:lpstr>CN20 </vt:lpstr>
      <vt:lpstr>CN21 </vt:lpstr>
      <vt:lpstr>CN22 </vt:lpstr>
      <vt:lpstr>CN23 </vt:lpstr>
      <vt:lpstr>CN24 </vt:lpstr>
      <vt:lpstr>CN25 </vt:lpstr>
      <vt:lpstr>CN26 </vt:lpstr>
      <vt:lpstr>CN27 </vt:lpstr>
      <vt:lpstr>CN28 </vt:lpstr>
      <vt:lpstr>CN29 </vt:lpstr>
      <vt:lpstr>CN3 </vt:lpstr>
      <vt:lpstr>CN30 </vt:lpstr>
      <vt:lpstr>CN31 </vt:lpstr>
      <vt:lpstr>CN32 </vt:lpstr>
      <vt:lpstr>CN33 </vt:lpstr>
      <vt:lpstr>CN4 </vt:lpstr>
      <vt:lpstr>CN5 </vt:lpstr>
      <vt:lpstr>CN6 </vt:lpstr>
      <vt:lpstr>CN7 </vt:lpstr>
      <vt:lpstr>CN8 </vt:lpstr>
      <vt:lpstr>CN9 </vt:lpstr>
      <vt:lpstr>CR16 </vt:lpstr>
      <vt:lpstr>DF5 / CK16 </vt:lpstr>
      <vt:lpstr>EF-C </vt:lpstr>
      <vt:lpstr>EF-C opt </vt:lpstr>
      <vt:lpstr>JG1 </vt:lpstr>
      <vt:lpstr>JG10 </vt:lpstr>
      <vt:lpstr>JG11 </vt:lpstr>
      <vt:lpstr>JG14 / TG14 </vt:lpstr>
      <vt:lpstr>JG2 </vt:lpstr>
      <vt:lpstr>JG3 </vt:lpstr>
      <vt:lpstr>JG4 </vt:lpstr>
      <vt:lpstr>JG5 </vt:lpstr>
      <vt:lpstr>JG6 </vt:lpstr>
      <vt:lpstr>JG7 </vt:lpstr>
      <vt:lpstr>JG8 </vt:lpstr>
      <vt:lpstr>JG9 </vt:lpstr>
      <vt:lpstr>JGA2 </vt:lpstr>
      <vt:lpstr>JGA3 </vt:lpstr>
      <vt:lpstr>JGB1 /TM85 </vt:lpstr>
      <vt:lpstr>JGB2 </vt:lpstr>
      <vt:lpstr>JGB3 </vt:lpstr>
      <vt:lpstr>JJA2 / TM153 </vt:lpstr>
      <vt:lpstr>JJA4 </vt:lpstr>
      <vt:lpstr>JJA6 </vt:lpstr>
      <vt:lpstr>JR1 </vt:lpstr>
      <vt:lpstr>JR12 </vt:lpstr>
      <vt:lpstr>JR2 </vt:lpstr>
      <vt:lpstr>JR3-II </vt:lpstr>
      <vt:lpstr>JR4 </vt:lpstr>
      <vt:lpstr>JR7 </vt:lpstr>
      <vt:lpstr>JR9 </vt:lpstr>
      <vt:lpstr>KB1 </vt:lpstr>
      <vt:lpstr>KB11 </vt:lpstr>
      <vt:lpstr>KB12 </vt:lpstr>
      <vt:lpstr>KB14 </vt:lpstr>
      <vt:lpstr>KB2 </vt:lpstr>
      <vt:lpstr>KB3 </vt:lpstr>
      <vt:lpstr>KB4 </vt:lpstr>
      <vt:lpstr>KM27 / psis14 </vt:lpstr>
      <vt:lpstr>MG1 </vt:lpstr>
      <vt:lpstr>MG14 </vt:lpstr>
      <vt:lpstr>MG2 </vt:lpstr>
      <vt:lpstr>MG3b </vt:lpstr>
      <vt:lpstr>MG4a </vt:lpstr>
      <vt:lpstr>MG5a / CK17 </vt:lpstr>
      <vt:lpstr>MG6 </vt:lpstr>
      <vt:lpstr>MG7/CN1 </vt:lpstr>
      <vt:lpstr>MG8a / CN17 </vt:lpstr>
      <vt:lpstr>MG9a </vt:lpstr>
      <vt:lpstr>MGe01 </vt:lpstr>
      <vt:lpstr>msis21 </vt:lpstr>
      <vt:lpstr>NM6 </vt:lpstr>
      <vt:lpstr>psis21 </vt:lpstr>
      <vt:lpstr>psis22 </vt:lpstr>
      <vt:lpstr>psis29 </vt:lpstr>
      <vt:lpstr>QBL4 </vt:lpstr>
      <vt:lpstr>TG1 / (KM4) </vt:lpstr>
      <vt:lpstr>TG12 </vt:lpstr>
      <vt:lpstr>TG13 </vt:lpstr>
      <vt:lpstr>TG15 </vt:lpstr>
      <vt:lpstr>TG16 </vt:lpstr>
      <vt:lpstr>TG18 </vt:lpstr>
      <vt:lpstr>TG2 </vt:lpstr>
      <vt:lpstr>TG4 / (KM2) </vt:lpstr>
      <vt:lpstr>TG6 </vt:lpstr>
      <vt:lpstr>TG7 </vt:lpstr>
      <vt:lpstr>TG8 </vt:lpstr>
      <vt:lpstr>TM10 </vt:lpstr>
      <vt:lpstr>TM112 / CN11 </vt:lpstr>
      <vt:lpstr>TM113 / RC11 </vt:lpstr>
      <vt:lpstr>TM114 / RC17 </vt:lpstr>
      <vt:lpstr>TM116 </vt:lpstr>
      <vt:lpstr>TM12 </vt:lpstr>
      <vt:lpstr>TM13 </vt:lpstr>
      <vt:lpstr>TM140 </vt:lpstr>
      <vt:lpstr>TM141</vt:lpstr>
      <vt:lpstr>TM143</vt:lpstr>
      <vt:lpstr>TM144 </vt:lpstr>
      <vt:lpstr>TM145 </vt:lpstr>
      <vt:lpstr>TM152 </vt:lpstr>
      <vt:lpstr>TM155 </vt:lpstr>
      <vt:lpstr>TM16 </vt:lpstr>
      <vt:lpstr>TM21 </vt:lpstr>
      <vt:lpstr>TM4 </vt:lpstr>
      <vt:lpstr>TM41 </vt:lpstr>
      <vt:lpstr>TM45 </vt:lpstr>
      <vt:lpstr>TM52 </vt:lpstr>
      <vt:lpstr>TM6 </vt:lpstr>
      <vt:lpstr>TM64/ CN15 </vt:lpstr>
      <vt:lpstr>TM69 </vt:lpstr>
      <vt:lpstr>TM71 </vt:lpstr>
      <vt:lpstr>TM72 </vt:lpstr>
      <vt:lpstr>TM73 </vt:lpstr>
      <vt:lpstr>TM74 </vt:lpstr>
      <vt:lpstr>TM8 </vt:lpstr>
      <vt:lpstr>TM81 </vt:lpstr>
      <vt:lpstr>TM86 </vt:lpstr>
      <vt:lpstr>TM92 </vt:lpstr>
      <vt:lpstr>TM95 / (TM75) </vt:lpstr>
      <vt:lpstr>VH11 </vt:lpstr>
      <vt:lpstr>VH12 </vt:lpstr>
      <vt:lpstr>VH14 </vt:lpstr>
      <vt:lpstr>VH15 </vt:lpstr>
      <vt:lpstr>VH16 </vt:lpstr>
      <vt:lpstr>VH17-II </vt:lpstr>
      <vt:lpstr>VH8 </vt:lpstr>
      <vt:lpstr>VH9 </vt:lpstr>
      <vt:lpstr>PS07</vt:lpstr>
      <vt:lpstr>JH01</vt:lpstr>
      <vt:lpstr>PowerPoint Presentation</vt:lpstr>
      <vt:lpstr>DM1</vt:lpstr>
      <vt:lpstr>dm2</vt:lpstr>
      <vt:lpstr>dm3</vt:lpstr>
      <vt:lpstr>dm4</vt:lpstr>
      <vt:lpstr>dm5</vt:lpstr>
      <vt:lpstr>dm6</vt:lpstr>
      <vt:lpstr>dm7</vt:lpstr>
      <vt:lpstr>Dm8 -std</vt:lpstr>
      <vt:lpstr>dm9</vt:lpstr>
      <vt:lpstr>dm10</vt:lpstr>
      <vt:lpstr>dm11</vt:lpstr>
      <vt:lpstr>dm12</vt:lpstr>
      <vt:lpstr>dm13</vt:lpstr>
      <vt:lpstr>dm14</vt:lpstr>
      <vt:lpstr>dm15</vt:lpstr>
      <vt:lpstr>dm16</vt:lpstr>
      <vt:lpstr>dm17</vt:lpstr>
      <vt:lpstr>dm18</vt:lpstr>
      <vt:lpstr>dm19</vt:lpstr>
      <vt:lpstr>dm20</vt:lpstr>
      <vt:lpstr>kk059</vt:lpstr>
      <vt:lpstr>kk060</vt:lpstr>
      <vt:lpstr>kk061</vt:lpstr>
      <vt:lpstr>kk066</vt:lpstr>
      <vt:lpstr>kk067</vt:lpstr>
      <vt:lpstr>kk068</vt:lpstr>
      <vt:lpstr>KK069</vt:lpstr>
      <vt:lpstr>DM21</vt:lpstr>
      <vt:lpstr>DM22</vt:lpstr>
      <vt:lpstr>Dm23-std</vt:lpstr>
      <vt:lpstr>DM24</vt:lpstr>
      <vt:lpstr>DM25</vt:lpstr>
      <vt:lpstr>DM26</vt:lpstr>
      <vt:lpstr>dm27</vt:lpstr>
      <vt:lpstr>DM28</vt:lpstr>
      <vt:lpstr>DM29</vt:lpstr>
      <vt:lpstr>DM30</vt:lpstr>
      <vt:lpstr>dm31</vt:lpstr>
      <vt:lpstr>DM32</vt:lpstr>
      <vt:lpstr>DM33</vt:lpstr>
      <vt:lpstr>DM34</vt:lpstr>
      <vt:lpstr>DM35</vt:lpstr>
      <vt:lpstr>DM36</vt:lpstr>
      <vt:lpstr>DM37</vt:lpstr>
      <vt:lpstr>DM38</vt:lpstr>
      <vt:lpstr>DM39</vt:lpstr>
      <vt:lpstr>DM40</vt:lpstr>
      <vt:lpstr>DM41</vt:lpstr>
      <vt:lpstr>DM42</vt:lpstr>
      <vt:lpstr>DM43</vt:lpstr>
      <vt:lpstr>DM44</vt:lpstr>
      <vt:lpstr>DM45</vt:lpstr>
      <vt:lpstr>DM46</vt:lpstr>
      <vt:lpstr>DM47</vt:lpstr>
      <vt:lpstr>DM48</vt:lpstr>
      <vt:lpstr>DM49</vt:lpstr>
      <vt:lpstr>DM50</vt:lpstr>
      <vt:lpstr>DM51</vt:lpstr>
      <vt:lpstr>DM52</vt:lpstr>
      <vt:lpstr>DM53</vt:lpstr>
      <vt:lpstr>DM54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R0 / F19 </dc:title>
  <dc:creator>Kaygisiz, Kübra</dc:creator>
  <cp:lastModifiedBy>Kaygisiz, Kübra</cp:lastModifiedBy>
  <cp:revision>1</cp:revision>
  <dcterms:created xsi:type="dcterms:W3CDTF">2022-08-19T07:49:03Z</dcterms:created>
  <dcterms:modified xsi:type="dcterms:W3CDTF">2022-08-24T05:18:02Z</dcterms:modified>
</cp:coreProperties>
</file>